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56.png" ContentType="image/png"/>
  <Override PartName="/ppt/media/image55.png" ContentType="image/png"/>
  <Override PartName="/ppt/media/image54.png" ContentType="image/png"/>
  <Override PartName="/ppt/media/image53.png" ContentType="image/png"/>
  <Override PartName="/ppt/media/image52.png" ContentType="image/png"/>
  <Override PartName="/ppt/media/image51.png" ContentType="image/png"/>
  <Override PartName="/ppt/media/image50.png" ContentType="image/png"/>
  <Override PartName="/ppt/media/image34.png" ContentType="image/png"/>
  <Override PartName="/ppt/media/image4.png" ContentType="image/png"/>
  <Override PartName="/ppt/media/image16.png" ContentType="image/png"/>
  <Override PartName="/ppt/media/image33.png" ContentType="image/png"/>
  <Override PartName="/ppt/media/image3.png" ContentType="image/png"/>
  <Override PartName="/ppt/media/image15.png" ContentType="image/png"/>
  <Override PartName="/ppt/media/image32.png" ContentType="image/png"/>
  <Override PartName="/ppt/media/image2.png" ContentType="image/png"/>
  <Override PartName="/ppt/media/image14.png" ContentType="image/png"/>
  <Override PartName="/ppt/media/image31.png" ContentType="image/png"/>
  <Override PartName="/ppt/media/image66.png" ContentType="image/png"/>
  <Override PartName="/ppt/media/image28.png" ContentType="image/png"/>
  <Override PartName="/ppt/media/image65.png" ContentType="image/png"/>
  <Override PartName="/ppt/media/image27.png" ContentType="image/png"/>
  <Override PartName="/ppt/media/image64.png" ContentType="image/png"/>
  <Override PartName="/ppt/media/image26.png" ContentType="image/png"/>
  <Override PartName="/ppt/media/image63.png" ContentType="image/png"/>
  <Override PartName="/ppt/media/image25.png" ContentType="image/png"/>
  <Override PartName="/ppt/media/image62.png" ContentType="image/png"/>
  <Override PartName="/ppt/media/image24.png" ContentType="image/png"/>
  <Override PartName="/ppt/media/image61.png" ContentType="image/png"/>
  <Override PartName="/ppt/media/image59.png" ContentType="image/png"/>
  <Override PartName="/ppt/media/image22.png" ContentType="image/png"/>
  <Override PartName="/ppt/media/image57.png" ContentType="image/png"/>
  <Override PartName="/ppt/media/image20.png" ContentType="image/png"/>
  <Override PartName="/ppt/media/image60.png" ContentType="image/png"/>
  <Override PartName="/ppt/media/image23.png" ContentType="image/png"/>
  <Override PartName="/ppt/media/image58.png" ContentType="image/png"/>
  <Override PartName="/ppt/media/image21.png" ContentType="image/png"/>
  <Override PartName="/ppt/media/image17.png" ContentType="image/png"/>
  <Override PartName="/ppt/media/image5.png" ContentType="image/png"/>
  <Override PartName="/ppt/media/image35.png" ContentType="image/png"/>
  <Override PartName="/ppt/media/image10.png" ContentType="image/png"/>
  <Override PartName="/ppt/media/image47.png" ContentType="image/png"/>
  <Override PartName="/ppt/media/image29.png" ContentType="image/png"/>
  <Override PartName="/ppt/media/image18.png" ContentType="image/png"/>
  <Override PartName="/ppt/media/image6.png" ContentType="image/png"/>
  <Override PartName="/ppt/media/image36.png" ContentType="image/png"/>
  <Override PartName="/ppt/media/image11.png" ContentType="image/png"/>
  <Override PartName="/ppt/media/image48.png" ContentType="image/png"/>
  <Override PartName="/ppt/media/image19.png" ContentType="image/png"/>
  <Override PartName="/ppt/media/image7.png" ContentType="image/png"/>
  <Override PartName="/ppt/media/image37.png" ContentType="image/png"/>
  <Override PartName="/ppt/media/image12.png" ContentType="image/png"/>
  <Override PartName="/ppt/media/image49.png" ContentType="image/png"/>
  <Override PartName="/ppt/media/image8.png" ContentType="image/png"/>
  <Override PartName="/ppt/media/image38.png" ContentType="image/png"/>
  <Override PartName="/ppt/media/image1.png" ContentType="image/png"/>
  <Override PartName="/ppt/media/image13.png" ContentType="image/png"/>
  <Override PartName="/ppt/media/image9.png" ContentType="image/png"/>
  <Override PartName="/ppt/media/image39.png" ContentType="image/png"/>
  <Override PartName="/ppt/media/image30.png" ContentType="image/png"/>
  <Override PartName="/ppt/media/image40.png" ContentType="image/png"/>
  <Override PartName="/ppt/media/image41.png" ContentType="image/png"/>
  <Override PartName="/ppt/media/image42.png" ContentType="image/png"/>
  <Override PartName="/ppt/media/image43.png" ContentType="image/png"/>
  <Override PartName="/ppt/media/image44.png" ContentType="image/png"/>
  <Override PartName="/ppt/media/image45.png" ContentType="image/png"/>
  <Override PartName="/ppt/media/image46.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Lst>
  <p:sldSz cx="21394738" cy="150876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039ACB9E-ED86-4EAE-93E5-6728FB8FBE6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1069920" y="604440"/>
            <a:ext cx="19256400" cy="2514600"/>
          </a:xfrm>
          <a:prstGeom prst="rect">
            <a:avLst/>
          </a:prstGeom>
          <a:noFill/>
          <a:ln w="0">
            <a:noFill/>
          </a:ln>
        </p:spPr>
        <p:txBody>
          <a:bodyPr lIns="149040" rIns="149040" tIns="74520" bIns="74520" anchor="ctr">
            <a:noAutofit/>
          </a:bodyPr>
          <a:p>
            <a:pPr indent="0" algn="ctr">
              <a:buNone/>
              <a:tabLst>
                <a:tab algn="l" pos="0"/>
                <a:tab algn="l" pos="1487520"/>
                <a:tab algn="l" pos="2975040"/>
                <a:tab algn="l" pos="4462560"/>
                <a:tab algn="l" pos="5950080"/>
                <a:tab algn="l" pos="7437600"/>
                <a:tab algn="l" pos="8924760"/>
                <a:tab algn="l" pos="10412280"/>
              </a:tabLst>
            </a:pPr>
            <a:endParaRPr b="0" lang="en-US" sz="7200" spc="-1" strike="noStrike">
              <a:solidFill>
                <a:srgbClr val="000000"/>
              </a:solidFill>
              <a:latin typeface="Calibri"/>
            </a:endParaRPr>
          </a:p>
        </p:txBody>
      </p:sp>
      <p:sp>
        <p:nvSpPr>
          <p:cNvPr id="27" name="PlaceHolder 2"/>
          <p:cNvSpPr>
            <a:spLocks noGrp="1"/>
          </p:cNvSpPr>
          <p:nvPr>
            <p:ph/>
          </p:nvPr>
        </p:nvSpPr>
        <p:spPr>
          <a:xfrm>
            <a:off x="1069920" y="3521160"/>
            <a:ext cx="19256400" cy="4749120"/>
          </a:xfrm>
          <a:prstGeom prst="rect">
            <a:avLst/>
          </a:prstGeom>
          <a:noFill/>
          <a:ln w="0">
            <a:noFill/>
          </a:ln>
        </p:spPr>
        <p:txBody>
          <a:bodyPr lIns="149040" rIns="149040" tIns="74520" bIns="74520" anchor="t">
            <a:normAutofit/>
          </a:bodyPr>
          <a:p>
            <a:pPr indent="0">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28" name="PlaceHolder 3"/>
          <p:cNvSpPr>
            <a:spLocks noGrp="1"/>
          </p:cNvSpPr>
          <p:nvPr>
            <p:ph/>
          </p:nvPr>
        </p:nvSpPr>
        <p:spPr>
          <a:xfrm>
            <a:off x="1069920" y="8721720"/>
            <a:ext cx="19256400" cy="4749120"/>
          </a:xfrm>
          <a:prstGeom prst="rect">
            <a:avLst/>
          </a:prstGeom>
          <a:noFill/>
          <a:ln w="0">
            <a:noFill/>
          </a:ln>
        </p:spPr>
        <p:txBody>
          <a:bodyPr lIns="149040" rIns="149040" tIns="74520" bIns="74520" anchor="t">
            <a:normAutofit/>
          </a:bodyPr>
          <a:p>
            <a:pPr indent="0">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C4D8741-21AC-40D5-A053-08139925BDB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1069920" y="604440"/>
            <a:ext cx="19256400" cy="2514600"/>
          </a:xfrm>
          <a:prstGeom prst="rect">
            <a:avLst/>
          </a:prstGeom>
          <a:noFill/>
          <a:ln w="0">
            <a:noFill/>
          </a:ln>
        </p:spPr>
        <p:txBody>
          <a:bodyPr lIns="149040" rIns="149040" tIns="74520" bIns="74520" anchor="ctr">
            <a:noAutofit/>
          </a:bodyPr>
          <a:p>
            <a:pPr indent="0" algn="ctr">
              <a:buNone/>
              <a:tabLst>
                <a:tab algn="l" pos="0"/>
                <a:tab algn="l" pos="1487520"/>
                <a:tab algn="l" pos="2975040"/>
                <a:tab algn="l" pos="4462560"/>
                <a:tab algn="l" pos="5950080"/>
                <a:tab algn="l" pos="7437600"/>
                <a:tab algn="l" pos="8924760"/>
                <a:tab algn="l" pos="10412280"/>
              </a:tabLst>
            </a:pPr>
            <a:endParaRPr b="0" lang="en-US" sz="7200" spc="-1" strike="noStrike">
              <a:solidFill>
                <a:srgbClr val="000000"/>
              </a:solidFill>
              <a:latin typeface="Calibri"/>
            </a:endParaRPr>
          </a:p>
        </p:txBody>
      </p:sp>
      <p:sp>
        <p:nvSpPr>
          <p:cNvPr id="30" name="PlaceHolder 2"/>
          <p:cNvSpPr>
            <a:spLocks noGrp="1"/>
          </p:cNvSpPr>
          <p:nvPr>
            <p:ph/>
          </p:nvPr>
        </p:nvSpPr>
        <p:spPr>
          <a:xfrm>
            <a:off x="1069920" y="3521160"/>
            <a:ext cx="9397080" cy="4749120"/>
          </a:xfrm>
          <a:prstGeom prst="rect">
            <a:avLst/>
          </a:prstGeom>
          <a:noFill/>
          <a:ln w="0">
            <a:noFill/>
          </a:ln>
        </p:spPr>
        <p:txBody>
          <a:bodyPr lIns="149040" rIns="149040" tIns="74520" bIns="74520" anchor="t">
            <a:normAutofit/>
          </a:bodyPr>
          <a:p>
            <a:pPr indent="0">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31" name="PlaceHolder 3"/>
          <p:cNvSpPr>
            <a:spLocks noGrp="1"/>
          </p:cNvSpPr>
          <p:nvPr>
            <p:ph/>
          </p:nvPr>
        </p:nvSpPr>
        <p:spPr>
          <a:xfrm>
            <a:off x="10937160" y="3521160"/>
            <a:ext cx="9397080" cy="4749120"/>
          </a:xfrm>
          <a:prstGeom prst="rect">
            <a:avLst/>
          </a:prstGeom>
          <a:noFill/>
          <a:ln w="0">
            <a:noFill/>
          </a:ln>
        </p:spPr>
        <p:txBody>
          <a:bodyPr lIns="149040" rIns="149040" tIns="74520" bIns="74520" anchor="t">
            <a:normAutofit/>
          </a:bodyPr>
          <a:p>
            <a:pPr indent="0">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32" name="PlaceHolder 4"/>
          <p:cNvSpPr>
            <a:spLocks noGrp="1"/>
          </p:cNvSpPr>
          <p:nvPr>
            <p:ph/>
          </p:nvPr>
        </p:nvSpPr>
        <p:spPr>
          <a:xfrm>
            <a:off x="1069920" y="8721720"/>
            <a:ext cx="9397080" cy="4749120"/>
          </a:xfrm>
          <a:prstGeom prst="rect">
            <a:avLst/>
          </a:prstGeom>
          <a:noFill/>
          <a:ln w="0">
            <a:noFill/>
          </a:ln>
        </p:spPr>
        <p:txBody>
          <a:bodyPr lIns="149040" rIns="149040" tIns="74520" bIns="74520" anchor="t">
            <a:normAutofit/>
          </a:bodyPr>
          <a:p>
            <a:pPr indent="0">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33" name="PlaceHolder 5"/>
          <p:cNvSpPr>
            <a:spLocks noGrp="1"/>
          </p:cNvSpPr>
          <p:nvPr>
            <p:ph/>
          </p:nvPr>
        </p:nvSpPr>
        <p:spPr>
          <a:xfrm>
            <a:off x="10937160" y="8721720"/>
            <a:ext cx="9397080" cy="4749120"/>
          </a:xfrm>
          <a:prstGeom prst="rect">
            <a:avLst/>
          </a:prstGeom>
          <a:noFill/>
          <a:ln w="0">
            <a:noFill/>
          </a:ln>
        </p:spPr>
        <p:txBody>
          <a:bodyPr lIns="149040" rIns="149040" tIns="74520" bIns="74520" anchor="t">
            <a:normAutofit/>
          </a:bodyPr>
          <a:p>
            <a:pPr indent="0">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7DA3121-59D7-4F3C-9C2E-72892798E3F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1069920" y="604440"/>
            <a:ext cx="19256400" cy="2514600"/>
          </a:xfrm>
          <a:prstGeom prst="rect">
            <a:avLst/>
          </a:prstGeom>
          <a:noFill/>
          <a:ln w="0">
            <a:noFill/>
          </a:ln>
        </p:spPr>
        <p:txBody>
          <a:bodyPr lIns="149040" rIns="149040" tIns="74520" bIns="74520" anchor="ctr">
            <a:noAutofit/>
          </a:bodyPr>
          <a:p>
            <a:pPr indent="0" algn="ctr">
              <a:buNone/>
              <a:tabLst>
                <a:tab algn="l" pos="0"/>
                <a:tab algn="l" pos="1487520"/>
                <a:tab algn="l" pos="2975040"/>
                <a:tab algn="l" pos="4462560"/>
                <a:tab algn="l" pos="5950080"/>
                <a:tab algn="l" pos="7437600"/>
                <a:tab algn="l" pos="8924760"/>
                <a:tab algn="l" pos="10412280"/>
              </a:tabLst>
            </a:pPr>
            <a:endParaRPr b="0" lang="en-US" sz="7200" spc="-1" strike="noStrike">
              <a:solidFill>
                <a:srgbClr val="000000"/>
              </a:solidFill>
              <a:latin typeface="Calibri"/>
            </a:endParaRPr>
          </a:p>
        </p:txBody>
      </p:sp>
      <p:sp>
        <p:nvSpPr>
          <p:cNvPr id="35" name="PlaceHolder 2"/>
          <p:cNvSpPr>
            <a:spLocks noGrp="1"/>
          </p:cNvSpPr>
          <p:nvPr>
            <p:ph/>
          </p:nvPr>
        </p:nvSpPr>
        <p:spPr>
          <a:xfrm>
            <a:off x="1069920" y="3521160"/>
            <a:ext cx="6200280" cy="4749120"/>
          </a:xfrm>
          <a:prstGeom prst="rect">
            <a:avLst/>
          </a:prstGeom>
          <a:noFill/>
          <a:ln w="0">
            <a:noFill/>
          </a:ln>
        </p:spPr>
        <p:txBody>
          <a:bodyPr lIns="149040" rIns="149040" tIns="74520" bIns="74520" anchor="t">
            <a:normAutofit/>
          </a:bodyPr>
          <a:p>
            <a:pPr indent="0">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36" name="PlaceHolder 3"/>
          <p:cNvSpPr>
            <a:spLocks noGrp="1"/>
          </p:cNvSpPr>
          <p:nvPr>
            <p:ph/>
          </p:nvPr>
        </p:nvSpPr>
        <p:spPr>
          <a:xfrm>
            <a:off x="7580520" y="3521160"/>
            <a:ext cx="6200280" cy="4749120"/>
          </a:xfrm>
          <a:prstGeom prst="rect">
            <a:avLst/>
          </a:prstGeom>
          <a:noFill/>
          <a:ln w="0">
            <a:noFill/>
          </a:ln>
        </p:spPr>
        <p:txBody>
          <a:bodyPr lIns="149040" rIns="149040" tIns="74520" bIns="74520" anchor="t">
            <a:normAutofit/>
          </a:bodyPr>
          <a:p>
            <a:pPr indent="0">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37" name="PlaceHolder 4"/>
          <p:cNvSpPr>
            <a:spLocks noGrp="1"/>
          </p:cNvSpPr>
          <p:nvPr>
            <p:ph/>
          </p:nvPr>
        </p:nvSpPr>
        <p:spPr>
          <a:xfrm>
            <a:off x="14091120" y="3521160"/>
            <a:ext cx="6200280" cy="4749120"/>
          </a:xfrm>
          <a:prstGeom prst="rect">
            <a:avLst/>
          </a:prstGeom>
          <a:noFill/>
          <a:ln w="0">
            <a:noFill/>
          </a:ln>
        </p:spPr>
        <p:txBody>
          <a:bodyPr lIns="149040" rIns="149040" tIns="74520" bIns="74520" anchor="t">
            <a:normAutofit/>
          </a:bodyPr>
          <a:p>
            <a:pPr indent="0">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38" name="PlaceHolder 5"/>
          <p:cNvSpPr>
            <a:spLocks noGrp="1"/>
          </p:cNvSpPr>
          <p:nvPr>
            <p:ph/>
          </p:nvPr>
        </p:nvSpPr>
        <p:spPr>
          <a:xfrm>
            <a:off x="1069920" y="8721720"/>
            <a:ext cx="6200280" cy="4749120"/>
          </a:xfrm>
          <a:prstGeom prst="rect">
            <a:avLst/>
          </a:prstGeom>
          <a:noFill/>
          <a:ln w="0">
            <a:noFill/>
          </a:ln>
        </p:spPr>
        <p:txBody>
          <a:bodyPr lIns="149040" rIns="149040" tIns="74520" bIns="74520" anchor="t">
            <a:normAutofit/>
          </a:bodyPr>
          <a:p>
            <a:pPr indent="0">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39" name="PlaceHolder 6"/>
          <p:cNvSpPr>
            <a:spLocks noGrp="1"/>
          </p:cNvSpPr>
          <p:nvPr>
            <p:ph/>
          </p:nvPr>
        </p:nvSpPr>
        <p:spPr>
          <a:xfrm>
            <a:off x="7580520" y="8721720"/>
            <a:ext cx="6200280" cy="4749120"/>
          </a:xfrm>
          <a:prstGeom prst="rect">
            <a:avLst/>
          </a:prstGeom>
          <a:noFill/>
          <a:ln w="0">
            <a:noFill/>
          </a:ln>
        </p:spPr>
        <p:txBody>
          <a:bodyPr lIns="149040" rIns="149040" tIns="74520" bIns="74520" anchor="t">
            <a:normAutofit/>
          </a:bodyPr>
          <a:p>
            <a:pPr indent="0">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40" name="PlaceHolder 7"/>
          <p:cNvSpPr>
            <a:spLocks noGrp="1"/>
          </p:cNvSpPr>
          <p:nvPr>
            <p:ph/>
          </p:nvPr>
        </p:nvSpPr>
        <p:spPr>
          <a:xfrm>
            <a:off x="14091120" y="8721720"/>
            <a:ext cx="6200280" cy="4749120"/>
          </a:xfrm>
          <a:prstGeom prst="rect">
            <a:avLst/>
          </a:prstGeom>
          <a:noFill/>
          <a:ln w="0">
            <a:noFill/>
          </a:ln>
        </p:spPr>
        <p:txBody>
          <a:bodyPr lIns="149040" rIns="149040" tIns="74520" bIns="74520" anchor="t">
            <a:normAutofit/>
          </a:bodyPr>
          <a:p>
            <a:pPr indent="0">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270D986-80B2-4500-AE4F-7A22FEC8C59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1069920" y="604440"/>
            <a:ext cx="19256400" cy="2514600"/>
          </a:xfrm>
          <a:prstGeom prst="rect">
            <a:avLst/>
          </a:prstGeom>
          <a:noFill/>
          <a:ln w="0">
            <a:noFill/>
          </a:ln>
        </p:spPr>
        <p:txBody>
          <a:bodyPr lIns="149040" rIns="149040" tIns="74520" bIns="74520" anchor="ctr">
            <a:noAutofit/>
          </a:bodyPr>
          <a:p>
            <a:pPr indent="0" algn="ctr">
              <a:buNone/>
              <a:tabLst>
                <a:tab algn="l" pos="0"/>
                <a:tab algn="l" pos="1487520"/>
                <a:tab algn="l" pos="2975040"/>
                <a:tab algn="l" pos="4462560"/>
                <a:tab algn="l" pos="5950080"/>
                <a:tab algn="l" pos="7437600"/>
                <a:tab algn="l" pos="8924760"/>
                <a:tab algn="l" pos="10412280"/>
              </a:tabLst>
            </a:pPr>
            <a:endParaRPr b="0" lang="en-US" sz="7200" spc="-1" strike="noStrike">
              <a:solidFill>
                <a:srgbClr val="000000"/>
              </a:solidFill>
              <a:latin typeface="Calibri"/>
            </a:endParaRPr>
          </a:p>
        </p:txBody>
      </p:sp>
      <p:sp>
        <p:nvSpPr>
          <p:cNvPr id="6" name="PlaceHolder 2"/>
          <p:cNvSpPr>
            <a:spLocks noGrp="1"/>
          </p:cNvSpPr>
          <p:nvPr>
            <p:ph type="subTitle"/>
          </p:nvPr>
        </p:nvSpPr>
        <p:spPr>
          <a:xfrm>
            <a:off x="1069920" y="3521160"/>
            <a:ext cx="19256400" cy="9956880"/>
          </a:xfrm>
          <a:prstGeom prst="rect">
            <a:avLst/>
          </a:prstGeom>
          <a:noFill/>
          <a:ln w="0">
            <a:noFill/>
          </a:ln>
        </p:spPr>
        <p:txBody>
          <a:bodyPr lIns="0" rIns="0" tIns="0" bIns="0" anchor="ctr">
            <a:noAutofit/>
          </a:bodyPr>
          <a:p>
            <a:pPr indent="0" algn="ctr">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C9BAA54-469E-4CC5-893B-51FE73362BF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1069920" y="604440"/>
            <a:ext cx="19256400" cy="2514600"/>
          </a:xfrm>
          <a:prstGeom prst="rect">
            <a:avLst/>
          </a:prstGeom>
          <a:noFill/>
          <a:ln w="0">
            <a:noFill/>
          </a:ln>
        </p:spPr>
        <p:txBody>
          <a:bodyPr lIns="149040" rIns="149040" tIns="74520" bIns="74520" anchor="ctr">
            <a:noAutofit/>
          </a:bodyPr>
          <a:p>
            <a:pPr indent="0" algn="ctr">
              <a:buNone/>
              <a:tabLst>
                <a:tab algn="l" pos="0"/>
                <a:tab algn="l" pos="1487520"/>
                <a:tab algn="l" pos="2975040"/>
                <a:tab algn="l" pos="4462560"/>
                <a:tab algn="l" pos="5950080"/>
                <a:tab algn="l" pos="7437600"/>
                <a:tab algn="l" pos="8924760"/>
                <a:tab algn="l" pos="10412280"/>
              </a:tabLst>
            </a:pPr>
            <a:endParaRPr b="0" lang="en-US" sz="7200" spc="-1" strike="noStrike">
              <a:solidFill>
                <a:srgbClr val="000000"/>
              </a:solidFill>
              <a:latin typeface="Calibri"/>
            </a:endParaRPr>
          </a:p>
        </p:txBody>
      </p:sp>
      <p:sp>
        <p:nvSpPr>
          <p:cNvPr id="8" name="PlaceHolder 2"/>
          <p:cNvSpPr>
            <a:spLocks noGrp="1"/>
          </p:cNvSpPr>
          <p:nvPr>
            <p:ph/>
          </p:nvPr>
        </p:nvSpPr>
        <p:spPr>
          <a:xfrm>
            <a:off x="1069920" y="3521160"/>
            <a:ext cx="19256400" cy="9956880"/>
          </a:xfrm>
          <a:prstGeom prst="rect">
            <a:avLst/>
          </a:prstGeom>
          <a:noFill/>
          <a:ln w="0">
            <a:noFill/>
          </a:ln>
        </p:spPr>
        <p:txBody>
          <a:bodyPr lIns="149040" rIns="149040" tIns="74520" bIns="74520" anchor="t">
            <a:normAutofit/>
          </a:bodyPr>
          <a:p>
            <a:pPr indent="0">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DBCD066-B2F5-4D5E-B29E-5B1BB2FEB67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1069920" y="604440"/>
            <a:ext cx="19256400" cy="2514600"/>
          </a:xfrm>
          <a:prstGeom prst="rect">
            <a:avLst/>
          </a:prstGeom>
          <a:noFill/>
          <a:ln w="0">
            <a:noFill/>
          </a:ln>
        </p:spPr>
        <p:txBody>
          <a:bodyPr lIns="149040" rIns="149040" tIns="74520" bIns="74520" anchor="ctr">
            <a:noAutofit/>
          </a:bodyPr>
          <a:p>
            <a:pPr indent="0" algn="ctr">
              <a:buNone/>
              <a:tabLst>
                <a:tab algn="l" pos="0"/>
                <a:tab algn="l" pos="1487520"/>
                <a:tab algn="l" pos="2975040"/>
                <a:tab algn="l" pos="4462560"/>
                <a:tab algn="l" pos="5950080"/>
                <a:tab algn="l" pos="7437600"/>
                <a:tab algn="l" pos="8924760"/>
                <a:tab algn="l" pos="10412280"/>
              </a:tabLst>
            </a:pPr>
            <a:endParaRPr b="0" lang="en-US" sz="7200" spc="-1" strike="noStrike">
              <a:solidFill>
                <a:srgbClr val="000000"/>
              </a:solidFill>
              <a:latin typeface="Calibri"/>
            </a:endParaRPr>
          </a:p>
        </p:txBody>
      </p:sp>
      <p:sp>
        <p:nvSpPr>
          <p:cNvPr id="10" name="PlaceHolder 2"/>
          <p:cNvSpPr>
            <a:spLocks noGrp="1"/>
          </p:cNvSpPr>
          <p:nvPr>
            <p:ph/>
          </p:nvPr>
        </p:nvSpPr>
        <p:spPr>
          <a:xfrm>
            <a:off x="1069920" y="3521160"/>
            <a:ext cx="9397080" cy="9956880"/>
          </a:xfrm>
          <a:prstGeom prst="rect">
            <a:avLst/>
          </a:prstGeom>
          <a:noFill/>
          <a:ln w="0">
            <a:noFill/>
          </a:ln>
        </p:spPr>
        <p:txBody>
          <a:bodyPr lIns="149040" rIns="149040" tIns="74520" bIns="74520" anchor="t">
            <a:normAutofit/>
          </a:bodyPr>
          <a:p>
            <a:pPr indent="0">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11" name="PlaceHolder 3"/>
          <p:cNvSpPr>
            <a:spLocks noGrp="1"/>
          </p:cNvSpPr>
          <p:nvPr>
            <p:ph/>
          </p:nvPr>
        </p:nvSpPr>
        <p:spPr>
          <a:xfrm>
            <a:off x="10937160" y="3521160"/>
            <a:ext cx="9397080" cy="9956880"/>
          </a:xfrm>
          <a:prstGeom prst="rect">
            <a:avLst/>
          </a:prstGeom>
          <a:noFill/>
          <a:ln w="0">
            <a:noFill/>
          </a:ln>
        </p:spPr>
        <p:txBody>
          <a:bodyPr lIns="149040" rIns="149040" tIns="74520" bIns="74520" anchor="t">
            <a:normAutofit/>
          </a:bodyPr>
          <a:p>
            <a:pPr indent="0">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6C4BF40-5FDF-4383-ACED-70D3AC4E3A5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1069920" y="604440"/>
            <a:ext cx="19256400" cy="2514600"/>
          </a:xfrm>
          <a:prstGeom prst="rect">
            <a:avLst/>
          </a:prstGeom>
          <a:noFill/>
          <a:ln w="0">
            <a:noFill/>
          </a:ln>
        </p:spPr>
        <p:txBody>
          <a:bodyPr lIns="149040" rIns="149040" tIns="74520" bIns="74520" anchor="ctr">
            <a:noAutofit/>
          </a:bodyPr>
          <a:p>
            <a:pPr indent="0" algn="ctr">
              <a:buNone/>
              <a:tabLst>
                <a:tab algn="l" pos="0"/>
                <a:tab algn="l" pos="1487520"/>
                <a:tab algn="l" pos="2975040"/>
                <a:tab algn="l" pos="4462560"/>
                <a:tab algn="l" pos="5950080"/>
                <a:tab algn="l" pos="7437600"/>
                <a:tab algn="l" pos="8924760"/>
                <a:tab algn="l" pos="10412280"/>
              </a:tabLst>
            </a:pPr>
            <a:endParaRPr b="0" lang="en-US" sz="7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3EA9428-752B-4D23-96D6-675AFE388E2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1069920" y="604440"/>
            <a:ext cx="19256400" cy="11657520"/>
          </a:xfrm>
          <a:prstGeom prst="rect">
            <a:avLst/>
          </a:prstGeom>
          <a:noFill/>
          <a:ln w="0">
            <a:noFill/>
          </a:ln>
        </p:spPr>
        <p:txBody>
          <a:bodyPr lIns="0" rIns="0" tIns="0" bIns="0" anchor="ctr">
            <a:noAutofit/>
          </a:bodyPr>
          <a:p>
            <a:pPr algn="ctr">
              <a:spcBef>
                <a:spcPts val="1301"/>
              </a:spcBef>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3510C13-3C4D-4FB4-8822-4A380C222D5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1069920" y="604440"/>
            <a:ext cx="19256400" cy="2514600"/>
          </a:xfrm>
          <a:prstGeom prst="rect">
            <a:avLst/>
          </a:prstGeom>
          <a:noFill/>
          <a:ln w="0">
            <a:noFill/>
          </a:ln>
        </p:spPr>
        <p:txBody>
          <a:bodyPr lIns="149040" rIns="149040" tIns="74520" bIns="74520" anchor="ctr">
            <a:noAutofit/>
          </a:bodyPr>
          <a:p>
            <a:pPr indent="0" algn="ctr">
              <a:buNone/>
              <a:tabLst>
                <a:tab algn="l" pos="0"/>
                <a:tab algn="l" pos="1487520"/>
                <a:tab algn="l" pos="2975040"/>
                <a:tab algn="l" pos="4462560"/>
                <a:tab algn="l" pos="5950080"/>
                <a:tab algn="l" pos="7437600"/>
                <a:tab algn="l" pos="8924760"/>
                <a:tab algn="l" pos="10412280"/>
              </a:tabLst>
            </a:pPr>
            <a:endParaRPr b="0" lang="en-US" sz="7200" spc="-1" strike="noStrike">
              <a:solidFill>
                <a:srgbClr val="000000"/>
              </a:solidFill>
              <a:latin typeface="Calibri"/>
            </a:endParaRPr>
          </a:p>
        </p:txBody>
      </p:sp>
      <p:sp>
        <p:nvSpPr>
          <p:cNvPr id="15" name="PlaceHolder 2"/>
          <p:cNvSpPr>
            <a:spLocks noGrp="1"/>
          </p:cNvSpPr>
          <p:nvPr>
            <p:ph/>
          </p:nvPr>
        </p:nvSpPr>
        <p:spPr>
          <a:xfrm>
            <a:off x="1069920" y="3521160"/>
            <a:ext cx="9397080" cy="4749120"/>
          </a:xfrm>
          <a:prstGeom prst="rect">
            <a:avLst/>
          </a:prstGeom>
          <a:noFill/>
          <a:ln w="0">
            <a:noFill/>
          </a:ln>
        </p:spPr>
        <p:txBody>
          <a:bodyPr lIns="149040" rIns="149040" tIns="74520" bIns="74520" anchor="t">
            <a:normAutofit/>
          </a:bodyPr>
          <a:p>
            <a:pPr indent="0">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16" name="PlaceHolder 3"/>
          <p:cNvSpPr>
            <a:spLocks noGrp="1"/>
          </p:cNvSpPr>
          <p:nvPr>
            <p:ph/>
          </p:nvPr>
        </p:nvSpPr>
        <p:spPr>
          <a:xfrm>
            <a:off x="10937160" y="3521160"/>
            <a:ext cx="9397080" cy="9956880"/>
          </a:xfrm>
          <a:prstGeom prst="rect">
            <a:avLst/>
          </a:prstGeom>
          <a:noFill/>
          <a:ln w="0">
            <a:noFill/>
          </a:ln>
        </p:spPr>
        <p:txBody>
          <a:bodyPr lIns="149040" rIns="149040" tIns="74520" bIns="74520" anchor="t">
            <a:normAutofit/>
          </a:bodyPr>
          <a:p>
            <a:pPr indent="0">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17" name="PlaceHolder 4"/>
          <p:cNvSpPr>
            <a:spLocks noGrp="1"/>
          </p:cNvSpPr>
          <p:nvPr>
            <p:ph/>
          </p:nvPr>
        </p:nvSpPr>
        <p:spPr>
          <a:xfrm>
            <a:off x="1069920" y="8721720"/>
            <a:ext cx="9397080" cy="4749120"/>
          </a:xfrm>
          <a:prstGeom prst="rect">
            <a:avLst/>
          </a:prstGeom>
          <a:noFill/>
          <a:ln w="0">
            <a:noFill/>
          </a:ln>
        </p:spPr>
        <p:txBody>
          <a:bodyPr lIns="149040" rIns="149040" tIns="74520" bIns="74520" anchor="t">
            <a:normAutofit/>
          </a:bodyPr>
          <a:p>
            <a:pPr indent="0">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2DA813A-FB3F-4378-8F31-3AAFA831BE2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1069920" y="604440"/>
            <a:ext cx="19256400" cy="2514600"/>
          </a:xfrm>
          <a:prstGeom prst="rect">
            <a:avLst/>
          </a:prstGeom>
          <a:noFill/>
          <a:ln w="0">
            <a:noFill/>
          </a:ln>
        </p:spPr>
        <p:txBody>
          <a:bodyPr lIns="149040" rIns="149040" tIns="74520" bIns="74520" anchor="ctr">
            <a:noAutofit/>
          </a:bodyPr>
          <a:p>
            <a:pPr indent="0" algn="ctr">
              <a:buNone/>
              <a:tabLst>
                <a:tab algn="l" pos="0"/>
                <a:tab algn="l" pos="1487520"/>
                <a:tab algn="l" pos="2975040"/>
                <a:tab algn="l" pos="4462560"/>
                <a:tab algn="l" pos="5950080"/>
                <a:tab algn="l" pos="7437600"/>
                <a:tab algn="l" pos="8924760"/>
                <a:tab algn="l" pos="10412280"/>
              </a:tabLst>
            </a:pPr>
            <a:endParaRPr b="0" lang="en-US" sz="7200" spc="-1" strike="noStrike">
              <a:solidFill>
                <a:srgbClr val="000000"/>
              </a:solidFill>
              <a:latin typeface="Calibri"/>
            </a:endParaRPr>
          </a:p>
        </p:txBody>
      </p:sp>
      <p:sp>
        <p:nvSpPr>
          <p:cNvPr id="19" name="PlaceHolder 2"/>
          <p:cNvSpPr>
            <a:spLocks noGrp="1"/>
          </p:cNvSpPr>
          <p:nvPr>
            <p:ph/>
          </p:nvPr>
        </p:nvSpPr>
        <p:spPr>
          <a:xfrm>
            <a:off x="1069920" y="3521160"/>
            <a:ext cx="9397080" cy="9956880"/>
          </a:xfrm>
          <a:prstGeom prst="rect">
            <a:avLst/>
          </a:prstGeom>
          <a:noFill/>
          <a:ln w="0">
            <a:noFill/>
          </a:ln>
        </p:spPr>
        <p:txBody>
          <a:bodyPr lIns="149040" rIns="149040" tIns="74520" bIns="74520" anchor="t">
            <a:normAutofit/>
          </a:bodyPr>
          <a:p>
            <a:pPr indent="0">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20" name="PlaceHolder 3"/>
          <p:cNvSpPr>
            <a:spLocks noGrp="1"/>
          </p:cNvSpPr>
          <p:nvPr>
            <p:ph/>
          </p:nvPr>
        </p:nvSpPr>
        <p:spPr>
          <a:xfrm>
            <a:off x="10937160" y="3521160"/>
            <a:ext cx="9397080" cy="4749120"/>
          </a:xfrm>
          <a:prstGeom prst="rect">
            <a:avLst/>
          </a:prstGeom>
          <a:noFill/>
          <a:ln w="0">
            <a:noFill/>
          </a:ln>
        </p:spPr>
        <p:txBody>
          <a:bodyPr lIns="149040" rIns="149040" tIns="74520" bIns="74520" anchor="t">
            <a:normAutofit/>
          </a:bodyPr>
          <a:p>
            <a:pPr indent="0">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21" name="PlaceHolder 4"/>
          <p:cNvSpPr>
            <a:spLocks noGrp="1"/>
          </p:cNvSpPr>
          <p:nvPr>
            <p:ph/>
          </p:nvPr>
        </p:nvSpPr>
        <p:spPr>
          <a:xfrm>
            <a:off x="10937160" y="8721720"/>
            <a:ext cx="9397080" cy="4749120"/>
          </a:xfrm>
          <a:prstGeom prst="rect">
            <a:avLst/>
          </a:prstGeom>
          <a:noFill/>
          <a:ln w="0">
            <a:noFill/>
          </a:ln>
        </p:spPr>
        <p:txBody>
          <a:bodyPr lIns="149040" rIns="149040" tIns="74520" bIns="74520" anchor="t">
            <a:normAutofit/>
          </a:bodyPr>
          <a:p>
            <a:pPr indent="0">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E72F6F3-24AA-4ED9-B484-5034C54291A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1069920" y="604440"/>
            <a:ext cx="19256400" cy="2514600"/>
          </a:xfrm>
          <a:prstGeom prst="rect">
            <a:avLst/>
          </a:prstGeom>
          <a:noFill/>
          <a:ln w="0">
            <a:noFill/>
          </a:ln>
        </p:spPr>
        <p:txBody>
          <a:bodyPr lIns="149040" rIns="149040" tIns="74520" bIns="74520" anchor="ctr">
            <a:noAutofit/>
          </a:bodyPr>
          <a:p>
            <a:pPr indent="0" algn="ctr">
              <a:buNone/>
              <a:tabLst>
                <a:tab algn="l" pos="0"/>
                <a:tab algn="l" pos="1487520"/>
                <a:tab algn="l" pos="2975040"/>
                <a:tab algn="l" pos="4462560"/>
                <a:tab algn="l" pos="5950080"/>
                <a:tab algn="l" pos="7437600"/>
                <a:tab algn="l" pos="8924760"/>
                <a:tab algn="l" pos="10412280"/>
              </a:tabLst>
            </a:pPr>
            <a:endParaRPr b="0" lang="en-US" sz="7200" spc="-1" strike="noStrike">
              <a:solidFill>
                <a:srgbClr val="000000"/>
              </a:solidFill>
              <a:latin typeface="Calibri"/>
            </a:endParaRPr>
          </a:p>
        </p:txBody>
      </p:sp>
      <p:sp>
        <p:nvSpPr>
          <p:cNvPr id="23" name="PlaceHolder 2"/>
          <p:cNvSpPr>
            <a:spLocks noGrp="1"/>
          </p:cNvSpPr>
          <p:nvPr>
            <p:ph/>
          </p:nvPr>
        </p:nvSpPr>
        <p:spPr>
          <a:xfrm>
            <a:off x="1069920" y="3521160"/>
            <a:ext cx="9397080" cy="4749120"/>
          </a:xfrm>
          <a:prstGeom prst="rect">
            <a:avLst/>
          </a:prstGeom>
          <a:noFill/>
          <a:ln w="0">
            <a:noFill/>
          </a:ln>
        </p:spPr>
        <p:txBody>
          <a:bodyPr lIns="149040" rIns="149040" tIns="74520" bIns="74520" anchor="t">
            <a:normAutofit/>
          </a:bodyPr>
          <a:p>
            <a:pPr indent="0">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24" name="PlaceHolder 3"/>
          <p:cNvSpPr>
            <a:spLocks noGrp="1"/>
          </p:cNvSpPr>
          <p:nvPr>
            <p:ph/>
          </p:nvPr>
        </p:nvSpPr>
        <p:spPr>
          <a:xfrm>
            <a:off x="10937160" y="3521160"/>
            <a:ext cx="9397080" cy="4749120"/>
          </a:xfrm>
          <a:prstGeom prst="rect">
            <a:avLst/>
          </a:prstGeom>
          <a:noFill/>
          <a:ln w="0">
            <a:noFill/>
          </a:ln>
        </p:spPr>
        <p:txBody>
          <a:bodyPr lIns="149040" rIns="149040" tIns="74520" bIns="74520" anchor="t">
            <a:normAutofit/>
          </a:bodyPr>
          <a:p>
            <a:pPr indent="0">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25" name="PlaceHolder 4"/>
          <p:cNvSpPr>
            <a:spLocks noGrp="1"/>
          </p:cNvSpPr>
          <p:nvPr>
            <p:ph/>
          </p:nvPr>
        </p:nvSpPr>
        <p:spPr>
          <a:xfrm>
            <a:off x="1069920" y="8721720"/>
            <a:ext cx="19256400" cy="4749120"/>
          </a:xfrm>
          <a:prstGeom prst="rect">
            <a:avLst/>
          </a:prstGeom>
          <a:noFill/>
          <a:ln w="0">
            <a:noFill/>
          </a:ln>
        </p:spPr>
        <p:txBody>
          <a:bodyPr lIns="149040" rIns="149040" tIns="74520" bIns="74520" anchor="t">
            <a:normAutofit/>
          </a:bodyPr>
          <a:p>
            <a:pPr indent="0">
              <a:spcBef>
                <a:spcPts val="1301"/>
              </a:spcBef>
              <a:buNone/>
              <a:tabLst>
                <a:tab algn="l" pos="1487520"/>
                <a:tab algn="l" pos="2975040"/>
                <a:tab algn="l" pos="4462560"/>
                <a:tab algn="l" pos="5950080"/>
                <a:tab algn="l" pos="7437600"/>
                <a:tab algn="l" pos="8924760"/>
                <a:tab algn="l" pos="10412280"/>
              </a:tabLst>
            </a:pPr>
            <a:endParaRPr b="0" lang="en-US" sz="5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D02411F-E859-42C6-8234-F05E8F49553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1069920" y="604440"/>
            <a:ext cx="19256400" cy="2514600"/>
          </a:xfrm>
          <a:prstGeom prst="rect">
            <a:avLst/>
          </a:prstGeom>
          <a:noFill/>
          <a:ln w="0">
            <a:noFill/>
          </a:ln>
        </p:spPr>
        <p:txBody>
          <a:bodyPr lIns="149040" rIns="149040" tIns="74520" bIns="74520" anchor="ctr">
            <a:noAutofit/>
          </a:bodyPr>
          <a:p>
            <a:pPr indent="0" algn="ctr">
              <a:buNone/>
              <a:tabLst>
                <a:tab algn="l" pos="0"/>
                <a:tab algn="l" pos="1487520"/>
                <a:tab algn="l" pos="2975040"/>
                <a:tab algn="l" pos="4462560"/>
                <a:tab algn="l" pos="5950080"/>
                <a:tab algn="l" pos="7437600"/>
                <a:tab algn="l" pos="8924760"/>
                <a:tab algn="l" pos="10412280"/>
              </a:tabLst>
            </a:pPr>
            <a:r>
              <a:rPr b="0" lang="en-US" sz="7200" spc="-1" strike="noStrike">
                <a:solidFill>
                  <a:srgbClr val="000000"/>
                </a:solidFill>
                <a:latin typeface="Calibri"/>
              </a:rPr>
              <a:t>Click to edit the title text format</a:t>
            </a:r>
            <a:endParaRPr b="0" lang="en-US" sz="7200" spc="-1" strike="noStrike">
              <a:solidFill>
                <a:srgbClr val="000000"/>
              </a:solidFill>
              <a:latin typeface="Calibri"/>
            </a:endParaRPr>
          </a:p>
        </p:txBody>
      </p:sp>
      <p:sp>
        <p:nvSpPr>
          <p:cNvPr id="1" name="PlaceHolder 2"/>
          <p:cNvSpPr>
            <a:spLocks noGrp="1"/>
          </p:cNvSpPr>
          <p:nvPr>
            <p:ph type="body"/>
          </p:nvPr>
        </p:nvSpPr>
        <p:spPr>
          <a:xfrm>
            <a:off x="1069920" y="3521160"/>
            <a:ext cx="19256400" cy="9956880"/>
          </a:xfrm>
          <a:prstGeom prst="rect">
            <a:avLst/>
          </a:prstGeom>
          <a:noFill/>
          <a:ln w="0">
            <a:noFill/>
          </a:ln>
        </p:spPr>
        <p:txBody>
          <a:bodyPr lIns="149040" rIns="149040" tIns="74520" bIns="74520" anchor="t">
            <a:normAutofit/>
          </a:bodyPr>
          <a:p>
            <a:pPr marL="557280" indent="-557280">
              <a:spcBef>
                <a:spcPts val="1301"/>
              </a:spcBef>
              <a:buClr>
                <a:srgbClr val="000000"/>
              </a:buClr>
              <a:buFont typeface="Arial"/>
              <a:buChar char="•"/>
              <a:tabLst>
                <a:tab algn="l" pos="1487520"/>
                <a:tab algn="l" pos="2975040"/>
                <a:tab algn="l" pos="4462560"/>
                <a:tab algn="l" pos="5950080"/>
                <a:tab algn="l" pos="7437600"/>
                <a:tab algn="l" pos="8924760"/>
                <a:tab algn="l" pos="10412280"/>
              </a:tabLst>
            </a:pPr>
            <a:r>
              <a:rPr b="0" lang="en-US" sz="5200" spc="-1" strike="noStrike">
                <a:solidFill>
                  <a:srgbClr val="000000"/>
                </a:solidFill>
                <a:latin typeface="Calibri"/>
              </a:rPr>
              <a:t>Click to edit the outline text format</a:t>
            </a:r>
            <a:endParaRPr b="0" lang="en-US" sz="5200" spc="-1" strike="noStrike">
              <a:solidFill>
                <a:srgbClr val="000000"/>
              </a:solidFill>
              <a:latin typeface="Calibri"/>
            </a:endParaRPr>
          </a:p>
          <a:p>
            <a:pPr lvl="1" marL="744480" indent="743040">
              <a:spcBef>
                <a:spcPts val="1301"/>
              </a:spcBef>
              <a:buClr>
                <a:srgbClr val="000000"/>
              </a:buClr>
              <a:buFont typeface="Arial"/>
              <a:buChar char="–"/>
              <a:tabLst>
                <a:tab algn="l" pos="1487520"/>
                <a:tab algn="l" pos="2975040"/>
                <a:tab algn="l" pos="4462560"/>
                <a:tab algn="l" pos="5950080"/>
                <a:tab algn="l" pos="7437600"/>
                <a:tab algn="l" pos="8924760"/>
                <a:tab algn="l" pos="10412280"/>
              </a:tabLst>
            </a:pPr>
            <a:r>
              <a:rPr b="0" lang="en-US" sz="5200" spc="-1" strike="noStrike">
                <a:solidFill>
                  <a:srgbClr val="000000"/>
                </a:solidFill>
                <a:latin typeface="Calibri"/>
              </a:rPr>
              <a:t>Second Outline Level</a:t>
            </a:r>
            <a:endParaRPr b="0" lang="en-US" sz="5200" spc="-1" strike="noStrike">
              <a:solidFill>
                <a:srgbClr val="000000"/>
              </a:solidFill>
              <a:latin typeface="Calibri"/>
            </a:endParaRPr>
          </a:p>
          <a:p>
            <a:pPr lvl="2" marL="1488960" indent="-1440">
              <a:spcBef>
                <a:spcPts val="1301"/>
              </a:spcBef>
              <a:buClr>
                <a:srgbClr val="000000"/>
              </a:buClr>
              <a:buFont typeface="Arial"/>
              <a:buChar char="•"/>
              <a:tabLst>
                <a:tab algn="l" pos="1487520"/>
                <a:tab algn="l" pos="2975040"/>
                <a:tab algn="l" pos="4462560"/>
                <a:tab algn="l" pos="5950080"/>
                <a:tab algn="l" pos="7437600"/>
                <a:tab algn="l" pos="8924760"/>
                <a:tab algn="l" pos="10412280"/>
              </a:tabLst>
            </a:pPr>
            <a:r>
              <a:rPr b="0" lang="en-US" sz="5200" spc="-1" strike="noStrike">
                <a:solidFill>
                  <a:srgbClr val="000000"/>
                </a:solidFill>
                <a:latin typeface="Calibri"/>
              </a:rPr>
              <a:t>Third Outline Level</a:t>
            </a:r>
            <a:endParaRPr b="0" lang="en-US" sz="5200" spc="-1" strike="noStrike">
              <a:solidFill>
                <a:srgbClr val="000000"/>
              </a:solidFill>
              <a:latin typeface="Calibri"/>
            </a:endParaRPr>
          </a:p>
          <a:p>
            <a:pPr lvl="3" marL="2233440" indent="-745920">
              <a:spcBef>
                <a:spcPts val="1301"/>
              </a:spcBef>
              <a:buClr>
                <a:srgbClr val="000000"/>
              </a:buClr>
              <a:buFont typeface="Arial"/>
              <a:buChar char="–"/>
              <a:tabLst>
                <a:tab algn="l" pos="1487520"/>
                <a:tab algn="l" pos="2975040"/>
                <a:tab algn="l" pos="4462560"/>
                <a:tab algn="l" pos="5950080"/>
                <a:tab algn="l" pos="7437600"/>
                <a:tab algn="l" pos="8924760"/>
                <a:tab algn="l" pos="10412280"/>
              </a:tabLst>
            </a:pPr>
            <a:r>
              <a:rPr b="0" lang="en-US" sz="5200" spc="-1" strike="noStrike">
                <a:solidFill>
                  <a:srgbClr val="000000"/>
                </a:solidFill>
                <a:latin typeface="Calibri"/>
              </a:rPr>
              <a:t>Fourth Outline Level</a:t>
            </a:r>
            <a:endParaRPr b="0" lang="en-US" sz="5200" spc="-1" strike="noStrike">
              <a:solidFill>
                <a:srgbClr val="000000"/>
              </a:solidFill>
              <a:latin typeface="Calibri"/>
            </a:endParaRPr>
          </a:p>
          <a:p>
            <a:pPr lvl="4" marL="2978280" indent="-1490760">
              <a:spcBef>
                <a:spcPts val="1301"/>
              </a:spcBef>
              <a:buClr>
                <a:srgbClr val="000000"/>
              </a:buClr>
              <a:buFont typeface="Arial"/>
              <a:buChar char="»"/>
              <a:tabLst>
                <a:tab algn="l" pos="1487520"/>
                <a:tab algn="l" pos="2975040"/>
                <a:tab algn="l" pos="4462560"/>
                <a:tab algn="l" pos="5950080"/>
                <a:tab algn="l" pos="7437600"/>
                <a:tab algn="l" pos="8924760"/>
                <a:tab algn="l" pos="10412280"/>
              </a:tabLst>
            </a:pPr>
            <a:r>
              <a:rPr b="0" lang="en-US" sz="5200" spc="-1" strike="noStrike">
                <a:solidFill>
                  <a:srgbClr val="000000"/>
                </a:solidFill>
                <a:latin typeface="Calibri"/>
              </a:rPr>
              <a:t>Fifth Outline Level</a:t>
            </a:r>
            <a:endParaRPr b="0" lang="en-US" sz="5200" spc="-1" strike="noStrike">
              <a:solidFill>
                <a:srgbClr val="000000"/>
              </a:solidFill>
              <a:latin typeface="Calibri"/>
            </a:endParaRPr>
          </a:p>
          <a:p>
            <a:pPr lvl="5" marL="2978280" indent="-1490760">
              <a:spcBef>
                <a:spcPts val="1301"/>
              </a:spcBef>
              <a:buClr>
                <a:srgbClr val="000000"/>
              </a:buClr>
              <a:buFont typeface="Arial"/>
              <a:buChar char="»"/>
              <a:tabLst>
                <a:tab algn="l" pos="1487520"/>
                <a:tab algn="l" pos="2975040"/>
                <a:tab algn="l" pos="4462560"/>
                <a:tab algn="l" pos="5950080"/>
                <a:tab algn="l" pos="7437600"/>
                <a:tab algn="l" pos="8924760"/>
                <a:tab algn="l" pos="10412280"/>
              </a:tabLst>
            </a:pPr>
            <a:r>
              <a:rPr b="0" lang="en-US" sz="5200" spc="-1" strike="noStrike">
                <a:solidFill>
                  <a:srgbClr val="000000"/>
                </a:solidFill>
                <a:latin typeface="Calibri"/>
              </a:rPr>
              <a:t>Sixth Outline Level</a:t>
            </a:r>
            <a:endParaRPr b="0" lang="en-US" sz="5200" spc="-1" strike="noStrike">
              <a:solidFill>
                <a:srgbClr val="000000"/>
              </a:solidFill>
              <a:latin typeface="Calibri"/>
            </a:endParaRPr>
          </a:p>
          <a:p>
            <a:pPr lvl="6" marL="2978280" indent="-1490760">
              <a:spcBef>
                <a:spcPts val="1301"/>
              </a:spcBef>
              <a:buClr>
                <a:srgbClr val="000000"/>
              </a:buClr>
              <a:buFont typeface="Arial"/>
              <a:buChar char="»"/>
              <a:tabLst>
                <a:tab algn="l" pos="1487520"/>
                <a:tab algn="l" pos="2975040"/>
                <a:tab algn="l" pos="4462560"/>
                <a:tab algn="l" pos="5950080"/>
                <a:tab algn="l" pos="7437600"/>
                <a:tab algn="l" pos="8924760"/>
                <a:tab algn="l" pos="10412280"/>
              </a:tabLst>
            </a:pPr>
            <a:r>
              <a:rPr b="0" lang="en-US" sz="5200" spc="-1" strike="noStrike">
                <a:solidFill>
                  <a:srgbClr val="000000"/>
                </a:solidFill>
                <a:latin typeface="Calibri"/>
              </a:rPr>
              <a:t>Seventh Outline Level</a:t>
            </a:r>
            <a:endParaRPr b="0" lang="en-US" sz="5200" spc="-1" strike="noStrike">
              <a:solidFill>
                <a:srgbClr val="000000"/>
              </a:solidFill>
              <a:latin typeface="Calibri"/>
            </a:endParaRPr>
          </a:p>
        </p:txBody>
      </p:sp>
      <p:sp>
        <p:nvSpPr>
          <p:cNvPr id="2" name="PlaceHolder 3"/>
          <p:cNvSpPr>
            <a:spLocks noGrp="1"/>
          </p:cNvSpPr>
          <p:nvPr>
            <p:ph type="dt" idx="1"/>
          </p:nvPr>
        </p:nvSpPr>
        <p:spPr>
          <a:xfrm>
            <a:off x="1069560" y="13984200"/>
            <a:ext cx="4992840" cy="803520"/>
          </a:xfrm>
          <a:prstGeom prst="rect">
            <a:avLst/>
          </a:prstGeom>
          <a:noFill/>
          <a:ln w="0">
            <a:noFill/>
          </a:ln>
        </p:spPr>
        <p:txBody>
          <a:bodyPr lIns="149040" rIns="149040" tIns="74520" bIns="74520" anchor="ctr">
            <a:noAutofit/>
          </a:bodyPr>
          <a:lstStyle>
            <a:lvl1pPr indent="0">
              <a:lnSpc>
                <a:spcPct val="100000"/>
              </a:lnSpc>
              <a:buNone/>
              <a:tabLst>
                <a:tab algn="l" pos="0"/>
                <a:tab algn="l" pos="1487520"/>
                <a:tab algn="l" pos="2975040"/>
                <a:tab algn="l" pos="4462560"/>
                <a:tab algn="l" pos="5950080"/>
                <a:tab algn="l" pos="7437600"/>
                <a:tab algn="l" pos="8924760"/>
                <a:tab algn="l" pos="10412280"/>
              </a:tabLst>
              <a:defRPr b="0" lang="en-GB" sz="2000" spc="-1" strike="noStrike">
                <a:solidFill>
                  <a:srgbClr val="898989"/>
                </a:solidFill>
                <a:latin typeface="Calibri"/>
              </a:defRPr>
            </a:lvl1pPr>
          </a:lstStyle>
          <a:p>
            <a:pPr indent="0">
              <a:lnSpc>
                <a:spcPct val="100000"/>
              </a:lnSpc>
              <a:buNone/>
              <a:tabLst>
                <a:tab algn="l" pos="0"/>
                <a:tab algn="l" pos="1487520"/>
                <a:tab algn="l" pos="2975040"/>
                <a:tab algn="l" pos="4462560"/>
                <a:tab algn="l" pos="5950080"/>
                <a:tab algn="l" pos="7437600"/>
                <a:tab algn="l" pos="8924760"/>
                <a:tab algn="l" pos="10412280"/>
              </a:tabLst>
            </a:pPr>
            <a:fld id="{71EC76DC-8CF9-4AFB-B8BC-EC54058713C7}" type="datetime">
              <a:rPr b="0" lang="en-GB" sz="2000" spc="-1" strike="noStrike">
                <a:solidFill>
                  <a:srgbClr val="898989"/>
                </a:solidFill>
                <a:latin typeface="Calibri"/>
              </a:rPr>
              <a:t>29/08/26</a:t>
            </a:fld>
            <a:endParaRPr b="0" lang="en-US" sz="2000" spc="-1" strike="noStrike">
              <a:solidFill>
                <a:srgbClr val="000000"/>
              </a:solidFill>
              <a:latin typeface="Arial"/>
            </a:endParaRPr>
          </a:p>
        </p:txBody>
      </p:sp>
      <p:sp>
        <p:nvSpPr>
          <p:cNvPr id="3" name="PlaceHolder 4"/>
          <p:cNvSpPr>
            <a:spLocks noGrp="1"/>
          </p:cNvSpPr>
          <p:nvPr>
            <p:ph type="ftr" idx="2"/>
          </p:nvPr>
        </p:nvSpPr>
        <p:spPr>
          <a:xfrm>
            <a:off x="7310520" y="13984200"/>
            <a:ext cx="6775200" cy="803520"/>
          </a:xfrm>
          <a:prstGeom prst="rect">
            <a:avLst/>
          </a:prstGeom>
          <a:noFill/>
          <a:ln w="0">
            <a:noFill/>
          </a:ln>
        </p:spPr>
        <p:txBody>
          <a:bodyPr lIns="149040" rIns="149040" tIns="74520" bIns="74520" anchor="ctr">
            <a:noAutofit/>
          </a:bodyPr>
          <a:p>
            <a:pPr indent="0">
              <a:buNone/>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 name="PlaceHolder 5"/>
          <p:cNvSpPr>
            <a:spLocks noGrp="1"/>
          </p:cNvSpPr>
          <p:nvPr>
            <p:ph type="sldNum" idx="3"/>
          </p:nvPr>
        </p:nvSpPr>
        <p:spPr>
          <a:xfrm>
            <a:off x="15333840" y="13984200"/>
            <a:ext cx="4992480" cy="803520"/>
          </a:xfrm>
          <a:prstGeom prst="rect">
            <a:avLst/>
          </a:prstGeom>
          <a:noFill/>
          <a:ln w="0">
            <a:noFill/>
          </a:ln>
        </p:spPr>
        <p:txBody>
          <a:bodyPr lIns="149040" rIns="149040" tIns="74520" bIns="74520" anchor="ctr">
            <a:noAutofit/>
          </a:bodyPr>
          <a:lstStyle>
            <a:lvl1pPr indent="0" algn="r">
              <a:lnSpc>
                <a:spcPct val="100000"/>
              </a:lnSpc>
              <a:buNone/>
              <a:tabLst>
                <a:tab algn="l" pos="0"/>
                <a:tab algn="l" pos="1487520"/>
                <a:tab algn="l" pos="2975040"/>
                <a:tab algn="l" pos="4462560"/>
                <a:tab algn="l" pos="5950080"/>
                <a:tab algn="l" pos="7437600"/>
                <a:tab algn="l" pos="8924760"/>
                <a:tab algn="l" pos="10412280"/>
              </a:tabLst>
              <a:defRPr b="0" lang="en-GB" sz="2000" spc="-1" strike="noStrike">
                <a:solidFill>
                  <a:srgbClr val="898989"/>
                </a:solidFill>
                <a:latin typeface="Calibri"/>
              </a:defRPr>
            </a:lvl1pPr>
          </a:lstStyle>
          <a:p>
            <a:pPr indent="0" algn="r">
              <a:lnSpc>
                <a:spcPct val="100000"/>
              </a:lnSpc>
              <a:buNone/>
              <a:tabLst>
                <a:tab algn="l" pos="0"/>
                <a:tab algn="l" pos="1487520"/>
                <a:tab algn="l" pos="2975040"/>
                <a:tab algn="l" pos="4462560"/>
                <a:tab algn="l" pos="5950080"/>
                <a:tab algn="l" pos="7437600"/>
                <a:tab algn="l" pos="8924760"/>
                <a:tab algn="l" pos="10412280"/>
              </a:tabLst>
            </a:pPr>
            <a:fld id="{CD9DEB68-B0D3-4C71-BD2C-6415E5C2BA53}" type="slidenum">
              <a:rPr b="0" lang="en-GB" sz="2000" spc="-1" strike="noStrike">
                <a:solidFill>
                  <a:srgbClr val="898989"/>
                </a:solidFill>
                <a:latin typeface="Calibri"/>
              </a:rPr>
              <a:t>&lt;number&gt;</a:t>
            </a:fld>
            <a:endParaRPr b="0" lang="en-US" sz="20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image" Target="../media/image3.png"/><Relationship Id="rId3" Type="http://schemas.openxmlformats.org/officeDocument/2006/relationships/image" Target="../media/image4.png"/><Relationship Id="rId4" Type="http://schemas.openxmlformats.org/officeDocument/2006/relationships/image" Target="../media/image5.png"/><Relationship Id="rId5" Type="http://schemas.openxmlformats.org/officeDocument/2006/relationships/image" Target="../media/image6.png"/><Relationship Id="rId6" Type="http://schemas.openxmlformats.org/officeDocument/2006/relationships/image" Target="../media/image7.png"/><Relationship Id="rId7" Type="http://schemas.openxmlformats.org/officeDocument/2006/relationships/image" Target="../media/image8.png"/><Relationship Id="rId8" Type="http://schemas.openxmlformats.org/officeDocument/2006/relationships/image" Target="../media/image9.png"/><Relationship Id="rId9" Type="http://schemas.openxmlformats.org/officeDocument/2006/relationships/image" Target="../media/image10.png"/><Relationship Id="rId10" Type="http://schemas.openxmlformats.org/officeDocument/2006/relationships/image" Target="../media/image11.png"/><Relationship Id="rId11" Type="http://schemas.openxmlformats.org/officeDocument/2006/relationships/image" Target="../media/image12.png"/><Relationship Id="rId12" Type="http://schemas.openxmlformats.org/officeDocument/2006/relationships/image" Target="../media/image13.png"/><Relationship Id="rId13" Type="http://schemas.openxmlformats.org/officeDocument/2006/relationships/image" Target="../media/image14.png"/><Relationship Id="rId14" Type="http://schemas.openxmlformats.org/officeDocument/2006/relationships/image" Target="../media/image15.png"/><Relationship Id="rId15" Type="http://schemas.openxmlformats.org/officeDocument/2006/relationships/image" Target="../media/image16.png"/><Relationship Id="rId16" Type="http://schemas.openxmlformats.org/officeDocument/2006/relationships/image" Target="../media/image2.png"/><Relationship Id="rId17" Type="http://schemas.openxmlformats.org/officeDocument/2006/relationships/image" Target="../media/image4.png"/><Relationship Id="rId18" Type="http://schemas.openxmlformats.org/officeDocument/2006/relationships/image" Target="../media/image6.png"/><Relationship Id="rId19" Type="http://schemas.openxmlformats.org/officeDocument/2006/relationships/image" Target="../media/image8.png"/><Relationship Id="rId20" Type="http://schemas.openxmlformats.org/officeDocument/2006/relationships/image" Target="../media/image10.png"/><Relationship Id="rId21" Type="http://schemas.openxmlformats.org/officeDocument/2006/relationships/image" Target="../media/image12.png"/><Relationship Id="rId22" Type="http://schemas.openxmlformats.org/officeDocument/2006/relationships/image" Target="../media/image17.png"/><Relationship Id="rId23" Type="http://schemas.openxmlformats.org/officeDocument/2006/relationships/image" Target="../media/image18.png"/><Relationship Id="rId24" Type="http://schemas.openxmlformats.org/officeDocument/2006/relationships/image" Target="../media/image19.png"/><Relationship Id="rId25" Type="http://schemas.openxmlformats.org/officeDocument/2006/relationships/image" Target="../media/image20.png"/><Relationship Id="rId26" Type="http://schemas.openxmlformats.org/officeDocument/2006/relationships/image" Target="../media/image21.png"/><Relationship Id="rId27" Type="http://schemas.openxmlformats.org/officeDocument/2006/relationships/image" Target="../media/image22.png"/><Relationship Id="rId28" Type="http://schemas.openxmlformats.org/officeDocument/2006/relationships/image" Target="../media/image23.png"/><Relationship Id="rId29" Type="http://schemas.openxmlformats.org/officeDocument/2006/relationships/image" Target="../media/image24.png"/><Relationship Id="rId30" Type="http://schemas.openxmlformats.org/officeDocument/2006/relationships/image" Target="../media/image25.png"/><Relationship Id="rId31" Type="http://schemas.openxmlformats.org/officeDocument/2006/relationships/image" Target="../media/image26.png"/><Relationship Id="rId32" Type="http://schemas.openxmlformats.org/officeDocument/2006/relationships/image" Target="../media/image2.png"/><Relationship Id="rId33" Type="http://schemas.openxmlformats.org/officeDocument/2006/relationships/image" Target="../media/image3.png"/><Relationship Id="rId34" Type="http://schemas.openxmlformats.org/officeDocument/2006/relationships/image" Target="../media/image4.png"/><Relationship Id="rId35" Type="http://schemas.openxmlformats.org/officeDocument/2006/relationships/image" Target="../media/image5.png"/><Relationship Id="rId36" Type="http://schemas.openxmlformats.org/officeDocument/2006/relationships/image" Target="../media/image6.png"/><Relationship Id="rId37" Type="http://schemas.openxmlformats.org/officeDocument/2006/relationships/image" Target="../media/image7.png"/><Relationship Id="rId38" Type="http://schemas.openxmlformats.org/officeDocument/2006/relationships/image" Target="../media/image8.png"/><Relationship Id="rId39" Type="http://schemas.openxmlformats.org/officeDocument/2006/relationships/image" Target="../media/image9.png"/><Relationship Id="rId40" Type="http://schemas.openxmlformats.org/officeDocument/2006/relationships/image" Target="../media/image10.png"/><Relationship Id="rId41" Type="http://schemas.openxmlformats.org/officeDocument/2006/relationships/image" Target="../media/image11.png"/><Relationship Id="rId42" Type="http://schemas.openxmlformats.org/officeDocument/2006/relationships/image" Target="../media/image12.png"/><Relationship Id="rId43" Type="http://schemas.openxmlformats.org/officeDocument/2006/relationships/image" Target="../media/image27.png"/><Relationship Id="rId44" Type="http://schemas.openxmlformats.org/officeDocument/2006/relationships/image" Target="../media/image13.png"/><Relationship Id="rId45" Type="http://schemas.openxmlformats.org/officeDocument/2006/relationships/image" Target="../media/image14.png"/><Relationship Id="rId46" Type="http://schemas.openxmlformats.org/officeDocument/2006/relationships/image" Target="../media/image15.png"/><Relationship Id="rId47" Type="http://schemas.openxmlformats.org/officeDocument/2006/relationships/image" Target="../media/image16.png"/><Relationship Id="rId48" Type="http://schemas.openxmlformats.org/officeDocument/2006/relationships/image" Target="../media/image2.png"/><Relationship Id="rId49" Type="http://schemas.openxmlformats.org/officeDocument/2006/relationships/image" Target="../media/image4.png"/><Relationship Id="rId50" Type="http://schemas.openxmlformats.org/officeDocument/2006/relationships/image" Target="../media/image28.png"/><Relationship Id="rId51" Type="http://schemas.openxmlformats.org/officeDocument/2006/relationships/image" Target="../media/image29.png"/><Relationship Id="rId52" Type="http://schemas.openxmlformats.org/officeDocument/2006/relationships/image" Target="../media/image2.png"/><Relationship Id="rId53" Type="http://schemas.openxmlformats.org/officeDocument/2006/relationships/image" Target="../media/image3.png"/><Relationship Id="rId54" Type="http://schemas.openxmlformats.org/officeDocument/2006/relationships/image" Target="../media/image4.png"/><Relationship Id="rId55" Type="http://schemas.openxmlformats.org/officeDocument/2006/relationships/image" Target="../media/image5.png"/><Relationship Id="rId56" Type="http://schemas.openxmlformats.org/officeDocument/2006/relationships/image" Target="../media/image6.png"/><Relationship Id="rId57" Type="http://schemas.openxmlformats.org/officeDocument/2006/relationships/image" Target="../media/image7.png"/><Relationship Id="rId58" Type="http://schemas.openxmlformats.org/officeDocument/2006/relationships/image" Target="../media/image8.png"/><Relationship Id="rId59" Type="http://schemas.openxmlformats.org/officeDocument/2006/relationships/image" Target="../media/image9.png"/><Relationship Id="rId60" Type="http://schemas.openxmlformats.org/officeDocument/2006/relationships/image" Target="../media/image10.png"/><Relationship Id="rId61" Type="http://schemas.openxmlformats.org/officeDocument/2006/relationships/image" Target="../media/image11.png"/><Relationship Id="rId62" Type="http://schemas.openxmlformats.org/officeDocument/2006/relationships/image" Target="../media/image30.png"/><Relationship Id="rId63" Type="http://schemas.openxmlformats.org/officeDocument/2006/relationships/image" Target="../media/image31.png"/><Relationship Id="rId64" Type="http://schemas.openxmlformats.org/officeDocument/2006/relationships/image" Target="../media/image32.png"/><Relationship Id="rId65" Type="http://schemas.openxmlformats.org/officeDocument/2006/relationships/image" Target="../media/image33.png"/><Relationship Id="rId66" Type="http://schemas.openxmlformats.org/officeDocument/2006/relationships/image" Target="../media/image34.png"/><Relationship Id="rId67" Type="http://schemas.openxmlformats.org/officeDocument/2006/relationships/image" Target="../media/image35.png"/><Relationship Id="rId68" Type="http://schemas.openxmlformats.org/officeDocument/2006/relationships/image" Target="../media/image36.png"/><Relationship Id="rId69" Type="http://schemas.openxmlformats.org/officeDocument/2006/relationships/image" Target="../media/image37.png"/><Relationship Id="rId70" Type="http://schemas.openxmlformats.org/officeDocument/2006/relationships/image" Target="../media/image38.png"/><Relationship Id="rId71" Type="http://schemas.openxmlformats.org/officeDocument/2006/relationships/image" Target="../media/image39.png"/><Relationship Id="rId72" Type="http://schemas.openxmlformats.org/officeDocument/2006/relationships/image" Target="../media/image40.png"/><Relationship Id="rId73" Type="http://schemas.openxmlformats.org/officeDocument/2006/relationships/image" Target="../media/image41.png"/><Relationship Id="rId74" Type="http://schemas.openxmlformats.org/officeDocument/2006/relationships/image" Target="../media/image42.png"/><Relationship Id="rId75" Type="http://schemas.openxmlformats.org/officeDocument/2006/relationships/image" Target="../media/image20.png"/><Relationship Id="rId76" Type="http://schemas.openxmlformats.org/officeDocument/2006/relationships/image" Target="../media/image22.png"/><Relationship Id="rId77" Type="http://schemas.openxmlformats.org/officeDocument/2006/relationships/image" Target="../media/image24.png"/><Relationship Id="rId78" Type="http://schemas.openxmlformats.org/officeDocument/2006/relationships/image" Target="../media/image26.png"/><Relationship Id="rId79" Type="http://schemas.openxmlformats.org/officeDocument/2006/relationships/image" Target="../media/image43.png"/><Relationship Id="rId80" Type="http://schemas.openxmlformats.org/officeDocument/2006/relationships/image" Target="../media/image44.png"/><Relationship Id="rId81" Type="http://schemas.openxmlformats.org/officeDocument/2006/relationships/image" Target="../media/image45.png"/><Relationship Id="rId82" Type="http://schemas.openxmlformats.org/officeDocument/2006/relationships/image" Target="../media/image46.png"/><Relationship Id="rId83" Type="http://schemas.openxmlformats.org/officeDocument/2006/relationships/image" Target="../media/image47.png"/><Relationship Id="rId84" Type="http://schemas.openxmlformats.org/officeDocument/2006/relationships/image" Target="../media/image48.png"/><Relationship Id="rId85" Type="http://schemas.openxmlformats.org/officeDocument/2006/relationships/image" Target="../media/image49.png"/><Relationship Id="rId86" Type="http://schemas.openxmlformats.org/officeDocument/2006/relationships/image" Target="../media/image46.png"/><Relationship Id="rId87" Type="http://schemas.openxmlformats.org/officeDocument/2006/relationships/image" Target="../media/image50.png"/><Relationship Id="rId88" Type="http://schemas.openxmlformats.org/officeDocument/2006/relationships/image" Target="../media/image51.png"/><Relationship Id="rId89" Type="http://schemas.openxmlformats.org/officeDocument/2006/relationships/image" Target="../media/image52.png"/><Relationship Id="rId90" Type="http://schemas.openxmlformats.org/officeDocument/2006/relationships/image" Target="../media/image53.png"/><Relationship Id="rId91" Type="http://schemas.openxmlformats.org/officeDocument/2006/relationships/image" Target="../media/image13.png"/><Relationship Id="rId9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54.png"/><Relationship Id="rId2" Type="http://schemas.openxmlformats.org/officeDocument/2006/relationships/image" Target="../media/image55.png"/><Relationship Id="rId3" Type="http://schemas.openxmlformats.org/officeDocument/2006/relationships/image" Target="../media/image55.png"/><Relationship Id="rId4" Type="http://schemas.openxmlformats.org/officeDocument/2006/relationships/image" Target="../media/image56.png"/><Relationship Id="rId5" Type="http://schemas.openxmlformats.org/officeDocument/2006/relationships/image" Target="../media/image55.png"/><Relationship Id="rId6" Type="http://schemas.openxmlformats.org/officeDocument/2006/relationships/image" Target="../media/image55.png"/><Relationship Id="rId7" Type="http://schemas.openxmlformats.org/officeDocument/2006/relationships/image" Target="../media/image57.png"/><Relationship Id="rId8" Type="http://schemas.openxmlformats.org/officeDocument/2006/relationships/image" Target="../media/image58.png"/><Relationship Id="rId9" Type="http://schemas.openxmlformats.org/officeDocument/2006/relationships/image" Target="../media/image59.png"/><Relationship Id="rId10" Type="http://schemas.openxmlformats.org/officeDocument/2006/relationships/image" Target="../media/image60.png"/><Relationship Id="rId11" Type="http://schemas.openxmlformats.org/officeDocument/2006/relationships/image" Target="../media/image61.png"/><Relationship Id="rId12" Type="http://schemas.openxmlformats.org/officeDocument/2006/relationships/image" Target="../media/image62.png"/><Relationship Id="rId13" Type="http://schemas.openxmlformats.org/officeDocument/2006/relationships/image" Target="../media/image63.png"/><Relationship Id="rId14" Type="http://schemas.openxmlformats.org/officeDocument/2006/relationships/image" Target="../media/image55.png"/><Relationship Id="rId15" Type="http://schemas.openxmlformats.org/officeDocument/2006/relationships/image" Target="../media/image55.png"/><Relationship Id="rId16" Type="http://schemas.openxmlformats.org/officeDocument/2006/relationships/image" Target="../media/image64.png"/><Relationship Id="rId17" Type="http://schemas.openxmlformats.org/officeDocument/2006/relationships/image" Target="../media/image55.png"/><Relationship Id="rId18" Type="http://schemas.openxmlformats.org/officeDocument/2006/relationships/image" Target="../media/image65.png"/><Relationship Id="rId19" Type="http://schemas.openxmlformats.org/officeDocument/2006/relationships/image" Target="../media/image57.png"/><Relationship Id="rId20" Type="http://schemas.openxmlformats.org/officeDocument/2006/relationships/image" Target="../media/image66.png"/><Relationship Id="rId21" Type="http://schemas.openxmlformats.org/officeDocument/2006/relationships/image" Target="../media/image59.png"/><Relationship Id="rId22" Type="http://schemas.openxmlformats.org/officeDocument/2006/relationships/image" Target="../media/image62.png"/><Relationship Id="rId23" Type="http://schemas.openxmlformats.org/officeDocument/2006/relationships/image" Target="../media/image61.png"/><Relationship Id="rId24" Type="http://schemas.openxmlformats.org/officeDocument/2006/relationships/image" Target="../media/image62.png"/><Relationship Id="rId25"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文本框 3591"/>
          <p:cNvSpPr/>
          <p:nvPr/>
        </p:nvSpPr>
        <p:spPr>
          <a:xfrm>
            <a:off x="1120680" y="343080"/>
            <a:ext cx="2152800" cy="55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1487520"/>
                <a:tab algn="l" pos="2975040"/>
                <a:tab algn="l" pos="4462560"/>
                <a:tab algn="l" pos="5950080"/>
                <a:tab algn="l" pos="7437600"/>
                <a:tab algn="l" pos="8924760"/>
                <a:tab algn="l" pos="10412280"/>
              </a:tabLst>
            </a:pPr>
            <a:r>
              <a:rPr b="1" lang="en-US" sz="3000" spc="-1" strike="noStrike">
                <a:solidFill>
                  <a:srgbClr val="000000"/>
                </a:solidFill>
                <a:latin typeface="Times New Roman"/>
              </a:rPr>
              <a:t>Fig.S1</a:t>
            </a:r>
            <a:endParaRPr b="0" lang="en-US" sz="3000" spc="-1" strike="noStrike">
              <a:solidFill>
                <a:srgbClr val="000000"/>
              </a:solidFill>
              <a:latin typeface="Arial"/>
            </a:endParaRPr>
          </a:p>
        </p:txBody>
      </p:sp>
      <p:sp>
        <p:nvSpPr>
          <p:cNvPr id="42" name="文本框 24"/>
          <p:cNvSpPr/>
          <p:nvPr/>
        </p:nvSpPr>
        <p:spPr>
          <a:xfrm>
            <a:off x="3281400" y="12296880"/>
            <a:ext cx="10698120" cy="155628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1487520"/>
                <a:tab algn="l" pos="2975040"/>
                <a:tab algn="l" pos="4462560"/>
                <a:tab algn="l" pos="5950080"/>
                <a:tab algn="l" pos="7437600"/>
                <a:tab algn="l" pos="8924760"/>
                <a:tab algn="l" pos="10412280"/>
              </a:tabLst>
            </a:pPr>
            <a:r>
              <a:rPr b="1" lang="en-US" sz="3200" spc="-1" strike="noStrike">
                <a:solidFill>
                  <a:srgbClr val="000000"/>
                </a:solidFill>
                <a:latin typeface="Times New Roman"/>
              </a:rPr>
              <a:t>Figure S1</a:t>
            </a:r>
            <a:r>
              <a:rPr b="0" lang="en-US" sz="3200" spc="-1" strike="noStrike">
                <a:solidFill>
                  <a:srgbClr val="000000"/>
                </a:solidFill>
                <a:latin typeface="Times New Roman"/>
              </a:rPr>
              <a:t>. Workflow of the study. </a:t>
            </a:r>
            <a:endParaRPr b="0" lang="en-US" sz="3200" spc="-1" strike="noStrike">
              <a:solidFill>
                <a:srgbClr val="000000"/>
              </a:solidFill>
              <a:latin typeface="Arial"/>
            </a:endParaRPr>
          </a:p>
          <a:p>
            <a:pPr algn="just">
              <a:lnSpc>
                <a:spcPct val="150000"/>
              </a:lnSpc>
              <a:tabLst>
                <a:tab algn="l" pos="0"/>
                <a:tab algn="l" pos="1487520"/>
                <a:tab algn="l" pos="2975040"/>
                <a:tab algn="l" pos="4462560"/>
                <a:tab algn="l" pos="5950080"/>
                <a:tab algn="l" pos="7437600"/>
                <a:tab algn="l" pos="8924760"/>
                <a:tab algn="l" pos="10412280"/>
              </a:tabLst>
            </a:pPr>
            <a:r>
              <a:rPr b="0" lang="en-US" sz="3200" spc="-1" strike="noStrike">
                <a:solidFill>
                  <a:srgbClr val="000000"/>
                </a:solidFill>
                <a:latin typeface="Times New Roman"/>
              </a:rPr>
              <a:t>ROC: Receiving operator characteristic curve.</a:t>
            </a:r>
            <a:endParaRPr b="0" lang="en-US" sz="3200" spc="-1" strike="noStrike">
              <a:solidFill>
                <a:srgbClr val="000000"/>
              </a:solidFill>
              <a:latin typeface="Arial"/>
            </a:endParaRPr>
          </a:p>
        </p:txBody>
      </p:sp>
      <p:grpSp>
        <p:nvGrpSpPr>
          <p:cNvPr id="43" name="组合 1"/>
          <p:cNvGrpSpPr/>
          <p:nvPr/>
        </p:nvGrpSpPr>
        <p:grpSpPr>
          <a:xfrm>
            <a:off x="1552680" y="1279440"/>
            <a:ext cx="19226160" cy="10010880"/>
            <a:chOff x="1552680" y="1279440"/>
            <a:chExt cx="19226160" cy="10010880"/>
          </a:xfrm>
        </p:grpSpPr>
        <p:sp>
          <p:nvSpPr>
            <p:cNvPr id="44" name="文本框 3"/>
            <p:cNvSpPr/>
            <p:nvPr/>
          </p:nvSpPr>
          <p:spPr>
            <a:xfrm>
              <a:off x="7809480" y="1279440"/>
              <a:ext cx="3608280" cy="550800"/>
            </a:xfrm>
            <a:prstGeom prst="rect">
              <a:avLst/>
            </a:prstGeom>
            <a:noFill/>
            <a:ln w="25560">
              <a:solidFill>
                <a:srgbClr val="000000"/>
              </a:solidFill>
              <a:miter/>
            </a:ln>
          </p:spPr>
          <p:style>
            <a:lnRef idx="0"/>
            <a:fillRef idx="0"/>
            <a:effectRef idx="0"/>
            <a:fontRef idx="minor"/>
          </p:style>
          <p:txBody>
            <a:bodyPr lIns="90000" rIns="90000" tIns="46800" bIns="46800" anchor="t">
              <a:spAutoFit/>
            </a:bodyPr>
            <a:p>
              <a:pPr algn="ctr">
                <a:lnSpc>
                  <a:spcPct val="100000"/>
                </a:lnSpc>
                <a:tabLst>
                  <a:tab algn="l" pos="0"/>
                  <a:tab algn="l" pos="1487520"/>
                  <a:tab algn="l" pos="2975040"/>
                  <a:tab algn="l" pos="4462560"/>
                  <a:tab algn="l" pos="5950080"/>
                  <a:tab algn="l" pos="7437600"/>
                  <a:tab algn="l" pos="8924760"/>
                  <a:tab algn="l" pos="10412280"/>
                </a:tabLst>
              </a:pPr>
              <a:r>
                <a:rPr b="0" lang="en-US" sz="3000" spc="-1" strike="noStrike">
                  <a:solidFill>
                    <a:srgbClr val="000000"/>
                  </a:solidFill>
                  <a:latin typeface="Times New Roman"/>
                </a:rPr>
                <a:t>Raw data (n = 852)</a:t>
              </a:r>
              <a:endParaRPr b="0" lang="en-US" sz="3000" spc="-1" strike="noStrike">
                <a:solidFill>
                  <a:srgbClr val="000000"/>
                </a:solidFill>
                <a:latin typeface="Arial"/>
              </a:endParaRPr>
            </a:p>
          </p:txBody>
        </p:sp>
        <p:cxnSp>
          <p:nvCxnSpPr>
            <p:cNvPr id="45" name="直接箭头连接符 5"/>
            <p:cNvCxnSpPr/>
            <p:nvPr/>
          </p:nvCxnSpPr>
          <p:spPr>
            <a:xfrm>
              <a:off x="9507240" y="1848960"/>
              <a:ext cx="1080" cy="1864440"/>
            </a:xfrm>
            <a:prstGeom prst="straightConnector1">
              <a:avLst/>
            </a:prstGeom>
            <a:ln w="25560">
              <a:solidFill>
                <a:srgbClr val="000000"/>
              </a:solidFill>
              <a:round/>
            </a:ln>
          </p:spPr>
        </p:cxnSp>
        <p:sp>
          <p:nvSpPr>
            <p:cNvPr id="46" name="文本框 6"/>
            <p:cNvSpPr/>
            <p:nvPr/>
          </p:nvSpPr>
          <p:spPr>
            <a:xfrm>
              <a:off x="9768600" y="2214360"/>
              <a:ext cx="4197960" cy="1251360"/>
            </a:xfrm>
            <a:prstGeom prst="rect">
              <a:avLst/>
            </a:prstGeom>
            <a:solidFill>
              <a:srgbClr val="ebf1de"/>
            </a:solidFill>
            <a:ln cap="rnd" w="9360">
              <a:solidFill>
                <a:srgbClr val="000000"/>
              </a:solidFill>
              <a:round/>
            </a:ln>
          </p:spPr>
          <p:style>
            <a:lnRef idx="0"/>
            <a:fillRef idx="0"/>
            <a:effectRef idx="0"/>
            <a:fontRef idx="minor"/>
          </p:style>
          <p:txBody>
            <a:bodyPr wrap="none" lIns="90000" rIns="90000" tIns="46800" bIns="46800" anchor="t">
              <a:spAutoFit/>
            </a:bodyPr>
            <a:p>
              <a:pPr>
                <a:lnSpc>
                  <a:spcPct val="100000"/>
                </a:lnSpc>
                <a:tabLst>
                  <a:tab algn="l" pos="0"/>
                  <a:tab algn="l" pos="1488960"/>
                  <a:tab algn="l" pos="2978280"/>
                  <a:tab algn="l" pos="4467240"/>
                  <a:tab algn="l" pos="5956200"/>
                  <a:tab algn="l" pos="7445520"/>
                  <a:tab algn="l" pos="8934480"/>
                  <a:tab algn="l" pos="10423440"/>
                </a:tabLst>
              </a:pPr>
              <a:r>
                <a:rPr b="1" lang="en-US" sz="2000" spc="-1" strike="noStrike">
                  <a:solidFill>
                    <a:srgbClr val="000000"/>
                  </a:solidFill>
                  <a:latin typeface="Times New Roman"/>
                  <a:ea typeface="宋体"/>
                </a:rPr>
                <a:t>Random stratified sampling</a:t>
              </a:r>
              <a:endParaRPr b="0" lang="en-US" sz="2000" spc="-1" strike="noStrike">
                <a:solidFill>
                  <a:srgbClr val="000000"/>
                </a:solidFill>
                <a:latin typeface="Arial"/>
              </a:endParaRPr>
            </a:p>
            <a:p>
              <a:pPr>
                <a:lnSpc>
                  <a:spcPct val="100000"/>
                </a:lnSpc>
                <a:tabLst>
                  <a:tab algn="l" pos="0"/>
                  <a:tab algn="l" pos="1488960"/>
                  <a:tab algn="l" pos="2978280"/>
                  <a:tab algn="l" pos="4467240"/>
                  <a:tab algn="l" pos="5956200"/>
                  <a:tab algn="l" pos="7445520"/>
                  <a:tab algn="l" pos="8934480"/>
                  <a:tab algn="l" pos="10423440"/>
                </a:tabLst>
              </a:pPr>
              <a:r>
                <a:rPr b="0" i="1" lang="en-US" sz="1400" spc="-1" strike="noStrike">
                  <a:solidFill>
                    <a:srgbClr val="000000"/>
                  </a:solidFill>
                  <a:latin typeface="Times New Roman"/>
                  <a:ea typeface="宋体"/>
                </a:rPr>
                <a:t>Stratified sampling by Binary dependent variable</a:t>
              </a:r>
              <a:endParaRPr b="0" lang="en-US" sz="1400" spc="-1" strike="noStrike">
                <a:solidFill>
                  <a:srgbClr val="000000"/>
                </a:solidFill>
                <a:latin typeface="Arial"/>
              </a:endParaRPr>
            </a:p>
            <a:p>
              <a:pPr>
                <a:lnSpc>
                  <a:spcPct val="100000"/>
                </a:lnSpc>
                <a:tabLst>
                  <a:tab algn="l" pos="0"/>
                  <a:tab algn="l" pos="1488960"/>
                  <a:tab algn="l" pos="2978280"/>
                  <a:tab algn="l" pos="4467240"/>
                  <a:tab algn="l" pos="5956200"/>
                  <a:tab algn="l" pos="7445520"/>
                  <a:tab algn="l" pos="8934480"/>
                  <a:tab algn="l" pos="10423440"/>
                </a:tabLst>
              </a:pPr>
              <a:r>
                <a:rPr b="0" i="1" lang="en-US" sz="1400" spc="-1" strike="noStrike">
                  <a:solidFill>
                    <a:srgbClr val="000000"/>
                  </a:solidFill>
                  <a:latin typeface="Times New Roman"/>
                  <a:ea typeface="宋体"/>
                </a:rPr>
                <a:t>Metastasis or not, Lymph Node Metastasis or not</a:t>
              </a:r>
              <a:endParaRPr b="0" lang="en-US" sz="1400" spc="-1" strike="noStrike">
                <a:solidFill>
                  <a:srgbClr val="000000"/>
                </a:solidFill>
                <a:latin typeface="Arial"/>
              </a:endParaRPr>
            </a:p>
            <a:p>
              <a:pPr>
                <a:lnSpc>
                  <a:spcPct val="100000"/>
                </a:lnSpc>
                <a:tabLst>
                  <a:tab algn="l" pos="0"/>
                  <a:tab algn="l" pos="1488960"/>
                  <a:tab algn="l" pos="2978280"/>
                  <a:tab algn="l" pos="4467240"/>
                  <a:tab algn="l" pos="5956200"/>
                  <a:tab algn="l" pos="7445520"/>
                  <a:tab algn="l" pos="8934480"/>
                  <a:tab algn="l" pos="10423440"/>
                </a:tabLst>
              </a:pPr>
              <a:r>
                <a:rPr b="0" i="1" lang="en-US" sz="1400" spc="-1" strike="noStrike">
                  <a:solidFill>
                    <a:srgbClr val="000000"/>
                  </a:solidFill>
                  <a:latin typeface="Times New Roman"/>
                  <a:ea typeface="宋体"/>
                </a:rPr>
                <a:t>srawor (simple random sampling without replacement))</a:t>
              </a:r>
              <a:endParaRPr b="0" lang="en-US" sz="1400" spc="-1" strike="noStrike">
                <a:solidFill>
                  <a:srgbClr val="000000"/>
                </a:solidFill>
                <a:latin typeface="Arial"/>
              </a:endParaRPr>
            </a:p>
            <a:p>
              <a:pPr>
                <a:lnSpc>
                  <a:spcPct val="100000"/>
                </a:lnSpc>
                <a:tabLst>
                  <a:tab algn="l" pos="0"/>
                  <a:tab algn="l" pos="1488960"/>
                  <a:tab algn="l" pos="2978280"/>
                  <a:tab algn="l" pos="4467240"/>
                  <a:tab algn="l" pos="5956200"/>
                  <a:tab algn="l" pos="7445520"/>
                  <a:tab algn="l" pos="8934480"/>
                  <a:tab algn="l" pos="10423440"/>
                </a:tabLst>
              </a:pPr>
              <a:r>
                <a:rPr b="0" i="1" lang="en-US" sz="1400" spc="-1" strike="noStrike">
                  <a:solidFill>
                    <a:srgbClr val="000000"/>
                  </a:solidFill>
                  <a:latin typeface="Times New Roman"/>
                  <a:ea typeface="宋体"/>
                </a:rPr>
                <a:t>70% in primary cohort, 30% in the internal test cohort</a:t>
              </a:r>
              <a:endParaRPr b="0" lang="en-US" sz="1400" spc="-1" strike="noStrike">
                <a:solidFill>
                  <a:srgbClr val="000000"/>
                </a:solidFill>
                <a:latin typeface="Arial"/>
              </a:endParaRPr>
            </a:p>
          </p:txBody>
        </p:sp>
        <p:sp>
          <p:nvSpPr>
            <p:cNvPr id="47" name="直接连接符 11"/>
            <p:cNvSpPr/>
            <p:nvPr/>
          </p:nvSpPr>
          <p:spPr>
            <a:xfrm>
              <a:off x="4857840" y="3713040"/>
              <a:ext cx="9299520" cy="0"/>
            </a:xfrm>
            <a:prstGeom prst="line">
              <a:avLst/>
            </a:prstGeom>
            <a:ln w="25560">
              <a:solidFill>
                <a:srgbClr val="000000"/>
              </a:solidFill>
              <a:round/>
            </a:ln>
          </p:spPr>
          <p:style>
            <a:lnRef idx="0"/>
            <a:fillRef idx="0"/>
            <a:effectRef idx="0"/>
            <a:fontRef idx="minor"/>
          </p:style>
          <p:txBody>
            <a:bodyPr lIns="90000" rIns="90000" tIns="-46800" bIns="-46800" anchor="t">
              <a:noAutofit/>
            </a:bodyPr>
            <a:p>
              <a:endParaRPr b="0" lang="en-US" sz="3000" spc="-1" strike="noStrike">
                <a:solidFill>
                  <a:srgbClr val="000000"/>
                </a:solidFill>
                <a:latin typeface="Arial"/>
              </a:endParaRPr>
            </a:p>
          </p:txBody>
        </p:sp>
        <p:cxnSp>
          <p:nvCxnSpPr>
            <p:cNvPr id="48" name="直接箭头连接符 13"/>
            <p:cNvCxnSpPr/>
            <p:nvPr/>
          </p:nvCxnSpPr>
          <p:spPr>
            <a:xfrm>
              <a:off x="4857480" y="3713040"/>
              <a:ext cx="1080" cy="1023120"/>
            </a:xfrm>
            <a:prstGeom prst="straightConnector1">
              <a:avLst/>
            </a:prstGeom>
            <a:ln w="25560">
              <a:solidFill>
                <a:srgbClr val="000000"/>
              </a:solidFill>
              <a:round/>
              <a:tailEnd len="med" type="triangle" w="med"/>
            </a:ln>
          </p:spPr>
        </p:cxnSp>
        <p:sp>
          <p:nvSpPr>
            <p:cNvPr id="49" name="文本框 16"/>
            <p:cNvSpPr/>
            <p:nvPr/>
          </p:nvSpPr>
          <p:spPr>
            <a:xfrm>
              <a:off x="2100960" y="4717440"/>
              <a:ext cx="5511960" cy="520560"/>
            </a:xfrm>
            <a:prstGeom prst="rect">
              <a:avLst/>
            </a:prstGeom>
            <a:noFill/>
            <a:ln w="25560">
              <a:solidFill>
                <a:srgbClr val="000000"/>
              </a:solidFill>
              <a:miter/>
            </a:ln>
          </p:spPr>
          <p:style>
            <a:lnRef idx="0"/>
            <a:fillRef idx="0"/>
            <a:effectRef idx="0"/>
            <a:fontRef idx="minor"/>
          </p:style>
          <p:txBody>
            <a:bodyPr wrap="none" lIns="90000" rIns="90000" tIns="46800" bIns="46800" anchor="t">
              <a:spAutoFit/>
            </a:bodyPr>
            <a:p>
              <a:pPr algn="ctr">
                <a:lnSpc>
                  <a:spcPct val="100000"/>
                </a:lnSpc>
                <a:tabLst>
                  <a:tab algn="l" pos="0"/>
                  <a:tab algn="l" pos="1487520"/>
                  <a:tab algn="l" pos="2975040"/>
                  <a:tab algn="l" pos="4462560"/>
                  <a:tab algn="l" pos="5950080"/>
                  <a:tab algn="l" pos="7437600"/>
                  <a:tab algn="l" pos="8924760"/>
                  <a:tab algn="l" pos="10412280"/>
                </a:tabLst>
              </a:pPr>
              <a:r>
                <a:rPr b="0" lang="en-US" sz="2800" spc="-1" strike="noStrike">
                  <a:solidFill>
                    <a:srgbClr val="000000"/>
                  </a:solidFill>
                  <a:latin typeface="Times New Roman"/>
                </a:rPr>
                <a:t>Primary Cohort (n=471) </a:t>
              </a:r>
              <a:r>
                <a:rPr b="0" lang="en-US" sz="1400" spc="-1" strike="noStrike">
                  <a:solidFill>
                    <a:srgbClr val="000000"/>
                  </a:solidFill>
                  <a:latin typeface="Times New Roman"/>
                </a:rPr>
                <a:t>Dazhou Central Hospital</a:t>
              </a:r>
              <a:endParaRPr b="0" lang="en-US" sz="1400" spc="-1" strike="noStrike">
                <a:solidFill>
                  <a:srgbClr val="000000"/>
                </a:solidFill>
                <a:latin typeface="Arial"/>
              </a:endParaRPr>
            </a:p>
          </p:txBody>
        </p:sp>
        <p:sp>
          <p:nvSpPr>
            <p:cNvPr id="50" name="文本框 22"/>
            <p:cNvSpPr/>
            <p:nvPr/>
          </p:nvSpPr>
          <p:spPr>
            <a:xfrm>
              <a:off x="5082840" y="5578560"/>
              <a:ext cx="6228000" cy="1038240"/>
            </a:xfrm>
            <a:prstGeom prst="rect">
              <a:avLst/>
            </a:prstGeom>
            <a:solidFill>
              <a:srgbClr val="e6e0ec"/>
            </a:solidFill>
            <a:ln cap="rnd" w="9360">
              <a:solidFill>
                <a:srgbClr val="000000"/>
              </a:solidFill>
              <a:round/>
            </a:ln>
          </p:spPr>
          <p:style>
            <a:lnRef idx="0"/>
            <a:fillRef idx="0"/>
            <a:effectRef idx="0"/>
            <a:fontRef idx="minor"/>
          </p:style>
          <p:txBody>
            <a:bodyPr wrap="none" lIns="90000" rIns="90000" tIns="46800" bIns="46800" anchor="t">
              <a:spAutoFit/>
            </a:bodyPr>
            <a:p>
              <a:pPr>
                <a:lnSpc>
                  <a:spcPct val="100000"/>
                </a:lnSpc>
                <a:tabLst>
                  <a:tab algn="l" pos="0"/>
                  <a:tab algn="l" pos="1488960"/>
                  <a:tab algn="l" pos="2978280"/>
                  <a:tab algn="l" pos="4467240"/>
                  <a:tab algn="l" pos="5956200"/>
                  <a:tab algn="l" pos="7445520"/>
                  <a:tab algn="l" pos="8934480"/>
                  <a:tab algn="l" pos="10423440"/>
                </a:tabLst>
              </a:pPr>
              <a:r>
                <a:rPr b="1" lang="en-US" sz="2000" spc="-1" strike="noStrike">
                  <a:solidFill>
                    <a:srgbClr val="000000"/>
                  </a:solidFill>
                  <a:latin typeface="Times New Roman"/>
                  <a:ea typeface="宋体"/>
                </a:rPr>
                <a:t>Random stratified sampling  10 times by different seeds</a:t>
              </a:r>
              <a:endParaRPr b="0" lang="en-US" sz="2000" spc="-1" strike="noStrike">
                <a:solidFill>
                  <a:srgbClr val="000000"/>
                </a:solidFill>
                <a:latin typeface="Arial"/>
              </a:endParaRPr>
            </a:p>
            <a:p>
              <a:pPr>
                <a:lnSpc>
                  <a:spcPct val="100000"/>
                </a:lnSpc>
                <a:tabLst>
                  <a:tab algn="l" pos="0"/>
                  <a:tab algn="l" pos="1488960"/>
                  <a:tab algn="l" pos="2978280"/>
                  <a:tab algn="l" pos="4467240"/>
                  <a:tab algn="l" pos="5956200"/>
                  <a:tab algn="l" pos="7445520"/>
                  <a:tab algn="l" pos="8934480"/>
                  <a:tab algn="l" pos="10423440"/>
                </a:tabLst>
              </a:pPr>
              <a:r>
                <a:rPr b="0" i="1" lang="en-US" sz="1400" spc="-1" strike="noStrike">
                  <a:solidFill>
                    <a:srgbClr val="000000"/>
                  </a:solidFill>
                  <a:latin typeface="Times New Roman"/>
                  <a:ea typeface="宋体"/>
                </a:rPr>
                <a:t>Stratified sampling by Binary dependent variable</a:t>
              </a:r>
              <a:endParaRPr b="0" lang="en-US" sz="1400" spc="-1" strike="noStrike">
                <a:solidFill>
                  <a:srgbClr val="000000"/>
                </a:solidFill>
                <a:latin typeface="Arial"/>
              </a:endParaRPr>
            </a:p>
            <a:p>
              <a:pPr>
                <a:lnSpc>
                  <a:spcPct val="100000"/>
                </a:lnSpc>
                <a:tabLst>
                  <a:tab algn="l" pos="0"/>
                  <a:tab algn="l" pos="1488960"/>
                  <a:tab algn="l" pos="2978280"/>
                  <a:tab algn="l" pos="4467240"/>
                  <a:tab algn="l" pos="5956200"/>
                  <a:tab algn="l" pos="7445520"/>
                  <a:tab algn="l" pos="8934480"/>
                  <a:tab algn="l" pos="10423440"/>
                </a:tabLst>
              </a:pPr>
              <a:r>
                <a:rPr b="0" i="1" lang="en-US" sz="1400" spc="-1" strike="noStrike">
                  <a:solidFill>
                    <a:srgbClr val="000000"/>
                  </a:solidFill>
                  <a:latin typeface="Times New Roman"/>
                  <a:ea typeface="宋体"/>
                </a:rPr>
                <a:t>Metastasis or not, Lymph Node Metastasis or not</a:t>
              </a:r>
              <a:endParaRPr b="0" lang="en-US" sz="1400" spc="-1" strike="noStrike">
                <a:solidFill>
                  <a:srgbClr val="000000"/>
                </a:solidFill>
                <a:latin typeface="Arial"/>
              </a:endParaRPr>
            </a:p>
            <a:p>
              <a:pPr>
                <a:lnSpc>
                  <a:spcPct val="100000"/>
                </a:lnSpc>
                <a:tabLst>
                  <a:tab algn="l" pos="0"/>
                  <a:tab algn="l" pos="1488960"/>
                  <a:tab algn="l" pos="2978280"/>
                  <a:tab algn="l" pos="4467240"/>
                  <a:tab algn="l" pos="5956200"/>
                  <a:tab algn="l" pos="7445520"/>
                  <a:tab algn="l" pos="8934480"/>
                  <a:tab algn="l" pos="10423440"/>
                </a:tabLst>
              </a:pPr>
              <a:r>
                <a:rPr b="0" i="1" lang="en-US" sz="1400" spc="-1" strike="noStrike">
                  <a:solidFill>
                    <a:srgbClr val="000000"/>
                  </a:solidFill>
                  <a:latin typeface="Times New Roman"/>
                  <a:ea typeface="宋体"/>
                </a:rPr>
                <a:t>srawor (simple random sampling without replacement))</a:t>
              </a:r>
              <a:endParaRPr b="0" lang="en-US" sz="1400" spc="-1" strike="noStrike">
                <a:solidFill>
                  <a:srgbClr val="000000"/>
                </a:solidFill>
                <a:latin typeface="Arial"/>
              </a:endParaRPr>
            </a:p>
          </p:txBody>
        </p:sp>
        <p:cxnSp>
          <p:nvCxnSpPr>
            <p:cNvPr id="51" name="直接箭头连接符 23"/>
            <p:cNvCxnSpPr/>
            <p:nvPr/>
          </p:nvCxnSpPr>
          <p:spPr>
            <a:xfrm>
              <a:off x="14157000" y="3712680"/>
              <a:ext cx="1080" cy="2780280"/>
            </a:xfrm>
            <a:prstGeom prst="straightConnector1">
              <a:avLst/>
            </a:prstGeom>
            <a:ln w="25560">
              <a:solidFill>
                <a:srgbClr val="000000"/>
              </a:solidFill>
              <a:round/>
              <a:tailEnd len="med" type="triangle" w="med"/>
            </a:ln>
          </p:spPr>
        </p:cxnSp>
        <p:sp>
          <p:nvSpPr>
            <p:cNvPr id="52" name="文本框 24"/>
            <p:cNvSpPr/>
            <p:nvPr/>
          </p:nvSpPr>
          <p:spPr>
            <a:xfrm>
              <a:off x="12066120" y="6475680"/>
              <a:ext cx="4104000" cy="1016640"/>
            </a:xfrm>
            <a:prstGeom prst="rect">
              <a:avLst/>
            </a:prstGeom>
            <a:noFill/>
            <a:ln w="25560">
              <a:solidFill>
                <a:srgbClr val="000000"/>
              </a:solidFill>
              <a:miter/>
            </a:ln>
          </p:spPr>
          <p:style>
            <a:lnRef idx="0"/>
            <a:fillRef idx="0"/>
            <a:effectRef idx="0"/>
            <a:fontRef idx="minor"/>
          </p:style>
          <p:txBody>
            <a:bodyPr wrap="none" lIns="90000" rIns="90000" tIns="46800" bIns="46800" anchor="t">
              <a:noAutofit/>
            </a:bodyPr>
            <a:p>
              <a:pPr algn="ctr">
                <a:lnSpc>
                  <a:spcPct val="100000"/>
                </a:lnSpc>
                <a:tabLst>
                  <a:tab algn="l" pos="0"/>
                  <a:tab algn="l" pos="1487520"/>
                  <a:tab algn="l" pos="2975040"/>
                  <a:tab algn="l" pos="4462560"/>
                  <a:tab algn="l" pos="5950080"/>
                  <a:tab algn="l" pos="7437600"/>
                  <a:tab algn="l" pos="8924760"/>
                  <a:tab algn="l" pos="10412280"/>
                </a:tabLst>
              </a:pPr>
              <a:r>
                <a:rPr b="0" lang="en-US" sz="2800" spc="-1" strike="noStrike">
                  <a:solidFill>
                    <a:srgbClr val="000000"/>
                  </a:solidFill>
                  <a:latin typeface="Times New Roman"/>
                </a:rPr>
                <a:t>Internal Test Cohort</a:t>
              </a:r>
              <a:endParaRPr b="0" lang="en-US" sz="2800" spc="-1" strike="noStrike">
                <a:solidFill>
                  <a:srgbClr val="000000"/>
                </a:solidFill>
                <a:latin typeface="Arial"/>
              </a:endParaRPr>
            </a:p>
            <a:p>
              <a:pPr algn="ctr">
                <a:lnSpc>
                  <a:spcPct val="100000"/>
                </a:lnSpc>
                <a:tabLst>
                  <a:tab algn="l" pos="0"/>
                  <a:tab algn="l" pos="1487520"/>
                  <a:tab algn="l" pos="2975040"/>
                  <a:tab algn="l" pos="4462560"/>
                  <a:tab algn="l" pos="5950080"/>
                  <a:tab algn="l" pos="7437600"/>
                  <a:tab algn="l" pos="8924760"/>
                  <a:tab algn="l" pos="10412280"/>
                </a:tabLst>
              </a:pPr>
              <a:r>
                <a:rPr b="0" lang="en-US" sz="2800" spc="-1" strike="noStrike">
                  <a:solidFill>
                    <a:srgbClr val="000000"/>
                  </a:solidFill>
                  <a:latin typeface="Times New Roman"/>
                </a:rPr>
                <a:t> </a:t>
              </a:r>
              <a:r>
                <a:rPr b="0" lang="en-US" sz="2800" spc="-1" strike="noStrike">
                  <a:solidFill>
                    <a:srgbClr val="000000"/>
                  </a:solidFill>
                  <a:latin typeface="Times New Roman"/>
                </a:rPr>
                <a:t>(n=203) </a:t>
              </a:r>
              <a:r>
                <a:rPr b="0" lang="en-US" sz="1400" spc="-1" strike="noStrike">
                  <a:solidFill>
                    <a:srgbClr val="000000"/>
                  </a:solidFill>
                  <a:latin typeface="Times New Roman"/>
                </a:rPr>
                <a:t>Dazhou Central Hospital</a:t>
              </a:r>
              <a:endParaRPr b="0" lang="en-US" sz="1400" spc="-1" strike="noStrike">
                <a:solidFill>
                  <a:srgbClr val="000000"/>
                </a:solidFill>
                <a:latin typeface="Arial"/>
              </a:endParaRPr>
            </a:p>
          </p:txBody>
        </p:sp>
        <p:sp>
          <p:nvSpPr>
            <p:cNvPr id="53" name="文本框 26"/>
            <p:cNvSpPr/>
            <p:nvPr/>
          </p:nvSpPr>
          <p:spPr>
            <a:xfrm>
              <a:off x="5204880" y="7062840"/>
              <a:ext cx="4572720" cy="398880"/>
            </a:xfrm>
            <a:prstGeom prst="rect">
              <a:avLst/>
            </a:prstGeom>
            <a:solidFill>
              <a:srgbClr val="e6e0ec"/>
            </a:solidFill>
            <a:ln w="9360">
              <a:solidFill>
                <a:srgbClr val="000000"/>
              </a:solidFill>
              <a:round/>
            </a:ln>
          </p:spPr>
          <p:style>
            <a:lnRef idx="0"/>
            <a:fillRef idx="0"/>
            <a:effectRef idx="0"/>
            <a:fontRef idx="minor"/>
          </p:style>
          <p:txBody>
            <a:bodyPr wrap="none" lIns="90000" rIns="90000" tIns="46800" bIns="46800" anchor="t">
              <a:spAutoFit/>
            </a:bodyPr>
            <a:p>
              <a:pPr>
                <a:lnSpc>
                  <a:spcPct val="100000"/>
                </a:lnSpc>
                <a:tabLst>
                  <a:tab algn="l" pos="0"/>
                  <a:tab algn="l" pos="1488960"/>
                  <a:tab algn="l" pos="2978280"/>
                  <a:tab algn="l" pos="4467240"/>
                  <a:tab algn="l" pos="5956200"/>
                  <a:tab algn="l" pos="7445520"/>
                  <a:tab algn="l" pos="8934480"/>
                  <a:tab algn="l" pos="10423440"/>
                </a:tabLst>
              </a:pPr>
              <a:r>
                <a:rPr b="0" lang="en-US" sz="2000" spc="-1" strike="noStrike">
                  <a:solidFill>
                    <a:srgbClr val="000000"/>
                  </a:solidFill>
                  <a:latin typeface="Times New Roman"/>
                  <a:ea typeface="宋体"/>
                </a:rPr>
                <a:t>10 folds Lasso regression in each sampling</a:t>
              </a:r>
              <a:endParaRPr b="0" lang="en-US" sz="2000" spc="-1" strike="noStrike">
                <a:solidFill>
                  <a:srgbClr val="000000"/>
                </a:solidFill>
                <a:latin typeface="Arial"/>
              </a:endParaRPr>
            </a:p>
          </p:txBody>
        </p:sp>
        <p:sp>
          <p:nvSpPr>
            <p:cNvPr id="54" name="文本框 29"/>
            <p:cNvSpPr/>
            <p:nvPr/>
          </p:nvSpPr>
          <p:spPr>
            <a:xfrm>
              <a:off x="1552680" y="7995960"/>
              <a:ext cx="7560360" cy="1191240"/>
            </a:xfrm>
            <a:prstGeom prst="rect">
              <a:avLst/>
            </a:prstGeom>
            <a:noFill/>
            <a:ln w="25560">
              <a:solidFill>
                <a:srgbClr val="000000"/>
              </a:solidFill>
              <a:miter/>
            </a:ln>
          </p:spPr>
          <p:style>
            <a:lnRef idx="0"/>
            <a:fillRef idx="0"/>
            <a:effectRef idx="0"/>
            <a:fontRef idx="minor"/>
          </p:style>
          <p:txBody>
            <a:bodyPr lIns="90000" rIns="90000" tIns="46800" bIns="46800" anchor="t">
              <a:spAutoFit/>
            </a:bodyPr>
            <a:p>
              <a:pPr>
                <a:lnSpc>
                  <a:spcPct val="100000"/>
                </a:lnSpc>
                <a:tabLst>
                  <a:tab algn="l" pos="0"/>
                  <a:tab algn="l" pos="1487520"/>
                  <a:tab algn="l" pos="2975040"/>
                  <a:tab algn="l" pos="4462560"/>
                  <a:tab algn="l" pos="5950080"/>
                  <a:tab algn="l" pos="7437600"/>
                  <a:tab algn="l" pos="8924760"/>
                  <a:tab algn="l" pos="10412280"/>
                </a:tabLst>
              </a:pPr>
              <a:r>
                <a:rPr b="0" lang="en-US" sz="3200" spc="-1" strike="noStrike">
                  <a:solidFill>
                    <a:srgbClr val="000000"/>
                  </a:solidFill>
                  <a:latin typeface="Times New Roman"/>
                </a:rPr>
                <a:t>Variables selected</a:t>
              </a:r>
              <a:endParaRPr b="0" lang="en-US" sz="3200" spc="-1" strike="noStrike">
                <a:solidFill>
                  <a:srgbClr val="000000"/>
                </a:solidFill>
                <a:latin typeface="Arial"/>
              </a:endParaRPr>
            </a:p>
            <a:p>
              <a:pPr>
                <a:lnSpc>
                  <a:spcPct val="100000"/>
                </a:lnSpc>
                <a:tabLst>
                  <a:tab algn="l" pos="0"/>
                  <a:tab algn="l" pos="1487520"/>
                  <a:tab algn="l" pos="2975040"/>
                  <a:tab algn="l" pos="4462560"/>
                  <a:tab algn="l" pos="5950080"/>
                  <a:tab algn="l" pos="7437600"/>
                  <a:tab algn="l" pos="8924760"/>
                  <a:tab algn="l" pos="10412280"/>
                </a:tabLst>
              </a:pPr>
              <a:r>
                <a:rPr b="0" i="1" lang="en-US" sz="2000" spc="-1" strike="noStrike">
                  <a:solidFill>
                    <a:srgbClr val="000000"/>
                  </a:solidFill>
                  <a:latin typeface="Times New Roman"/>
                </a:rPr>
                <a:t>By using the minimum criteria (Min) and the 1 standard error of the minimum criteria (1SE)</a:t>
              </a:r>
              <a:endParaRPr b="0" lang="en-US" sz="2000" spc="-1" strike="noStrike">
                <a:solidFill>
                  <a:srgbClr val="000000"/>
                </a:solidFill>
                <a:latin typeface="Arial"/>
              </a:endParaRPr>
            </a:p>
          </p:txBody>
        </p:sp>
        <p:sp>
          <p:nvSpPr>
            <p:cNvPr id="55" name="文本框 41"/>
            <p:cNvSpPr/>
            <p:nvPr/>
          </p:nvSpPr>
          <p:spPr>
            <a:xfrm>
              <a:off x="12376800" y="9519840"/>
              <a:ext cx="3585240" cy="1770480"/>
            </a:xfrm>
            <a:prstGeom prst="rect">
              <a:avLst/>
            </a:prstGeom>
            <a:noFill/>
            <a:ln w="25560">
              <a:solidFill>
                <a:srgbClr val="000000"/>
              </a:solidFill>
              <a:miter/>
            </a:ln>
          </p:spPr>
          <p:style>
            <a:lnRef idx="0"/>
            <a:fillRef idx="0"/>
            <a:effectRef idx="0"/>
            <a:fontRef idx="minor"/>
          </p:style>
          <p:txBody>
            <a:bodyPr wrap="none" lIns="90000" rIns="90000" tIns="46800" bIns="46800" anchor="t">
              <a:spAutoFit/>
            </a:bodyPr>
            <a:p>
              <a:pPr algn="ctr">
                <a:lnSpc>
                  <a:spcPct val="100000"/>
                </a:lnSpc>
                <a:tabLst>
                  <a:tab algn="l" pos="0"/>
                  <a:tab algn="l" pos="1487520"/>
                  <a:tab algn="l" pos="2975040"/>
                  <a:tab algn="l" pos="4462560"/>
                  <a:tab algn="l" pos="5950080"/>
                  <a:tab algn="l" pos="7437600"/>
                  <a:tab algn="l" pos="8924760"/>
                  <a:tab algn="l" pos="10412280"/>
                </a:tabLst>
              </a:pPr>
              <a:r>
                <a:rPr b="0" lang="en-US" sz="3000" spc="-1" strike="noStrike">
                  <a:solidFill>
                    <a:srgbClr val="000000"/>
                  </a:solidFill>
                  <a:latin typeface="Times New Roman"/>
                </a:rPr>
                <a:t>Evaluation the models</a:t>
              </a:r>
              <a:endParaRPr b="0" lang="en-US" sz="3000" spc="-1" strike="noStrike">
                <a:solidFill>
                  <a:srgbClr val="000000"/>
                </a:solidFill>
                <a:latin typeface="Arial"/>
              </a:endParaRPr>
            </a:p>
            <a:p>
              <a:pPr algn="ctr">
                <a:lnSpc>
                  <a:spcPct val="100000"/>
                </a:lnSpc>
                <a:tabLst>
                  <a:tab algn="l" pos="0"/>
                  <a:tab algn="l" pos="1487520"/>
                  <a:tab algn="l" pos="2975040"/>
                  <a:tab algn="l" pos="4462560"/>
                  <a:tab algn="l" pos="5950080"/>
                  <a:tab algn="l" pos="7437600"/>
                  <a:tab algn="l" pos="8924760"/>
                  <a:tab algn="l" pos="10412280"/>
                </a:tabLst>
              </a:pPr>
              <a:r>
                <a:rPr b="0" i="1" lang="en-US" sz="2000" spc="-1" strike="noStrike">
                  <a:solidFill>
                    <a:srgbClr val="000000"/>
                  </a:solidFill>
                  <a:latin typeface="Times New Roman"/>
                </a:rPr>
                <a:t>ROC</a:t>
              </a:r>
              <a:endParaRPr b="0" lang="en-US" sz="2000" spc="-1" strike="noStrike">
                <a:solidFill>
                  <a:srgbClr val="000000"/>
                </a:solidFill>
                <a:latin typeface="Arial"/>
              </a:endParaRPr>
            </a:p>
            <a:p>
              <a:pPr algn="ctr">
                <a:lnSpc>
                  <a:spcPct val="100000"/>
                </a:lnSpc>
                <a:tabLst>
                  <a:tab algn="l" pos="0"/>
                  <a:tab algn="l" pos="1487520"/>
                  <a:tab algn="l" pos="2975040"/>
                  <a:tab algn="l" pos="4462560"/>
                  <a:tab algn="l" pos="5950080"/>
                  <a:tab algn="l" pos="7437600"/>
                  <a:tab algn="l" pos="8924760"/>
                  <a:tab algn="l" pos="10412280"/>
                </a:tabLst>
              </a:pPr>
              <a:r>
                <a:rPr b="0" i="1" lang="en-US" sz="2000" spc="-1" strike="noStrike">
                  <a:solidFill>
                    <a:srgbClr val="000000"/>
                  </a:solidFill>
                  <a:latin typeface="Times New Roman"/>
                </a:rPr>
                <a:t>Nomogram</a:t>
              </a:r>
              <a:endParaRPr b="0" lang="en-US" sz="2000" spc="-1" strike="noStrike">
                <a:solidFill>
                  <a:srgbClr val="000000"/>
                </a:solidFill>
                <a:latin typeface="Arial"/>
              </a:endParaRPr>
            </a:p>
            <a:p>
              <a:pPr algn="ctr">
                <a:lnSpc>
                  <a:spcPct val="100000"/>
                </a:lnSpc>
                <a:tabLst>
                  <a:tab algn="l" pos="0"/>
                  <a:tab algn="l" pos="1487520"/>
                  <a:tab algn="l" pos="2975040"/>
                  <a:tab algn="l" pos="4462560"/>
                  <a:tab algn="l" pos="5950080"/>
                  <a:tab algn="l" pos="7437600"/>
                  <a:tab algn="l" pos="8924760"/>
                  <a:tab algn="l" pos="10412280"/>
                </a:tabLst>
              </a:pPr>
              <a:r>
                <a:rPr b="0" i="1" lang="en-US" sz="2000" spc="-1" strike="noStrike">
                  <a:solidFill>
                    <a:srgbClr val="000000"/>
                  </a:solidFill>
                  <a:latin typeface="Times New Roman"/>
                </a:rPr>
                <a:t>GiViTI calibration belt</a:t>
              </a:r>
              <a:endParaRPr b="0" lang="en-US" sz="2000" spc="-1" strike="noStrike">
                <a:solidFill>
                  <a:srgbClr val="000000"/>
                </a:solidFill>
                <a:latin typeface="Arial"/>
              </a:endParaRPr>
            </a:p>
            <a:p>
              <a:pPr algn="ctr">
                <a:lnSpc>
                  <a:spcPct val="100000"/>
                </a:lnSpc>
                <a:tabLst>
                  <a:tab algn="l" pos="0"/>
                  <a:tab algn="l" pos="1487520"/>
                  <a:tab algn="l" pos="2975040"/>
                  <a:tab algn="l" pos="4462560"/>
                  <a:tab algn="l" pos="5950080"/>
                  <a:tab algn="l" pos="7437600"/>
                  <a:tab algn="l" pos="8924760"/>
                  <a:tab algn="l" pos="10412280"/>
                </a:tabLst>
              </a:pPr>
              <a:r>
                <a:rPr b="0" i="1" lang="en-US" sz="2000" spc="-1" strike="noStrike">
                  <a:solidFill>
                    <a:srgbClr val="000000"/>
                  </a:solidFill>
                  <a:latin typeface="Times New Roman"/>
                </a:rPr>
                <a:t>Decision curve</a:t>
              </a:r>
              <a:endParaRPr b="0" lang="en-US" sz="2000" spc="-1" strike="noStrike">
                <a:solidFill>
                  <a:srgbClr val="000000"/>
                </a:solidFill>
                <a:latin typeface="Arial"/>
              </a:endParaRPr>
            </a:p>
          </p:txBody>
        </p:sp>
        <p:sp>
          <p:nvSpPr>
            <p:cNvPr id="56" name="文本框 24"/>
            <p:cNvSpPr/>
            <p:nvPr/>
          </p:nvSpPr>
          <p:spPr>
            <a:xfrm>
              <a:off x="16557480" y="6477840"/>
              <a:ext cx="4221360" cy="1016640"/>
            </a:xfrm>
            <a:prstGeom prst="rect">
              <a:avLst/>
            </a:prstGeom>
            <a:noFill/>
            <a:ln w="25560">
              <a:solidFill>
                <a:srgbClr val="000000"/>
              </a:solidFill>
              <a:miter/>
            </a:ln>
          </p:spPr>
          <p:style>
            <a:lnRef idx="0"/>
            <a:fillRef idx="0"/>
            <a:effectRef idx="0"/>
            <a:fontRef idx="minor"/>
          </p:style>
          <p:txBody>
            <a:bodyPr wrap="none" lIns="90000" rIns="90000" tIns="46800" bIns="46800" anchor="t">
              <a:noAutofit/>
            </a:bodyPr>
            <a:p>
              <a:pPr>
                <a:lnSpc>
                  <a:spcPct val="100000"/>
                </a:lnSpc>
                <a:tabLst>
                  <a:tab algn="l" pos="0"/>
                  <a:tab algn="l" pos="1487520"/>
                  <a:tab algn="l" pos="2975040"/>
                  <a:tab algn="l" pos="4462560"/>
                  <a:tab algn="l" pos="5950080"/>
                  <a:tab algn="l" pos="7437600"/>
                  <a:tab algn="l" pos="8924760"/>
                  <a:tab algn="l" pos="10412280"/>
                </a:tabLst>
              </a:pPr>
              <a:r>
                <a:rPr b="0" lang="en-US" sz="2800" spc="-1" strike="noStrike">
                  <a:solidFill>
                    <a:srgbClr val="000000"/>
                  </a:solidFill>
                  <a:latin typeface="Times New Roman"/>
                </a:rPr>
                <a:t>External Test Cohort </a:t>
              </a:r>
              <a:endParaRPr b="0" lang="en-US" sz="2800" spc="-1" strike="noStrike">
                <a:solidFill>
                  <a:srgbClr val="000000"/>
                </a:solidFill>
                <a:latin typeface="Arial"/>
              </a:endParaRPr>
            </a:p>
            <a:p>
              <a:pPr>
                <a:lnSpc>
                  <a:spcPct val="100000"/>
                </a:lnSpc>
                <a:tabLst>
                  <a:tab algn="l" pos="0"/>
                  <a:tab algn="l" pos="1487520"/>
                  <a:tab algn="l" pos="2975040"/>
                  <a:tab algn="l" pos="4462560"/>
                  <a:tab algn="l" pos="5950080"/>
                  <a:tab algn="l" pos="7437600"/>
                  <a:tab algn="l" pos="8924760"/>
                  <a:tab algn="l" pos="10412280"/>
                </a:tabLst>
              </a:pPr>
              <a:r>
                <a:rPr b="0" lang="en-US" sz="2800" spc="-1" strike="noStrike">
                  <a:solidFill>
                    <a:srgbClr val="000000"/>
                  </a:solidFill>
                  <a:latin typeface="Times New Roman"/>
                </a:rPr>
                <a:t>(n=178) </a:t>
              </a:r>
              <a:r>
                <a:rPr b="0" lang="en-US" sz="1400" spc="-1" strike="noStrike">
                  <a:solidFill>
                    <a:srgbClr val="000000"/>
                  </a:solidFill>
                  <a:latin typeface="Times New Roman"/>
                </a:rPr>
                <a:t>West China Hospital</a:t>
              </a:r>
              <a:endParaRPr b="0" lang="en-US" sz="1400" spc="-1" strike="noStrike">
                <a:solidFill>
                  <a:srgbClr val="000000"/>
                </a:solidFill>
                <a:latin typeface="Arial"/>
              </a:endParaRPr>
            </a:p>
            <a:p>
              <a:pPr>
                <a:lnSpc>
                  <a:spcPct val="100000"/>
                </a:lnSpc>
                <a:tabLst>
                  <a:tab algn="l" pos="0"/>
                  <a:tab algn="l" pos="1487520"/>
                  <a:tab algn="l" pos="2975040"/>
                  <a:tab algn="l" pos="4462560"/>
                  <a:tab algn="l" pos="5950080"/>
                  <a:tab algn="l" pos="7437600"/>
                  <a:tab algn="l" pos="8924760"/>
                  <a:tab algn="l" pos="10412280"/>
                </a:tabLst>
              </a:pPr>
              <a:endParaRPr b="0" lang="en-US" sz="1400" spc="-1" strike="noStrike">
                <a:solidFill>
                  <a:srgbClr val="000000"/>
                </a:solidFill>
                <a:latin typeface="Arial"/>
              </a:endParaRPr>
            </a:p>
          </p:txBody>
        </p:sp>
        <p:sp>
          <p:nvSpPr>
            <p:cNvPr id="57" name="直接连接符 10"/>
            <p:cNvSpPr/>
            <p:nvPr/>
          </p:nvSpPr>
          <p:spPr>
            <a:xfrm>
              <a:off x="18604080" y="7515360"/>
              <a:ext cx="0" cy="1117440"/>
            </a:xfrm>
            <a:prstGeom prst="line">
              <a:avLst/>
            </a:prstGeom>
            <a:ln w="28440">
              <a:solidFill>
                <a:srgbClr val="000000"/>
              </a:solidFill>
              <a:round/>
            </a:ln>
          </p:spPr>
          <p:style>
            <a:lnRef idx="0"/>
            <a:fillRef idx="0"/>
            <a:effectRef idx="0"/>
            <a:fontRef idx="minor"/>
          </p:style>
          <p:txBody>
            <a:bodyPr lIns="90000" rIns="90000" tIns="46800" bIns="46800" anchor="t">
              <a:noAutofit/>
            </a:bodyPr>
            <a:p>
              <a:endParaRPr b="0" lang="en-US" sz="3000" spc="-1" strike="noStrike">
                <a:solidFill>
                  <a:srgbClr val="000000"/>
                </a:solidFill>
                <a:latin typeface="Arial"/>
              </a:endParaRPr>
            </a:p>
          </p:txBody>
        </p:sp>
        <p:cxnSp>
          <p:nvCxnSpPr>
            <p:cNvPr id="58" name="直接箭头连接符 34"/>
            <p:cNvCxnSpPr/>
            <p:nvPr/>
          </p:nvCxnSpPr>
          <p:spPr>
            <a:xfrm>
              <a:off x="14117400" y="7507080"/>
              <a:ext cx="1080" cy="1981800"/>
            </a:xfrm>
            <a:prstGeom prst="straightConnector1">
              <a:avLst/>
            </a:prstGeom>
            <a:ln w="25560">
              <a:solidFill>
                <a:srgbClr val="000000"/>
              </a:solidFill>
              <a:round/>
              <a:tailEnd len="med" type="triangle" w="med"/>
            </a:ln>
          </p:spPr>
        </p:cxnSp>
      </p:grpSp>
      <p:sp>
        <p:nvSpPr>
          <p:cNvPr id="59" name="直接连接符 21"/>
          <p:cNvSpPr/>
          <p:nvPr/>
        </p:nvSpPr>
        <p:spPr>
          <a:xfrm>
            <a:off x="9113760" y="8623440"/>
            <a:ext cx="9506160" cy="0"/>
          </a:xfrm>
          <a:prstGeom prst="line">
            <a:avLst/>
          </a:prstGeom>
          <a:ln w="25560">
            <a:solidFill>
              <a:srgbClr val="000000"/>
            </a:solidFill>
            <a:round/>
          </a:ln>
        </p:spPr>
        <p:style>
          <a:lnRef idx="0"/>
          <a:fillRef idx="0"/>
          <a:effectRef idx="0"/>
          <a:fontRef idx="minor"/>
        </p:style>
        <p:txBody>
          <a:bodyPr lIns="90000" rIns="90000" tIns="-46800" bIns="-46800" anchor="t">
            <a:noAutofit/>
          </a:bodyPr>
          <a:p>
            <a:endParaRPr b="0" lang="en-US" sz="3000" spc="-1" strike="noStrike">
              <a:solidFill>
                <a:srgbClr val="000000"/>
              </a:solidFill>
              <a:latin typeface="Arial"/>
            </a:endParaRPr>
          </a:p>
        </p:txBody>
      </p:sp>
      <p:cxnSp>
        <p:nvCxnSpPr>
          <p:cNvPr id="60" name="直接箭头连接符 25"/>
          <p:cNvCxnSpPr/>
          <p:nvPr/>
        </p:nvCxnSpPr>
        <p:spPr>
          <a:xfrm>
            <a:off x="4865400" y="5240160"/>
            <a:ext cx="1080" cy="2736000"/>
          </a:xfrm>
          <a:prstGeom prst="straightConnector1">
            <a:avLst/>
          </a:prstGeom>
          <a:ln w="25560">
            <a:solidFill>
              <a:srgbClr val="000000"/>
            </a:solidFill>
            <a:round/>
            <a:tailEnd len="med" type="triangle" w="med"/>
          </a:ln>
        </p:spPr>
      </p:cxn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1" name="文本框 616"/>
          <p:cNvSpPr/>
          <p:nvPr/>
        </p:nvSpPr>
        <p:spPr>
          <a:xfrm>
            <a:off x="1913040" y="1639800"/>
            <a:ext cx="2152440" cy="55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1487520"/>
                <a:tab algn="l" pos="2975040"/>
                <a:tab algn="l" pos="4462560"/>
                <a:tab algn="l" pos="5950080"/>
                <a:tab algn="l" pos="7437600"/>
                <a:tab algn="l" pos="8924760"/>
                <a:tab algn="l" pos="10412280"/>
              </a:tabLst>
            </a:pPr>
            <a:r>
              <a:rPr b="1" lang="en-US" sz="3000" spc="-1" strike="noStrike">
                <a:solidFill>
                  <a:srgbClr val="000000"/>
                </a:solidFill>
                <a:latin typeface="Times New Roman"/>
              </a:rPr>
              <a:t>Fig.S2</a:t>
            </a:r>
            <a:endParaRPr b="0" lang="en-US" sz="3000" spc="-1" strike="noStrike">
              <a:solidFill>
                <a:srgbClr val="000000"/>
              </a:solidFill>
              <a:latin typeface="Arial"/>
            </a:endParaRPr>
          </a:p>
        </p:txBody>
      </p:sp>
      <p:grpSp>
        <p:nvGrpSpPr>
          <p:cNvPr id="62" name="组合 3"/>
          <p:cNvGrpSpPr/>
          <p:nvPr/>
        </p:nvGrpSpPr>
        <p:grpSpPr>
          <a:xfrm>
            <a:off x="11063160" y="3297240"/>
            <a:ext cx="6959880" cy="6662880"/>
            <a:chOff x="11063160" y="3297240"/>
            <a:chExt cx="6959880" cy="6662880"/>
          </a:xfrm>
        </p:grpSpPr>
        <p:sp>
          <p:nvSpPr>
            <p:cNvPr id="63" name="tx4"/>
            <p:cNvSpPr/>
            <p:nvPr/>
          </p:nvSpPr>
          <p:spPr>
            <a:xfrm>
              <a:off x="11683080" y="4461120"/>
              <a:ext cx="423360" cy="11088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zh-CN" sz="1600" spc="-1" strike="noStrike">
                  <a:solidFill>
                    <a:srgbClr val="000000"/>
                  </a:solidFill>
                  <a:latin typeface="Arial"/>
                </a:rPr>
                <a:t>Points</a:t>
              </a:r>
              <a:endParaRPr b="0" lang="en-US" sz="1600" spc="-1" strike="noStrike">
                <a:solidFill>
                  <a:srgbClr val="000000"/>
                </a:solidFill>
                <a:latin typeface="Arial"/>
              </a:endParaRPr>
            </a:p>
          </p:txBody>
        </p:sp>
        <p:sp>
          <p:nvSpPr>
            <p:cNvPr id="64" name="pl5"/>
            <p:cNvSpPr/>
            <p:nvPr/>
          </p:nvSpPr>
          <p:spPr>
            <a:xfrm>
              <a:off x="13299120" y="4518360"/>
              <a:ext cx="4616280" cy="360"/>
            </a:xfrm>
            <a:custGeom>
              <a:avLst/>
              <a:gdLst/>
              <a:ahLst/>
              <a:rect l="l" t="t" r="r" b="b"/>
              <a:pathLst>
                <a:path w="4615901" h="1">
                  <a:moveTo>
                    <a:pt x="0" y="0"/>
                  </a:moveTo>
                  <a:lnTo>
                    <a:pt x="4615901"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5" name="pl6"/>
            <p:cNvSpPr/>
            <p:nvPr/>
          </p:nvSpPr>
          <p:spPr>
            <a:xfrm>
              <a:off x="13299120" y="4472640"/>
              <a:ext cx="360" cy="4572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6" name="pl7"/>
            <p:cNvSpPr/>
            <p:nvPr/>
          </p:nvSpPr>
          <p:spPr>
            <a:xfrm>
              <a:off x="13760640" y="4472640"/>
              <a:ext cx="360" cy="4572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7" name="pl8"/>
            <p:cNvSpPr/>
            <p:nvPr/>
          </p:nvSpPr>
          <p:spPr>
            <a:xfrm>
              <a:off x="14222160" y="4472640"/>
              <a:ext cx="360" cy="4572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8" name="pl9"/>
            <p:cNvSpPr/>
            <p:nvPr/>
          </p:nvSpPr>
          <p:spPr>
            <a:xfrm>
              <a:off x="14684040" y="4472640"/>
              <a:ext cx="360" cy="4572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9" name="pl10"/>
            <p:cNvSpPr/>
            <p:nvPr/>
          </p:nvSpPr>
          <p:spPr>
            <a:xfrm>
              <a:off x="15145560" y="4472640"/>
              <a:ext cx="360" cy="4572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0" name="pl11"/>
            <p:cNvSpPr/>
            <p:nvPr/>
          </p:nvSpPr>
          <p:spPr>
            <a:xfrm>
              <a:off x="15607080" y="4472640"/>
              <a:ext cx="360" cy="4572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1" name="pl12"/>
            <p:cNvSpPr/>
            <p:nvPr/>
          </p:nvSpPr>
          <p:spPr>
            <a:xfrm>
              <a:off x="16068960" y="4472640"/>
              <a:ext cx="360" cy="4572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2" name="pl13"/>
            <p:cNvSpPr/>
            <p:nvPr/>
          </p:nvSpPr>
          <p:spPr>
            <a:xfrm>
              <a:off x="16530480" y="4472640"/>
              <a:ext cx="360" cy="4572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3" name="pl14"/>
            <p:cNvSpPr/>
            <p:nvPr/>
          </p:nvSpPr>
          <p:spPr>
            <a:xfrm>
              <a:off x="16992360" y="4472640"/>
              <a:ext cx="360" cy="4572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4" name="pl15"/>
            <p:cNvSpPr/>
            <p:nvPr/>
          </p:nvSpPr>
          <p:spPr>
            <a:xfrm>
              <a:off x="17453880" y="4472640"/>
              <a:ext cx="360" cy="4572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5" name="pl16"/>
            <p:cNvSpPr/>
            <p:nvPr/>
          </p:nvSpPr>
          <p:spPr>
            <a:xfrm>
              <a:off x="17915400" y="4472640"/>
              <a:ext cx="360" cy="4572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6" name="pl17"/>
            <p:cNvSpPr/>
            <p:nvPr/>
          </p:nvSpPr>
          <p:spPr>
            <a:xfrm>
              <a:off x="13299120" y="4518360"/>
              <a:ext cx="4616280" cy="360"/>
            </a:xfrm>
            <a:custGeom>
              <a:avLst/>
              <a:gdLst/>
              <a:ahLst/>
              <a:rect l="l" t="t" r="r" b="b"/>
              <a:pathLst>
                <a:path w="4615901" h="1">
                  <a:moveTo>
                    <a:pt x="0" y="0"/>
                  </a:moveTo>
                  <a:lnTo>
                    <a:pt x="4615901"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7" name="pl18"/>
            <p:cNvSpPr/>
            <p:nvPr/>
          </p:nvSpPr>
          <p:spPr>
            <a:xfrm>
              <a:off x="13299120" y="45183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8" name="pl19"/>
            <p:cNvSpPr/>
            <p:nvPr/>
          </p:nvSpPr>
          <p:spPr>
            <a:xfrm>
              <a:off x="13760640" y="45183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9" name="pl20"/>
            <p:cNvSpPr/>
            <p:nvPr/>
          </p:nvSpPr>
          <p:spPr>
            <a:xfrm>
              <a:off x="14222160" y="45183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0" name="pl21"/>
            <p:cNvSpPr/>
            <p:nvPr/>
          </p:nvSpPr>
          <p:spPr>
            <a:xfrm>
              <a:off x="14684040" y="45183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1" name="pl22"/>
            <p:cNvSpPr/>
            <p:nvPr/>
          </p:nvSpPr>
          <p:spPr>
            <a:xfrm>
              <a:off x="15145560" y="45183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2" name="pl23"/>
            <p:cNvSpPr/>
            <p:nvPr/>
          </p:nvSpPr>
          <p:spPr>
            <a:xfrm>
              <a:off x="15607080" y="45183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3" name="pl24"/>
            <p:cNvSpPr/>
            <p:nvPr/>
          </p:nvSpPr>
          <p:spPr>
            <a:xfrm>
              <a:off x="16068960" y="45183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4" name="pl25"/>
            <p:cNvSpPr/>
            <p:nvPr/>
          </p:nvSpPr>
          <p:spPr>
            <a:xfrm>
              <a:off x="16530480" y="45183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5" name="pl26"/>
            <p:cNvSpPr/>
            <p:nvPr/>
          </p:nvSpPr>
          <p:spPr>
            <a:xfrm>
              <a:off x="16992360" y="45183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6" name="pl27"/>
            <p:cNvSpPr/>
            <p:nvPr/>
          </p:nvSpPr>
          <p:spPr>
            <a:xfrm>
              <a:off x="17453880" y="45183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7" name="pl28"/>
            <p:cNvSpPr/>
            <p:nvPr/>
          </p:nvSpPr>
          <p:spPr>
            <a:xfrm>
              <a:off x="17915400" y="45183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8" name="tx29"/>
            <p:cNvSpPr/>
            <p:nvPr/>
          </p:nvSpPr>
          <p:spPr>
            <a:xfrm>
              <a:off x="13263120" y="4313160"/>
              <a:ext cx="71280" cy="9504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0</a:t>
              </a:r>
              <a:endParaRPr b="0" lang="en-US" sz="1400" spc="-1" strike="noStrike">
                <a:solidFill>
                  <a:srgbClr val="000000"/>
                </a:solidFill>
                <a:latin typeface="Arial"/>
              </a:endParaRPr>
            </a:p>
          </p:txBody>
        </p:sp>
        <p:sp>
          <p:nvSpPr>
            <p:cNvPr id="89" name="tx30"/>
            <p:cNvSpPr/>
            <p:nvPr/>
          </p:nvSpPr>
          <p:spPr>
            <a:xfrm>
              <a:off x="13688640" y="4313160"/>
              <a:ext cx="144360" cy="9504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10</a:t>
              </a:r>
              <a:endParaRPr b="0" lang="en-US" sz="1400" spc="-1" strike="noStrike">
                <a:solidFill>
                  <a:srgbClr val="000000"/>
                </a:solidFill>
                <a:latin typeface="Arial"/>
              </a:endParaRPr>
            </a:p>
          </p:txBody>
        </p:sp>
        <p:sp>
          <p:nvSpPr>
            <p:cNvPr id="90" name="tx31"/>
            <p:cNvSpPr/>
            <p:nvPr/>
          </p:nvSpPr>
          <p:spPr>
            <a:xfrm>
              <a:off x="14150880" y="4313160"/>
              <a:ext cx="142560" cy="9504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20</a:t>
              </a:r>
              <a:endParaRPr b="0" lang="en-US" sz="1400" spc="-1" strike="noStrike">
                <a:solidFill>
                  <a:srgbClr val="000000"/>
                </a:solidFill>
                <a:latin typeface="Arial"/>
              </a:endParaRPr>
            </a:p>
          </p:txBody>
        </p:sp>
        <p:sp>
          <p:nvSpPr>
            <p:cNvPr id="91" name="tx32"/>
            <p:cNvSpPr/>
            <p:nvPr/>
          </p:nvSpPr>
          <p:spPr>
            <a:xfrm>
              <a:off x="14611320" y="4313160"/>
              <a:ext cx="144360" cy="9504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30</a:t>
              </a:r>
              <a:endParaRPr b="0" lang="en-US" sz="1400" spc="-1" strike="noStrike">
                <a:solidFill>
                  <a:srgbClr val="000000"/>
                </a:solidFill>
                <a:latin typeface="Arial"/>
              </a:endParaRPr>
            </a:p>
          </p:txBody>
        </p:sp>
        <p:sp>
          <p:nvSpPr>
            <p:cNvPr id="92" name="tx33"/>
            <p:cNvSpPr/>
            <p:nvPr/>
          </p:nvSpPr>
          <p:spPr>
            <a:xfrm>
              <a:off x="15073200" y="4313160"/>
              <a:ext cx="144360" cy="9504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40</a:t>
              </a:r>
              <a:endParaRPr b="0" lang="en-US" sz="1400" spc="-1" strike="noStrike">
                <a:solidFill>
                  <a:srgbClr val="000000"/>
                </a:solidFill>
                <a:latin typeface="Arial"/>
              </a:endParaRPr>
            </a:p>
          </p:txBody>
        </p:sp>
        <p:sp>
          <p:nvSpPr>
            <p:cNvPr id="93" name="tx34"/>
            <p:cNvSpPr/>
            <p:nvPr/>
          </p:nvSpPr>
          <p:spPr>
            <a:xfrm>
              <a:off x="15535080" y="4313160"/>
              <a:ext cx="144360" cy="9504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50</a:t>
              </a:r>
              <a:endParaRPr b="0" lang="en-US" sz="1400" spc="-1" strike="noStrike">
                <a:solidFill>
                  <a:srgbClr val="000000"/>
                </a:solidFill>
                <a:latin typeface="Arial"/>
              </a:endParaRPr>
            </a:p>
          </p:txBody>
        </p:sp>
        <p:sp>
          <p:nvSpPr>
            <p:cNvPr id="94" name="tx35"/>
            <p:cNvSpPr/>
            <p:nvPr/>
          </p:nvSpPr>
          <p:spPr>
            <a:xfrm>
              <a:off x="15997320" y="4313160"/>
              <a:ext cx="142560" cy="9504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60</a:t>
              </a:r>
              <a:endParaRPr b="0" lang="en-US" sz="1400" spc="-1" strike="noStrike">
                <a:solidFill>
                  <a:srgbClr val="000000"/>
                </a:solidFill>
                <a:latin typeface="Arial"/>
              </a:endParaRPr>
            </a:p>
          </p:txBody>
        </p:sp>
        <p:sp>
          <p:nvSpPr>
            <p:cNvPr id="95" name="tx36"/>
            <p:cNvSpPr/>
            <p:nvPr/>
          </p:nvSpPr>
          <p:spPr>
            <a:xfrm>
              <a:off x="16457760" y="4313160"/>
              <a:ext cx="144360" cy="9504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70</a:t>
              </a:r>
              <a:endParaRPr b="0" lang="en-US" sz="1400" spc="-1" strike="noStrike">
                <a:solidFill>
                  <a:srgbClr val="000000"/>
                </a:solidFill>
                <a:latin typeface="Arial"/>
              </a:endParaRPr>
            </a:p>
          </p:txBody>
        </p:sp>
        <p:sp>
          <p:nvSpPr>
            <p:cNvPr id="96" name="tx37"/>
            <p:cNvSpPr/>
            <p:nvPr/>
          </p:nvSpPr>
          <p:spPr>
            <a:xfrm>
              <a:off x="16919640" y="4313160"/>
              <a:ext cx="144360" cy="9504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80</a:t>
              </a:r>
              <a:endParaRPr b="0" lang="en-US" sz="1400" spc="-1" strike="noStrike">
                <a:solidFill>
                  <a:srgbClr val="000000"/>
                </a:solidFill>
                <a:latin typeface="Arial"/>
              </a:endParaRPr>
            </a:p>
          </p:txBody>
        </p:sp>
        <p:sp>
          <p:nvSpPr>
            <p:cNvPr id="97" name="tx38"/>
            <p:cNvSpPr/>
            <p:nvPr/>
          </p:nvSpPr>
          <p:spPr>
            <a:xfrm>
              <a:off x="17381880" y="4313160"/>
              <a:ext cx="144360" cy="9504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90</a:t>
              </a:r>
              <a:endParaRPr b="0" lang="en-US" sz="1400" spc="-1" strike="noStrike">
                <a:solidFill>
                  <a:srgbClr val="000000"/>
                </a:solidFill>
                <a:latin typeface="Arial"/>
              </a:endParaRPr>
            </a:p>
          </p:txBody>
        </p:sp>
        <p:sp>
          <p:nvSpPr>
            <p:cNvPr id="98" name="tx39"/>
            <p:cNvSpPr/>
            <p:nvPr/>
          </p:nvSpPr>
          <p:spPr>
            <a:xfrm>
              <a:off x="17807400" y="4313160"/>
              <a:ext cx="215640" cy="9504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100</a:t>
              </a:r>
              <a:endParaRPr b="0" lang="en-US" sz="1400" spc="-1" strike="noStrike">
                <a:solidFill>
                  <a:srgbClr val="000000"/>
                </a:solidFill>
                <a:latin typeface="Arial"/>
              </a:endParaRPr>
            </a:p>
          </p:txBody>
        </p:sp>
        <p:sp>
          <p:nvSpPr>
            <p:cNvPr id="99" name="pl40"/>
            <p:cNvSpPr/>
            <p:nvPr/>
          </p:nvSpPr>
          <p:spPr>
            <a:xfrm>
              <a:off x="13414320" y="4518360"/>
              <a:ext cx="4385520" cy="360"/>
            </a:xfrm>
            <a:custGeom>
              <a:avLst/>
              <a:gdLst/>
              <a:ahLst/>
              <a:rect l="l" t="t" r="r" b="b"/>
              <a:pathLst>
                <a:path w="4385106" h="1">
                  <a:moveTo>
                    <a:pt x="0" y="0"/>
                  </a:moveTo>
                  <a:lnTo>
                    <a:pt x="4385106"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0" name="pl41"/>
            <p:cNvSpPr/>
            <p:nvPr/>
          </p:nvSpPr>
          <p:spPr>
            <a:xfrm>
              <a:off x="1341432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1" name="pl42"/>
            <p:cNvSpPr/>
            <p:nvPr/>
          </p:nvSpPr>
          <p:spPr>
            <a:xfrm>
              <a:off x="1352988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2" name="pl43"/>
            <p:cNvSpPr/>
            <p:nvPr/>
          </p:nvSpPr>
          <p:spPr>
            <a:xfrm>
              <a:off x="1364508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3" name="pl44"/>
            <p:cNvSpPr/>
            <p:nvPr/>
          </p:nvSpPr>
          <p:spPr>
            <a:xfrm>
              <a:off x="1387620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4" name="pl45"/>
            <p:cNvSpPr/>
            <p:nvPr/>
          </p:nvSpPr>
          <p:spPr>
            <a:xfrm>
              <a:off x="1399140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5" name="pl46"/>
            <p:cNvSpPr/>
            <p:nvPr/>
          </p:nvSpPr>
          <p:spPr>
            <a:xfrm>
              <a:off x="1410696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6" name="pl47"/>
            <p:cNvSpPr/>
            <p:nvPr/>
          </p:nvSpPr>
          <p:spPr>
            <a:xfrm>
              <a:off x="1433772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7" name="pl48"/>
            <p:cNvSpPr/>
            <p:nvPr/>
          </p:nvSpPr>
          <p:spPr>
            <a:xfrm>
              <a:off x="1445292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8" name="pl49"/>
            <p:cNvSpPr/>
            <p:nvPr/>
          </p:nvSpPr>
          <p:spPr>
            <a:xfrm>
              <a:off x="1456848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9" name="pl50"/>
            <p:cNvSpPr/>
            <p:nvPr/>
          </p:nvSpPr>
          <p:spPr>
            <a:xfrm>
              <a:off x="1479924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0" name="pl51"/>
            <p:cNvSpPr/>
            <p:nvPr/>
          </p:nvSpPr>
          <p:spPr>
            <a:xfrm>
              <a:off x="1491480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1" name="pl52"/>
            <p:cNvSpPr/>
            <p:nvPr/>
          </p:nvSpPr>
          <p:spPr>
            <a:xfrm>
              <a:off x="1503000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2" name="pl53"/>
            <p:cNvSpPr/>
            <p:nvPr/>
          </p:nvSpPr>
          <p:spPr>
            <a:xfrm>
              <a:off x="1526112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3" name="pl54"/>
            <p:cNvSpPr/>
            <p:nvPr/>
          </p:nvSpPr>
          <p:spPr>
            <a:xfrm>
              <a:off x="1537632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4" name="pl55"/>
            <p:cNvSpPr/>
            <p:nvPr/>
          </p:nvSpPr>
          <p:spPr>
            <a:xfrm>
              <a:off x="1549188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5" name="pl56"/>
            <p:cNvSpPr/>
            <p:nvPr/>
          </p:nvSpPr>
          <p:spPr>
            <a:xfrm>
              <a:off x="1572264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6" name="pl57"/>
            <p:cNvSpPr/>
            <p:nvPr/>
          </p:nvSpPr>
          <p:spPr>
            <a:xfrm>
              <a:off x="1583820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7" name="pl58"/>
            <p:cNvSpPr/>
            <p:nvPr/>
          </p:nvSpPr>
          <p:spPr>
            <a:xfrm>
              <a:off x="1595340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8" name="pl59"/>
            <p:cNvSpPr/>
            <p:nvPr/>
          </p:nvSpPr>
          <p:spPr>
            <a:xfrm>
              <a:off x="1618416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9" name="pl60"/>
            <p:cNvSpPr/>
            <p:nvPr/>
          </p:nvSpPr>
          <p:spPr>
            <a:xfrm>
              <a:off x="1629972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0" name="pl61"/>
            <p:cNvSpPr/>
            <p:nvPr/>
          </p:nvSpPr>
          <p:spPr>
            <a:xfrm>
              <a:off x="1641528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1" name="pl62"/>
            <p:cNvSpPr/>
            <p:nvPr/>
          </p:nvSpPr>
          <p:spPr>
            <a:xfrm>
              <a:off x="1664604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2" name="pl63"/>
            <p:cNvSpPr/>
            <p:nvPr/>
          </p:nvSpPr>
          <p:spPr>
            <a:xfrm>
              <a:off x="1676124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3" name="pl64"/>
            <p:cNvSpPr/>
            <p:nvPr/>
          </p:nvSpPr>
          <p:spPr>
            <a:xfrm>
              <a:off x="1687680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4" name="pl65"/>
            <p:cNvSpPr/>
            <p:nvPr/>
          </p:nvSpPr>
          <p:spPr>
            <a:xfrm>
              <a:off x="1710756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5" name="pl66"/>
            <p:cNvSpPr/>
            <p:nvPr/>
          </p:nvSpPr>
          <p:spPr>
            <a:xfrm>
              <a:off x="1722312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6" name="pl67"/>
            <p:cNvSpPr/>
            <p:nvPr/>
          </p:nvSpPr>
          <p:spPr>
            <a:xfrm>
              <a:off x="1733832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7" name="pl68"/>
            <p:cNvSpPr/>
            <p:nvPr/>
          </p:nvSpPr>
          <p:spPr>
            <a:xfrm>
              <a:off x="1756944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8" name="pl69"/>
            <p:cNvSpPr/>
            <p:nvPr/>
          </p:nvSpPr>
          <p:spPr>
            <a:xfrm>
              <a:off x="1768464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9" name="pl70"/>
            <p:cNvSpPr/>
            <p:nvPr/>
          </p:nvSpPr>
          <p:spPr>
            <a:xfrm>
              <a:off x="17800200" y="449532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30" name="tx71"/>
            <p:cNvSpPr/>
            <p:nvPr/>
          </p:nvSpPr>
          <p:spPr>
            <a:xfrm>
              <a:off x="11683080" y="5721480"/>
              <a:ext cx="872640" cy="14112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en-US" sz="1600" spc="-1" strike="noStrike">
                  <a:solidFill>
                    <a:srgbClr val="000000"/>
                  </a:solidFill>
                  <a:latin typeface="Arial"/>
                </a:rPr>
                <a:t>   </a:t>
              </a:r>
              <a:r>
                <a:rPr b="0" lang="en-US" sz="1600" spc="-1" strike="noStrike">
                  <a:solidFill>
                    <a:srgbClr val="000000"/>
                  </a:solidFill>
                  <a:latin typeface="Arial"/>
                </a:rPr>
                <a:t>C</a:t>
              </a:r>
              <a:r>
                <a:rPr b="0" lang="zh-CN" sz="1600" spc="-1" strike="noStrike">
                  <a:solidFill>
                    <a:srgbClr val="000000"/>
                  </a:solidFill>
                  <a:latin typeface="Arial"/>
                </a:rPr>
                <a:t>utoff_</a:t>
              </a:r>
              <a:r>
                <a:rPr b="0" lang="en-US" sz="1600" spc="-1" strike="noStrike">
                  <a:solidFill>
                    <a:srgbClr val="000000"/>
                  </a:solidFill>
                  <a:latin typeface="Arial"/>
                </a:rPr>
                <a:t>CA</a:t>
              </a:r>
              <a:r>
                <a:rPr b="0" lang="zh-CN" sz="1600" spc="-1" strike="noStrike">
                  <a:solidFill>
                    <a:srgbClr val="000000"/>
                  </a:solidFill>
                  <a:latin typeface="Arial"/>
                </a:rPr>
                <a:t>19</a:t>
              </a:r>
              <a:r>
                <a:rPr b="0" lang="en-US" sz="1600" spc="-1" strike="noStrike">
                  <a:solidFill>
                    <a:srgbClr val="000000"/>
                  </a:solidFill>
                  <a:latin typeface="Arial"/>
                </a:rPr>
                <a:t>-</a:t>
              </a:r>
              <a:r>
                <a:rPr b="0" lang="zh-CN" sz="1600" spc="-1" strike="noStrike">
                  <a:solidFill>
                    <a:srgbClr val="000000"/>
                  </a:solidFill>
                  <a:latin typeface="Arial"/>
                </a:rPr>
                <a:t>9</a:t>
              </a:r>
              <a:endParaRPr b="0" lang="en-US" sz="1600" spc="-1" strike="noStrike">
                <a:solidFill>
                  <a:srgbClr val="000000"/>
                </a:solidFill>
                <a:latin typeface="Arial"/>
              </a:endParaRPr>
            </a:p>
          </p:txBody>
        </p:sp>
        <p:sp>
          <p:nvSpPr>
            <p:cNvPr id="131" name="pl72"/>
            <p:cNvSpPr/>
            <p:nvPr/>
          </p:nvSpPr>
          <p:spPr>
            <a:xfrm>
              <a:off x="13299120" y="5822280"/>
              <a:ext cx="4503600" cy="360"/>
            </a:xfrm>
            <a:custGeom>
              <a:avLst/>
              <a:gdLst/>
              <a:ahLst/>
              <a:rect l="l" t="t" r="r" b="b"/>
              <a:pathLst>
                <a:path w="4503222" h="1">
                  <a:moveTo>
                    <a:pt x="0" y="0"/>
                  </a:moveTo>
                  <a:lnTo>
                    <a:pt x="4503222"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32" name="pl73"/>
            <p:cNvSpPr/>
            <p:nvPr/>
          </p:nvSpPr>
          <p:spPr>
            <a:xfrm>
              <a:off x="13299120" y="582228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33" name="pl74"/>
            <p:cNvSpPr/>
            <p:nvPr/>
          </p:nvSpPr>
          <p:spPr>
            <a:xfrm>
              <a:off x="13299120" y="5822280"/>
              <a:ext cx="360" cy="45720"/>
            </a:xfrm>
            <a:custGeom>
              <a:avLst/>
              <a:gdLst/>
              <a:ahLst/>
              <a:rect l="l" t="t" r="r" b="b"/>
              <a:pathLst>
                <a:path w="1" h="45719">
                  <a:moveTo>
                    <a:pt x="0" y="0"/>
                  </a:moveTo>
                  <a:lnTo>
                    <a:pt x="0" y="45719"/>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34" name="pl75"/>
            <p:cNvSpPr/>
            <p:nvPr/>
          </p:nvSpPr>
          <p:spPr>
            <a:xfrm>
              <a:off x="13299120" y="582228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35" name="pl76"/>
            <p:cNvSpPr/>
            <p:nvPr/>
          </p:nvSpPr>
          <p:spPr>
            <a:xfrm>
              <a:off x="13299120" y="582228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36" name="tx77"/>
            <p:cNvSpPr/>
            <p:nvPr/>
          </p:nvSpPr>
          <p:spPr>
            <a:xfrm>
              <a:off x="13263480" y="5949720"/>
              <a:ext cx="527040" cy="17208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en-US" sz="1400" spc="-1" strike="noStrike">
                  <a:solidFill>
                    <a:srgbClr val="000000"/>
                  </a:solidFill>
                  <a:latin typeface="Arial"/>
                </a:rPr>
                <a:t>Below</a:t>
              </a:r>
              <a:r>
                <a:rPr b="0" lang="en-US" sz="1400" spc="-1" strike="noStrike" baseline="30000">
                  <a:solidFill>
                    <a:srgbClr val="000000"/>
                  </a:solidFill>
                  <a:latin typeface="Arial"/>
                </a:rPr>
                <a:t>cut-off</a:t>
              </a:r>
              <a:endParaRPr b="0" lang="en-US" sz="1400" spc="-1" strike="noStrike">
                <a:solidFill>
                  <a:srgbClr val="000000"/>
                </a:solidFill>
                <a:latin typeface="Arial"/>
              </a:endParaRPr>
            </a:p>
          </p:txBody>
        </p:sp>
        <p:sp>
          <p:nvSpPr>
            <p:cNvPr id="137" name="pl78"/>
            <p:cNvSpPr/>
            <p:nvPr/>
          </p:nvSpPr>
          <p:spPr>
            <a:xfrm>
              <a:off x="17802720" y="582228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38" name="pl79"/>
            <p:cNvSpPr/>
            <p:nvPr/>
          </p:nvSpPr>
          <p:spPr>
            <a:xfrm>
              <a:off x="17802720" y="5776560"/>
              <a:ext cx="360" cy="45720"/>
            </a:xfrm>
            <a:custGeom>
              <a:avLst/>
              <a:gdLst/>
              <a:ahLst/>
              <a:rect l="l" t="t" r="r" b="b"/>
              <a:pathLst>
                <a:path w="1" h="45719">
                  <a:moveTo>
                    <a:pt x="0" y="45719"/>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39" name="pl80"/>
            <p:cNvSpPr/>
            <p:nvPr/>
          </p:nvSpPr>
          <p:spPr>
            <a:xfrm>
              <a:off x="17802720" y="582228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40" name="pl81"/>
            <p:cNvSpPr/>
            <p:nvPr/>
          </p:nvSpPr>
          <p:spPr>
            <a:xfrm>
              <a:off x="17802720" y="582228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41" name="tx82"/>
            <p:cNvSpPr/>
            <p:nvPr/>
          </p:nvSpPr>
          <p:spPr>
            <a:xfrm>
              <a:off x="17766000" y="5618160"/>
              <a:ext cx="72720" cy="9504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42" name="tx83"/>
            <p:cNvSpPr/>
            <p:nvPr/>
          </p:nvSpPr>
          <p:spPr>
            <a:xfrm>
              <a:off x="11063160" y="7124400"/>
              <a:ext cx="653040" cy="12456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en-US" sz="1600" spc="-1" strike="noStrike">
                  <a:solidFill>
                    <a:srgbClr val="000000"/>
                  </a:solidFill>
                  <a:latin typeface="Arial"/>
                </a:rPr>
                <a:t>                  </a:t>
              </a:r>
              <a:r>
                <a:rPr b="0" lang="zh-CN" sz="1600" spc="-1" strike="noStrike">
                  <a:solidFill>
                    <a:srgbClr val="000000"/>
                  </a:solidFill>
                  <a:latin typeface="Arial"/>
                </a:rPr>
                <a:t>T</a:t>
              </a:r>
              <a:r>
                <a:rPr b="0" lang="en-US" sz="1600" spc="-1" strike="noStrike">
                  <a:solidFill>
                    <a:srgbClr val="000000"/>
                  </a:solidFill>
                  <a:latin typeface="Arial"/>
                </a:rPr>
                <a:t> stage</a:t>
              </a:r>
              <a:endParaRPr b="0" lang="en-US" sz="1600" spc="-1" strike="noStrike">
                <a:solidFill>
                  <a:srgbClr val="000000"/>
                </a:solidFill>
                <a:latin typeface="Arial"/>
              </a:endParaRPr>
            </a:p>
          </p:txBody>
        </p:sp>
        <p:sp>
          <p:nvSpPr>
            <p:cNvPr id="143" name="pl84"/>
            <p:cNvSpPr/>
            <p:nvPr/>
          </p:nvSpPr>
          <p:spPr>
            <a:xfrm>
              <a:off x="13299120" y="7126200"/>
              <a:ext cx="4616280" cy="360"/>
            </a:xfrm>
            <a:custGeom>
              <a:avLst/>
              <a:gdLst/>
              <a:ahLst/>
              <a:rect l="l" t="t" r="r" b="b"/>
              <a:pathLst>
                <a:path w="4615901" h="1">
                  <a:moveTo>
                    <a:pt x="0" y="0"/>
                  </a:moveTo>
                  <a:lnTo>
                    <a:pt x="4615901"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44" name="pl85"/>
            <p:cNvSpPr/>
            <p:nvPr/>
          </p:nvSpPr>
          <p:spPr>
            <a:xfrm>
              <a:off x="13299120" y="7126200"/>
              <a:ext cx="4616280" cy="360"/>
            </a:xfrm>
            <a:custGeom>
              <a:avLst/>
              <a:gdLst/>
              <a:ahLst/>
              <a:rect l="l" t="t" r="r" b="b"/>
              <a:pathLst>
                <a:path w="4615901" h="1">
                  <a:moveTo>
                    <a:pt x="0" y="0"/>
                  </a:moveTo>
                  <a:lnTo>
                    <a:pt x="4615901"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45" name="pl86"/>
            <p:cNvSpPr/>
            <p:nvPr/>
          </p:nvSpPr>
          <p:spPr>
            <a:xfrm>
              <a:off x="13299120" y="712620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46" name="pl87"/>
            <p:cNvSpPr/>
            <p:nvPr/>
          </p:nvSpPr>
          <p:spPr>
            <a:xfrm>
              <a:off x="17915400" y="712620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47" name="pl88"/>
            <p:cNvSpPr/>
            <p:nvPr/>
          </p:nvSpPr>
          <p:spPr>
            <a:xfrm>
              <a:off x="13299120" y="7126200"/>
              <a:ext cx="4616280" cy="360"/>
            </a:xfrm>
            <a:custGeom>
              <a:avLst/>
              <a:gdLst/>
              <a:ahLst/>
              <a:rect l="l" t="t" r="r" b="b"/>
              <a:pathLst>
                <a:path w="4615901" h="1">
                  <a:moveTo>
                    <a:pt x="0" y="0"/>
                  </a:moveTo>
                  <a:lnTo>
                    <a:pt x="4615901"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48" name="pl89"/>
            <p:cNvSpPr/>
            <p:nvPr/>
          </p:nvSpPr>
          <p:spPr>
            <a:xfrm>
              <a:off x="13299120" y="71262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49" name="pl90"/>
            <p:cNvSpPr/>
            <p:nvPr/>
          </p:nvSpPr>
          <p:spPr>
            <a:xfrm>
              <a:off x="17915400" y="71262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50" name="tx91"/>
            <p:cNvSpPr/>
            <p:nvPr/>
          </p:nvSpPr>
          <p:spPr>
            <a:xfrm>
              <a:off x="13263120" y="7234200"/>
              <a:ext cx="71280" cy="9504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1</a:t>
              </a:r>
              <a:endParaRPr b="0" lang="en-US" sz="1400" spc="-1" strike="noStrike">
                <a:solidFill>
                  <a:srgbClr val="000000"/>
                </a:solidFill>
                <a:latin typeface="Arial"/>
              </a:endParaRPr>
            </a:p>
          </p:txBody>
        </p:sp>
        <p:sp>
          <p:nvSpPr>
            <p:cNvPr id="151" name="tx92"/>
            <p:cNvSpPr/>
            <p:nvPr/>
          </p:nvSpPr>
          <p:spPr>
            <a:xfrm>
              <a:off x="17878680" y="7234200"/>
              <a:ext cx="72720" cy="9504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3</a:t>
              </a:r>
              <a:endParaRPr b="0" lang="en-US" sz="1400" spc="-1" strike="noStrike">
                <a:solidFill>
                  <a:srgbClr val="000000"/>
                </a:solidFill>
                <a:latin typeface="Arial"/>
              </a:endParaRPr>
            </a:p>
          </p:txBody>
        </p:sp>
        <p:sp>
          <p:nvSpPr>
            <p:cNvPr id="152" name="pl93"/>
            <p:cNvSpPr/>
            <p:nvPr/>
          </p:nvSpPr>
          <p:spPr>
            <a:xfrm>
              <a:off x="15607080" y="71262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53" name="pl94"/>
            <p:cNvSpPr/>
            <p:nvPr/>
          </p:nvSpPr>
          <p:spPr>
            <a:xfrm>
              <a:off x="15607080" y="7080480"/>
              <a:ext cx="360" cy="45720"/>
            </a:xfrm>
            <a:custGeom>
              <a:avLst/>
              <a:gdLst/>
              <a:ahLst/>
              <a:rect l="l" t="t" r="r" b="b"/>
              <a:pathLst>
                <a:path w="1" h="45719">
                  <a:moveTo>
                    <a:pt x="0" y="45719"/>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54" name="pl95"/>
            <p:cNvSpPr/>
            <p:nvPr/>
          </p:nvSpPr>
          <p:spPr>
            <a:xfrm>
              <a:off x="15607080" y="71262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55" name="pl96"/>
            <p:cNvSpPr/>
            <p:nvPr/>
          </p:nvSpPr>
          <p:spPr>
            <a:xfrm>
              <a:off x="15607080" y="71262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56" name="tx97"/>
            <p:cNvSpPr/>
            <p:nvPr/>
          </p:nvSpPr>
          <p:spPr>
            <a:xfrm>
              <a:off x="15571800" y="6923160"/>
              <a:ext cx="71280" cy="9180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2</a:t>
              </a:r>
              <a:endParaRPr b="0" lang="en-US" sz="1400" spc="-1" strike="noStrike">
                <a:solidFill>
                  <a:srgbClr val="000000"/>
                </a:solidFill>
                <a:latin typeface="Arial"/>
              </a:endParaRPr>
            </a:p>
          </p:txBody>
        </p:sp>
        <p:sp>
          <p:nvSpPr>
            <p:cNvPr id="157" name="tx98"/>
            <p:cNvSpPr/>
            <p:nvPr/>
          </p:nvSpPr>
          <p:spPr>
            <a:xfrm>
              <a:off x="11683080" y="8372880"/>
              <a:ext cx="804600" cy="11088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zh-CN" sz="1600" spc="-1" strike="noStrike">
                  <a:solidFill>
                    <a:srgbClr val="000000"/>
                  </a:solidFill>
                  <a:latin typeface="Arial"/>
                </a:rPr>
                <a:t>Total Points</a:t>
              </a:r>
              <a:endParaRPr b="0" lang="en-US" sz="1600" spc="-1" strike="noStrike">
                <a:solidFill>
                  <a:srgbClr val="000000"/>
                </a:solidFill>
                <a:latin typeface="Arial"/>
              </a:endParaRPr>
            </a:p>
          </p:txBody>
        </p:sp>
        <p:sp>
          <p:nvSpPr>
            <p:cNvPr id="158" name="pl99"/>
            <p:cNvSpPr/>
            <p:nvPr/>
          </p:nvSpPr>
          <p:spPr>
            <a:xfrm>
              <a:off x="13299120" y="8430120"/>
              <a:ext cx="4616280" cy="360"/>
            </a:xfrm>
            <a:custGeom>
              <a:avLst/>
              <a:gdLst/>
              <a:ahLst/>
              <a:rect l="l" t="t" r="r" b="b"/>
              <a:pathLst>
                <a:path w="4615901" h="1">
                  <a:moveTo>
                    <a:pt x="0" y="0"/>
                  </a:moveTo>
                  <a:lnTo>
                    <a:pt x="4615901"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59" name="pl100"/>
            <p:cNvSpPr/>
            <p:nvPr/>
          </p:nvSpPr>
          <p:spPr>
            <a:xfrm>
              <a:off x="13299120" y="843012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60" name="pl101"/>
            <p:cNvSpPr/>
            <p:nvPr/>
          </p:nvSpPr>
          <p:spPr>
            <a:xfrm>
              <a:off x="13718520" y="843012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61" name="pl102"/>
            <p:cNvSpPr/>
            <p:nvPr/>
          </p:nvSpPr>
          <p:spPr>
            <a:xfrm>
              <a:off x="14138280" y="843012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62" name="pl103"/>
            <p:cNvSpPr/>
            <p:nvPr/>
          </p:nvSpPr>
          <p:spPr>
            <a:xfrm>
              <a:off x="14558040" y="843012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63" name="pl104"/>
            <p:cNvSpPr/>
            <p:nvPr/>
          </p:nvSpPr>
          <p:spPr>
            <a:xfrm>
              <a:off x="14977800" y="843012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64" name="pl105"/>
            <p:cNvSpPr/>
            <p:nvPr/>
          </p:nvSpPr>
          <p:spPr>
            <a:xfrm>
              <a:off x="15397560" y="843012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65" name="pl106"/>
            <p:cNvSpPr/>
            <p:nvPr/>
          </p:nvSpPr>
          <p:spPr>
            <a:xfrm>
              <a:off x="15816960" y="843012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66" name="pl107"/>
            <p:cNvSpPr/>
            <p:nvPr/>
          </p:nvSpPr>
          <p:spPr>
            <a:xfrm>
              <a:off x="16236720" y="843012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67" name="pl108"/>
            <p:cNvSpPr/>
            <p:nvPr/>
          </p:nvSpPr>
          <p:spPr>
            <a:xfrm>
              <a:off x="16656480" y="843012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68" name="pl109"/>
            <p:cNvSpPr/>
            <p:nvPr/>
          </p:nvSpPr>
          <p:spPr>
            <a:xfrm>
              <a:off x="17076240" y="843012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69" name="pl110"/>
            <p:cNvSpPr/>
            <p:nvPr/>
          </p:nvSpPr>
          <p:spPr>
            <a:xfrm>
              <a:off x="17496000" y="843012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70" name="pl111"/>
            <p:cNvSpPr/>
            <p:nvPr/>
          </p:nvSpPr>
          <p:spPr>
            <a:xfrm>
              <a:off x="17915400" y="843012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71" name="pl112"/>
            <p:cNvSpPr/>
            <p:nvPr/>
          </p:nvSpPr>
          <p:spPr>
            <a:xfrm>
              <a:off x="13299120" y="8430120"/>
              <a:ext cx="4616280" cy="360"/>
            </a:xfrm>
            <a:custGeom>
              <a:avLst/>
              <a:gdLst/>
              <a:ahLst/>
              <a:rect l="l" t="t" r="r" b="b"/>
              <a:pathLst>
                <a:path w="4615901" h="1">
                  <a:moveTo>
                    <a:pt x="0" y="0"/>
                  </a:moveTo>
                  <a:lnTo>
                    <a:pt x="4615901"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72" name="pl113"/>
            <p:cNvSpPr/>
            <p:nvPr/>
          </p:nvSpPr>
          <p:spPr>
            <a:xfrm>
              <a:off x="13299120" y="84301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73" name="pl114"/>
            <p:cNvSpPr/>
            <p:nvPr/>
          </p:nvSpPr>
          <p:spPr>
            <a:xfrm>
              <a:off x="13718520" y="84301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74" name="pl115"/>
            <p:cNvSpPr/>
            <p:nvPr/>
          </p:nvSpPr>
          <p:spPr>
            <a:xfrm>
              <a:off x="14138280" y="84301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75" name="pl116"/>
            <p:cNvSpPr/>
            <p:nvPr/>
          </p:nvSpPr>
          <p:spPr>
            <a:xfrm>
              <a:off x="14558040" y="84301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76" name="pl117"/>
            <p:cNvSpPr/>
            <p:nvPr/>
          </p:nvSpPr>
          <p:spPr>
            <a:xfrm>
              <a:off x="14977800" y="84301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77" name="pl118"/>
            <p:cNvSpPr/>
            <p:nvPr/>
          </p:nvSpPr>
          <p:spPr>
            <a:xfrm>
              <a:off x="15397560" y="84301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78" name="pl119"/>
            <p:cNvSpPr/>
            <p:nvPr/>
          </p:nvSpPr>
          <p:spPr>
            <a:xfrm>
              <a:off x="15816960" y="84301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79" name="pl120"/>
            <p:cNvSpPr/>
            <p:nvPr/>
          </p:nvSpPr>
          <p:spPr>
            <a:xfrm>
              <a:off x="16236720" y="84301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80" name="pl121"/>
            <p:cNvSpPr/>
            <p:nvPr/>
          </p:nvSpPr>
          <p:spPr>
            <a:xfrm>
              <a:off x="16656480" y="84301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81" name="pl122"/>
            <p:cNvSpPr/>
            <p:nvPr/>
          </p:nvSpPr>
          <p:spPr>
            <a:xfrm>
              <a:off x="17076240" y="84301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82" name="pl123"/>
            <p:cNvSpPr/>
            <p:nvPr/>
          </p:nvSpPr>
          <p:spPr>
            <a:xfrm>
              <a:off x="17496000" y="84301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83" name="pl124"/>
            <p:cNvSpPr/>
            <p:nvPr/>
          </p:nvSpPr>
          <p:spPr>
            <a:xfrm>
              <a:off x="17915400" y="84301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84" name="tx125"/>
            <p:cNvSpPr/>
            <p:nvPr/>
          </p:nvSpPr>
          <p:spPr>
            <a:xfrm>
              <a:off x="13263120" y="8555400"/>
              <a:ext cx="71280" cy="9180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0</a:t>
              </a:r>
              <a:endParaRPr b="0" lang="en-US" sz="1400" spc="-1" strike="noStrike">
                <a:solidFill>
                  <a:srgbClr val="000000"/>
                </a:solidFill>
                <a:latin typeface="Arial"/>
              </a:endParaRPr>
            </a:p>
          </p:txBody>
        </p:sp>
        <p:sp>
          <p:nvSpPr>
            <p:cNvPr id="185" name="tx126"/>
            <p:cNvSpPr/>
            <p:nvPr/>
          </p:nvSpPr>
          <p:spPr>
            <a:xfrm>
              <a:off x="13645800" y="8555400"/>
              <a:ext cx="144360" cy="9180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20</a:t>
              </a:r>
              <a:endParaRPr b="0" lang="en-US" sz="1400" spc="-1" strike="noStrike">
                <a:solidFill>
                  <a:srgbClr val="000000"/>
                </a:solidFill>
                <a:latin typeface="Arial"/>
              </a:endParaRPr>
            </a:p>
          </p:txBody>
        </p:sp>
        <p:sp>
          <p:nvSpPr>
            <p:cNvPr id="186" name="tx127"/>
            <p:cNvSpPr/>
            <p:nvPr/>
          </p:nvSpPr>
          <p:spPr>
            <a:xfrm>
              <a:off x="14066640" y="8555400"/>
              <a:ext cx="142560" cy="9180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40</a:t>
              </a:r>
              <a:endParaRPr b="0" lang="en-US" sz="1400" spc="-1" strike="noStrike">
                <a:solidFill>
                  <a:srgbClr val="000000"/>
                </a:solidFill>
                <a:latin typeface="Arial"/>
              </a:endParaRPr>
            </a:p>
          </p:txBody>
        </p:sp>
        <p:sp>
          <p:nvSpPr>
            <p:cNvPr id="187" name="tx128"/>
            <p:cNvSpPr/>
            <p:nvPr/>
          </p:nvSpPr>
          <p:spPr>
            <a:xfrm>
              <a:off x="14485680" y="8555400"/>
              <a:ext cx="144360" cy="9180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60</a:t>
              </a:r>
              <a:endParaRPr b="0" lang="en-US" sz="1400" spc="-1" strike="noStrike">
                <a:solidFill>
                  <a:srgbClr val="000000"/>
                </a:solidFill>
                <a:latin typeface="Arial"/>
              </a:endParaRPr>
            </a:p>
          </p:txBody>
        </p:sp>
        <p:sp>
          <p:nvSpPr>
            <p:cNvPr id="188" name="tx129"/>
            <p:cNvSpPr/>
            <p:nvPr/>
          </p:nvSpPr>
          <p:spPr>
            <a:xfrm>
              <a:off x="14904720" y="8555400"/>
              <a:ext cx="144360" cy="9180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80</a:t>
              </a:r>
              <a:endParaRPr b="0" lang="en-US" sz="1400" spc="-1" strike="noStrike">
                <a:solidFill>
                  <a:srgbClr val="000000"/>
                </a:solidFill>
                <a:latin typeface="Arial"/>
              </a:endParaRPr>
            </a:p>
          </p:txBody>
        </p:sp>
        <p:sp>
          <p:nvSpPr>
            <p:cNvPr id="189" name="tx130"/>
            <p:cNvSpPr/>
            <p:nvPr/>
          </p:nvSpPr>
          <p:spPr>
            <a:xfrm>
              <a:off x="15289200" y="8555400"/>
              <a:ext cx="215640" cy="9180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100</a:t>
              </a:r>
              <a:endParaRPr b="0" lang="en-US" sz="1400" spc="-1" strike="noStrike">
                <a:solidFill>
                  <a:srgbClr val="000000"/>
                </a:solidFill>
                <a:latin typeface="Arial"/>
              </a:endParaRPr>
            </a:p>
          </p:txBody>
        </p:sp>
        <p:sp>
          <p:nvSpPr>
            <p:cNvPr id="190" name="tx131"/>
            <p:cNvSpPr/>
            <p:nvPr/>
          </p:nvSpPr>
          <p:spPr>
            <a:xfrm>
              <a:off x="15708240" y="8555400"/>
              <a:ext cx="215640" cy="9180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120</a:t>
              </a:r>
              <a:endParaRPr b="0" lang="en-US" sz="1400" spc="-1" strike="noStrike">
                <a:solidFill>
                  <a:srgbClr val="000000"/>
                </a:solidFill>
                <a:latin typeface="Arial"/>
              </a:endParaRPr>
            </a:p>
          </p:txBody>
        </p:sp>
        <p:sp>
          <p:nvSpPr>
            <p:cNvPr id="191" name="tx132"/>
            <p:cNvSpPr/>
            <p:nvPr/>
          </p:nvSpPr>
          <p:spPr>
            <a:xfrm>
              <a:off x="16129080" y="8555400"/>
              <a:ext cx="215640" cy="9180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140</a:t>
              </a:r>
              <a:endParaRPr b="0" lang="en-US" sz="1400" spc="-1" strike="noStrike">
                <a:solidFill>
                  <a:srgbClr val="000000"/>
                </a:solidFill>
                <a:latin typeface="Arial"/>
              </a:endParaRPr>
            </a:p>
          </p:txBody>
        </p:sp>
        <p:sp>
          <p:nvSpPr>
            <p:cNvPr id="192" name="tx133"/>
            <p:cNvSpPr/>
            <p:nvPr/>
          </p:nvSpPr>
          <p:spPr>
            <a:xfrm>
              <a:off x="16548120" y="8555400"/>
              <a:ext cx="215640" cy="9180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160</a:t>
              </a:r>
              <a:endParaRPr b="0" lang="en-US" sz="1400" spc="-1" strike="noStrike">
                <a:solidFill>
                  <a:srgbClr val="000000"/>
                </a:solidFill>
                <a:latin typeface="Arial"/>
              </a:endParaRPr>
            </a:p>
          </p:txBody>
        </p:sp>
        <p:sp>
          <p:nvSpPr>
            <p:cNvPr id="193" name="tx134"/>
            <p:cNvSpPr/>
            <p:nvPr/>
          </p:nvSpPr>
          <p:spPr>
            <a:xfrm>
              <a:off x="16967520" y="8555400"/>
              <a:ext cx="215640" cy="9180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180</a:t>
              </a:r>
              <a:endParaRPr b="0" lang="en-US" sz="1400" spc="-1" strike="noStrike">
                <a:solidFill>
                  <a:srgbClr val="000000"/>
                </a:solidFill>
                <a:latin typeface="Arial"/>
              </a:endParaRPr>
            </a:p>
          </p:txBody>
        </p:sp>
        <p:sp>
          <p:nvSpPr>
            <p:cNvPr id="194" name="tx135"/>
            <p:cNvSpPr/>
            <p:nvPr/>
          </p:nvSpPr>
          <p:spPr>
            <a:xfrm>
              <a:off x="17388000" y="8555400"/>
              <a:ext cx="215640" cy="9180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200</a:t>
              </a:r>
              <a:endParaRPr b="0" lang="en-US" sz="1400" spc="-1" strike="noStrike">
                <a:solidFill>
                  <a:srgbClr val="000000"/>
                </a:solidFill>
                <a:latin typeface="Arial"/>
              </a:endParaRPr>
            </a:p>
          </p:txBody>
        </p:sp>
        <p:sp>
          <p:nvSpPr>
            <p:cNvPr id="195" name="tx136"/>
            <p:cNvSpPr/>
            <p:nvPr/>
          </p:nvSpPr>
          <p:spPr>
            <a:xfrm>
              <a:off x="17807400" y="8555400"/>
              <a:ext cx="215640" cy="9180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220</a:t>
              </a:r>
              <a:endParaRPr b="0" lang="en-US" sz="1400" spc="-1" strike="noStrike">
                <a:solidFill>
                  <a:srgbClr val="000000"/>
                </a:solidFill>
                <a:latin typeface="Arial"/>
              </a:endParaRPr>
            </a:p>
          </p:txBody>
        </p:sp>
        <p:sp>
          <p:nvSpPr>
            <p:cNvPr id="196" name="pl137"/>
            <p:cNvSpPr/>
            <p:nvPr/>
          </p:nvSpPr>
          <p:spPr>
            <a:xfrm>
              <a:off x="13299120" y="8430120"/>
              <a:ext cx="4616280" cy="360"/>
            </a:xfrm>
            <a:custGeom>
              <a:avLst/>
              <a:gdLst/>
              <a:ahLst/>
              <a:rect l="l" t="t" r="r" b="b"/>
              <a:pathLst>
                <a:path w="4615901" h="1">
                  <a:moveTo>
                    <a:pt x="0" y="0"/>
                  </a:moveTo>
                  <a:lnTo>
                    <a:pt x="4615901"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97" name="pl138"/>
            <p:cNvSpPr/>
            <p:nvPr/>
          </p:nvSpPr>
          <p:spPr>
            <a:xfrm>
              <a:off x="1329912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98" name="pl139"/>
            <p:cNvSpPr/>
            <p:nvPr/>
          </p:nvSpPr>
          <p:spPr>
            <a:xfrm>
              <a:off x="1338300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99" name="pl140"/>
            <p:cNvSpPr/>
            <p:nvPr/>
          </p:nvSpPr>
          <p:spPr>
            <a:xfrm>
              <a:off x="1346688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00" name="pl141"/>
            <p:cNvSpPr/>
            <p:nvPr/>
          </p:nvSpPr>
          <p:spPr>
            <a:xfrm>
              <a:off x="1355076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01" name="pl142"/>
            <p:cNvSpPr/>
            <p:nvPr/>
          </p:nvSpPr>
          <p:spPr>
            <a:xfrm>
              <a:off x="1363464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02" name="pl143"/>
            <p:cNvSpPr/>
            <p:nvPr/>
          </p:nvSpPr>
          <p:spPr>
            <a:xfrm>
              <a:off x="1371852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03" name="pl144"/>
            <p:cNvSpPr/>
            <p:nvPr/>
          </p:nvSpPr>
          <p:spPr>
            <a:xfrm>
              <a:off x="1380240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04" name="pl145"/>
            <p:cNvSpPr/>
            <p:nvPr/>
          </p:nvSpPr>
          <p:spPr>
            <a:xfrm>
              <a:off x="1388664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05" name="pl146"/>
            <p:cNvSpPr/>
            <p:nvPr/>
          </p:nvSpPr>
          <p:spPr>
            <a:xfrm>
              <a:off x="1397052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06" name="pl147"/>
            <p:cNvSpPr/>
            <p:nvPr/>
          </p:nvSpPr>
          <p:spPr>
            <a:xfrm>
              <a:off x="1405440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07" name="pl148"/>
            <p:cNvSpPr/>
            <p:nvPr/>
          </p:nvSpPr>
          <p:spPr>
            <a:xfrm>
              <a:off x="1413828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08" name="pl149"/>
            <p:cNvSpPr/>
            <p:nvPr/>
          </p:nvSpPr>
          <p:spPr>
            <a:xfrm>
              <a:off x="1422216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09" name="pl150"/>
            <p:cNvSpPr/>
            <p:nvPr/>
          </p:nvSpPr>
          <p:spPr>
            <a:xfrm>
              <a:off x="1430604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10" name="pl151"/>
            <p:cNvSpPr/>
            <p:nvPr/>
          </p:nvSpPr>
          <p:spPr>
            <a:xfrm>
              <a:off x="1439028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11" name="pl152"/>
            <p:cNvSpPr/>
            <p:nvPr/>
          </p:nvSpPr>
          <p:spPr>
            <a:xfrm>
              <a:off x="1447416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12" name="pl153"/>
            <p:cNvSpPr/>
            <p:nvPr/>
          </p:nvSpPr>
          <p:spPr>
            <a:xfrm>
              <a:off x="1455804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13" name="pl154"/>
            <p:cNvSpPr/>
            <p:nvPr/>
          </p:nvSpPr>
          <p:spPr>
            <a:xfrm>
              <a:off x="1464192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14" name="pl155"/>
            <p:cNvSpPr/>
            <p:nvPr/>
          </p:nvSpPr>
          <p:spPr>
            <a:xfrm>
              <a:off x="1472580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15" name="pl156"/>
            <p:cNvSpPr/>
            <p:nvPr/>
          </p:nvSpPr>
          <p:spPr>
            <a:xfrm>
              <a:off x="1480968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16" name="pl157"/>
            <p:cNvSpPr/>
            <p:nvPr/>
          </p:nvSpPr>
          <p:spPr>
            <a:xfrm>
              <a:off x="1489392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17" name="pl158"/>
            <p:cNvSpPr/>
            <p:nvPr/>
          </p:nvSpPr>
          <p:spPr>
            <a:xfrm>
              <a:off x="1497780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18" name="pl159"/>
            <p:cNvSpPr/>
            <p:nvPr/>
          </p:nvSpPr>
          <p:spPr>
            <a:xfrm>
              <a:off x="1506168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19" name="pl160"/>
            <p:cNvSpPr/>
            <p:nvPr/>
          </p:nvSpPr>
          <p:spPr>
            <a:xfrm>
              <a:off x="1514556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20" name="pl161"/>
            <p:cNvSpPr/>
            <p:nvPr/>
          </p:nvSpPr>
          <p:spPr>
            <a:xfrm>
              <a:off x="1522944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21" name="pl162"/>
            <p:cNvSpPr/>
            <p:nvPr/>
          </p:nvSpPr>
          <p:spPr>
            <a:xfrm>
              <a:off x="1531332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22" name="pl163"/>
            <p:cNvSpPr/>
            <p:nvPr/>
          </p:nvSpPr>
          <p:spPr>
            <a:xfrm>
              <a:off x="1539756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23" name="pl164"/>
            <p:cNvSpPr/>
            <p:nvPr/>
          </p:nvSpPr>
          <p:spPr>
            <a:xfrm>
              <a:off x="1548144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24" name="pl165"/>
            <p:cNvSpPr/>
            <p:nvPr/>
          </p:nvSpPr>
          <p:spPr>
            <a:xfrm>
              <a:off x="1556532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25" name="pl166"/>
            <p:cNvSpPr/>
            <p:nvPr/>
          </p:nvSpPr>
          <p:spPr>
            <a:xfrm>
              <a:off x="1564920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26" name="pl167"/>
            <p:cNvSpPr/>
            <p:nvPr/>
          </p:nvSpPr>
          <p:spPr>
            <a:xfrm>
              <a:off x="1573308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27" name="pl168"/>
            <p:cNvSpPr/>
            <p:nvPr/>
          </p:nvSpPr>
          <p:spPr>
            <a:xfrm>
              <a:off x="1581696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28" name="pl169"/>
            <p:cNvSpPr/>
            <p:nvPr/>
          </p:nvSpPr>
          <p:spPr>
            <a:xfrm>
              <a:off x="1590120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29" name="pl170"/>
            <p:cNvSpPr/>
            <p:nvPr/>
          </p:nvSpPr>
          <p:spPr>
            <a:xfrm>
              <a:off x="1598508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30" name="pl171"/>
            <p:cNvSpPr/>
            <p:nvPr/>
          </p:nvSpPr>
          <p:spPr>
            <a:xfrm>
              <a:off x="1606896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31" name="pl172"/>
            <p:cNvSpPr/>
            <p:nvPr/>
          </p:nvSpPr>
          <p:spPr>
            <a:xfrm>
              <a:off x="1615284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32" name="pl173"/>
            <p:cNvSpPr/>
            <p:nvPr/>
          </p:nvSpPr>
          <p:spPr>
            <a:xfrm>
              <a:off x="1623672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33" name="pl174"/>
            <p:cNvSpPr/>
            <p:nvPr/>
          </p:nvSpPr>
          <p:spPr>
            <a:xfrm>
              <a:off x="1632060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34" name="pl175"/>
            <p:cNvSpPr/>
            <p:nvPr/>
          </p:nvSpPr>
          <p:spPr>
            <a:xfrm>
              <a:off x="1640484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35" name="pl176"/>
            <p:cNvSpPr/>
            <p:nvPr/>
          </p:nvSpPr>
          <p:spPr>
            <a:xfrm>
              <a:off x="1648872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36" name="pl177"/>
            <p:cNvSpPr/>
            <p:nvPr/>
          </p:nvSpPr>
          <p:spPr>
            <a:xfrm>
              <a:off x="1657260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37" name="pl178"/>
            <p:cNvSpPr/>
            <p:nvPr/>
          </p:nvSpPr>
          <p:spPr>
            <a:xfrm>
              <a:off x="1665648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38" name="pl179"/>
            <p:cNvSpPr/>
            <p:nvPr/>
          </p:nvSpPr>
          <p:spPr>
            <a:xfrm>
              <a:off x="1674036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39" name="pl180"/>
            <p:cNvSpPr/>
            <p:nvPr/>
          </p:nvSpPr>
          <p:spPr>
            <a:xfrm>
              <a:off x="1682424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40" name="pl181"/>
            <p:cNvSpPr/>
            <p:nvPr/>
          </p:nvSpPr>
          <p:spPr>
            <a:xfrm>
              <a:off x="1690812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41" name="pl182"/>
            <p:cNvSpPr/>
            <p:nvPr/>
          </p:nvSpPr>
          <p:spPr>
            <a:xfrm>
              <a:off x="1699236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42" name="pl183"/>
            <p:cNvSpPr/>
            <p:nvPr/>
          </p:nvSpPr>
          <p:spPr>
            <a:xfrm>
              <a:off x="1707624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43" name="pl184"/>
            <p:cNvSpPr/>
            <p:nvPr/>
          </p:nvSpPr>
          <p:spPr>
            <a:xfrm>
              <a:off x="1716012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44" name="pl185"/>
            <p:cNvSpPr/>
            <p:nvPr/>
          </p:nvSpPr>
          <p:spPr>
            <a:xfrm>
              <a:off x="1724400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45" name="pl186"/>
            <p:cNvSpPr/>
            <p:nvPr/>
          </p:nvSpPr>
          <p:spPr>
            <a:xfrm>
              <a:off x="1732788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46" name="pl187"/>
            <p:cNvSpPr/>
            <p:nvPr/>
          </p:nvSpPr>
          <p:spPr>
            <a:xfrm>
              <a:off x="1741176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47" name="pl188"/>
            <p:cNvSpPr/>
            <p:nvPr/>
          </p:nvSpPr>
          <p:spPr>
            <a:xfrm>
              <a:off x="1749600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48" name="pl189"/>
            <p:cNvSpPr/>
            <p:nvPr/>
          </p:nvSpPr>
          <p:spPr>
            <a:xfrm>
              <a:off x="1757988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49" name="pl190"/>
            <p:cNvSpPr/>
            <p:nvPr/>
          </p:nvSpPr>
          <p:spPr>
            <a:xfrm>
              <a:off x="1766376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50" name="pl191"/>
            <p:cNvSpPr/>
            <p:nvPr/>
          </p:nvSpPr>
          <p:spPr>
            <a:xfrm>
              <a:off x="1774764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51" name="pl192"/>
            <p:cNvSpPr/>
            <p:nvPr/>
          </p:nvSpPr>
          <p:spPr>
            <a:xfrm>
              <a:off x="1783152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52" name="pl193"/>
            <p:cNvSpPr/>
            <p:nvPr/>
          </p:nvSpPr>
          <p:spPr>
            <a:xfrm>
              <a:off x="17915400" y="843012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53" name="tx194"/>
            <p:cNvSpPr/>
            <p:nvPr/>
          </p:nvSpPr>
          <p:spPr>
            <a:xfrm>
              <a:off x="11584080" y="9676080"/>
              <a:ext cx="1236600" cy="11268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zh-CN" sz="1600" spc="-1" strike="noStrike">
                  <a:solidFill>
                    <a:srgbClr val="000000"/>
                  </a:solidFill>
                  <a:latin typeface="Arial"/>
                </a:rPr>
                <a:t>Risk of </a:t>
              </a:r>
              <a:r>
                <a:rPr b="0" lang="en-US" sz="1600" spc="-1" strike="noStrike">
                  <a:solidFill>
                    <a:srgbClr val="000000"/>
                  </a:solidFill>
                  <a:latin typeface="Arial"/>
                </a:rPr>
                <a:t>LNM</a:t>
              </a:r>
              <a:endParaRPr b="0" lang="en-US" sz="1600" spc="-1" strike="noStrike">
                <a:solidFill>
                  <a:srgbClr val="000000"/>
                </a:solidFill>
                <a:latin typeface="Arial"/>
              </a:endParaRPr>
            </a:p>
          </p:txBody>
        </p:sp>
        <p:sp>
          <p:nvSpPr>
            <p:cNvPr id="254" name="pl195"/>
            <p:cNvSpPr/>
            <p:nvPr/>
          </p:nvSpPr>
          <p:spPr>
            <a:xfrm>
              <a:off x="13338360" y="97340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55" name="pl196"/>
            <p:cNvSpPr/>
            <p:nvPr/>
          </p:nvSpPr>
          <p:spPr>
            <a:xfrm>
              <a:off x="13338360" y="973404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56" name="tx197"/>
            <p:cNvSpPr/>
            <p:nvPr/>
          </p:nvSpPr>
          <p:spPr>
            <a:xfrm>
              <a:off x="13248720" y="9865080"/>
              <a:ext cx="179280" cy="9504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0.2</a:t>
              </a:r>
              <a:endParaRPr b="0" lang="en-US" sz="1400" spc="-1" strike="noStrike">
                <a:solidFill>
                  <a:srgbClr val="000000"/>
                </a:solidFill>
                <a:latin typeface="Arial"/>
              </a:endParaRPr>
            </a:p>
          </p:txBody>
        </p:sp>
        <p:sp>
          <p:nvSpPr>
            <p:cNvPr id="257" name="pl198"/>
            <p:cNvSpPr/>
            <p:nvPr/>
          </p:nvSpPr>
          <p:spPr>
            <a:xfrm>
              <a:off x="14208840" y="97340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58" name="pl199"/>
            <p:cNvSpPr/>
            <p:nvPr/>
          </p:nvSpPr>
          <p:spPr>
            <a:xfrm>
              <a:off x="14208840" y="973404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59" name="tx200"/>
            <p:cNvSpPr/>
            <p:nvPr/>
          </p:nvSpPr>
          <p:spPr>
            <a:xfrm>
              <a:off x="14118840" y="9865080"/>
              <a:ext cx="179280" cy="9504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0.3</a:t>
              </a:r>
              <a:endParaRPr b="0" lang="en-US" sz="1400" spc="-1" strike="noStrike">
                <a:solidFill>
                  <a:srgbClr val="000000"/>
                </a:solidFill>
                <a:latin typeface="Arial"/>
              </a:endParaRPr>
            </a:p>
          </p:txBody>
        </p:sp>
        <p:sp>
          <p:nvSpPr>
            <p:cNvPr id="260" name="pl201"/>
            <p:cNvSpPr/>
            <p:nvPr/>
          </p:nvSpPr>
          <p:spPr>
            <a:xfrm>
              <a:off x="14922360" y="97340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61" name="pl202"/>
            <p:cNvSpPr/>
            <p:nvPr/>
          </p:nvSpPr>
          <p:spPr>
            <a:xfrm>
              <a:off x="14922360" y="973404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62" name="tx203"/>
            <p:cNvSpPr/>
            <p:nvPr/>
          </p:nvSpPr>
          <p:spPr>
            <a:xfrm>
              <a:off x="14832000" y="9865080"/>
              <a:ext cx="180720" cy="9504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0.4</a:t>
              </a:r>
              <a:endParaRPr b="0" lang="en-US" sz="1400" spc="-1" strike="noStrike">
                <a:solidFill>
                  <a:srgbClr val="000000"/>
                </a:solidFill>
                <a:latin typeface="Arial"/>
              </a:endParaRPr>
            </a:p>
          </p:txBody>
        </p:sp>
        <p:sp>
          <p:nvSpPr>
            <p:cNvPr id="263" name="pl204"/>
            <p:cNvSpPr/>
            <p:nvPr/>
          </p:nvSpPr>
          <p:spPr>
            <a:xfrm>
              <a:off x="15577200" y="97340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64" name="pl205"/>
            <p:cNvSpPr/>
            <p:nvPr/>
          </p:nvSpPr>
          <p:spPr>
            <a:xfrm>
              <a:off x="15577200" y="973404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65" name="tx206"/>
            <p:cNvSpPr/>
            <p:nvPr/>
          </p:nvSpPr>
          <p:spPr>
            <a:xfrm>
              <a:off x="15487560" y="9865080"/>
              <a:ext cx="179280" cy="9504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0.5</a:t>
              </a:r>
              <a:endParaRPr b="0" lang="en-US" sz="1400" spc="-1" strike="noStrike">
                <a:solidFill>
                  <a:srgbClr val="000000"/>
                </a:solidFill>
                <a:latin typeface="Arial"/>
              </a:endParaRPr>
            </a:p>
          </p:txBody>
        </p:sp>
        <p:sp>
          <p:nvSpPr>
            <p:cNvPr id="266" name="pl207"/>
            <p:cNvSpPr/>
            <p:nvPr/>
          </p:nvSpPr>
          <p:spPr>
            <a:xfrm>
              <a:off x="16232040" y="97340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67" name="pl208"/>
            <p:cNvSpPr/>
            <p:nvPr/>
          </p:nvSpPr>
          <p:spPr>
            <a:xfrm>
              <a:off x="16232040" y="973404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68" name="tx209"/>
            <p:cNvSpPr/>
            <p:nvPr/>
          </p:nvSpPr>
          <p:spPr>
            <a:xfrm>
              <a:off x="16141680" y="9865080"/>
              <a:ext cx="179280" cy="9504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0.6</a:t>
              </a:r>
              <a:endParaRPr b="0" lang="en-US" sz="1400" spc="-1" strike="noStrike">
                <a:solidFill>
                  <a:srgbClr val="000000"/>
                </a:solidFill>
                <a:latin typeface="Arial"/>
              </a:endParaRPr>
            </a:p>
          </p:txBody>
        </p:sp>
        <p:sp>
          <p:nvSpPr>
            <p:cNvPr id="269" name="pl210"/>
            <p:cNvSpPr/>
            <p:nvPr/>
          </p:nvSpPr>
          <p:spPr>
            <a:xfrm>
              <a:off x="16945560" y="97340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70" name="pl211"/>
            <p:cNvSpPr/>
            <p:nvPr/>
          </p:nvSpPr>
          <p:spPr>
            <a:xfrm>
              <a:off x="16945560" y="973404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71" name="tx212"/>
            <p:cNvSpPr/>
            <p:nvPr/>
          </p:nvSpPr>
          <p:spPr>
            <a:xfrm>
              <a:off x="16854480" y="9865080"/>
              <a:ext cx="180720" cy="9504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zh-CN" sz="1400" spc="-1" strike="noStrike">
                  <a:solidFill>
                    <a:srgbClr val="000000"/>
                  </a:solidFill>
                  <a:latin typeface="Arial"/>
                </a:rPr>
                <a:t>0.7</a:t>
              </a:r>
              <a:endParaRPr b="0" lang="en-US" sz="1400" spc="-1" strike="noStrike">
                <a:solidFill>
                  <a:srgbClr val="000000"/>
                </a:solidFill>
                <a:latin typeface="Arial"/>
              </a:endParaRPr>
            </a:p>
          </p:txBody>
        </p:sp>
        <p:sp>
          <p:nvSpPr>
            <p:cNvPr id="272" name="pl213"/>
            <p:cNvSpPr/>
            <p:nvPr/>
          </p:nvSpPr>
          <p:spPr>
            <a:xfrm>
              <a:off x="13338360" y="9734040"/>
              <a:ext cx="3606840" cy="360"/>
            </a:xfrm>
            <a:custGeom>
              <a:avLst/>
              <a:gdLst/>
              <a:ahLst/>
              <a:rect l="l" t="t" r="r" b="b"/>
              <a:pathLst>
                <a:path w="3606377" h="1">
                  <a:moveTo>
                    <a:pt x="0" y="0"/>
                  </a:moveTo>
                  <a:lnTo>
                    <a:pt x="3606377"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73" name="文本框 612"/>
            <p:cNvSpPr/>
            <p:nvPr/>
          </p:nvSpPr>
          <p:spPr>
            <a:xfrm>
              <a:off x="11129400" y="3297240"/>
              <a:ext cx="939600" cy="55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1487520"/>
                  <a:tab algn="l" pos="2975040"/>
                  <a:tab algn="l" pos="4462560"/>
                  <a:tab algn="l" pos="5950080"/>
                  <a:tab algn="l" pos="7437600"/>
                  <a:tab algn="l" pos="8924760"/>
                  <a:tab algn="l" pos="10412280"/>
                </a:tabLst>
              </a:pPr>
              <a:r>
                <a:rPr b="1" lang="en-US" sz="3000" spc="-1" strike="noStrike">
                  <a:solidFill>
                    <a:srgbClr val="000000"/>
                  </a:solidFill>
                  <a:latin typeface="Times New Roman"/>
                </a:rPr>
                <a:t>B</a:t>
              </a:r>
              <a:endParaRPr b="0" lang="en-US" sz="3000" spc="-1" strike="noStrike">
                <a:solidFill>
                  <a:srgbClr val="000000"/>
                </a:solidFill>
                <a:latin typeface="Arial"/>
              </a:endParaRPr>
            </a:p>
          </p:txBody>
        </p:sp>
        <p:sp>
          <p:nvSpPr>
            <p:cNvPr id="274" name="文本框 613"/>
            <p:cNvSpPr/>
            <p:nvPr/>
          </p:nvSpPr>
          <p:spPr>
            <a:xfrm>
              <a:off x="13794120" y="3552840"/>
              <a:ext cx="2880720" cy="3988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1487520"/>
                  <a:tab algn="l" pos="2975040"/>
                  <a:tab algn="l" pos="4462560"/>
                  <a:tab algn="l" pos="5950080"/>
                  <a:tab algn="l" pos="7437600"/>
                  <a:tab algn="l" pos="8924760"/>
                  <a:tab algn="l" pos="10412280"/>
                </a:tabLst>
              </a:pPr>
              <a:r>
                <a:rPr b="0" lang="en-US" sz="2000" spc="-1" strike="noStrike">
                  <a:solidFill>
                    <a:srgbClr val="000000"/>
                  </a:solidFill>
                  <a:latin typeface="Arial"/>
                </a:rPr>
                <a:t>1se nomogram </a:t>
              </a:r>
              <a:endParaRPr b="0" lang="en-US" sz="2000" spc="-1" strike="noStrike">
                <a:solidFill>
                  <a:srgbClr val="000000"/>
                </a:solidFill>
                <a:latin typeface="Arial"/>
              </a:endParaRPr>
            </a:p>
          </p:txBody>
        </p:sp>
      </p:grpSp>
      <p:grpSp>
        <p:nvGrpSpPr>
          <p:cNvPr id="275" name="组合 2"/>
          <p:cNvGrpSpPr/>
          <p:nvPr/>
        </p:nvGrpSpPr>
        <p:grpSpPr>
          <a:xfrm>
            <a:off x="1390680" y="3297240"/>
            <a:ext cx="7945560" cy="7377120"/>
            <a:chOff x="1390680" y="3297240"/>
            <a:chExt cx="7945560" cy="7377120"/>
          </a:xfrm>
        </p:grpSpPr>
        <p:sp>
          <p:nvSpPr>
            <p:cNvPr id="276" name="文本框 610"/>
            <p:cNvSpPr/>
            <p:nvPr/>
          </p:nvSpPr>
          <p:spPr>
            <a:xfrm>
              <a:off x="1890000" y="3297240"/>
              <a:ext cx="938160" cy="55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1487520"/>
                  <a:tab algn="l" pos="2975040"/>
                  <a:tab algn="l" pos="4462560"/>
                  <a:tab algn="l" pos="5950080"/>
                  <a:tab algn="l" pos="7437600"/>
                  <a:tab algn="l" pos="8924760"/>
                  <a:tab algn="l" pos="10412280"/>
                </a:tabLst>
              </a:pPr>
              <a:r>
                <a:rPr b="1" lang="en-US" sz="3000" spc="-1" strike="noStrike">
                  <a:solidFill>
                    <a:srgbClr val="000000"/>
                  </a:solidFill>
                  <a:latin typeface="Times New Roman"/>
                </a:rPr>
                <a:t>A</a:t>
              </a:r>
              <a:endParaRPr b="0" lang="en-US" sz="3000" spc="-1" strike="noStrike">
                <a:solidFill>
                  <a:srgbClr val="000000"/>
                </a:solidFill>
                <a:latin typeface="Arial"/>
              </a:endParaRPr>
            </a:p>
          </p:txBody>
        </p:sp>
        <p:grpSp>
          <p:nvGrpSpPr>
            <p:cNvPr id="277" name="组合 1"/>
            <p:cNvGrpSpPr/>
            <p:nvPr/>
          </p:nvGrpSpPr>
          <p:grpSpPr>
            <a:xfrm>
              <a:off x="1390680" y="3851280"/>
              <a:ext cx="7945560" cy="6823080"/>
              <a:chOff x="1390680" y="3851280"/>
              <a:chExt cx="7945560" cy="6823080"/>
            </a:xfrm>
          </p:grpSpPr>
          <p:sp>
            <p:nvSpPr>
              <p:cNvPr id="278" name="rc3"/>
              <p:cNvSpPr/>
              <p:nvPr/>
            </p:nvSpPr>
            <p:spPr>
              <a:xfrm>
                <a:off x="2334600" y="3851280"/>
                <a:ext cx="6850800" cy="6591960"/>
              </a:xfrm>
              <a:prstGeom prst="rect">
                <a:avLst/>
              </a:prstGeom>
              <a:solidFill>
                <a:srgbClr val="ffffff"/>
              </a:solidFill>
              <a:ln cap="rnd" w="9360">
                <a:solidFill>
                  <a:srgbClr val="ffffff"/>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79" name="rc4"/>
              <p:cNvSpPr/>
              <p:nvPr/>
            </p:nvSpPr>
            <p:spPr>
              <a:xfrm>
                <a:off x="2273040" y="4027680"/>
                <a:ext cx="6850800" cy="6591960"/>
              </a:xfrm>
              <a:prstGeom prst="rect">
                <a:avLst/>
              </a:prstGeom>
              <a:solidFill>
                <a:srgbClr val="ffffff"/>
              </a:solidFill>
              <a:ln cap="rnd" w="13680">
                <a:solidFill>
                  <a:srgbClr val="ffffff"/>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80" name="rc5"/>
              <p:cNvSpPr/>
              <p:nvPr/>
            </p:nvSpPr>
            <p:spPr>
              <a:xfrm>
                <a:off x="3280680" y="3913920"/>
                <a:ext cx="4517280" cy="617364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81" name="pl6"/>
              <p:cNvSpPr/>
              <p:nvPr/>
            </p:nvSpPr>
            <p:spPr>
              <a:xfrm>
                <a:off x="3896640" y="3913920"/>
                <a:ext cx="360" cy="6173640"/>
              </a:xfrm>
              <a:custGeom>
                <a:avLst/>
                <a:gdLst/>
                <a:ahLst/>
                <a:rect l="l" t="t" r="r" b="b"/>
                <a:pathLst>
                  <a:path w="1" h="6850972">
                    <a:moveTo>
                      <a:pt x="0" y="6850972"/>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82" name="pl7"/>
              <p:cNvSpPr/>
              <p:nvPr/>
            </p:nvSpPr>
            <p:spPr>
              <a:xfrm>
                <a:off x="4307400" y="3913920"/>
                <a:ext cx="360" cy="6173640"/>
              </a:xfrm>
              <a:custGeom>
                <a:avLst/>
                <a:gdLst/>
                <a:ahLst/>
                <a:rect l="l" t="t" r="r" b="b"/>
                <a:pathLst>
                  <a:path w="1" h="6850972">
                    <a:moveTo>
                      <a:pt x="0" y="6850972"/>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83" name="pl8"/>
              <p:cNvSpPr/>
              <p:nvPr/>
            </p:nvSpPr>
            <p:spPr>
              <a:xfrm>
                <a:off x="5128560" y="3913920"/>
                <a:ext cx="360" cy="6173640"/>
              </a:xfrm>
              <a:custGeom>
                <a:avLst/>
                <a:gdLst/>
                <a:ahLst/>
                <a:rect l="l" t="t" r="r" b="b"/>
                <a:pathLst>
                  <a:path w="1" h="6850972">
                    <a:moveTo>
                      <a:pt x="0" y="6850972"/>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84" name="pl9"/>
              <p:cNvSpPr/>
              <p:nvPr/>
            </p:nvSpPr>
            <p:spPr>
              <a:xfrm>
                <a:off x="5950080" y="3913920"/>
                <a:ext cx="360" cy="6173640"/>
              </a:xfrm>
              <a:custGeom>
                <a:avLst/>
                <a:gdLst/>
                <a:ahLst/>
                <a:rect l="l" t="t" r="r" b="b"/>
                <a:pathLst>
                  <a:path w="1" h="6850972">
                    <a:moveTo>
                      <a:pt x="0" y="6850972"/>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85" name="pl10"/>
              <p:cNvSpPr/>
              <p:nvPr/>
            </p:nvSpPr>
            <p:spPr>
              <a:xfrm>
                <a:off x="6771240" y="3913920"/>
                <a:ext cx="360" cy="6173640"/>
              </a:xfrm>
              <a:custGeom>
                <a:avLst/>
                <a:gdLst/>
                <a:ahLst/>
                <a:rect l="l" t="t" r="r" b="b"/>
                <a:pathLst>
                  <a:path w="1" h="6850972">
                    <a:moveTo>
                      <a:pt x="0" y="6850972"/>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86" name="pl11"/>
              <p:cNvSpPr/>
              <p:nvPr/>
            </p:nvSpPr>
            <p:spPr>
              <a:xfrm>
                <a:off x="7182000" y="3913920"/>
                <a:ext cx="360" cy="6173640"/>
              </a:xfrm>
              <a:custGeom>
                <a:avLst/>
                <a:gdLst/>
                <a:ahLst/>
                <a:rect l="l" t="t" r="r" b="b"/>
                <a:pathLst>
                  <a:path w="1" h="6850972">
                    <a:moveTo>
                      <a:pt x="0" y="6850972"/>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87" name="pl12"/>
              <p:cNvSpPr/>
              <p:nvPr/>
            </p:nvSpPr>
            <p:spPr>
              <a:xfrm>
                <a:off x="3280680" y="9375480"/>
                <a:ext cx="4517280" cy="360"/>
              </a:xfrm>
              <a:custGeom>
                <a:avLst/>
                <a:gdLst/>
                <a:ahLst/>
                <a:rect l="l" t="t" r="r" b="b"/>
                <a:pathLst>
                  <a:path w="4823701" h="1">
                    <a:moveTo>
                      <a:pt x="0" y="0"/>
                    </a:moveTo>
                    <a:lnTo>
                      <a:pt x="4823701"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88" name="pl13"/>
              <p:cNvSpPr/>
              <p:nvPr/>
            </p:nvSpPr>
            <p:spPr>
              <a:xfrm>
                <a:off x="3280680" y="8188200"/>
                <a:ext cx="4517280" cy="360"/>
              </a:xfrm>
              <a:custGeom>
                <a:avLst/>
                <a:gdLst/>
                <a:ahLst/>
                <a:rect l="l" t="t" r="r" b="b"/>
                <a:pathLst>
                  <a:path w="4823701" h="1">
                    <a:moveTo>
                      <a:pt x="0" y="0"/>
                    </a:moveTo>
                    <a:lnTo>
                      <a:pt x="4823701"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89" name="pl14"/>
              <p:cNvSpPr/>
              <p:nvPr/>
            </p:nvSpPr>
            <p:spPr>
              <a:xfrm>
                <a:off x="3280680" y="7000920"/>
                <a:ext cx="4517280" cy="360"/>
              </a:xfrm>
              <a:custGeom>
                <a:avLst/>
                <a:gdLst/>
                <a:ahLst/>
                <a:rect l="l" t="t" r="r" b="b"/>
                <a:pathLst>
                  <a:path w="4823701" h="1">
                    <a:moveTo>
                      <a:pt x="0" y="0"/>
                    </a:moveTo>
                    <a:lnTo>
                      <a:pt x="4823701"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90" name="pl15"/>
              <p:cNvSpPr/>
              <p:nvPr/>
            </p:nvSpPr>
            <p:spPr>
              <a:xfrm>
                <a:off x="3280680" y="5813640"/>
                <a:ext cx="4517280" cy="360"/>
              </a:xfrm>
              <a:custGeom>
                <a:avLst/>
                <a:gdLst/>
                <a:ahLst/>
                <a:rect l="l" t="t" r="r" b="b"/>
                <a:pathLst>
                  <a:path w="4823701" h="1">
                    <a:moveTo>
                      <a:pt x="0" y="0"/>
                    </a:moveTo>
                    <a:lnTo>
                      <a:pt x="4823701"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91" name="pl16"/>
              <p:cNvSpPr/>
              <p:nvPr/>
            </p:nvSpPr>
            <p:spPr>
              <a:xfrm>
                <a:off x="3280680" y="4626360"/>
                <a:ext cx="4517280" cy="360"/>
              </a:xfrm>
              <a:custGeom>
                <a:avLst/>
                <a:gdLst/>
                <a:ahLst/>
                <a:rect l="l" t="t" r="r" b="b"/>
                <a:pathLst>
                  <a:path w="4823701" h="1">
                    <a:moveTo>
                      <a:pt x="0" y="0"/>
                    </a:moveTo>
                    <a:lnTo>
                      <a:pt x="4823701"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92" name="pl17"/>
              <p:cNvSpPr/>
              <p:nvPr/>
            </p:nvSpPr>
            <p:spPr>
              <a:xfrm>
                <a:off x="4718160" y="3913920"/>
                <a:ext cx="360" cy="6173640"/>
              </a:xfrm>
              <a:custGeom>
                <a:avLst/>
                <a:gdLst/>
                <a:ahLst/>
                <a:rect l="l" t="t" r="r" b="b"/>
                <a:pathLst>
                  <a:path w="1" h="6850972">
                    <a:moveTo>
                      <a:pt x="0" y="6850972"/>
                    </a:moveTo>
                    <a:lnTo>
                      <a:pt x="0" y="0"/>
                    </a:lnTo>
                  </a:path>
                </a:pathLst>
              </a:custGeom>
              <a:noFill/>
              <a:ln w="1368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93" name="pl18"/>
              <p:cNvSpPr/>
              <p:nvPr/>
            </p:nvSpPr>
            <p:spPr>
              <a:xfrm>
                <a:off x="5539320" y="3913920"/>
                <a:ext cx="360" cy="6173640"/>
              </a:xfrm>
              <a:custGeom>
                <a:avLst/>
                <a:gdLst/>
                <a:ahLst/>
                <a:rect l="l" t="t" r="r" b="b"/>
                <a:pathLst>
                  <a:path w="1" h="6850972">
                    <a:moveTo>
                      <a:pt x="0" y="6850972"/>
                    </a:moveTo>
                    <a:lnTo>
                      <a:pt x="0" y="0"/>
                    </a:lnTo>
                  </a:path>
                </a:pathLst>
              </a:custGeom>
              <a:noFill/>
              <a:ln w="1368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94" name="pl19"/>
              <p:cNvSpPr/>
              <p:nvPr/>
            </p:nvSpPr>
            <p:spPr>
              <a:xfrm>
                <a:off x="6360840" y="3913920"/>
                <a:ext cx="360" cy="6173640"/>
              </a:xfrm>
              <a:custGeom>
                <a:avLst/>
                <a:gdLst/>
                <a:ahLst/>
                <a:rect l="l" t="t" r="r" b="b"/>
                <a:pathLst>
                  <a:path w="1" h="6850972">
                    <a:moveTo>
                      <a:pt x="0" y="6850972"/>
                    </a:moveTo>
                    <a:lnTo>
                      <a:pt x="0" y="0"/>
                    </a:lnTo>
                  </a:path>
                </a:pathLst>
              </a:custGeom>
              <a:noFill/>
              <a:ln w="1368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95" name="rc20"/>
              <p:cNvSpPr/>
              <p:nvPr/>
            </p:nvSpPr>
            <p:spPr>
              <a:xfrm>
                <a:off x="3485880" y="8840880"/>
                <a:ext cx="410400" cy="1068480"/>
              </a:xfrm>
              <a:prstGeom prst="rect">
                <a:avLst/>
              </a:prstGeom>
              <a:solidFill>
                <a:srgbClr val="0072b5"/>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96" name="rc21"/>
              <p:cNvSpPr/>
              <p:nvPr/>
            </p:nvSpPr>
            <p:spPr>
              <a:xfrm>
                <a:off x="3485880" y="7653600"/>
                <a:ext cx="410400" cy="1068480"/>
              </a:xfrm>
              <a:prstGeom prst="rect">
                <a:avLst/>
              </a:prstGeom>
              <a:solidFill>
                <a:srgbClr val="0072b5"/>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97" name="rc22"/>
              <p:cNvSpPr/>
              <p:nvPr/>
            </p:nvSpPr>
            <p:spPr>
              <a:xfrm>
                <a:off x="3485880" y="6466320"/>
                <a:ext cx="821160" cy="1068480"/>
              </a:xfrm>
              <a:prstGeom prst="rect">
                <a:avLst/>
              </a:prstGeom>
              <a:solidFill>
                <a:srgbClr val="0072b5"/>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98" name="rc23"/>
              <p:cNvSpPr/>
              <p:nvPr/>
            </p:nvSpPr>
            <p:spPr>
              <a:xfrm>
                <a:off x="3485880" y="5279040"/>
                <a:ext cx="2874600" cy="1068480"/>
              </a:xfrm>
              <a:prstGeom prst="rect">
                <a:avLst/>
              </a:prstGeom>
              <a:solidFill>
                <a:srgbClr val="bc3c29"/>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299" name="rc24"/>
              <p:cNvSpPr/>
              <p:nvPr/>
            </p:nvSpPr>
            <p:spPr>
              <a:xfrm>
                <a:off x="3485880" y="4091760"/>
                <a:ext cx="4106520" cy="1068480"/>
              </a:xfrm>
              <a:prstGeom prst="rect">
                <a:avLst/>
              </a:prstGeom>
              <a:solidFill>
                <a:srgbClr val="bc3c29"/>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00" name="rc25"/>
              <p:cNvSpPr/>
              <p:nvPr/>
            </p:nvSpPr>
            <p:spPr>
              <a:xfrm>
                <a:off x="3280680" y="3913920"/>
                <a:ext cx="4517280" cy="6173640"/>
              </a:xfrm>
              <a:prstGeom prst="rect">
                <a:avLst/>
              </a:prstGeom>
              <a:noFill/>
              <a:ln cap="rnd" w="13680">
                <a:solidFill>
                  <a:srgbClr val="333333"/>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01" name="tx26"/>
              <p:cNvSpPr/>
              <p:nvPr/>
            </p:nvSpPr>
            <p:spPr>
              <a:xfrm>
                <a:off x="2152800" y="9352440"/>
                <a:ext cx="669960" cy="7452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en-US" sz="1600" spc="-1" strike="noStrike">
                    <a:solidFill>
                      <a:srgbClr val="4d4d4d"/>
                    </a:solidFill>
                    <a:latin typeface="Arial"/>
                  </a:rPr>
                  <a:t> </a:t>
                </a:r>
                <a:r>
                  <a:rPr b="0" lang="zh-CN" sz="1600" spc="-1" strike="noStrike">
                    <a:solidFill>
                      <a:srgbClr val="4d4d4d"/>
                    </a:solidFill>
                    <a:latin typeface="Arial"/>
                  </a:rPr>
                  <a:t>CA19</a:t>
                </a:r>
                <a:r>
                  <a:rPr b="0" lang="en-US" sz="1600" spc="-1" strike="noStrike">
                    <a:solidFill>
                      <a:srgbClr val="4d4d4d"/>
                    </a:solidFill>
                    <a:latin typeface="Arial"/>
                  </a:rPr>
                  <a:t>-</a:t>
                </a:r>
                <a:r>
                  <a:rPr b="0" lang="zh-CN" sz="1600" spc="-1" strike="noStrike">
                    <a:solidFill>
                      <a:srgbClr val="4d4d4d"/>
                    </a:solidFill>
                    <a:latin typeface="Arial"/>
                  </a:rPr>
                  <a:t>9</a:t>
                </a:r>
                <a:r>
                  <a:rPr b="0" lang="en-US" sz="1600" spc="-1" strike="noStrike">
                    <a:solidFill>
                      <a:srgbClr val="4d4d4d"/>
                    </a:solidFill>
                    <a:latin typeface="Arial"/>
                  </a:rPr>
                  <a:t>/</a:t>
                </a:r>
                <a:r>
                  <a:rPr b="0" lang="zh-CN" sz="1600" spc="-1" strike="noStrike">
                    <a:solidFill>
                      <a:srgbClr val="4d4d4d"/>
                    </a:solidFill>
                    <a:latin typeface="Arial"/>
                  </a:rPr>
                  <a:t>CA153</a:t>
                </a:r>
                <a:endParaRPr b="0" lang="en-US" sz="1600" spc="-1" strike="noStrike">
                  <a:solidFill>
                    <a:srgbClr val="000000"/>
                  </a:solidFill>
                  <a:latin typeface="Arial"/>
                </a:endParaRPr>
              </a:p>
            </p:txBody>
          </p:sp>
          <p:sp>
            <p:nvSpPr>
              <p:cNvPr id="302" name="tx27"/>
              <p:cNvSpPr/>
              <p:nvPr/>
            </p:nvSpPr>
            <p:spPr>
              <a:xfrm>
                <a:off x="2081160" y="8204400"/>
                <a:ext cx="563400" cy="7452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zh-CN" sz="1600" spc="-1" strike="noStrike">
                    <a:solidFill>
                      <a:srgbClr val="4d4d4d"/>
                    </a:solidFill>
                    <a:latin typeface="Arial"/>
                  </a:rPr>
                  <a:t>CEA</a:t>
                </a:r>
                <a:r>
                  <a:rPr b="0" lang="en-US" sz="1600" spc="-1" strike="noStrike">
                    <a:solidFill>
                      <a:srgbClr val="4d4d4d"/>
                    </a:solidFill>
                    <a:latin typeface="Arial"/>
                  </a:rPr>
                  <a:t>/</a:t>
                </a:r>
                <a:r>
                  <a:rPr b="0" lang="zh-CN" sz="1600" spc="-1" strike="noStrike">
                    <a:solidFill>
                      <a:srgbClr val="4d4d4d"/>
                    </a:solidFill>
                    <a:latin typeface="Arial"/>
                  </a:rPr>
                  <a:t>CA153</a:t>
                </a:r>
                <a:endParaRPr b="0" lang="en-US" sz="1600" spc="-1" strike="noStrike">
                  <a:solidFill>
                    <a:srgbClr val="000000"/>
                  </a:solidFill>
                  <a:latin typeface="Arial"/>
                </a:endParaRPr>
              </a:p>
            </p:txBody>
          </p:sp>
          <p:sp>
            <p:nvSpPr>
              <p:cNvPr id="303" name="tx28"/>
              <p:cNvSpPr/>
              <p:nvPr/>
            </p:nvSpPr>
            <p:spPr>
              <a:xfrm>
                <a:off x="2057040" y="6934320"/>
                <a:ext cx="484200" cy="9180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en-US" sz="1600" spc="-1" strike="noStrike">
                    <a:solidFill>
                      <a:srgbClr val="4d4d4d"/>
                    </a:solidFill>
                    <a:latin typeface="Arial"/>
                  </a:rPr>
                  <a:t>  </a:t>
                </a:r>
                <a:r>
                  <a:rPr b="0" lang="en-US" sz="1600" spc="-1" strike="noStrike">
                    <a:solidFill>
                      <a:srgbClr val="4d4d4d"/>
                    </a:solidFill>
                    <a:latin typeface="Arial"/>
                  </a:rPr>
                  <a:t>C</a:t>
                </a:r>
                <a:r>
                  <a:rPr b="0" lang="zh-CN" sz="1600" spc="-1" strike="noStrike">
                    <a:solidFill>
                      <a:srgbClr val="4d4d4d"/>
                    </a:solidFill>
                    <a:latin typeface="Arial"/>
                  </a:rPr>
                  <a:t>utoff_</a:t>
                </a:r>
                <a:r>
                  <a:rPr b="0" lang="en-US" sz="1600" spc="-1" strike="noStrike">
                    <a:solidFill>
                      <a:srgbClr val="4d4d4d"/>
                    </a:solidFill>
                    <a:latin typeface="Arial"/>
                  </a:rPr>
                  <a:t>CEA</a:t>
                </a:r>
                <a:endParaRPr b="0" lang="en-US" sz="1600" spc="-1" strike="noStrike">
                  <a:solidFill>
                    <a:srgbClr val="000000"/>
                  </a:solidFill>
                  <a:latin typeface="Arial"/>
                </a:endParaRPr>
              </a:p>
            </p:txBody>
          </p:sp>
          <p:sp>
            <p:nvSpPr>
              <p:cNvPr id="304" name="tx29"/>
              <p:cNvSpPr/>
              <p:nvPr/>
            </p:nvSpPr>
            <p:spPr>
              <a:xfrm>
                <a:off x="2129040" y="5756040"/>
                <a:ext cx="598320" cy="9180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en-US" sz="1600" spc="-1" strike="noStrike">
                    <a:solidFill>
                      <a:srgbClr val="4d4d4d"/>
                    </a:solidFill>
                    <a:latin typeface="Arial"/>
                  </a:rPr>
                  <a:t>   </a:t>
                </a:r>
                <a:r>
                  <a:rPr b="0" lang="en-US" sz="1600" spc="-1" strike="noStrike">
                    <a:solidFill>
                      <a:srgbClr val="4d4d4d"/>
                    </a:solidFill>
                    <a:latin typeface="Arial"/>
                  </a:rPr>
                  <a:t>C</a:t>
                </a:r>
                <a:r>
                  <a:rPr b="0" lang="zh-CN" sz="1600" spc="-1" strike="noStrike">
                    <a:solidFill>
                      <a:srgbClr val="4d4d4d"/>
                    </a:solidFill>
                    <a:latin typeface="Arial"/>
                  </a:rPr>
                  <a:t>utoff_</a:t>
                </a:r>
                <a:r>
                  <a:rPr b="0" lang="en-US" sz="1600" spc="-1" strike="noStrike">
                    <a:solidFill>
                      <a:srgbClr val="4d4d4d"/>
                    </a:solidFill>
                    <a:latin typeface="Arial"/>
                  </a:rPr>
                  <a:t>CA</a:t>
                </a:r>
                <a:r>
                  <a:rPr b="0" lang="zh-CN" sz="1600" spc="-1" strike="noStrike">
                    <a:solidFill>
                      <a:srgbClr val="4d4d4d"/>
                    </a:solidFill>
                    <a:latin typeface="Arial"/>
                  </a:rPr>
                  <a:t>19</a:t>
                </a:r>
                <a:r>
                  <a:rPr b="0" lang="en-US" sz="1600" spc="-1" strike="noStrike">
                    <a:solidFill>
                      <a:srgbClr val="4d4d4d"/>
                    </a:solidFill>
                    <a:latin typeface="Arial"/>
                  </a:rPr>
                  <a:t>-</a:t>
                </a:r>
                <a:r>
                  <a:rPr b="0" lang="zh-CN" sz="1600" spc="-1" strike="noStrike">
                    <a:solidFill>
                      <a:srgbClr val="4d4d4d"/>
                    </a:solidFill>
                    <a:latin typeface="Arial"/>
                  </a:rPr>
                  <a:t>9</a:t>
                </a:r>
                <a:endParaRPr b="0" lang="en-US" sz="1600" spc="-1" strike="noStrike">
                  <a:solidFill>
                    <a:srgbClr val="000000"/>
                  </a:solidFill>
                  <a:latin typeface="Arial"/>
                </a:endParaRPr>
              </a:p>
            </p:txBody>
          </p:sp>
          <p:sp>
            <p:nvSpPr>
              <p:cNvPr id="305" name="tx30"/>
              <p:cNvSpPr/>
              <p:nvPr/>
            </p:nvSpPr>
            <p:spPr>
              <a:xfrm>
                <a:off x="1390680" y="4532040"/>
                <a:ext cx="576000" cy="15840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en-US" sz="1600" spc="-1" strike="noStrike">
                    <a:solidFill>
                      <a:srgbClr val="4d4d4d"/>
                    </a:solidFill>
                    <a:latin typeface="Arial"/>
                  </a:rPr>
                  <a:t>                 </a:t>
                </a:r>
                <a:r>
                  <a:rPr b="0" lang="zh-CN" sz="1600" spc="-1" strike="noStrike">
                    <a:solidFill>
                      <a:srgbClr val="4d4d4d"/>
                    </a:solidFill>
                    <a:latin typeface="Arial"/>
                  </a:rPr>
                  <a:t>T</a:t>
                </a:r>
                <a:r>
                  <a:rPr b="0" lang="en-US" sz="1600" spc="-1" strike="noStrike">
                    <a:solidFill>
                      <a:srgbClr val="4d4d4d"/>
                    </a:solidFill>
                    <a:latin typeface="Arial"/>
                  </a:rPr>
                  <a:t> stage</a:t>
                </a:r>
                <a:endParaRPr b="0" lang="en-US" sz="1600" spc="-1" strike="noStrike">
                  <a:solidFill>
                    <a:srgbClr val="000000"/>
                  </a:solidFill>
                  <a:latin typeface="Arial"/>
                </a:endParaRPr>
              </a:p>
            </p:txBody>
          </p:sp>
          <p:sp>
            <p:nvSpPr>
              <p:cNvPr id="306" name="pl31"/>
              <p:cNvSpPr/>
              <p:nvPr/>
            </p:nvSpPr>
            <p:spPr>
              <a:xfrm>
                <a:off x="3247920" y="9375480"/>
                <a:ext cx="3240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07" name="pl32"/>
              <p:cNvSpPr/>
              <p:nvPr/>
            </p:nvSpPr>
            <p:spPr>
              <a:xfrm>
                <a:off x="3247920" y="8188200"/>
                <a:ext cx="3240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08" name="pl33"/>
              <p:cNvSpPr/>
              <p:nvPr/>
            </p:nvSpPr>
            <p:spPr>
              <a:xfrm>
                <a:off x="3247920" y="7000920"/>
                <a:ext cx="3240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09" name="pl34"/>
              <p:cNvSpPr/>
              <p:nvPr/>
            </p:nvSpPr>
            <p:spPr>
              <a:xfrm>
                <a:off x="3247920" y="5813640"/>
                <a:ext cx="3240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10" name="pl35"/>
              <p:cNvSpPr/>
              <p:nvPr/>
            </p:nvSpPr>
            <p:spPr>
              <a:xfrm>
                <a:off x="3247920" y="4626360"/>
                <a:ext cx="3240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11" name="pl36"/>
              <p:cNvSpPr/>
              <p:nvPr/>
            </p:nvSpPr>
            <p:spPr>
              <a:xfrm>
                <a:off x="4718160" y="10087560"/>
                <a:ext cx="360" cy="31320"/>
              </a:xfrm>
              <a:custGeom>
                <a:avLst/>
                <a:gdLst/>
                <a:ahLst/>
                <a:rect l="l" t="t" r="r" b="b"/>
                <a:pathLst>
                  <a:path w="1" h="34794">
                    <a:moveTo>
                      <a:pt x="0" y="34794"/>
                    </a:moveTo>
                    <a:lnTo>
                      <a:pt x="0" y="0"/>
                    </a:lnTo>
                  </a:path>
                </a:pathLst>
              </a:custGeom>
              <a:noFill/>
              <a:ln w="13680">
                <a:solidFill>
                  <a:srgbClr val="333333"/>
                </a:solidFill>
                <a:round/>
              </a:ln>
            </p:spPr>
            <p:style>
              <a:lnRef idx="0"/>
              <a:fillRef idx="0"/>
              <a:effectRef idx="0"/>
              <a:fontRef idx="minor"/>
            </p:style>
            <p:txBody>
              <a:bodyPr lIns="90000" rIns="90000" tIns="-15480" bIns="-154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12" name="pl37"/>
              <p:cNvSpPr/>
              <p:nvPr/>
            </p:nvSpPr>
            <p:spPr>
              <a:xfrm>
                <a:off x="5539320" y="10087560"/>
                <a:ext cx="360" cy="31320"/>
              </a:xfrm>
              <a:custGeom>
                <a:avLst/>
                <a:gdLst/>
                <a:ahLst/>
                <a:rect l="l" t="t" r="r" b="b"/>
                <a:pathLst>
                  <a:path w="1" h="34794">
                    <a:moveTo>
                      <a:pt x="0" y="34794"/>
                    </a:moveTo>
                    <a:lnTo>
                      <a:pt x="0" y="0"/>
                    </a:lnTo>
                  </a:path>
                </a:pathLst>
              </a:custGeom>
              <a:noFill/>
              <a:ln w="13680">
                <a:solidFill>
                  <a:srgbClr val="333333"/>
                </a:solidFill>
                <a:round/>
              </a:ln>
            </p:spPr>
            <p:style>
              <a:lnRef idx="0"/>
              <a:fillRef idx="0"/>
              <a:effectRef idx="0"/>
              <a:fontRef idx="minor"/>
            </p:style>
            <p:txBody>
              <a:bodyPr lIns="90000" rIns="90000" tIns="-15480" bIns="-154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13" name="pl38"/>
              <p:cNvSpPr/>
              <p:nvPr/>
            </p:nvSpPr>
            <p:spPr>
              <a:xfrm>
                <a:off x="6360840" y="10087560"/>
                <a:ext cx="360" cy="31320"/>
              </a:xfrm>
              <a:custGeom>
                <a:avLst/>
                <a:gdLst/>
                <a:ahLst/>
                <a:rect l="l" t="t" r="r" b="b"/>
                <a:pathLst>
                  <a:path w="1" h="34794">
                    <a:moveTo>
                      <a:pt x="0" y="34794"/>
                    </a:moveTo>
                    <a:lnTo>
                      <a:pt x="0" y="0"/>
                    </a:lnTo>
                  </a:path>
                </a:pathLst>
              </a:custGeom>
              <a:noFill/>
              <a:ln w="13680">
                <a:solidFill>
                  <a:srgbClr val="333333"/>
                </a:solidFill>
                <a:round/>
              </a:ln>
            </p:spPr>
            <p:style>
              <a:lnRef idx="0"/>
              <a:fillRef idx="0"/>
              <a:effectRef idx="0"/>
              <a:fontRef idx="minor"/>
            </p:style>
            <p:txBody>
              <a:bodyPr lIns="90000" rIns="90000" tIns="-15480" bIns="-154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14" name="tx39"/>
              <p:cNvSpPr/>
              <p:nvPr/>
            </p:nvSpPr>
            <p:spPr>
              <a:xfrm>
                <a:off x="4689360" y="10287360"/>
                <a:ext cx="58680" cy="7272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zh-CN" sz="1600" spc="-1" strike="noStrike">
                    <a:solidFill>
                      <a:srgbClr val="4d4d4d"/>
                    </a:solidFill>
                    <a:latin typeface="Arial"/>
                  </a:rPr>
                  <a:t>3</a:t>
                </a:r>
                <a:endParaRPr b="0" lang="en-US" sz="1600" spc="-1" strike="noStrike">
                  <a:solidFill>
                    <a:srgbClr val="000000"/>
                  </a:solidFill>
                  <a:latin typeface="Arial"/>
                </a:endParaRPr>
              </a:p>
            </p:txBody>
          </p:sp>
          <p:sp>
            <p:nvSpPr>
              <p:cNvPr id="315" name="tx40"/>
              <p:cNvSpPr/>
              <p:nvPr/>
            </p:nvSpPr>
            <p:spPr>
              <a:xfrm>
                <a:off x="5511600" y="10288800"/>
                <a:ext cx="56880" cy="7128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zh-CN" sz="1600" spc="-1" strike="noStrike">
                    <a:solidFill>
                      <a:srgbClr val="4d4d4d"/>
                    </a:solidFill>
                    <a:latin typeface="Arial"/>
                  </a:rPr>
                  <a:t>5</a:t>
                </a:r>
                <a:endParaRPr b="0" lang="en-US" sz="1600" spc="-1" strike="noStrike">
                  <a:solidFill>
                    <a:srgbClr val="000000"/>
                  </a:solidFill>
                  <a:latin typeface="Arial"/>
                </a:endParaRPr>
              </a:p>
            </p:txBody>
          </p:sp>
          <p:sp>
            <p:nvSpPr>
              <p:cNvPr id="316" name="tx41"/>
              <p:cNvSpPr/>
              <p:nvPr/>
            </p:nvSpPr>
            <p:spPr>
              <a:xfrm>
                <a:off x="6332400" y="10288800"/>
                <a:ext cx="56880" cy="7128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zh-CN" sz="1600" spc="-1" strike="noStrike">
                    <a:solidFill>
                      <a:srgbClr val="4d4d4d"/>
                    </a:solidFill>
                    <a:latin typeface="Arial"/>
                  </a:rPr>
                  <a:t>7</a:t>
                </a:r>
                <a:endParaRPr b="0" lang="en-US" sz="1600" spc="-1" strike="noStrike">
                  <a:solidFill>
                    <a:srgbClr val="000000"/>
                  </a:solidFill>
                  <a:latin typeface="Arial"/>
                </a:endParaRPr>
              </a:p>
            </p:txBody>
          </p:sp>
          <p:sp>
            <p:nvSpPr>
              <p:cNvPr id="317" name="tx42"/>
              <p:cNvSpPr/>
              <p:nvPr/>
            </p:nvSpPr>
            <p:spPr>
              <a:xfrm>
                <a:off x="4793400" y="10581480"/>
                <a:ext cx="1585080" cy="92880"/>
              </a:xfrm>
              <a:prstGeom prst="rect">
                <a:avLst/>
              </a:prstGeom>
              <a:noFill/>
              <a:ln w="0">
                <a:noFill/>
              </a:ln>
            </p:spPr>
            <p:style>
              <a:lnRef idx="0"/>
              <a:fillRef idx="0"/>
              <a:effectRef idx="0"/>
              <a:fontRef idx="minor"/>
            </p:style>
            <p:txBody>
              <a:bodyPr wrap="none" lIns="0" rIns="0" tIns="0" bIns="0" anchor="ctr" anchorCtr="1">
                <a:noAutofit/>
              </a:bodyPr>
              <a:p>
                <a:pPr>
                  <a:lnSpc>
                    <a:spcPts val="1100"/>
                  </a:lnSpc>
                  <a:tabLst>
                    <a:tab algn="l" pos="0"/>
                    <a:tab algn="l" pos="1487520"/>
                    <a:tab algn="l" pos="2975040"/>
                    <a:tab algn="l" pos="4462560"/>
                    <a:tab algn="l" pos="5950080"/>
                    <a:tab algn="l" pos="7437600"/>
                    <a:tab algn="l" pos="8924760"/>
                    <a:tab algn="l" pos="10412280"/>
                  </a:tabLst>
                </a:pPr>
                <a:r>
                  <a:rPr b="0" lang="zh-CN" sz="1600" spc="-1" strike="noStrike">
                    <a:solidFill>
                      <a:srgbClr val="000000"/>
                    </a:solidFill>
                    <a:latin typeface="Arial"/>
                  </a:rPr>
                  <a:t>Times of variables selected</a:t>
                </a:r>
                <a:endParaRPr b="0" lang="en-US" sz="1600" spc="-1" strike="noStrike">
                  <a:solidFill>
                    <a:srgbClr val="000000"/>
                  </a:solidFill>
                  <a:latin typeface="Arial"/>
                </a:endParaRPr>
              </a:p>
            </p:txBody>
          </p:sp>
          <p:sp>
            <p:nvSpPr>
              <p:cNvPr id="318" name="tx44"/>
              <p:cNvSpPr/>
              <p:nvPr/>
            </p:nvSpPr>
            <p:spPr>
              <a:xfrm>
                <a:off x="8267400" y="6619320"/>
                <a:ext cx="1068840" cy="91440"/>
              </a:xfrm>
              <a:prstGeom prst="rect">
                <a:avLst/>
              </a:prstGeom>
              <a:noFill/>
              <a:ln w="0">
                <a:noFill/>
              </a:ln>
            </p:spPr>
            <p:style>
              <a:lnRef idx="0"/>
              <a:fillRef idx="0"/>
              <a:effectRef idx="0"/>
              <a:fontRef idx="minor"/>
            </p:style>
            <p:txBody>
              <a:bodyPr wrap="none" lIns="0" rIns="0" tIns="0" bIns="0" anchor="ctr" anchorCtr="1">
                <a:noAutofit/>
              </a:bodyPr>
              <a:p>
                <a:pPr>
                  <a:lnSpc>
                    <a:spcPts val="1100"/>
                  </a:lnSpc>
                  <a:tabLst>
                    <a:tab algn="l" pos="0"/>
                    <a:tab algn="l" pos="1487520"/>
                    <a:tab algn="l" pos="2975040"/>
                    <a:tab algn="l" pos="4462560"/>
                    <a:tab algn="l" pos="5950080"/>
                    <a:tab algn="l" pos="7437600"/>
                    <a:tab algn="l" pos="8924760"/>
                    <a:tab algn="l" pos="10412280"/>
                  </a:tabLst>
                </a:pPr>
                <a:r>
                  <a:rPr b="0" lang="zh-CN" sz="1600" spc="-1" strike="noStrike">
                    <a:solidFill>
                      <a:srgbClr val="000000"/>
                    </a:solidFill>
                    <a:latin typeface="Arial"/>
                  </a:rPr>
                  <a:t>Variables selected</a:t>
                </a:r>
                <a:endParaRPr b="0" lang="en-US" sz="1600" spc="-1" strike="noStrike">
                  <a:solidFill>
                    <a:srgbClr val="000000"/>
                  </a:solidFill>
                  <a:latin typeface="Arial"/>
                </a:endParaRPr>
              </a:p>
            </p:txBody>
          </p:sp>
          <p:sp>
            <p:nvSpPr>
              <p:cNvPr id="319" name="rc45"/>
              <p:cNvSpPr/>
              <p:nvPr/>
            </p:nvSpPr>
            <p:spPr>
              <a:xfrm>
                <a:off x="7993800" y="6898680"/>
                <a:ext cx="205200" cy="19764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20" name="rc46"/>
              <p:cNvSpPr/>
              <p:nvPr/>
            </p:nvSpPr>
            <p:spPr>
              <a:xfrm>
                <a:off x="8002080" y="6843240"/>
                <a:ext cx="188640" cy="181440"/>
              </a:xfrm>
              <a:prstGeom prst="rect">
                <a:avLst/>
              </a:prstGeom>
              <a:solidFill>
                <a:srgbClr val="bc3c29"/>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21" name="rc47"/>
              <p:cNvSpPr/>
              <p:nvPr/>
            </p:nvSpPr>
            <p:spPr>
              <a:xfrm>
                <a:off x="7993800" y="7096320"/>
                <a:ext cx="205200" cy="19764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22" name="rc48"/>
              <p:cNvSpPr/>
              <p:nvPr/>
            </p:nvSpPr>
            <p:spPr>
              <a:xfrm>
                <a:off x="8002080" y="7104600"/>
                <a:ext cx="188640" cy="181440"/>
              </a:xfrm>
              <a:prstGeom prst="rect">
                <a:avLst/>
              </a:prstGeom>
              <a:solidFill>
                <a:srgbClr val="0072b5"/>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23" name="tx49"/>
              <p:cNvSpPr/>
              <p:nvPr/>
            </p:nvSpPr>
            <p:spPr>
              <a:xfrm>
                <a:off x="8538480" y="6944760"/>
                <a:ext cx="433080" cy="7128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zh-CN" sz="1600" spc="-1" strike="noStrike">
                    <a:solidFill>
                      <a:srgbClr val="000000"/>
                    </a:solidFill>
                    <a:latin typeface="Arial"/>
                  </a:rPr>
                  <a:t>&gt; median</a:t>
                </a:r>
                <a:endParaRPr b="0" lang="en-US" sz="1600" spc="-1" strike="noStrike">
                  <a:solidFill>
                    <a:srgbClr val="000000"/>
                  </a:solidFill>
                  <a:latin typeface="Arial"/>
                </a:endParaRPr>
              </a:p>
            </p:txBody>
          </p:sp>
          <p:sp>
            <p:nvSpPr>
              <p:cNvPr id="324" name="tx50"/>
              <p:cNvSpPr/>
              <p:nvPr/>
            </p:nvSpPr>
            <p:spPr>
              <a:xfrm>
                <a:off x="8538480" y="7196400"/>
                <a:ext cx="495000" cy="7272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zh-CN" sz="1600" spc="-1" strike="noStrike">
                    <a:solidFill>
                      <a:srgbClr val="000000"/>
                    </a:solidFill>
                    <a:latin typeface="Arial"/>
                  </a:rPr>
                  <a:t>&lt;= median</a:t>
                </a:r>
                <a:endParaRPr b="0" lang="en-US" sz="1600" spc="-1" strike="noStrike">
                  <a:solidFill>
                    <a:srgbClr val="000000"/>
                  </a:solidFill>
                  <a:latin typeface="Arial"/>
                </a:endParaRPr>
              </a:p>
            </p:txBody>
          </p:sp>
        </p:grpSp>
      </p:grpSp>
      <p:sp>
        <p:nvSpPr>
          <p:cNvPr id="325" name="文本框 270"/>
          <p:cNvSpPr/>
          <p:nvPr/>
        </p:nvSpPr>
        <p:spPr>
          <a:xfrm>
            <a:off x="2057400" y="11144160"/>
            <a:ext cx="17570520" cy="302004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1487520"/>
                <a:tab algn="l" pos="2975040"/>
                <a:tab algn="l" pos="4462560"/>
                <a:tab algn="l" pos="5950080"/>
                <a:tab algn="l" pos="7437600"/>
                <a:tab algn="l" pos="8924760"/>
                <a:tab algn="l" pos="10412280"/>
              </a:tabLst>
            </a:pPr>
            <a:r>
              <a:rPr b="1" lang="en-US" sz="2400" spc="-1" strike="noStrike">
                <a:solidFill>
                  <a:srgbClr val="000000"/>
                </a:solidFill>
                <a:latin typeface="Times New Roman"/>
              </a:rPr>
              <a:t>Figure S2</a:t>
            </a:r>
            <a:r>
              <a:rPr b="0" lang="en-US" sz="2400" spc="-1" strike="noStrike">
                <a:solidFill>
                  <a:srgbClr val="000000"/>
                </a:solidFill>
                <a:latin typeface="Times New Roman"/>
              </a:rPr>
              <a:t>. The multivariate selection and nomogram for LNM. </a:t>
            </a:r>
            <a:endParaRPr b="0" lang="en-US" sz="2400" spc="-1" strike="noStrike">
              <a:solidFill>
                <a:srgbClr val="000000"/>
              </a:solidFill>
              <a:latin typeface="Arial"/>
            </a:endParaRPr>
          </a:p>
          <a:p>
            <a:pPr algn="just">
              <a:lnSpc>
                <a:spcPct val="100000"/>
              </a:lnSpc>
              <a:tabLst>
                <a:tab algn="l" pos="0"/>
                <a:tab algn="l" pos="1487520"/>
                <a:tab algn="l" pos="2975040"/>
                <a:tab algn="l" pos="4462560"/>
                <a:tab algn="l" pos="5950080"/>
                <a:tab algn="l" pos="7437600"/>
                <a:tab algn="l" pos="8924760"/>
                <a:tab algn="l" pos="10412280"/>
              </a:tabLst>
            </a:pPr>
            <a:r>
              <a:rPr b="0" lang="en-US" sz="2400" spc="-1" strike="noStrike">
                <a:solidFill>
                  <a:srgbClr val="000000"/>
                </a:solidFill>
                <a:latin typeface="Times New Roman"/>
              </a:rPr>
              <a:t>(A) Based on 1 standard error of the minimum criteria (1se) results of 10 times LASSO calculation, we chosen the variables, of which selected times were greater than the median selected times, to build the LNM model. (B) The nomogram was developed in the primary cohort, based on the 1se, with cutoff_CA19-9 and tumor stage. </a:t>
            </a:r>
            <a:endParaRPr b="0" lang="en-US" sz="2400" spc="-1" strike="noStrike">
              <a:solidFill>
                <a:srgbClr val="000000"/>
              </a:solidFill>
              <a:latin typeface="Arial"/>
            </a:endParaRPr>
          </a:p>
          <a:p>
            <a:pPr algn="just">
              <a:lnSpc>
                <a:spcPct val="100000"/>
              </a:lnSpc>
              <a:tabLst>
                <a:tab algn="l" pos="0"/>
                <a:tab algn="l" pos="1487520"/>
                <a:tab algn="l" pos="2975040"/>
                <a:tab algn="l" pos="4462560"/>
                <a:tab algn="l" pos="5950080"/>
                <a:tab algn="l" pos="7437600"/>
                <a:tab algn="l" pos="8924760"/>
                <a:tab algn="l" pos="10412280"/>
              </a:tabLst>
            </a:pPr>
            <a:r>
              <a:rPr b="0" lang="en-US" sz="2400" spc="-1" strike="noStrike">
                <a:solidFill>
                  <a:srgbClr val="000000"/>
                </a:solidFill>
                <a:latin typeface="Times New Roman"/>
              </a:rPr>
              <a:t>Nomogram read guidance: Score each variable according to its value level (represented by Points line on the nomogram), and then add the scores of each variable to get the total score (represented by Total points line on the nomogram). The probability corresponding to the vertical line of the total score is the probability of LNM in patients, and the higher the score, the higher the probability of LNM.</a:t>
            </a:r>
            <a:endParaRPr b="0" lang="en-US" sz="2400" spc="-1" strike="noStrike">
              <a:solidFill>
                <a:srgbClr val="000000"/>
              </a:solidFill>
              <a:latin typeface="Arial"/>
            </a:endParaRPr>
          </a:p>
          <a:p>
            <a:pPr algn="just">
              <a:lnSpc>
                <a:spcPct val="100000"/>
              </a:lnSpc>
              <a:tabLst>
                <a:tab algn="l" pos="0"/>
                <a:tab algn="l" pos="1487520"/>
                <a:tab algn="l" pos="2975040"/>
                <a:tab algn="l" pos="4462560"/>
                <a:tab algn="l" pos="5950080"/>
                <a:tab algn="l" pos="7437600"/>
                <a:tab algn="l" pos="8924760"/>
                <a:tab algn="l" pos="10412280"/>
              </a:tabLst>
            </a:pPr>
            <a:r>
              <a:rPr b="0" lang="en-US" sz="2400" spc="-1" strike="noStrike">
                <a:solidFill>
                  <a:srgbClr val="000000"/>
                </a:solidFill>
                <a:latin typeface="Times New Roman"/>
              </a:rPr>
              <a:t>CA, carbohydrate antigen. LNM: Lymph node metastasis. </a:t>
            </a:r>
            <a:endParaRPr b="0" lang="en-US" sz="2400" spc="-1" strike="noStrike">
              <a:solidFill>
                <a:srgbClr val="000000"/>
              </a:solidFill>
              <a:latin typeface="Arial"/>
            </a:endParaRPr>
          </a:p>
        </p:txBody>
      </p:sp>
      <p:sp>
        <p:nvSpPr>
          <p:cNvPr id="326" name="tx77"/>
          <p:cNvSpPr/>
          <p:nvPr/>
        </p:nvSpPr>
        <p:spPr>
          <a:xfrm>
            <a:off x="17525880" y="5578560"/>
            <a:ext cx="527040" cy="17280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r>
              <a:rPr b="0" lang="en-US" sz="1400" spc="-1" strike="noStrike">
                <a:solidFill>
                  <a:srgbClr val="000000"/>
                </a:solidFill>
                <a:latin typeface="Arial"/>
              </a:rPr>
              <a:t>Above</a:t>
            </a:r>
            <a:r>
              <a:rPr b="0" lang="en-US" sz="1400" spc="-1" strike="noStrike" baseline="30000">
                <a:solidFill>
                  <a:srgbClr val="000000"/>
                </a:solidFill>
                <a:latin typeface="Arial"/>
              </a:rPr>
              <a:t>cut-off</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327" name="图片 513" descr=""/>
          <p:cNvPicPr/>
          <p:nvPr/>
        </p:nvPicPr>
        <p:blipFill>
          <a:blip r:embed="rId1"/>
          <a:stretch/>
        </p:blipFill>
        <p:spPr>
          <a:xfrm>
            <a:off x="112680" y="3727440"/>
            <a:ext cx="7050240" cy="6912000"/>
          </a:xfrm>
          <a:prstGeom prst="rect">
            <a:avLst/>
          </a:prstGeom>
          <a:ln w="0">
            <a:noFill/>
          </a:ln>
        </p:spPr>
      </p:pic>
      <p:sp>
        <p:nvSpPr>
          <p:cNvPr id="328" name="文本框 317"/>
          <p:cNvSpPr/>
          <p:nvPr/>
        </p:nvSpPr>
        <p:spPr>
          <a:xfrm>
            <a:off x="401760" y="1927080"/>
            <a:ext cx="2152440" cy="55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1487520"/>
                <a:tab algn="l" pos="2975040"/>
                <a:tab algn="l" pos="4462560"/>
                <a:tab algn="l" pos="5950080"/>
                <a:tab algn="l" pos="7437600"/>
                <a:tab algn="l" pos="8924760"/>
                <a:tab algn="l" pos="10412280"/>
              </a:tabLst>
            </a:pPr>
            <a:r>
              <a:rPr b="1" lang="en-US" sz="3000" spc="-1" strike="noStrike">
                <a:solidFill>
                  <a:srgbClr val="000000"/>
                </a:solidFill>
                <a:latin typeface="Times New Roman"/>
              </a:rPr>
              <a:t>Fig.S3</a:t>
            </a:r>
            <a:endParaRPr b="0" lang="en-US" sz="3000" spc="-1" strike="noStrike">
              <a:solidFill>
                <a:srgbClr val="000000"/>
              </a:solidFill>
              <a:latin typeface="Arial"/>
            </a:endParaRPr>
          </a:p>
        </p:txBody>
      </p:sp>
      <p:sp>
        <p:nvSpPr>
          <p:cNvPr id="329" name="文本框 312"/>
          <p:cNvSpPr/>
          <p:nvPr/>
        </p:nvSpPr>
        <p:spPr>
          <a:xfrm>
            <a:off x="473040" y="3079800"/>
            <a:ext cx="939960" cy="55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1487520"/>
                <a:tab algn="l" pos="2975040"/>
                <a:tab algn="l" pos="4462560"/>
                <a:tab algn="l" pos="5950080"/>
                <a:tab algn="l" pos="7437600"/>
                <a:tab algn="l" pos="8924760"/>
                <a:tab algn="l" pos="10412280"/>
              </a:tabLst>
            </a:pPr>
            <a:r>
              <a:rPr b="1" lang="en-US" sz="3000" spc="-1" strike="noStrike">
                <a:solidFill>
                  <a:srgbClr val="000000"/>
                </a:solidFill>
                <a:latin typeface="Times New Roman"/>
              </a:rPr>
              <a:t>A</a:t>
            </a:r>
            <a:endParaRPr b="0" lang="en-US" sz="3000" spc="-1" strike="noStrike">
              <a:solidFill>
                <a:srgbClr val="000000"/>
              </a:solidFill>
              <a:latin typeface="Arial"/>
            </a:endParaRPr>
          </a:p>
        </p:txBody>
      </p:sp>
      <p:sp>
        <p:nvSpPr>
          <p:cNvPr id="330" name="文本框 313"/>
          <p:cNvSpPr/>
          <p:nvPr/>
        </p:nvSpPr>
        <p:spPr>
          <a:xfrm>
            <a:off x="7458120" y="3079800"/>
            <a:ext cx="939600" cy="55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1487520"/>
                <a:tab algn="l" pos="2975040"/>
                <a:tab algn="l" pos="4462560"/>
                <a:tab algn="l" pos="5950080"/>
                <a:tab algn="l" pos="7437600"/>
                <a:tab algn="l" pos="8924760"/>
                <a:tab algn="l" pos="10412280"/>
              </a:tabLst>
            </a:pPr>
            <a:r>
              <a:rPr b="1" lang="en-US" sz="3000" spc="-1" strike="noStrike">
                <a:solidFill>
                  <a:srgbClr val="000000"/>
                </a:solidFill>
                <a:latin typeface="Times New Roman"/>
              </a:rPr>
              <a:t>B</a:t>
            </a:r>
            <a:endParaRPr b="0" lang="en-US" sz="3000" spc="-1" strike="noStrike">
              <a:solidFill>
                <a:srgbClr val="000000"/>
              </a:solidFill>
              <a:latin typeface="Arial"/>
            </a:endParaRPr>
          </a:p>
        </p:txBody>
      </p:sp>
      <p:grpSp>
        <p:nvGrpSpPr>
          <p:cNvPr id="331" name="组合 3"/>
          <p:cNvGrpSpPr/>
          <p:nvPr/>
        </p:nvGrpSpPr>
        <p:grpSpPr>
          <a:xfrm>
            <a:off x="6934320" y="3440160"/>
            <a:ext cx="7126200" cy="7329600"/>
            <a:chOff x="6934320" y="3440160"/>
            <a:chExt cx="7126200" cy="7329600"/>
          </a:xfrm>
        </p:grpSpPr>
        <p:sp>
          <p:nvSpPr>
            <p:cNvPr id="332" name="tx36"/>
            <p:cNvSpPr/>
            <p:nvPr/>
          </p:nvSpPr>
          <p:spPr>
            <a:xfrm>
              <a:off x="6934320" y="3871800"/>
              <a:ext cx="1440360" cy="40752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zh-CN" sz="1600" spc="-1" strike="noStrike">
                  <a:solidFill>
                    <a:srgbClr val="4d4d4d"/>
                  </a:solidFill>
                  <a:latin typeface="Arial"/>
                </a:rPr>
                <a:t>T</a:t>
              </a:r>
              <a:r>
                <a:rPr b="0" lang="en-US" sz="1600" spc="-1" strike="noStrike">
                  <a:solidFill>
                    <a:srgbClr val="4d4d4d"/>
                  </a:solidFill>
                  <a:latin typeface="Arial"/>
                </a:rPr>
                <a:t> stage</a:t>
              </a:r>
              <a:endParaRPr b="0" lang="en-US" sz="1600" spc="-1" strike="noStrike">
                <a:solidFill>
                  <a:srgbClr val="000000"/>
                </a:solidFill>
                <a:latin typeface="Arial"/>
              </a:endParaRPr>
            </a:p>
          </p:txBody>
        </p:sp>
        <p:grpSp>
          <p:nvGrpSpPr>
            <p:cNvPr id="333" name="组合 2"/>
            <p:cNvGrpSpPr/>
            <p:nvPr/>
          </p:nvGrpSpPr>
          <p:grpSpPr>
            <a:xfrm>
              <a:off x="7528680" y="3440160"/>
              <a:ext cx="6531840" cy="7329600"/>
              <a:chOff x="7528680" y="3440160"/>
              <a:chExt cx="6531840" cy="7329600"/>
            </a:xfrm>
          </p:grpSpPr>
          <p:sp>
            <p:nvSpPr>
              <p:cNvPr id="334" name="rc5"/>
              <p:cNvSpPr/>
              <p:nvPr/>
            </p:nvSpPr>
            <p:spPr>
              <a:xfrm>
                <a:off x="8992080" y="3586320"/>
                <a:ext cx="4824720" cy="684972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35" name="pl6"/>
              <p:cNvSpPr/>
              <p:nvPr/>
            </p:nvSpPr>
            <p:spPr>
              <a:xfrm>
                <a:off x="9465120" y="3440160"/>
                <a:ext cx="360" cy="6849720"/>
              </a:xfrm>
              <a:custGeom>
                <a:avLst/>
                <a:gdLst/>
                <a:ahLst/>
                <a:rect l="l" t="t" r="r" b="b"/>
                <a:pathLst>
                  <a:path w="1" h="6850972">
                    <a:moveTo>
                      <a:pt x="0" y="6850972"/>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36" name="pl7"/>
              <p:cNvSpPr/>
              <p:nvPr/>
            </p:nvSpPr>
            <p:spPr>
              <a:xfrm>
                <a:off x="9903960" y="3440160"/>
                <a:ext cx="360" cy="6849720"/>
              </a:xfrm>
              <a:custGeom>
                <a:avLst/>
                <a:gdLst/>
                <a:ahLst/>
                <a:rect l="l" t="t" r="r" b="b"/>
                <a:pathLst>
                  <a:path w="1" h="6850972">
                    <a:moveTo>
                      <a:pt x="0" y="6850972"/>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37" name="pl8"/>
              <p:cNvSpPr/>
              <p:nvPr/>
            </p:nvSpPr>
            <p:spPr>
              <a:xfrm>
                <a:off x="10781280" y="3440160"/>
                <a:ext cx="360" cy="6849720"/>
              </a:xfrm>
              <a:custGeom>
                <a:avLst/>
                <a:gdLst/>
                <a:ahLst/>
                <a:rect l="l" t="t" r="r" b="b"/>
                <a:pathLst>
                  <a:path w="1" h="6850972">
                    <a:moveTo>
                      <a:pt x="0" y="6850972"/>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38" name="pl9"/>
              <p:cNvSpPr/>
              <p:nvPr/>
            </p:nvSpPr>
            <p:spPr>
              <a:xfrm>
                <a:off x="11658600" y="3440160"/>
                <a:ext cx="360" cy="6849720"/>
              </a:xfrm>
              <a:custGeom>
                <a:avLst/>
                <a:gdLst/>
                <a:ahLst/>
                <a:rect l="l" t="t" r="r" b="b"/>
                <a:pathLst>
                  <a:path w="1" h="6850972">
                    <a:moveTo>
                      <a:pt x="0" y="6850972"/>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39" name="pl10"/>
              <p:cNvSpPr/>
              <p:nvPr/>
            </p:nvSpPr>
            <p:spPr>
              <a:xfrm>
                <a:off x="12535920" y="3440160"/>
                <a:ext cx="360" cy="6849720"/>
              </a:xfrm>
              <a:custGeom>
                <a:avLst/>
                <a:gdLst/>
                <a:ahLst/>
                <a:rect l="l" t="t" r="r" b="b"/>
                <a:pathLst>
                  <a:path w="1" h="6850972">
                    <a:moveTo>
                      <a:pt x="0" y="6850972"/>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40" name="pl11"/>
              <p:cNvSpPr/>
              <p:nvPr/>
            </p:nvSpPr>
            <p:spPr>
              <a:xfrm>
                <a:off x="12974400" y="3440160"/>
                <a:ext cx="360" cy="6849720"/>
              </a:xfrm>
              <a:custGeom>
                <a:avLst/>
                <a:gdLst/>
                <a:ahLst/>
                <a:rect l="l" t="t" r="r" b="b"/>
                <a:pathLst>
                  <a:path w="1" h="6850972">
                    <a:moveTo>
                      <a:pt x="0" y="6850972"/>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41" name="pl12"/>
              <p:cNvSpPr/>
              <p:nvPr/>
            </p:nvSpPr>
            <p:spPr>
              <a:xfrm>
                <a:off x="8807400" y="9719280"/>
                <a:ext cx="4824720" cy="360"/>
              </a:xfrm>
              <a:custGeom>
                <a:avLst/>
                <a:gdLst/>
                <a:ahLst/>
                <a:rect l="l" t="t" r="r" b="b"/>
                <a:pathLst>
                  <a:path w="4823701" h="1">
                    <a:moveTo>
                      <a:pt x="0" y="0"/>
                    </a:moveTo>
                    <a:lnTo>
                      <a:pt x="4823701"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42" name="pl13"/>
              <p:cNvSpPr/>
              <p:nvPr/>
            </p:nvSpPr>
            <p:spPr>
              <a:xfrm>
                <a:off x="8807400" y="8767800"/>
                <a:ext cx="4824720" cy="360"/>
              </a:xfrm>
              <a:custGeom>
                <a:avLst/>
                <a:gdLst/>
                <a:ahLst/>
                <a:rect l="l" t="t" r="r" b="b"/>
                <a:pathLst>
                  <a:path w="4823701" h="1">
                    <a:moveTo>
                      <a:pt x="0" y="0"/>
                    </a:moveTo>
                    <a:lnTo>
                      <a:pt x="4823701"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43" name="pl14"/>
              <p:cNvSpPr/>
              <p:nvPr/>
            </p:nvSpPr>
            <p:spPr>
              <a:xfrm>
                <a:off x="8807400" y="7816320"/>
                <a:ext cx="4824720" cy="360"/>
              </a:xfrm>
              <a:custGeom>
                <a:avLst/>
                <a:gdLst/>
                <a:ahLst/>
                <a:rect l="l" t="t" r="r" b="b"/>
                <a:pathLst>
                  <a:path w="4823701" h="1">
                    <a:moveTo>
                      <a:pt x="0" y="0"/>
                    </a:moveTo>
                    <a:lnTo>
                      <a:pt x="4823701"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44" name="pl15"/>
              <p:cNvSpPr/>
              <p:nvPr/>
            </p:nvSpPr>
            <p:spPr>
              <a:xfrm>
                <a:off x="8807400" y="6864840"/>
                <a:ext cx="4824720" cy="360"/>
              </a:xfrm>
              <a:custGeom>
                <a:avLst/>
                <a:gdLst/>
                <a:ahLst/>
                <a:rect l="l" t="t" r="r" b="b"/>
                <a:pathLst>
                  <a:path w="4823701" h="1">
                    <a:moveTo>
                      <a:pt x="0" y="0"/>
                    </a:moveTo>
                    <a:lnTo>
                      <a:pt x="4823701"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45" name="pl16"/>
              <p:cNvSpPr/>
              <p:nvPr/>
            </p:nvSpPr>
            <p:spPr>
              <a:xfrm>
                <a:off x="8807400" y="5913720"/>
                <a:ext cx="4824720" cy="360"/>
              </a:xfrm>
              <a:custGeom>
                <a:avLst/>
                <a:gdLst/>
                <a:ahLst/>
                <a:rect l="l" t="t" r="r" b="b"/>
                <a:pathLst>
                  <a:path w="4823701" h="1">
                    <a:moveTo>
                      <a:pt x="0" y="0"/>
                    </a:moveTo>
                    <a:lnTo>
                      <a:pt x="4823701"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46" name="pl17"/>
              <p:cNvSpPr/>
              <p:nvPr/>
            </p:nvSpPr>
            <p:spPr>
              <a:xfrm>
                <a:off x="8807400" y="4962240"/>
                <a:ext cx="4824720" cy="360"/>
              </a:xfrm>
              <a:custGeom>
                <a:avLst/>
                <a:gdLst/>
                <a:ahLst/>
                <a:rect l="l" t="t" r="r" b="b"/>
                <a:pathLst>
                  <a:path w="4823701" h="1">
                    <a:moveTo>
                      <a:pt x="0" y="0"/>
                    </a:moveTo>
                    <a:lnTo>
                      <a:pt x="4823701"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47" name="pl18"/>
              <p:cNvSpPr/>
              <p:nvPr/>
            </p:nvSpPr>
            <p:spPr>
              <a:xfrm>
                <a:off x="8807400" y="4010760"/>
                <a:ext cx="4824720" cy="360"/>
              </a:xfrm>
              <a:custGeom>
                <a:avLst/>
                <a:gdLst/>
                <a:ahLst/>
                <a:rect l="l" t="t" r="r" b="b"/>
                <a:pathLst>
                  <a:path w="4823701" h="1">
                    <a:moveTo>
                      <a:pt x="0" y="0"/>
                    </a:moveTo>
                    <a:lnTo>
                      <a:pt x="4823701"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48" name="pl19"/>
              <p:cNvSpPr/>
              <p:nvPr/>
            </p:nvSpPr>
            <p:spPr>
              <a:xfrm>
                <a:off x="10342440" y="3440160"/>
                <a:ext cx="360" cy="6849720"/>
              </a:xfrm>
              <a:custGeom>
                <a:avLst/>
                <a:gdLst/>
                <a:ahLst/>
                <a:rect l="l" t="t" r="r" b="b"/>
                <a:pathLst>
                  <a:path w="1" h="6850972">
                    <a:moveTo>
                      <a:pt x="0" y="6850972"/>
                    </a:moveTo>
                    <a:lnTo>
                      <a:pt x="0" y="0"/>
                    </a:lnTo>
                  </a:path>
                </a:pathLst>
              </a:custGeom>
              <a:noFill/>
              <a:ln w="1368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49" name="pl20"/>
              <p:cNvSpPr/>
              <p:nvPr/>
            </p:nvSpPr>
            <p:spPr>
              <a:xfrm>
                <a:off x="11219760" y="3440160"/>
                <a:ext cx="360" cy="6849720"/>
              </a:xfrm>
              <a:custGeom>
                <a:avLst/>
                <a:gdLst/>
                <a:ahLst/>
                <a:rect l="l" t="t" r="r" b="b"/>
                <a:pathLst>
                  <a:path w="1" h="6850972">
                    <a:moveTo>
                      <a:pt x="0" y="6850972"/>
                    </a:moveTo>
                    <a:lnTo>
                      <a:pt x="0" y="0"/>
                    </a:lnTo>
                  </a:path>
                </a:pathLst>
              </a:custGeom>
              <a:noFill/>
              <a:ln w="1368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50" name="pl21"/>
              <p:cNvSpPr/>
              <p:nvPr/>
            </p:nvSpPr>
            <p:spPr>
              <a:xfrm>
                <a:off x="12097080" y="3440160"/>
                <a:ext cx="360" cy="6849720"/>
              </a:xfrm>
              <a:custGeom>
                <a:avLst/>
                <a:gdLst/>
                <a:ahLst/>
                <a:rect l="l" t="t" r="r" b="b"/>
                <a:pathLst>
                  <a:path w="1" h="6850972">
                    <a:moveTo>
                      <a:pt x="0" y="6850972"/>
                    </a:moveTo>
                    <a:lnTo>
                      <a:pt x="0" y="0"/>
                    </a:lnTo>
                  </a:path>
                </a:pathLst>
              </a:custGeom>
              <a:noFill/>
              <a:ln w="1368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51" name="rc22"/>
              <p:cNvSpPr/>
              <p:nvPr/>
            </p:nvSpPr>
            <p:spPr>
              <a:xfrm>
                <a:off x="9026640" y="9290880"/>
                <a:ext cx="438480" cy="856080"/>
              </a:xfrm>
              <a:prstGeom prst="rect">
                <a:avLst/>
              </a:prstGeom>
              <a:solidFill>
                <a:srgbClr val="0072b5"/>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52" name="rc23"/>
              <p:cNvSpPr/>
              <p:nvPr/>
            </p:nvSpPr>
            <p:spPr>
              <a:xfrm>
                <a:off x="9026640" y="8339760"/>
                <a:ext cx="438480" cy="856080"/>
              </a:xfrm>
              <a:prstGeom prst="rect">
                <a:avLst/>
              </a:prstGeom>
              <a:solidFill>
                <a:srgbClr val="0072b5"/>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53" name="rc24"/>
              <p:cNvSpPr/>
              <p:nvPr/>
            </p:nvSpPr>
            <p:spPr>
              <a:xfrm>
                <a:off x="9026640" y="7388280"/>
                <a:ext cx="438480" cy="856080"/>
              </a:xfrm>
              <a:prstGeom prst="rect">
                <a:avLst/>
              </a:prstGeom>
              <a:solidFill>
                <a:srgbClr val="0072b5"/>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54" name="rc25"/>
              <p:cNvSpPr/>
              <p:nvPr/>
            </p:nvSpPr>
            <p:spPr>
              <a:xfrm>
                <a:off x="9026640" y="6436800"/>
                <a:ext cx="876960" cy="856080"/>
              </a:xfrm>
              <a:prstGeom prst="rect">
                <a:avLst/>
              </a:prstGeom>
              <a:solidFill>
                <a:srgbClr val="0072b5"/>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55" name="rc26"/>
              <p:cNvSpPr/>
              <p:nvPr/>
            </p:nvSpPr>
            <p:spPr>
              <a:xfrm>
                <a:off x="9026640" y="5485320"/>
                <a:ext cx="876960" cy="856080"/>
              </a:xfrm>
              <a:prstGeom prst="rect">
                <a:avLst/>
              </a:prstGeom>
              <a:solidFill>
                <a:srgbClr val="0072b5"/>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56" name="rc27"/>
              <p:cNvSpPr/>
              <p:nvPr/>
            </p:nvSpPr>
            <p:spPr>
              <a:xfrm>
                <a:off x="9026640" y="4534200"/>
                <a:ext cx="3947760" cy="856080"/>
              </a:xfrm>
              <a:prstGeom prst="rect">
                <a:avLst/>
              </a:prstGeom>
              <a:solidFill>
                <a:srgbClr val="bc3c29"/>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57" name="rc28"/>
              <p:cNvSpPr/>
              <p:nvPr/>
            </p:nvSpPr>
            <p:spPr>
              <a:xfrm>
                <a:off x="9026640" y="3582720"/>
                <a:ext cx="4386240" cy="856080"/>
              </a:xfrm>
              <a:prstGeom prst="rect">
                <a:avLst/>
              </a:prstGeom>
              <a:solidFill>
                <a:srgbClr val="bc3c29"/>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58" name="rc29"/>
              <p:cNvSpPr/>
              <p:nvPr/>
            </p:nvSpPr>
            <p:spPr>
              <a:xfrm>
                <a:off x="8807400" y="3440160"/>
                <a:ext cx="4824720" cy="6849720"/>
              </a:xfrm>
              <a:prstGeom prst="rect">
                <a:avLst/>
              </a:prstGeom>
              <a:noFill/>
              <a:ln cap="rnd" w="13680">
                <a:solidFill>
                  <a:srgbClr val="333333"/>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59" name="tx30"/>
              <p:cNvSpPr/>
              <p:nvPr/>
            </p:nvSpPr>
            <p:spPr>
              <a:xfrm>
                <a:off x="7629840" y="9676800"/>
                <a:ext cx="714240" cy="8244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en-US" sz="1600" spc="-1" strike="noStrike">
                    <a:solidFill>
                      <a:srgbClr val="4d4d4d"/>
                    </a:solidFill>
                    <a:latin typeface="Arial"/>
                  </a:rPr>
                  <a:t>  </a:t>
                </a:r>
                <a:r>
                  <a:rPr b="0" lang="zh-CN" sz="1600" spc="-1" strike="noStrike">
                    <a:solidFill>
                      <a:srgbClr val="4d4d4d"/>
                    </a:solidFill>
                    <a:latin typeface="Arial"/>
                  </a:rPr>
                  <a:t>CA19</a:t>
                </a:r>
                <a:r>
                  <a:rPr b="0" lang="en-US" sz="1600" spc="-1" strike="noStrike">
                    <a:solidFill>
                      <a:srgbClr val="4d4d4d"/>
                    </a:solidFill>
                    <a:latin typeface="Arial"/>
                  </a:rPr>
                  <a:t>-</a:t>
                </a:r>
                <a:r>
                  <a:rPr b="0" lang="zh-CN" sz="1600" spc="-1" strike="noStrike">
                    <a:solidFill>
                      <a:srgbClr val="4d4d4d"/>
                    </a:solidFill>
                    <a:latin typeface="Arial"/>
                  </a:rPr>
                  <a:t>9</a:t>
                </a:r>
                <a:r>
                  <a:rPr b="0" lang="en-US" sz="1600" spc="-1" strike="noStrike">
                    <a:solidFill>
                      <a:srgbClr val="4d4d4d"/>
                    </a:solidFill>
                    <a:latin typeface="Arial"/>
                  </a:rPr>
                  <a:t>/</a:t>
                </a:r>
                <a:r>
                  <a:rPr b="0" lang="zh-CN" sz="1600" spc="-1" strike="noStrike">
                    <a:solidFill>
                      <a:srgbClr val="4d4d4d"/>
                    </a:solidFill>
                    <a:latin typeface="Arial"/>
                  </a:rPr>
                  <a:t>CA153</a:t>
                </a:r>
                <a:endParaRPr b="0" lang="en-US" sz="1600" spc="-1" strike="noStrike">
                  <a:solidFill>
                    <a:srgbClr val="000000"/>
                  </a:solidFill>
                  <a:latin typeface="Arial"/>
                </a:endParaRPr>
              </a:p>
            </p:txBody>
          </p:sp>
          <p:sp>
            <p:nvSpPr>
              <p:cNvPr id="360" name="tx31"/>
              <p:cNvSpPr/>
              <p:nvPr/>
            </p:nvSpPr>
            <p:spPr>
              <a:xfrm>
                <a:off x="7528680" y="8722800"/>
                <a:ext cx="477720" cy="8388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en-US" sz="1600" spc="-1" strike="noStrike">
                    <a:solidFill>
                      <a:srgbClr val="4d4d4d"/>
                    </a:solidFill>
                    <a:latin typeface="Arial"/>
                  </a:rPr>
                  <a:t> </a:t>
                </a:r>
                <a:r>
                  <a:rPr b="0" lang="zh-CN" sz="1600" spc="-1" strike="noStrike">
                    <a:solidFill>
                      <a:srgbClr val="4d4d4d"/>
                    </a:solidFill>
                    <a:latin typeface="Arial"/>
                  </a:rPr>
                  <a:t>CEA</a:t>
                </a:r>
                <a:r>
                  <a:rPr b="0" lang="en-US" sz="1600" spc="-1" strike="noStrike">
                    <a:solidFill>
                      <a:srgbClr val="4d4d4d"/>
                    </a:solidFill>
                    <a:latin typeface="Arial"/>
                  </a:rPr>
                  <a:t>/</a:t>
                </a:r>
                <a:r>
                  <a:rPr b="0" lang="zh-CN" sz="1600" spc="-1" strike="noStrike">
                    <a:solidFill>
                      <a:srgbClr val="4d4d4d"/>
                    </a:solidFill>
                    <a:latin typeface="Arial"/>
                  </a:rPr>
                  <a:t>AFP</a:t>
                </a:r>
                <a:endParaRPr b="0" lang="en-US" sz="1600" spc="-1" strike="noStrike">
                  <a:solidFill>
                    <a:srgbClr val="000000"/>
                  </a:solidFill>
                  <a:latin typeface="Arial"/>
                </a:endParaRPr>
              </a:p>
            </p:txBody>
          </p:sp>
          <p:sp>
            <p:nvSpPr>
              <p:cNvPr id="361" name="tx32"/>
              <p:cNvSpPr/>
              <p:nvPr/>
            </p:nvSpPr>
            <p:spPr>
              <a:xfrm>
                <a:off x="7567200" y="7786800"/>
                <a:ext cx="603360" cy="8244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en-US" sz="1600" spc="-1" strike="noStrike">
                    <a:solidFill>
                      <a:srgbClr val="4d4d4d"/>
                    </a:solidFill>
                    <a:latin typeface="Arial"/>
                  </a:rPr>
                  <a:t> </a:t>
                </a:r>
                <a:r>
                  <a:rPr b="0" lang="zh-CN" sz="1600" spc="-1" strike="noStrike">
                    <a:solidFill>
                      <a:srgbClr val="4d4d4d"/>
                    </a:solidFill>
                    <a:latin typeface="Arial"/>
                  </a:rPr>
                  <a:t>CEA</a:t>
                </a:r>
                <a:r>
                  <a:rPr b="0" lang="en-US" sz="1600" spc="-1" strike="noStrike">
                    <a:solidFill>
                      <a:srgbClr val="4d4d4d"/>
                    </a:solidFill>
                    <a:latin typeface="Arial"/>
                  </a:rPr>
                  <a:t>/</a:t>
                </a:r>
                <a:r>
                  <a:rPr b="0" lang="zh-CN" sz="1600" spc="-1" strike="noStrike">
                    <a:solidFill>
                      <a:srgbClr val="4d4d4d"/>
                    </a:solidFill>
                    <a:latin typeface="Arial"/>
                  </a:rPr>
                  <a:t>CA153</a:t>
                </a:r>
                <a:endParaRPr b="0" lang="en-US" sz="1600" spc="-1" strike="noStrike">
                  <a:solidFill>
                    <a:srgbClr val="000000"/>
                  </a:solidFill>
                  <a:latin typeface="Arial"/>
                </a:endParaRPr>
              </a:p>
            </p:txBody>
          </p:sp>
          <p:sp>
            <p:nvSpPr>
              <p:cNvPr id="362" name="tx33"/>
              <p:cNvSpPr/>
              <p:nvPr/>
            </p:nvSpPr>
            <p:spPr>
              <a:xfrm>
                <a:off x="7623360" y="6850800"/>
                <a:ext cx="714240" cy="8244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en-US" sz="1600" spc="-1" strike="noStrike">
                    <a:solidFill>
                      <a:srgbClr val="4d4d4d"/>
                    </a:solidFill>
                    <a:latin typeface="Arial"/>
                  </a:rPr>
                  <a:t>  </a:t>
                </a:r>
                <a:r>
                  <a:rPr b="0" lang="zh-CN" sz="1600" spc="-1" strike="noStrike">
                    <a:solidFill>
                      <a:srgbClr val="4d4d4d"/>
                    </a:solidFill>
                    <a:latin typeface="Arial"/>
                  </a:rPr>
                  <a:t>CA19</a:t>
                </a:r>
                <a:r>
                  <a:rPr b="0" lang="en-US" sz="1600" spc="-1" strike="noStrike">
                    <a:solidFill>
                      <a:srgbClr val="4d4d4d"/>
                    </a:solidFill>
                    <a:latin typeface="Arial"/>
                  </a:rPr>
                  <a:t>-</a:t>
                </a:r>
                <a:r>
                  <a:rPr b="0" lang="zh-CN" sz="1600" spc="-1" strike="noStrike">
                    <a:solidFill>
                      <a:srgbClr val="4d4d4d"/>
                    </a:solidFill>
                    <a:latin typeface="Arial"/>
                  </a:rPr>
                  <a:t>9</a:t>
                </a:r>
                <a:r>
                  <a:rPr b="0" lang="en-US" sz="1600" spc="-1" strike="noStrike">
                    <a:solidFill>
                      <a:srgbClr val="4d4d4d"/>
                    </a:solidFill>
                    <a:latin typeface="Arial"/>
                  </a:rPr>
                  <a:t>/</a:t>
                </a:r>
                <a:r>
                  <a:rPr b="0" lang="zh-CN" sz="1600" spc="-1" strike="noStrike">
                    <a:solidFill>
                      <a:srgbClr val="4d4d4d"/>
                    </a:solidFill>
                    <a:latin typeface="Arial"/>
                  </a:rPr>
                  <a:t>CA125</a:t>
                </a:r>
                <a:endParaRPr b="0" lang="en-US" sz="1600" spc="-1" strike="noStrike">
                  <a:solidFill>
                    <a:srgbClr val="000000"/>
                  </a:solidFill>
                  <a:latin typeface="Arial"/>
                </a:endParaRPr>
              </a:p>
            </p:txBody>
          </p:sp>
          <p:sp>
            <p:nvSpPr>
              <p:cNvPr id="363" name="tx34"/>
              <p:cNvSpPr/>
              <p:nvPr/>
            </p:nvSpPr>
            <p:spPr>
              <a:xfrm>
                <a:off x="7536960" y="5842800"/>
                <a:ext cx="515880" cy="10296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en-US" sz="1600" spc="-1" strike="noStrike">
                    <a:solidFill>
                      <a:srgbClr val="4d4d4d"/>
                    </a:solidFill>
                    <a:latin typeface="Arial"/>
                  </a:rPr>
                  <a:t>   </a:t>
                </a:r>
                <a:r>
                  <a:rPr b="0" lang="en-US" sz="1600" spc="-1" strike="noStrike">
                    <a:solidFill>
                      <a:srgbClr val="4d4d4d"/>
                    </a:solidFill>
                    <a:latin typeface="Arial"/>
                  </a:rPr>
                  <a:t>C</a:t>
                </a:r>
                <a:r>
                  <a:rPr b="0" lang="zh-CN" sz="1600" spc="-1" strike="noStrike">
                    <a:solidFill>
                      <a:srgbClr val="4d4d4d"/>
                    </a:solidFill>
                    <a:latin typeface="Arial"/>
                  </a:rPr>
                  <a:t>utoff_</a:t>
                </a:r>
                <a:r>
                  <a:rPr b="0" lang="en-US" sz="1600" spc="-1" strike="noStrike">
                    <a:solidFill>
                      <a:srgbClr val="4d4d4d"/>
                    </a:solidFill>
                    <a:latin typeface="Arial"/>
                  </a:rPr>
                  <a:t>CEA</a:t>
                </a:r>
                <a:endParaRPr b="0" lang="en-US" sz="1600" spc="-1" strike="noStrike">
                  <a:solidFill>
                    <a:srgbClr val="000000"/>
                  </a:solidFill>
                  <a:latin typeface="Arial"/>
                </a:endParaRPr>
              </a:p>
            </p:txBody>
          </p:sp>
          <p:sp>
            <p:nvSpPr>
              <p:cNvPr id="364" name="tx35"/>
              <p:cNvSpPr/>
              <p:nvPr/>
            </p:nvSpPr>
            <p:spPr>
              <a:xfrm>
                <a:off x="7566120" y="4898880"/>
                <a:ext cx="639720" cy="10296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en-US" sz="1600" spc="-1" strike="noStrike">
                    <a:solidFill>
                      <a:srgbClr val="4d4d4d"/>
                    </a:solidFill>
                    <a:latin typeface="Arial"/>
                  </a:rPr>
                  <a:t>    </a:t>
                </a:r>
                <a:r>
                  <a:rPr b="0" lang="en-US" sz="1600" spc="-1" strike="noStrike">
                    <a:solidFill>
                      <a:srgbClr val="4d4d4d"/>
                    </a:solidFill>
                    <a:latin typeface="Arial"/>
                  </a:rPr>
                  <a:t>C</a:t>
                </a:r>
                <a:r>
                  <a:rPr b="0" lang="zh-CN" sz="1600" spc="-1" strike="noStrike">
                    <a:solidFill>
                      <a:srgbClr val="4d4d4d"/>
                    </a:solidFill>
                    <a:latin typeface="Arial"/>
                  </a:rPr>
                  <a:t>utoff_</a:t>
                </a:r>
                <a:r>
                  <a:rPr b="0" lang="en-US" sz="1600" spc="-1" strike="noStrike">
                    <a:solidFill>
                      <a:srgbClr val="4d4d4d"/>
                    </a:solidFill>
                    <a:latin typeface="Arial"/>
                  </a:rPr>
                  <a:t>CA</a:t>
                </a:r>
                <a:r>
                  <a:rPr b="0" lang="zh-CN" sz="1600" spc="-1" strike="noStrike">
                    <a:solidFill>
                      <a:srgbClr val="4d4d4d"/>
                    </a:solidFill>
                    <a:latin typeface="Arial"/>
                  </a:rPr>
                  <a:t>19</a:t>
                </a:r>
                <a:r>
                  <a:rPr b="0" lang="en-US" sz="1600" spc="-1" strike="noStrike">
                    <a:solidFill>
                      <a:srgbClr val="4d4d4d"/>
                    </a:solidFill>
                    <a:latin typeface="Arial"/>
                  </a:rPr>
                  <a:t>-</a:t>
                </a:r>
                <a:r>
                  <a:rPr b="0" lang="zh-CN" sz="1600" spc="-1" strike="noStrike">
                    <a:solidFill>
                      <a:srgbClr val="4d4d4d"/>
                    </a:solidFill>
                    <a:latin typeface="Arial"/>
                  </a:rPr>
                  <a:t>9</a:t>
                </a:r>
                <a:endParaRPr b="0" lang="en-US" sz="1600" spc="-1" strike="noStrike">
                  <a:solidFill>
                    <a:srgbClr val="000000"/>
                  </a:solidFill>
                  <a:latin typeface="Arial"/>
                </a:endParaRPr>
              </a:p>
            </p:txBody>
          </p:sp>
          <p:sp>
            <p:nvSpPr>
              <p:cNvPr id="365" name="pl37"/>
              <p:cNvSpPr/>
              <p:nvPr/>
            </p:nvSpPr>
            <p:spPr>
              <a:xfrm>
                <a:off x="8772480" y="9719280"/>
                <a:ext cx="3456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66" name="pl38"/>
              <p:cNvSpPr/>
              <p:nvPr/>
            </p:nvSpPr>
            <p:spPr>
              <a:xfrm>
                <a:off x="8772480" y="8767800"/>
                <a:ext cx="3456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67" name="pl39"/>
              <p:cNvSpPr/>
              <p:nvPr/>
            </p:nvSpPr>
            <p:spPr>
              <a:xfrm>
                <a:off x="8772480" y="7816320"/>
                <a:ext cx="3456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68" name="pl40"/>
              <p:cNvSpPr/>
              <p:nvPr/>
            </p:nvSpPr>
            <p:spPr>
              <a:xfrm>
                <a:off x="8772480" y="6864840"/>
                <a:ext cx="3456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69" name="pl41"/>
              <p:cNvSpPr/>
              <p:nvPr/>
            </p:nvSpPr>
            <p:spPr>
              <a:xfrm>
                <a:off x="8772480" y="5913720"/>
                <a:ext cx="3456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70" name="pl42"/>
              <p:cNvSpPr/>
              <p:nvPr/>
            </p:nvSpPr>
            <p:spPr>
              <a:xfrm>
                <a:off x="8772480" y="4962240"/>
                <a:ext cx="3456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71" name="pl43"/>
              <p:cNvSpPr/>
              <p:nvPr/>
            </p:nvSpPr>
            <p:spPr>
              <a:xfrm>
                <a:off x="8772480" y="4010760"/>
                <a:ext cx="3456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72" name="pl44"/>
              <p:cNvSpPr/>
              <p:nvPr/>
            </p:nvSpPr>
            <p:spPr>
              <a:xfrm>
                <a:off x="10342440" y="10289880"/>
                <a:ext cx="360" cy="34560"/>
              </a:xfrm>
              <a:custGeom>
                <a:avLst/>
                <a:gdLst/>
                <a:ahLst/>
                <a:rect l="l" t="t" r="r" b="b"/>
                <a:pathLst>
                  <a:path w="1" h="34794">
                    <a:moveTo>
                      <a:pt x="0" y="34794"/>
                    </a:moveTo>
                    <a:lnTo>
                      <a:pt x="0" y="0"/>
                    </a:lnTo>
                  </a:path>
                </a:pathLst>
              </a:custGeom>
              <a:noFill/>
              <a:ln w="13680">
                <a:solidFill>
                  <a:srgbClr val="333333"/>
                </a:solidFill>
                <a:round/>
              </a:ln>
            </p:spPr>
            <p:style>
              <a:lnRef idx="0"/>
              <a:fillRef idx="0"/>
              <a:effectRef idx="0"/>
              <a:fontRef idx="minor"/>
            </p:style>
            <p:txBody>
              <a:bodyPr lIns="90000" rIns="90000" tIns="-12240" bIns="-122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73" name="pl45"/>
              <p:cNvSpPr/>
              <p:nvPr/>
            </p:nvSpPr>
            <p:spPr>
              <a:xfrm>
                <a:off x="11219760" y="10289880"/>
                <a:ext cx="360" cy="34560"/>
              </a:xfrm>
              <a:custGeom>
                <a:avLst/>
                <a:gdLst/>
                <a:ahLst/>
                <a:rect l="l" t="t" r="r" b="b"/>
                <a:pathLst>
                  <a:path w="1" h="34794">
                    <a:moveTo>
                      <a:pt x="0" y="34794"/>
                    </a:moveTo>
                    <a:lnTo>
                      <a:pt x="0" y="0"/>
                    </a:lnTo>
                  </a:path>
                </a:pathLst>
              </a:custGeom>
              <a:noFill/>
              <a:ln w="13680">
                <a:solidFill>
                  <a:srgbClr val="333333"/>
                </a:solidFill>
                <a:round/>
              </a:ln>
            </p:spPr>
            <p:style>
              <a:lnRef idx="0"/>
              <a:fillRef idx="0"/>
              <a:effectRef idx="0"/>
              <a:fontRef idx="minor"/>
            </p:style>
            <p:txBody>
              <a:bodyPr lIns="90000" rIns="90000" tIns="-12240" bIns="-122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74" name="pl46"/>
              <p:cNvSpPr/>
              <p:nvPr/>
            </p:nvSpPr>
            <p:spPr>
              <a:xfrm>
                <a:off x="12097080" y="10289880"/>
                <a:ext cx="360" cy="34560"/>
              </a:xfrm>
              <a:custGeom>
                <a:avLst/>
                <a:gdLst/>
                <a:ahLst/>
                <a:rect l="l" t="t" r="r" b="b"/>
                <a:pathLst>
                  <a:path w="1" h="34794">
                    <a:moveTo>
                      <a:pt x="0" y="34794"/>
                    </a:moveTo>
                    <a:lnTo>
                      <a:pt x="0" y="0"/>
                    </a:lnTo>
                  </a:path>
                </a:pathLst>
              </a:custGeom>
              <a:noFill/>
              <a:ln w="13680">
                <a:solidFill>
                  <a:srgbClr val="333333"/>
                </a:solidFill>
                <a:round/>
              </a:ln>
            </p:spPr>
            <p:style>
              <a:lnRef idx="0"/>
              <a:fillRef idx="0"/>
              <a:effectRef idx="0"/>
              <a:fontRef idx="minor"/>
            </p:style>
            <p:txBody>
              <a:bodyPr lIns="90000" rIns="90000" tIns="-12240" bIns="-122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75" name="tx47"/>
              <p:cNvSpPr/>
              <p:nvPr/>
            </p:nvSpPr>
            <p:spPr>
              <a:xfrm>
                <a:off x="10312200" y="10446840"/>
                <a:ext cx="61920" cy="8064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zh-CN" sz="1600" spc="-1" strike="noStrike">
                    <a:solidFill>
                      <a:srgbClr val="4d4d4d"/>
                    </a:solidFill>
                    <a:latin typeface="Arial"/>
                  </a:rPr>
                  <a:t>3</a:t>
                </a:r>
                <a:endParaRPr b="0" lang="en-US" sz="1600" spc="-1" strike="noStrike">
                  <a:solidFill>
                    <a:srgbClr val="000000"/>
                  </a:solidFill>
                  <a:latin typeface="Arial"/>
                </a:endParaRPr>
              </a:p>
            </p:txBody>
          </p:sp>
          <p:sp>
            <p:nvSpPr>
              <p:cNvPr id="376" name="tx48"/>
              <p:cNvSpPr/>
              <p:nvPr/>
            </p:nvSpPr>
            <p:spPr>
              <a:xfrm>
                <a:off x="11188800" y="10448280"/>
                <a:ext cx="61920" cy="7920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zh-CN" sz="1600" spc="-1" strike="noStrike">
                    <a:solidFill>
                      <a:srgbClr val="4d4d4d"/>
                    </a:solidFill>
                    <a:latin typeface="Arial"/>
                  </a:rPr>
                  <a:t>5</a:t>
                </a:r>
                <a:endParaRPr b="0" lang="en-US" sz="1600" spc="-1" strike="noStrike">
                  <a:solidFill>
                    <a:srgbClr val="000000"/>
                  </a:solidFill>
                  <a:latin typeface="Arial"/>
                </a:endParaRPr>
              </a:p>
            </p:txBody>
          </p:sp>
          <p:sp>
            <p:nvSpPr>
              <p:cNvPr id="377" name="tx49"/>
              <p:cNvSpPr/>
              <p:nvPr/>
            </p:nvSpPr>
            <p:spPr>
              <a:xfrm>
                <a:off x="12065400" y="10449720"/>
                <a:ext cx="63360" cy="7776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zh-CN" sz="1600" spc="-1" strike="noStrike">
                    <a:solidFill>
                      <a:srgbClr val="4d4d4d"/>
                    </a:solidFill>
                    <a:latin typeface="Arial"/>
                  </a:rPr>
                  <a:t>7</a:t>
                </a:r>
                <a:endParaRPr b="0" lang="en-US" sz="1600" spc="-1" strike="noStrike">
                  <a:solidFill>
                    <a:srgbClr val="000000"/>
                  </a:solidFill>
                  <a:latin typeface="Arial"/>
                </a:endParaRPr>
              </a:p>
            </p:txBody>
          </p:sp>
          <p:sp>
            <p:nvSpPr>
              <p:cNvPr id="378" name="tx50"/>
              <p:cNvSpPr/>
              <p:nvPr/>
            </p:nvSpPr>
            <p:spPr>
              <a:xfrm>
                <a:off x="10432440" y="10666440"/>
                <a:ext cx="1693080" cy="103320"/>
              </a:xfrm>
              <a:prstGeom prst="rect">
                <a:avLst/>
              </a:prstGeom>
              <a:noFill/>
              <a:ln w="0">
                <a:noFill/>
              </a:ln>
            </p:spPr>
            <p:style>
              <a:lnRef idx="0"/>
              <a:fillRef idx="0"/>
              <a:effectRef idx="0"/>
              <a:fontRef idx="minor"/>
            </p:style>
            <p:txBody>
              <a:bodyPr wrap="none" lIns="0" rIns="0" tIns="0" bIns="0" anchor="ctr" anchorCtr="1">
                <a:noAutofit/>
              </a:bodyPr>
              <a:p>
                <a:pPr>
                  <a:lnSpc>
                    <a:spcPts val="1100"/>
                  </a:lnSpc>
                  <a:tabLst>
                    <a:tab algn="l" pos="0"/>
                    <a:tab algn="l" pos="1487520"/>
                    <a:tab algn="l" pos="2975040"/>
                    <a:tab algn="l" pos="4462560"/>
                    <a:tab algn="l" pos="5950080"/>
                    <a:tab algn="l" pos="7437600"/>
                    <a:tab algn="l" pos="8924760"/>
                    <a:tab algn="l" pos="10412280"/>
                  </a:tabLst>
                </a:pPr>
                <a:r>
                  <a:rPr b="0" lang="zh-CN" sz="1600" spc="-1" strike="noStrike">
                    <a:solidFill>
                      <a:srgbClr val="000000"/>
                    </a:solidFill>
                    <a:latin typeface="Arial"/>
                  </a:rPr>
                  <a:t>Times of variables selected</a:t>
                </a:r>
                <a:endParaRPr b="0" lang="en-US" sz="1600" spc="-1" strike="noStrike">
                  <a:solidFill>
                    <a:srgbClr val="000000"/>
                  </a:solidFill>
                  <a:latin typeface="Arial"/>
                </a:endParaRPr>
              </a:p>
            </p:txBody>
          </p:sp>
          <p:sp>
            <p:nvSpPr>
              <p:cNvPr id="379" name="tx52"/>
              <p:cNvSpPr/>
              <p:nvPr/>
            </p:nvSpPr>
            <p:spPr>
              <a:xfrm>
                <a:off x="10914120" y="7707240"/>
                <a:ext cx="1141560" cy="101520"/>
              </a:xfrm>
              <a:prstGeom prst="rect">
                <a:avLst/>
              </a:prstGeom>
              <a:noFill/>
              <a:ln w="0">
                <a:noFill/>
              </a:ln>
            </p:spPr>
            <p:style>
              <a:lnRef idx="0"/>
              <a:fillRef idx="0"/>
              <a:effectRef idx="0"/>
              <a:fontRef idx="minor"/>
            </p:style>
            <p:txBody>
              <a:bodyPr wrap="none" lIns="0" rIns="0" tIns="0" bIns="0" anchor="ctr" anchorCtr="1">
                <a:noAutofit/>
              </a:bodyPr>
              <a:p>
                <a:pPr>
                  <a:lnSpc>
                    <a:spcPts val="1100"/>
                  </a:lnSpc>
                  <a:tabLst>
                    <a:tab algn="l" pos="0"/>
                    <a:tab algn="l" pos="1487520"/>
                    <a:tab algn="l" pos="2975040"/>
                    <a:tab algn="l" pos="4462560"/>
                    <a:tab algn="l" pos="5950080"/>
                    <a:tab algn="l" pos="7437600"/>
                    <a:tab algn="l" pos="8924760"/>
                    <a:tab algn="l" pos="10412280"/>
                  </a:tabLst>
                </a:pPr>
                <a:r>
                  <a:rPr b="0" lang="zh-CN" sz="1600" spc="-1" strike="noStrike">
                    <a:solidFill>
                      <a:srgbClr val="000000"/>
                    </a:solidFill>
                    <a:latin typeface="Arial"/>
                  </a:rPr>
                  <a:t>Variables selected</a:t>
                </a:r>
                <a:endParaRPr b="0" lang="en-US" sz="1600" spc="-1" strike="noStrike">
                  <a:solidFill>
                    <a:srgbClr val="000000"/>
                  </a:solidFill>
                  <a:latin typeface="Arial"/>
                </a:endParaRPr>
              </a:p>
            </p:txBody>
          </p:sp>
          <p:sp>
            <p:nvSpPr>
              <p:cNvPr id="380" name="rc53"/>
              <p:cNvSpPr/>
              <p:nvPr/>
            </p:nvSpPr>
            <p:spPr>
              <a:xfrm>
                <a:off x="13841280" y="6751800"/>
                <a:ext cx="219240" cy="21924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81" name="rc54"/>
              <p:cNvSpPr/>
              <p:nvPr/>
            </p:nvSpPr>
            <p:spPr>
              <a:xfrm>
                <a:off x="10706760" y="8003520"/>
                <a:ext cx="201240" cy="201240"/>
              </a:xfrm>
              <a:prstGeom prst="rect">
                <a:avLst/>
              </a:prstGeom>
              <a:solidFill>
                <a:srgbClr val="bc3c29"/>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82" name="rc55"/>
              <p:cNvSpPr/>
              <p:nvPr/>
            </p:nvSpPr>
            <p:spPr>
              <a:xfrm>
                <a:off x="13841280" y="6971040"/>
                <a:ext cx="219240" cy="21924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83" name="rc56"/>
              <p:cNvSpPr/>
              <p:nvPr/>
            </p:nvSpPr>
            <p:spPr>
              <a:xfrm>
                <a:off x="10706760" y="8294760"/>
                <a:ext cx="201240" cy="201240"/>
              </a:xfrm>
              <a:prstGeom prst="rect">
                <a:avLst/>
              </a:prstGeom>
              <a:solidFill>
                <a:srgbClr val="0072b5"/>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84" name="tx57"/>
              <p:cNvSpPr/>
              <p:nvPr/>
            </p:nvSpPr>
            <p:spPr>
              <a:xfrm>
                <a:off x="11224800" y="8118000"/>
                <a:ext cx="463680" cy="8244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zh-CN" sz="1600" spc="-1" strike="noStrike">
                    <a:solidFill>
                      <a:srgbClr val="000000"/>
                    </a:solidFill>
                    <a:latin typeface="Arial"/>
                  </a:rPr>
                  <a:t>&gt; median</a:t>
                </a:r>
                <a:endParaRPr b="0" lang="en-US" sz="1600" spc="-1" strike="noStrike">
                  <a:solidFill>
                    <a:srgbClr val="000000"/>
                  </a:solidFill>
                  <a:latin typeface="Arial"/>
                </a:endParaRPr>
              </a:p>
            </p:txBody>
          </p:sp>
          <p:sp>
            <p:nvSpPr>
              <p:cNvPr id="385" name="tx58"/>
              <p:cNvSpPr/>
              <p:nvPr/>
            </p:nvSpPr>
            <p:spPr>
              <a:xfrm>
                <a:off x="11224800" y="8410320"/>
                <a:ext cx="528480" cy="8064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zh-CN" sz="1600" spc="-1" strike="noStrike">
                    <a:solidFill>
                      <a:srgbClr val="000000"/>
                    </a:solidFill>
                    <a:latin typeface="Arial"/>
                  </a:rPr>
                  <a:t>&lt;= median</a:t>
                </a:r>
                <a:endParaRPr b="0" lang="en-US" sz="1600" spc="-1" strike="noStrike">
                  <a:solidFill>
                    <a:srgbClr val="000000"/>
                  </a:solidFill>
                  <a:latin typeface="Arial"/>
                </a:endParaRPr>
              </a:p>
            </p:txBody>
          </p:sp>
        </p:grpSp>
      </p:grpSp>
      <p:sp>
        <p:nvSpPr>
          <p:cNvPr id="386" name="文本框 313"/>
          <p:cNvSpPr/>
          <p:nvPr/>
        </p:nvSpPr>
        <p:spPr>
          <a:xfrm>
            <a:off x="14801760" y="3079800"/>
            <a:ext cx="939960" cy="55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1487520"/>
                <a:tab algn="l" pos="2975040"/>
                <a:tab algn="l" pos="4462560"/>
                <a:tab algn="l" pos="5950080"/>
                <a:tab algn="l" pos="7437600"/>
                <a:tab algn="l" pos="8924760"/>
                <a:tab algn="l" pos="10412280"/>
              </a:tabLst>
            </a:pPr>
            <a:r>
              <a:rPr b="1" lang="en-US" sz="3000" spc="-1" strike="noStrike">
                <a:solidFill>
                  <a:srgbClr val="000000"/>
                </a:solidFill>
                <a:latin typeface="Times New Roman"/>
              </a:rPr>
              <a:t>C</a:t>
            </a:r>
            <a:endParaRPr b="0" lang="en-US" sz="3000" spc="-1" strike="noStrike">
              <a:solidFill>
                <a:srgbClr val="000000"/>
              </a:solidFill>
              <a:latin typeface="Arial"/>
            </a:endParaRPr>
          </a:p>
        </p:txBody>
      </p:sp>
      <p:grpSp>
        <p:nvGrpSpPr>
          <p:cNvPr id="387" name="组合 1"/>
          <p:cNvGrpSpPr/>
          <p:nvPr/>
        </p:nvGrpSpPr>
        <p:grpSpPr>
          <a:xfrm>
            <a:off x="13763520" y="3583080"/>
            <a:ext cx="6851880" cy="7385040"/>
            <a:chOff x="13763520" y="3583080"/>
            <a:chExt cx="6851880" cy="7385040"/>
          </a:xfrm>
        </p:grpSpPr>
        <p:sp>
          <p:nvSpPr>
            <p:cNvPr id="388" name="rc5"/>
            <p:cNvSpPr/>
            <p:nvPr/>
          </p:nvSpPr>
          <p:spPr>
            <a:xfrm>
              <a:off x="15832440" y="3583080"/>
              <a:ext cx="4782960" cy="684576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89" name="pl6"/>
            <p:cNvSpPr/>
            <p:nvPr/>
          </p:nvSpPr>
          <p:spPr>
            <a:xfrm>
              <a:off x="16484400" y="3583080"/>
              <a:ext cx="360" cy="6845760"/>
            </a:xfrm>
            <a:custGeom>
              <a:avLst/>
              <a:gdLst/>
              <a:ahLst/>
              <a:rect l="l" t="t" r="r" b="b"/>
              <a:pathLst>
                <a:path w="1" h="6850972">
                  <a:moveTo>
                    <a:pt x="0" y="6850972"/>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90" name="pl7"/>
            <p:cNvSpPr/>
            <p:nvPr/>
          </p:nvSpPr>
          <p:spPr>
            <a:xfrm>
              <a:off x="16919280" y="3583080"/>
              <a:ext cx="360" cy="6845760"/>
            </a:xfrm>
            <a:custGeom>
              <a:avLst/>
              <a:gdLst/>
              <a:ahLst/>
              <a:rect l="l" t="t" r="r" b="b"/>
              <a:pathLst>
                <a:path w="1" h="6850972">
                  <a:moveTo>
                    <a:pt x="0" y="6850972"/>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91" name="pl8"/>
            <p:cNvSpPr/>
            <p:nvPr/>
          </p:nvSpPr>
          <p:spPr>
            <a:xfrm>
              <a:off x="17789040" y="3583080"/>
              <a:ext cx="360" cy="6845760"/>
            </a:xfrm>
            <a:custGeom>
              <a:avLst/>
              <a:gdLst/>
              <a:ahLst/>
              <a:rect l="l" t="t" r="r" b="b"/>
              <a:pathLst>
                <a:path w="1" h="6850972">
                  <a:moveTo>
                    <a:pt x="0" y="6850972"/>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92" name="pl9"/>
            <p:cNvSpPr/>
            <p:nvPr/>
          </p:nvSpPr>
          <p:spPr>
            <a:xfrm>
              <a:off x="18658800" y="3583080"/>
              <a:ext cx="360" cy="6845760"/>
            </a:xfrm>
            <a:custGeom>
              <a:avLst/>
              <a:gdLst/>
              <a:ahLst/>
              <a:rect l="l" t="t" r="r" b="b"/>
              <a:pathLst>
                <a:path w="1" h="6850972">
                  <a:moveTo>
                    <a:pt x="0" y="6850972"/>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93" name="pl10"/>
            <p:cNvSpPr/>
            <p:nvPr/>
          </p:nvSpPr>
          <p:spPr>
            <a:xfrm>
              <a:off x="19528560" y="3583080"/>
              <a:ext cx="360" cy="6845760"/>
            </a:xfrm>
            <a:custGeom>
              <a:avLst/>
              <a:gdLst/>
              <a:ahLst/>
              <a:rect l="l" t="t" r="r" b="b"/>
              <a:pathLst>
                <a:path w="1" h="6850972">
                  <a:moveTo>
                    <a:pt x="0" y="6850972"/>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94" name="pl11"/>
            <p:cNvSpPr/>
            <p:nvPr/>
          </p:nvSpPr>
          <p:spPr>
            <a:xfrm>
              <a:off x="19963440" y="3583080"/>
              <a:ext cx="360" cy="6845760"/>
            </a:xfrm>
            <a:custGeom>
              <a:avLst/>
              <a:gdLst/>
              <a:ahLst/>
              <a:rect l="l" t="t" r="r" b="b"/>
              <a:pathLst>
                <a:path w="1" h="6850972">
                  <a:moveTo>
                    <a:pt x="0" y="6850972"/>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95" name="pl12"/>
            <p:cNvSpPr/>
            <p:nvPr/>
          </p:nvSpPr>
          <p:spPr>
            <a:xfrm>
              <a:off x="15832440" y="10062360"/>
              <a:ext cx="4782960" cy="360"/>
            </a:xfrm>
            <a:custGeom>
              <a:avLst/>
              <a:gdLst/>
              <a:ahLst/>
              <a:rect l="l" t="t" r="r" b="b"/>
              <a:pathLst>
                <a:path w="4823701" h="1">
                  <a:moveTo>
                    <a:pt x="0" y="0"/>
                  </a:moveTo>
                  <a:lnTo>
                    <a:pt x="4823701"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96" name="pl13"/>
            <p:cNvSpPr/>
            <p:nvPr/>
          </p:nvSpPr>
          <p:spPr>
            <a:xfrm>
              <a:off x="15832440" y="9451080"/>
              <a:ext cx="4782960" cy="360"/>
            </a:xfrm>
            <a:custGeom>
              <a:avLst/>
              <a:gdLst/>
              <a:ahLst/>
              <a:rect l="l" t="t" r="r" b="b"/>
              <a:pathLst>
                <a:path w="4823701" h="1">
                  <a:moveTo>
                    <a:pt x="0" y="0"/>
                  </a:moveTo>
                  <a:lnTo>
                    <a:pt x="4823701"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97" name="pl14"/>
            <p:cNvSpPr/>
            <p:nvPr/>
          </p:nvSpPr>
          <p:spPr>
            <a:xfrm>
              <a:off x="15832440" y="8839800"/>
              <a:ext cx="4782960" cy="360"/>
            </a:xfrm>
            <a:custGeom>
              <a:avLst/>
              <a:gdLst/>
              <a:ahLst/>
              <a:rect l="l" t="t" r="r" b="b"/>
              <a:pathLst>
                <a:path w="4823701" h="1">
                  <a:moveTo>
                    <a:pt x="0" y="0"/>
                  </a:moveTo>
                  <a:lnTo>
                    <a:pt x="4823701"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98" name="pl15"/>
            <p:cNvSpPr/>
            <p:nvPr/>
          </p:nvSpPr>
          <p:spPr>
            <a:xfrm>
              <a:off x="15832440" y="8228520"/>
              <a:ext cx="4782960" cy="360"/>
            </a:xfrm>
            <a:custGeom>
              <a:avLst/>
              <a:gdLst/>
              <a:ahLst/>
              <a:rect l="l" t="t" r="r" b="b"/>
              <a:pathLst>
                <a:path w="4823701" h="1">
                  <a:moveTo>
                    <a:pt x="0" y="0"/>
                  </a:moveTo>
                  <a:lnTo>
                    <a:pt x="4823701"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399" name="pl16"/>
            <p:cNvSpPr/>
            <p:nvPr/>
          </p:nvSpPr>
          <p:spPr>
            <a:xfrm>
              <a:off x="15832440" y="7617240"/>
              <a:ext cx="4782960" cy="360"/>
            </a:xfrm>
            <a:custGeom>
              <a:avLst/>
              <a:gdLst/>
              <a:ahLst/>
              <a:rect l="l" t="t" r="r" b="b"/>
              <a:pathLst>
                <a:path w="4823701" h="1">
                  <a:moveTo>
                    <a:pt x="0" y="0"/>
                  </a:moveTo>
                  <a:lnTo>
                    <a:pt x="4823701"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00" name="pl17"/>
            <p:cNvSpPr/>
            <p:nvPr/>
          </p:nvSpPr>
          <p:spPr>
            <a:xfrm>
              <a:off x="15832440" y="7005960"/>
              <a:ext cx="4782960" cy="360"/>
            </a:xfrm>
            <a:custGeom>
              <a:avLst/>
              <a:gdLst/>
              <a:ahLst/>
              <a:rect l="l" t="t" r="r" b="b"/>
              <a:pathLst>
                <a:path w="4823701" h="1">
                  <a:moveTo>
                    <a:pt x="0" y="0"/>
                  </a:moveTo>
                  <a:lnTo>
                    <a:pt x="4823701"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01" name="pl18"/>
            <p:cNvSpPr/>
            <p:nvPr/>
          </p:nvSpPr>
          <p:spPr>
            <a:xfrm>
              <a:off x="15832440" y="6394680"/>
              <a:ext cx="4782960" cy="360"/>
            </a:xfrm>
            <a:custGeom>
              <a:avLst/>
              <a:gdLst/>
              <a:ahLst/>
              <a:rect l="l" t="t" r="r" b="b"/>
              <a:pathLst>
                <a:path w="4823701" h="1">
                  <a:moveTo>
                    <a:pt x="0" y="0"/>
                  </a:moveTo>
                  <a:lnTo>
                    <a:pt x="4823701"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02" name="pl19"/>
            <p:cNvSpPr/>
            <p:nvPr/>
          </p:nvSpPr>
          <p:spPr>
            <a:xfrm>
              <a:off x="15832440" y="5783400"/>
              <a:ext cx="4782960" cy="360"/>
            </a:xfrm>
            <a:custGeom>
              <a:avLst/>
              <a:gdLst/>
              <a:ahLst/>
              <a:rect l="l" t="t" r="r" b="b"/>
              <a:pathLst>
                <a:path w="4823701" h="1">
                  <a:moveTo>
                    <a:pt x="0" y="0"/>
                  </a:moveTo>
                  <a:lnTo>
                    <a:pt x="4823701"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03" name="pl20"/>
            <p:cNvSpPr/>
            <p:nvPr/>
          </p:nvSpPr>
          <p:spPr>
            <a:xfrm>
              <a:off x="15832440" y="5172120"/>
              <a:ext cx="4782960" cy="360"/>
            </a:xfrm>
            <a:custGeom>
              <a:avLst/>
              <a:gdLst/>
              <a:ahLst/>
              <a:rect l="l" t="t" r="r" b="b"/>
              <a:pathLst>
                <a:path w="4823701" h="1">
                  <a:moveTo>
                    <a:pt x="0" y="0"/>
                  </a:moveTo>
                  <a:lnTo>
                    <a:pt x="4823701"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04" name="pl21"/>
            <p:cNvSpPr/>
            <p:nvPr/>
          </p:nvSpPr>
          <p:spPr>
            <a:xfrm>
              <a:off x="15832440" y="4560840"/>
              <a:ext cx="4782960" cy="360"/>
            </a:xfrm>
            <a:custGeom>
              <a:avLst/>
              <a:gdLst/>
              <a:ahLst/>
              <a:rect l="l" t="t" r="r" b="b"/>
              <a:pathLst>
                <a:path w="4823701" h="1">
                  <a:moveTo>
                    <a:pt x="0" y="0"/>
                  </a:moveTo>
                  <a:lnTo>
                    <a:pt x="4823701"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05" name="pl22"/>
            <p:cNvSpPr/>
            <p:nvPr/>
          </p:nvSpPr>
          <p:spPr>
            <a:xfrm>
              <a:off x="15832440" y="3949560"/>
              <a:ext cx="4782960" cy="360"/>
            </a:xfrm>
            <a:custGeom>
              <a:avLst/>
              <a:gdLst/>
              <a:ahLst/>
              <a:rect l="l" t="t" r="r" b="b"/>
              <a:pathLst>
                <a:path w="4823701" h="1">
                  <a:moveTo>
                    <a:pt x="0" y="0"/>
                  </a:moveTo>
                  <a:lnTo>
                    <a:pt x="4823701"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06" name="pl23"/>
            <p:cNvSpPr/>
            <p:nvPr/>
          </p:nvSpPr>
          <p:spPr>
            <a:xfrm>
              <a:off x="17354160" y="3583080"/>
              <a:ext cx="360" cy="6845760"/>
            </a:xfrm>
            <a:custGeom>
              <a:avLst/>
              <a:gdLst/>
              <a:ahLst/>
              <a:rect l="l" t="t" r="r" b="b"/>
              <a:pathLst>
                <a:path w="1" h="6850972">
                  <a:moveTo>
                    <a:pt x="0" y="6850972"/>
                  </a:moveTo>
                  <a:lnTo>
                    <a:pt x="0" y="0"/>
                  </a:lnTo>
                </a:path>
              </a:pathLst>
            </a:custGeom>
            <a:noFill/>
            <a:ln w="1368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07" name="pl24"/>
            <p:cNvSpPr/>
            <p:nvPr/>
          </p:nvSpPr>
          <p:spPr>
            <a:xfrm>
              <a:off x="18223920" y="3583080"/>
              <a:ext cx="360" cy="6845760"/>
            </a:xfrm>
            <a:custGeom>
              <a:avLst/>
              <a:gdLst/>
              <a:ahLst/>
              <a:rect l="l" t="t" r="r" b="b"/>
              <a:pathLst>
                <a:path w="1" h="6850972">
                  <a:moveTo>
                    <a:pt x="0" y="6850972"/>
                  </a:moveTo>
                  <a:lnTo>
                    <a:pt x="0" y="0"/>
                  </a:lnTo>
                </a:path>
              </a:pathLst>
            </a:custGeom>
            <a:noFill/>
            <a:ln w="1368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08" name="pl25"/>
            <p:cNvSpPr/>
            <p:nvPr/>
          </p:nvSpPr>
          <p:spPr>
            <a:xfrm>
              <a:off x="19093680" y="3583080"/>
              <a:ext cx="360" cy="6845760"/>
            </a:xfrm>
            <a:custGeom>
              <a:avLst/>
              <a:gdLst/>
              <a:ahLst/>
              <a:rect l="l" t="t" r="r" b="b"/>
              <a:pathLst>
                <a:path w="1" h="6850972">
                  <a:moveTo>
                    <a:pt x="0" y="6850972"/>
                  </a:moveTo>
                  <a:lnTo>
                    <a:pt x="0" y="0"/>
                  </a:lnTo>
                </a:path>
              </a:pathLst>
            </a:custGeom>
            <a:noFill/>
            <a:ln w="1368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09" name="rc26"/>
            <p:cNvSpPr/>
            <p:nvPr/>
          </p:nvSpPr>
          <p:spPr>
            <a:xfrm>
              <a:off x="16049520" y="9787320"/>
              <a:ext cx="434520" cy="550080"/>
            </a:xfrm>
            <a:prstGeom prst="rect">
              <a:avLst/>
            </a:prstGeom>
            <a:solidFill>
              <a:srgbClr val="0072b5"/>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10" name="rc27"/>
            <p:cNvSpPr/>
            <p:nvPr/>
          </p:nvSpPr>
          <p:spPr>
            <a:xfrm>
              <a:off x="16049520" y="9176040"/>
              <a:ext cx="434520" cy="550080"/>
            </a:xfrm>
            <a:prstGeom prst="rect">
              <a:avLst/>
            </a:prstGeom>
            <a:solidFill>
              <a:srgbClr val="0072b5"/>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11" name="rc28"/>
            <p:cNvSpPr/>
            <p:nvPr/>
          </p:nvSpPr>
          <p:spPr>
            <a:xfrm>
              <a:off x="16049520" y="8564760"/>
              <a:ext cx="434520" cy="550080"/>
            </a:xfrm>
            <a:prstGeom prst="rect">
              <a:avLst/>
            </a:prstGeom>
            <a:solidFill>
              <a:srgbClr val="0072b5"/>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12" name="rc29"/>
            <p:cNvSpPr/>
            <p:nvPr/>
          </p:nvSpPr>
          <p:spPr>
            <a:xfrm>
              <a:off x="16049520" y="7953480"/>
              <a:ext cx="434520" cy="550080"/>
            </a:xfrm>
            <a:prstGeom prst="rect">
              <a:avLst/>
            </a:prstGeom>
            <a:solidFill>
              <a:srgbClr val="0072b5"/>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13" name="rc30"/>
            <p:cNvSpPr/>
            <p:nvPr/>
          </p:nvSpPr>
          <p:spPr>
            <a:xfrm>
              <a:off x="16049520" y="7342200"/>
              <a:ext cx="1304280" cy="550080"/>
            </a:xfrm>
            <a:prstGeom prst="rect">
              <a:avLst/>
            </a:prstGeom>
            <a:solidFill>
              <a:srgbClr val="0072b5"/>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14" name="rc31"/>
            <p:cNvSpPr/>
            <p:nvPr/>
          </p:nvSpPr>
          <p:spPr>
            <a:xfrm>
              <a:off x="16049520" y="6730920"/>
              <a:ext cx="2174040" cy="550080"/>
            </a:xfrm>
            <a:prstGeom prst="rect">
              <a:avLst/>
            </a:prstGeom>
            <a:solidFill>
              <a:srgbClr val="0072b5"/>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15" name="rc32"/>
            <p:cNvSpPr/>
            <p:nvPr/>
          </p:nvSpPr>
          <p:spPr>
            <a:xfrm>
              <a:off x="16049520" y="6119640"/>
              <a:ext cx="2608920" cy="550080"/>
            </a:xfrm>
            <a:prstGeom prst="rect">
              <a:avLst/>
            </a:prstGeom>
            <a:solidFill>
              <a:srgbClr val="bc3c29"/>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16" name="rc33"/>
            <p:cNvSpPr/>
            <p:nvPr/>
          </p:nvSpPr>
          <p:spPr>
            <a:xfrm>
              <a:off x="16049520" y="5508360"/>
              <a:ext cx="2608920" cy="550080"/>
            </a:xfrm>
            <a:prstGeom prst="rect">
              <a:avLst/>
            </a:prstGeom>
            <a:solidFill>
              <a:srgbClr val="bc3c29"/>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17" name="rc34"/>
            <p:cNvSpPr/>
            <p:nvPr/>
          </p:nvSpPr>
          <p:spPr>
            <a:xfrm>
              <a:off x="16049520" y="4897080"/>
              <a:ext cx="3478680" cy="550080"/>
            </a:xfrm>
            <a:prstGeom prst="rect">
              <a:avLst/>
            </a:prstGeom>
            <a:solidFill>
              <a:srgbClr val="bc3c29"/>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18" name="rc35"/>
            <p:cNvSpPr/>
            <p:nvPr/>
          </p:nvSpPr>
          <p:spPr>
            <a:xfrm>
              <a:off x="16049520" y="4285800"/>
              <a:ext cx="4348440" cy="550080"/>
            </a:xfrm>
            <a:prstGeom prst="rect">
              <a:avLst/>
            </a:prstGeom>
            <a:solidFill>
              <a:srgbClr val="bc3c29"/>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19" name="rc36"/>
            <p:cNvSpPr/>
            <p:nvPr/>
          </p:nvSpPr>
          <p:spPr>
            <a:xfrm>
              <a:off x="16049520" y="3674520"/>
              <a:ext cx="4348440" cy="550080"/>
            </a:xfrm>
            <a:prstGeom prst="rect">
              <a:avLst/>
            </a:prstGeom>
            <a:solidFill>
              <a:srgbClr val="bc3c29"/>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20" name="rc37"/>
            <p:cNvSpPr/>
            <p:nvPr/>
          </p:nvSpPr>
          <p:spPr>
            <a:xfrm>
              <a:off x="15832440" y="3583080"/>
              <a:ext cx="4782960" cy="6845760"/>
            </a:xfrm>
            <a:prstGeom prst="rect">
              <a:avLst/>
            </a:prstGeom>
            <a:noFill/>
            <a:ln cap="rnd" w="13680">
              <a:solidFill>
                <a:srgbClr val="333333"/>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21" name="tx38"/>
            <p:cNvSpPr/>
            <p:nvPr/>
          </p:nvSpPr>
          <p:spPr>
            <a:xfrm>
              <a:off x="14475240" y="10000800"/>
              <a:ext cx="504000" cy="14400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zh-CN" sz="1600" spc="-1" strike="noStrike">
                  <a:solidFill>
                    <a:srgbClr val="4d4d4d"/>
                  </a:solidFill>
                  <a:latin typeface="Arial"/>
                </a:rPr>
                <a:t>Age</a:t>
              </a:r>
              <a:endParaRPr b="0" lang="en-US" sz="1600" spc="-1" strike="noStrike">
                <a:solidFill>
                  <a:srgbClr val="000000"/>
                </a:solidFill>
                <a:latin typeface="Arial"/>
              </a:endParaRPr>
            </a:p>
          </p:txBody>
        </p:sp>
        <p:sp>
          <p:nvSpPr>
            <p:cNvPr id="422" name="tx39"/>
            <p:cNvSpPr/>
            <p:nvPr/>
          </p:nvSpPr>
          <p:spPr>
            <a:xfrm>
              <a:off x="14691240" y="9411840"/>
              <a:ext cx="595080" cy="8064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zh-CN" sz="1600" spc="-1" strike="noStrike">
                  <a:solidFill>
                    <a:srgbClr val="4d4d4d"/>
                  </a:solidFill>
                  <a:latin typeface="Arial"/>
                </a:rPr>
                <a:t>CEA</a:t>
              </a:r>
              <a:r>
                <a:rPr b="0" lang="en-US" sz="1600" spc="-1" strike="noStrike">
                  <a:solidFill>
                    <a:srgbClr val="4d4d4d"/>
                  </a:solidFill>
                  <a:latin typeface="Arial"/>
                </a:rPr>
                <a:t>/</a:t>
              </a:r>
              <a:r>
                <a:rPr b="0" lang="zh-CN" sz="1600" spc="-1" strike="noStrike">
                  <a:solidFill>
                    <a:srgbClr val="4d4d4d"/>
                  </a:solidFill>
                  <a:latin typeface="Arial"/>
                </a:rPr>
                <a:t>CA125</a:t>
              </a:r>
              <a:endParaRPr b="0" lang="en-US" sz="1600" spc="-1" strike="noStrike">
                <a:solidFill>
                  <a:srgbClr val="000000"/>
                </a:solidFill>
                <a:latin typeface="Arial"/>
              </a:endParaRPr>
            </a:p>
          </p:txBody>
        </p:sp>
        <p:sp>
          <p:nvSpPr>
            <p:cNvPr id="423" name="tx40"/>
            <p:cNvSpPr/>
            <p:nvPr/>
          </p:nvSpPr>
          <p:spPr>
            <a:xfrm>
              <a:off x="14619240" y="8776800"/>
              <a:ext cx="487080" cy="10620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en-US" sz="1600" spc="-1" strike="noStrike">
                  <a:solidFill>
                    <a:srgbClr val="4d4d4d"/>
                  </a:solidFill>
                  <a:latin typeface="Arial"/>
                </a:rPr>
                <a:t>   </a:t>
              </a:r>
              <a:r>
                <a:rPr b="0" lang="en-US" sz="1600" spc="-1" strike="noStrike">
                  <a:solidFill>
                    <a:srgbClr val="4d4d4d"/>
                  </a:solidFill>
                  <a:latin typeface="Arial"/>
                </a:rPr>
                <a:t>C</a:t>
              </a:r>
              <a:r>
                <a:rPr b="0" lang="zh-CN" sz="1600" spc="-1" strike="noStrike">
                  <a:solidFill>
                    <a:srgbClr val="4d4d4d"/>
                  </a:solidFill>
                  <a:latin typeface="Arial"/>
                </a:rPr>
                <a:t>utoff_</a:t>
              </a:r>
              <a:r>
                <a:rPr b="0" lang="en-US" sz="1600" spc="-1" strike="noStrike">
                  <a:solidFill>
                    <a:srgbClr val="4d4d4d"/>
                  </a:solidFill>
                  <a:latin typeface="Arial"/>
                </a:rPr>
                <a:t>AFP</a:t>
              </a:r>
              <a:endParaRPr b="0" lang="en-US" sz="1600" spc="-1" strike="noStrike">
                <a:solidFill>
                  <a:srgbClr val="000000"/>
                </a:solidFill>
                <a:latin typeface="Arial"/>
              </a:endParaRPr>
            </a:p>
          </p:txBody>
        </p:sp>
        <p:sp>
          <p:nvSpPr>
            <p:cNvPr id="424" name="tx41"/>
            <p:cNvSpPr/>
            <p:nvPr/>
          </p:nvSpPr>
          <p:spPr>
            <a:xfrm>
              <a:off x="14691240" y="8200080"/>
              <a:ext cx="634680" cy="10296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en-US" sz="1600" spc="-1" strike="noStrike">
                  <a:solidFill>
                    <a:srgbClr val="4d4d4d"/>
                  </a:solidFill>
                  <a:latin typeface="Arial"/>
                </a:rPr>
                <a:t>  </a:t>
              </a:r>
              <a:r>
                <a:rPr b="0" lang="en-US" sz="1600" spc="-1" strike="noStrike">
                  <a:solidFill>
                    <a:srgbClr val="4d4d4d"/>
                  </a:solidFill>
                  <a:latin typeface="Arial"/>
                </a:rPr>
                <a:t>C</a:t>
              </a:r>
              <a:r>
                <a:rPr b="0" lang="zh-CN" sz="1600" spc="-1" strike="noStrike">
                  <a:solidFill>
                    <a:srgbClr val="4d4d4d"/>
                  </a:solidFill>
                  <a:latin typeface="Arial"/>
                </a:rPr>
                <a:t>utoff_</a:t>
              </a:r>
              <a:r>
                <a:rPr b="0" lang="en-US" sz="1600" spc="-1" strike="noStrike">
                  <a:solidFill>
                    <a:srgbClr val="4d4d4d"/>
                  </a:solidFill>
                  <a:latin typeface="Arial"/>
                </a:rPr>
                <a:t>CA</a:t>
              </a:r>
              <a:r>
                <a:rPr b="0" lang="zh-CN" sz="1600" spc="-1" strike="noStrike">
                  <a:solidFill>
                    <a:srgbClr val="4d4d4d"/>
                  </a:solidFill>
                  <a:latin typeface="Arial"/>
                </a:rPr>
                <a:t>125</a:t>
              </a:r>
              <a:endParaRPr b="0" lang="en-US" sz="1600" spc="-1" strike="noStrike">
                <a:solidFill>
                  <a:srgbClr val="000000"/>
                </a:solidFill>
                <a:latin typeface="Arial"/>
              </a:endParaRPr>
            </a:p>
          </p:txBody>
        </p:sp>
        <p:sp>
          <p:nvSpPr>
            <p:cNvPr id="425" name="tx42"/>
            <p:cNvSpPr/>
            <p:nvPr/>
          </p:nvSpPr>
          <p:spPr>
            <a:xfrm>
              <a:off x="14619240" y="7592400"/>
              <a:ext cx="474480" cy="8244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zh-CN" sz="1600" spc="-1" strike="noStrike">
                  <a:solidFill>
                    <a:srgbClr val="4d4d4d"/>
                  </a:solidFill>
                  <a:latin typeface="Arial"/>
                </a:rPr>
                <a:t>CEA.AFP</a:t>
              </a:r>
              <a:endParaRPr b="0" lang="en-US" sz="1600" spc="-1" strike="noStrike">
                <a:solidFill>
                  <a:srgbClr val="000000"/>
                </a:solidFill>
                <a:latin typeface="Arial"/>
              </a:endParaRPr>
            </a:p>
          </p:txBody>
        </p:sp>
        <p:sp>
          <p:nvSpPr>
            <p:cNvPr id="426" name="tx43"/>
            <p:cNvSpPr/>
            <p:nvPr/>
          </p:nvSpPr>
          <p:spPr>
            <a:xfrm>
              <a:off x="14619240" y="6982560"/>
              <a:ext cx="595080" cy="8388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zh-CN" sz="1600" spc="-1" strike="noStrike">
                  <a:solidFill>
                    <a:srgbClr val="4d4d4d"/>
                  </a:solidFill>
                  <a:latin typeface="Arial"/>
                </a:rPr>
                <a:t>CEA.CA153</a:t>
              </a:r>
              <a:endParaRPr b="0" lang="en-US" sz="1600" spc="-1" strike="noStrike">
                <a:solidFill>
                  <a:srgbClr val="000000"/>
                </a:solidFill>
                <a:latin typeface="Arial"/>
              </a:endParaRPr>
            </a:p>
          </p:txBody>
        </p:sp>
        <p:sp>
          <p:nvSpPr>
            <p:cNvPr id="427" name="tx44"/>
            <p:cNvSpPr/>
            <p:nvPr/>
          </p:nvSpPr>
          <p:spPr>
            <a:xfrm>
              <a:off x="14691240" y="6383880"/>
              <a:ext cx="706320" cy="8388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en-US" sz="1600" spc="-1" strike="noStrike">
                  <a:solidFill>
                    <a:srgbClr val="4d4d4d"/>
                  </a:solidFill>
                  <a:latin typeface="Arial"/>
                </a:rPr>
                <a:t> </a:t>
              </a:r>
              <a:r>
                <a:rPr b="0" lang="zh-CN" sz="1600" spc="-1" strike="noStrike">
                  <a:solidFill>
                    <a:srgbClr val="4d4d4d"/>
                  </a:solidFill>
                  <a:latin typeface="Arial"/>
                </a:rPr>
                <a:t>CA19</a:t>
              </a:r>
              <a:r>
                <a:rPr b="0" lang="en-US" sz="1600" spc="-1" strike="noStrike">
                  <a:solidFill>
                    <a:srgbClr val="4d4d4d"/>
                  </a:solidFill>
                  <a:latin typeface="Arial"/>
                </a:rPr>
                <a:t>-</a:t>
              </a:r>
              <a:r>
                <a:rPr b="0" lang="zh-CN" sz="1600" spc="-1" strike="noStrike">
                  <a:solidFill>
                    <a:srgbClr val="4d4d4d"/>
                  </a:solidFill>
                  <a:latin typeface="Arial"/>
                </a:rPr>
                <a:t>9</a:t>
              </a:r>
              <a:r>
                <a:rPr b="0" lang="en-US" sz="1600" spc="-1" strike="noStrike">
                  <a:solidFill>
                    <a:srgbClr val="4d4d4d"/>
                  </a:solidFill>
                  <a:latin typeface="Arial"/>
                </a:rPr>
                <a:t>/</a:t>
              </a:r>
              <a:r>
                <a:rPr b="0" lang="zh-CN" sz="1600" spc="-1" strike="noStrike">
                  <a:solidFill>
                    <a:srgbClr val="4d4d4d"/>
                  </a:solidFill>
                  <a:latin typeface="Arial"/>
                </a:rPr>
                <a:t>CA153</a:t>
              </a:r>
              <a:endParaRPr b="0" lang="en-US" sz="1600" spc="-1" strike="noStrike">
                <a:solidFill>
                  <a:srgbClr val="000000"/>
                </a:solidFill>
                <a:latin typeface="Arial"/>
              </a:endParaRPr>
            </a:p>
          </p:txBody>
        </p:sp>
        <p:sp>
          <p:nvSpPr>
            <p:cNvPr id="428" name="tx45"/>
            <p:cNvSpPr/>
            <p:nvPr/>
          </p:nvSpPr>
          <p:spPr>
            <a:xfrm>
              <a:off x="14619240" y="5727960"/>
              <a:ext cx="510840" cy="10296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en-US" sz="1600" spc="-1" strike="noStrike">
                  <a:solidFill>
                    <a:srgbClr val="4d4d4d"/>
                  </a:solidFill>
                  <a:latin typeface="Arial"/>
                </a:rPr>
                <a:t>  </a:t>
              </a:r>
              <a:r>
                <a:rPr b="0" lang="en-US" sz="1600" spc="-1" strike="noStrike">
                  <a:solidFill>
                    <a:srgbClr val="4d4d4d"/>
                  </a:solidFill>
                  <a:latin typeface="Arial"/>
                </a:rPr>
                <a:t>C</a:t>
              </a:r>
              <a:r>
                <a:rPr b="0" lang="zh-CN" sz="1600" spc="-1" strike="noStrike">
                  <a:solidFill>
                    <a:srgbClr val="4d4d4d"/>
                  </a:solidFill>
                  <a:latin typeface="Arial"/>
                </a:rPr>
                <a:t>utoff_</a:t>
              </a:r>
              <a:r>
                <a:rPr b="0" lang="en-US" sz="1600" spc="-1" strike="noStrike">
                  <a:solidFill>
                    <a:srgbClr val="4d4d4d"/>
                  </a:solidFill>
                  <a:latin typeface="Arial"/>
                </a:rPr>
                <a:t>CEA</a:t>
              </a:r>
              <a:endParaRPr b="0" lang="en-US" sz="1600" spc="-1" strike="noStrike">
                <a:solidFill>
                  <a:srgbClr val="000000"/>
                </a:solidFill>
                <a:latin typeface="Arial"/>
              </a:endParaRPr>
            </a:p>
          </p:txBody>
        </p:sp>
        <p:sp>
          <p:nvSpPr>
            <p:cNvPr id="429" name="tx46"/>
            <p:cNvSpPr/>
            <p:nvPr/>
          </p:nvSpPr>
          <p:spPr>
            <a:xfrm>
              <a:off x="14691240" y="5121720"/>
              <a:ext cx="706320" cy="8388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en-US" sz="1600" spc="-1" strike="noStrike">
                  <a:solidFill>
                    <a:srgbClr val="4d4d4d"/>
                  </a:solidFill>
                  <a:latin typeface="Arial"/>
                </a:rPr>
                <a:t> </a:t>
              </a:r>
              <a:r>
                <a:rPr b="0" lang="zh-CN" sz="1600" spc="-1" strike="noStrike">
                  <a:solidFill>
                    <a:srgbClr val="4d4d4d"/>
                  </a:solidFill>
                  <a:latin typeface="Arial"/>
                </a:rPr>
                <a:t>CA19</a:t>
              </a:r>
              <a:r>
                <a:rPr b="0" lang="en-US" sz="1600" spc="-1" strike="noStrike">
                  <a:solidFill>
                    <a:srgbClr val="4d4d4d"/>
                  </a:solidFill>
                  <a:latin typeface="Arial"/>
                </a:rPr>
                <a:t>-</a:t>
              </a:r>
              <a:r>
                <a:rPr b="0" lang="zh-CN" sz="1600" spc="-1" strike="noStrike">
                  <a:solidFill>
                    <a:srgbClr val="4d4d4d"/>
                  </a:solidFill>
                  <a:latin typeface="Arial"/>
                </a:rPr>
                <a:t>9</a:t>
              </a:r>
              <a:r>
                <a:rPr b="0" lang="en-US" sz="1600" spc="-1" strike="noStrike">
                  <a:solidFill>
                    <a:srgbClr val="4d4d4d"/>
                  </a:solidFill>
                  <a:latin typeface="Arial"/>
                </a:rPr>
                <a:t>/</a:t>
              </a:r>
              <a:r>
                <a:rPr b="0" lang="zh-CN" sz="1600" spc="-1" strike="noStrike">
                  <a:solidFill>
                    <a:srgbClr val="4d4d4d"/>
                  </a:solidFill>
                  <a:latin typeface="Arial"/>
                </a:rPr>
                <a:t>CA125</a:t>
              </a:r>
              <a:endParaRPr b="0" lang="en-US" sz="1600" spc="-1" strike="noStrike">
                <a:solidFill>
                  <a:srgbClr val="000000"/>
                </a:solidFill>
                <a:latin typeface="Arial"/>
              </a:endParaRPr>
            </a:p>
          </p:txBody>
        </p:sp>
        <p:sp>
          <p:nvSpPr>
            <p:cNvPr id="430" name="tx47"/>
            <p:cNvSpPr/>
            <p:nvPr/>
          </p:nvSpPr>
          <p:spPr>
            <a:xfrm>
              <a:off x="14651640" y="4528080"/>
              <a:ext cx="634680" cy="10476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en-US" sz="1600" spc="-1" strike="noStrike">
                  <a:solidFill>
                    <a:srgbClr val="4d4d4d"/>
                  </a:solidFill>
                  <a:latin typeface="Arial"/>
                </a:rPr>
                <a:t>   </a:t>
              </a:r>
              <a:r>
                <a:rPr b="0" lang="en-US" sz="1600" spc="-1" strike="noStrike">
                  <a:solidFill>
                    <a:srgbClr val="4d4d4d"/>
                  </a:solidFill>
                  <a:latin typeface="Arial"/>
                </a:rPr>
                <a:t>Cu</a:t>
              </a:r>
              <a:r>
                <a:rPr b="0" lang="zh-CN" sz="1600" spc="-1" strike="noStrike">
                  <a:solidFill>
                    <a:srgbClr val="4d4d4d"/>
                  </a:solidFill>
                  <a:latin typeface="Arial"/>
                </a:rPr>
                <a:t>toff_</a:t>
              </a:r>
              <a:r>
                <a:rPr b="0" lang="en-US" sz="1600" spc="-1" strike="noStrike">
                  <a:solidFill>
                    <a:srgbClr val="4d4d4d"/>
                  </a:solidFill>
                  <a:latin typeface="Arial"/>
                </a:rPr>
                <a:t>CA</a:t>
              </a:r>
              <a:r>
                <a:rPr b="0" lang="zh-CN" sz="1600" spc="-1" strike="noStrike">
                  <a:solidFill>
                    <a:srgbClr val="4d4d4d"/>
                  </a:solidFill>
                  <a:latin typeface="Arial"/>
                </a:rPr>
                <a:t>19</a:t>
              </a:r>
              <a:r>
                <a:rPr b="0" lang="en-US" sz="1600" spc="-1" strike="noStrike">
                  <a:solidFill>
                    <a:srgbClr val="4d4d4d"/>
                  </a:solidFill>
                  <a:latin typeface="Arial"/>
                </a:rPr>
                <a:t>-</a:t>
              </a:r>
              <a:r>
                <a:rPr b="0" lang="zh-CN" sz="1600" spc="-1" strike="noStrike">
                  <a:solidFill>
                    <a:srgbClr val="4d4d4d"/>
                  </a:solidFill>
                  <a:latin typeface="Arial"/>
                </a:rPr>
                <a:t>9</a:t>
              </a:r>
              <a:endParaRPr b="0" lang="en-US" sz="1600" spc="-1" strike="noStrike">
                <a:solidFill>
                  <a:srgbClr val="000000"/>
                </a:solidFill>
                <a:latin typeface="Arial"/>
              </a:endParaRPr>
            </a:p>
          </p:txBody>
        </p:sp>
        <p:sp>
          <p:nvSpPr>
            <p:cNvPr id="431" name="tx48"/>
            <p:cNvSpPr/>
            <p:nvPr/>
          </p:nvSpPr>
          <p:spPr>
            <a:xfrm>
              <a:off x="13763520" y="3951720"/>
              <a:ext cx="919440" cy="10152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en-US" sz="1600" spc="-1" strike="noStrike">
                  <a:solidFill>
                    <a:srgbClr val="4d4d4d"/>
                  </a:solidFill>
                  <a:latin typeface="Arial"/>
                </a:rPr>
                <a:t>                  </a:t>
              </a:r>
              <a:r>
                <a:rPr b="0" lang="zh-CN" sz="1600" spc="-1" strike="noStrike">
                  <a:solidFill>
                    <a:srgbClr val="4d4d4d"/>
                  </a:solidFill>
                  <a:latin typeface="Arial"/>
                </a:rPr>
                <a:t>T</a:t>
              </a:r>
              <a:r>
                <a:rPr b="0" lang="en-US" sz="1600" spc="-1" strike="noStrike">
                  <a:solidFill>
                    <a:srgbClr val="4d4d4d"/>
                  </a:solidFill>
                  <a:latin typeface="Arial"/>
                </a:rPr>
                <a:t> stage</a:t>
              </a:r>
              <a:endParaRPr b="0" lang="en-US" sz="1600" spc="-1" strike="noStrike">
                <a:solidFill>
                  <a:srgbClr val="000000"/>
                </a:solidFill>
                <a:latin typeface="Arial"/>
              </a:endParaRPr>
            </a:p>
          </p:txBody>
        </p:sp>
        <p:sp>
          <p:nvSpPr>
            <p:cNvPr id="432" name="pl49"/>
            <p:cNvSpPr/>
            <p:nvPr/>
          </p:nvSpPr>
          <p:spPr>
            <a:xfrm>
              <a:off x="15797880" y="10062360"/>
              <a:ext cx="3420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33" name="pl50"/>
            <p:cNvSpPr/>
            <p:nvPr/>
          </p:nvSpPr>
          <p:spPr>
            <a:xfrm>
              <a:off x="15797880" y="9451080"/>
              <a:ext cx="3420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34" name="pl51"/>
            <p:cNvSpPr/>
            <p:nvPr/>
          </p:nvSpPr>
          <p:spPr>
            <a:xfrm>
              <a:off x="15797880" y="8839800"/>
              <a:ext cx="3420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35" name="pl52"/>
            <p:cNvSpPr/>
            <p:nvPr/>
          </p:nvSpPr>
          <p:spPr>
            <a:xfrm>
              <a:off x="15797880" y="8228520"/>
              <a:ext cx="3420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36" name="pl53"/>
            <p:cNvSpPr/>
            <p:nvPr/>
          </p:nvSpPr>
          <p:spPr>
            <a:xfrm>
              <a:off x="15797880" y="7617240"/>
              <a:ext cx="3420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37" name="pl54"/>
            <p:cNvSpPr/>
            <p:nvPr/>
          </p:nvSpPr>
          <p:spPr>
            <a:xfrm>
              <a:off x="15797880" y="7005960"/>
              <a:ext cx="3420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38" name="pl55"/>
            <p:cNvSpPr/>
            <p:nvPr/>
          </p:nvSpPr>
          <p:spPr>
            <a:xfrm>
              <a:off x="15797880" y="6394680"/>
              <a:ext cx="3420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39" name="pl56"/>
            <p:cNvSpPr/>
            <p:nvPr/>
          </p:nvSpPr>
          <p:spPr>
            <a:xfrm>
              <a:off x="15797880" y="5783400"/>
              <a:ext cx="3420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40" name="pl57"/>
            <p:cNvSpPr/>
            <p:nvPr/>
          </p:nvSpPr>
          <p:spPr>
            <a:xfrm>
              <a:off x="15797880" y="5172120"/>
              <a:ext cx="3420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41" name="pl58"/>
            <p:cNvSpPr/>
            <p:nvPr/>
          </p:nvSpPr>
          <p:spPr>
            <a:xfrm>
              <a:off x="15797880" y="4560840"/>
              <a:ext cx="3420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42" name="pl59"/>
            <p:cNvSpPr/>
            <p:nvPr/>
          </p:nvSpPr>
          <p:spPr>
            <a:xfrm>
              <a:off x="15797880" y="3949560"/>
              <a:ext cx="3420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43" name="pl60"/>
            <p:cNvSpPr/>
            <p:nvPr/>
          </p:nvSpPr>
          <p:spPr>
            <a:xfrm>
              <a:off x="17354160" y="10428840"/>
              <a:ext cx="360" cy="34560"/>
            </a:xfrm>
            <a:custGeom>
              <a:avLst/>
              <a:gdLst/>
              <a:ahLst/>
              <a:rect l="l" t="t" r="r" b="b"/>
              <a:pathLst>
                <a:path w="1" h="34794">
                  <a:moveTo>
                    <a:pt x="0" y="34794"/>
                  </a:moveTo>
                  <a:lnTo>
                    <a:pt x="0" y="0"/>
                  </a:lnTo>
                </a:path>
              </a:pathLst>
            </a:custGeom>
            <a:noFill/>
            <a:ln w="13680">
              <a:solidFill>
                <a:srgbClr val="333333"/>
              </a:solidFill>
              <a:round/>
            </a:ln>
          </p:spPr>
          <p:style>
            <a:lnRef idx="0"/>
            <a:fillRef idx="0"/>
            <a:effectRef idx="0"/>
            <a:fontRef idx="minor"/>
          </p:style>
          <p:txBody>
            <a:bodyPr lIns="90000" rIns="90000" tIns="-12240" bIns="-122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44" name="pl61"/>
            <p:cNvSpPr/>
            <p:nvPr/>
          </p:nvSpPr>
          <p:spPr>
            <a:xfrm>
              <a:off x="18223920" y="10428840"/>
              <a:ext cx="360" cy="34560"/>
            </a:xfrm>
            <a:custGeom>
              <a:avLst/>
              <a:gdLst/>
              <a:ahLst/>
              <a:rect l="l" t="t" r="r" b="b"/>
              <a:pathLst>
                <a:path w="1" h="34794">
                  <a:moveTo>
                    <a:pt x="0" y="34794"/>
                  </a:moveTo>
                  <a:lnTo>
                    <a:pt x="0" y="0"/>
                  </a:lnTo>
                </a:path>
              </a:pathLst>
            </a:custGeom>
            <a:noFill/>
            <a:ln w="13680">
              <a:solidFill>
                <a:srgbClr val="333333"/>
              </a:solidFill>
              <a:round/>
            </a:ln>
          </p:spPr>
          <p:style>
            <a:lnRef idx="0"/>
            <a:fillRef idx="0"/>
            <a:effectRef idx="0"/>
            <a:fontRef idx="minor"/>
          </p:style>
          <p:txBody>
            <a:bodyPr lIns="90000" rIns="90000" tIns="-12240" bIns="-122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45" name="pl62"/>
            <p:cNvSpPr/>
            <p:nvPr/>
          </p:nvSpPr>
          <p:spPr>
            <a:xfrm>
              <a:off x="19093680" y="10428840"/>
              <a:ext cx="360" cy="34560"/>
            </a:xfrm>
            <a:custGeom>
              <a:avLst/>
              <a:gdLst/>
              <a:ahLst/>
              <a:rect l="l" t="t" r="r" b="b"/>
              <a:pathLst>
                <a:path w="1" h="34794">
                  <a:moveTo>
                    <a:pt x="0" y="34794"/>
                  </a:moveTo>
                  <a:lnTo>
                    <a:pt x="0" y="0"/>
                  </a:lnTo>
                </a:path>
              </a:pathLst>
            </a:custGeom>
            <a:noFill/>
            <a:ln w="13680">
              <a:solidFill>
                <a:srgbClr val="333333"/>
              </a:solidFill>
              <a:round/>
            </a:ln>
          </p:spPr>
          <p:style>
            <a:lnRef idx="0"/>
            <a:fillRef idx="0"/>
            <a:effectRef idx="0"/>
            <a:fontRef idx="minor"/>
          </p:style>
          <p:txBody>
            <a:bodyPr lIns="90000" rIns="90000" tIns="-12240" bIns="-122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46" name="tx63"/>
            <p:cNvSpPr/>
            <p:nvPr/>
          </p:nvSpPr>
          <p:spPr>
            <a:xfrm>
              <a:off x="17322840" y="10591920"/>
              <a:ext cx="61560" cy="8064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zh-CN" sz="1600" spc="-1" strike="noStrike">
                  <a:solidFill>
                    <a:srgbClr val="4d4d4d"/>
                  </a:solidFill>
                  <a:latin typeface="Arial"/>
                </a:rPr>
                <a:t>3</a:t>
              </a:r>
              <a:endParaRPr b="0" lang="en-US" sz="1600" spc="-1" strike="noStrike">
                <a:solidFill>
                  <a:srgbClr val="000000"/>
                </a:solidFill>
                <a:latin typeface="Arial"/>
              </a:endParaRPr>
            </a:p>
          </p:txBody>
        </p:sp>
        <p:sp>
          <p:nvSpPr>
            <p:cNvPr id="447" name="tx64"/>
            <p:cNvSpPr/>
            <p:nvPr/>
          </p:nvSpPr>
          <p:spPr>
            <a:xfrm>
              <a:off x="18192960" y="10595160"/>
              <a:ext cx="61560" cy="7776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zh-CN" sz="1600" spc="-1" strike="noStrike">
                  <a:solidFill>
                    <a:srgbClr val="4d4d4d"/>
                  </a:solidFill>
                  <a:latin typeface="Arial"/>
                </a:rPr>
                <a:t>5</a:t>
              </a:r>
              <a:endParaRPr b="0" lang="en-US" sz="1600" spc="-1" strike="noStrike">
                <a:solidFill>
                  <a:srgbClr val="000000"/>
                </a:solidFill>
                <a:latin typeface="Arial"/>
              </a:endParaRPr>
            </a:p>
          </p:txBody>
        </p:sp>
        <p:sp>
          <p:nvSpPr>
            <p:cNvPr id="448" name="tx65"/>
            <p:cNvSpPr/>
            <p:nvPr/>
          </p:nvSpPr>
          <p:spPr>
            <a:xfrm>
              <a:off x="19062720" y="10595160"/>
              <a:ext cx="60120" cy="7776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zh-CN" sz="1600" spc="-1" strike="noStrike">
                  <a:solidFill>
                    <a:srgbClr val="4d4d4d"/>
                  </a:solidFill>
                  <a:latin typeface="Arial"/>
                </a:rPr>
                <a:t>7</a:t>
              </a:r>
              <a:endParaRPr b="0" lang="en-US" sz="1600" spc="-1" strike="noStrike">
                <a:solidFill>
                  <a:srgbClr val="000000"/>
                </a:solidFill>
                <a:latin typeface="Arial"/>
              </a:endParaRPr>
            </a:p>
          </p:txBody>
        </p:sp>
        <p:sp>
          <p:nvSpPr>
            <p:cNvPr id="449" name="tx66"/>
            <p:cNvSpPr/>
            <p:nvPr/>
          </p:nvSpPr>
          <p:spPr>
            <a:xfrm>
              <a:off x="17427600" y="10865160"/>
              <a:ext cx="1678320" cy="102960"/>
            </a:xfrm>
            <a:prstGeom prst="rect">
              <a:avLst/>
            </a:prstGeom>
            <a:noFill/>
            <a:ln w="0">
              <a:noFill/>
            </a:ln>
          </p:spPr>
          <p:style>
            <a:lnRef idx="0"/>
            <a:fillRef idx="0"/>
            <a:effectRef idx="0"/>
            <a:fontRef idx="minor"/>
          </p:style>
          <p:txBody>
            <a:bodyPr wrap="none" lIns="0" rIns="0" tIns="0" bIns="0" anchor="ctr" anchorCtr="1">
              <a:noAutofit/>
            </a:bodyPr>
            <a:p>
              <a:pPr>
                <a:lnSpc>
                  <a:spcPts val="1100"/>
                </a:lnSpc>
                <a:tabLst>
                  <a:tab algn="l" pos="0"/>
                  <a:tab algn="l" pos="1487520"/>
                  <a:tab algn="l" pos="2975040"/>
                  <a:tab algn="l" pos="4462560"/>
                  <a:tab algn="l" pos="5950080"/>
                  <a:tab algn="l" pos="7437600"/>
                  <a:tab algn="l" pos="8924760"/>
                  <a:tab algn="l" pos="10412280"/>
                </a:tabLst>
              </a:pPr>
              <a:r>
                <a:rPr b="0" lang="zh-CN" sz="1600" spc="-1" strike="noStrike">
                  <a:solidFill>
                    <a:srgbClr val="000000"/>
                  </a:solidFill>
                  <a:latin typeface="Arial"/>
                </a:rPr>
                <a:t>Times of variables selected</a:t>
              </a:r>
              <a:endParaRPr b="0" lang="en-US" sz="1600" spc="-1" strike="noStrike">
                <a:solidFill>
                  <a:srgbClr val="000000"/>
                </a:solidFill>
                <a:latin typeface="Arial"/>
              </a:endParaRPr>
            </a:p>
          </p:txBody>
        </p:sp>
        <p:sp>
          <p:nvSpPr>
            <p:cNvPr id="450" name="tx68"/>
            <p:cNvSpPr/>
            <p:nvPr/>
          </p:nvSpPr>
          <p:spPr>
            <a:xfrm>
              <a:off x="18270720" y="8215560"/>
              <a:ext cx="1131840" cy="101520"/>
            </a:xfrm>
            <a:prstGeom prst="rect">
              <a:avLst/>
            </a:prstGeom>
            <a:noFill/>
            <a:ln w="0">
              <a:noFill/>
            </a:ln>
          </p:spPr>
          <p:style>
            <a:lnRef idx="0"/>
            <a:fillRef idx="0"/>
            <a:effectRef idx="0"/>
            <a:fontRef idx="minor"/>
          </p:style>
          <p:txBody>
            <a:bodyPr wrap="none" lIns="0" rIns="0" tIns="0" bIns="0" anchor="ctr" anchorCtr="1">
              <a:noAutofit/>
            </a:bodyPr>
            <a:p>
              <a:pPr>
                <a:lnSpc>
                  <a:spcPts val="1100"/>
                </a:lnSpc>
                <a:tabLst>
                  <a:tab algn="l" pos="0"/>
                  <a:tab algn="l" pos="1487520"/>
                  <a:tab algn="l" pos="2975040"/>
                  <a:tab algn="l" pos="4462560"/>
                  <a:tab algn="l" pos="5950080"/>
                  <a:tab algn="l" pos="7437600"/>
                  <a:tab algn="l" pos="8924760"/>
                  <a:tab algn="l" pos="10412280"/>
                </a:tabLst>
              </a:pPr>
              <a:r>
                <a:rPr b="0" lang="zh-CN" sz="1600" spc="-1" strike="noStrike">
                  <a:solidFill>
                    <a:srgbClr val="000000"/>
                  </a:solidFill>
                  <a:latin typeface="Arial"/>
                </a:rPr>
                <a:t>Variables selected</a:t>
              </a:r>
              <a:endParaRPr b="0" lang="en-US" sz="1600" spc="-1" strike="noStrike">
                <a:solidFill>
                  <a:srgbClr val="000000"/>
                </a:solidFill>
                <a:latin typeface="Arial"/>
              </a:endParaRPr>
            </a:p>
          </p:txBody>
        </p:sp>
        <p:sp>
          <p:nvSpPr>
            <p:cNvPr id="451" name="rc69"/>
            <p:cNvSpPr/>
            <p:nvPr/>
          </p:nvSpPr>
          <p:spPr>
            <a:xfrm>
              <a:off x="18334440" y="8408160"/>
              <a:ext cx="217440" cy="21924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52" name="rc70"/>
            <p:cNvSpPr/>
            <p:nvPr/>
          </p:nvSpPr>
          <p:spPr>
            <a:xfrm>
              <a:off x="18072720" y="8537760"/>
              <a:ext cx="199440" cy="201240"/>
            </a:xfrm>
            <a:prstGeom prst="rect">
              <a:avLst/>
            </a:prstGeom>
            <a:solidFill>
              <a:srgbClr val="bc3c29"/>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53" name="rc71"/>
            <p:cNvSpPr/>
            <p:nvPr/>
          </p:nvSpPr>
          <p:spPr>
            <a:xfrm>
              <a:off x="18334440" y="8627400"/>
              <a:ext cx="217440" cy="21924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54" name="rc72"/>
            <p:cNvSpPr/>
            <p:nvPr/>
          </p:nvSpPr>
          <p:spPr>
            <a:xfrm>
              <a:off x="18072720" y="8828640"/>
              <a:ext cx="199440" cy="201240"/>
            </a:xfrm>
            <a:prstGeom prst="rect">
              <a:avLst/>
            </a:prstGeom>
            <a:solidFill>
              <a:srgbClr val="0072b5"/>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55" name="tx73"/>
            <p:cNvSpPr/>
            <p:nvPr/>
          </p:nvSpPr>
          <p:spPr>
            <a:xfrm>
              <a:off x="18547200" y="8619480"/>
              <a:ext cx="460080" cy="8388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zh-CN" sz="1600" spc="-1" strike="noStrike">
                  <a:solidFill>
                    <a:srgbClr val="000000"/>
                  </a:solidFill>
                  <a:latin typeface="Arial"/>
                </a:rPr>
                <a:t>&gt; median</a:t>
              </a:r>
              <a:endParaRPr b="0" lang="en-US" sz="1600" spc="-1" strike="noStrike">
                <a:solidFill>
                  <a:srgbClr val="000000"/>
                </a:solidFill>
                <a:latin typeface="Arial"/>
              </a:endParaRPr>
            </a:p>
          </p:txBody>
        </p:sp>
        <p:sp>
          <p:nvSpPr>
            <p:cNvPr id="456" name="tx74"/>
            <p:cNvSpPr/>
            <p:nvPr/>
          </p:nvSpPr>
          <p:spPr>
            <a:xfrm>
              <a:off x="18547200" y="8911800"/>
              <a:ext cx="523800" cy="80640"/>
            </a:xfrm>
            <a:prstGeom prst="rect">
              <a:avLst/>
            </a:prstGeom>
            <a:noFill/>
            <a:ln w="0">
              <a:noFill/>
            </a:ln>
          </p:spPr>
          <p:style>
            <a:lnRef idx="0"/>
            <a:fillRef idx="0"/>
            <a:effectRef idx="0"/>
            <a:fontRef idx="minor"/>
          </p:style>
          <p:txBody>
            <a:bodyPr wrap="none" lIns="0" rIns="0" tIns="0" bIns="0" anchor="ctr" anchorCtr="1">
              <a:noAutofit/>
            </a:bodyPr>
            <a:p>
              <a:pPr>
                <a:lnSpc>
                  <a:spcPts val="873"/>
                </a:lnSpc>
                <a:tabLst>
                  <a:tab algn="l" pos="0"/>
                  <a:tab algn="l" pos="1487520"/>
                  <a:tab algn="l" pos="2975040"/>
                  <a:tab algn="l" pos="4462560"/>
                  <a:tab algn="l" pos="5950080"/>
                  <a:tab algn="l" pos="7437600"/>
                  <a:tab algn="l" pos="8924760"/>
                  <a:tab algn="l" pos="10412280"/>
                </a:tabLst>
              </a:pPr>
              <a:r>
                <a:rPr b="0" lang="zh-CN" sz="1600" spc="-1" strike="noStrike">
                  <a:solidFill>
                    <a:srgbClr val="000000"/>
                  </a:solidFill>
                  <a:latin typeface="Arial"/>
                </a:rPr>
                <a:t>&lt;= median</a:t>
              </a:r>
              <a:endParaRPr b="0" lang="en-US" sz="1600" spc="-1" strike="noStrike">
                <a:solidFill>
                  <a:srgbClr val="000000"/>
                </a:solidFill>
                <a:latin typeface="Arial"/>
              </a:endParaRPr>
            </a:p>
          </p:txBody>
        </p:sp>
      </p:grpSp>
      <p:sp>
        <p:nvSpPr>
          <p:cNvPr id="457" name="文本框 139"/>
          <p:cNvSpPr/>
          <p:nvPr/>
        </p:nvSpPr>
        <p:spPr>
          <a:xfrm>
            <a:off x="1625760" y="11215800"/>
            <a:ext cx="18649800" cy="26542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1487520"/>
                <a:tab algn="l" pos="2975040"/>
                <a:tab algn="l" pos="4462560"/>
                <a:tab algn="l" pos="5950080"/>
                <a:tab algn="l" pos="7437600"/>
                <a:tab algn="l" pos="8924760"/>
                <a:tab algn="l" pos="10412280"/>
              </a:tabLst>
            </a:pPr>
            <a:r>
              <a:rPr b="1" lang="en-US" sz="2400" spc="-1" strike="noStrike">
                <a:solidFill>
                  <a:srgbClr val="000000"/>
                </a:solidFill>
                <a:latin typeface="Times New Roman"/>
              </a:rPr>
              <a:t>Figure S3.</a:t>
            </a:r>
            <a:r>
              <a:rPr b="0" lang="en-US" sz="2400" spc="-1" strike="noStrike">
                <a:solidFill>
                  <a:srgbClr val="000000"/>
                </a:solidFill>
                <a:latin typeface="Times New Roman"/>
              </a:rPr>
              <a:t> The texture features of CRC metastasis were selected using the LASSO and IQR. </a:t>
            </a:r>
            <a:endParaRPr b="0" lang="en-US" sz="2400" spc="-1" strike="noStrike">
              <a:solidFill>
                <a:srgbClr val="000000"/>
              </a:solidFill>
              <a:latin typeface="Arial"/>
            </a:endParaRPr>
          </a:p>
          <a:p>
            <a:pPr algn="just">
              <a:lnSpc>
                <a:spcPct val="100000"/>
              </a:lnSpc>
              <a:tabLst>
                <a:tab algn="l" pos="0"/>
                <a:tab algn="l" pos="1487520"/>
                <a:tab algn="l" pos="2975040"/>
                <a:tab algn="l" pos="4462560"/>
                <a:tab algn="l" pos="5950080"/>
                <a:tab algn="l" pos="7437600"/>
                <a:tab algn="l" pos="8924760"/>
                <a:tab algn="l" pos="10412280"/>
              </a:tabLst>
            </a:pPr>
            <a:r>
              <a:rPr b="0" lang="en-US" sz="2400" spc="-1" strike="noStrike">
                <a:solidFill>
                  <a:srgbClr val="000000"/>
                </a:solidFill>
                <a:latin typeface="Times New Roman"/>
              </a:rPr>
              <a:t>(A) Tuning parameter (λ) selection in the LASSO model used random stratified sampling 10 times by different seeds for CRC metastasis (there was only 1 representative seed, the remaining 9 seeds are not shown). The area under the receiver operating characteristic curve was plotted versus log (λ). Dotted vertical lines were drawn at the optimal values by using the minimum criteria (left dashed line) and the 1 standard error of the minimum criteria (right dashed line). Based on the 1 standard error of the minimum criteria (B) and the minimum criteria (C) results of 10 times LASSO calculation, we chosen the variables, of which selected times were greater than the median selected times, to build the CRC metastasis model.</a:t>
            </a:r>
            <a:endParaRPr b="0" lang="en-US" sz="2400" spc="-1" strike="noStrike">
              <a:solidFill>
                <a:srgbClr val="000000"/>
              </a:solidFill>
              <a:latin typeface="Arial"/>
            </a:endParaRPr>
          </a:p>
          <a:p>
            <a:pPr algn="just">
              <a:lnSpc>
                <a:spcPct val="100000"/>
              </a:lnSpc>
              <a:tabLst>
                <a:tab algn="l" pos="0"/>
                <a:tab algn="l" pos="1487520"/>
                <a:tab algn="l" pos="2975040"/>
                <a:tab algn="l" pos="4462560"/>
                <a:tab algn="l" pos="5950080"/>
                <a:tab algn="l" pos="7437600"/>
                <a:tab algn="l" pos="8924760"/>
                <a:tab algn="l" pos="10412280"/>
              </a:tabLst>
            </a:pPr>
            <a:r>
              <a:rPr b="0" lang="en-US" sz="2400" spc="-1" strike="noStrike">
                <a:solidFill>
                  <a:srgbClr val="000000"/>
                </a:solidFill>
                <a:latin typeface="Times New Roman"/>
              </a:rPr>
              <a:t>LASSO: Least absolute shrinkage and selection operator; IQR: Interquartile range.</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58" name="组合 372"/>
          <p:cNvGrpSpPr/>
          <p:nvPr/>
        </p:nvGrpSpPr>
        <p:grpSpPr>
          <a:xfrm>
            <a:off x="2994120" y="7399440"/>
            <a:ext cx="7315200" cy="7316640"/>
            <a:chOff x="2994120" y="7399440"/>
            <a:chExt cx="7315200" cy="7316640"/>
          </a:xfrm>
        </p:grpSpPr>
        <p:sp>
          <p:nvSpPr>
            <p:cNvPr id="459" name="rc3"/>
            <p:cNvSpPr/>
            <p:nvPr/>
          </p:nvSpPr>
          <p:spPr>
            <a:xfrm>
              <a:off x="2994120" y="7399440"/>
              <a:ext cx="7315200" cy="7316640"/>
            </a:xfrm>
            <a:prstGeom prst="rect">
              <a:avLst/>
            </a:prstGeom>
            <a:solidFill>
              <a:srgbClr val="ffffff"/>
            </a:solidFill>
            <a:ln cap="rnd" w="9360">
              <a:solidFill>
                <a:srgbClr val="ffffff"/>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60" name="tx4"/>
            <p:cNvSpPr/>
            <p:nvPr/>
          </p:nvSpPr>
          <p:spPr>
            <a:xfrm>
              <a:off x="3444480" y="8300520"/>
              <a:ext cx="423360" cy="11088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zh-CN" sz="1200" spc="-1" strike="noStrike">
                  <a:solidFill>
                    <a:srgbClr val="000000"/>
                  </a:solidFill>
                  <a:latin typeface="Arial"/>
                </a:rPr>
                <a:t>Points</a:t>
              </a:r>
              <a:endParaRPr b="0" lang="en-US" sz="1200" spc="-1" strike="noStrike">
                <a:solidFill>
                  <a:srgbClr val="000000"/>
                </a:solidFill>
                <a:latin typeface="Arial"/>
              </a:endParaRPr>
            </a:p>
          </p:txBody>
        </p:sp>
        <p:sp>
          <p:nvSpPr>
            <p:cNvPr id="461" name="pl5"/>
            <p:cNvSpPr/>
            <p:nvPr/>
          </p:nvSpPr>
          <p:spPr>
            <a:xfrm>
              <a:off x="5060160" y="8357760"/>
              <a:ext cx="4615920" cy="360"/>
            </a:xfrm>
            <a:custGeom>
              <a:avLst/>
              <a:gdLst/>
              <a:ahLst/>
              <a:rect l="l" t="t" r="r" b="b"/>
              <a:pathLst>
                <a:path w="4615901" h="1">
                  <a:moveTo>
                    <a:pt x="0" y="0"/>
                  </a:moveTo>
                  <a:lnTo>
                    <a:pt x="4615901"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62" name="pl6"/>
            <p:cNvSpPr/>
            <p:nvPr/>
          </p:nvSpPr>
          <p:spPr>
            <a:xfrm>
              <a:off x="5060160" y="8312040"/>
              <a:ext cx="360" cy="4572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63" name="pl7"/>
            <p:cNvSpPr/>
            <p:nvPr/>
          </p:nvSpPr>
          <p:spPr>
            <a:xfrm>
              <a:off x="5521680" y="8312040"/>
              <a:ext cx="360" cy="4572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64" name="pl8"/>
            <p:cNvSpPr/>
            <p:nvPr/>
          </p:nvSpPr>
          <p:spPr>
            <a:xfrm>
              <a:off x="5983200" y="8312040"/>
              <a:ext cx="360" cy="4572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65" name="pl9"/>
            <p:cNvSpPr/>
            <p:nvPr/>
          </p:nvSpPr>
          <p:spPr>
            <a:xfrm>
              <a:off x="6444720" y="8312040"/>
              <a:ext cx="360" cy="4572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66" name="pl10"/>
            <p:cNvSpPr/>
            <p:nvPr/>
          </p:nvSpPr>
          <p:spPr>
            <a:xfrm>
              <a:off x="6906600" y="8312040"/>
              <a:ext cx="360" cy="4572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67" name="pl11"/>
            <p:cNvSpPr/>
            <p:nvPr/>
          </p:nvSpPr>
          <p:spPr>
            <a:xfrm>
              <a:off x="7368120" y="8312040"/>
              <a:ext cx="360" cy="4572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68" name="pl12"/>
            <p:cNvSpPr/>
            <p:nvPr/>
          </p:nvSpPr>
          <p:spPr>
            <a:xfrm>
              <a:off x="7829640" y="8312040"/>
              <a:ext cx="360" cy="4572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69" name="pl13"/>
            <p:cNvSpPr/>
            <p:nvPr/>
          </p:nvSpPr>
          <p:spPr>
            <a:xfrm>
              <a:off x="8291160" y="8312040"/>
              <a:ext cx="360" cy="4572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70" name="pl14"/>
            <p:cNvSpPr/>
            <p:nvPr/>
          </p:nvSpPr>
          <p:spPr>
            <a:xfrm>
              <a:off x="8753040" y="8312040"/>
              <a:ext cx="360" cy="4572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71" name="pl15"/>
            <p:cNvSpPr/>
            <p:nvPr/>
          </p:nvSpPr>
          <p:spPr>
            <a:xfrm>
              <a:off x="9214560" y="8312040"/>
              <a:ext cx="360" cy="4572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72" name="pl16"/>
            <p:cNvSpPr/>
            <p:nvPr/>
          </p:nvSpPr>
          <p:spPr>
            <a:xfrm>
              <a:off x="9676080" y="8312040"/>
              <a:ext cx="360" cy="4572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73" name="pl17"/>
            <p:cNvSpPr/>
            <p:nvPr/>
          </p:nvSpPr>
          <p:spPr>
            <a:xfrm>
              <a:off x="5060160" y="8357760"/>
              <a:ext cx="4615920" cy="360"/>
            </a:xfrm>
            <a:custGeom>
              <a:avLst/>
              <a:gdLst/>
              <a:ahLst/>
              <a:rect l="l" t="t" r="r" b="b"/>
              <a:pathLst>
                <a:path w="4615901" h="1">
                  <a:moveTo>
                    <a:pt x="0" y="0"/>
                  </a:moveTo>
                  <a:lnTo>
                    <a:pt x="4615901"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74" name="pl18"/>
            <p:cNvSpPr/>
            <p:nvPr/>
          </p:nvSpPr>
          <p:spPr>
            <a:xfrm>
              <a:off x="5060160" y="83577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75" name="pl19"/>
            <p:cNvSpPr/>
            <p:nvPr/>
          </p:nvSpPr>
          <p:spPr>
            <a:xfrm>
              <a:off x="5521680" y="83577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76" name="pl20"/>
            <p:cNvSpPr/>
            <p:nvPr/>
          </p:nvSpPr>
          <p:spPr>
            <a:xfrm>
              <a:off x="5983200" y="83577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77" name="pl21"/>
            <p:cNvSpPr/>
            <p:nvPr/>
          </p:nvSpPr>
          <p:spPr>
            <a:xfrm>
              <a:off x="6444720" y="83577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78" name="pl22"/>
            <p:cNvSpPr/>
            <p:nvPr/>
          </p:nvSpPr>
          <p:spPr>
            <a:xfrm>
              <a:off x="6906600" y="83577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79" name="pl23"/>
            <p:cNvSpPr/>
            <p:nvPr/>
          </p:nvSpPr>
          <p:spPr>
            <a:xfrm>
              <a:off x="7368120" y="83577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80" name="pl24"/>
            <p:cNvSpPr/>
            <p:nvPr/>
          </p:nvSpPr>
          <p:spPr>
            <a:xfrm>
              <a:off x="7829640" y="83577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81" name="pl25"/>
            <p:cNvSpPr/>
            <p:nvPr/>
          </p:nvSpPr>
          <p:spPr>
            <a:xfrm>
              <a:off x="8291160" y="83577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82" name="pl26"/>
            <p:cNvSpPr/>
            <p:nvPr/>
          </p:nvSpPr>
          <p:spPr>
            <a:xfrm>
              <a:off x="8753040" y="83577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83" name="pl27"/>
            <p:cNvSpPr/>
            <p:nvPr/>
          </p:nvSpPr>
          <p:spPr>
            <a:xfrm>
              <a:off x="9214560" y="83577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84" name="pl28"/>
            <p:cNvSpPr/>
            <p:nvPr/>
          </p:nvSpPr>
          <p:spPr>
            <a:xfrm>
              <a:off x="9676080" y="83577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485" name="tx29" descr=""/>
            <p:cNvPicPr/>
            <p:nvPr/>
          </p:nvPicPr>
          <p:blipFill>
            <a:blip r:embed="rId1"/>
            <a:stretch/>
          </p:blipFill>
          <p:spPr>
            <a:xfrm>
              <a:off x="5010480" y="8111520"/>
              <a:ext cx="100080" cy="145800"/>
            </a:xfrm>
            <a:prstGeom prst="rect">
              <a:avLst/>
            </a:prstGeom>
            <a:ln w="0">
              <a:noFill/>
            </a:ln>
          </p:spPr>
        </p:pic>
        <p:pic>
          <p:nvPicPr>
            <p:cNvPr id="486" name="tx30" descr=""/>
            <p:cNvPicPr/>
            <p:nvPr/>
          </p:nvPicPr>
          <p:blipFill>
            <a:blip r:embed="rId2"/>
            <a:stretch/>
          </p:blipFill>
          <p:spPr>
            <a:xfrm>
              <a:off x="5436720" y="8111520"/>
              <a:ext cx="172080" cy="145800"/>
            </a:xfrm>
            <a:prstGeom prst="rect">
              <a:avLst/>
            </a:prstGeom>
            <a:ln w="0">
              <a:noFill/>
            </a:ln>
          </p:spPr>
        </p:pic>
        <p:pic>
          <p:nvPicPr>
            <p:cNvPr id="487" name="tx31" descr=""/>
            <p:cNvPicPr/>
            <p:nvPr/>
          </p:nvPicPr>
          <p:blipFill>
            <a:blip r:embed="rId3"/>
            <a:stretch/>
          </p:blipFill>
          <p:spPr>
            <a:xfrm>
              <a:off x="5897880" y="8111520"/>
              <a:ext cx="172080" cy="145800"/>
            </a:xfrm>
            <a:prstGeom prst="rect">
              <a:avLst/>
            </a:prstGeom>
            <a:ln w="0">
              <a:noFill/>
            </a:ln>
          </p:spPr>
        </p:pic>
        <p:pic>
          <p:nvPicPr>
            <p:cNvPr id="488" name="tx32" descr=""/>
            <p:cNvPicPr/>
            <p:nvPr/>
          </p:nvPicPr>
          <p:blipFill>
            <a:blip r:embed="rId4"/>
            <a:stretch/>
          </p:blipFill>
          <p:spPr>
            <a:xfrm>
              <a:off x="6359040" y="8111520"/>
              <a:ext cx="172080" cy="145800"/>
            </a:xfrm>
            <a:prstGeom prst="rect">
              <a:avLst/>
            </a:prstGeom>
            <a:ln w="0">
              <a:noFill/>
            </a:ln>
          </p:spPr>
        </p:pic>
        <p:pic>
          <p:nvPicPr>
            <p:cNvPr id="489" name="tx33" descr=""/>
            <p:cNvPicPr/>
            <p:nvPr/>
          </p:nvPicPr>
          <p:blipFill>
            <a:blip r:embed="rId5"/>
            <a:stretch/>
          </p:blipFill>
          <p:spPr>
            <a:xfrm>
              <a:off x="6820920" y="8111520"/>
              <a:ext cx="172080" cy="145800"/>
            </a:xfrm>
            <a:prstGeom prst="rect">
              <a:avLst/>
            </a:prstGeom>
            <a:ln w="0">
              <a:noFill/>
            </a:ln>
          </p:spPr>
        </p:pic>
        <p:pic>
          <p:nvPicPr>
            <p:cNvPr id="490" name="tx34" descr=""/>
            <p:cNvPicPr/>
            <p:nvPr/>
          </p:nvPicPr>
          <p:blipFill>
            <a:blip r:embed="rId6"/>
            <a:stretch/>
          </p:blipFill>
          <p:spPr>
            <a:xfrm>
              <a:off x="7282800" y="8111520"/>
              <a:ext cx="172080" cy="145800"/>
            </a:xfrm>
            <a:prstGeom prst="rect">
              <a:avLst/>
            </a:prstGeom>
            <a:ln w="0">
              <a:noFill/>
            </a:ln>
          </p:spPr>
        </p:pic>
        <p:pic>
          <p:nvPicPr>
            <p:cNvPr id="491" name="tx35" descr=""/>
            <p:cNvPicPr/>
            <p:nvPr/>
          </p:nvPicPr>
          <p:blipFill>
            <a:blip r:embed="rId7"/>
            <a:stretch/>
          </p:blipFill>
          <p:spPr>
            <a:xfrm>
              <a:off x="7744320" y="8111520"/>
              <a:ext cx="172080" cy="145800"/>
            </a:xfrm>
            <a:prstGeom prst="rect">
              <a:avLst/>
            </a:prstGeom>
            <a:ln w="0">
              <a:noFill/>
            </a:ln>
          </p:spPr>
        </p:pic>
        <p:pic>
          <p:nvPicPr>
            <p:cNvPr id="492" name="tx36" descr=""/>
            <p:cNvPicPr/>
            <p:nvPr/>
          </p:nvPicPr>
          <p:blipFill>
            <a:blip r:embed="rId8"/>
            <a:stretch/>
          </p:blipFill>
          <p:spPr>
            <a:xfrm>
              <a:off x="8205480" y="8111520"/>
              <a:ext cx="172080" cy="145800"/>
            </a:xfrm>
            <a:prstGeom prst="rect">
              <a:avLst/>
            </a:prstGeom>
            <a:ln w="0">
              <a:noFill/>
            </a:ln>
          </p:spPr>
        </p:pic>
        <p:pic>
          <p:nvPicPr>
            <p:cNvPr id="493" name="tx37" descr=""/>
            <p:cNvPicPr/>
            <p:nvPr/>
          </p:nvPicPr>
          <p:blipFill>
            <a:blip r:embed="rId9"/>
            <a:stretch/>
          </p:blipFill>
          <p:spPr>
            <a:xfrm>
              <a:off x="8667360" y="8111520"/>
              <a:ext cx="172080" cy="145800"/>
            </a:xfrm>
            <a:prstGeom prst="rect">
              <a:avLst/>
            </a:prstGeom>
            <a:ln w="0">
              <a:noFill/>
            </a:ln>
          </p:spPr>
        </p:pic>
        <p:pic>
          <p:nvPicPr>
            <p:cNvPr id="494" name="tx38" descr=""/>
            <p:cNvPicPr/>
            <p:nvPr/>
          </p:nvPicPr>
          <p:blipFill>
            <a:blip r:embed="rId10"/>
            <a:stretch/>
          </p:blipFill>
          <p:spPr>
            <a:xfrm>
              <a:off x="9129240" y="8111520"/>
              <a:ext cx="172080" cy="145800"/>
            </a:xfrm>
            <a:prstGeom prst="rect">
              <a:avLst/>
            </a:prstGeom>
            <a:ln w="0">
              <a:noFill/>
            </a:ln>
          </p:spPr>
        </p:pic>
        <p:pic>
          <p:nvPicPr>
            <p:cNvPr id="495" name="tx39" descr=""/>
            <p:cNvPicPr/>
            <p:nvPr/>
          </p:nvPicPr>
          <p:blipFill>
            <a:blip r:embed="rId11"/>
            <a:stretch/>
          </p:blipFill>
          <p:spPr>
            <a:xfrm>
              <a:off x="9554760" y="8111520"/>
              <a:ext cx="243720" cy="145800"/>
            </a:xfrm>
            <a:prstGeom prst="rect">
              <a:avLst/>
            </a:prstGeom>
            <a:ln w="0">
              <a:noFill/>
            </a:ln>
          </p:spPr>
        </p:pic>
        <p:sp>
          <p:nvSpPr>
            <p:cNvPr id="496" name="pl40"/>
            <p:cNvSpPr/>
            <p:nvPr/>
          </p:nvSpPr>
          <p:spPr>
            <a:xfrm>
              <a:off x="5175360" y="8357760"/>
              <a:ext cx="4385160" cy="360"/>
            </a:xfrm>
            <a:custGeom>
              <a:avLst/>
              <a:gdLst/>
              <a:ahLst/>
              <a:rect l="l" t="t" r="r" b="b"/>
              <a:pathLst>
                <a:path w="4385106" h="1">
                  <a:moveTo>
                    <a:pt x="0" y="0"/>
                  </a:moveTo>
                  <a:lnTo>
                    <a:pt x="4385106"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97" name="pl41"/>
            <p:cNvSpPr/>
            <p:nvPr/>
          </p:nvSpPr>
          <p:spPr>
            <a:xfrm>
              <a:off x="517536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98" name="pl42"/>
            <p:cNvSpPr/>
            <p:nvPr/>
          </p:nvSpPr>
          <p:spPr>
            <a:xfrm>
              <a:off x="529092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499" name="pl43"/>
            <p:cNvSpPr/>
            <p:nvPr/>
          </p:nvSpPr>
          <p:spPr>
            <a:xfrm>
              <a:off x="540612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00" name="pl44"/>
            <p:cNvSpPr/>
            <p:nvPr/>
          </p:nvSpPr>
          <p:spPr>
            <a:xfrm>
              <a:off x="563688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01" name="pl45"/>
            <p:cNvSpPr/>
            <p:nvPr/>
          </p:nvSpPr>
          <p:spPr>
            <a:xfrm>
              <a:off x="575244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02" name="pl46"/>
            <p:cNvSpPr/>
            <p:nvPr/>
          </p:nvSpPr>
          <p:spPr>
            <a:xfrm>
              <a:off x="586800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03" name="pl47"/>
            <p:cNvSpPr/>
            <p:nvPr/>
          </p:nvSpPr>
          <p:spPr>
            <a:xfrm>
              <a:off x="609876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04" name="pl48"/>
            <p:cNvSpPr/>
            <p:nvPr/>
          </p:nvSpPr>
          <p:spPr>
            <a:xfrm>
              <a:off x="621396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05" name="pl49"/>
            <p:cNvSpPr/>
            <p:nvPr/>
          </p:nvSpPr>
          <p:spPr>
            <a:xfrm>
              <a:off x="632952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06" name="pl50"/>
            <p:cNvSpPr/>
            <p:nvPr/>
          </p:nvSpPr>
          <p:spPr>
            <a:xfrm>
              <a:off x="656028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07" name="pl51"/>
            <p:cNvSpPr/>
            <p:nvPr/>
          </p:nvSpPr>
          <p:spPr>
            <a:xfrm>
              <a:off x="667584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08" name="pl52"/>
            <p:cNvSpPr/>
            <p:nvPr/>
          </p:nvSpPr>
          <p:spPr>
            <a:xfrm>
              <a:off x="679104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09" name="pl53"/>
            <p:cNvSpPr/>
            <p:nvPr/>
          </p:nvSpPr>
          <p:spPr>
            <a:xfrm>
              <a:off x="702180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10" name="pl54"/>
            <p:cNvSpPr/>
            <p:nvPr/>
          </p:nvSpPr>
          <p:spPr>
            <a:xfrm>
              <a:off x="713736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11" name="pl55"/>
            <p:cNvSpPr/>
            <p:nvPr/>
          </p:nvSpPr>
          <p:spPr>
            <a:xfrm>
              <a:off x="725256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12" name="pl56"/>
            <p:cNvSpPr/>
            <p:nvPr/>
          </p:nvSpPr>
          <p:spPr>
            <a:xfrm>
              <a:off x="748368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13" name="pl57"/>
            <p:cNvSpPr/>
            <p:nvPr/>
          </p:nvSpPr>
          <p:spPr>
            <a:xfrm>
              <a:off x="759888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14" name="pl58"/>
            <p:cNvSpPr/>
            <p:nvPr/>
          </p:nvSpPr>
          <p:spPr>
            <a:xfrm>
              <a:off x="771444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15" name="pl59"/>
            <p:cNvSpPr/>
            <p:nvPr/>
          </p:nvSpPr>
          <p:spPr>
            <a:xfrm>
              <a:off x="794520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16" name="pl60"/>
            <p:cNvSpPr/>
            <p:nvPr/>
          </p:nvSpPr>
          <p:spPr>
            <a:xfrm>
              <a:off x="806040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17" name="pl61"/>
            <p:cNvSpPr/>
            <p:nvPr/>
          </p:nvSpPr>
          <p:spPr>
            <a:xfrm>
              <a:off x="817596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18" name="pl62"/>
            <p:cNvSpPr/>
            <p:nvPr/>
          </p:nvSpPr>
          <p:spPr>
            <a:xfrm>
              <a:off x="840672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19" name="pl63"/>
            <p:cNvSpPr/>
            <p:nvPr/>
          </p:nvSpPr>
          <p:spPr>
            <a:xfrm>
              <a:off x="852228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20" name="pl64"/>
            <p:cNvSpPr/>
            <p:nvPr/>
          </p:nvSpPr>
          <p:spPr>
            <a:xfrm>
              <a:off x="863748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21" name="pl65"/>
            <p:cNvSpPr/>
            <p:nvPr/>
          </p:nvSpPr>
          <p:spPr>
            <a:xfrm>
              <a:off x="886824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22" name="pl66"/>
            <p:cNvSpPr/>
            <p:nvPr/>
          </p:nvSpPr>
          <p:spPr>
            <a:xfrm>
              <a:off x="898380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23" name="pl67"/>
            <p:cNvSpPr/>
            <p:nvPr/>
          </p:nvSpPr>
          <p:spPr>
            <a:xfrm>
              <a:off x="909900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24" name="pl68"/>
            <p:cNvSpPr/>
            <p:nvPr/>
          </p:nvSpPr>
          <p:spPr>
            <a:xfrm>
              <a:off x="933012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25" name="pl69"/>
            <p:cNvSpPr/>
            <p:nvPr/>
          </p:nvSpPr>
          <p:spPr>
            <a:xfrm>
              <a:off x="944532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26" name="pl70"/>
            <p:cNvSpPr/>
            <p:nvPr/>
          </p:nvSpPr>
          <p:spPr>
            <a:xfrm>
              <a:off x="9560880" y="8335080"/>
              <a:ext cx="360" cy="2268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27" name="tx71"/>
            <p:cNvSpPr/>
            <p:nvPr/>
          </p:nvSpPr>
          <p:spPr>
            <a:xfrm>
              <a:off x="3444480" y="9561240"/>
              <a:ext cx="872640" cy="14112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en-US" sz="1200" spc="-1" strike="noStrike">
                  <a:solidFill>
                    <a:srgbClr val="000000"/>
                  </a:solidFill>
                  <a:latin typeface="Arial"/>
                </a:rPr>
                <a:t>   </a:t>
              </a:r>
              <a:r>
                <a:rPr b="0" lang="en-US" sz="1200" spc="-1" strike="noStrike">
                  <a:solidFill>
                    <a:srgbClr val="000000"/>
                  </a:solidFill>
                  <a:latin typeface="Arial"/>
                </a:rPr>
                <a:t>C</a:t>
              </a:r>
              <a:r>
                <a:rPr b="0" lang="zh-CN" sz="1200" spc="-1" strike="noStrike">
                  <a:solidFill>
                    <a:srgbClr val="000000"/>
                  </a:solidFill>
                  <a:latin typeface="Arial"/>
                </a:rPr>
                <a:t>utoff_</a:t>
              </a:r>
              <a:r>
                <a:rPr b="0" lang="en-US" sz="1200" spc="-1" strike="noStrike">
                  <a:solidFill>
                    <a:srgbClr val="000000"/>
                  </a:solidFill>
                  <a:latin typeface="Arial"/>
                </a:rPr>
                <a:t>CA</a:t>
              </a:r>
              <a:r>
                <a:rPr b="0" lang="zh-CN" sz="1200" spc="-1" strike="noStrike">
                  <a:solidFill>
                    <a:srgbClr val="000000"/>
                  </a:solidFill>
                  <a:latin typeface="Arial"/>
                </a:rPr>
                <a:t>19</a:t>
              </a:r>
              <a:r>
                <a:rPr b="0" lang="en-US" sz="1200" spc="-1" strike="noStrike">
                  <a:solidFill>
                    <a:srgbClr val="000000"/>
                  </a:solidFill>
                  <a:latin typeface="Arial"/>
                </a:rPr>
                <a:t>-</a:t>
              </a:r>
              <a:r>
                <a:rPr b="0" lang="zh-CN" sz="1200" spc="-1" strike="noStrike">
                  <a:solidFill>
                    <a:srgbClr val="000000"/>
                  </a:solidFill>
                  <a:latin typeface="Arial"/>
                </a:rPr>
                <a:t>9</a:t>
              </a:r>
              <a:endParaRPr b="0" lang="en-US" sz="1200" spc="-1" strike="noStrike">
                <a:solidFill>
                  <a:srgbClr val="000000"/>
                </a:solidFill>
                <a:latin typeface="Arial"/>
              </a:endParaRPr>
            </a:p>
          </p:txBody>
        </p:sp>
        <p:sp>
          <p:nvSpPr>
            <p:cNvPr id="528" name="pl72"/>
            <p:cNvSpPr/>
            <p:nvPr/>
          </p:nvSpPr>
          <p:spPr>
            <a:xfrm>
              <a:off x="5060160" y="9662040"/>
              <a:ext cx="2520720" cy="360"/>
            </a:xfrm>
            <a:custGeom>
              <a:avLst/>
              <a:gdLst/>
              <a:ahLst/>
              <a:rect l="l" t="t" r="r" b="b"/>
              <a:pathLst>
                <a:path w="2520876" h="1">
                  <a:moveTo>
                    <a:pt x="0" y="0"/>
                  </a:moveTo>
                  <a:lnTo>
                    <a:pt x="2520876"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29" name="pl73"/>
            <p:cNvSpPr/>
            <p:nvPr/>
          </p:nvSpPr>
          <p:spPr>
            <a:xfrm>
              <a:off x="5060160" y="96620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30" name="pl74"/>
            <p:cNvSpPr/>
            <p:nvPr/>
          </p:nvSpPr>
          <p:spPr>
            <a:xfrm>
              <a:off x="5060160" y="9662040"/>
              <a:ext cx="360" cy="45720"/>
            </a:xfrm>
            <a:custGeom>
              <a:avLst/>
              <a:gdLst/>
              <a:ahLst/>
              <a:rect l="l" t="t" r="r" b="b"/>
              <a:pathLst>
                <a:path w="1" h="45719">
                  <a:moveTo>
                    <a:pt x="0" y="0"/>
                  </a:moveTo>
                  <a:lnTo>
                    <a:pt x="0" y="45719"/>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31" name="pl75"/>
            <p:cNvSpPr/>
            <p:nvPr/>
          </p:nvSpPr>
          <p:spPr>
            <a:xfrm>
              <a:off x="5060160" y="96620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32" name="pl76"/>
            <p:cNvSpPr/>
            <p:nvPr/>
          </p:nvSpPr>
          <p:spPr>
            <a:xfrm>
              <a:off x="5060160" y="96620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33" name="pl78"/>
            <p:cNvSpPr/>
            <p:nvPr/>
          </p:nvSpPr>
          <p:spPr>
            <a:xfrm>
              <a:off x="7580880" y="96620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34" name="pl79"/>
            <p:cNvSpPr/>
            <p:nvPr/>
          </p:nvSpPr>
          <p:spPr>
            <a:xfrm>
              <a:off x="7580880" y="9616320"/>
              <a:ext cx="360" cy="45720"/>
            </a:xfrm>
            <a:custGeom>
              <a:avLst/>
              <a:gdLst/>
              <a:ahLst/>
              <a:rect l="l" t="t" r="r" b="b"/>
              <a:pathLst>
                <a:path w="1" h="45719">
                  <a:moveTo>
                    <a:pt x="0" y="45719"/>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35" name="pl80"/>
            <p:cNvSpPr/>
            <p:nvPr/>
          </p:nvSpPr>
          <p:spPr>
            <a:xfrm>
              <a:off x="7580880" y="96620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36" name="pl81"/>
            <p:cNvSpPr/>
            <p:nvPr/>
          </p:nvSpPr>
          <p:spPr>
            <a:xfrm>
              <a:off x="7580880" y="96620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537" name="tx82" descr=""/>
            <p:cNvPicPr/>
            <p:nvPr/>
          </p:nvPicPr>
          <p:blipFill>
            <a:blip r:embed="rId12"/>
            <a:stretch/>
          </p:blipFill>
          <p:spPr>
            <a:xfrm>
              <a:off x="7395840" y="9388080"/>
              <a:ext cx="617760" cy="172440"/>
            </a:xfrm>
            <a:prstGeom prst="rect">
              <a:avLst/>
            </a:prstGeom>
            <a:ln w="0">
              <a:noFill/>
            </a:ln>
          </p:spPr>
        </p:pic>
        <p:sp>
          <p:nvSpPr>
            <p:cNvPr id="538" name="tx83"/>
            <p:cNvSpPr/>
            <p:nvPr/>
          </p:nvSpPr>
          <p:spPr>
            <a:xfrm>
              <a:off x="3157200" y="10911600"/>
              <a:ext cx="393480" cy="10008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en-US" sz="1200" spc="-1" strike="noStrike">
                  <a:solidFill>
                    <a:srgbClr val="000000"/>
                  </a:solidFill>
                  <a:latin typeface="Arial"/>
                </a:rPr>
                <a:t>                  </a:t>
              </a:r>
              <a:r>
                <a:rPr b="0" lang="zh-CN" sz="1200" spc="-1" strike="noStrike">
                  <a:solidFill>
                    <a:srgbClr val="000000"/>
                  </a:solidFill>
                  <a:latin typeface="Arial"/>
                </a:rPr>
                <a:t>T</a:t>
              </a:r>
              <a:r>
                <a:rPr b="0" lang="en-US" sz="1200" spc="-1" strike="noStrike">
                  <a:solidFill>
                    <a:srgbClr val="000000"/>
                  </a:solidFill>
                  <a:latin typeface="Arial"/>
                </a:rPr>
                <a:t> stage</a:t>
              </a:r>
              <a:endParaRPr b="0" lang="en-US" sz="1200" spc="-1" strike="noStrike">
                <a:solidFill>
                  <a:srgbClr val="000000"/>
                </a:solidFill>
                <a:latin typeface="Arial"/>
              </a:endParaRPr>
            </a:p>
          </p:txBody>
        </p:sp>
        <p:sp>
          <p:nvSpPr>
            <p:cNvPr id="539" name="pl84"/>
            <p:cNvSpPr/>
            <p:nvPr/>
          </p:nvSpPr>
          <p:spPr>
            <a:xfrm>
              <a:off x="5060160" y="10966320"/>
              <a:ext cx="4615920" cy="360"/>
            </a:xfrm>
            <a:custGeom>
              <a:avLst/>
              <a:gdLst/>
              <a:ahLst/>
              <a:rect l="l" t="t" r="r" b="b"/>
              <a:pathLst>
                <a:path w="4615901" h="1">
                  <a:moveTo>
                    <a:pt x="0" y="0"/>
                  </a:moveTo>
                  <a:lnTo>
                    <a:pt x="4615901"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40" name="pl85"/>
            <p:cNvSpPr/>
            <p:nvPr/>
          </p:nvSpPr>
          <p:spPr>
            <a:xfrm>
              <a:off x="5060160" y="10966320"/>
              <a:ext cx="4615920" cy="360"/>
            </a:xfrm>
            <a:custGeom>
              <a:avLst/>
              <a:gdLst/>
              <a:ahLst/>
              <a:rect l="l" t="t" r="r" b="b"/>
              <a:pathLst>
                <a:path w="4615901" h="1">
                  <a:moveTo>
                    <a:pt x="0" y="0"/>
                  </a:moveTo>
                  <a:lnTo>
                    <a:pt x="4615901"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41" name="pl86"/>
            <p:cNvSpPr/>
            <p:nvPr/>
          </p:nvSpPr>
          <p:spPr>
            <a:xfrm>
              <a:off x="5060160" y="1096632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42" name="pl87"/>
            <p:cNvSpPr/>
            <p:nvPr/>
          </p:nvSpPr>
          <p:spPr>
            <a:xfrm>
              <a:off x="9676080" y="1096632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43" name="pl88"/>
            <p:cNvSpPr/>
            <p:nvPr/>
          </p:nvSpPr>
          <p:spPr>
            <a:xfrm>
              <a:off x="5060160" y="10966320"/>
              <a:ext cx="4615920" cy="360"/>
            </a:xfrm>
            <a:custGeom>
              <a:avLst/>
              <a:gdLst/>
              <a:ahLst/>
              <a:rect l="l" t="t" r="r" b="b"/>
              <a:pathLst>
                <a:path w="4615901" h="1">
                  <a:moveTo>
                    <a:pt x="0" y="0"/>
                  </a:moveTo>
                  <a:lnTo>
                    <a:pt x="4615901"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44" name="pl89"/>
            <p:cNvSpPr/>
            <p:nvPr/>
          </p:nvSpPr>
          <p:spPr>
            <a:xfrm>
              <a:off x="5060160" y="109663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45" name="pl90"/>
            <p:cNvSpPr/>
            <p:nvPr/>
          </p:nvSpPr>
          <p:spPr>
            <a:xfrm>
              <a:off x="9676080" y="109663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546" name="tx91" descr=""/>
            <p:cNvPicPr/>
            <p:nvPr/>
          </p:nvPicPr>
          <p:blipFill>
            <a:blip r:embed="rId13"/>
            <a:stretch/>
          </p:blipFill>
          <p:spPr>
            <a:xfrm>
              <a:off x="5010480" y="11033640"/>
              <a:ext cx="100080" cy="145800"/>
            </a:xfrm>
            <a:prstGeom prst="rect">
              <a:avLst/>
            </a:prstGeom>
            <a:ln w="0">
              <a:noFill/>
            </a:ln>
          </p:spPr>
        </p:pic>
        <p:pic>
          <p:nvPicPr>
            <p:cNvPr id="547" name="tx92" descr=""/>
            <p:cNvPicPr/>
            <p:nvPr/>
          </p:nvPicPr>
          <p:blipFill>
            <a:blip r:embed="rId14"/>
            <a:stretch/>
          </p:blipFill>
          <p:spPr>
            <a:xfrm>
              <a:off x="9626040" y="11032560"/>
              <a:ext cx="100080" cy="145800"/>
            </a:xfrm>
            <a:prstGeom prst="rect">
              <a:avLst/>
            </a:prstGeom>
            <a:ln w="0">
              <a:noFill/>
            </a:ln>
          </p:spPr>
        </p:pic>
        <p:sp>
          <p:nvSpPr>
            <p:cNvPr id="548" name="pl93"/>
            <p:cNvSpPr/>
            <p:nvPr/>
          </p:nvSpPr>
          <p:spPr>
            <a:xfrm>
              <a:off x="7368120" y="109663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49" name="pl94"/>
            <p:cNvSpPr/>
            <p:nvPr/>
          </p:nvSpPr>
          <p:spPr>
            <a:xfrm>
              <a:off x="7368120" y="10920600"/>
              <a:ext cx="360" cy="45720"/>
            </a:xfrm>
            <a:custGeom>
              <a:avLst/>
              <a:gdLst/>
              <a:ahLst/>
              <a:rect l="l" t="t" r="r" b="b"/>
              <a:pathLst>
                <a:path w="1" h="45719">
                  <a:moveTo>
                    <a:pt x="0" y="45719"/>
                  </a:moveTo>
                  <a:lnTo>
                    <a:pt x="0" y="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50" name="pl95"/>
            <p:cNvSpPr/>
            <p:nvPr/>
          </p:nvSpPr>
          <p:spPr>
            <a:xfrm>
              <a:off x="7368120" y="109663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51" name="pl96"/>
            <p:cNvSpPr/>
            <p:nvPr/>
          </p:nvSpPr>
          <p:spPr>
            <a:xfrm>
              <a:off x="7368120" y="109663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552" name="tx97" descr=""/>
            <p:cNvPicPr/>
            <p:nvPr/>
          </p:nvPicPr>
          <p:blipFill>
            <a:blip r:embed="rId15"/>
            <a:stretch/>
          </p:blipFill>
          <p:spPr>
            <a:xfrm>
              <a:off x="7318800" y="10721520"/>
              <a:ext cx="100080" cy="145800"/>
            </a:xfrm>
            <a:prstGeom prst="rect">
              <a:avLst/>
            </a:prstGeom>
            <a:ln w="0">
              <a:noFill/>
            </a:ln>
          </p:spPr>
        </p:pic>
        <p:sp>
          <p:nvSpPr>
            <p:cNvPr id="553" name="tx98"/>
            <p:cNvSpPr/>
            <p:nvPr/>
          </p:nvSpPr>
          <p:spPr>
            <a:xfrm>
              <a:off x="3444480" y="12213360"/>
              <a:ext cx="804600" cy="11088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zh-CN" sz="1200" spc="-1" strike="noStrike">
                  <a:solidFill>
                    <a:srgbClr val="000000"/>
                  </a:solidFill>
                  <a:latin typeface="Arial"/>
                </a:rPr>
                <a:t>Total Points</a:t>
              </a:r>
              <a:endParaRPr b="0" lang="en-US" sz="1200" spc="-1" strike="noStrike">
                <a:solidFill>
                  <a:srgbClr val="000000"/>
                </a:solidFill>
                <a:latin typeface="Arial"/>
              </a:endParaRPr>
            </a:p>
          </p:txBody>
        </p:sp>
        <p:sp>
          <p:nvSpPr>
            <p:cNvPr id="554" name="pl99"/>
            <p:cNvSpPr/>
            <p:nvPr/>
          </p:nvSpPr>
          <p:spPr>
            <a:xfrm>
              <a:off x="5060160" y="12270600"/>
              <a:ext cx="4615920" cy="360"/>
            </a:xfrm>
            <a:custGeom>
              <a:avLst/>
              <a:gdLst/>
              <a:ahLst/>
              <a:rect l="l" t="t" r="r" b="b"/>
              <a:pathLst>
                <a:path w="4615901" h="1">
                  <a:moveTo>
                    <a:pt x="0" y="0"/>
                  </a:moveTo>
                  <a:lnTo>
                    <a:pt x="4615901"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55" name="pl100"/>
            <p:cNvSpPr/>
            <p:nvPr/>
          </p:nvSpPr>
          <p:spPr>
            <a:xfrm>
              <a:off x="5060160" y="1227060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56" name="pl101"/>
            <p:cNvSpPr/>
            <p:nvPr/>
          </p:nvSpPr>
          <p:spPr>
            <a:xfrm>
              <a:off x="5636880" y="1227060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57" name="pl102"/>
            <p:cNvSpPr/>
            <p:nvPr/>
          </p:nvSpPr>
          <p:spPr>
            <a:xfrm>
              <a:off x="6213960" y="1227060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58" name="pl103"/>
            <p:cNvSpPr/>
            <p:nvPr/>
          </p:nvSpPr>
          <p:spPr>
            <a:xfrm>
              <a:off x="6791040" y="1227060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59" name="pl104"/>
            <p:cNvSpPr/>
            <p:nvPr/>
          </p:nvSpPr>
          <p:spPr>
            <a:xfrm>
              <a:off x="7368120" y="1227060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60" name="pl105"/>
            <p:cNvSpPr/>
            <p:nvPr/>
          </p:nvSpPr>
          <p:spPr>
            <a:xfrm>
              <a:off x="7945200" y="1227060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61" name="pl106"/>
            <p:cNvSpPr/>
            <p:nvPr/>
          </p:nvSpPr>
          <p:spPr>
            <a:xfrm>
              <a:off x="8522280" y="1227060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62" name="pl107"/>
            <p:cNvSpPr/>
            <p:nvPr/>
          </p:nvSpPr>
          <p:spPr>
            <a:xfrm>
              <a:off x="9099000" y="1227060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63" name="pl108"/>
            <p:cNvSpPr/>
            <p:nvPr/>
          </p:nvSpPr>
          <p:spPr>
            <a:xfrm>
              <a:off x="9676080" y="1227060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64" name="pl109"/>
            <p:cNvSpPr/>
            <p:nvPr/>
          </p:nvSpPr>
          <p:spPr>
            <a:xfrm>
              <a:off x="5060160" y="12270600"/>
              <a:ext cx="4615920" cy="360"/>
            </a:xfrm>
            <a:custGeom>
              <a:avLst/>
              <a:gdLst/>
              <a:ahLst/>
              <a:rect l="l" t="t" r="r" b="b"/>
              <a:pathLst>
                <a:path w="4615901" h="1">
                  <a:moveTo>
                    <a:pt x="0" y="0"/>
                  </a:moveTo>
                  <a:lnTo>
                    <a:pt x="4615901"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65" name="pl110"/>
            <p:cNvSpPr/>
            <p:nvPr/>
          </p:nvSpPr>
          <p:spPr>
            <a:xfrm>
              <a:off x="5060160" y="122706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66" name="pl111"/>
            <p:cNvSpPr/>
            <p:nvPr/>
          </p:nvSpPr>
          <p:spPr>
            <a:xfrm>
              <a:off x="5636880" y="122706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67" name="pl112"/>
            <p:cNvSpPr/>
            <p:nvPr/>
          </p:nvSpPr>
          <p:spPr>
            <a:xfrm>
              <a:off x="6213960" y="122706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68" name="pl113"/>
            <p:cNvSpPr/>
            <p:nvPr/>
          </p:nvSpPr>
          <p:spPr>
            <a:xfrm>
              <a:off x="6791040" y="122706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69" name="pl114"/>
            <p:cNvSpPr/>
            <p:nvPr/>
          </p:nvSpPr>
          <p:spPr>
            <a:xfrm>
              <a:off x="7368120" y="122706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70" name="pl115"/>
            <p:cNvSpPr/>
            <p:nvPr/>
          </p:nvSpPr>
          <p:spPr>
            <a:xfrm>
              <a:off x="7945200" y="122706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71" name="pl116"/>
            <p:cNvSpPr/>
            <p:nvPr/>
          </p:nvSpPr>
          <p:spPr>
            <a:xfrm>
              <a:off x="8522280" y="122706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72" name="pl117"/>
            <p:cNvSpPr/>
            <p:nvPr/>
          </p:nvSpPr>
          <p:spPr>
            <a:xfrm>
              <a:off x="9099000" y="122706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73" name="pl118"/>
            <p:cNvSpPr/>
            <p:nvPr/>
          </p:nvSpPr>
          <p:spPr>
            <a:xfrm>
              <a:off x="9676080" y="122706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574" name="tx119" descr=""/>
            <p:cNvPicPr/>
            <p:nvPr/>
          </p:nvPicPr>
          <p:blipFill>
            <a:blip r:embed="rId16"/>
            <a:stretch/>
          </p:blipFill>
          <p:spPr>
            <a:xfrm>
              <a:off x="5010480" y="12336840"/>
              <a:ext cx="100080" cy="145800"/>
            </a:xfrm>
            <a:prstGeom prst="rect">
              <a:avLst/>
            </a:prstGeom>
            <a:ln w="0">
              <a:noFill/>
            </a:ln>
          </p:spPr>
        </p:pic>
        <p:pic>
          <p:nvPicPr>
            <p:cNvPr id="575" name="tx120" descr=""/>
            <p:cNvPicPr/>
            <p:nvPr/>
          </p:nvPicPr>
          <p:blipFill>
            <a:blip r:embed="rId17"/>
            <a:stretch/>
          </p:blipFill>
          <p:spPr>
            <a:xfrm>
              <a:off x="5550840" y="12336840"/>
              <a:ext cx="172080" cy="145800"/>
            </a:xfrm>
            <a:prstGeom prst="rect">
              <a:avLst/>
            </a:prstGeom>
            <a:ln w="0">
              <a:noFill/>
            </a:ln>
          </p:spPr>
        </p:pic>
        <p:pic>
          <p:nvPicPr>
            <p:cNvPr id="576" name="tx121" descr=""/>
            <p:cNvPicPr/>
            <p:nvPr/>
          </p:nvPicPr>
          <p:blipFill>
            <a:blip r:embed="rId18"/>
            <a:stretch/>
          </p:blipFill>
          <p:spPr>
            <a:xfrm>
              <a:off x="6128640" y="12336840"/>
              <a:ext cx="172080" cy="145800"/>
            </a:xfrm>
            <a:prstGeom prst="rect">
              <a:avLst/>
            </a:prstGeom>
            <a:ln w="0">
              <a:noFill/>
            </a:ln>
          </p:spPr>
        </p:pic>
        <p:pic>
          <p:nvPicPr>
            <p:cNvPr id="577" name="tx122" descr=""/>
            <p:cNvPicPr/>
            <p:nvPr/>
          </p:nvPicPr>
          <p:blipFill>
            <a:blip r:embed="rId19"/>
            <a:stretch/>
          </p:blipFill>
          <p:spPr>
            <a:xfrm>
              <a:off x="6705000" y="12336840"/>
              <a:ext cx="172080" cy="145800"/>
            </a:xfrm>
            <a:prstGeom prst="rect">
              <a:avLst/>
            </a:prstGeom>
            <a:ln w="0">
              <a:noFill/>
            </a:ln>
          </p:spPr>
        </p:pic>
        <p:pic>
          <p:nvPicPr>
            <p:cNvPr id="578" name="tx123" descr=""/>
            <p:cNvPicPr/>
            <p:nvPr/>
          </p:nvPicPr>
          <p:blipFill>
            <a:blip r:embed="rId20"/>
            <a:stretch/>
          </p:blipFill>
          <p:spPr>
            <a:xfrm>
              <a:off x="7282800" y="12336840"/>
              <a:ext cx="172080" cy="145800"/>
            </a:xfrm>
            <a:prstGeom prst="rect">
              <a:avLst/>
            </a:prstGeom>
            <a:ln w="0">
              <a:noFill/>
            </a:ln>
          </p:spPr>
        </p:pic>
        <p:pic>
          <p:nvPicPr>
            <p:cNvPr id="579" name="tx124" descr=""/>
            <p:cNvPicPr/>
            <p:nvPr/>
          </p:nvPicPr>
          <p:blipFill>
            <a:blip r:embed="rId21"/>
            <a:stretch/>
          </p:blipFill>
          <p:spPr>
            <a:xfrm>
              <a:off x="7824240" y="12336840"/>
              <a:ext cx="243720" cy="145800"/>
            </a:xfrm>
            <a:prstGeom prst="rect">
              <a:avLst/>
            </a:prstGeom>
            <a:ln w="0">
              <a:noFill/>
            </a:ln>
          </p:spPr>
        </p:pic>
        <p:pic>
          <p:nvPicPr>
            <p:cNvPr id="580" name="tx125" descr=""/>
            <p:cNvPicPr/>
            <p:nvPr/>
          </p:nvPicPr>
          <p:blipFill>
            <a:blip r:embed="rId22"/>
            <a:stretch/>
          </p:blipFill>
          <p:spPr>
            <a:xfrm>
              <a:off x="8400600" y="12336840"/>
              <a:ext cx="243720" cy="145800"/>
            </a:xfrm>
            <a:prstGeom prst="rect">
              <a:avLst/>
            </a:prstGeom>
            <a:ln w="0">
              <a:noFill/>
            </a:ln>
          </p:spPr>
        </p:pic>
        <p:pic>
          <p:nvPicPr>
            <p:cNvPr id="581" name="tx126" descr=""/>
            <p:cNvPicPr/>
            <p:nvPr/>
          </p:nvPicPr>
          <p:blipFill>
            <a:blip r:embed="rId23"/>
            <a:stretch/>
          </p:blipFill>
          <p:spPr>
            <a:xfrm>
              <a:off x="8978400" y="12336840"/>
              <a:ext cx="243720" cy="145800"/>
            </a:xfrm>
            <a:prstGeom prst="rect">
              <a:avLst/>
            </a:prstGeom>
            <a:ln w="0">
              <a:noFill/>
            </a:ln>
          </p:spPr>
        </p:pic>
        <p:pic>
          <p:nvPicPr>
            <p:cNvPr id="582" name="tx127" descr=""/>
            <p:cNvPicPr/>
            <p:nvPr/>
          </p:nvPicPr>
          <p:blipFill>
            <a:blip r:embed="rId24"/>
            <a:stretch/>
          </p:blipFill>
          <p:spPr>
            <a:xfrm>
              <a:off x="9554760" y="12336840"/>
              <a:ext cx="243720" cy="145800"/>
            </a:xfrm>
            <a:prstGeom prst="rect">
              <a:avLst/>
            </a:prstGeom>
            <a:ln w="0">
              <a:noFill/>
            </a:ln>
          </p:spPr>
        </p:pic>
        <p:sp>
          <p:nvSpPr>
            <p:cNvPr id="583" name="pl128"/>
            <p:cNvSpPr/>
            <p:nvPr/>
          </p:nvSpPr>
          <p:spPr>
            <a:xfrm>
              <a:off x="5060160" y="12270600"/>
              <a:ext cx="4615920" cy="360"/>
            </a:xfrm>
            <a:custGeom>
              <a:avLst/>
              <a:gdLst/>
              <a:ahLst/>
              <a:rect l="l" t="t" r="r" b="b"/>
              <a:pathLst>
                <a:path w="4615901" h="1">
                  <a:moveTo>
                    <a:pt x="0" y="0"/>
                  </a:moveTo>
                  <a:lnTo>
                    <a:pt x="4615901"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84" name="pl129"/>
            <p:cNvSpPr/>
            <p:nvPr/>
          </p:nvSpPr>
          <p:spPr>
            <a:xfrm>
              <a:off x="506016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85" name="pl130"/>
            <p:cNvSpPr/>
            <p:nvPr/>
          </p:nvSpPr>
          <p:spPr>
            <a:xfrm>
              <a:off x="517536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86" name="pl131"/>
            <p:cNvSpPr/>
            <p:nvPr/>
          </p:nvSpPr>
          <p:spPr>
            <a:xfrm>
              <a:off x="529092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87" name="pl132"/>
            <p:cNvSpPr/>
            <p:nvPr/>
          </p:nvSpPr>
          <p:spPr>
            <a:xfrm>
              <a:off x="540612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88" name="pl133"/>
            <p:cNvSpPr/>
            <p:nvPr/>
          </p:nvSpPr>
          <p:spPr>
            <a:xfrm>
              <a:off x="552168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89" name="pl134"/>
            <p:cNvSpPr/>
            <p:nvPr/>
          </p:nvSpPr>
          <p:spPr>
            <a:xfrm>
              <a:off x="563688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90" name="pl135"/>
            <p:cNvSpPr/>
            <p:nvPr/>
          </p:nvSpPr>
          <p:spPr>
            <a:xfrm>
              <a:off x="575244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91" name="pl136"/>
            <p:cNvSpPr/>
            <p:nvPr/>
          </p:nvSpPr>
          <p:spPr>
            <a:xfrm>
              <a:off x="586800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92" name="pl137"/>
            <p:cNvSpPr/>
            <p:nvPr/>
          </p:nvSpPr>
          <p:spPr>
            <a:xfrm>
              <a:off x="598320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93" name="pl138"/>
            <p:cNvSpPr/>
            <p:nvPr/>
          </p:nvSpPr>
          <p:spPr>
            <a:xfrm>
              <a:off x="609876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94" name="pl139"/>
            <p:cNvSpPr/>
            <p:nvPr/>
          </p:nvSpPr>
          <p:spPr>
            <a:xfrm>
              <a:off x="621396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95" name="pl140"/>
            <p:cNvSpPr/>
            <p:nvPr/>
          </p:nvSpPr>
          <p:spPr>
            <a:xfrm>
              <a:off x="632952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96" name="pl141"/>
            <p:cNvSpPr/>
            <p:nvPr/>
          </p:nvSpPr>
          <p:spPr>
            <a:xfrm>
              <a:off x="644472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97" name="pl142"/>
            <p:cNvSpPr/>
            <p:nvPr/>
          </p:nvSpPr>
          <p:spPr>
            <a:xfrm>
              <a:off x="656028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98" name="pl143"/>
            <p:cNvSpPr/>
            <p:nvPr/>
          </p:nvSpPr>
          <p:spPr>
            <a:xfrm>
              <a:off x="667584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599" name="pl144"/>
            <p:cNvSpPr/>
            <p:nvPr/>
          </p:nvSpPr>
          <p:spPr>
            <a:xfrm>
              <a:off x="679104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00" name="pl145"/>
            <p:cNvSpPr/>
            <p:nvPr/>
          </p:nvSpPr>
          <p:spPr>
            <a:xfrm>
              <a:off x="690660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01" name="pl146"/>
            <p:cNvSpPr/>
            <p:nvPr/>
          </p:nvSpPr>
          <p:spPr>
            <a:xfrm>
              <a:off x="702180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02" name="pl147"/>
            <p:cNvSpPr/>
            <p:nvPr/>
          </p:nvSpPr>
          <p:spPr>
            <a:xfrm>
              <a:off x="713736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03" name="pl148"/>
            <p:cNvSpPr/>
            <p:nvPr/>
          </p:nvSpPr>
          <p:spPr>
            <a:xfrm>
              <a:off x="725256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04" name="pl149"/>
            <p:cNvSpPr/>
            <p:nvPr/>
          </p:nvSpPr>
          <p:spPr>
            <a:xfrm>
              <a:off x="736812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05" name="pl150"/>
            <p:cNvSpPr/>
            <p:nvPr/>
          </p:nvSpPr>
          <p:spPr>
            <a:xfrm>
              <a:off x="748368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06" name="pl151"/>
            <p:cNvSpPr/>
            <p:nvPr/>
          </p:nvSpPr>
          <p:spPr>
            <a:xfrm>
              <a:off x="759888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07" name="pl152"/>
            <p:cNvSpPr/>
            <p:nvPr/>
          </p:nvSpPr>
          <p:spPr>
            <a:xfrm>
              <a:off x="771444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08" name="pl153"/>
            <p:cNvSpPr/>
            <p:nvPr/>
          </p:nvSpPr>
          <p:spPr>
            <a:xfrm>
              <a:off x="782964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09" name="pl154"/>
            <p:cNvSpPr/>
            <p:nvPr/>
          </p:nvSpPr>
          <p:spPr>
            <a:xfrm>
              <a:off x="794520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10" name="pl155"/>
            <p:cNvSpPr/>
            <p:nvPr/>
          </p:nvSpPr>
          <p:spPr>
            <a:xfrm>
              <a:off x="806040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11" name="pl156"/>
            <p:cNvSpPr/>
            <p:nvPr/>
          </p:nvSpPr>
          <p:spPr>
            <a:xfrm>
              <a:off x="817596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12" name="pl157"/>
            <p:cNvSpPr/>
            <p:nvPr/>
          </p:nvSpPr>
          <p:spPr>
            <a:xfrm>
              <a:off x="829116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13" name="pl158"/>
            <p:cNvSpPr/>
            <p:nvPr/>
          </p:nvSpPr>
          <p:spPr>
            <a:xfrm>
              <a:off x="840672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14" name="pl159"/>
            <p:cNvSpPr/>
            <p:nvPr/>
          </p:nvSpPr>
          <p:spPr>
            <a:xfrm>
              <a:off x="852228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15" name="pl160"/>
            <p:cNvSpPr/>
            <p:nvPr/>
          </p:nvSpPr>
          <p:spPr>
            <a:xfrm>
              <a:off x="863748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16" name="pl161"/>
            <p:cNvSpPr/>
            <p:nvPr/>
          </p:nvSpPr>
          <p:spPr>
            <a:xfrm>
              <a:off x="875304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17" name="pl162"/>
            <p:cNvSpPr/>
            <p:nvPr/>
          </p:nvSpPr>
          <p:spPr>
            <a:xfrm>
              <a:off x="886824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18" name="pl163"/>
            <p:cNvSpPr/>
            <p:nvPr/>
          </p:nvSpPr>
          <p:spPr>
            <a:xfrm>
              <a:off x="898380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19" name="pl164"/>
            <p:cNvSpPr/>
            <p:nvPr/>
          </p:nvSpPr>
          <p:spPr>
            <a:xfrm>
              <a:off x="909900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20" name="pl165"/>
            <p:cNvSpPr/>
            <p:nvPr/>
          </p:nvSpPr>
          <p:spPr>
            <a:xfrm>
              <a:off x="921456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21" name="pl166"/>
            <p:cNvSpPr/>
            <p:nvPr/>
          </p:nvSpPr>
          <p:spPr>
            <a:xfrm>
              <a:off x="933012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22" name="pl167"/>
            <p:cNvSpPr/>
            <p:nvPr/>
          </p:nvSpPr>
          <p:spPr>
            <a:xfrm>
              <a:off x="944532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23" name="pl168"/>
            <p:cNvSpPr/>
            <p:nvPr/>
          </p:nvSpPr>
          <p:spPr>
            <a:xfrm>
              <a:off x="956088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24" name="pl169"/>
            <p:cNvSpPr/>
            <p:nvPr/>
          </p:nvSpPr>
          <p:spPr>
            <a:xfrm>
              <a:off x="9676080" y="12270600"/>
              <a:ext cx="360" cy="2268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4120" bIns="-241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25" name="tx170"/>
            <p:cNvSpPr/>
            <p:nvPr/>
          </p:nvSpPr>
          <p:spPr>
            <a:xfrm>
              <a:off x="3444480" y="13516560"/>
              <a:ext cx="1236240" cy="11268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zh-CN" sz="1200" spc="-1" strike="noStrike">
                  <a:solidFill>
                    <a:srgbClr val="000000"/>
                  </a:solidFill>
                  <a:latin typeface="Arial"/>
                </a:rPr>
                <a:t>Risk of metastasis</a:t>
              </a:r>
              <a:endParaRPr b="0" lang="en-US" sz="1200" spc="-1" strike="noStrike">
                <a:solidFill>
                  <a:srgbClr val="000000"/>
                </a:solidFill>
                <a:latin typeface="Arial"/>
              </a:endParaRPr>
            </a:p>
          </p:txBody>
        </p:sp>
        <p:sp>
          <p:nvSpPr>
            <p:cNvPr id="626" name="pl171"/>
            <p:cNvSpPr/>
            <p:nvPr/>
          </p:nvSpPr>
          <p:spPr>
            <a:xfrm>
              <a:off x="5371920" y="135745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27" name="pl172"/>
            <p:cNvSpPr/>
            <p:nvPr/>
          </p:nvSpPr>
          <p:spPr>
            <a:xfrm>
              <a:off x="5371920" y="1357452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628" name="tx173" descr=""/>
            <p:cNvPicPr/>
            <p:nvPr/>
          </p:nvPicPr>
          <p:blipFill>
            <a:blip r:embed="rId25"/>
            <a:stretch/>
          </p:blipFill>
          <p:spPr>
            <a:xfrm>
              <a:off x="5267520" y="13640760"/>
              <a:ext cx="208080" cy="145800"/>
            </a:xfrm>
            <a:prstGeom prst="rect">
              <a:avLst/>
            </a:prstGeom>
            <a:ln w="0">
              <a:noFill/>
            </a:ln>
          </p:spPr>
        </p:pic>
        <p:sp>
          <p:nvSpPr>
            <p:cNvPr id="629" name="pl174"/>
            <p:cNvSpPr/>
            <p:nvPr/>
          </p:nvSpPr>
          <p:spPr>
            <a:xfrm>
              <a:off x="6172920" y="135745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30" name="pl175"/>
            <p:cNvSpPr/>
            <p:nvPr/>
          </p:nvSpPr>
          <p:spPr>
            <a:xfrm>
              <a:off x="6172920" y="1357452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631" name="tx176" descr=""/>
            <p:cNvPicPr/>
            <p:nvPr/>
          </p:nvPicPr>
          <p:blipFill>
            <a:blip r:embed="rId26"/>
            <a:stretch/>
          </p:blipFill>
          <p:spPr>
            <a:xfrm>
              <a:off x="6069240" y="13640760"/>
              <a:ext cx="208080" cy="145800"/>
            </a:xfrm>
            <a:prstGeom prst="rect">
              <a:avLst/>
            </a:prstGeom>
            <a:ln w="0">
              <a:noFill/>
            </a:ln>
          </p:spPr>
        </p:pic>
        <p:sp>
          <p:nvSpPr>
            <p:cNvPr id="632" name="pl177"/>
            <p:cNvSpPr/>
            <p:nvPr/>
          </p:nvSpPr>
          <p:spPr>
            <a:xfrm>
              <a:off x="6829200" y="135745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33" name="pl178"/>
            <p:cNvSpPr/>
            <p:nvPr/>
          </p:nvSpPr>
          <p:spPr>
            <a:xfrm>
              <a:off x="6829200" y="1357452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634" name="tx179" descr=""/>
            <p:cNvPicPr/>
            <p:nvPr/>
          </p:nvPicPr>
          <p:blipFill>
            <a:blip r:embed="rId27"/>
            <a:stretch/>
          </p:blipFill>
          <p:spPr>
            <a:xfrm>
              <a:off x="6725880" y="13640760"/>
              <a:ext cx="208080" cy="145800"/>
            </a:xfrm>
            <a:prstGeom prst="rect">
              <a:avLst/>
            </a:prstGeom>
            <a:ln w="0">
              <a:noFill/>
            </a:ln>
          </p:spPr>
        </p:pic>
        <p:sp>
          <p:nvSpPr>
            <p:cNvPr id="635" name="pl180"/>
            <p:cNvSpPr/>
            <p:nvPr/>
          </p:nvSpPr>
          <p:spPr>
            <a:xfrm>
              <a:off x="7431840" y="135745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36" name="pl181"/>
            <p:cNvSpPr/>
            <p:nvPr/>
          </p:nvSpPr>
          <p:spPr>
            <a:xfrm>
              <a:off x="7431840" y="1357452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637" name="tx182" descr=""/>
            <p:cNvPicPr/>
            <p:nvPr/>
          </p:nvPicPr>
          <p:blipFill>
            <a:blip r:embed="rId28"/>
            <a:stretch/>
          </p:blipFill>
          <p:spPr>
            <a:xfrm>
              <a:off x="7328520" y="13640760"/>
              <a:ext cx="208080" cy="145800"/>
            </a:xfrm>
            <a:prstGeom prst="rect">
              <a:avLst/>
            </a:prstGeom>
            <a:ln w="0">
              <a:noFill/>
            </a:ln>
          </p:spPr>
        </p:pic>
        <p:sp>
          <p:nvSpPr>
            <p:cNvPr id="638" name="pl183"/>
            <p:cNvSpPr/>
            <p:nvPr/>
          </p:nvSpPr>
          <p:spPr>
            <a:xfrm>
              <a:off x="8034480" y="135745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39" name="pl184"/>
            <p:cNvSpPr/>
            <p:nvPr/>
          </p:nvSpPr>
          <p:spPr>
            <a:xfrm>
              <a:off x="8034480" y="1357452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640" name="tx185" descr=""/>
            <p:cNvPicPr/>
            <p:nvPr/>
          </p:nvPicPr>
          <p:blipFill>
            <a:blip r:embed="rId29"/>
            <a:stretch/>
          </p:blipFill>
          <p:spPr>
            <a:xfrm>
              <a:off x="7930800" y="13640760"/>
              <a:ext cx="208080" cy="145800"/>
            </a:xfrm>
            <a:prstGeom prst="rect">
              <a:avLst/>
            </a:prstGeom>
            <a:ln w="0">
              <a:noFill/>
            </a:ln>
          </p:spPr>
        </p:pic>
        <p:sp>
          <p:nvSpPr>
            <p:cNvPr id="641" name="pl186"/>
            <p:cNvSpPr/>
            <p:nvPr/>
          </p:nvSpPr>
          <p:spPr>
            <a:xfrm>
              <a:off x="8691120" y="135745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42" name="pl187"/>
            <p:cNvSpPr/>
            <p:nvPr/>
          </p:nvSpPr>
          <p:spPr>
            <a:xfrm>
              <a:off x="8691120" y="1357452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643" name="tx188" descr=""/>
            <p:cNvPicPr/>
            <p:nvPr/>
          </p:nvPicPr>
          <p:blipFill>
            <a:blip r:embed="rId30"/>
            <a:stretch/>
          </p:blipFill>
          <p:spPr>
            <a:xfrm>
              <a:off x="8587440" y="13640760"/>
              <a:ext cx="208080" cy="145800"/>
            </a:xfrm>
            <a:prstGeom prst="rect">
              <a:avLst/>
            </a:prstGeom>
            <a:ln w="0">
              <a:noFill/>
            </a:ln>
          </p:spPr>
        </p:pic>
        <p:sp>
          <p:nvSpPr>
            <p:cNvPr id="644" name="pl189"/>
            <p:cNvSpPr/>
            <p:nvPr/>
          </p:nvSpPr>
          <p:spPr>
            <a:xfrm>
              <a:off x="9492120" y="135745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45" name="pl190"/>
            <p:cNvSpPr/>
            <p:nvPr/>
          </p:nvSpPr>
          <p:spPr>
            <a:xfrm>
              <a:off x="9492120" y="13574520"/>
              <a:ext cx="360" cy="4572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1080" bIns="-108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646" name="tx191" descr=""/>
            <p:cNvPicPr/>
            <p:nvPr/>
          </p:nvPicPr>
          <p:blipFill>
            <a:blip r:embed="rId31"/>
            <a:stretch/>
          </p:blipFill>
          <p:spPr>
            <a:xfrm>
              <a:off x="9388080" y="13640760"/>
              <a:ext cx="208080" cy="145800"/>
            </a:xfrm>
            <a:prstGeom prst="rect">
              <a:avLst/>
            </a:prstGeom>
            <a:ln w="0">
              <a:noFill/>
            </a:ln>
          </p:spPr>
        </p:pic>
        <p:sp>
          <p:nvSpPr>
            <p:cNvPr id="647" name="pl192"/>
            <p:cNvSpPr/>
            <p:nvPr/>
          </p:nvSpPr>
          <p:spPr>
            <a:xfrm>
              <a:off x="5371920" y="13574520"/>
              <a:ext cx="4119840" cy="360"/>
            </a:xfrm>
            <a:custGeom>
              <a:avLst/>
              <a:gdLst/>
              <a:ahLst/>
              <a:rect l="l" t="t" r="r" b="b"/>
              <a:pathLst>
                <a:path w="4119992" h="1">
                  <a:moveTo>
                    <a:pt x="0" y="0"/>
                  </a:moveTo>
                  <a:lnTo>
                    <a:pt x="4119992"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grpSp>
      <p:grpSp>
        <p:nvGrpSpPr>
          <p:cNvPr id="648" name="组合 7"/>
          <p:cNvGrpSpPr/>
          <p:nvPr/>
        </p:nvGrpSpPr>
        <p:grpSpPr>
          <a:xfrm>
            <a:off x="10761840" y="7504200"/>
            <a:ext cx="7380000" cy="7435800"/>
            <a:chOff x="10761840" y="7504200"/>
            <a:chExt cx="7380000" cy="7435800"/>
          </a:xfrm>
        </p:grpSpPr>
        <p:sp>
          <p:nvSpPr>
            <p:cNvPr id="649" name="rc3"/>
            <p:cNvSpPr/>
            <p:nvPr/>
          </p:nvSpPr>
          <p:spPr>
            <a:xfrm>
              <a:off x="10761840" y="7504200"/>
              <a:ext cx="7380000" cy="7435800"/>
            </a:xfrm>
            <a:prstGeom prst="rect">
              <a:avLst/>
            </a:prstGeom>
            <a:solidFill>
              <a:srgbClr val="ffffff"/>
            </a:solidFill>
            <a:ln cap="rnd" w="9360">
              <a:solidFill>
                <a:srgbClr val="ffffff"/>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50" name="tx4"/>
            <p:cNvSpPr/>
            <p:nvPr/>
          </p:nvSpPr>
          <p:spPr>
            <a:xfrm>
              <a:off x="11216160" y="8420040"/>
              <a:ext cx="427320" cy="11268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zh-CN" sz="1200" spc="-1" strike="noStrike">
                  <a:solidFill>
                    <a:srgbClr val="000000"/>
                  </a:solidFill>
                  <a:latin typeface="Arial"/>
                </a:rPr>
                <a:t>Points</a:t>
              </a:r>
              <a:endParaRPr b="0" lang="en-US" sz="1200" spc="-1" strike="noStrike">
                <a:solidFill>
                  <a:srgbClr val="000000"/>
                </a:solidFill>
                <a:latin typeface="Arial"/>
              </a:endParaRPr>
            </a:p>
          </p:txBody>
        </p:sp>
        <p:sp>
          <p:nvSpPr>
            <p:cNvPr id="651" name="pl5"/>
            <p:cNvSpPr/>
            <p:nvPr/>
          </p:nvSpPr>
          <p:spPr>
            <a:xfrm>
              <a:off x="12845880" y="8478360"/>
              <a:ext cx="4656960" cy="360"/>
            </a:xfrm>
            <a:custGeom>
              <a:avLst/>
              <a:gdLst/>
              <a:ahLst/>
              <a:rect l="l" t="t" r="r" b="b"/>
              <a:pathLst>
                <a:path w="4615901" h="1">
                  <a:moveTo>
                    <a:pt x="0" y="0"/>
                  </a:moveTo>
                  <a:lnTo>
                    <a:pt x="4615901"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52" name="pl6"/>
            <p:cNvSpPr/>
            <p:nvPr/>
          </p:nvSpPr>
          <p:spPr>
            <a:xfrm>
              <a:off x="12845880" y="8431920"/>
              <a:ext cx="360" cy="4644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53" name="pl7"/>
            <p:cNvSpPr/>
            <p:nvPr/>
          </p:nvSpPr>
          <p:spPr>
            <a:xfrm>
              <a:off x="13311720" y="8431920"/>
              <a:ext cx="360" cy="4644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54" name="pl8"/>
            <p:cNvSpPr/>
            <p:nvPr/>
          </p:nvSpPr>
          <p:spPr>
            <a:xfrm>
              <a:off x="13777560" y="8431920"/>
              <a:ext cx="360" cy="4644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55" name="pl9"/>
            <p:cNvSpPr/>
            <p:nvPr/>
          </p:nvSpPr>
          <p:spPr>
            <a:xfrm>
              <a:off x="14243040" y="8431920"/>
              <a:ext cx="360" cy="4644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56" name="pl10"/>
            <p:cNvSpPr/>
            <p:nvPr/>
          </p:nvSpPr>
          <p:spPr>
            <a:xfrm>
              <a:off x="14708880" y="8431920"/>
              <a:ext cx="360" cy="4644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57" name="pl11"/>
            <p:cNvSpPr/>
            <p:nvPr/>
          </p:nvSpPr>
          <p:spPr>
            <a:xfrm>
              <a:off x="15174720" y="8431920"/>
              <a:ext cx="360" cy="4644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58" name="pl12"/>
            <p:cNvSpPr/>
            <p:nvPr/>
          </p:nvSpPr>
          <p:spPr>
            <a:xfrm>
              <a:off x="15640200" y="8431920"/>
              <a:ext cx="360" cy="4644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59" name="pl13"/>
            <p:cNvSpPr/>
            <p:nvPr/>
          </p:nvSpPr>
          <p:spPr>
            <a:xfrm>
              <a:off x="16106040" y="8431920"/>
              <a:ext cx="360" cy="4644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60" name="pl14"/>
            <p:cNvSpPr/>
            <p:nvPr/>
          </p:nvSpPr>
          <p:spPr>
            <a:xfrm>
              <a:off x="16571520" y="8431920"/>
              <a:ext cx="360" cy="4644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61" name="pl15"/>
            <p:cNvSpPr/>
            <p:nvPr/>
          </p:nvSpPr>
          <p:spPr>
            <a:xfrm>
              <a:off x="17037360" y="8431920"/>
              <a:ext cx="360" cy="4644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62" name="pl16"/>
            <p:cNvSpPr/>
            <p:nvPr/>
          </p:nvSpPr>
          <p:spPr>
            <a:xfrm>
              <a:off x="17503200" y="8431920"/>
              <a:ext cx="360" cy="4644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63" name="pl17"/>
            <p:cNvSpPr/>
            <p:nvPr/>
          </p:nvSpPr>
          <p:spPr>
            <a:xfrm>
              <a:off x="12845880" y="8478360"/>
              <a:ext cx="4656960" cy="360"/>
            </a:xfrm>
            <a:custGeom>
              <a:avLst/>
              <a:gdLst/>
              <a:ahLst/>
              <a:rect l="l" t="t" r="r" b="b"/>
              <a:pathLst>
                <a:path w="4615901" h="1">
                  <a:moveTo>
                    <a:pt x="0" y="0"/>
                  </a:moveTo>
                  <a:lnTo>
                    <a:pt x="4615901"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64" name="pl18"/>
            <p:cNvSpPr/>
            <p:nvPr/>
          </p:nvSpPr>
          <p:spPr>
            <a:xfrm>
              <a:off x="12845880" y="84783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65" name="pl19"/>
            <p:cNvSpPr/>
            <p:nvPr/>
          </p:nvSpPr>
          <p:spPr>
            <a:xfrm>
              <a:off x="13311720" y="84783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66" name="pl20"/>
            <p:cNvSpPr/>
            <p:nvPr/>
          </p:nvSpPr>
          <p:spPr>
            <a:xfrm>
              <a:off x="13777560" y="84783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67" name="pl21"/>
            <p:cNvSpPr/>
            <p:nvPr/>
          </p:nvSpPr>
          <p:spPr>
            <a:xfrm>
              <a:off x="14243040" y="84783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68" name="pl22"/>
            <p:cNvSpPr/>
            <p:nvPr/>
          </p:nvSpPr>
          <p:spPr>
            <a:xfrm>
              <a:off x="14708880" y="84783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69" name="pl23"/>
            <p:cNvSpPr/>
            <p:nvPr/>
          </p:nvSpPr>
          <p:spPr>
            <a:xfrm>
              <a:off x="15174720" y="84783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70" name="pl24"/>
            <p:cNvSpPr/>
            <p:nvPr/>
          </p:nvSpPr>
          <p:spPr>
            <a:xfrm>
              <a:off x="15640200" y="84783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71" name="pl25"/>
            <p:cNvSpPr/>
            <p:nvPr/>
          </p:nvSpPr>
          <p:spPr>
            <a:xfrm>
              <a:off x="16106040" y="84783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72" name="pl26"/>
            <p:cNvSpPr/>
            <p:nvPr/>
          </p:nvSpPr>
          <p:spPr>
            <a:xfrm>
              <a:off x="16571520" y="84783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73" name="pl27"/>
            <p:cNvSpPr/>
            <p:nvPr/>
          </p:nvSpPr>
          <p:spPr>
            <a:xfrm>
              <a:off x="17037360" y="84783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74" name="pl28"/>
            <p:cNvSpPr/>
            <p:nvPr/>
          </p:nvSpPr>
          <p:spPr>
            <a:xfrm>
              <a:off x="17503200" y="84783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675" name="tx29" descr=""/>
            <p:cNvPicPr/>
            <p:nvPr/>
          </p:nvPicPr>
          <p:blipFill>
            <a:blip r:embed="rId32"/>
            <a:stretch/>
          </p:blipFill>
          <p:spPr>
            <a:xfrm>
              <a:off x="12796200" y="8230320"/>
              <a:ext cx="100080" cy="145800"/>
            </a:xfrm>
            <a:prstGeom prst="rect">
              <a:avLst/>
            </a:prstGeom>
            <a:ln w="0">
              <a:noFill/>
            </a:ln>
          </p:spPr>
        </p:pic>
        <p:pic>
          <p:nvPicPr>
            <p:cNvPr id="676" name="tx30" descr=""/>
            <p:cNvPicPr/>
            <p:nvPr/>
          </p:nvPicPr>
          <p:blipFill>
            <a:blip r:embed="rId33"/>
            <a:stretch/>
          </p:blipFill>
          <p:spPr>
            <a:xfrm>
              <a:off x="13225320" y="8230320"/>
              <a:ext cx="172080" cy="145800"/>
            </a:xfrm>
            <a:prstGeom prst="rect">
              <a:avLst/>
            </a:prstGeom>
            <a:ln w="0">
              <a:noFill/>
            </a:ln>
          </p:spPr>
        </p:pic>
        <p:pic>
          <p:nvPicPr>
            <p:cNvPr id="677" name="tx31" descr=""/>
            <p:cNvPicPr/>
            <p:nvPr/>
          </p:nvPicPr>
          <p:blipFill>
            <a:blip r:embed="rId34"/>
            <a:stretch/>
          </p:blipFill>
          <p:spPr>
            <a:xfrm>
              <a:off x="13691520" y="8230320"/>
              <a:ext cx="172080" cy="145800"/>
            </a:xfrm>
            <a:prstGeom prst="rect">
              <a:avLst/>
            </a:prstGeom>
            <a:ln w="0">
              <a:noFill/>
            </a:ln>
          </p:spPr>
        </p:pic>
        <p:pic>
          <p:nvPicPr>
            <p:cNvPr id="678" name="tx32" descr=""/>
            <p:cNvPicPr/>
            <p:nvPr/>
          </p:nvPicPr>
          <p:blipFill>
            <a:blip r:embed="rId35"/>
            <a:stretch/>
          </p:blipFill>
          <p:spPr>
            <a:xfrm>
              <a:off x="14157360" y="8230320"/>
              <a:ext cx="172080" cy="145800"/>
            </a:xfrm>
            <a:prstGeom prst="rect">
              <a:avLst/>
            </a:prstGeom>
            <a:ln w="0">
              <a:noFill/>
            </a:ln>
          </p:spPr>
        </p:pic>
        <p:pic>
          <p:nvPicPr>
            <p:cNvPr id="679" name="tx33" descr=""/>
            <p:cNvPicPr/>
            <p:nvPr/>
          </p:nvPicPr>
          <p:blipFill>
            <a:blip r:embed="rId36"/>
            <a:stretch/>
          </p:blipFill>
          <p:spPr>
            <a:xfrm>
              <a:off x="14623560" y="8230320"/>
              <a:ext cx="172080" cy="145800"/>
            </a:xfrm>
            <a:prstGeom prst="rect">
              <a:avLst/>
            </a:prstGeom>
            <a:ln w="0">
              <a:noFill/>
            </a:ln>
          </p:spPr>
        </p:pic>
        <p:pic>
          <p:nvPicPr>
            <p:cNvPr id="680" name="tx34" descr=""/>
            <p:cNvPicPr/>
            <p:nvPr/>
          </p:nvPicPr>
          <p:blipFill>
            <a:blip r:embed="rId37"/>
            <a:stretch/>
          </p:blipFill>
          <p:spPr>
            <a:xfrm>
              <a:off x="15089400" y="8230320"/>
              <a:ext cx="172080" cy="145800"/>
            </a:xfrm>
            <a:prstGeom prst="rect">
              <a:avLst/>
            </a:prstGeom>
            <a:ln w="0">
              <a:noFill/>
            </a:ln>
          </p:spPr>
        </p:pic>
        <p:pic>
          <p:nvPicPr>
            <p:cNvPr id="681" name="tx35" descr=""/>
            <p:cNvPicPr/>
            <p:nvPr/>
          </p:nvPicPr>
          <p:blipFill>
            <a:blip r:embed="rId38"/>
            <a:stretch/>
          </p:blipFill>
          <p:spPr>
            <a:xfrm>
              <a:off x="15555240" y="8230320"/>
              <a:ext cx="172080" cy="145800"/>
            </a:xfrm>
            <a:prstGeom prst="rect">
              <a:avLst/>
            </a:prstGeom>
            <a:ln w="0">
              <a:noFill/>
            </a:ln>
          </p:spPr>
        </p:pic>
        <p:pic>
          <p:nvPicPr>
            <p:cNvPr id="682" name="tx36" descr=""/>
            <p:cNvPicPr/>
            <p:nvPr/>
          </p:nvPicPr>
          <p:blipFill>
            <a:blip r:embed="rId39"/>
            <a:stretch/>
          </p:blipFill>
          <p:spPr>
            <a:xfrm>
              <a:off x="16020360" y="8230320"/>
              <a:ext cx="172080" cy="145800"/>
            </a:xfrm>
            <a:prstGeom prst="rect">
              <a:avLst/>
            </a:prstGeom>
            <a:ln w="0">
              <a:noFill/>
            </a:ln>
          </p:spPr>
        </p:pic>
        <p:pic>
          <p:nvPicPr>
            <p:cNvPr id="683" name="tx37" descr=""/>
            <p:cNvPicPr/>
            <p:nvPr/>
          </p:nvPicPr>
          <p:blipFill>
            <a:blip r:embed="rId40"/>
            <a:stretch/>
          </p:blipFill>
          <p:spPr>
            <a:xfrm>
              <a:off x="16486200" y="8230320"/>
              <a:ext cx="172080" cy="145800"/>
            </a:xfrm>
            <a:prstGeom prst="rect">
              <a:avLst/>
            </a:prstGeom>
            <a:ln w="0">
              <a:noFill/>
            </a:ln>
          </p:spPr>
        </p:pic>
        <p:pic>
          <p:nvPicPr>
            <p:cNvPr id="684" name="tx38" descr=""/>
            <p:cNvPicPr/>
            <p:nvPr/>
          </p:nvPicPr>
          <p:blipFill>
            <a:blip r:embed="rId41"/>
            <a:stretch/>
          </p:blipFill>
          <p:spPr>
            <a:xfrm>
              <a:off x="16951320" y="8230320"/>
              <a:ext cx="172080" cy="145800"/>
            </a:xfrm>
            <a:prstGeom prst="rect">
              <a:avLst/>
            </a:prstGeom>
            <a:ln w="0">
              <a:noFill/>
            </a:ln>
          </p:spPr>
        </p:pic>
        <p:pic>
          <p:nvPicPr>
            <p:cNvPr id="685" name="tx39" descr=""/>
            <p:cNvPicPr/>
            <p:nvPr/>
          </p:nvPicPr>
          <p:blipFill>
            <a:blip r:embed="rId42"/>
            <a:stretch/>
          </p:blipFill>
          <p:spPr>
            <a:xfrm>
              <a:off x="17381520" y="8230320"/>
              <a:ext cx="243720" cy="145800"/>
            </a:xfrm>
            <a:prstGeom prst="rect">
              <a:avLst/>
            </a:prstGeom>
            <a:ln w="0">
              <a:noFill/>
            </a:ln>
          </p:spPr>
        </p:pic>
        <p:sp>
          <p:nvSpPr>
            <p:cNvPr id="686" name="pl40"/>
            <p:cNvSpPr/>
            <p:nvPr/>
          </p:nvSpPr>
          <p:spPr>
            <a:xfrm>
              <a:off x="12962520" y="8478360"/>
              <a:ext cx="4424040" cy="360"/>
            </a:xfrm>
            <a:custGeom>
              <a:avLst/>
              <a:gdLst/>
              <a:ahLst/>
              <a:rect l="l" t="t" r="r" b="b"/>
              <a:pathLst>
                <a:path w="4385106" h="1">
                  <a:moveTo>
                    <a:pt x="0" y="0"/>
                  </a:moveTo>
                  <a:lnTo>
                    <a:pt x="4385106"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87" name="pl41"/>
            <p:cNvSpPr/>
            <p:nvPr/>
          </p:nvSpPr>
          <p:spPr>
            <a:xfrm>
              <a:off x="1296252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88" name="pl42"/>
            <p:cNvSpPr/>
            <p:nvPr/>
          </p:nvSpPr>
          <p:spPr>
            <a:xfrm>
              <a:off x="1307880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89" name="pl43"/>
            <p:cNvSpPr/>
            <p:nvPr/>
          </p:nvSpPr>
          <p:spPr>
            <a:xfrm>
              <a:off x="1319544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90" name="pl44"/>
            <p:cNvSpPr/>
            <p:nvPr/>
          </p:nvSpPr>
          <p:spPr>
            <a:xfrm>
              <a:off x="1342836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91" name="pl45"/>
            <p:cNvSpPr/>
            <p:nvPr/>
          </p:nvSpPr>
          <p:spPr>
            <a:xfrm>
              <a:off x="1354464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92" name="pl46"/>
            <p:cNvSpPr/>
            <p:nvPr/>
          </p:nvSpPr>
          <p:spPr>
            <a:xfrm>
              <a:off x="1366092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93" name="pl47"/>
            <p:cNvSpPr/>
            <p:nvPr/>
          </p:nvSpPr>
          <p:spPr>
            <a:xfrm>
              <a:off x="1389384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94" name="pl48"/>
            <p:cNvSpPr/>
            <p:nvPr/>
          </p:nvSpPr>
          <p:spPr>
            <a:xfrm>
              <a:off x="1401048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95" name="pl49"/>
            <p:cNvSpPr/>
            <p:nvPr/>
          </p:nvSpPr>
          <p:spPr>
            <a:xfrm>
              <a:off x="1412676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96" name="pl50"/>
            <p:cNvSpPr/>
            <p:nvPr/>
          </p:nvSpPr>
          <p:spPr>
            <a:xfrm>
              <a:off x="1435968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97" name="pl51"/>
            <p:cNvSpPr/>
            <p:nvPr/>
          </p:nvSpPr>
          <p:spPr>
            <a:xfrm>
              <a:off x="1447596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98" name="pl52"/>
            <p:cNvSpPr/>
            <p:nvPr/>
          </p:nvSpPr>
          <p:spPr>
            <a:xfrm>
              <a:off x="1459260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699" name="pl53"/>
            <p:cNvSpPr/>
            <p:nvPr/>
          </p:nvSpPr>
          <p:spPr>
            <a:xfrm>
              <a:off x="1482516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00" name="pl54"/>
            <p:cNvSpPr/>
            <p:nvPr/>
          </p:nvSpPr>
          <p:spPr>
            <a:xfrm>
              <a:off x="1494180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01" name="pl55"/>
            <p:cNvSpPr/>
            <p:nvPr/>
          </p:nvSpPr>
          <p:spPr>
            <a:xfrm>
              <a:off x="1505808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02" name="pl56"/>
            <p:cNvSpPr/>
            <p:nvPr/>
          </p:nvSpPr>
          <p:spPr>
            <a:xfrm>
              <a:off x="1529100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03" name="pl57"/>
            <p:cNvSpPr/>
            <p:nvPr/>
          </p:nvSpPr>
          <p:spPr>
            <a:xfrm>
              <a:off x="1540728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04" name="pl58"/>
            <p:cNvSpPr/>
            <p:nvPr/>
          </p:nvSpPr>
          <p:spPr>
            <a:xfrm>
              <a:off x="1552392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05" name="pl59"/>
            <p:cNvSpPr/>
            <p:nvPr/>
          </p:nvSpPr>
          <p:spPr>
            <a:xfrm>
              <a:off x="1575684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06" name="pl60"/>
            <p:cNvSpPr/>
            <p:nvPr/>
          </p:nvSpPr>
          <p:spPr>
            <a:xfrm>
              <a:off x="1587312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07" name="pl61"/>
            <p:cNvSpPr/>
            <p:nvPr/>
          </p:nvSpPr>
          <p:spPr>
            <a:xfrm>
              <a:off x="1598940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08" name="pl62"/>
            <p:cNvSpPr/>
            <p:nvPr/>
          </p:nvSpPr>
          <p:spPr>
            <a:xfrm>
              <a:off x="1622232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09" name="pl63"/>
            <p:cNvSpPr/>
            <p:nvPr/>
          </p:nvSpPr>
          <p:spPr>
            <a:xfrm>
              <a:off x="1633896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10" name="pl64"/>
            <p:cNvSpPr/>
            <p:nvPr/>
          </p:nvSpPr>
          <p:spPr>
            <a:xfrm>
              <a:off x="1645524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11" name="pl65"/>
            <p:cNvSpPr/>
            <p:nvPr/>
          </p:nvSpPr>
          <p:spPr>
            <a:xfrm>
              <a:off x="1668816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12" name="pl66"/>
            <p:cNvSpPr/>
            <p:nvPr/>
          </p:nvSpPr>
          <p:spPr>
            <a:xfrm>
              <a:off x="1680444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13" name="pl67"/>
            <p:cNvSpPr/>
            <p:nvPr/>
          </p:nvSpPr>
          <p:spPr>
            <a:xfrm>
              <a:off x="1692108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14" name="pl68"/>
            <p:cNvSpPr/>
            <p:nvPr/>
          </p:nvSpPr>
          <p:spPr>
            <a:xfrm>
              <a:off x="1715364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15" name="pl69"/>
            <p:cNvSpPr/>
            <p:nvPr/>
          </p:nvSpPr>
          <p:spPr>
            <a:xfrm>
              <a:off x="1727028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16" name="pl70"/>
            <p:cNvSpPr/>
            <p:nvPr/>
          </p:nvSpPr>
          <p:spPr>
            <a:xfrm>
              <a:off x="17386560" y="8454960"/>
              <a:ext cx="360" cy="23040"/>
            </a:xfrm>
            <a:custGeom>
              <a:avLst/>
              <a:gdLst/>
              <a:ahLst/>
              <a:rect l="l" t="t" r="r" b="b"/>
              <a:pathLst>
                <a:path w="1" h="22860">
                  <a:moveTo>
                    <a:pt x="0" y="22860"/>
                  </a:moveTo>
                  <a:lnTo>
                    <a:pt x="0" y="0"/>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17" name="tx71"/>
            <p:cNvSpPr/>
            <p:nvPr/>
          </p:nvSpPr>
          <p:spPr>
            <a:xfrm>
              <a:off x="11216160" y="9133200"/>
              <a:ext cx="880200" cy="14328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en-US" sz="1200" spc="-1" strike="noStrike">
                  <a:solidFill>
                    <a:srgbClr val="000000"/>
                  </a:solidFill>
                  <a:latin typeface="Arial"/>
                </a:rPr>
                <a:t>   </a:t>
              </a:r>
              <a:r>
                <a:rPr b="0" lang="en-US" sz="1200" spc="-1" strike="noStrike">
                  <a:solidFill>
                    <a:srgbClr val="000000"/>
                  </a:solidFill>
                  <a:latin typeface="Arial"/>
                </a:rPr>
                <a:t>C</a:t>
              </a:r>
              <a:r>
                <a:rPr b="0" lang="zh-CN" sz="1200" spc="-1" strike="noStrike">
                  <a:solidFill>
                    <a:srgbClr val="000000"/>
                  </a:solidFill>
                  <a:latin typeface="Arial"/>
                </a:rPr>
                <a:t>utoff_</a:t>
              </a:r>
              <a:r>
                <a:rPr b="0" lang="en-US" sz="1200" spc="-1" strike="noStrike">
                  <a:solidFill>
                    <a:srgbClr val="000000"/>
                  </a:solidFill>
                  <a:latin typeface="Arial"/>
                </a:rPr>
                <a:t>CA</a:t>
              </a:r>
              <a:r>
                <a:rPr b="0" lang="zh-CN" sz="1200" spc="-1" strike="noStrike">
                  <a:solidFill>
                    <a:srgbClr val="000000"/>
                  </a:solidFill>
                  <a:latin typeface="Arial"/>
                </a:rPr>
                <a:t>19</a:t>
              </a:r>
              <a:r>
                <a:rPr b="0" lang="en-US" sz="1200" spc="-1" strike="noStrike">
                  <a:solidFill>
                    <a:srgbClr val="000000"/>
                  </a:solidFill>
                  <a:latin typeface="Arial"/>
                </a:rPr>
                <a:t>-</a:t>
              </a:r>
              <a:r>
                <a:rPr b="0" lang="zh-CN" sz="1200" spc="-1" strike="noStrike">
                  <a:solidFill>
                    <a:srgbClr val="000000"/>
                  </a:solidFill>
                  <a:latin typeface="Arial"/>
                </a:rPr>
                <a:t>9</a:t>
              </a:r>
              <a:endParaRPr b="0" lang="en-US" sz="1200" spc="-1" strike="noStrike">
                <a:solidFill>
                  <a:srgbClr val="000000"/>
                </a:solidFill>
                <a:latin typeface="Arial"/>
              </a:endParaRPr>
            </a:p>
          </p:txBody>
        </p:sp>
        <p:sp>
          <p:nvSpPr>
            <p:cNvPr id="718" name="pl72"/>
            <p:cNvSpPr/>
            <p:nvPr/>
          </p:nvSpPr>
          <p:spPr>
            <a:xfrm>
              <a:off x="12845880" y="9235800"/>
              <a:ext cx="41760" cy="360"/>
            </a:xfrm>
            <a:custGeom>
              <a:avLst/>
              <a:gdLst/>
              <a:ahLst/>
              <a:rect l="l" t="t" r="r" b="b"/>
              <a:pathLst>
                <a:path w="41699" h="1">
                  <a:moveTo>
                    <a:pt x="0" y="0"/>
                  </a:moveTo>
                  <a:lnTo>
                    <a:pt x="41699"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19" name="pl73"/>
            <p:cNvSpPr/>
            <p:nvPr/>
          </p:nvSpPr>
          <p:spPr>
            <a:xfrm>
              <a:off x="12845880" y="92358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20" name="pl74"/>
            <p:cNvSpPr/>
            <p:nvPr/>
          </p:nvSpPr>
          <p:spPr>
            <a:xfrm>
              <a:off x="12845880" y="9235800"/>
              <a:ext cx="360" cy="46440"/>
            </a:xfrm>
            <a:custGeom>
              <a:avLst/>
              <a:gdLst/>
              <a:ahLst/>
              <a:rect l="l" t="t" r="r" b="b"/>
              <a:pathLst>
                <a:path w="1" h="45719">
                  <a:moveTo>
                    <a:pt x="0" y="0"/>
                  </a:moveTo>
                  <a:lnTo>
                    <a:pt x="0" y="45719"/>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21" name="pl75"/>
            <p:cNvSpPr/>
            <p:nvPr/>
          </p:nvSpPr>
          <p:spPr>
            <a:xfrm>
              <a:off x="12845880" y="92358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22" name="pl76"/>
            <p:cNvSpPr/>
            <p:nvPr/>
          </p:nvSpPr>
          <p:spPr>
            <a:xfrm>
              <a:off x="12845880" y="92358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723" name="tx77" descr=""/>
            <p:cNvPicPr/>
            <p:nvPr/>
          </p:nvPicPr>
          <p:blipFill>
            <a:blip r:embed="rId43"/>
            <a:stretch/>
          </p:blipFill>
          <p:spPr>
            <a:xfrm>
              <a:off x="12544920" y="9271800"/>
              <a:ext cx="603000" cy="168840"/>
            </a:xfrm>
            <a:prstGeom prst="rect">
              <a:avLst/>
            </a:prstGeom>
            <a:ln w="0">
              <a:noFill/>
            </a:ln>
          </p:spPr>
        </p:pic>
        <p:sp>
          <p:nvSpPr>
            <p:cNvPr id="724" name="pl78"/>
            <p:cNvSpPr/>
            <p:nvPr/>
          </p:nvSpPr>
          <p:spPr>
            <a:xfrm>
              <a:off x="12888000" y="92358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25" name="pl79"/>
            <p:cNvSpPr/>
            <p:nvPr/>
          </p:nvSpPr>
          <p:spPr>
            <a:xfrm>
              <a:off x="12888000" y="9189360"/>
              <a:ext cx="360" cy="4644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26" name="pl80"/>
            <p:cNvSpPr/>
            <p:nvPr/>
          </p:nvSpPr>
          <p:spPr>
            <a:xfrm>
              <a:off x="12888000" y="92358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27" name="pl81"/>
            <p:cNvSpPr/>
            <p:nvPr/>
          </p:nvSpPr>
          <p:spPr>
            <a:xfrm>
              <a:off x="12888000" y="92358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728" name="tx82" descr=""/>
            <p:cNvPicPr/>
            <p:nvPr/>
          </p:nvPicPr>
          <p:blipFill>
            <a:blip r:embed="rId44"/>
            <a:stretch/>
          </p:blipFill>
          <p:spPr>
            <a:xfrm>
              <a:off x="12771000" y="8959680"/>
              <a:ext cx="617760" cy="173880"/>
            </a:xfrm>
            <a:prstGeom prst="rect">
              <a:avLst/>
            </a:prstGeom>
            <a:ln w="0">
              <a:noFill/>
            </a:ln>
          </p:spPr>
        </p:pic>
        <p:sp>
          <p:nvSpPr>
            <p:cNvPr id="729" name="tx83"/>
            <p:cNvSpPr/>
            <p:nvPr/>
          </p:nvSpPr>
          <p:spPr>
            <a:xfrm>
              <a:off x="10857600" y="9937440"/>
              <a:ext cx="425880" cy="7596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en-US" sz="1200" spc="-1" strike="noStrike">
                  <a:solidFill>
                    <a:srgbClr val="000000"/>
                  </a:solidFill>
                  <a:latin typeface="Arial"/>
                </a:rPr>
                <a:t>                   </a:t>
              </a:r>
              <a:r>
                <a:rPr b="0" lang="zh-CN" sz="1200" spc="-1" strike="noStrike">
                  <a:solidFill>
                    <a:srgbClr val="000000"/>
                  </a:solidFill>
                  <a:latin typeface="Arial"/>
                </a:rPr>
                <a:t>T</a:t>
              </a:r>
              <a:r>
                <a:rPr b="0" lang="en-US" sz="1200" spc="-1" strike="noStrike">
                  <a:solidFill>
                    <a:srgbClr val="000000"/>
                  </a:solidFill>
                  <a:latin typeface="Arial"/>
                </a:rPr>
                <a:t> stage</a:t>
              </a:r>
              <a:endParaRPr b="0" lang="en-US" sz="1200" spc="-1" strike="noStrike">
                <a:solidFill>
                  <a:srgbClr val="000000"/>
                </a:solidFill>
                <a:latin typeface="Arial"/>
              </a:endParaRPr>
            </a:p>
          </p:txBody>
        </p:sp>
        <p:sp>
          <p:nvSpPr>
            <p:cNvPr id="730" name="pl84"/>
            <p:cNvSpPr/>
            <p:nvPr/>
          </p:nvSpPr>
          <p:spPr>
            <a:xfrm>
              <a:off x="12845880" y="9993240"/>
              <a:ext cx="527400" cy="360"/>
            </a:xfrm>
            <a:custGeom>
              <a:avLst/>
              <a:gdLst/>
              <a:ahLst/>
              <a:rect l="l" t="t" r="r" b="b"/>
              <a:pathLst>
                <a:path w="522899" h="1">
                  <a:moveTo>
                    <a:pt x="0" y="0"/>
                  </a:moveTo>
                  <a:lnTo>
                    <a:pt x="522899"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31" name="pl85"/>
            <p:cNvSpPr/>
            <p:nvPr/>
          </p:nvSpPr>
          <p:spPr>
            <a:xfrm>
              <a:off x="12845880" y="9993240"/>
              <a:ext cx="527400" cy="360"/>
            </a:xfrm>
            <a:custGeom>
              <a:avLst/>
              <a:gdLst/>
              <a:ahLst/>
              <a:rect l="l" t="t" r="r" b="b"/>
              <a:pathLst>
                <a:path w="522899" h="1">
                  <a:moveTo>
                    <a:pt x="0" y="0"/>
                  </a:moveTo>
                  <a:lnTo>
                    <a:pt x="522899"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32" name="pl86"/>
            <p:cNvSpPr/>
            <p:nvPr/>
          </p:nvSpPr>
          <p:spPr>
            <a:xfrm>
              <a:off x="12845880" y="999324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33" name="pl87"/>
            <p:cNvSpPr/>
            <p:nvPr/>
          </p:nvSpPr>
          <p:spPr>
            <a:xfrm>
              <a:off x="13373640" y="999324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34" name="pl88"/>
            <p:cNvSpPr/>
            <p:nvPr/>
          </p:nvSpPr>
          <p:spPr>
            <a:xfrm>
              <a:off x="12845880" y="9993240"/>
              <a:ext cx="527400" cy="360"/>
            </a:xfrm>
            <a:custGeom>
              <a:avLst/>
              <a:gdLst/>
              <a:ahLst/>
              <a:rect l="l" t="t" r="r" b="b"/>
              <a:pathLst>
                <a:path w="522899" h="1">
                  <a:moveTo>
                    <a:pt x="0" y="0"/>
                  </a:moveTo>
                  <a:lnTo>
                    <a:pt x="522899"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35" name="pl89"/>
            <p:cNvSpPr/>
            <p:nvPr/>
          </p:nvSpPr>
          <p:spPr>
            <a:xfrm>
              <a:off x="12845880" y="99932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36" name="pl90"/>
            <p:cNvSpPr/>
            <p:nvPr/>
          </p:nvSpPr>
          <p:spPr>
            <a:xfrm>
              <a:off x="13373640" y="99932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737" name="tx91" descr=""/>
            <p:cNvPicPr/>
            <p:nvPr/>
          </p:nvPicPr>
          <p:blipFill>
            <a:blip r:embed="rId45"/>
            <a:stretch/>
          </p:blipFill>
          <p:spPr>
            <a:xfrm>
              <a:off x="12796200" y="10063080"/>
              <a:ext cx="100080" cy="145800"/>
            </a:xfrm>
            <a:prstGeom prst="rect">
              <a:avLst/>
            </a:prstGeom>
            <a:ln w="0">
              <a:noFill/>
            </a:ln>
          </p:spPr>
        </p:pic>
        <p:pic>
          <p:nvPicPr>
            <p:cNvPr id="738" name="tx92" descr=""/>
            <p:cNvPicPr/>
            <p:nvPr/>
          </p:nvPicPr>
          <p:blipFill>
            <a:blip r:embed="rId46"/>
            <a:stretch/>
          </p:blipFill>
          <p:spPr>
            <a:xfrm>
              <a:off x="13323240" y="10062360"/>
              <a:ext cx="100080" cy="145800"/>
            </a:xfrm>
            <a:prstGeom prst="rect">
              <a:avLst/>
            </a:prstGeom>
            <a:ln w="0">
              <a:noFill/>
            </a:ln>
          </p:spPr>
        </p:pic>
        <p:sp>
          <p:nvSpPr>
            <p:cNvPr id="739" name="pl93"/>
            <p:cNvSpPr/>
            <p:nvPr/>
          </p:nvSpPr>
          <p:spPr>
            <a:xfrm>
              <a:off x="13109760" y="99932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40" name="pl94"/>
            <p:cNvSpPr/>
            <p:nvPr/>
          </p:nvSpPr>
          <p:spPr>
            <a:xfrm>
              <a:off x="13109760" y="9946440"/>
              <a:ext cx="360" cy="46440"/>
            </a:xfrm>
            <a:custGeom>
              <a:avLst/>
              <a:gdLst/>
              <a:ahLst/>
              <a:rect l="l" t="t" r="r" b="b"/>
              <a:pathLst>
                <a:path w="1" h="45719">
                  <a:moveTo>
                    <a:pt x="0" y="45719"/>
                  </a:moveTo>
                  <a:lnTo>
                    <a:pt x="0" y="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41" name="pl95"/>
            <p:cNvSpPr/>
            <p:nvPr/>
          </p:nvSpPr>
          <p:spPr>
            <a:xfrm>
              <a:off x="13109760" y="99932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42" name="pl96"/>
            <p:cNvSpPr/>
            <p:nvPr/>
          </p:nvSpPr>
          <p:spPr>
            <a:xfrm>
              <a:off x="13109760" y="99932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743" name="tx97" descr=""/>
            <p:cNvPicPr/>
            <p:nvPr/>
          </p:nvPicPr>
          <p:blipFill>
            <a:blip r:embed="rId47"/>
            <a:stretch/>
          </p:blipFill>
          <p:spPr>
            <a:xfrm>
              <a:off x="13059720" y="9745560"/>
              <a:ext cx="100080" cy="145800"/>
            </a:xfrm>
            <a:prstGeom prst="rect">
              <a:avLst/>
            </a:prstGeom>
            <a:ln w="0">
              <a:noFill/>
            </a:ln>
          </p:spPr>
        </p:pic>
        <p:sp>
          <p:nvSpPr>
            <p:cNvPr id="744" name="tx98"/>
            <p:cNvSpPr/>
            <p:nvPr/>
          </p:nvSpPr>
          <p:spPr>
            <a:xfrm>
              <a:off x="11216160" y="10691280"/>
              <a:ext cx="982800" cy="11448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en-US" sz="1200" spc="-1" strike="noStrike">
                  <a:solidFill>
                    <a:srgbClr val="000000"/>
                  </a:solidFill>
                  <a:latin typeface="Arial"/>
                </a:rPr>
                <a:t> </a:t>
              </a:r>
              <a:r>
                <a:rPr b="0" lang="zh-CN" sz="1200" spc="-1" strike="noStrike">
                  <a:solidFill>
                    <a:srgbClr val="000000"/>
                  </a:solidFill>
                  <a:latin typeface="Arial"/>
                </a:rPr>
                <a:t>CA19</a:t>
              </a:r>
              <a:r>
                <a:rPr b="0" lang="en-US" sz="1200" spc="-1" strike="noStrike">
                  <a:solidFill>
                    <a:srgbClr val="000000"/>
                  </a:solidFill>
                  <a:latin typeface="Arial"/>
                </a:rPr>
                <a:t>-</a:t>
              </a:r>
              <a:r>
                <a:rPr b="0" lang="zh-CN" sz="1200" spc="-1" strike="noStrike">
                  <a:solidFill>
                    <a:srgbClr val="000000"/>
                  </a:solidFill>
                  <a:latin typeface="Arial"/>
                </a:rPr>
                <a:t>9</a:t>
              </a:r>
              <a:r>
                <a:rPr b="0" lang="en-US" sz="1200" spc="-1" strike="noStrike">
                  <a:solidFill>
                    <a:srgbClr val="000000"/>
                  </a:solidFill>
                  <a:latin typeface="Arial"/>
                </a:rPr>
                <a:t>/</a:t>
              </a:r>
              <a:r>
                <a:rPr b="0" lang="zh-CN" sz="1200" spc="-1" strike="noStrike">
                  <a:solidFill>
                    <a:srgbClr val="000000"/>
                  </a:solidFill>
                  <a:latin typeface="Arial"/>
                </a:rPr>
                <a:t>CA125</a:t>
              </a:r>
              <a:endParaRPr b="0" lang="en-US" sz="1200" spc="-1" strike="noStrike">
                <a:solidFill>
                  <a:srgbClr val="000000"/>
                </a:solidFill>
                <a:latin typeface="Arial"/>
              </a:endParaRPr>
            </a:p>
          </p:txBody>
        </p:sp>
        <p:sp>
          <p:nvSpPr>
            <p:cNvPr id="745" name="pl99"/>
            <p:cNvSpPr/>
            <p:nvPr/>
          </p:nvSpPr>
          <p:spPr>
            <a:xfrm>
              <a:off x="12845880" y="10750320"/>
              <a:ext cx="606240" cy="360"/>
            </a:xfrm>
            <a:custGeom>
              <a:avLst/>
              <a:gdLst/>
              <a:ahLst/>
              <a:rect l="l" t="t" r="r" b="b"/>
              <a:pathLst>
                <a:path w="600960" h="1">
                  <a:moveTo>
                    <a:pt x="0" y="0"/>
                  </a:moveTo>
                  <a:lnTo>
                    <a:pt x="60096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46" name="pl100"/>
            <p:cNvSpPr/>
            <p:nvPr/>
          </p:nvSpPr>
          <p:spPr>
            <a:xfrm>
              <a:off x="12845880" y="10750320"/>
              <a:ext cx="360" cy="46440"/>
            </a:xfrm>
            <a:custGeom>
              <a:avLst/>
              <a:gdLst/>
              <a:ahLst/>
              <a:rect l="l" t="t" r="r" b="b"/>
              <a:pathLst>
                <a:path w="1" h="45719">
                  <a:moveTo>
                    <a:pt x="0" y="0"/>
                  </a:moveTo>
                  <a:lnTo>
                    <a:pt x="0" y="45719"/>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47" name="pl101"/>
            <p:cNvSpPr/>
            <p:nvPr/>
          </p:nvSpPr>
          <p:spPr>
            <a:xfrm>
              <a:off x="12906720" y="10750320"/>
              <a:ext cx="360" cy="46440"/>
            </a:xfrm>
            <a:custGeom>
              <a:avLst/>
              <a:gdLst/>
              <a:ahLst/>
              <a:rect l="l" t="t" r="r" b="b"/>
              <a:pathLst>
                <a:path w="1" h="45719">
                  <a:moveTo>
                    <a:pt x="0" y="0"/>
                  </a:moveTo>
                  <a:lnTo>
                    <a:pt x="0" y="45719"/>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48" name="pl102"/>
            <p:cNvSpPr/>
            <p:nvPr/>
          </p:nvSpPr>
          <p:spPr>
            <a:xfrm>
              <a:off x="12967200" y="10750320"/>
              <a:ext cx="360" cy="46440"/>
            </a:xfrm>
            <a:custGeom>
              <a:avLst/>
              <a:gdLst/>
              <a:ahLst/>
              <a:rect l="l" t="t" r="r" b="b"/>
              <a:pathLst>
                <a:path w="1" h="45719">
                  <a:moveTo>
                    <a:pt x="0" y="0"/>
                  </a:moveTo>
                  <a:lnTo>
                    <a:pt x="0" y="45719"/>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49" name="pl103"/>
            <p:cNvSpPr/>
            <p:nvPr/>
          </p:nvSpPr>
          <p:spPr>
            <a:xfrm>
              <a:off x="13028040" y="10750320"/>
              <a:ext cx="360" cy="46440"/>
            </a:xfrm>
            <a:custGeom>
              <a:avLst/>
              <a:gdLst/>
              <a:ahLst/>
              <a:rect l="l" t="t" r="r" b="b"/>
              <a:pathLst>
                <a:path w="1" h="45719">
                  <a:moveTo>
                    <a:pt x="0" y="0"/>
                  </a:moveTo>
                  <a:lnTo>
                    <a:pt x="0" y="45719"/>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50" name="pl104"/>
            <p:cNvSpPr/>
            <p:nvPr/>
          </p:nvSpPr>
          <p:spPr>
            <a:xfrm>
              <a:off x="13088520" y="10750320"/>
              <a:ext cx="360" cy="46440"/>
            </a:xfrm>
            <a:custGeom>
              <a:avLst/>
              <a:gdLst/>
              <a:ahLst/>
              <a:rect l="l" t="t" r="r" b="b"/>
              <a:pathLst>
                <a:path w="1" h="45719">
                  <a:moveTo>
                    <a:pt x="0" y="0"/>
                  </a:moveTo>
                  <a:lnTo>
                    <a:pt x="0" y="45719"/>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51" name="pl105"/>
            <p:cNvSpPr/>
            <p:nvPr/>
          </p:nvSpPr>
          <p:spPr>
            <a:xfrm>
              <a:off x="13149360" y="10750320"/>
              <a:ext cx="360" cy="46440"/>
            </a:xfrm>
            <a:custGeom>
              <a:avLst/>
              <a:gdLst/>
              <a:ahLst/>
              <a:rect l="l" t="t" r="r" b="b"/>
              <a:pathLst>
                <a:path w="1" h="45719">
                  <a:moveTo>
                    <a:pt x="0" y="0"/>
                  </a:moveTo>
                  <a:lnTo>
                    <a:pt x="0" y="45719"/>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52" name="pl106"/>
            <p:cNvSpPr/>
            <p:nvPr/>
          </p:nvSpPr>
          <p:spPr>
            <a:xfrm>
              <a:off x="13209840" y="10750320"/>
              <a:ext cx="360" cy="46440"/>
            </a:xfrm>
            <a:custGeom>
              <a:avLst/>
              <a:gdLst/>
              <a:ahLst/>
              <a:rect l="l" t="t" r="r" b="b"/>
              <a:pathLst>
                <a:path w="1" h="45719">
                  <a:moveTo>
                    <a:pt x="0" y="0"/>
                  </a:moveTo>
                  <a:lnTo>
                    <a:pt x="0" y="45719"/>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53" name="pl107"/>
            <p:cNvSpPr/>
            <p:nvPr/>
          </p:nvSpPr>
          <p:spPr>
            <a:xfrm>
              <a:off x="13270320" y="10750320"/>
              <a:ext cx="360" cy="46440"/>
            </a:xfrm>
            <a:custGeom>
              <a:avLst/>
              <a:gdLst/>
              <a:ahLst/>
              <a:rect l="l" t="t" r="r" b="b"/>
              <a:pathLst>
                <a:path w="1" h="45719">
                  <a:moveTo>
                    <a:pt x="0" y="0"/>
                  </a:moveTo>
                  <a:lnTo>
                    <a:pt x="0" y="45719"/>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54" name="pl108"/>
            <p:cNvSpPr/>
            <p:nvPr/>
          </p:nvSpPr>
          <p:spPr>
            <a:xfrm>
              <a:off x="13331160" y="10750320"/>
              <a:ext cx="360" cy="46440"/>
            </a:xfrm>
            <a:custGeom>
              <a:avLst/>
              <a:gdLst/>
              <a:ahLst/>
              <a:rect l="l" t="t" r="r" b="b"/>
              <a:pathLst>
                <a:path w="1" h="45719">
                  <a:moveTo>
                    <a:pt x="0" y="0"/>
                  </a:moveTo>
                  <a:lnTo>
                    <a:pt x="0" y="45719"/>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55" name="pl109"/>
            <p:cNvSpPr/>
            <p:nvPr/>
          </p:nvSpPr>
          <p:spPr>
            <a:xfrm>
              <a:off x="13391640" y="10750320"/>
              <a:ext cx="360" cy="46440"/>
            </a:xfrm>
            <a:custGeom>
              <a:avLst/>
              <a:gdLst/>
              <a:ahLst/>
              <a:rect l="l" t="t" r="r" b="b"/>
              <a:pathLst>
                <a:path w="1" h="45719">
                  <a:moveTo>
                    <a:pt x="0" y="0"/>
                  </a:moveTo>
                  <a:lnTo>
                    <a:pt x="0" y="45719"/>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56" name="pl110"/>
            <p:cNvSpPr/>
            <p:nvPr/>
          </p:nvSpPr>
          <p:spPr>
            <a:xfrm>
              <a:off x="13452480" y="10750320"/>
              <a:ext cx="360" cy="46440"/>
            </a:xfrm>
            <a:custGeom>
              <a:avLst/>
              <a:gdLst/>
              <a:ahLst/>
              <a:rect l="l" t="t" r="r" b="b"/>
              <a:pathLst>
                <a:path w="1" h="45719">
                  <a:moveTo>
                    <a:pt x="0" y="0"/>
                  </a:moveTo>
                  <a:lnTo>
                    <a:pt x="0" y="45719"/>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57" name="pl111"/>
            <p:cNvSpPr/>
            <p:nvPr/>
          </p:nvSpPr>
          <p:spPr>
            <a:xfrm>
              <a:off x="12845880" y="10750320"/>
              <a:ext cx="606240" cy="360"/>
            </a:xfrm>
            <a:custGeom>
              <a:avLst/>
              <a:gdLst/>
              <a:ahLst/>
              <a:rect l="l" t="t" r="r" b="b"/>
              <a:pathLst>
                <a:path w="600960" h="1">
                  <a:moveTo>
                    <a:pt x="0" y="0"/>
                  </a:moveTo>
                  <a:lnTo>
                    <a:pt x="60096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58" name="pl112"/>
            <p:cNvSpPr/>
            <p:nvPr/>
          </p:nvSpPr>
          <p:spPr>
            <a:xfrm>
              <a:off x="12845880" y="107503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59" name="pl113"/>
            <p:cNvSpPr/>
            <p:nvPr/>
          </p:nvSpPr>
          <p:spPr>
            <a:xfrm>
              <a:off x="12906720" y="107503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60" name="pl114"/>
            <p:cNvSpPr/>
            <p:nvPr/>
          </p:nvSpPr>
          <p:spPr>
            <a:xfrm>
              <a:off x="12967200" y="107503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61" name="pl115"/>
            <p:cNvSpPr/>
            <p:nvPr/>
          </p:nvSpPr>
          <p:spPr>
            <a:xfrm>
              <a:off x="13028040" y="107503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62" name="pl116"/>
            <p:cNvSpPr/>
            <p:nvPr/>
          </p:nvSpPr>
          <p:spPr>
            <a:xfrm>
              <a:off x="13088520" y="107503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63" name="pl117"/>
            <p:cNvSpPr/>
            <p:nvPr/>
          </p:nvSpPr>
          <p:spPr>
            <a:xfrm>
              <a:off x="13149360" y="107503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64" name="pl118"/>
            <p:cNvSpPr/>
            <p:nvPr/>
          </p:nvSpPr>
          <p:spPr>
            <a:xfrm>
              <a:off x="13209840" y="107503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65" name="pl119"/>
            <p:cNvSpPr/>
            <p:nvPr/>
          </p:nvSpPr>
          <p:spPr>
            <a:xfrm>
              <a:off x="13270320" y="107503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66" name="pl120"/>
            <p:cNvSpPr/>
            <p:nvPr/>
          </p:nvSpPr>
          <p:spPr>
            <a:xfrm>
              <a:off x="13331160" y="107503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67" name="pl121"/>
            <p:cNvSpPr/>
            <p:nvPr/>
          </p:nvSpPr>
          <p:spPr>
            <a:xfrm>
              <a:off x="13391640" y="107503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68" name="pl122"/>
            <p:cNvSpPr/>
            <p:nvPr/>
          </p:nvSpPr>
          <p:spPr>
            <a:xfrm>
              <a:off x="13452480" y="1075032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769" name="tx123" descr=""/>
            <p:cNvPicPr/>
            <p:nvPr/>
          </p:nvPicPr>
          <p:blipFill>
            <a:blip r:embed="rId48"/>
            <a:stretch/>
          </p:blipFill>
          <p:spPr>
            <a:xfrm>
              <a:off x="12796200" y="10818720"/>
              <a:ext cx="100080" cy="145800"/>
            </a:xfrm>
            <a:prstGeom prst="rect">
              <a:avLst/>
            </a:prstGeom>
            <a:ln w="0">
              <a:noFill/>
            </a:ln>
          </p:spPr>
        </p:pic>
        <p:pic>
          <p:nvPicPr>
            <p:cNvPr id="770" name="tx124" descr=""/>
            <p:cNvPicPr/>
            <p:nvPr/>
          </p:nvPicPr>
          <p:blipFill>
            <a:blip r:embed="rId49"/>
            <a:stretch/>
          </p:blipFill>
          <p:spPr>
            <a:xfrm>
              <a:off x="13003200" y="10818720"/>
              <a:ext cx="172080" cy="145800"/>
            </a:xfrm>
            <a:prstGeom prst="rect">
              <a:avLst/>
            </a:prstGeom>
            <a:ln w="0">
              <a:noFill/>
            </a:ln>
          </p:spPr>
        </p:pic>
        <p:pic>
          <p:nvPicPr>
            <p:cNvPr id="771" name="tx125" descr=""/>
            <p:cNvPicPr/>
            <p:nvPr/>
          </p:nvPicPr>
          <p:blipFill>
            <a:blip r:embed="rId50"/>
            <a:stretch/>
          </p:blipFill>
          <p:spPr>
            <a:xfrm>
              <a:off x="13306320" y="10818720"/>
              <a:ext cx="172080" cy="145800"/>
            </a:xfrm>
            <a:prstGeom prst="rect">
              <a:avLst/>
            </a:prstGeom>
            <a:ln w="0">
              <a:noFill/>
            </a:ln>
          </p:spPr>
        </p:pic>
        <p:sp>
          <p:nvSpPr>
            <p:cNvPr id="772" name="tx126"/>
            <p:cNvSpPr/>
            <p:nvPr/>
          </p:nvSpPr>
          <p:spPr>
            <a:xfrm>
              <a:off x="11216160" y="11405160"/>
              <a:ext cx="709200" cy="14328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en-US" sz="1200" spc="-1" strike="noStrike">
                  <a:solidFill>
                    <a:srgbClr val="000000"/>
                  </a:solidFill>
                  <a:latin typeface="Arial"/>
                </a:rPr>
                <a:t>  </a:t>
              </a:r>
              <a:r>
                <a:rPr b="0" lang="en-US" sz="1200" spc="-1" strike="noStrike">
                  <a:solidFill>
                    <a:srgbClr val="000000"/>
                  </a:solidFill>
                  <a:latin typeface="Arial"/>
                </a:rPr>
                <a:t>C</a:t>
              </a:r>
              <a:r>
                <a:rPr b="0" lang="zh-CN" sz="1200" spc="-1" strike="noStrike">
                  <a:solidFill>
                    <a:srgbClr val="000000"/>
                  </a:solidFill>
                  <a:latin typeface="Arial"/>
                </a:rPr>
                <a:t>utoff_</a:t>
              </a:r>
              <a:r>
                <a:rPr b="0" lang="en-US" sz="1200" spc="-1" strike="noStrike">
                  <a:solidFill>
                    <a:srgbClr val="000000"/>
                  </a:solidFill>
                  <a:latin typeface="Arial"/>
                </a:rPr>
                <a:t>CEA</a:t>
              </a:r>
              <a:endParaRPr b="0" lang="en-US" sz="1200" spc="-1" strike="noStrike">
                <a:solidFill>
                  <a:srgbClr val="000000"/>
                </a:solidFill>
                <a:latin typeface="Arial"/>
              </a:endParaRPr>
            </a:p>
          </p:txBody>
        </p:sp>
        <p:sp>
          <p:nvSpPr>
            <p:cNvPr id="773" name="pl127"/>
            <p:cNvSpPr/>
            <p:nvPr/>
          </p:nvSpPr>
          <p:spPr>
            <a:xfrm>
              <a:off x="12845880" y="11507760"/>
              <a:ext cx="185400" cy="360"/>
            </a:xfrm>
            <a:custGeom>
              <a:avLst/>
              <a:gdLst/>
              <a:ahLst/>
              <a:rect l="l" t="t" r="r" b="b"/>
              <a:pathLst>
                <a:path w="183933" h="1">
                  <a:moveTo>
                    <a:pt x="0" y="0"/>
                  </a:moveTo>
                  <a:lnTo>
                    <a:pt x="183933"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74" name="pl128"/>
            <p:cNvSpPr/>
            <p:nvPr/>
          </p:nvSpPr>
          <p:spPr>
            <a:xfrm>
              <a:off x="12845880" y="115077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75" name="pl129"/>
            <p:cNvSpPr/>
            <p:nvPr/>
          </p:nvSpPr>
          <p:spPr>
            <a:xfrm>
              <a:off x="12845880" y="11507760"/>
              <a:ext cx="360" cy="46440"/>
            </a:xfrm>
            <a:custGeom>
              <a:avLst/>
              <a:gdLst/>
              <a:ahLst/>
              <a:rect l="l" t="t" r="r" b="b"/>
              <a:pathLst>
                <a:path w="1" h="45719">
                  <a:moveTo>
                    <a:pt x="0" y="0"/>
                  </a:moveTo>
                  <a:lnTo>
                    <a:pt x="0" y="45719"/>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76" name="pl130"/>
            <p:cNvSpPr/>
            <p:nvPr/>
          </p:nvSpPr>
          <p:spPr>
            <a:xfrm>
              <a:off x="12845880" y="115077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77" name="pl131"/>
            <p:cNvSpPr/>
            <p:nvPr/>
          </p:nvSpPr>
          <p:spPr>
            <a:xfrm>
              <a:off x="12845880" y="115077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778" name="tx132" descr=""/>
            <p:cNvPicPr/>
            <p:nvPr/>
          </p:nvPicPr>
          <p:blipFill>
            <a:blip r:embed="rId51"/>
            <a:stretch/>
          </p:blipFill>
          <p:spPr>
            <a:xfrm>
              <a:off x="12544920" y="11521800"/>
              <a:ext cx="603000" cy="275400"/>
            </a:xfrm>
            <a:prstGeom prst="rect">
              <a:avLst/>
            </a:prstGeom>
            <a:ln w="0">
              <a:noFill/>
            </a:ln>
          </p:spPr>
        </p:pic>
        <p:sp>
          <p:nvSpPr>
            <p:cNvPr id="779" name="pl133"/>
            <p:cNvSpPr/>
            <p:nvPr/>
          </p:nvSpPr>
          <p:spPr>
            <a:xfrm>
              <a:off x="13031640" y="115077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80" name="pl134"/>
            <p:cNvSpPr/>
            <p:nvPr/>
          </p:nvSpPr>
          <p:spPr>
            <a:xfrm>
              <a:off x="13031640" y="11461320"/>
              <a:ext cx="360" cy="46440"/>
            </a:xfrm>
            <a:custGeom>
              <a:avLst/>
              <a:gdLst/>
              <a:ahLst/>
              <a:rect l="l" t="t" r="r" b="b"/>
              <a:pathLst>
                <a:path w="1" h="45720">
                  <a:moveTo>
                    <a:pt x="0" y="45720"/>
                  </a:moveTo>
                  <a:lnTo>
                    <a:pt x="0" y="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81" name="pl135"/>
            <p:cNvSpPr/>
            <p:nvPr/>
          </p:nvSpPr>
          <p:spPr>
            <a:xfrm>
              <a:off x="13031640" y="115077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82" name="pl136"/>
            <p:cNvSpPr/>
            <p:nvPr/>
          </p:nvSpPr>
          <p:spPr>
            <a:xfrm>
              <a:off x="13031640" y="1150776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83" name="tx138"/>
            <p:cNvSpPr/>
            <p:nvPr/>
          </p:nvSpPr>
          <p:spPr>
            <a:xfrm>
              <a:off x="11216160" y="12205800"/>
              <a:ext cx="982800" cy="11448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en-US" sz="1200" spc="-1" strike="noStrike">
                  <a:solidFill>
                    <a:srgbClr val="000000"/>
                  </a:solidFill>
                  <a:latin typeface="Arial"/>
                </a:rPr>
                <a:t> </a:t>
              </a:r>
              <a:r>
                <a:rPr b="0" lang="zh-CN" sz="1200" spc="-1" strike="noStrike">
                  <a:solidFill>
                    <a:srgbClr val="000000"/>
                  </a:solidFill>
                  <a:latin typeface="Arial"/>
                </a:rPr>
                <a:t>CA19</a:t>
              </a:r>
              <a:r>
                <a:rPr b="0" lang="en-US" sz="1200" spc="-1" strike="noStrike">
                  <a:solidFill>
                    <a:srgbClr val="000000"/>
                  </a:solidFill>
                  <a:latin typeface="Arial"/>
                </a:rPr>
                <a:t>-</a:t>
              </a:r>
              <a:r>
                <a:rPr b="0" lang="zh-CN" sz="1200" spc="-1" strike="noStrike">
                  <a:solidFill>
                    <a:srgbClr val="000000"/>
                  </a:solidFill>
                  <a:latin typeface="Arial"/>
                </a:rPr>
                <a:t>9</a:t>
              </a:r>
              <a:r>
                <a:rPr b="0" lang="en-US" sz="1200" spc="-1" strike="noStrike">
                  <a:solidFill>
                    <a:srgbClr val="000000"/>
                  </a:solidFill>
                  <a:latin typeface="Arial"/>
                </a:rPr>
                <a:t>/</a:t>
              </a:r>
              <a:r>
                <a:rPr b="0" lang="zh-CN" sz="1200" spc="-1" strike="noStrike">
                  <a:solidFill>
                    <a:srgbClr val="000000"/>
                  </a:solidFill>
                  <a:latin typeface="Arial"/>
                </a:rPr>
                <a:t>CA153</a:t>
              </a:r>
              <a:endParaRPr b="0" lang="en-US" sz="1200" spc="-1" strike="noStrike">
                <a:solidFill>
                  <a:srgbClr val="000000"/>
                </a:solidFill>
                <a:latin typeface="Arial"/>
              </a:endParaRPr>
            </a:p>
          </p:txBody>
        </p:sp>
        <p:sp>
          <p:nvSpPr>
            <p:cNvPr id="784" name="pl139"/>
            <p:cNvSpPr/>
            <p:nvPr/>
          </p:nvSpPr>
          <p:spPr>
            <a:xfrm>
              <a:off x="12845880" y="12265200"/>
              <a:ext cx="4656960" cy="360"/>
            </a:xfrm>
            <a:custGeom>
              <a:avLst/>
              <a:gdLst/>
              <a:ahLst/>
              <a:rect l="l" t="t" r="r" b="b"/>
              <a:pathLst>
                <a:path w="4615901" h="1">
                  <a:moveTo>
                    <a:pt x="0" y="0"/>
                  </a:moveTo>
                  <a:lnTo>
                    <a:pt x="4615901"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85" name="pl140"/>
            <p:cNvSpPr/>
            <p:nvPr/>
          </p:nvSpPr>
          <p:spPr>
            <a:xfrm>
              <a:off x="12845880" y="1226520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86" name="pl141"/>
            <p:cNvSpPr/>
            <p:nvPr/>
          </p:nvSpPr>
          <p:spPr>
            <a:xfrm>
              <a:off x="13363560" y="1226520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87" name="pl142"/>
            <p:cNvSpPr/>
            <p:nvPr/>
          </p:nvSpPr>
          <p:spPr>
            <a:xfrm>
              <a:off x="13880880" y="1226520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88" name="pl143"/>
            <p:cNvSpPr/>
            <p:nvPr/>
          </p:nvSpPr>
          <p:spPr>
            <a:xfrm>
              <a:off x="14398560" y="1226520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89" name="pl144"/>
            <p:cNvSpPr/>
            <p:nvPr/>
          </p:nvSpPr>
          <p:spPr>
            <a:xfrm>
              <a:off x="14915880" y="1226520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90" name="pl145"/>
            <p:cNvSpPr/>
            <p:nvPr/>
          </p:nvSpPr>
          <p:spPr>
            <a:xfrm>
              <a:off x="15433200" y="1226520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91" name="pl146"/>
            <p:cNvSpPr/>
            <p:nvPr/>
          </p:nvSpPr>
          <p:spPr>
            <a:xfrm>
              <a:off x="15950880" y="1226520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92" name="pl147"/>
            <p:cNvSpPr/>
            <p:nvPr/>
          </p:nvSpPr>
          <p:spPr>
            <a:xfrm>
              <a:off x="16468200" y="1226520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93" name="pl148"/>
            <p:cNvSpPr/>
            <p:nvPr/>
          </p:nvSpPr>
          <p:spPr>
            <a:xfrm>
              <a:off x="16985520" y="1226520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94" name="pl149"/>
            <p:cNvSpPr/>
            <p:nvPr/>
          </p:nvSpPr>
          <p:spPr>
            <a:xfrm>
              <a:off x="17503200" y="1226520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95" name="pl150"/>
            <p:cNvSpPr/>
            <p:nvPr/>
          </p:nvSpPr>
          <p:spPr>
            <a:xfrm>
              <a:off x="12845880" y="12265200"/>
              <a:ext cx="4656960" cy="360"/>
            </a:xfrm>
            <a:custGeom>
              <a:avLst/>
              <a:gdLst/>
              <a:ahLst/>
              <a:rect l="l" t="t" r="r" b="b"/>
              <a:pathLst>
                <a:path w="4615901" h="1">
                  <a:moveTo>
                    <a:pt x="0" y="0"/>
                  </a:moveTo>
                  <a:lnTo>
                    <a:pt x="4615901"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96" name="pl151"/>
            <p:cNvSpPr/>
            <p:nvPr/>
          </p:nvSpPr>
          <p:spPr>
            <a:xfrm>
              <a:off x="12845880" y="122652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97" name="pl152"/>
            <p:cNvSpPr/>
            <p:nvPr/>
          </p:nvSpPr>
          <p:spPr>
            <a:xfrm>
              <a:off x="13363560" y="122652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98" name="pl153"/>
            <p:cNvSpPr/>
            <p:nvPr/>
          </p:nvSpPr>
          <p:spPr>
            <a:xfrm>
              <a:off x="13880880" y="122652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799" name="pl154"/>
            <p:cNvSpPr/>
            <p:nvPr/>
          </p:nvSpPr>
          <p:spPr>
            <a:xfrm>
              <a:off x="14398560" y="122652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00" name="pl155"/>
            <p:cNvSpPr/>
            <p:nvPr/>
          </p:nvSpPr>
          <p:spPr>
            <a:xfrm>
              <a:off x="14915880" y="122652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01" name="pl156"/>
            <p:cNvSpPr/>
            <p:nvPr/>
          </p:nvSpPr>
          <p:spPr>
            <a:xfrm>
              <a:off x="15433200" y="122652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02" name="pl157"/>
            <p:cNvSpPr/>
            <p:nvPr/>
          </p:nvSpPr>
          <p:spPr>
            <a:xfrm>
              <a:off x="15950880" y="122652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03" name="pl158"/>
            <p:cNvSpPr/>
            <p:nvPr/>
          </p:nvSpPr>
          <p:spPr>
            <a:xfrm>
              <a:off x="16468200" y="122652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04" name="pl159"/>
            <p:cNvSpPr/>
            <p:nvPr/>
          </p:nvSpPr>
          <p:spPr>
            <a:xfrm>
              <a:off x="16985520" y="122652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05" name="pl160"/>
            <p:cNvSpPr/>
            <p:nvPr/>
          </p:nvSpPr>
          <p:spPr>
            <a:xfrm>
              <a:off x="17503200" y="1226520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806" name="tx161" descr=""/>
            <p:cNvPicPr/>
            <p:nvPr/>
          </p:nvPicPr>
          <p:blipFill>
            <a:blip r:embed="rId52"/>
            <a:stretch/>
          </p:blipFill>
          <p:spPr>
            <a:xfrm>
              <a:off x="12796200" y="12333240"/>
              <a:ext cx="100080" cy="145800"/>
            </a:xfrm>
            <a:prstGeom prst="rect">
              <a:avLst/>
            </a:prstGeom>
            <a:ln w="0">
              <a:noFill/>
            </a:ln>
          </p:spPr>
        </p:pic>
        <p:pic>
          <p:nvPicPr>
            <p:cNvPr id="807" name="tx162" descr=""/>
            <p:cNvPicPr/>
            <p:nvPr/>
          </p:nvPicPr>
          <p:blipFill>
            <a:blip r:embed="rId53"/>
            <a:stretch/>
          </p:blipFill>
          <p:spPr>
            <a:xfrm>
              <a:off x="13277880" y="12333240"/>
              <a:ext cx="172080" cy="145800"/>
            </a:xfrm>
            <a:prstGeom prst="rect">
              <a:avLst/>
            </a:prstGeom>
            <a:ln w="0">
              <a:noFill/>
            </a:ln>
          </p:spPr>
        </p:pic>
        <p:pic>
          <p:nvPicPr>
            <p:cNvPr id="808" name="tx163" descr=""/>
            <p:cNvPicPr/>
            <p:nvPr/>
          </p:nvPicPr>
          <p:blipFill>
            <a:blip r:embed="rId54"/>
            <a:stretch/>
          </p:blipFill>
          <p:spPr>
            <a:xfrm>
              <a:off x="13795560" y="12333240"/>
              <a:ext cx="172080" cy="145800"/>
            </a:xfrm>
            <a:prstGeom prst="rect">
              <a:avLst/>
            </a:prstGeom>
            <a:ln w="0">
              <a:noFill/>
            </a:ln>
          </p:spPr>
        </p:pic>
        <p:pic>
          <p:nvPicPr>
            <p:cNvPr id="809" name="tx164" descr=""/>
            <p:cNvPicPr/>
            <p:nvPr/>
          </p:nvPicPr>
          <p:blipFill>
            <a:blip r:embed="rId55"/>
            <a:stretch/>
          </p:blipFill>
          <p:spPr>
            <a:xfrm>
              <a:off x="14312880" y="12333240"/>
              <a:ext cx="172080" cy="145800"/>
            </a:xfrm>
            <a:prstGeom prst="rect">
              <a:avLst/>
            </a:prstGeom>
            <a:ln w="0">
              <a:noFill/>
            </a:ln>
          </p:spPr>
        </p:pic>
        <p:pic>
          <p:nvPicPr>
            <p:cNvPr id="810" name="tx165" descr=""/>
            <p:cNvPicPr/>
            <p:nvPr/>
          </p:nvPicPr>
          <p:blipFill>
            <a:blip r:embed="rId56"/>
            <a:stretch/>
          </p:blipFill>
          <p:spPr>
            <a:xfrm>
              <a:off x="14830560" y="12333240"/>
              <a:ext cx="172080" cy="145800"/>
            </a:xfrm>
            <a:prstGeom prst="rect">
              <a:avLst/>
            </a:prstGeom>
            <a:ln w="0">
              <a:noFill/>
            </a:ln>
          </p:spPr>
        </p:pic>
        <p:pic>
          <p:nvPicPr>
            <p:cNvPr id="811" name="tx166" descr=""/>
            <p:cNvPicPr/>
            <p:nvPr/>
          </p:nvPicPr>
          <p:blipFill>
            <a:blip r:embed="rId57"/>
            <a:stretch/>
          </p:blipFill>
          <p:spPr>
            <a:xfrm>
              <a:off x="15347520" y="12333240"/>
              <a:ext cx="172080" cy="145800"/>
            </a:xfrm>
            <a:prstGeom prst="rect">
              <a:avLst/>
            </a:prstGeom>
            <a:ln w="0">
              <a:noFill/>
            </a:ln>
          </p:spPr>
        </p:pic>
        <p:pic>
          <p:nvPicPr>
            <p:cNvPr id="812" name="tx167" descr=""/>
            <p:cNvPicPr/>
            <p:nvPr/>
          </p:nvPicPr>
          <p:blipFill>
            <a:blip r:embed="rId58"/>
            <a:stretch/>
          </p:blipFill>
          <p:spPr>
            <a:xfrm>
              <a:off x="15864840" y="12333240"/>
              <a:ext cx="172080" cy="145800"/>
            </a:xfrm>
            <a:prstGeom prst="rect">
              <a:avLst/>
            </a:prstGeom>
            <a:ln w="0">
              <a:noFill/>
            </a:ln>
          </p:spPr>
        </p:pic>
        <p:pic>
          <p:nvPicPr>
            <p:cNvPr id="813" name="tx168" descr=""/>
            <p:cNvPicPr/>
            <p:nvPr/>
          </p:nvPicPr>
          <p:blipFill>
            <a:blip r:embed="rId59"/>
            <a:stretch/>
          </p:blipFill>
          <p:spPr>
            <a:xfrm>
              <a:off x="16382520" y="12333240"/>
              <a:ext cx="172080" cy="145800"/>
            </a:xfrm>
            <a:prstGeom prst="rect">
              <a:avLst/>
            </a:prstGeom>
            <a:ln w="0">
              <a:noFill/>
            </a:ln>
          </p:spPr>
        </p:pic>
        <p:pic>
          <p:nvPicPr>
            <p:cNvPr id="814" name="tx169" descr=""/>
            <p:cNvPicPr/>
            <p:nvPr/>
          </p:nvPicPr>
          <p:blipFill>
            <a:blip r:embed="rId60"/>
            <a:stretch/>
          </p:blipFill>
          <p:spPr>
            <a:xfrm>
              <a:off x="16899840" y="12333240"/>
              <a:ext cx="172080" cy="145800"/>
            </a:xfrm>
            <a:prstGeom prst="rect">
              <a:avLst/>
            </a:prstGeom>
            <a:ln w="0">
              <a:noFill/>
            </a:ln>
          </p:spPr>
        </p:pic>
        <p:pic>
          <p:nvPicPr>
            <p:cNvPr id="815" name="tx170" descr=""/>
            <p:cNvPicPr/>
            <p:nvPr/>
          </p:nvPicPr>
          <p:blipFill>
            <a:blip r:embed="rId61"/>
            <a:stretch/>
          </p:blipFill>
          <p:spPr>
            <a:xfrm>
              <a:off x="17417520" y="12333240"/>
              <a:ext cx="172080" cy="145800"/>
            </a:xfrm>
            <a:prstGeom prst="rect">
              <a:avLst/>
            </a:prstGeom>
            <a:ln w="0">
              <a:noFill/>
            </a:ln>
          </p:spPr>
        </p:pic>
        <p:sp>
          <p:nvSpPr>
            <p:cNvPr id="816" name="tx171"/>
            <p:cNvSpPr/>
            <p:nvPr/>
          </p:nvSpPr>
          <p:spPr>
            <a:xfrm>
              <a:off x="11216160" y="12964320"/>
              <a:ext cx="811800" cy="11268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zh-CN" sz="1200" spc="-1" strike="noStrike">
                  <a:solidFill>
                    <a:srgbClr val="000000"/>
                  </a:solidFill>
                  <a:latin typeface="Arial"/>
                </a:rPr>
                <a:t>Total Points</a:t>
              </a:r>
              <a:endParaRPr b="0" lang="en-US" sz="1200" spc="-1" strike="noStrike">
                <a:solidFill>
                  <a:srgbClr val="000000"/>
                </a:solidFill>
                <a:latin typeface="Arial"/>
              </a:endParaRPr>
            </a:p>
          </p:txBody>
        </p:sp>
        <p:sp>
          <p:nvSpPr>
            <p:cNvPr id="817" name="pl172"/>
            <p:cNvSpPr/>
            <p:nvPr/>
          </p:nvSpPr>
          <p:spPr>
            <a:xfrm>
              <a:off x="12845880" y="13022640"/>
              <a:ext cx="4656960" cy="360"/>
            </a:xfrm>
            <a:custGeom>
              <a:avLst/>
              <a:gdLst/>
              <a:ahLst/>
              <a:rect l="l" t="t" r="r" b="b"/>
              <a:pathLst>
                <a:path w="4615901" h="1">
                  <a:moveTo>
                    <a:pt x="0" y="0"/>
                  </a:moveTo>
                  <a:lnTo>
                    <a:pt x="4615901"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18" name="pl173"/>
            <p:cNvSpPr/>
            <p:nvPr/>
          </p:nvSpPr>
          <p:spPr>
            <a:xfrm>
              <a:off x="12845880" y="1302264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19" name="pl174"/>
            <p:cNvSpPr/>
            <p:nvPr/>
          </p:nvSpPr>
          <p:spPr>
            <a:xfrm>
              <a:off x="13234320" y="1302264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20" name="pl175"/>
            <p:cNvSpPr/>
            <p:nvPr/>
          </p:nvSpPr>
          <p:spPr>
            <a:xfrm>
              <a:off x="13622400" y="1302264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21" name="pl176"/>
            <p:cNvSpPr/>
            <p:nvPr/>
          </p:nvSpPr>
          <p:spPr>
            <a:xfrm>
              <a:off x="14010480" y="1302264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22" name="pl177"/>
            <p:cNvSpPr/>
            <p:nvPr/>
          </p:nvSpPr>
          <p:spPr>
            <a:xfrm>
              <a:off x="14398560" y="1302264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23" name="pl178"/>
            <p:cNvSpPr/>
            <p:nvPr/>
          </p:nvSpPr>
          <p:spPr>
            <a:xfrm>
              <a:off x="14786640" y="1302264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24" name="pl179"/>
            <p:cNvSpPr/>
            <p:nvPr/>
          </p:nvSpPr>
          <p:spPr>
            <a:xfrm>
              <a:off x="15174720" y="1302264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25" name="pl180"/>
            <p:cNvSpPr/>
            <p:nvPr/>
          </p:nvSpPr>
          <p:spPr>
            <a:xfrm>
              <a:off x="15562800" y="1302264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26" name="pl181"/>
            <p:cNvSpPr/>
            <p:nvPr/>
          </p:nvSpPr>
          <p:spPr>
            <a:xfrm>
              <a:off x="15950880" y="1302264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27" name="pl182"/>
            <p:cNvSpPr/>
            <p:nvPr/>
          </p:nvSpPr>
          <p:spPr>
            <a:xfrm>
              <a:off x="16338960" y="1302264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28" name="pl183"/>
            <p:cNvSpPr/>
            <p:nvPr/>
          </p:nvSpPr>
          <p:spPr>
            <a:xfrm>
              <a:off x="16727040" y="1302264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29" name="pl184"/>
            <p:cNvSpPr/>
            <p:nvPr/>
          </p:nvSpPr>
          <p:spPr>
            <a:xfrm>
              <a:off x="17115120" y="1302264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30" name="pl185"/>
            <p:cNvSpPr/>
            <p:nvPr/>
          </p:nvSpPr>
          <p:spPr>
            <a:xfrm>
              <a:off x="17503200" y="1302264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31" name="pl186"/>
            <p:cNvSpPr/>
            <p:nvPr/>
          </p:nvSpPr>
          <p:spPr>
            <a:xfrm>
              <a:off x="12845880" y="13022640"/>
              <a:ext cx="4656960" cy="360"/>
            </a:xfrm>
            <a:custGeom>
              <a:avLst/>
              <a:gdLst/>
              <a:ahLst/>
              <a:rect l="l" t="t" r="r" b="b"/>
              <a:pathLst>
                <a:path w="4615901" h="1">
                  <a:moveTo>
                    <a:pt x="0" y="0"/>
                  </a:moveTo>
                  <a:lnTo>
                    <a:pt x="4615901"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32" name="pl187"/>
            <p:cNvSpPr/>
            <p:nvPr/>
          </p:nvSpPr>
          <p:spPr>
            <a:xfrm>
              <a:off x="12845880" y="130226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33" name="pl188"/>
            <p:cNvSpPr/>
            <p:nvPr/>
          </p:nvSpPr>
          <p:spPr>
            <a:xfrm>
              <a:off x="13234320" y="130226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34" name="pl189"/>
            <p:cNvSpPr/>
            <p:nvPr/>
          </p:nvSpPr>
          <p:spPr>
            <a:xfrm>
              <a:off x="13622400" y="130226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35" name="pl190"/>
            <p:cNvSpPr/>
            <p:nvPr/>
          </p:nvSpPr>
          <p:spPr>
            <a:xfrm>
              <a:off x="14010480" y="130226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36" name="pl191"/>
            <p:cNvSpPr/>
            <p:nvPr/>
          </p:nvSpPr>
          <p:spPr>
            <a:xfrm>
              <a:off x="14398560" y="130226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37" name="pl192"/>
            <p:cNvSpPr/>
            <p:nvPr/>
          </p:nvSpPr>
          <p:spPr>
            <a:xfrm>
              <a:off x="14786640" y="130226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38" name="pl193"/>
            <p:cNvSpPr/>
            <p:nvPr/>
          </p:nvSpPr>
          <p:spPr>
            <a:xfrm>
              <a:off x="15174720" y="130226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39" name="pl194"/>
            <p:cNvSpPr/>
            <p:nvPr/>
          </p:nvSpPr>
          <p:spPr>
            <a:xfrm>
              <a:off x="15562800" y="130226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40" name="pl195"/>
            <p:cNvSpPr/>
            <p:nvPr/>
          </p:nvSpPr>
          <p:spPr>
            <a:xfrm>
              <a:off x="15950880" y="130226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41" name="pl196"/>
            <p:cNvSpPr/>
            <p:nvPr/>
          </p:nvSpPr>
          <p:spPr>
            <a:xfrm>
              <a:off x="16338960" y="130226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42" name="pl197"/>
            <p:cNvSpPr/>
            <p:nvPr/>
          </p:nvSpPr>
          <p:spPr>
            <a:xfrm>
              <a:off x="16727040" y="130226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43" name="pl198"/>
            <p:cNvSpPr/>
            <p:nvPr/>
          </p:nvSpPr>
          <p:spPr>
            <a:xfrm>
              <a:off x="17115120" y="130226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44" name="pl199"/>
            <p:cNvSpPr/>
            <p:nvPr/>
          </p:nvSpPr>
          <p:spPr>
            <a:xfrm>
              <a:off x="17503200" y="1302264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845" name="tx200" descr=""/>
            <p:cNvPicPr/>
            <p:nvPr/>
          </p:nvPicPr>
          <p:blipFill>
            <a:blip r:embed="rId62"/>
            <a:stretch/>
          </p:blipFill>
          <p:spPr>
            <a:xfrm>
              <a:off x="12796200" y="13091400"/>
              <a:ext cx="100080" cy="145800"/>
            </a:xfrm>
            <a:prstGeom prst="rect">
              <a:avLst/>
            </a:prstGeom>
            <a:ln w="0">
              <a:noFill/>
            </a:ln>
          </p:spPr>
        </p:pic>
        <p:pic>
          <p:nvPicPr>
            <p:cNvPr id="846" name="tx201" descr=""/>
            <p:cNvPicPr/>
            <p:nvPr/>
          </p:nvPicPr>
          <p:blipFill>
            <a:blip r:embed="rId63"/>
            <a:stretch/>
          </p:blipFill>
          <p:spPr>
            <a:xfrm>
              <a:off x="13148640" y="13091400"/>
              <a:ext cx="172080" cy="145800"/>
            </a:xfrm>
            <a:prstGeom prst="rect">
              <a:avLst/>
            </a:prstGeom>
            <a:ln w="0">
              <a:noFill/>
            </a:ln>
          </p:spPr>
        </p:pic>
        <p:pic>
          <p:nvPicPr>
            <p:cNvPr id="847" name="tx202" descr=""/>
            <p:cNvPicPr/>
            <p:nvPr/>
          </p:nvPicPr>
          <p:blipFill>
            <a:blip r:embed="rId64"/>
            <a:stretch/>
          </p:blipFill>
          <p:spPr>
            <a:xfrm>
              <a:off x="13536720" y="13091400"/>
              <a:ext cx="172080" cy="145800"/>
            </a:xfrm>
            <a:prstGeom prst="rect">
              <a:avLst/>
            </a:prstGeom>
            <a:ln w="0">
              <a:noFill/>
            </a:ln>
          </p:spPr>
        </p:pic>
        <p:pic>
          <p:nvPicPr>
            <p:cNvPr id="848" name="tx203" descr=""/>
            <p:cNvPicPr/>
            <p:nvPr/>
          </p:nvPicPr>
          <p:blipFill>
            <a:blip r:embed="rId65"/>
            <a:stretch/>
          </p:blipFill>
          <p:spPr>
            <a:xfrm>
              <a:off x="13924080" y="13091400"/>
              <a:ext cx="172080" cy="145800"/>
            </a:xfrm>
            <a:prstGeom prst="rect">
              <a:avLst/>
            </a:prstGeom>
            <a:ln w="0">
              <a:noFill/>
            </a:ln>
          </p:spPr>
        </p:pic>
        <p:pic>
          <p:nvPicPr>
            <p:cNvPr id="849" name="tx204" descr=""/>
            <p:cNvPicPr/>
            <p:nvPr/>
          </p:nvPicPr>
          <p:blipFill>
            <a:blip r:embed="rId66"/>
            <a:stretch/>
          </p:blipFill>
          <p:spPr>
            <a:xfrm>
              <a:off x="14312880" y="13091400"/>
              <a:ext cx="172080" cy="145800"/>
            </a:xfrm>
            <a:prstGeom prst="rect">
              <a:avLst/>
            </a:prstGeom>
            <a:ln w="0">
              <a:noFill/>
            </a:ln>
          </p:spPr>
        </p:pic>
        <p:pic>
          <p:nvPicPr>
            <p:cNvPr id="850" name="tx205" descr=""/>
            <p:cNvPicPr/>
            <p:nvPr/>
          </p:nvPicPr>
          <p:blipFill>
            <a:blip r:embed="rId67"/>
            <a:stretch/>
          </p:blipFill>
          <p:spPr>
            <a:xfrm>
              <a:off x="14700240" y="13091400"/>
              <a:ext cx="172080" cy="145800"/>
            </a:xfrm>
            <a:prstGeom prst="rect">
              <a:avLst/>
            </a:prstGeom>
            <a:ln w="0">
              <a:noFill/>
            </a:ln>
          </p:spPr>
        </p:pic>
        <p:pic>
          <p:nvPicPr>
            <p:cNvPr id="851" name="tx206" descr=""/>
            <p:cNvPicPr/>
            <p:nvPr/>
          </p:nvPicPr>
          <p:blipFill>
            <a:blip r:embed="rId68"/>
            <a:stretch/>
          </p:blipFill>
          <p:spPr>
            <a:xfrm>
              <a:off x="15089400" y="13091400"/>
              <a:ext cx="172080" cy="145800"/>
            </a:xfrm>
            <a:prstGeom prst="rect">
              <a:avLst/>
            </a:prstGeom>
            <a:ln w="0">
              <a:noFill/>
            </a:ln>
          </p:spPr>
        </p:pic>
        <p:pic>
          <p:nvPicPr>
            <p:cNvPr id="852" name="tx207" descr=""/>
            <p:cNvPicPr/>
            <p:nvPr/>
          </p:nvPicPr>
          <p:blipFill>
            <a:blip r:embed="rId69"/>
            <a:stretch/>
          </p:blipFill>
          <p:spPr>
            <a:xfrm>
              <a:off x="15476760" y="13091400"/>
              <a:ext cx="172080" cy="145800"/>
            </a:xfrm>
            <a:prstGeom prst="rect">
              <a:avLst/>
            </a:prstGeom>
            <a:ln w="0">
              <a:noFill/>
            </a:ln>
          </p:spPr>
        </p:pic>
        <p:pic>
          <p:nvPicPr>
            <p:cNvPr id="853" name="tx208" descr=""/>
            <p:cNvPicPr/>
            <p:nvPr/>
          </p:nvPicPr>
          <p:blipFill>
            <a:blip r:embed="rId70"/>
            <a:stretch/>
          </p:blipFill>
          <p:spPr>
            <a:xfrm>
              <a:off x="15864840" y="13091400"/>
              <a:ext cx="172080" cy="145800"/>
            </a:xfrm>
            <a:prstGeom prst="rect">
              <a:avLst/>
            </a:prstGeom>
            <a:ln w="0">
              <a:noFill/>
            </a:ln>
          </p:spPr>
        </p:pic>
        <p:pic>
          <p:nvPicPr>
            <p:cNvPr id="854" name="tx209" descr=""/>
            <p:cNvPicPr/>
            <p:nvPr/>
          </p:nvPicPr>
          <p:blipFill>
            <a:blip r:embed="rId71"/>
            <a:stretch/>
          </p:blipFill>
          <p:spPr>
            <a:xfrm>
              <a:off x="16252920" y="13091400"/>
              <a:ext cx="172080" cy="145800"/>
            </a:xfrm>
            <a:prstGeom prst="rect">
              <a:avLst/>
            </a:prstGeom>
            <a:ln w="0">
              <a:noFill/>
            </a:ln>
          </p:spPr>
        </p:pic>
        <p:pic>
          <p:nvPicPr>
            <p:cNvPr id="855" name="tx210" descr=""/>
            <p:cNvPicPr/>
            <p:nvPr/>
          </p:nvPicPr>
          <p:blipFill>
            <a:blip r:embed="rId72"/>
            <a:stretch/>
          </p:blipFill>
          <p:spPr>
            <a:xfrm>
              <a:off x="16605360" y="13091400"/>
              <a:ext cx="243720" cy="145800"/>
            </a:xfrm>
            <a:prstGeom prst="rect">
              <a:avLst/>
            </a:prstGeom>
            <a:ln w="0">
              <a:noFill/>
            </a:ln>
          </p:spPr>
        </p:pic>
        <p:pic>
          <p:nvPicPr>
            <p:cNvPr id="856" name="tx211" descr=""/>
            <p:cNvPicPr/>
            <p:nvPr/>
          </p:nvPicPr>
          <p:blipFill>
            <a:blip r:embed="rId73"/>
            <a:stretch/>
          </p:blipFill>
          <p:spPr>
            <a:xfrm>
              <a:off x="16993440" y="13091400"/>
              <a:ext cx="243720" cy="145800"/>
            </a:xfrm>
            <a:prstGeom prst="rect">
              <a:avLst/>
            </a:prstGeom>
            <a:ln w="0">
              <a:noFill/>
            </a:ln>
          </p:spPr>
        </p:pic>
        <p:pic>
          <p:nvPicPr>
            <p:cNvPr id="857" name="tx212" descr=""/>
            <p:cNvPicPr/>
            <p:nvPr/>
          </p:nvPicPr>
          <p:blipFill>
            <a:blip r:embed="rId74"/>
            <a:stretch/>
          </p:blipFill>
          <p:spPr>
            <a:xfrm>
              <a:off x="17381520" y="13091400"/>
              <a:ext cx="243720" cy="145800"/>
            </a:xfrm>
            <a:prstGeom prst="rect">
              <a:avLst/>
            </a:prstGeom>
            <a:ln w="0">
              <a:noFill/>
            </a:ln>
          </p:spPr>
        </p:pic>
        <p:sp>
          <p:nvSpPr>
            <p:cNvPr id="858" name="pl213"/>
            <p:cNvSpPr/>
            <p:nvPr/>
          </p:nvSpPr>
          <p:spPr>
            <a:xfrm>
              <a:off x="12845880" y="13022640"/>
              <a:ext cx="4656960" cy="360"/>
            </a:xfrm>
            <a:custGeom>
              <a:avLst/>
              <a:gdLst/>
              <a:ahLst/>
              <a:rect l="l" t="t" r="r" b="b"/>
              <a:pathLst>
                <a:path w="4615901" h="1">
                  <a:moveTo>
                    <a:pt x="0" y="0"/>
                  </a:moveTo>
                  <a:lnTo>
                    <a:pt x="4615901"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59" name="pl214"/>
            <p:cNvSpPr/>
            <p:nvPr/>
          </p:nvSpPr>
          <p:spPr>
            <a:xfrm>
              <a:off x="1284588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60" name="pl215"/>
            <p:cNvSpPr/>
            <p:nvPr/>
          </p:nvSpPr>
          <p:spPr>
            <a:xfrm>
              <a:off x="1292364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61" name="pl216"/>
            <p:cNvSpPr/>
            <p:nvPr/>
          </p:nvSpPr>
          <p:spPr>
            <a:xfrm>
              <a:off x="1300140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62" name="pl217"/>
            <p:cNvSpPr/>
            <p:nvPr/>
          </p:nvSpPr>
          <p:spPr>
            <a:xfrm>
              <a:off x="1307880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63" name="pl218"/>
            <p:cNvSpPr/>
            <p:nvPr/>
          </p:nvSpPr>
          <p:spPr>
            <a:xfrm>
              <a:off x="1315656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64" name="pl219"/>
            <p:cNvSpPr/>
            <p:nvPr/>
          </p:nvSpPr>
          <p:spPr>
            <a:xfrm>
              <a:off x="1323432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65" name="pl220"/>
            <p:cNvSpPr/>
            <p:nvPr/>
          </p:nvSpPr>
          <p:spPr>
            <a:xfrm>
              <a:off x="1331172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66" name="pl221"/>
            <p:cNvSpPr/>
            <p:nvPr/>
          </p:nvSpPr>
          <p:spPr>
            <a:xfrm>
              <a:off x="1338948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67" name="pl222"/>
            <p:cNvSpPr/>
            <p:nvPr/>
          </p:nvSpPr>
          <p:spPr>
            <a:xfrm>
              <a:off x="1346688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68" name="pl223"/>
            <p:cNvSpPr/>
            <p:nvPr/>
          </p:nvSpPr>
          <p:spPr>
            <a:xfrm>
              <a:off x="1354464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69" name="pl224"/>
            <p:cNvSpPr/>
            <p:nvPr/>
          </p:nvSpPr>
          <p:spPr>
            <a:xfrm>
              <a:off x="1362240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70" name="pl225"/>
            <p:cNvSpPr/>
            <p:nvPr/>
          </p:nvSpPr>
          <p:spPr>
            <a:xfrm>
              <a:off x="1369980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71" name="pl226"/>
            <p:cNvSpPr/>
            <p:nvPr/>
          </p:nvSpPr>
          <p:spPr>
            <a:xfrm>
              <a:off x="1377756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72" name="pl227"/>
            <p:cNvSpPr/>
            <p:nvPr/>
          </p:nvSpPr>
          <p:spPr>
            <a:xfrm>
              <a:off x="1385496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73" name="pl228"/>
            <p:cNvSpPr/>
            <p:nvPr/>
          </p:nvSpPr>
          <p:spPr>
            <a:xfrm>
              <a:off x="1393272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74" name="pl229"/>
            <p:cNvSpPr/>
            <p:nvPr/>
          </p:nvSpPr>
          <p:spPr>
            <a:xfrm>
              <a:off x="1401048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75" name="pl230"/>
            <p:cNvSpPr/>
            <p:nvPr/>
          </p:nvSpPr>
          <p:spPr>
            <a:xfrm>
              <a:off x="1408788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76" name="pl231"/>
            <p:cNvSpPr/>
            <p:nvPr/>
          </p:nvSpPr>
          <p:spPr>
            <a:xfrm>
              <a:off x="1416564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77" name="pl232"/>
            <p:cNvSpPr/>
            <p:nvPr/>
          </p:nvSpPr>
          <p:spPr>
            <a:xfrm>
              <a:off x="1424304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78" name="pl233"/>
            <p:cNvSpPr/>
            <p:nvPr/>
          </p:nvSpPr>
          <p:spPr>
            <a:xfrm>
              <a:off x="1432080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79" name="pl234"/>
            <p:cNvSpPr/>
            <p:nvPr/>
          </p:nvSpPr>
          <p:spPr>
            <a:xfrm>
              <a:off x="1439856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80" name="pl235"/>
            <p:cNvSpPr/>
            <p:nvPr/>
          </p:nvSpPr>
          <p:spPr>
            <a:xfrm>
              <a:off x="1447596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81" name="pl236"/>
            <p:cNvSpPr/>
            <p:nvPr/>
          </p:nvSpPr>
          <p:spPr>
            <a:xfrm>
              <a:off x="1455372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82" name="pl237"/>
            <p:cNvSpPr/>
            <p:nvPr/>
          </p:nvSpPr>
          <p:spPr>
            <a:xfrm>
              <a:off x="1463112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83" name="pl238"/>
            <p:cNvSpPr/>
            <p:nvPr/>
          </p:nvSpPr>
          <p:spPr>
            <a:xfrm>
              <a:off x="1470888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84" name="pl239"/>
            <p:cNvSpPr/>
            <p:nvPr/>
          </p:nvSpPr>
          <p:spPr>
            <a:xfrm>
              <a:off x="1478664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85" name="pl240"/>
            <p:cNvSpPr/>
            <p:nvPr/>
          </p:nvSpPr>
          <p:spPr>
            <a:xfrm>
              <a:off x="1486404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86" name="pl241"/>
            <p:cNvSpPr/>
            <p:nvPr/>
          </p:nvSpPr>
          <p:spPr>
            <a:xfrm>
              <a:off x="1494180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87" name="pl242"/>
            <p:cNvSpPr/>
            <p:nvPr/>
          </p:nvSpPr>
          <p:spPr>
            <a:xfrm>
              <a:off x="1501920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88" name="pl243"/>
            <p:cNvSpPr/>
            <p:nvPr/>
          </p:nvSpPr>
          <p:spPr>
            <a:xfrm>
              <a:off x="1509696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89" name="pl244"/>
            <p:cNvSpPr/>
            <p:nvPr/>
          </p:nvSpPr>
          <p:spPr>
            <a:xfrm>
              <a:off x="1517472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90" name="pl245"/>
            <p:cNvSpPr/>
            <p:nvPr/>
          </p:nvSpPr>
          <p:spPr>
            <a:xfrm>
              <a:off x="1525212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91" name="pl246"/>
            <p:cNvSpPr/>
            <p:nvPr/>
          </p:nvSpPr>
          <p:spPr>
            <a:xfrm>
              <a:off x="1532988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92" name="pl247"/>
            <p:cNvSpPr/>
            <p:nvPr/>
          </p:nvSpPr>
          <p:spPr>
            <a:xfrm>
              <a:off x="1540728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93" name="pl248"/>
            <p:cNvSpPr/>
            <p:nvPr/>
          </p:nvSpPr>
          <p:spPr>
            <a:xfrm>
              <a:off x="1548504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94" name="pl249"/>
            <p:cNvSpPr/>
            <p:nvPr/>
          </p:nvSpPr>
          <p:spPr>
            <a:xfrm>
              <a:off x="1556280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95" name="pl250"/>
            <p:cNvSpPr/>
            <p:nvPr/>
          </p:nvSpPr>
          <p:spPr>
            <a:xfrm>
              <a:off x="1564020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96" name="pl251"/>
            <p:cNvSpPr/>
            <p:nvPr/>
          </p:nvSpPr>
          <p:spPr>
            <a:xfrm>
              <a:off x="1571796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97" name="pl252"/>
            <p:cNvSpPr/>
            <p:nvPr/>
          </p:nvSpPr>
          <p:spPr>
            <a:xfrm>
              <a:off x="1579536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98" name="pl253"/>
            <p:cNvSpPr/>
            <p:nvPr/>
          </p:nvSpPr>
          <p:spPr>
            <a:xfrm>
              <a:off x="1587312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899" name="pl254"/>
            <p:cNvSpPr/>
            <p:nvPr/>
          </p:nvSpPr>
          <p:spPr>
            <a:xfrm>
              <a:off x="1595088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00" name="pl255"/>
            <p:cNvSpPr/>
            <p:nvPr/>
          </p:nvSpPr>
          <p:spPr>
            <a:xfrm>
              <a:off x="1602828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01" name="pl256"/>
            <p:cNvSpPr/>
            <p:nvPr/>
          </p:nvSpPr>
          <p:spPr>
            <a:xfrm>
              <a:off x="1610604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02" name="pl257"/>
            <p:cNvSpPr/>
            <p:nvPr/>
          </p:nvSpPr>
          <p:spPr>
            <a:xfrm>
              <a:off x="1618344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03" name="pl258"/>
            <p:cNvSpPr/>
            <p:nvPr/>
          </p:nvSpPr>
          <p:spPr>
            <a:xfrm>
              <a:off x="1626120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04" name="pl259"/>
            <p:cNvSpPr/>
            <p:nvPr/>
          </p:nvSpPr>
          <p:spPr>
            <a:xfrm>
              <a:off x="1633896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05" name="pl260"/>
            <p:cNvSpPr/>
            <p:nvPr/>
          </p:nvSpPr>
          <p:spPr>
            <a:xfrm>
              <a:off x="1641636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06" name="pl261"/>
            <p:cNvSpPr/>
            <p:nvPr/>
          </p:nvSpPr>
          <p:spPr>
            <a:xfrm>
              <a:off x="1649412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07" name="pl262"/>
            <p:cNvSpPr/>
            <p:nvPr/>
          </p:nvSpPr>
          <p:spPr>
            <a:xfrm>
              <a:off x="1657152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08" name="pl263"/>
            <p:cNvSpPr/>
            <p:nvPr/>
          </p:nvSpPr>
          <p:spPr>
            <a:xfrm>
              <a:off x="1664928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09" name="pl264"/>
            <p:cNvSpPr/>
            <p:nvPr/>
          </p:nvSpPr>
          <p:spPr>
            <a:xfrm>
              <a:off x="1672704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10" name="pl265"/>
            <p:cNvSpPr/>
            <p:nvPr/>
          </p:nvSpPr>
          <p:spPr>
            <a:xfrm>
              <a:off x="1680444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11" name="pl266"/>
            <p:cNvSpPr/>
            <p:nvPr/>
          </p:nvSpPr>
          <p:spPr>
            <a:xfrm>
              <a:off x="1688220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12" name="pl267"/>
            <p:cNvSpPr/>
            <p:nvPr/>
          </p:nvSpPr>
          <p:spPr>
            <a:xfrm>
              <a:off x="1695960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13" name="pl268"/>
            <p:cNvSpPr/>
            <p:nvPr/>
          </p:nvSpPr>
          <p:spPr>
            <a:xfrm>
              <a:off x="1703736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14" name="pl269"/>
            <p:cNvSpPr/>
            <p:nvPr/>
          </p:nvSpPr>
          <p:spPr>
            <a:xfrm>
              <a:off x="1711512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15" name="pl270"/>
            <p:cNvSpPr/>
            <p:nvPr/>
          </p:nvSpPr>
          <p:spPr>
            <a:xfrm>
              <a:off x="1719252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16" name="pl271"/>
            <p:cNvSpPr/>
            <p:nvPr/>
          </p:nvSpPr>
          <p:spPr>
            <a:xfrm>
              <a:off x="1727028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17" name="pl272"/>
            <p:cNvSpPr/>
            <p:nvPr/>
          </p:nvSpPr>
          <p:spPr>
            <a:xfrm>
              <a:off x="1734768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18" name="pl273"/>
            <p:cNvSpPr/>
            <p:nvPr/>
          </p:nvSpPr>
          <p:spPr>
            <a:xfrm>
              <a:off x="1742544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19" name="pl274"/>
            <p:cNvSpPr/>
            <p:nvPr/>
          </p:nvSpPr>
          <p:spPr>
            <a:xfrm>
              <a:off x="17503200" y="13022640"/>
              <a:ext cx="360" cy="23040"/>
            </a:xfrm>
            <a:custGeom>
              <a:avLst/>
              <a:gdLst/>
              <a:ahLst/>
              <a:rect l="l" t="t" r="r" b="b"/>
              <a:pathLst>
                <a:path w="1" h="22859">
                  <a:moveTo>
                    <a:pt x="0" y="0"/>
                  </a:moveTo>
                  <a:lnTo>
                    <a:pt x="0" y="22859"/>
                  </a:lnTo>
                </a:path>
              </a:pathLst>
            </a:custGeom>
            <a:noFill/>
            <a:ln cap="rnd" w="9360">
              <a:solidFill>
                <a:srgbClr val="000000"/>
              </a:solidFill>
              <a:round/>
            </a:ln>
          </p:spPr>
          <p:style>
            <a:lnRef idx="0"/>
            <a:fillRef idx="0"/>
            <a:effectRef idx="0"/>
            <a:fontRef idx="minor"/>
          </p:style>
          <p:txBody>
            <a:bodyPr lIns="90000" rIns="90000" tIns="-23760" bIns="-237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20" name="tx275"/>
            <p:cNvSpPr/>
            <p:nvPr/>
          </p:nvSpPr>
          <p:spPr>
            <a:xfrm>
              <a:off x="11216160" y="13721040"/>
              <a:ext cx="1247400" cy="11448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zh-CN" sz="1200" spc="-1" strike="noStrike">
                  <a:solidFill>
                    <a:srgbClr val="000000"/>
                  </a:solidFill>
                  <a:latin typeface="Arial"/>
                </a:rPr>
                <a:t>Risk of metastasis</a:t>
              </a:r>
              <a:endParaRPr b="0" lang="en-US" sz="1200" spc="-1" strike="noStrike">
                <a:solidFill>
                  <a:srgbClr val="000000"/>
                </a:solidFill>
                <a:latin typeface="Arial"/>
              </a:endParaRPr>
            </a:p>
          </p:txBody>
        </p:sp>
        <p:sp>
          <p:nvSpPr>
            <p:cNvPr id="921" name="pl276"/>
            <p:cNvSpPr/>
            <p:nvPr/>
          </p:nvSpPr>
          <p:spPr>
            <a:xfrm>
              <a:off x="12984840" y="1378008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22" name="pl277"/>
            <p:cNvSpPr/>
            <p:nvPr/>
          </p:nvSpPr>
          <p:spPr>
            <a:xfrm>
              <a:off x="12984840" y="1378008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923" name="tx278" descr=""/>
            <p:cNvPicPr/>
            <p:nvPr/>
          </p:nvPicPr>
          <p:blipFill>
            <a:blip r:embed="rId75"/>
            <a:stretch/>
          </p:blipFill>
          <p:spPr>
            <a:xfrm>
              <a:off x="12881160" y="13848480"/>
              <a:ext cx="208080" cy="145800"/>
            </a:xfrm>
            <a:prstGeom prst="rect">
              <a:avLst/>
            </a:prstGeom>
            <a:ln w="0">
              <a:noFill/>
            </a:ln>
          </p:spPr>
        </p:pic>
        <p:sp>
          <p:nvSpPr>
            <p:cNvPr id="924" name="pl279"/>
            <p:cNvSpPr/>
            <p:nvPr/>
          </p:nvSpPr>
          <p:spPr>
            <a:xfrm>
              <a:off x="13114080" y="1378008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25" name="pl280"/>
            <p:cNvSpPr/>
            <p:nvPr/>
          </p:nvSpPr>
          <p:spPr>
            <a:xfrm>
              <a:off x="13114080" y="1378008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26" name="tx281"/>
            <p:cNvSpPr/>
            <p:nvPr/>
          </p:nvSpPr>
          <p:spPr>
            <a:xfrm>
              <a:off x="13023720" y="13889160"/>
              <a:ext cx="180720" cy="9684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27" name="pl282"/>
            <p:cNvSpPr/>
            <p:nvPr/>
          </p:nvSpPr>
          <p:spPr>
            <a:xfrm>
              <a:off x="13219920" y="1378008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28" name="pl283"/>
            <p:cNvSpPr/>
            <p:nvPr/>
          </p:nvSpPr>
          <p:spPr>
            <a:xfrm>
              <a:off x="13219920" y="1378008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929" name="tx284" descr=""/>
            <p:cNvPicPr/>
            <p:nvPr/>
          </p:nvPicPr>
          <p:blipFill>
            <a:blip r:embed="rId76"/>
            <a:stretch/>
          </p:blipFill>
          <p:spPr>
            <a:xfrm>
              <a:off x="13116960" y="13848480"/>
              <a:ext cx="208080" cy="145800"/>
            </a:xfrm>
            <a:prstGeom prst="rect">
              <a:avLst/>
            </a:prstGeom>
            <a:ln w="0">
              <a:noFill/>
            </a:ln>
          </p:spPr>
        </p:pic>
        <p:sp>
          <p:nvSpPr>
            <p:cNvPr id="930" name="pl285"/>
            <p:cNvSpPr/>
            <p:nvPr/>
          </p:nvSpPr>
          <p:spPr>
            <a:xfrm>
              <a:off x="13317120" y="1378008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31" name="pl286"/>
            <p:cNvSpPr/>
            <p:nvPr/>
          </p:nvSpPr>
          <p:spPr>
            <a:xfrm>
              <a:off x="13317120" y="1378008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32" name="tx287"/>
            <p:cNvSpPr/>
            <p:nvPr/>
          </p:nvSpPr>
          <p:spPr>
            <a:xfrm>
              <a:off x="13227120" y="13889160"/>
              <a:ext cx="180720" cy="9684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33" name="pl288"/>
            <p:cNvSpPr/>
            <p:nvPr/>
          </p:nvSpPr>
          <p:spPr>
            <a:xfrm>
              <a:off x="13414320" y="1378008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34" name="pl289"/>
            <p:cNvSpPr/>
            <p:nvPr/>
          </p:nvSpPr>
          <p:spPr>
            <a:xfrm>
              <a:off x="13414320" y="1378008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935" name="tx290" descr=""/>
            <p:cNvPicPr/>
            <p:nvPr/>
          </p:nvPicPr>
          <p:blipFill>
            <a:blip r:embed="rId77"/>
            <a:stretch/>
          </p:blipFill>
          <p:spPr>
            <a:xfrm>
              <a:off x="13310640" y="13848480"/>
              <a:ext cx="208080" cy="145800"/>
            </a:xfrm>
            <a:prstGeom prst="rect">
              <a:avLst/>
            </a:prstGeom>
            <a:ln w="0">
              <a:noFill/>
            </a:ln>
          </p:spPr>
        </p:pic>
        <p:sp>
          <p:nvSpPr>
            <p:cNvPr id="936" name="pl291"/>
            <p:cNvSpPr/>
            <p:nvPr/>
          </p:nvSpPr>
          <p:spPr>
            <a:xfrm>
              <a:off x="13520160" y="1378008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37" name="pl292"/>
            <p:cNvSpPr/>
            <p:nvPr/>
          </p:nvSpPr>
          <p:spPr>
            <a:xfrm>
              <a:off x="13520160" y="1378008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38" name="tx293"/>
            <p:cNvSpPr/>
            <p:nvPr/>
          </p:nvSpPr>
          <p:spPr>
            <a:xfrm>
              <a:off x="13428720" y="13889160"/>
              <a:ext cx="182520" cy="9684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39" name="pl294"/>
            <p:cNvSpPr/>
            <p:nvPr/>
          </p:nvSpPr>
          <p:spPr>
            <a:xfrm>
              <a:off x="13649400" y="1378008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40" name="pl295"/>
            <p:cNvSpPr/>
            <p:nvPr/>
          </p:nvSpPr>
          <p:spPr>
            <a:xfrm>
              <a:off x="13649400" y="1378008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941" name="tx296" descr=""/>
            <p:cNvPicPr/>
            <p:nvPr/>
          </p:nvPicPr>
          <p:blipFill>
            <a:blip r:embed="rId78"/>
            <a:stretch/>
          </p:blipFill>
          <p:spPr>
            <a:xfrm>
              <a:off x="13546080" y="13848480"/>
              <a:ext cx="208080" cy="145800"/>
            </a:xfrm>
            <a:prstGeom prst="rect">
              <a:avLst/>
            </a:prstGeom>
            <a:ln w="0">
              <a:noFill/>
            </a:ln>
          </p:spPr>
        </p:pic>
        <p:sp>
          <p:nvSpPr>
            <p:cNvPr id="942" name="pl297"/>
            <p:cNvSpPr/>
            <p:nvPr/>
          </p:nvSpPr>
          <p:spPr>
            <a:xfrm>
              <a:off x="13843800" y="1378008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43" name="pl298"/>
            <p:cNvSpPr/>
            <p:nvPr/>
          </p:nvSpPr>
          <p:spPr>
            <a:xfrm>
              <a:off x="13843800" y="1378008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44" name="tx299"/>
            <p:cNvSpPr/>
            <p:nvPr/>
          </p:nvSpPr>
          <p:spPr>
            <a:xfrm>
              <a:off x="13752360" y="13889160"/>
              <a:ext cx="182520" cy="96840"/>
            </a:xfrm>
            <a:prstGeom prst="rect">
              <a:avLst/>
            </a:prstGeom>
            <a:noFill/>
            <a:ln w="0">
              <a:noFill/>
            </a:ln>
          </p:spPr>
          <p:style>
            <a:lnRef idx="0"/>
            <a:fillRef idx="0"/>
            <a:effectRef idx="0"/>
            <a:fontRef idx="minor"/>
          </p:style>
          <p:txBody>
            <a:bodyPr wrap="none" lIns="0" rIns="0" tIns="0" bIns="0" anchor="ctr" anchorCtr="1">
              <a:noAutofit/>
            </a:bodyPr>
            <a:p>
              <a:pPr>
                <a:lnSpc>
                  <a:spcPts val="1023"/>
                </a:lnSpc>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45" name="pl300"/>
            <p:cNvSpPr/>
            <p:nvPr/>
          </p:nvSpPr>
          <p:spPr>
            <a:xfrm>
              <a:off x="14022720" y="1378008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46" name="pl301"/>
            <p:cNvSpPr/>
            <p:nvPr/>
          </p:nvSpPr>
          <p:spPr>
            <a:xfrm>
              <a:off x="14022720" y="1378008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947" name="tx302" descr=""/>
            <p:cNvPicPr/>
            <p:nvPr/>
          </p:nvPicPr>
          <p:blipFill>
            <a:blip r:embed="rId79"/>
            <a:stretch/>
          </p:blipFill>
          <p:spPr>
            <a:xfrm>
              <a:off x="13883400" y="13848480"/>
              <a:ext cx="279720" cy="145800"/>
            </a:xfrm>
            <a:prstGeom prst="rect">
              <a:avLst/>
            </a:prstGeom>
            <a:ln w="0">
              <a:noFill/>
            </a:ln>
          </p:spPr>
        </p:pic>
        <p:sp>
          <p:nvSpPr>
            <p:cNvPr id="948" name="pl303"/>
            <p:cNvSpPr/>
            <p:nvPr/>
          </p:nvSpPr>
          <p:spPr>
            <a:xfrm>
              <a:off x="14418360" y="1378008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49" name="pl304"/>
            <p:cNvSpPr/>
            <p:nvPr/>
          </p:nvSpPr>
          <p:spPr>
            <a:xfrm>
              <a:off x="14418360" y="1378008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950" name="tx305" descr=""/>
            <p:cNvPicPr/>
            <p:nvPr/>
          </p:nvPicPr>
          <p:blipFill>
            <a:blip r:embed="rId80"/>
            <a:stretch/>
          </p:blipFill>
          <p:spPr>
            <a:xfrm>
              <a:off x="14278680" y="13848480"/>
              <a:ext cx="279720" cy="145800"/>
            </a:xfrm>
            <a:prstGeom prst="rect">
              <a:avLst/>
            </a:prstGeom>
            <a:ln w="0">
              <a:noFill/>
            </a:ln>
          </p:spPr>
        </p:pic>
        <p:sp>
          <p:nvSpPr>
            <p:cNvPr id="951" name="pl306"/>
            <p:cNvSpPr/>
            <p:nvPr/>
          </p:nvSpPr>
          <p:spPr>
            <a:xfrm>
              <a:off x="14972400" y="13780080"/>
              <a:ext cx="360" cy="360"/>
            </a:xfrm>
            <a:custGeom>
              <a:avLst/>
              <a:gdLst/>
              <a:ahLst/>
              <a:rect l="l" t="t" r="r" b="b"/>
              <a:pathLst>
                <a:path w="0" h="0">
                  <a:moveTo>
                    <a:pt x="0"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52" name="pl307"/>
            <p:cNvSpPr/>
            <p:nvPr/>
          </p:nvSpPr>
          <p:spPr>
            <a:xfrm>
              <a:off x="14972400" y="13780080"/>
              <a:ext cx="360" cy="46440"/>
            </a:xfrm>
            <a:custGeom>
              <a:avLst/>
              <a:gdLst/>
              <a:ahLst/>
              <a:rect l="l" t="t" r="r" b="b"/>
              <a:pathLst>
                <a:path w="1" h="45720">
                  <a:moveTo>
                    <a:pt x="0" y="0"/>
                  </a:moveTo>
                  <a:lnTo>
                    <a:pt x="0" y="45720"/>
                  </a:lnTo>
                </a:path>
              </a:pathLst>
            </a:custGeom>
            <a:noFill/>
            <a:ln cap="rnd" w="9360">
              <a:solidFill>
                <a:srgbClr val="000000"/>
              </a:solidFill>
              <a:round/>
            </a:ln>
          </p:spPr>
          <p:style>
            <a:lnRef idx="0"/>
            <a:fillRef idx="0"/>
            <a:effectRef idx="0"/>
            <a:fontRef idx="minor"/>
          </p:style>
          <p:txBody>
            <a:bodyPr lIns="90000" rIns="90000" tIns="-360" bIns="-3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953" name="tx308" descr=""/>
            <p:cNvPicPr/>
            <p:nvPr/>
          </p:nvPicPr>
          <p:blipFill>
            <a:blip r:embed="rId81"/>
            <a:stretch/>
          </p:blipFill>
          <p:spPr>
            <a:xfrm>
              <a:off x="14797080" y="13848480"/>
              <a:ext cx="351720" cy="145800"/>
            </a:xfrm>
            <a:prstGeom prst="rect">
              <a:avLst/>
            </a:prstGeom>
            <a:ln w="0">
              <a:noFill/>
            </a:ln>
          </p:spPr>
        </p:pic>
        <p:sp>
          <p:nvSpPr>
            <p:cNvPr id="954" name="pl309"/>
            <p:cNvSpPr/>
            <p:nvPr/>
          </p:nvSpPr>
          <p:spPr>
            <a:xfrm>
              <a:off x="12984840" y="13780080"/>
              <a:ext cx="1987200" cy="360"/>
            </a:xfrm>
            <a:custGeom>
              <a:avLst/>
              <a:gdLst/>
              <a:ahLst/>
              <a:rect l="l" t="t" r="r" b="b"/>
              <a:pathLst>
                <a:path w="1969995" h="1">
                  <a:moveTo>
                    <a:pt x="0" y="0"/>
                  </a:moveTo>
                  <a:lnTo>
                    <a:pt x="1969995"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grpSp>
      <p:sp>
        <p:nvSpPr>
          <p:cNvPr id="955" name="文本框 3591"/>
          <p:cNvSpPr/>
          <p:nvPr/>
        </p:nvSpPr>
        <p:spPr>
          <a:xfrm>
            <a:off x="689040" y="343080"/>
            <a:ext cx="2152440" cy="55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1487520"/>
                <a:tab algn="l" pos="2975040"/>
                <a:tab algn="l" pos="4462560"/>
                <a:tab algn="l" pos="5950080"/>
                <a:tab algn="l" pos="7437600"/>
                <a:tab algn="l" pos="8924760"/>
                <a:tab algn="l" pos="10412280"/>
              </a:tabLst>
            </a:pPr>
            <a:r>
              <a:rPr b="1" lang="en-US" sz="3000" spc="-1" strike="noStrike">
                <a:solidFill>
                  <a:srgbClr val="000000"/>
                </a:solidFill>
                <a:latin typeface="Times New Roman"/>
              </a:rPr>
              <a:t>Fig.S4</a:t>
            </a:r>
            <a:endParaRPr b="0" lang="en-US" sz="3000" spc="-1" strike="noStrike">
              <a:solidFill>
                <a:srgbClr val="000000"/>
              </a:solidFill>
              <a:latin typeface="Arial"/>
            </a:endParaRPr>
          </a:p>
        </p:txBody>
      </p:sp>
      <p:sp>
        <p:nvSpPr>
          <p:cNvPr id="956" name="文本框 1251"/>
          <p:cNvSpPr/>
          <p:nvPr/>
        </p:nvSpPr>
        <p:spPr>
          <a:xfrm>
            <a:off x="5261040" y="7407360"/>
            <a:ext cx="36720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1487520"/>
                <a:tab algn="l" pos="2975040"/>
                <a:tab algn="l" pos="4462560"/>
                <a:tab algn="l" pos="5950080"/>
                <a:tab algn="l" pos="7437600"/>
                <a:tab algn="l" pos="8924760"/>
                <a:tab algn="l" pos="10412280"/>
              </a:tabLst>
            </a:pPr>
            <a:r>
              <a:rPr b="0" lang="en-US" sz="1800" spc="-1" strike="noStrike">
                <a:solidFill>
                  <a:srgbClr val="000000"/>
                </a:solidFill>
                <a:latin typeface="Times New Roman"/>
              </a:rPr>
              <a:t>1se nomogram   </a:t>
            </a:r>
            <a:endParaRPr b="0" lang="en-US" sz="1800" spc="-1" strike="noStrike">
              <a:solidFill>
                <a:srgbClr val="000000"/>
              </a:solidFill>
              <a:latin typeface="Arial"/>
            </a:endParaRPr>
          </a:p>
        </p:txBody>
      </p:sp>
      <p:sp>
        <p:nvSpPr>
          <p:cNvPr id="957" name="文本框 1252"/>
          <p:cNvSpPr/>
          <p:nvPr/>
        </p:nvSpPr>
        <p:spPr>
          <a:xfrm>
            <a:off x="12930120" y="7472520"/>
            <a:ext cx="36720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1487520"/>
                <a:tab algn="l" pos="2975040"/>
                <a:tab algn="l" pos="4462560"/>
                <a:tab algn="l" pos="5950080"/>
                <a:tab algn="l" pos="7437600"/>
                <a:tab algn="l" pos="8924760"/>
                <a:tab algn="l" pos="10412280"/>
              </a:tabLst>
            </a:pPr>
            <a:r>
              <a:rPr b="0" lang="en-US" sz="1800" spc="-1" strike="noStrike">
                <a:solidFill>
                  <a:srgbClr val="000000"/>
                </a:solidFill>
                <a:latin typeface="Times New Roman"/>
              </a:rPr>
              <a:t>min nomogram  </a:t>
            </a:r>
            <a:endParaRPr b="0" lang="en-US" sz="1800" spc="-1" strike="noStrike">
              <a:solidFill>
                <a:srgbClr val="000000"/>
              </a:solidFill>
              <a:latin typeface="Arial"/>
            </a:endParaRPr>
          </a:p>
        </p:txBody>
      </p:sp>
      <p:sp>
        <p:nvSpPr>
          <p:cNvPr id="958" name="文本框 1255"/>
          <p:cNvSpPr/>
          <p:nvPr/>
        </p:nvSpPr>
        <p:spPr>
          <a:xfrm>
            <a:off x="2595600" y="7223040"/>
            <a:ext cx="939600" cy="55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1487520"/>
                <a:tab algn="l" pos="2975040"/>
                <a:tab algn="l" pos="4462560"/>
                <a:tab algn="l" pos="5950080"/>
                <a:tab algn="l" pos="7437600"/>
                <a:tab algn="l" pos="8924760"/>
                <a:tab algn="l" pos="10412280"/>
              </a:tabLst>
            </a:pPr>
            <a:r>
              <a:rPr b="1" lang="en-US" sz="3000" spc="-1" strike="noStrike">
                <a:solidFill>
                  <a:srgbClr val="000000"/>
                </a:solidFill>
                <a:latin typeface="Times New Roman"/>
              </a:rPr>
              <a:t>C</a:t>
            </a:r>
            <a:endParaRPr b="0" lang="en-US" sz="3000" spc="-1" strike="noStrike">
              <a:solidFill>
                <a:srgbClr val="000000"/>
              </a:solidFill>
              <a:latin typeface="Arial"/>
            </a:endParaRPr>
          </a:p>
        </p:txBody>
      </p:sp>
      <p:sp>
        <p:nvSpPr>
          <p:cNvPr id="959" name="文本框 1256"/>
          <p:cNvSpPr/>
          <p:nvPr/>
        </p:nvSpPr>
        <p:spPr>
          <a:xfrm>
            <a:off x="10551960" y="7223040"/>
            <a:ext cx="939960" cy="55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1487520"/>
                <a:tab algn="l" pos="2975040"/>
                <a:tab algn="l" pos="4462560"/>
                <a:tab algn="l" pos="5950080"/>
                <a:tab algn="l" pos="7437600"/>
                <a:tab algn="l" pos="8924760"/>
                <a:tab algn="l" pos="10412280"/>
              </a:tabLst>
            </a:pPr>
            <a:r>
              <a:rPr b="1" lang="en-US" sz="3000" spc="-1" strike="noStrike">
                <a:solidFill>
                  <a:srgbClr val="000000"/>
                </a:solidFill>
                <a:latin typeface="Times New Roman"/>
              </a:rPr>
              <a:t>D</a:t>
            </a:r>
            <a:endParaRPr b="0" lang="en-US" sz="3000" spc="-1" strike="noStrike">
              <a:solidFill>
                <a:srgbClr val="000000"/>
              </a:solidFill>
              <a:latin typeface="Arial"/>
            </a:endParaRPr>
          </a:p>
        </p:txBody>
      </p:sp>
      <p:sp>
        <p:nvSpPr>
          <p:cNvPr id="960" name="文本框 60"/>
          <p:cNvSpPr/>
          <p:nvPr/>
        </p:nvSpPr>
        <p:spPr>
          <a:xfrm>
            <a:off x="2917800" y="100080"/>
            <a:ext cx="919080" cy="55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1487520"/>
                <a:tab algn="l" pos="2975040"/>
                <a:tab algn="l" pos="4462560"/>
                <a:tab algn="l" pos="5950080"/>
                <a:tab algn="l" pos="7437600"/>
                <a:tab algn="l" pos="8924760"/>
                <a:tab algn="l" pos="10412280"/>
              </a:tabLst>
            </a:pPr>
            <a:r>
              <a:rPr b="1" lang="en-US" sz="3000" spc="-1" strike="noStrike">
                <a:solidFill>
                  <a:srgbClr val="000000"/>
                </a:solidFill>
                <a:latin typeface="Times New Roman"/>
              </a:rPr>
              <a:t>A</a:t>
            </a:r>
            <a:endParaRPr b="0" lang="en-US" sz="3000" spc="-1" strike="noStrike">
              <a:solidFill>
                <a:srgbClr val="000000"/>
              </a:solidFill>
              <a:latin typeface="Arial"/>
            </a:endParaRPr>
          </a:p>
        </p:txBody>
      </p:sp>
      <p:sp>
        <p:nvSpPr>
          <p:cNvPr id="961" name="文本框 61"/>
          <p:cNvSpPr/>
          <p:nvPr/>
        </p:nvSpPr>
        <p:spPr>
          <a:xfrm>
            <a:off x="5803920" y="352440"/>
            <a:ext cx="271620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1487520"/>
                <a:tab algn="l" pos="2975040"/>
                <a:tab algn="l" pos="4462560"/>
                <a:tab algn="l" pos="5950080"/>
                <a:tab algn="l" pos="7437600"/>
                <a:tab algn="l" pos="8924760"/>
                <a:tab algn="l" pos="10412280"/>
              </a:tabLst>
            </a:pPr>
            <a:r>
              <a:rPr b="0" lang="en-US" sz="1800" spc="-1" strike="noStrike">
                <a:solidFill>
                  <a:srgbClr val="000000"/>
                </a:solidFill>
                <a:latin typeface="Times New Roman"/>
              </a:rPr>
              <a:t>Internal test cohort </a:t>
            </a:r>
            <a:endParaRPr b="0" lang="en-US" sz="1800" spc="-1" strike="noStrike">
              <a:solidFill>
                <a:srgbClr val="000000"/>
              </a:solidFill>
              <a:latin typeface="Arial"/>
            </a:endParaRPr>
          </a:p>
        </p:txBody>
      </p:sp>
      <p:sp>
        <p:nvSpPr>
          <p:cNvPr id="962" name="文本框 122"/>
          <p:cNvSpPr/>
          <p:nvPr/>
        </p:nvSpPr>
        <p:spPr>
          <a:xfrm>
            <a:off x="10875960" y="103320"/>
            <a:ext cx="917640" cy="55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1487520"/>
                <a:tab algn="l" pos="2975040"/>
                <a:tab algn="l" pos="4462560"/>
                <a:tab algn="l" pos="5950080"/>
                <a:tab algn="l" pos="7437600"/>
                <a:tab algn="l" pos="8924760"/>
                <a:tab algn="l" pos="10412280"/>
              </a:tabLst>
            </a:pPr>
            <a:r>
              <a:rPr b="1" lang="en-US" sz="3000" spc="-1" strike="noStrike">
                <a:solidFill>
                  <a:srgbClr val="000000"/>
                </a:solidFill>
                <a:latin typeface="Times New Roman"/>
              </a:rPr>
              <a:t>B</a:t>
            </a:r>
            <a:endParaRPr b="0" lang="en-US" sz="3000" spc="-1" strike="noStrike">
              <a:solidFill>
                <a:srgbClr val="000000"/>
              </a:solidFill>
              <a:latin typeface="Arial"/>
            </a:endParaRPr>
          </a:p>
        </p:txBody>
      </p:sp>
      <p:sp>
        <p:nvSpPr>
          <p:cNvPr id="963" name="rc3"/>
          <p:cNvSpPr/>
          <p:nvPr/>
        </p:nvSpPr>
        <p:spPr>
          <a:xfrm>
            <a:off x="2840040" y="696960"/>
            <a:ext cx="7315200" cy="6383160"/>
          </a:xfrm>
          <a:prstGeom prst="rect">
            <a:avLst/>
          </a:prstGeom>
          <a:solidFill>
            <a:srgbClr val="ffffff"/>
          </a:solidFill>
          <a:ln cap="rnd" w="9360">
            <a:solidFill>
              <a:srgbClr val="ffffff"/>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64" name="rc4"/>
          <p:cNvSpPr/>
          <p:nvPr/>
        </p:nvSpPr>
        <p:spPr>
          <a:xfrm>
            <a:off x="2840040" y="696960"/>
            <a:ext cx="7315200" cy="6383160"/>
          </a:xfrm>
          <a:prstGeom prst="rect">
            <a:avLst/>
          </a:prstGeom>
          <a:solidFill>
            <a:srgbClr val="ffffff"/>
          </a:solidFill>
          <a:ln cap="rnd" w="13680">
            <a:solidFill>
              <a:srgbClr val="ffffff"/>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65" name="rc5"/>
          <p:cNvSpPr/>
          <p:nvPr/>
        </p:nvSpPr>
        <p:spPr>
          <a:xfrm>
            <a:off x="3995640" y="947880"/>
            <a:ext cx="5872320" cy="535608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66" name="pl6"/>
          <p:cNvSpPr/>
          <p:nvPr/>
        </p:nvSpPr>
        <p:spPr>
          <a:xfrm>
            <a:off x="3995640" y="5451480"/>
            <a:ext cx="5872320" cy="360"/>
          </a:xfrm>
          <a:custGeom>
            <a:avLst/>
            <a:gdLst/>
            <a:ahLst/>
            <a:rect l="l" t="t" r="r" b="b"/>
            <a:pathLst>
              <a:path w="5872085" h="1">
                <a:moveTo>
                  <a:pt x="0" y="0"/>
                </a:moveTo>
                <a:lnTo>
                  <a:pt x="5872085" y="0"/>
                </a:lnTo>
              </a:path>
            </a:pathLst>
          </a:custGeom>
          <a:noFill/>
          <a:ln w="684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67" name="pl7"/>
          <p:cNvSpPr/>
          <p:nvPr/>
        </p:nvSpPr>
        <p:spPr>
          <a:xfrm>
            <a:off x="3995640" y="4233960"/>
            <a:ext cx="5872320" cy="360"/>
          </a:xfrm>
          <a:custGeom>
            <a:avLst/>
            <a:gdLst/>
            <a:ahLst/>
            <a:rect l="l" t="t" r="r" b="b"/>
            <a:pathLst>
              <a:path w="5872085" h="1">
                <a:moveTo>
                  <a:pt x="0" y="0"/>
                </a:moveTo>
                <a:lnTo>
                  <a:pt x="5872085" y="0"/>
                </a:lnTo>
              </a:path>
            </a:pathLst>
          </a:custGeom>
          <a:noFill/>
          <a:ln w="684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68" name="pl8"/>
          <p:cNvSpPr/>
          <p:nvPr/>
        </p:nvSpPr>
        <p:spPr>
          <a:xfrm>
            <a:off x="3995640" y="3017880"/>
            <a:ext cx="5872320" cy="360"/>
          </a:xfrm>
          <a:custGeom>
            <a:avLst/>
            <a:gdLst/>
            <a:ahLst/>
            <a:rect l="l" t="t" r="r" b="b"/>
            <a:pathLst>
              <a:path w="5872085" h="1">
                <a:moveTo>
                  <a:pt x="0" y="0"/>
                </a:moveTo>
                <a:lnTo>
                  <a:pt x="5872085" y="0"/>
                </a:lnTo>
              </a:path>
            </a:pathLst>
          </a:custGeom>
          <a:noFill/>
          <a:ln w="684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69" name="pl9"/>
          <p:cNvSpPr/>
          <p:nvPr/>
        </p:nvSpPr>
        <p:spPr>
          <a:xfrm>
            <a:off x="3995640" y="1800360"/>
            <a:ext cx="5872320" cy="360"/>
          </a:xfrm>
          <a:custGeom>
            <a:avLst/>
            <a:gdLst/>
            <a:ahLst/>
            <a:rect l="l" t="t" r="r" b="b"/>
            <a:pathLst>
              <a:path w="5872085" h="1">
                <a:moveTo>
                  <a:pt x="0" y="0"/>
                </a:moveTo>
                <a:lnTo>
                  <a:pt x="5872085" y="0"/>
                </a:lnTo>
              </a:path>
            </a:pathLst>
          </a:custGeom>
          <a:noFill/>
          <a:ln w="684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70" name="pl10"/>
          <p:cNvSpPr/>
          <p:nvPr/>
        </p:nvSpPr>
        <p:spPr>
          <a:xfrm>
            <a:off x="8933040" y="947880"/>
            <a:ext cx="360" cy="5356080"/>
          </a:xfrm>
          <a:custGeom>
            <a:avLst/>
            <a:gdLst/>
            <a:ahLst/>
            <a:rect l="l" t="t" r="r" b="b"/>
            <a:pathLst>
              <a:path w="1" h="6136999">
                <a:moveTo>
                  <a:pt x="0" y="6136999"/>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71" name="pl11"/>
          <p:cNvSpPr/>
          <p:nvPr/>
        </p:nvSpPr>
        <p:spPr>
          <a:xfrm>
            <a:off x="7597800" y="947880"/>
            <a:ext cx="360" cy="5356080"/>
          </a:xfrm>
          <a:custGeom>
            <a:avLst/>
            <a:gdLst/>
            <a:ahLst/>
            <a:rect l="l" t="t" r="r" b="b"/>
            <a:pathLst>
              <a:path w="1" h="6136999">
                <a:moveTo>
                  <a:pt x="0" y="6136999"/>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72" name="pl12"/>
          <p:cNvSpPr/>
          <p:nvPr/>
        </p:nvSpPr>
        <p:spPr>
          <a:xfrm>
            <a:off x="6264360" y="947880"/>
            <a:ext cx="360" cy="5356080"/>
          </a:xfrm>
          <a:custGeom>
            <a:avLst/>
            <a:gdLst/>
            <a:ahLst/>
            <a:rect l="l" t="t" r="r" b="b"/>
            <a:pathLst>
              <a:path w="1" h="6136999">
                <a:moveTo>
                  <a:pt x="0" y="6136999"/>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73" name="pl13"/>
          <p:cNvSpPr/>
          <p:nvPr/>
        </p:nvSpPr>
        <p:spPr>
          <a:xfrm>
            <a:off x="4929120" y="947880"/>
            <a:ext cx="360" cy="5356080"/>
          </a:xfrm>
          <a:custGeom>
            <a:avLst/>
            <a:gdLst/>
            <a:ahLst/>
            <a:rect l="l" t="t" r="r" b="b"/>
            <a:pathLst>
              <a:path w="1" h="6136999">
                <a:moveTo>
                  <a:pt x="0" y="6136999"/>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74" name="pl14"/>
          <p:cNvSpPr/>
          <p:nvPr/>
        </p:nvSpPr>
        <p:spPr>
          <a:xfrm>
            <a:off x="3995640" y="6059520"/>
            <a:ext cx="5872320" cy="360"/>
          </a:xfrm>
          <a:custGeom>
            <a:avLst/>
            <a:gdLst/>
            <a:ahLst/>
            <a:rect l="l" t="t" r="r" b="b"/>
            <a:pathLst>
              <a:path w="5872085" h="1">
                <a:moveTo>
                  <a:pt x="0" y="0"/>
                </a:moveTo>
                <a:lnTo>
                  <a:pt x="5872085"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75" name="pl15"/>
          <p:cNvSpPr/>
          <p:nvPr/>
        </p:nvSpPr>
        <p:spPr>
          <a:xfrm>
            <a:off x="3995640" y="4843440"/>
            <a:ext cx="5872320" cy="360"/>
          </a:xfrm>
          <a:custGeom>
            <a:avLst/>
            <a:gdLst/>
            <a:ahLst/>
            <a:rect l="l" t="t" r="r" b="b"/>
            <a:pathLst>
              <a:path w="5872085" h="1">
                <a:moveTo>
                  <a:pt x="0" y="0"/>
                </a:moveTo>
                <a:lnTo>
                  <a:pt x="5872085"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76" name="pl16"/>
          <p:cNvSpPr/>
          <p:nvPr/>
        </p:nvSpPr>
        <p:spPr>
          <a:xfrm>
            <a:off x="3995640" y="3625920"/>
            <a:ext cx="5872320" cy="360"/>
          </a:xfrm>
          <a:custGeom>
            <a:avLst/>
            <a:gdLst/>
            <a:ahLst/>
            <a:rect l="l" t="t" r="r" b="b"/>
            <a:pathLst>
              <a:path w="5872085" h="1">
                <a:moveTo>
                  <a:pt x="0" y="0"/>
                </a:moveTo>
                <a:lnTo>
                  <a:pt x="5872085"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77" name="pl17"/>
          <p:cNvSpPr/>
          <p:nvPr/>
        </p:nvSpPr>
        <p:spPr>
          <a:xfrm>
            <a:off x="3995640" y="2408400"/>
            <a:ext cx="5872320" cy="360"/>
          </a:xfrm>
          <a:custGeom>
            <a:avLst/>
            <a:gdLst/>
            <a:ahLst/>
            <a:rect l="l" t="t" r="r" b="b"/>
            <a:pathLst>
              <a:path w="5872085" h="1">
                <a:moveTo>
                  <a:pt x="0" y="0"/>
                </a:moveTo>
                <a:lnTo>
                  <a:pt x="5872085"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78" name="pl18"/>
          <p:cNvSpPr/>
          <p:nvPr/>
        </p:nvSpPr>
        <p:spPr>
          <a:xfrm>
            <a:off x="3995640" y="1192320"/>
            <a:ext cx="5872320" cy="360"/>
          </a:xfrm>
          <a:custGeom>
            <a:avLst/>
            <a:gdLst/>
            <a:ahLst/>
            <a:rect l="l" t="t" r="r" b="b"/>
            <a:pathLst>
              <a:path w="5872085" h="1">
                <a:moveTo>
                  <a:pt x="0" y="0"/>
                </a:moveTo>
                <a:lnTo>
                  <a:pt x="5872085"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79" name="pl19"/>
          <p:cNvSpPr/>
          <p:nvPr/>
        </p:nvSpPr>
        <p:spPr>
          <a:xfrm>
            <a:off x="9599760" y="947880"/>
            <a:ext cx="360" cy="5356080"/>
          </a:xfrm>
          <a:custGeom>
            <a:avLst/>
            <a:gdLst/>
            <a:ahLst/>
            <a:rect l="l" t="t" r="r" b="b"/>
            <a:pathLst>
              <a:path w="1" h="6136999">
                <a:moveTo>
                  <a:pt x="0" y="6136999"/>
                </a:moveTo>
                <a:lnTo>
                  <a:pt x="0" y="0"/>
                </a:lnTo>
              </a:path>
            </a:pathLst>
          </a:custGeom>
          <a:noFill/>
          <a:ln w="1368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80" name="pl20"/>
          <p:cNvSpPr/>
          <p:nvPr/>
        </p:nvSpPr>
        <p:spPr>
          <a:xfrm>
            <a:off x="8265960" y="947880"/>
            <a:ext cx="360" cy="5356080"/>
          </a:xfrm>
          <a:custGeom>
            <a:avLst/>
            <a:gdLst/>
            <a:ahLst/>
            <a:rect l="l" t="t" r="r" b="b"/>
            <a:pathLst>
              <a:path w="1" h="6136999">
                <a:moveTo>
                  <a:pt x="0" y="6136999"/>
                </a:moveTo>
                <a:lnTo>
                  <a:pt x="0" y="0"/>
                </a:lnTo>
              </a:path>
            </a:pathLst>
          </a:custGeom>
          <a:noFill/>
          <a:ln w="1368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81" name="pl21"/>
          <p:cNvSpPr/>
          <p:nvPr/>
        </p:nvSpPr>
        <p:spPr>
          <a:xfrm>
            <a:off x="6931080" y="947880"/>
            <a:ext cx="360" cy="5356080"/>
          </a:xfrm>
          <a:custGeom>
            <a:avLst/>
            <a:gdLst/>
            <a:ahLst/>
            <a:rect l="l" t="t" r="r" b="b"/>
            <a:pathLst>
              <a:path w="1" h="6136999">
                <a:moveTo>
                  <a:pt x="0" y="6136999"/>
                </a:moveTo>
                <a:lnTo>
                  <a:pt x="0" y="0"/>
                </a:lnTo>
              </a:path>
            </a:pathLst>
          </a:custGeom>
          <a:noFill/>
          <a:ln w="1368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82" name="pl22"/>
          <p:cNvSpPr/>
          <p:nvPr/>
        </p:nvSpPr>
        <p:spPr>
          <a:xfrm>
            <a:off x="5595840" y="947880"/>
            <a:ext cx="360" cy="5356080"/>
          </a:xfrm>
          <a:custGeom>
            <a:avLst/>
            <a:gdLst/>
            <a:ahLst/>
            <a:rect l="l" t="t" r="r" b="b"/>
            <a:pathLst>
              <a:path w="1" h="6136999">
                <a:moveTo>
                  <a:pt x="0" y="6136999"/>
                </a:moveTo>
                <a:lnTo>
                  <a:pt x="0" y="0"/>
                </a:lnTo>
              </a:path>
            </a:pathLst>
          </a:custGeom>
          <a:noFill/>
          <a:ln w="1368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83" name="pl23"/>
          <p:cNvSpPr/>
          <p:nvPr/>
        </p:nvSpPr>
        <p:spPr>
          <a:xfrm>
            <a:off x="4262400" y="947880"/>
            <a:ext cx="360" cy="5356080"/>
          </a:xfrm>
          <a:custGeom>
            <a:avLst/>
            <a:gdLst/>
            <a:ahLst/>
            <a:rect l="l" t="t" r="r" b="b"/>
            <a:pathLst>
              <a:path w="1" h="6136999">
                <a:moveTo>
                  <a:pt x="0" y="6136999"/>
                </a:moveTo>
                <a:lnTo>
                  <a:pt x="0" y="0"/>
                </a:lnTo>
              </a:path>
            </a:pathLst>
          </a:custGeom>
          <a:noFill/>
          <a:ln w="1368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84" name="pl24"/>
          <p:cNvSpPr/>
          <p:nvPr/>
        </p:nvSpPr>
        <p:spPr>
          <a:xfrm>
            <a:off x="4262400" y="1192320"/>
            <a:ext cx="5337360" cy="4867200"/>
          </a:xfrm>
          <a:custGeom>
            <a:avLst/>
            <a:gdLst/>
            <a:ahLst/>
            <a:rect l="l" t="t" r="r" b="b"/>
            <a:pathLst>
              <a:path w="5338259" h="5579090">
                <a:moveTo>
                  <a:pt x="0" y="5579090"/>
                </a:moveTo>
                <a:lnTo>
                  <a:pt x="232098" y="4628109"/>
                </a:lnTo>
                <a:lnTo>
                  <a:pt x="928393" y="2662747"/>
                </a:lnTo>
                <a:lnTo>
                  <a:pt x="1392589" y="2282355"/>
                </a:lnTo>
                <a:lnTo>
                  <a:pt x="2042464" y="1965361"/>
                </a:lnTo>
                <a:lnTo>
                  <a:pt x="3527893" y="316993"/>
                </a:lnTo>
                <a:lnTo>
                  <a:pt x="5338259" y="0"/>
                </a:lnTo>
              </a:path>
            </a:pathLst>
          </a:custGeom>
          <a:noFill/>
          <a:ln w="13680">
            <a:solidFill>
              <a:srgbClr val="000000"/>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85" name="pl25"/>
          <p:cNvSpPr/>
          <p:nvPr/>
        </p:nvSpPr>
        <p:spPr>
          <a:xfrm>
            <a:off x="4262400" y="1192320"/>
            <a:ext cx="5337360" cy="4867200"/>
          </a:xfrm>
          <a:custGeom>
            <a:avLst/>
            <a:gdLst/>
            <a:ahLst/>
            <a:rect l="l" t="t" r="r" b="b"/>
            <a:pathLst>
              <a:path w="5338259" h="5579090">
                <a:moveTo>
                  <a:pt x="0" y="5579090"/>
                </a:moveTo>
                <a:lnTo>
                  <a:pt x="0" y="5515692"/>
                </a:lnTo>
                <a:lnTo>
                  <a:pt x="0" y="5452293"/>
                </a:lnTo>
                <a:lnTo>
                  <a:pt x="0" y="5388894"/>
                </a:lnTo>
                <a:lnTo>
                  <a:pt x="0" y="5325495"/>
                </a:lnTo>
                <a:lnTo>
                  <a:pt x="0" y="5262097"/>
                </a:lnTo>
                <a:lnTo>
                  <a:pt x="0" y="5198698"/>
                </a:lnTo>
                <a:lnTo>
                  <a:pt x="46419" y="5198698"/>
                </a:lnTo>
                <a:lnTo>
                  <a:pt x="46419" y="5135299"/>
                </a:lnTo>
                <a:lnTo>
                  <a:pt x="46419" y="5071900"/>
                </a:lnTo>
                <a:lnTo>
                  <a:pt x="46419" y="5008502"/>
                </a:lnTo>
                <a:lnTo>
                  <a:pt x="46419" y="4945103"/>
                </a:lnTo>
                <a:lnTo>
                  <a:pt x="46419" y="4881704"/>
                </a:lnTo>
                <a:lnTo>
                  <a:pt x="46419" y="4818305"/>
                </a:lnTo>
                <a:lnTo>
                  <a:pt x="92839" y="4818305"/>
                </a:lnTo>
                <a:lnTo>
                  <a:pt x="92839" y="4754906"/>
                </a:lnTo>
                <a:lnTo>
                  <a:pt x="92839" y="4691508"/>
                </a:lnTo>
                <a:lnTo>
                  <a:pt x="139258" y="4691508"/>
                </a:lnTo>
                <a:lnTo>
                  <a:pt x="139258" y="4628109"/>
                </a:lnTo>
                <a:lnTo>
                  <a:pt x="139258" y="4564710"/>
                </a:lnTo>
                <a:lnTo>
                  <a:pt x="139258" y="4501311"/>
                </a:lnTo>
                <a:lnTo>
                  <a:pt x="139258" y="4437913"/>
                </a:lnTo>
                <a:lnTo>
                  <a:pt x="185678" y="4437913"/>
                </a:lnTo>
                <a:lnTo>
                  <a:pt x="232098" y="4437913"/>
                </a:lnTo>
                <a:lnTo>
                  <a:pt x="232098" y="4374514"/>
                </a:lnTo>
                <a:lnTo>
                  <a:pt x="232098" y="4311115"/>
                </a:lnTo>
                <a:lnTo>
                  <a:pt x="232098" y="4247716"/>
                </a:lnTo>
                <a:lnTo>
                  <a:pt x="232098" y="4184318"/>
                </a:lnTo>
                <a:lnTo>
                  <a:pt x="232098" y="4120919"/>
                </a:lnTo>
                <a:lnTo>
                  <a:pt x="232098" y="4057520"/>
                </a:lnTo>
                <a:lnTo>
                  <a:pt x="278517" y="4057520"/>
                </a:lnTo>
                <a:lnTo>
                  <a:pt x="278517" y="3994121"/>
                </a:lnTo>
                <a:lnTo>
                  <a:pt x="278517" y="3930723"/>
                </a:lnTo>
                <a:lnTo>
                  <a:pt x="278517" y="3867324"/>
                </a:lnTo>
                <a:lnTo>
                  <a:pt x="324937" y="3867324"/>
                </a:lnTo>
                <a:lnTo>
                  <a:pt x="324937" y="3803925"/>
                </a:lnTo>
                <a:lnTo>
                  <a:pt x="324937" y="3740526"/>
                </a:lnTo>
                <a:lnTo>
                  <a:pt x="324937" y="3677128"/>
                </a:lnTo>
                <a:lnTo>
                  <a:pt x="324937" y="3613729"/>
                </a:lnTo>
                <a:lnTo>
                  <a:pt x="324937" y="3550330"/>
                </a:lnTo>
                <a:lnTo>
                  <a:pt x="371357" y="3550330"/>
                </a:lnTo>
                <a:lnTo>
                  <a:pt x="371357" y="3486931"/>
                </a:lnTo>
                <a:lnTo>
                  <a:pt x="417776" y="3486931"/>
                </a:lnTo>
                <a:lnTo>
                  <a:pt x="417776" y="3423533"/>
                </a:lnTo>
                <a:lnTo>
                  <a:pt x="464196" y="3423533"/>
                </a:lnTo>
                <a:lnTo>
                  <a:pt x="510616" y="3423533"/>
                </a:lnTo>
                <a:lnTo>
                  <a:pt x="557035" y="3423533"/>
                </a:lnTo>
                <a:lnTo>
                  <a:pt x="557035" y="3360134"/>
                </a:lnTo>
                <a:lnTo>
                  <a:pt x="557035" y="3296735"/>
                </a:lnTo>
                <a:lnTo>
                  <a:pt x="557035" y="3233336"/>
                </a:lnTo>
                <a:lnTo>
                  <a:pt x="603455" y="3233336"/>
                </a:lnTo>
                <a:lnTo>
                  <a:pt x="603455" y="3169937"/>
                </a:lnTo>
                <a:lnTo>
                  <a:pt x="649875" y="3169937"/>
                </a:lnTo>
                <a:lnTo>
                  <a:pt x="696294" y="3169937"/>
                </a:lnTo>
                <a:lnTo>
                  <a:pt x="696294" y="3106539"/>
                </a:lnTo>
                <a:lnTo>
                  <a:pt x="696294" y="3043140"/>
                </a:lnTo>
                <a:lnTo>
                  <a:pt x="742714" y="3043140"/>
                </a:lnTo>
                <a:lnTo>
                  <a:pt x="789134" y="3043140"/>
                </a:lnTo>
                <a:lnTo>
                  <a:pt x="789134" y="2979741"/>
                </a:lnTo>
                <a:lnTo>
                  <a:pt x="789134" y="2916342"/>
                </a:lnTo>
                <a:lnTo>
                  <a:pt x="789134" y="2852944"/>
                </a:lnTo>
                <a:lnTo>
                  <a:pt x="789134" y="2789545"/>
                </a:lnTo>
                <a:lnTo>
                  <a:pt x="789134" y="2726146"/>
                </a:lnTo>
                <a:lnTo>
                  <a:pt x="835553" y="2726146"/>
                </a:lnTo>
                <a:lnTo>
                  <a:pt x="881973" y="2726146"/>
                </a:lnTo>
                <a:lnTo>
                  <a:pt x="881973" y="2662747"/>
                </a:lnTo>
                <a:lnTo>
                  <a:pt x="928393" y="2662747"/>
                </a:lnTo>
                <a:lnTo>
                  <a:pt x="928393" y="2599349"/>
                </a:lnTo>
                <a:lnTo>
                  <a:pt x="974812" y="2599349"/>
                </a:lnTo>
                <a:lnTo>
                  <a:pt x="1021232" y="2599349"/>
                </a:lnTo>
                <a:lnTo>
                  <a:pt x="1021232" y="2535950"/>
                </a:lnTo>
                <a:lnTo>
                  <a:pt x="1021232" y="2472551"/>
                </a:lnTo>
                <a:lnTo>
                  <a:pt x="1021232" y="2409152"/>
                </a:lnTo>
                <a:lnTo>
                  <a:pt x="1067651" y="2409152"/>
                </a:lnTo>
                <a:lnTo>
                  <a:pt x="1114071" y="2409152"/>
                </a:lnTo>
                <a:lnTo>
                  <a:pt x="1114071" y="2345754"/>
                </a:lnTo>
                <a:lnTo>
                  <a:pt x="1114071" y="2282355"/>
                </a:lnTo>
                <a:lnTo>
                  <a:pt x="1160491" y="2282355"/>
                </a:lnTo>
                <a:lnTo>
                  <a:pt x="1206910" y="2282355"/>
                </a:lnTo>
                <a:lnTo>
                  <a:pt x="1253330" y="2282355"/>
                </a:lnTo>
                <a:lnTo>
                  <a:pt x="1299750" y="2282355"/>
                </a:lnTo>
                <a:lnTo>
                  <a:pt x="1346169" y="2282355"/>
                </a:lnTo>
                <a:lnTo>
                  <a:pt x="1392589" y="2282355"/>
                </a:lnTo>
                <a:lnTo>
                  <a:pt x="1439009" y="2282355"/>
                </a:lnTo>
                <a:lnTo>
                  <a:pt x="1439009" y="2218956"/>
                </a:lnTo>
                <a:lnTo>
                  <a:pt x="1439009" y="2155557"/>
                </a:lnTo>
                <a:lnTo>
                  <a:pt x="1439009" y="2092159"/>
                </a:lnTo>
                <a:lnTo>
                  <a:pt x="1485428" y="2092159"/>
                </a:lnTo>
                <a:lnTo>
                  <a:pt x="1531848" y="2092159"/>
                </a:lnTo>
                <a:lnTo>
                  <a:pt x="1531848" y="2028760"/>
                </a:lnTo>
                <a:lnTo>
                  <a:pt x="1578268" y="2028760"/>
                </a:lnTo>
                <a:lnTo>
                  <a:pt x="1578268" y="1965361"/>
                </a:lnTo>
                <a:lnTo>
                  <a:pt x="1578268" y="1901962"/>
                </a:lnTo>
                <a:lnTo>
                  <a:pt x="1624687" y="1901962"/>
                </a:lnTo>
                <a:lnTo>
                  <a:pt x="1624687" y="1838564"/>
                </a:lnTo>
                <a:lnTo>
                  <a:pt x="1624687" y="1775165"/>
                </a:lnTo>
                <a:lnTo>
                  <a:pt x="1671107" y="1775165"/>
                </a:lnTo>
                <a:lnTo>
                  <a:pt x="1717527" y="1775165"/>
                </a:lnTo>
                <a:lnTo>
                  <a:pt x="1763946" y="1775165"/>
                </a:lnTo>
                <a:lnTo>
                  <a:pt x="1810366" y="1775165"/>
                </a:lnTo>
                <a:lnTo>
                  <a:pt x="1856786" y="1775165"/>
                </a:lnTo>
                <a:lnTo>
                  <a:pt x="1856786" y="1711766"/>
                </a:lnTo>
                <a:lnTo>
                  <a:pt x="1903205" y="1711766"/>
                </a:lnTo>
                <a:lnTo>
                  <a:pt x="1903205" y="1648367"/>
                </a:lnTo>
                <a:lnTo>
                  <a:pt x="1949625" y="1648367"/>
                </a:lnTo>
                <a:lnTo>
                  <a:pt x="1996045" y="1648367"/>
                </a:lnTo>
                <a:lnTo>
                  <a:pt x="2042464" y="1648367"/>
                </a:lnTo>
                <a:lnTo>
                  <a:pt x="2088884" y="1648367"/>
                </a:lnTo>
                <a:lnTo>
                  <a:pt x="2135303" y="1648367"/>
                </a:lnTo>
                <a:lnTo>
                  <a:pt x="2135303" y="1584968"/>
                </a:lnTo>
                <a:lnTo>
                  <a:pt x="2135303" y="1521570"/>
                </a:lnTo>
                <a:lnTo>
                  <a:pt x="2135303" y="1458171"/>
                </a:lnTo>
                <a:lnTo>
                  <a:pt x="2135303" y="1394772"/>
                </a:lnTo>
                <a:lnTo>
                  <a:pt x="2181723" y="1394772"/>
                </a:lnTo>
                <a:lnTo>
                  <a:pt x="2181723" y="1331373"/>
                </a:lnTo>
                <a:lnTo>
                  <a:pt x="2181723" y="1267975"/>
                </a:lnTo>
                <a:lnTo>
                  <a:pt x="2228143" y="1267975"/>
                </a:lnTo>
                <a:lnTo>
                  <a:pt x="2228143" y="1204576"/>
                </a:lnTo>
                <a:lnTo>
                  <a:pt x="2228143" y="1141177"/>
                </a:lnTo>
                <a:lnTo>
                  <a:pt x="2274562" y="1141177"/>
                </a:lnTo>
                <a:lnTo>
                  <a:pt x="2320982" y="1141177"/>
                </a:lnTo>
                <a:lnTo>
                  <a:pt x="2367402" y="1141177"/>
                </a:lnTo>
                <a:lnTo>
                  <a:pt x="2413821" y="1141177"/>
                </a:lnTo>
                <a:lnTo>
                  <a:pt x="2413821" y="1077778"/>
                </a:lnTo>
                <a:lnTo>
                  <a:pt x="2413821" y="1014380"/>
                </a:lnTo>
                <a:lnTo>
                  <a:pt x="2460241" y="1014380"/>
                </a:lnTo>
                <a:lnTo>
                  <a:pt x="2506661" y="1014380"/>
                </a:lnTo>
                <a:lnTo>
                  <a:pt x="2506661" y="950981"/>
                </a:lnTo>
                <a:lnTo>
                  <a:pt x="2553080" y="950981"/>
                </a:lnTo>
                <a:lnTo>
                  <a:pt x="2553080" y="887582"/>
                </a:lnTo>
                <a:lnTo>
                  <a:pt x="2553080" y="824183"/>
                </a:lnTo>
                <a:lnTo>
                  <a:pt x="2599500" y="824183"/>
                </a:lnTo>
                <a:lnTo>
                  <a:pt x="2645920" y="824183"/>
                </a:lnTo>
                <a:lnTo>
                  <a:pt x="2645920" y="760785"/>
                </a:lnTo>
                <a:lnTo>
                  <a:pt x="2692339" y="760785"/>
                </a:lnTo>
                <a:lnTo>
                  <a:pt x="2738759" y="760785"/>
                </a:lnTo>
                <a:lnTo>
                  <a:pt x="2785179" y="760785"/>
                </a:lnTo>
                <a:lnTo>
                  <a:pt x="2831598" y="760785"/>
                </a:lnTo>
                <a:lnTo>
                  <a:pt x="2831598" y="697386"/>
                </a:lnTo>
                <a:lnTo>
                  <a:pt x="2878018" y="697386"/>
                </a:lnTo>
                <a:lnTo>
                  <a:pt x="2924438" y="697386"/>
                </a:lnTo>
                <a:lnTo>
                  <a:pt x="2970857" y="697386"/>
                </a:lnTo>
                <a:lnTo>
                  <a:pt x="2970857" y="633987"/>
                </a:lnTo>
                <a:lnTo>
                  <a:pt x="3017277" y="633987"/>
                </a:lnTo>
                <a:lnTo>
                  <a:pt x="3063696" y="633987"/>
                </a:lnTo>
                <a:lnTo>
                  <a:pt x="3063696" y="570588"/>
                </a:lnTo>
                <a:lnTo>
                  <a:pt x="3110116" y="570588"/>
                </a:lnTo>
                <a:lnTo>
                  <a:pt x="3156536" y="570588"/>
                </a:lnTo>
                <a:lnTo>
                  <a:pt x="3202955" y="570588"/>
                </a:lnTo>
                <a:lnTo>
                  <a:pt x="3249375" y="570588"/>
                </a:lnTo>
                <a:lnTo>
                  <a:pt x="3295795" y="570588"/>
                </a:lnTo>
                <a:lnTo>
                  <a:pt x="3295795" y="507190"/>
                </a:lnTo>
                <a:lnTo>
                  <a:pt x="3342214" y="507190"/>
                </a:lnTo>
                <a:lnTo>
                  <a:pt x="3342214" y="443791"/>
                </a:lnTo>
                <a:lnTo>
                  <a:pt x="3388634" y="443791"/>
                </a:lnTo>
                <a:lnTo>
                  <a:pt x="3388634" y="380392"/>
                </a:lnTo>
                <a:lnTo>
                  <a:pt x="3435054" y="380392"/>
                </a:lnTo>
                <a:lnTo>
                  <a:pt x="3435054" y="316993"/>
                </a:lnTo>
                <a:lnTo>
                  <a:pt x="3481473" y="316993"/>
                </a:lnTo>
                <a:lnTo>
                  <a:pt x="3527893" y="316993"/>
                </a:lnTo>
                <a:lnTo>
                  <a:pt x="3574313" y="316993"/>
                </a:lnTo>
                <a:lnTo>
                  <a:pt x="3574313" y="253595"/>
                </a:lnTo>
                <a:lnTo>
                  <a:pt x="3620732" y="253595"/>
                </a:lnTo>
                <a:lnTo>
                  <a:pt x="3667152" y="253595"/>
                </a:lnTo>
                <a:lnTo>
                  <a:pt x="3713572" y="253595"/>
                </a:lnTo>
                <a:lnTo>
                  <a:pt x="3759991" y="253595"/>
                </a:lnTo>
                <a:lnTo>
                  <a:pt x="3806411" y="253595"/>
                </a:lnTo>
                <a:lnTo>
                  <a:pt x="3852831" y="253595"/>
                </a:lnTo>
                <a:lnTo>
                  <a:pt x="3899250" y="253595"/>
                </a:lnTo>
                <a:lnTo>
                  <a:pt x="3945670" y="253595"/>
                </a:lnTo>
                <a:lnTo>
                  <a:pt x="3992090" y="253595"/>
                </a:lnTo>
                <a:lnTo>
                  <a:pt x="3992090" y="190196"/>
                </a:lnTo>
                <a:lnTo>
                  <a:pt x="4038509" y="190196"/>
                </a:lnTo>
                <a:lnTo>
                  <a:pt x="4084929" y="190196"/>
                </a:lnTo>
                <a:lnTo>
                  <a:pt x="4131348" y="190196"/>
                </a:lnTo>
                <a:lnTo>
                  <a:pt x="4177768" y="190196"/>
                </a:lnTo>
                <a:lnTo>
                  <a:pt x="4224188" y="190196"/>
                </a:lnTo>
                <a:lnTo>
                  <a:pt x="4270607" y="190196"/>
                </a:lnTo>
                <a:lnTo>
                  <a:pt x="4317027" y="190196"/>
                </a:lnTo>
                <a:lnTo>
                  <a:pt x="4317027" y="126797"/>
                </a:lnTo>
                <a:lnTo>
                  <a:pt x="4363447" y="126797"/>
                </a:lnTo>
                <a:lnTo>
                  <a:pt x="4409866" y="126797"/>
                </a:lnTo>
                <a:lnTo>
                  <a:pt x="4456286" y="126797"/>
                </a:lnTo>
                <a:lnTo>
                  <a:pt x="4502706" y="126797"/>
                </a:lnTo>
                <a:lnTo>
                  <a:pt x="4549125" y="126797"/>
                </a:lnTo>
                <a:lnTo>
                  <a:pt x="4595545" y="126797"/>
                </a:lnTo>
                <a:lnTo>
                  <a:pt x="4595545" y="63398"/>
                </a:lnTo>
                <a:lnTo>
                  <a:pt x="4641965" y="63398"/>
                </a:lnTo>
                <a:lnTo>
                  <a:pt x="4688384" y="63398"/>
                </a:lnTo>
                <a:lnTo>
                  <a:pt x="4734804" y="63398"/>
                </a:lnTo>
                <a:lnTo>
                  <a:pt x="4781224" y="63398"/>
                </a:lnTo>
                <a:lnTo>
                  <a:pt x="4827643" y="63398"/>
                </a:lnTo>
                <a:lnTo>
                  <a:pt x="4874063" y="63398"/>
                </a:lnTo>
                <a:lnTo>
                  <a:pt x="4920483" y="63398"/>
                </a:lnTo>
                <a:lnTo>
                  <a:pt x="4966902" y="63398"/>
                </a:lnTo>
                <a:lnTo>
                  <a:pt x="5013322" y="63398"/>
                </a:lnTo>
                <a:lnTo>
                  <a:pt x="5059741" y="63398"/>
                </a:lnTo>
                <a:lnTo>
                  <a:pt x="5106161" y="63398"/>
                </a:lnTo>
                <a:lnTo>
                  <a:pt x="5106161" y="0"/>
                </a:lnTo>
                <a:lnTo>
                  <a:pt x="5152581" y="0"/>
                </a:lnTo>
                <a:lnTo>
                  <a:pt x="5199000" y="0"/>
                </a:lnTo>
                <a:lnTo>
                  <a:pt x="5245420" y="0"/>
                </a:lnTo>
                <a:lnTo>
                  <a:pt x="5291840" y="0"/>
                </a:lnTo>
                <a:lnTo>
                  <a:pt x="5338259" y="0"/>
                </a:lnTo>
              </a:path>
            </a:pathLst>
          </a:custGeom>
          <a:noFill/>
          <a:ln w="13680">
            <a:solidFill>
              <a:srgbClr val="ff0000"/>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986" name="tx26" descr=""/>
          <p:cNvPicPr/>
          <p:nvPr/>
        </p:nvPicPr>
        <p:blipFill>
          <a:blip r:embed="rId82"/>
          <a:stretch/>
        </p:blipFill>
        <p:spPr>
          <a:xfrm>
            <a:off x="6111720" y="4361040"/>
            <a:ext cx="3711600" cy="244440"/>
          </a:xfrm>
          <a:prstGeom prst="rect">
            <a:avLst/>
          </a:prstGeom>
          <a:ln w="0">
            <a:noFill/>
          </a:ln>
        </p:spPr>
      </p:pic>
      <p:pic>
        <p:nvPicPr>
          <p:cNvPr id="987" name="tx27" descr=""/>
          <p:cNvPicPr/>
          <p:nvPr/>
        </p:nvPicPr>
        <p:blipFill>
          <a:blip r:embed="rId83"/>
          <a:stretch/>
        </p:blipFill>
        <p:spPr>
          <a:xfrm>
            <a:off x="6111720" y="4645080"/>
            <a:ext cx="2357640" cy="203040"/>
          </a:xfrm>
          <a:prstGeom prst="rect">
            <a:avLst/>
          </a:prstGeom>
          <a:ln w="0">
            <a:noFill/>
          </a:ln>
        </p:spPr>
      </p:pic>
      <p:pic>
        <p:nvPicPr>
          <p:cNvPr id="988" name="tx28" descr=""/>
          <p:cNvPicPr/>
          <p:nvPr/>
        </p:nvPicPr>
        <p:blipFill>
          <a:blip r:embed="rId84"/>
          <a:stretch/>
        </p:blipFill>
        <p:spPr>
          <a:xfrm>
            <a:off x="6121440" y="4889520"/>
            <a:ext cx="2357280" cy="201600"/>
          </a:xfrm>
          <a:prstGeom prst="rect">
            <a:avLst/>
          </a:prstGeom>
          <a:ln w="0">
            <a:noFill/>
          </a:ln>
        </p:spPr>
      </p:pic>
      <p:pic>
        <p:nvPicPr>
          <p:cNvPr id="989" name="tx29" descr=""/>
          <p:cNvPicPr/>
          <p:nvPr/>
        </p:nvPicPr>
        <p:blipFill>
          <a:blip r:embed="rId85"/>
          <a:stretch/>
        </p:blipFill>
        <p:spPr>
          <a:xfrm>
            <a:off x="6111720" y="5378400"/>
            <a:ext cx="1182960" cy="201600"/>
          </a:xfrm>
          <a:prstGeom prst="rect">
            <a:avLst/>
          </a:prstGeom>
          <a:ln w="0">
            <a:noFill/>
          </a:ln>
        </p:spPr>
      </p:pic>
      <p:sp>
        <p:nvSpPr>
          <p:cNvPr id="990" name="pl30"/>
          <p:cNvSpPr/>
          <p:nvPr/>
        </p:nvSpPr>
        <p:spPr>
          <a:xfrm>
            <a:off x="3995640" y="947880"/>
            <a:ext cx="5872320" cy="5356080"/>
          </a:xfrm>
          <a:custGeom>
            <a:avLst/>
            <a:gdLst/>
            <a:ahLst/>
            <a:rect l="l" t="t" r="r" b="b"/>
            <a:pathLst>
              <a:path w="5872085" h="6136999">
                <a:moveTo>
                  <a:pt x="0" y="6136999"/>
                </a:moveTo>
                <a:lnTo>
                  <a:pt x="5872085" y="0"/>
                </a:lnTo>
              </a:path>
            </a:pathLst>
          </a:custGeom>
          <a:noFill/>
          <a:ln w="13680">
            <a:solidFill>
              <a:srgbClr val="000000"/>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91" name="rc31"/>
          <p:cNvSpPr/>
          <p:nvPr/>
        </p:nvSpPr>
        <p:spPr>
          <a:xfrm>
            <a:off x="3995640" y="947880"/>
            <a:ext cx="5872320" cy="5356080"/>
          </a:xfrm>
          <a:prstGeom prst="rect">
            <a:avLst/>
          </a:prstGeom>
          <a:noFill/>
          <a:ln cap="rnd" w="13680">
            <a:solidFill>
              <a:srgbClr val="333333"/>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92" name="tx32"/>
          <p:cNvSpPr/>
          <p:nvPr/>
        </p:nvSpPr>
        <p:spPr>
          <a:xfrm>
            <a:off x="3438360" y="5977080"/>
            <a:ext cx="493920" cy="161640"/>
          </a:xfrm>
          <a:prstGeom prst="rect">
            <a:avLst/>
          </a:prstGeom>
          <a:noFill/>
          <a:ln w="0">
            <a:noFill/>
          </a:ln>
        </p:spPr>
        <p:style>
          <a:lnRef idx="0"/>
          <a:fillRef idx="0"/>
          <a:effectRef idx="0"/>
          <a:fontRef idx="minor"/>
        </p:style>
        <p:txBody>
          <a:bodyPr wrap="none" lIns="0" rIns="0" tIns="0" bIns="0" anchor="ctr" anchorCtr="1">
            <a:noAutofit/>
          </a:bodyPr>
          <a:p>
            <a:pPr>
              <a:lnSpc>
                <a:spcPts val="1998"/>
              </a:lnSpc>
              <a:tabLst>
                <a:tab algn="l" pos="0"/>
                <a:tab algn="l" pos="1487520"/>
                <a:tab algn="l" pos="2975040"/>
                <a:tab algn="l" pos="4462560"/>
                <a:tab algn="l" pos="5950080"/>
                <a:tab algn="l" pos="7437600"/>
                <a:tab algn="l" pos="8924760"/>
                <a:tab algn="l" pos="10412280"/>
              </a:tabLst>
            </a:pPr>
            <a:r>
              <a:rPr b="0" lang="zh-CN" sz="2000" spc="-1" strike="noStrike">
                <a:solidFill>
                  <a:srgbClr val="4d4d4d"/>
                </a:solidFill>
                <a:latin typeface="Arial"/>
              </a:rPr>
              <a:t>0.00</a:t>
            </a:r>
            <a:endParaRPr b="0" lang="en-US" sz="2000" spc="-1" strike="noStrike">
              <a:solidFill>
                <a:srgbClr val="000000"/>
              </a:solidFill>
              <a:latin typeface="Arial"/>
            </a:endParaRPr>
          </a:p>
        </p:txBody>
      </p:sp>
      <p:sp>
        <p:nvSpPr>
          <p:cNvPr id="993" name="tx33"/>
          <p:cNvSpPr/>
          <p:nvPr/>
        </p:nvSpPr>
        <p:spPr>
          <a:xfrm>
            <a:off x="3438360" y="4761000"/>
            <a:ext cx="493920" cy="162000"/>
          </a:xfrm>
          <a:prstGeom prst="rect">
            <a:avLst/>
          </a:prstGeom>
          <a:noFill/>
          <a:ln w="0">
            <a:noFill/>
          </a:ln>
        </p:spPr>
        <p:style>
          <a:lnRef idx="0"/>
          <a:fillRef idx="0"/>
          <a:effectRef idx="0"/>
          <a:fontRef idx="minor"/>
        </p:style>
        <p:txBody>
          <a:bodyPr wrap="none" lIns="0" rIns="0" tIns="0" bIns="0" anchor="ctr" anchorCtr="1">
            <a:noAutofit/>
          </a:bodyPr>
          <a:p>
            <a:pPr>
              <a:lnSpc>
                <a:spcPts val="1998"/>
              </a:lnSpc>
              <a:tabLst>
                <a:tab algn="l" pos="0"/>
                <a:tab algn="l" pos="1487520"/>
                <a:tab algn="l" pos="2975040"/>
                <a:tab algn="l" pos="4462560"/>
                <a:tab algn="l" pos="5950080"/>
                <a:tab algn="l" pos="7437600"/>
                <a:tab algn="l" pos="8924760"/>
                <a:tab algn="l" pos="10412280"/>
              </a:tabLst>
            </a:pPr>
            <a:r>
              <a:rPr b="0" lang="zh-CN" sz="2000" spc="-1" strike="noStrike">
                <a:solidFill>
                  <a:srgbClr val="4d4d4d"/>
                </a:solidFill>
                <a:latin typeface="Arial"/>
              </a:rPr>
              <a:t>0.25</a:t>
            </a:r>
            <a:endParaRPr b="0" lang="en-US" sz="2000" spc="-1" strike="noStrike">
              <a:solidFill>
                <a:srgbClr val="000000"/>
              </a:solidFill>
              <a:latin typeface="Arial"/>
            </a:endParaRPr>
          </a:p>
        </p:txBody>
      </p:sp>
      <p:sp>
        <p:nvSpPr>
          <p:cNvPr id="994" name="tx34"/>
          <p:cNvSpPr/>
          <p:nvPr/>
        </p:nvSpPr>
        <p:spPr>
          <a:xfrm>
            <a:off x="3438360" y="3543480"/>
            <a:ext cx="493920" cy="161640"/>
          </a:xfrm>
          <a:prstGeom prst="rect">
            <a:avLst/>
          </a:prstGeom>
          <a:noFill/>
          <a:ln w="0">
            <a:noFill/>
          </a:ln>
        </p:spPr>
        <p:style>
          <a:lnRef idx="0"/>
          <a:fillRef idx="0"/>
          <a:effectRef idx="0"/>
          <a:fontRef idx="minor"/>
        </p:style>
        <p:txBody>
          <a:bodyPr wrap="none" lIns="0" rIns="0" tIns="0" bIns="0" anchor="ctr" anchorCtr="1">
            <a:noAutofit/>
          </a:bodyPr>
          <a:p>
            <a:pPr>
              <a:lnSpc>
                <a:spcPts val="1998"/>
              </a:lnSpc>
              <a:tabLst>
                <a:tab algn="l" pos="0"/>
                <a:tab algn="l" pos="1487520"/>
                <a:tab algn="l" pos="2975040"/>
                <a:tab algn="l" pos="4462560"/>
                <a:tab algn="l" pos="5950080"/>
                <a:tab algn="l" pos="7437600"/>
                <a:tab algn="l" pos="8924760"/>
                <a:tab algn="l" pos="10412280"/>
              </a:tabLst>
            </a:pPr>
            <a:r>
              <a:rPr b="0" lang="zh-CN" sz="2000" spc="-1" strike="noStrike">
                <a:solidFill>
                  <a:srgbClr val="4d4d4d"/>
                </a:solidFill>
                <a:latin typeface="Arial"/>
              </a:rPr>
              <a:t>0.50</a:t>
            </a:r>
            <a:endParaRPr b="0" lang="en-US" sz="2000" spc="-1" strike="noStrike">
              <a:solidFill>
                <a:srgbClr val="000000"/>
              </a:solidFill>
              <a:latin typeface="Arial"/>
            </a:endParaRPr>
          </a:p>
        </p:txBody>
      </p:sp>
      <p:sp>
        <p:nvSpPr>
          <p:cNvPr id="995" name="tx35"/>
          <p:cNvSpPr/>
          <p:nvPr/>
        </p:nvSpPr>
        <p:spPr>
          <a:xfrm>
            <a:off x="3438360" y="2325600"/>
            <a:ext cx="493920" cy="162000"/>
          </a:xfrm>
          <a:prstGeom prst="rect">
            <a:avLst/>
          </a:prstGeom>
          <a:noFill/>
          <a:ln w="0">
            <a:noFill/>
          </a:ln>
        </p:spPr>
        <p:style>
          <a:lnRef idx="0"/>
          <a:fillRef idx="0"/>
          <a:effectRef idx="0"/>
          <a:fontRef idx="minor"/>
        </p:style>
        <p:txBody>
          <a:bodyPr wrap="none" lIns="0" rIns="0" tIns="0" bIns="0" anchor="ctr" anchorCtr="1">
            <a:noAutofit/>
          </a:bodyPr>
          <a:p>
            <a:pPr>
              <a:lnSpc>
                <a:spcPts val="1998"/>
              </a:lnSpc>
              <a:tabLst>
                <a:tab algn="l" pos="0"/>
                <a:tab algn="l" pos="1487520"/>
                <a:tab algn="l" pos="2975040"/>
                <a:tab algn="l" pos="4462560"/>
                <a:tab algn="l" pos="5950080"/>
                <a:tab algn="l" pos="7437600"/>
                <a:tab algn="l" pos="8924760"/>
                <a:tab algn="l" pos="10412280"/>
              </a:tabLst>
            </a:pPr>
            <a:r>
              <a:rPr b="0" lang="zh-CN" sz="2000" spc="-1" strike="noStrike">
                <a:solidFill>
                  <a:srgbClr val="4d4d4d"/>
                </a:solidFill>
                <a:latin typeface="Arial"/>
              </a:rPr>
              <a:t>0.75</a:t>
            </a:r>
            <a:endParaRPr b="0" lang="en-US" sz="2000" spc="-1" strike="noStrike">
              <a:solidFill>
                <a:srgbClr val="000000"/>
              </a:solidFill>
              <a:latin typeface="Arial"/>
            </a:endParaRPr>
          </a:p>
        </p:txBody>
      </p:sp>
      <p:sp>
        <p:nvSpPr>
          <p:cNvPr id="996" name="tx36"/>
          <p:cNvSpPr/>
          <p:nvPr/>
        </p:nvSpPr>
        <p:spPr>
          <a:xfrm>
            <a:off x="3438360" y="1109520"/>
            <a:ext cx="493920" cy="162000"/>
          </a:xfrm>
          <a:prstGeom prst="rect">
            <a:avLst/>
          </a:prstGeom>
          <a:noFill/>
          <a:ln w="0">
            <a:noFill/>
          </a:ln>
        </p:spPr>
        <p:style>
          <a:lnRef idx="0"/>
          <a:fillRef idx="0"/>
          <a:effectRef idx="0"/>
          <a:fontRef idx="minor"/>
        </p:style>
        <p:txBody>
          <a:bodyPr wrap="none" lIns="0" rIns="0" tIns="0" bIns="0" anchor="ctr" anchorCtr="1">
            <a:noAutofit/>
          </a:bodyPr>
          <a:p>
            <a:pPr>
              <a:lnSpc>
                <a:spcPts val="1998"/>
              </a:lnSpc>
              <a:tabLst>
                <a:tab algn="l" pos="0"/>
                <a:tab algn="l" pos="1487520"/>
                <a:tab algn="l" pos="2975040"/>
                <a:tab algn="l" pos="4462560"/>
                <a:tab algn="l" pos="5950080"/>
                <a:tab algn="l" pos="7437600"/>
                <a:tab algn="l" pos="8924760"/>
                <a:tab algn="l" pos="10412280"/>
              </a:tabLst>
            </a:pPr>
            <a:r>
              <a:rPr b="0" lang="zh-CN" sz="2000" spc="-1" strike="noStrike">
                <a:solidFill>
                  <a:srgbClr val="4d4d4d"/>
                </a:solidFill>
                <a:latin typeface="Arial"/>
              </a:rPr>
              <a:t>1.00</a:t>
            </a:r>
            <a:endParaRPr b="0" lang="en-US" sz="2000" spc="-1" strike="noStrike">
              <a:solidFill>
                <a:srgbClr val="000000"/>
              </a:solidFill>
              <a:latin typeface="Arial"/>
            </a:endParaRPr>
          </a:p>
        </p:txBody>
      </p:sp>
      <p:sp>
        <p:nvSpPr>
          <p:cNvPr id="997" name="pl37"/>
          <p:cNvSpPr/>
          <p:nvPr/>
        </p:nvSpPr>
        <p:spPr>
          <a:xfrm>
            <a:off x="3960720" y="6059520"/>
            <a:ext cx="3492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98" name="pl38"/>
          <p:cNvSpPr/>
          <p:nvPr/>
        </p:nvSpPr>
        <p:spPr>
          <a:xfrm>
            <a:off x="3960720" y="4843440"/>
            <a:ext cx="3492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999" name="pl39"/>
          <p:cNvSpPr/>
          <p:nvPr/>
        </p:nvSpPr>
        <p:spPr>
          <a:xfrm>
            <a:off x="3960720" y="3625920"/>
            <a:ext cx="3492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00" name="pl40"/>
          <p:cNvSpPr/>
          <p:nvPr/>
        </p:nvSpPr>
        <p:spPr>
          <a:xfrm>
            <a:off x="3960720" y="2408400"/>
            <a:ext cx="3492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01" name="pl41"/>
          <p:cNvSpPr/>
          <p:nvPr/>
        </p:nvSpPr>
        <p:spPr>
          <a:xfrm>
            <a:off x="3960720" y="1192320"/>
            <a:ext cx="3492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02" name="pl42"/>
          <p:cNvSpPr/>
          <p:nvPr/>
        </p:nvSpPr>
        <p:spPr>
          <a:xfrm>
            <a:off x="9599760" y="6303960"/>
            <a:ext cx="360" cy="30240"/>
          </a:xfrm>
          <a:custGeom>
            <a:avLst/>
            <a:gdLst/>
            <a:ahLst/>
            <a:rect l="l" t="t" r="r" b="b"/>
            <a:pathLst>
              <a:path w="1" h="34794">
                <a:moveTo>
                  <a:pt x="0" y="34794"/>
                </a:moveTo>
                <a:lnTo>
                  <a:pt x="0" y="0"/>
                </a:lnTo>
              </a:path>
            </a:pathLst>
          </a:custGeom>
          <a:noFill/>
          <a:ln w="13680">
            <a:solidFill>
              <a:srgbClr val="333333"/>
            </a:solidFill>
            <a:round/>
          </a:ln>
        </p:spPr>
        <p:style>
          <a:lnRef idx="0"/>
          <a:fillRef idx="0"/>
          <a:effectRef idx="0"/>
          <a:fontRef idx="minor"/>
        </p:style>
        <p:txBody>
          <a:bodyPr lIns="90000" rIns="90000" tIns="-16560" bIns="-165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03" name="pl43"/>
          <p:cNvSpPr/>
          <p:nvPr/>
        </p:nvSpPr>
        <p:spPr>
          <a:xfrm>
            <a:off x="8265960" y="6303960"/>
            <a:ext cx="360" cy="30240"/>
          </a:xfrm>
          <a:custGeom>
            <a:avLst/>
            <a:gdLst/>
            <a:ahLst/>
            <a:rect l="l" t="t" r="r" b="b"/>
            <a:pathLst>
              <a:path w="1" h="34794">
                <a:moveTo>
                  <a:pt x="0" y="34794"/>
                </a:moveTo>
                <a:lnTo>
                  <a:pt x="0" y="0"/>
                </a:lnTo>
              </a:path>
            </a:pathLst>
          </a:custGeom>
          <a:noFill/>
          <a:ln w="13680">
            <a:solidFill>
              <a:srgbClr val="333333"/>
            </a:solidFill>
            <a:round/>
          </a:ln>
        </p:spPr>
        <p:style>
          <a:lnRef idx="0"/>
          <a:fillRef idx="0"/>
          <a:effectRef idx="0"/>
          <a:fontRef idx="minor"/>
        </p:style>
        <p:txBody>
          <a:bodyPr lIns="90000" rIns="90000" tIns="-16560" bIns="-165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04" name="pl44"/>
          <p:cNvSpPr/>
          <p:nvPr/>
        </p:nvSpPr>
        <p:spPr>
          <a:xfrm>
            <a:off x="6931080" y="6303960"/>
            <a:ext cx="360" cy="30240"/>
          </a:xfrm>
          <a:custGeom>
            <a:avLst/>
            <a:gdLst/>
            <a:ahLst/>
            <a:rect l="l" t="t" r="r" b="b"/>
            <a:pathLst>
              <a:path w="1" h="34794">
                <a:moveTo>
                  <a:pt x="0" y="34794"/>
                </a:moveTo>
                <a:lnTo>
                  <a:pt x="0" y="0"/>
                </a:lnTo>
              </a:path>
            </a:pathLst>
          </a:custGeom>
          <a:noFill/>
          <a:ln w="13680">
            <a:solidFill>
              <a:srgbClr val="333333"/>
            </a:solidFill>
            <a:round/>
          </a:ln>
        </p:spPr>
        <p:style>
          <a:lnRef idx="0"/>
          <a:fillRef idx="0"/>
          <a:effectRef idx="0"/>
          <a:fontRef idx="minor"/>
        </p:style>
        <p:txBody>
          <a:bodyPr lIns="90000" rIns="90000" tIns="-16560" bIns="-165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05" name="pl45"/>
          <p:cNvSpPr/>
          <p:nvPr/>
        </p:nvSpPr>
        <p:spPr>
          <a:xfrm>
            <a:off x="5595840" y="6303960"/>
            <a:ext cx="360" cy="30240"/>
          </a:xfrm>
          <a:custGeom>
            <a:avLst/>
            <a:gdLst/>
            <a:ahLst/>
            <a:rect l="l" t="t" r="r" b="b"/>
            <a:pathLst>
              <a:path w="1" h="34794">
                <a:moveTo>
                  <a:pt x="0" y="34794"/>
                </a:moveTo>
                <a:lnTo>
                  <a:pt x="0" y="0"/>
                </a:lnTo>
              </a:path>
            </a:pathLst>
          </a:custGeom>
          <a:noFill/>
          <a:ln w="13680">
            <a:solidFill>
              <a:srgbClr val="333333"/>
            </a:solidFill>
            <a:round/>
          </a:ln>
        </p:spPr>
        <p:style>
          <a:lnRef idx="0"/>
          <a:fillRef idx="0"/>
          <a:effectRef idx="0"/>
          <a:fontRef idx="minor"/>
        </p:style>
        <p:txBody>
          <a:bodyPr lIns="90000" rIns="90000" tIns="-16560" bIns="-165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06" name="pl46"/>
          <p:cNvSpPr/>
          <p:nvPr/>
        </p:nvSpPr>
        <p:spPr>
          <a:xfrm>
            <a:off x="4262400" y="6303960"/>
            <a:ext cx="360" cy="30240"/>
          </a:xfrm>
          <a:custGeom>
            <a:avLst/>
            <a:gdLst/>
            <a:ahLst/>
            <a:rect l="l" t="t" r="r" b="b"/>
            <a:pathLst>
              <a:path w="1" h="34794">
                <a:moveTo>
                  <a:pt x="0" y="34794"/>
                </a:moveTo>
                <a:lnTo>
                  <a:pt x="0" y="0"/>
                </a:lnTo>
              </a:path>
            </a:pathLst>
          </a:custGeom>
          <a:noFill/>
          <a:ln w="13680">
            <a:solidFill>
              <a:srgbClr val="333333"/>
            </a:solidFill>
            <a:round/>
          </a:ln>
        </p:spPr>
        <p:style>
          <a:lnRef idx="0"/>
          <a:fillRef idx="0"/>
          <a:effectRef idx="0"/>
          <a:fontRef idx="minor"/>
        </p:style>
        <p:txBody>
          <a:bodyPr lIns="90000" rIns="90000" tIns="-16560" bIns="-165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07" name="tx47"/>
          <p:cNvSpPr/>
          <p:nvPr/>
        </p:nvSpPr>
        <p:spPr>
          <a:xfrm>
            <a:off x="9353520" y="6410160"/>
            <a:ext cx="493920" cy="162000"/>
          </a:xfrm>
          <a:prstGeom prst="rect">
            <a:avLst/>
          </a:prstGeom>
          <a:noFill/>
          <a:ln w="0">
            <a:noFill/>
          </a:ln>
        </p:spPr>
        <p:style>
          <a:lnRef idx="0"/>
          <a:fillRef idx="0"/>
          <a:effectRef idx="0"/>
          <a:fontRef idx="minor"/>
        </p:style>
        <p:txBody>
          <a:bodyPr wrap="none" lIns="0" rIns="0" tIns="0" bIns="0" anchor="ctr" anchorCtr="1">
            <a:noAutofit/>
          </a:bodyPr>
          <a:p>
            <a:pPr>
              <a:lnSpc>
                <a:spcPts val="1998"/>
              </a:lnSpc>
              <a:tabLst>
                <a:tab algn="l" pos="0"/>
                <a:tab algn="l" pos="1487520"/>
                <a:tab algn="l" pos="2975040"/>
                <a:tab algn="l" pos="4462560"/>
                <a:tab algn="l" pos="5950080"/>
                <a:tab algn="l" pos="7437600"/>
                <a:tab algn="l" pos="8924760"/>
                <a:tab algn="l" pos="10412280"/>
              </a:tabLst>
            </a:pPr>
            <a:r>
              <a:rPr b="0" lang="zh-CN" sz="2000" spc="-1" strike="noStrike">
                <a:solidFill>
                  <a:srgbClr val="4d4d4d"/>
                </a:solidFill>
                <a:latin typeface="Arial"/>
              </a:rPr>
              <a:t>0.00</a:t>
            </a:r>
            <a:endParaRPr b="0" lang="en-US" sz="2000" spc="-1" strike="noStrike">
              <a:solidFill>
                <a:srgbClr val="000000"/>
              </a:solidFill>
              <a:latin typeface="Arial"/>
            </a:endParaRPr>
          </a:p>
        </p:txBody>
      </p:sp>
      <p:sp>
        <p:nvSpPr>
          <p:cNvPr id="1008" name="tx48"/>
          <p:cNvSpPr/>
          <p:nvPr/>
        </p:nvSpPr>
        <p:spPr>
          <a:xfrm>
            <a:off x="8018640" y="6410160"/>
            <a:ext cx="493560" cy="162000"/>
          </a:xfrm>
          <a:prstGeom prst="rect">
            <a:avLst/>
          </a:prstGeom>
          <a:noFill/>
          <a:ln w="0">
            <a:noFill/>
          </a:ln>
        </p:spPr>
        <p:style>
          <a:lnRef idx="0"/>
          <a:fillRef idx="0"/>
          <a:effectRef idx="0"/>
          <a:fontRef idx="minor"/>
        </p:style>
        <p:txBody>
          <a:bodyPr wrap="none" lIns="0" rIns="0" tIns="0" bIns="0" anchor="ctr" anchorCtr="1">
            <a:noAutofit/>
          </a:bodyPr>
          <a:p>
            <a:pPr>
              <a:lnSpc>
                <a:spcPts val="1998"/>
              </a:lnSpc>
              <a:tabLst>
                <a:tab algn="l" pos="0"/>
                <a:tab algn="l" pos="1487520"/>
                <a:tab algn="l" pos="2975040"/>
                <a:tab algn="l" pos="4462560"/>
                <a:tab algn="l" pos="5950080"/>
                <a:tab algn="l" pos="7437600"/>
                <a:tab algn="l" pos="8924760"/>
                <a:tab algn="l" pos="10412280"/>
              </a:tabLst>
            </a:pPr>
            <a:r>
              <a:rPr b="0" lang="zh-CN" sz="2000" spc="-1" strike="noStrike">
                <a:solidFill>
                  <a:srgbClr val="4d4d4d"/>
                </a:solidFill>
                <a:latin typeface="Arial"/>
              </a:rPr>
              <a:t>0.25</a:t>
            </a:r>
            <a:endParaRPr b="0" lang="en-US" sz="2000" spc="-1" strike="noStrike">
              <a:solidFill>
                <a:srgbClr val="000000"/>
              </a:solidFill>
              <a:latin typeface="Arial"/>
            </a:endParaRPr>
          </a:p>
        </p:txBody>
      </p:sp>
      <p:sp>
        <p:nvSpPr>
          <p:cNvPr id="1009" name="tx49"/>
          <p:cNvSpPr/>
          <p:nvPr/>
        </p:nvSpPr>
        <p:spPr>
          <a:xfrm>
            <a:off x="6683400" y="6410160"/>
            <a:ext cx="495360" cy="162000"/>
          </a:xfrm>
          <a:prstGeom prst="rect">
            <a:avLst/>
          </a:prstGeom>
          <a:noFill/>
          <a:ln w="0">
            <a:noFill/>
          </a:ln>
        </p:spPr>
        <p:style>
          <a:lnRef idx="0"/>
          <a:fillRef idx="0"/>
          <a:effectRef idx="0"/>
          <a:fontRef idx="minor"/>
        </p:style>
        <p:txBody>
          <a:bodyPr wrap="none" lIns="0" rIns="0" tIns="0" bIns="0" anchor="ctr" anchorCtr="1">
            <a:noAutofit/>
          </a:bodyPr>
          <a:p>
            <a:pPr>
              <a:lnSpc>
                <a:spcPts val="1998"/>
              </a:lnSpc>
              <a:tabLst>
                <a:tab algn="l" pos="0"/>
                <a:tab algn="l" pos="1487520"/>
                <a:tab algn="l" pos="2975040"/>
                <a:tab algn="l" pos="4462560"/>
                <a:tab algn="l" pos="5950080"/>
                <a:tab algn="l" pos="7437600"/>
                <a:tab algn="l" pos="8924760"/>
                <a:tab algn="l" pos="10412280"/>
              </a:tabLst>
            </a:pPr>
            <a:r>
              <a:rPr b="0" lang="zh-CN" sz="2000" spc="-1" strike="noStrike">
                <a:solidFill>
                  <a:srgbClr val="4d4d4d"/>
                </a:solidFill>
                <a:latin typeface="Arial"/>
              </a:rPr>
              <a:t>0.50</a:t>
            </a:r>
            <a:endParaRPr b="0" lang="en-US" sz="2000" spc="-1" strike="noStrike">
              <a:solidFill>
                <a:srgbClr val="000000"/>
              </a:solidFill>
              <a:latin typeface="Arial"/>
            </a:endParaRPr>
          </a:p>
        </p:txBody>
      </p:sp>
      <p:sp>
        <p:nvSpPr>
          <p:cNvPr id="1010" name="tx50"/>
          <p:cNvSpPr/>
          <p:nvPr/>
        </p:nvSpPr>
        <p:spPr>
          <a:xfrm>
            <a:off x="5349960" y="6410160"/>
            <a:ext cx="493560" cy="162000"/>
          </a:xfrm>
          <a:prstGeom prst="rect">
            <a:avLst/>
          </a:prstGeom>
          <a:noFill/>
          <a:ln w="0">
            <a:noFill/>
          </a:ln>
        </p:spPr>
        <p:style>
          <a:lnRef idx="0"/>
          <a:fillRef idx="0"/>
          <a:effectRef idx="0"/>
          <a:fontRef idx="minor"/>
        </p:style>
        <p:txBody>
          <a:bodyPr wrap="none" lIns="0" rIns="0" tIns="0" bIns="0" anchor="ctr" anchorCtr="1">
            <a:noAutofit/>
          </a:bodyPr>
          <a:p>
            <a:pPr>
              <a:lnSpc>
                <a:spcPts val="1998"/>
              </a:lnSpc>
              <a:tabLst>
                <a:tab algn="l" pos="0"/>
                <a:tab algn="l" pos="1487520"/>
                <a:tab algn="l" pos="2975040"/>
                <a:tab algn="l" pos="4462560"/>
                <a:tab algn="l" pos="5950080"/>
                <a:tab algn="l" pos="7437600"/>
                <a:tab algn="l" pos="8924760"/>
                <a:tab algn="l" pos="10412280"/>
              </a:tabLst>
            </a:pPr>
            <a:r>
              <a:rPr b="0" lang="zh-CN" sz="2000" spc="-1" strike="noStrike">
                <a:solidFill>
                  <a:srgbClr val="4d4d4d"/>
                </a:solidFill>
                <a:latin typeface="Arial"/>
              </a:rPr>
              <a:t>0.75</a:t>
            </a:r>
            <a:endParaRPr b="0" lang="en-US" sz="2000" spc="-1" strike="noStrike">
              <a:solidFill>
                <a:srgbClr val="000000"/>
              </a:solidFill>
              <a:latin typeface="Arial"/>
            </a:endParaRPr>
          </a:p>
        </p:txBody>
      </p:sp>
      <p:sp>
        <p:nvSpPr>
          <p:cNvPr id="1011" name="tx51"/>
          <p:cNvSpPr/>
          <p:nvPr/>
        </p:nvSpPr>
        <p:spPr>
          <a:xfrm>
            <a:off x="4014720" y="6410160"/>
            <a:ext cx="493920" cy="162000"/>
          </a:xfrm>
          <a:prstGeom prst="rect">
            <a:avLst/>
          </a:prstGeom>
          <a:noFill/>
          <a:ln w="0">
            <a:noFill/>
          </a:ln>
        </p:spPr>
        <p:style>
          <a:lnRef idx="0"/>
          <a:fillRef idx="0"/>
          <a:effectRef idx="0"/>
          <a:fontRef idx="minor"/>
        </p:style>
        <p:txBody>
          <a:bodyPr wrap="none" lIns="0" rIns="0" tIns="0" bIns="0" anchor="ctr" anchorCtr="1">
            <a:noAutofit/>
          </a:bodyPr>
          <a:p>
            <a:pPr>
              <a:lnSpc>
                <a:spcPts val="1998"/>
              </a:lnSpc>
              <a:tabLst>
                <a:tab algn="l" pos="0"/>
                <a:tab algn="l" pos="1487520"/>
                <a:tab algn="l" pos="2975040"/>
                <a:tab algn="l" pos="4462560"/>
                <a:tab algn="l" pos="5950080"/>
                <a:tab algn="l" pos="7437600"/>
                <a:tab algn="l" pos="8924760"/>
                <a:tab algn="l" pos="10412280"/>
              </a:tabLst>
            </a:pPr>
            <a:r>
              <a:rPr b="0" lang="zh-CN" sz="2000" spc="-1" strike="noStrike">
                <a:solidFill>
                  <a:srgbClr val="4d4d4d"/>
                </a:solidFill>
                <a:latin typeface="Arial"/>
              </a:rPr>
              <a:t>1.00</a:t>
            </a:r>
            <a:endParaRPr b="0" lang="en-US" sz="2000" spc="-1" strike="noStrike">
              <a:solidFill>
                <a:srgbClr val="000000"/>
              </a:solidFill>
              <a:latin typeface="Arial"/>
            </a:endParaRPr>
          </a:p>
        </p:txBody>
      </p:sp>
      <p:sp>
        <p:nvSpPr>
          <p:cNvPr id="1012" name="tx52"/>
          <p:cNvSpPr/>
          <p:nvPr/>
        </p:nvSpPr>
        <p:spPr>
          <a:xfrm>
            <a:off x="6245280" y="6703920"/>
            <a:ext cx="1371600" cy="249480"/>
          </a:xfrm>
          <a:prstGeom prst="rect">
            <a:avLst/>
          </a:prstGeom>
          <a:noFill/>
          <a:ln w="0">
            <a:noFill/>
          </a:ln>
        </p:spPr>
        <p:style>
          <a:lnRef idx="0"/>
          <a:fillRef idx="0"/>
          <a:effectRef idx="0"/>
          <a:fontRef idx="minor"/>
        </p:style>
        <p:txBody>
          <a:bodyPr wrap="none" lIns="0" rIns="0" tIns="0" bIns="0" anchor="ctr" anchorCtr="1">
            <a:noAutofit/>
          </a:bodyPr>
          <a:p>
            <a:pPr>
              <a:lnSpc>
                <a:spcPts val="2398"/>
              </a:lnSpc>
              <a:tabLst>
                <a:tab algn="l" pos="0"/>
                <a:tab algn="l" pos="1487520"/>
                <a:tab algn="l" pos="2975040"/>
                <a:tab algn="l" pos="4462560"/>
                <a:tab algn="l" pos="5950080"/>
                <a:tab algn="l" pos="7437600"/>
                <a:tab algn="l" pos="8924760"/>
                <a:tab algn="l" pos="10412280"/>
              </a:tabLst>
            </a:pPr>
            <a:r>
              <a:rPr b="0" lang="zh-CN" sz="2400" spc="-1" strike="noStrike">
                <a:solidFill>
                  <a:srgbClr val="000000"/>
                </a:solidFill>
                <a:latin typeface="Arial"/>
              </a:rPr>
              <a:t>Specificity</a:t>
            </a:r>
            <a:endParaRPr b="0" lang="en-US" sz="2400" spc="-1" strike="noStrike">
              <a:solidFill>
                <a:srgbClr val="000000"/>
              </a:solidFill>
              <a:latin typeface="Arial"/>
            </a:endParaRPr>
          </a:p>
        </p:txBody>
      </p:sp>
      <p:sp>
        <p:nvSpPr>
          <p:cNvPr id="1013" name="tx53"/>
          <p:cNvSpPr/>
          <p:nvPr/>
        </p:nvSpPr>
        <p:spPr>
          <a:xfrm rot="16200000">
            <a:off x="2376360" y="3482280"/>
            <a:ext cx="1197000" cy="285840"/>
          </a:xfrm>
          <a:prstGeom prst="rect">
            <a:avLst/>
          </a:prstGeom>
          <a:noFill/>
          <a:ln w="0">
            <a:noFill/>
          </a:ln>
        </p:spPr>
        <p:style>
          <a:lnRef idx="0"/>
          <a:fillRef idx="0"/>
          <a:effectRef idx="0"/>
          <a:fontRef idx="minor"/>
        </p:style>
        <p:txBody>
          <a:bodyPr wrap="none" lIns="0" rIns="0" tIns="0" bIns="0" anchor="ctr" anchorCtr="1">
            <a:noAutofit/>
          </a:bodyPr>
          <a:p>
            <a:pPr>
              <a:lnSpc>
                <a:spcPts val="2398"/>
              </a:lnSpc>
              <a:tabLst>
                <a:tab algn="l" pos="0"/>
                <a:tab algn="l" pos="1487520"/>
                <a:tab algn="l" pos="2975040"/>
                <a:tab algn="l" pos="4462560"/>
                <a:tab algn="l" pos="5950080"/>
                <a:tab algn="l" pos="7437600"/>
                <a:tab algn="l" pos="8924760"/>
                <a:tab algn="l" pos="10412280"/>
              </a:tabLst>
            </a:pPr>
            <a:r>
              <a:rPr b="0" lang="zh-CN" sz="2400" spc="-1" strike="noStrike">
                <a:solidFill>
                  <a:srgbClr val="000000"/>
                </a:solidFill>
                <a:latin typeface="Arial"/>
              </a:rPr>
              <a:t>Sensitivity</a:t>
            </a:r>
            <a:endParaRPr b="0" lang="en-US" sz="2400" spc="-1" strike="noStrike">
              <a:solidFill>
                <a:srgbClr val="000000"/>
              </a:solidFill>
              <a:latin typeface="Arial"/>
            </a:endParaRPr>
          </a:p>
        </p:txBody>
      </p:sp>
      <p:sp>
        <p:nvSpPr>
          <p:cNvPr id="1014" name="rc54"/>
          <p:cNvSpPr/>
          <p:nvPr/>
        </p:nvSpPr>
        <p:spPr>
          <a:xfrm>
            <a:off x="4602240" y="1003320"/>
            <a:ext cx="1135080" cy="960480"/>
          </a:xfrm>
          <a:prstGeom prst="rect">
            <a:avLst/>
          </a:prstGeom>
          <a:solidFill>
            <a:srgbClr val="ffffff"/>
          </a:solidFill>
          <a:ln cap="rnd" w="13680">
            <a:solidFill>
              <a:srgbClr val="000000"/>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15" name="rc55"/>
          <p:cNvSpPr/>
          <p:nvPr/>
        </p:nvSpPr>
        <p:spPr>
          <a:xfrm>
            <a:off x="4672080" y="1125360"/>
            <a:ext cx="218880" cy="38916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16" name="pl56"/>
          <p:cNvSpPr/>
          <p:nvPr/>
        </p:nvSpPr>
        <p:spPr>
          <a:xfrm>
            <a:off x="4692600" y="1319040"/>
            <a:ext cx="176400" cy="360"/>
          </a:xfrm>
          <a:custGeom>
            <a:avLst/>
            <a:gdLst/>
            <a:ahLst/>
            <a:rect l="l" t="t" r="r" b="b"/>
            <a:pathLst>
              <a:path w="175564" h="1">
                <a:moveTo>
                  <a:pt x="0" y="0"/>
                </a:moveTo>
                <a:lnTo>
                  <a:pt x="175564" y="0"/>
                </a:lnTo>
              </a:path>
            </a:pathLst>
          </a:custGeom>
          <a:noFill/>
          <a:ln w="1368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17" name="pl58"/>
          <p:cNvSpPr/>
          <p:nvPr/>
        </p:nvSpPr>
        <p:spPr>
          <a:xfrm>
            <a:off x="4692600" y="1708200"/>
            <a:ext cx="176400" cy="360"/>
          </a:xfrm>
          <a:custGeom>
            <a:avLst/>
            <a:gdLst/>
            <a:ahLst/>
            <a:rect l="l" t="t" r="r" b="b"/>
            <a:pathLst>
              <a:path w="175564" h="1">
                <a:moveTo>
                  <a:pt x="0" y="0"/>
                </a:moveTo>
                <a:lnTo>
                  <a:pt x="175564" y="0"/>
                </a:lnTo>
              </a:path>
            </a:pathLst>
          </a:custGeom>
          <a:noFill/>
          <a:ln w="13680">
            <a:solidFill>
              <a:srgbClr val="ff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18" name="tx59"/>
          <p:cNvSpPr/>
          <p:nvPr/>
        </p:nvSpPr>
        <p:spPr>
          <a:xfrm>
            <a:off x="5068800" y="1228680"/>
            <a:ext cx="409680" cy="162000"/>
          </a:xfrm>
          <a:prstGeom prst="rect">
            <a:avLst/>
          </a:prstGeom>
          <a:noFill/>
          <a:ln w="0">
            <a:noFill/>
          </a:ln>
        </p:spPr>
        <p:style>
          <a:lnRef idx="0"/>
          <a:fillRef idx="0"/>
          <a:effectRef idx="0"/>
          <a:fontRef idx="minor"/>
        </p:style>
        <p:txBody>
          <a:bodyPr wrap="none" lIns="0" rIns="0" tIns="0" bIns="0" anchor="ctr" anchorCtr="1">
            <a:noAutofit/>
          </a:bodyPr>
          <a:p>
            <a:pPr>
              <a:lnSpc>
                <a:spcPts val="1998"/>
              </a:lnSpc>
              <a:tabLst>
                <a:tab algn="l" pos="0"/>
                <a:tab algn="l" pos="1487520"/>
                <a:tab algn="l" pos="2975040"/>
                <a:tab algn="l" pos="4462560"/>
                <a:tab algn="l" pos="5950080"/>
                <a:tab algn="l" pos="7437600"/>
                <a:tab algn="l" pos="8924760"/>
                <a:tab algn="l" pos="10412280"/>
              </a:tabLst>
            </a:pPr>
            <a:r>
              <a:rPr b="0" lang="zh-CN" sz="2000" spc="-1" strike="noStrike">
                <a:solidFill>
                  <a:srgbClr val="000000"/>
                </a:solidFill>
                <a:latin typeface="Arial"/>
              </a:rPr>
              <a:t>1se</a:t>
            </a:r>
            <a:endParaRPr b="0" lang="en-US" sz="2000" spc="-1" strike="noStrike">
              <a:solidFill>
                <a:srgbClr val="000000"/>
              </a:solidFill>
              <a:latin typeface="Arial"/>
            </a:endParaRPr>
          </a:p>
        </p:txBody>
      </p:sp>
      <p:sp>
        <p:nvSpPr>
          <p:cNvPr id="1019" name="tx60"/>
          <p:cNvSpPr/>
          <p:nvPr/>
        </p:nvSpPr>
        <p:spPr>
          <a:xfrm>
            <a:off x="5068800" y="1620720"/>
            <a:ext cx="409680" cy="158760"/>
          </a:xfrm>
          <a:prstGeom prst="rect">
            <a:avLst/>
          </a:prstGeom>
          <a:noFill/>
          <a:ln w="0">
            <a:noFill/>
          </a:ln>
        </p:spPr>
        <p:style>
          <a:lnRef idx="0"/>
          <a:fillRef idx="0"/>
          <a:effectRef idx="0"/>
          <a:fontRef idx="minor"/>
        </p:style>
        <p:txBody>
          <a:bodyPr wrap="none" lIns="0" rIns="0" tIns="0" bIns="0" anchor="ctr" anchorCtr="1">
            <a:noAutofit/>
          </a:bodyPr>
          <a:p>
            <a:pPr>
              <a:lnSpc>
                <a:spcPts val="1998"/>
              </a:lnSpc>
              <a:tabLst>
                <a:tab algn="l" pos="0"/>
                <a:tab algn="l" pos="1487520"/>
                <a:tab algn="l" pos="2975040"/>
                <a:tab algn="l" pos="4462560"/>
                <a:tab algn="l" pos="5950080"/>
                <a:tab algn="l" pos="7437600"/>
                <a:tab algn="l" pos="8924760"/>
                <a:tab algn="l" pos="10412280"/>
              </a:tabLst>
            </a:pPr>
            <a:r>
              <a:rPr b="0" lang="zh-CN" sz="2000" spc="-1" strike="noStrike">
                <a:solidFill>
                  <a:srgbClr val="000000"/>
                </a:solidFill>
                <a:latin typeface="Arial"/>
              </a:rPr>
              <a:t>min</a:t>
            </a:r>
            <a:endParaRPr b="0" lang="en-US" sz="2000" spc="-1" strike="noStrike">
              <a:solidFill>
                <a:srgbClr val="000000"/>
              </a:solidFill>
              <a:latin typeface="Arial"/>
            </a:endParaRPr>
          </a:p>
        </p:txBody>
      </p:sp>
      <p:sp>
        <p:nvSpPr>
          <p:cNvPr id="1020" name="rc3"/>
          <p:cNvSpPr/>
          <p:nvPr/>
        </p:nvSpPr>
        <p:spPr>
          <a:xfrm>
            <a:off x="11180880" y="750960"/>
            <a:ext cx="7315200" cy="6345000"/>
          </a:xfrm>
          <a:prstGeom prst="rect">
            <a:avLst/>
          </a:prstGeom>
          <a:solidFill>
            <a:srgbClr val="ffffff"/>
          </a:solidFill>
          <a:ln cap="rnd" w="9360">
            <a:solidFill>
              <a:srgbClr val="ffffff"/>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21" name="rc4"/>
          <p:cNvSpPr/>
          <p:nvPr/>
        </p:nvSpPr>
        <p:spPr>
          <a:xfrm>
            <a:off x="11180880" y="750960"/>
            <a:ext cx="7315200" cy="6345000"/>
          </a:xfrm>
          <a:prstGeom prst="rect">
            <a:avLst/>
          </a:prstGeom>
          <a:solidFill>
            <a:srgbClr val="ffffff"/>
          </a:solidFill>
          <a:ln cap="rnd" w="13680">
            <a:solidFill>
              <a:srgbClr val="ffffff"/>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22" name="rc5"/>
          <p:cNvSpPr/>
          <p:nvPr/>
        </p:nvSpPr>
        <p:spPr>
          <a:xfrm>
            <a:off x="12336480" y="1000080"/>
            <a:ext cx="5872320" cy="532440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23" name="pl6"/>
          <p:cNvSpPr/>
          <p:nvPr/>
        </p:nvSpPr>
        <p:spPr>
          <a:xfrm>
            <a:off x="12336480" y="5477040"/>
            <a:ext cx="5872320" cy="360"/>
          </a:xfrm>
          <a:custGeom>
            <a:avLst/>
            <a:gdLst/>
            <a:ahLst/>
            <a:rect l="l" t="t" r="r" b="b"/>
            <a:pathLst>
              <a:path w="5872085" h="1">
                <a:moveTo>
                  <a:pt x="0" y="0"/>
                </a:moveTo>
                <a:lnTo>
                  <a:pt x="5872085" y="0"/>
                </a:lnTo>
              </a:path>
            </a:pathLst>
          </a:custGeom>
          <a:noFill/>
          <a:ln w="684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24" name="pl7"/>
          <p:cNvSpPr/>
          <p:nvPr/>
        </p:nvSpPr>
        <p:spPr>
          <a:xfrm>
            <a:off x="12336480" y="4267080"/>
            <a:ext cx="5872320" cy="360"/>
          </a:xfrm>
          <a:custGeom>
            <a:avLst/>
            <a:gdLst/>
            <a:ahLst/>
            <a:rect l="l" t="t" r="r" b="b"/>
            <a:pathLst>
              <a:path w="5872085" h="1">
                <a:moveTo>
                  <a:pt x="0" y="0"/>
                </a:moveTo>
                <a:lnTo>
                  <a:pt x="5872085" y="0"/>
                </a:lnTo>
              </a:path>
            </a:pathLst>
          </a:custGeom>
          <a:noFill/>
          <a:ln w="684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25" name="pl8"/>
          <p:cNvSpPr/>
          <p:nvPr/>
        </p:nvSpPr>
        <p:spPr>
          <a:xfrm>
            <a:off x="12336480" y="3057480"/>
            <a:ext cx="5872320" cy="360"/>
          </a:xfrm>
          <a:custGeom>
            <a:avLst/>
            <a:gdLst/>
            <a:ahLst/>
            <a:rect l="l" t="t" r="r" b="b"/>
            <a:pathLst>
              <a:path w="5872085" h="1">
                <a:moveTo>
                  <a:pt x="0" y="0"/>
                </a:moveTo>
                <a:lnTo>
                  <a:pt x="5872085" y="0"/>
                </a:lnTo>
              </a:path>
            </a:pathLst>
          </a:custGeom>
          <a:noFill/>
          <a:ln w="684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26" name="pl9"/>
          <p:cNvSpPr/>
          <p:nvPr/>
        </p:nvSpPr>
        <p:spPr>
          <a:xfrm>
            <a:off x="12336480" y="1847880"/>
            <a:ext cx="5872320" cy="360"/>
          </a:xfrm>
          <a:custGeom>
            <a:avLst/>
            <a:gdLst/>
            <a:ahLst/>
            <a:rect l="l" t="t" r="r" b="b"/>
            <a:pathLst>
              <a:path w="5872085" h="1">
                <a:moveTo>
                  <a:pt x="0" y="0"/>
                </a:moveTo>
                <a:lnTo>
                  <a:pt x="5872085" y="0"/>
                </a:lnTo>
              </a:path>
            </a:pathLst>
          </a:custGeom>
          <a:noFill/>
          <a:ln w="684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27" name="pl10"/>
          <p:cNvSpPr/>
          <p:nvPr/>
        </p:nvSpPr>
        <p:spPr>
          <a:xfrm>
            <a:off x="17273520" y="1000080"/>
            <a:ext cx="360" cy="5324400"/>
          </a:xfrm>
          <a:custGeom>
            <a:avLst/>
            <a:gdLst/>
            <a:ahLst/>
            <a:rect l="l" t="t" r="r" b="b"/>
            <a:pathLst>
              <a:path w="1" h="6136999">
                <a:moveTo>
                  <a:pt x="0" y="6136999"/>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28" name="pl11"/>
          <p:cNvSpPr/>
          <p:nvPr/>
        </p:nvSpPr>
        <p:spPr>
          <a:xfrm>
            <a:off x="15938640" y="1000080"/>
            <a:ext cx="360" cy="5324400"/>
          </a:xfrm>
          <a:custGeom>
            <a:avLst/>
            <a:gdLst/>
            <a:ahLst/>
            <a:rect l="l" t="t" r="r" b="b"/>
            <a:pathLst>
              <a:path w="1" h="6136999">
                <a:moveTo>
                  <a:pt x="0" y="6136999"/>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29" name="pl12"/>
          <p:cNvSpPr/>
          <p:nvPr/>
        </p:nvSpPr>
        <p:spPr>
          <a:xfrm>
            <a:off x="14604840" y="1000080"/>
            <a:ext cx="360" cy="5324400"/>
          </a:xfrm>
          <a:custGeom>
            <a:avLst/>
            <a:gdLst/>
            <a:ahLst/>
            <a:rect l="l" t="t" r="r" b="b"/>
            <a:pathLst>
              <a:path w="1" h="6136999">
                <a:moveTo>
                  <a:pt x="0" y="6136999"/>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30" name="pl13"/>
          <p:cNvSpPr/>
          <p:nvPr/>
        </p:nvSpPr>
        <p:spPr>
          <a:xfrm>
            <a:off x="13269960" y="1000080"/>
            <a:ext cx="360" cy="5324400"/>
          </a:xfrm>
          <a:custGeom>
            <a:avLst/>
            <a:gdLst/>
            <a:ahLst/>
            <a:rect l="l" t="t" r="r" b="b"/>
            <a:pathLst>
              <a:path w="1" h="6136999">
                <a:moveTo>
                  <a:pt x="0" y="6136999"/>
                </a:moveTo>
                <a:lnTo>
                  <a:pt x="0" y="0"/>
                </a:lnTo>
              </a:path>
            </a:pathLst>
          </a:custGeom>
          <a:noFill/>
          <a:ln w="684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31" name="pl14"/>
          <p:cNvSpPr/>
          <p:nvPr/>
        </p:nvSpPr>
        <p:spPr>
          <a:xfrm>
            <a:off x="12336480" y="6081840"/>
            <a:ext cx="5872320" cy="360"/>
          </a:xfrm>
          <a:custGeom>
            <a:avLst/>
            <a:gdLst/>
            <a:ahLst/>
            <a:rect l="l" t="t" r="r" b="b"/>
            <a:pathLst>
              <a:path w="5872085" h="1">
                <a:moveTo>
                  <a:pt x="0" y="0"/>
                </a:moveTo>
                <a:lnTo>
                  <a:pt x="5872085"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32" name="pl15"/>
          <p:cNvSpPr/>
          <p:nvPr/>
        </p:nvSpPr>
        <p:spPr>
          <a:xfrm>
            <a:off x="12336480" y="4871880"/>
            <a:ext cx="5872320" cy="360"/>
          </a:xfrm>
          <a:custGeom>
            <a:avLst/>
            <a:gdLst/>
            <a:ahLst/>
            <a:rect l="l" t="t" r="r" b="b"/>
            <a:pathLst>
              <a:path w="5872085" h="1">
                <a:moveTo>
                  <a:pt x="0" y="0"/>
                </a:moveTo>
                <a:lnTo>
                  <a:pt x="5872085"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33" name="pl16"/>
          <p:cNvSpPr/>
          <p:nvPr/>
        </p:nvSpPr>
        <p:spPr>
          <a:xfrm>
            <a:off x="12336480" y="3662280"/>
            <a:ext cx="5872320" cy="360"/>
          </a:xfrm>
          <a:custGeom>
            <a:avLst/>
            <a:gdLst/>
            <a:ahLst/>
            <a:rect l="l" t="t" r="r" b="b"/>
            <a:pathLst>
              <a:path w="5872085" h="1">
                <a:moveTo>
                  <a:pt x="0" y="0"/>
                </a:moveTo>
                <a:lnTo>
                  <a:pt x="5872085"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34" name="pl17"/>
          <p:cNvSpPr/>
          <p:nvPr/>
        </p:nvSpPr>
        <p:spPr>
          <a:xfrm>
            <a:off x="12336480" y="2452680"/>
            <a:ext cx="5872320" cy="360"/>
          </a:xfrm>
          <a:custGeom>
            <a:avLst/>
            <a:gdLst/>
            <a:ahLst/>
            <a:rect l="l" t="t" r="r" b="b"/>
            <a:pathLst>
              <a:path w="5872085" h="1">
                <a:moveTo>
                  <a:pt x="0" y="0"/>
                </a:moveTo>
                <a:lnTo>
                  <a:pt x="5872085"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35" name="pl18"/>
          <p:cNvSpPr/>
          <p:nvPr/>
        </p:nvSpPr>
        <p:spPr>
          <a:xfrm>
            <a:off x="12336480" y="1243080"/>
            <a:ext cx="5872320" cy="360"/>
          </a:xfrm>
          <a:custGeom>
            <a:avLst/>
            <a:gdLst/>
            <a:ahLst/>
            <a:rect l="l" t="t" r="r" b="b"/>
            <a:pathLst>
              <a:path w="5872085" h="1">
                <a:moveTo>
                  <a:pt x="0" y="0"/>
                </a:moveTo>
                <a:lnTo>
                  <a:pt x="5872085" y="0"/>
                </a:lnTo>
              </a:path>
            </a:pathLst>
          </a:custGeom>
          <a:noFill/>
          <a:ln w="1368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36" name="pl19"/>
          <p:cNvSpPr/>
          <p:nvPr/>
        </p:nvSpPr>
        <p:spPr>
          <a:xfrm>
            <a:off x="17940240" y="1000080"/>
            <a:ext cx="360" cy="5324400"/>
          </a:xfrm>
          <a:custGeom>
            <a:avLst/>
            <a:gdLst/>
            <a:ahLst/>
            <a:rect l="l" t="t" r="r" b="b"/>
            <a:pathLst>
              <a:path w="1" h="6136999">
                <a:moveTo>
                  <a:pt x="0" y="6136999"/>
                </a:moveTo>
                <a:lnTo>
                  <a:pt x="0" y="0"/>
                </a:lnTo>
              </a:path>
            </a:pathLst>
          </a:custGeom>
          <a:noFill/>
          <a:ln w="1368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37" name="pl20"/>
          <p:cNvSpPr/>
          <p:nvPr/>
        </p:nvSpPr>
        <p:spPr>
          <a:xfrm>
            <a:off x="16606800" y="1000080"/>
            <a:ext cx="360" cy="5324400"/>
          </a:xfrm>
          <a:custGeom>
            <a:avLst/>
            <a:gdLst/>
            <a:ahLst/>
            <a:rect l="l" t="t" r="r" b="b"/>
            <a:pathLst>
              <a:path w="1" h="6136999">
                <a:moveTo>
                  <a:pt x="0" y="6136999"/>
                </a:moveTo>
                <a:lnTo>
                  <a:pt x="0" y="0"/>
                </a:lnTo>
              </a:path>
            </a:pathLst>
          </a:custGeom>
          <a:noFill/>
          <a:ln w="1368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38" name="pl21"/>
          <p:cNvSpPr/>
          <p:nvPr/>
        </p:nvSpPr>
        <p:spPr>
          <a:xfrm>
            <a:off x="15271920" y="1000080"/>
            <a:ext cx="360" cy="5324400"/>
          </a:xfrm>
          <a:custGeom>
            <a:avLst/>
            <a:gdLst/>
            <a:ahLst/>
            <a:rect l="l" t="t" r="r" b="b"/>
            <a:pathLst>
              <a:path w="1" h="6136999">
                <a:moveTo>
                  <a:pt x="0" y="6136999"/>
                </a:moveTo>
                <a:lnTo>
                  <a:pt x="0" y="0"/>
                </a:lnTo>
              </a:path>
            </a:pathLst>
          </a:custGeom>
          <a:noFill/>
          <a:ln w="1368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39" name="pl22"/>
          <p:cNvSpPr/>
          <p:nvPr/>
        </p:nvSpPr>
        <p:spPr>
          <a:xfrm>
            <a:off x="13936680" y="1000080"/>
            <a:ext cx="360" cy="5324400"/>
          </a:xfrm>
          <a:custGeom>
            <a:avLst/>
            <a:gdLst/>
            <a:ahLst/>
            <a:rect l="l" t="t" r="r" b="b"/>
            <a:pathLst>
              <a:path w="1" h="6136999">
                <a:moveTo>
                  <a:pt x="0" y="6136999"/>
                </a:moveTo>
                <a:lnTo>
                  <a:pt x="0" y="0"/>
                </a:lnTo>
              </a:path>
            </a:pathLst>
          </a:custGeom>
          <a:noFill/>
          <a:ln w="1368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40" name="pl23"/>
          <p:cNvSpPr/>
          <p:nvPr/>
        </p:nvSpPr>
        <p:spPr>
          <a:xfrm>
            <a:off x="12603240" y="1000080"/>
            <a:ext cx="360" cy="5324400"/>
          </a:xfrm>
          <a:custGeom>
            <a:avLst/>
            <a:gdLst/>
            <a:ahLst/>
            <a:rect l="l" t="t" r="r" b="b"/>
            <a:pathLst>
              <a:path w="1" h="6136999">
                <a:moveTo>
                  <a:pt x="0" y="6136999"/>
                </a:moveTo>
                <a:lnTo>
                  <a:pt x="0" y="0"/>
                </a:lnTo>
              </a:path>
            </a:pathLst>
          </a:custGeom>
          <a:noFill/>
          <a:ln w="1368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41" name="pl24"/>
          <p:cNvSpPr/>
          <p:nvPr/>
        </p:nvSpPr>
        <p:spPr>
          <a:xfrm>
            <a:off x="12603240" y="1243080"/>
            <a:ext cx="5337000" cy="4838760"/>
          </a:xfrm>
          <a:custGeom>
            <a:avLst/>
            <a:gdLst/>
            <a:ahLst/>
            <a:rect l="l" t="t" r="r" b="b"/>
            <a:pathLst>
              <a:path w="5338259" h="5579090">
                <a:moveTo>
                  <a:pt x="0" y="5579090"/>
                </a:moveTo>
                <a:lnTo>
                  <a:pt x="237255" y="4437913"/>
                </a:lnTo>
                <a:lnTo>
                  <a:pt x="533825" y="3613729"/>
                </a:lnTo>
                <a:lnTo>
                  <a:pt x="1186279" y="2599349"/>
                </a:lnTo>
                <a:lnTo>
                  <a:pt x="3499525" y="633987"/>
                </a:lnTo>
                <a:lnTo>
                  <a:pt x="3974037" y="570588"/>
                </a:lnTo>
                <a:lnTo>
                  <a:pt x="5338259" y="0"/>
                </a:lnTo>
              </a:path>
            </a:pathLst>
          </a:custGeom>
          <a:noFill/>
          <a:ln w="13680">
            <a:solidFill>
              <a:srgbClr val="000000"/>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42" name="pl25"/>
          <p:cNvSpPr/>
          <p:nvPr/>
        </p:nvSpPr>
        <p:spPr>
          <a:xfrm>
            <a:off x="12603240" y="1243080"/>
            <a:ext cx="5337000" cy="4838760"/>
          </a:xfrm>
          <a:custGeom>
            <a:avLst/>
            <a:gdLst/>
            <a:ahLst/>
            <a:rect l="l" t="t" r="r" b="b"/>
            <a:pathLst>
              <a:path w="5338259" h="5579090">
                <a:moveTo>
                  <a:pt x="0" y="5579090"/>
                </a:moveTo>
                <a:lnTo>
                  <a:pt x="0" y="5515692"/>
                </a:lnTo>
                <a:lnTo>
                  <a:pt x="0" y="5452293"/>
                </a:lnTo>
                <a:lnTo>
                  <a:pt x="0" y="5388894"/>
                </a:lnTo>
                <a:lnTo>
                  <a:pt x="0" y="5325495"/>
                </a:lnTo>
                <a:lnTo>
                  <a:pt x="0" y="5262097"/>
                </a:lnTo>
                <a:lnTo>
                  <a:pt x="0" y="5198698"/>
                </a:lnTo>
                <a:lnTo>
                  <a:pt x="59313" y="5198698"/>
                </a:lnTo>
                <a:lnTo>
                  <a:pt x="59313" y="5135299"/>
                </a:lnTo>
                <a:lnTo>
                  <a:pt x="59313" y="5071900"/>
                </a:lnTo>
                <a:lnTo>
                  <a:pt x="59313" y="5008502"/>
                </a:lnTo>
                <a:lnTo>
                  <a:pt x="118627" y="5008502"/>
                </a:lnTo>
                <a:lnTo>
                  <a:pt x="118627" y="4945103"/>
                </a:lnTo>
                <a:lnTo>
                  <a:pt x="118627" y="4881704"/>
                </a:lnTo>
                <a:lnTo>
                  <a:pt x="118627" y="4818305"/>
                </a:lnTo>
                <a:lnTo>
                  <a:pt x="177941" y="4818305"/>
                </a:lnTo>
                <a:lnTo>
                  <a:pt x="177941" y="4754906"/>
                </a:lnTo>
                <a:lnTo>
                  <a:pt x="237255" y="4754906"/>
                </a:lnTo>
                <a:lnTo>
                  <a:pt x="237255" y="4691508"/>
                </a:lnTo>
                <a:lnTo>
                  <a:pt x="237255" y="4628109"/>
                </a:lnTo>
                <a:lnTo>
                  <a:pt x="237255" y="4564710"/>
                </a:lnTo>
                <a:lnTo>
                  <a:pt x="237255" y="4501311"/>
                </a:lnTo>
                <a:lnTo>
                  <a:pt x="237255" y="4437913"/>
                </a:lnTo>
                <a:lnTo>
                  <a:pt x="237255" y="4374514"/>
                </a:lnTo>
                <a:lnTo>
                  <a:pt x="237255" y="4311115"/>
                </a:lnTo>
                <a:lnTo>
                  <a:pt x="296569" y="4311115"/>
                </a:lnTo>
                <a:lnTo>
                  <a:pt x="296569" y="4247716"/>
                </a:lnTo>
                <a:lnTo>
                  <a:pt x="355883" y="4247716"/>
                </a:lnTo>
                <a:lnTo>
                  <a:pt x="355883" y="4184318"/>
                </a:lnTo>
                <a:lnTo>
                  <a:pt x="355883" y="4120919"/>
                </a:lnTo>
                <a:lnTo>
                  <a:pt x="355883" y="4057520"/>
                </a:lnTo>
                <a:lnTo>
                  <a:pt x="355883" y="3994121"/>
                </a:lnTo>
                <a:lnTo>
                  <a:pt x="355883" y="3930723"/>
                </a:lnTo>
                <a:lnTo>
                  <a:pt x="355883" y="3867324"/>
                </a:lnTo>
                <a:lnTo>
                  <a:pt x="355883" y="3803925"/>
                </a:lnTo>
                <a:lnTo>
                  <a:pt x="355883" y="3740526"/>
                </a:lnTo>
                <a:lnTo>
                  <a:pt x="355883" y="3677128"/>
                </a:lnTo>
                <a:lnTo>
                  <a:pt x="415197" y="3677128"/>
                </a:lnTo>
                <a:lnTo>
                  <a:pt x="415197" y="3613729"/>
                </a:lnTo>
                <a:lnTo>
                  <a:pt x="474511" y="3613729"/>
                </a:lnTo>
                <a:lnTo>
                  <a:pt x="474511" y="3550330"/>
                </a:lnTo>
                <a:lnTo>
                  <a:pt x="474511" y="3486931"/>
                </a:lnTo>
                <a:lnTo>
                  <a:pt x="474511" y="3423533"/>
                </a:lnTo>
                <a:lnTo>
                  <a:pt x="533825" y="3423533"/>
                </a:lnTo>
                <a:lnTo>
                  <a:pt x="533825" y="3360134"/>
                </a:lnTo>
                <a:lnTo>
                  <a:pt x="593139" y="3360134"/>
                </a:lnTo>
                <a:lnTo>
                  <a:pt x="593139" y="3296735"/>
                </a:lnTo>
                <a:lnTo>
                  <a:pt x="652453" y="3296735"/>
                </a:lnTo>
                <a:lnTo>
                  <a:pt x="652453" y="3233336"/>
                </a:lnTo>
                <a:lnTo>
                  <a:pt x="652453" y="3169937"/>
                </a:lnTo>
                <a:lnTo>
                  <a:pt x="711767" y="3169937"/>
                </a:lnTo>
                <a:lnTo>
                  <a:pt x="711767" y="3106539"/>
                </a:lnTo>
                <a:lnTo>
                  <a:pt x="711767" y="3043140"/>
                </a:lnTo>
                <a:lnTo>
                  <a:pt x="711767" y="2979741"/>
                </a:lnTo>
                <a:lnTo>
                  <a:pt x="771081" y="2979741"/>
                </a:lnTo>
                <a:lnTo>
                  <a:pt x="771081" y="2916342"/>
                </a:lnTo>
                <a:lnTo>
                  <a:pt x="830395" y="2916342"/>
                </a:lnTo>
                <a:lnTo>
                  <a:pt x="889709" y="2916342"/>
                </a:lnTo>
                <a:lnTo>
                  <a:pt x="889709" y="2852944"/>
                </a:lnTo>
                <a:lnTo>
                  <a:pt x="889709" y="2789545"/>
                </a:lnTo>
                <a:lnTo>
                  <a:pt x="889709" y="2726146"/>
                </a:lnTo>
                <a:lnTo>
                  <a:pt x="889709" y="2662747"/>
                </a:lnTo>
                <a:lnTo>
                  <a:pt x="889709" y="2599349"/>
                </a:lnTo>
                <a:lnTo>
                  <a:pt x="889709" y="2535950"/>
                </a:lnTo>
                <a:lnTo>
                  <a:pt x="889709" y="2472551"/>
                </a:lnTo>
                <a:lnTo>
                  <a:pt x="889709" y="2409152"/>
                </a:lnTo>
                <a:lnTo>
                  <a:pt x="889709" y="2345754"/>
                </a:lnTo>
                <a:lnTo>
                  <a:pt x="949023" y="2345754"/>
                </a:lnTo>
                <a:lnTo>
                  <a:pt x="949023" y="2282355"/>
                </a:lnTo>
                <a:lnTo>
                  <a:pt x="949023" y="2218956"/>
                </a:lnTo>
                <a:lnTo>
                  <a:pt x="1008337" y="2218956"/>
                </a:lnTo>
                <a:lnTo>
                  <a:pt x="1067651" y="2218956"/>
                </a:lnTo>
                <a:lnTo>
                  <a:pt x="1126965" y="2218956"/>
                </a:lnTo>
                <a:lnTo>
                  <a:pt x="1126965" y="2155557"/>
                </a:lnTo>
                <a:lnTo>
                  <a:pt x="1186279" y="2155557"/>
                </a:lnTo>
                <a:lnTo>
                  <a:pt x="1245593" y="2155557"/>
                </a:lnTo>
                <a:lnTo>
                  <a:pt x="1245593" y="2092159"/>
                </a:lnTo>
                <a:lnTo>
                  <a:pt x="1245593" y="2028760"/>
                </a:lnTo>
                <a:lnTo>
                  <a:pt x="1245593" y="1965361"/>
                </a:lnTo>
                <a:lnTo>
                  <a:pt x="1304907" y="1965361"/>
                </a:lnTo>
                <a:lnTo>
                  <a:pt x="1304907" y="1901962"/>
                </a:lnTo>
                <a:lnTo>
                  <a:pt x="1364221" y="1901962"/>
                </a:lnTo>
                <a:lnTo>
                  <a:pt x="1423535" y="1901962"/>
                </a:lnTo>
                <a:lnTo>
                  <a:pt x="1482849" y="1901962"/>
                </a:lnTo>
                <a:lnTo>
                  <a:pt x="1542163" y="1901962"/>
                </a:lnTo>
                <a:lnTo>
                  <a:pt x="1542163" y="1838564"/>
                </a:lnTo>
                <a:lnTo>
                  <a:pt x="1601477" y="1838564"/>
                </a:lnTo>
                <a:lnTo>
                  <a:pt x="1660791" y="1838564"/>
                </a:lnTo>
                <a:lnTo>
                  <a:pt x="1720105" y="1838564"/>
                </a:lnTo>
                <a:lnTo>
                  <a:pt x="1779419" y="1838564"/>
                </a:lnTo>
                <a:lnTo>
                  <a:pt x="1779419" y="1775165"/>
                </a:lnTo>
                <a:lnTo>
                  <a:pt x="1838733" y="1775165"/>
                </a:lnTo>
                <a:lnTo>
                  <a:pt x="1838733" y="1711766"/>
                </a:lnTo>
                <a:lnTo>
                  <a:pt x="1898047" y="1711766"/>
                </a:lnTo>
                <a:lnTo>
                  <a:pt x="1957361" y="1711766"/>
                </a:lnTo>
                <a:lnTo>
                  <a:pt x="1957361" y="1648367"/>
                </a:lnTo>
                <a:lnTo>
                  <a:pt x="2016675" y="1648367"/>
                </a:lnTo>
                <a:lnTo>
                  <a:pt x="2016675" y="1584968"/>
                </a:lnTo>
                <a:lnTo>
                  <a:pt x="2016675" y="1521570"/>
                </a:lnTo>
                <a:lnTo>
                  <a:pt x="2075989" y="1521570"/>
                </a:lnTo>
                <a:lnTo>
                  <a:pt x="2135303" y="1521570"/>
                </a:lnTo>
                <a:lnTo>
                  <a:pt x="2194617" y="1521570"/>
                </a:lnTo>
                <a:lnTo>
                  <a:pt x="2194617" y="1458171"/>
                </a:lnTo>
                <a:lnTo>
                  <a:pt x="2194617" y="1394772"/>
                </a:lnTo>
                <a:lnTo>
                  <a:pt x="2253931" y="1394772"/>
                </a:lnTo>
                <a:lnTo>
                  <a:pt x="2313245" y="1394772"/>
                </a:lnTo>
                <a:lnTo>
                  <a:pt x="2372559" y="1394772"/>
                </a:lnTo>
                <a:lnTo>
                  <a:pt x="2431873" y="1394772"/>
                </a:lnTo>
                <a:lnTo>
                  <a:pt x="2431873" y="1331373"/>
                </a:lnTo>
                <a:lnTo>
                  <a:pt x="2491187" y="1331373"/>
                </a:lnTo>
                <a:lnTo>
                  <a:pt x="2550501" y="1331373"/>
                </a:lnTo>
                <a:lnTo>
                  <a:pt x="2609815" y="1331373"/>
                </a:lnTo>
                <a:lnTo>
                  <a:pt x="2609815" y="1267975"/>
                </a:lnTo>
                <a:lnTo>
                  <a:pt x="2669129" y="1267975"/>
                </a:lnTo>
                <a:lnTo>
                  <a:pt x="2669129" y="1204576"/>
                </a:lnTo>
                <a:lnTo>
                  <a:pt x="2669129" y="1141177"/>
                </a:lnTo>
                <a:lnTo>
                  <a:pt x="2669129" y="1077778"/>
                </a:lnTo>
                <a:lnTo>
                  <a:pt x="2669129" y="1014380"/>
                </a:lnTo>
                <a:lnTo>
                  <a:pt x="2728443" y="1014380"/>
                </a:lnTo>
                <a:lnTo>
                  <a:pt x="2728443" y="950981"/>
                </a:lnTo>
                <a:lnTo>
                  <a:pt x="2787757" y="950981"/>
                </a:lnTo>
                <a:lnTo>
                  <a:pt x="2787757" y="887582"/>
                </a:lnTo>
                <a:lnTo>
                  <a:pt x="2787757" y="824183"/>
                </a:lnTo>
                <a:lnTo>
                  <a:pt x="2847071" y="824183"/>
                </a:lnTo>
                <a:lnTo>
                  <a:pt x="2906385" y="824183"/>
                </a:lnTo>
                <a:lnTo>
                  <a:pt x="2906385" y="760785"/>
                </a:lnTo>
                <a:lnTo>
                  <a:pt x="2965699" y="760785"/>
                </a:lnTo>
                <a:lnTo>
                  <a:pt x="3025013" y="760785"/>
                </a:lnTo>
                <a:lnTo>
                  <a:pt x="3084327" y="760785"/>
                </a:lnTo>
                <a:lnTo>
                  <a:pt x="3084327" y="697386"/>
                </a:lnTo>
                <a:lnTo>
                  <a:pt x="3143641" y="697386"/>
                </a:lnTo>
                <a:lnTo>
                  <a:pt x="3143641" y="633987"/>
                </a:lnTo>
                <a:lnTo>
                  <a:pt x="3202955" y="633987"/>
                </a:lnTo>
                <a:lnTo>
                  <a:pt x="3262269" y="633987"/>
                </a:lnTo>
                <a:lnTo>
                  <a:pt x="3262269" y="570588"/>
                </a:lnTo>
                <a:lnTo>
                  <a:pt x="3321583" y="570588"/>
                </a:lnTo>
                <a:lnTo>
                  <a:pt x="3380897" y="570588"/>
                </a:lnTo>
                <a:lnTo>
                  <a:pt x="3440211" y="570588"/>
                </a:lnTo>
                <a:lnTo>
                  <a:pt x="3440211" y="507190"/>
                </a:lnTo>
                <a:lnTo>
                  <a:pt x="3499525" y="507190"/>
                </a:lnTo>
                <a:lnTo>
                  <a:pt x="3558839" y="507190"/>
                </a:lnTo>
                <a:lnTo>
                  <a:pt x="3618153" y="507190"/>
                </a:lnTo>
                <a:lnTo>
                  <a:pt x="3677467" y="507190"/>
                </a:lnTo>
                <a:lnTo>
                  <a:pt x="3736781" y="507190"/>
                </a:lnTo>
                <a:lnTo>
                  <a:pt x="3796095" y="507190"/>
                </a:lnTo>
                <a:lnTo>
                  <a:pt x="3855409" y="507190"/>
                </a:lnTo>
                <a:lnTo>
                  <a:pt x="3855409" y="443791"/>
                </a:lnTo>
                <a:lnTo>
                  <a:pt x="3914723" y="443791"/>
                </a:lnTo>
                <a:lnTo>
                  <a:pt x="3974037" y="443791"/>
                </a:lnTo>
                <a:lnTo>
                  <a:pt x="4033351" y="443791"/>
                </a:lnTo>
                <a:lnTo>
                  <a:pt x="4092665" y="443791"/>
                </a:lnTo>
                <a:lnTo>
                  <a:pt x="4151979" y="443791"/>
                </a:lnTo>
                <a:lnTo>
                  <a:pt x="4211293" y="443791"/>
                </a:lnTo>
                <a:lnTo>
                  <a:pt x="4270607" y="443791"/>
                </a:lnTo>
                <a:lnTo>
                  <a:pt x="4270607" y="380392"/>
                </a:lnTo>
                <a:lnTo>
                  <a:pt x="4270607" y="316993"/>
                </a:lnTo>
                <a:lnTo>
                  <a:pt x="4329921" y="316993"/>
                </a:lnTo>
                <a:lnTo>
                  <a:pt x="4389235" y="316993"/>
                </a:lnTo>
                <a:lnTo>
                  <a:pt x="4448549" y="316993"/>
                </a:lnTo>
                <a:lnTo>
                  <a:pt x="4507863" y="316993"/>
                </a:lnTo>
                <a:lnTo>
                  <a:pt x="4567177" y="316993"/>
                </a:lnTo>
                <a:lnTo>
                  <a:pt x="4626491" y="316993"/>
                </a:lnTo>
                <a:lnTo>
                  <a:pt x="4685805" y="316993"/>
                </a:lnTo>
                <a:lnTo>
                  <a:pt x="4685805" y="253595"/>
                </a:lnTo>
                <a:lnTo>
                  <a:pt x="4745119" y="253595"/>
                </a:lnTo>
                <a:lnTo>
                  <a:pt x="4804433" y="253595"/>
                </a:lnTo>
                <a:lnTo>
                  <a:pt x="4863747" y="253595"/>
                </a:lnTo>
                <a:lnTo>
                  <a:pt x="4863747" y="190196"/>
                </a:lnTo>
                <a:lnTo>
                  <a:pt x="4923061" y="190196"/>
                </a:lnTo>
                <a:lnTo>
                  <a:pt x="4982375" y="190196"/>
                </a:lnTo>
                <a:lnTo>
                  <a:pt x="5041689" y="190196"/>
                </a:lnTo>
                <a:lnTo>
                  <a:pt x="5101003" y="190196"/>
                </a:lnTo>
                <a:lnTo>
                  <a:pt x="5160317" y="190196"/>
                </a:lnTo>
                <a:lnTo>
                  <a:pt x="5160317" y="126797"/>
                </a:lnTo>
                <a:lnTo>
                  <a:pt x="5160317" y="63398"/>
                </a:lnTo>
                <a:lnTo>
                  <a:pt x="5219631" y="63398"/>
                </a:lnTo>
                <a:lnTo>
                  <a:pt x="5219631" y="0"/>
                </a:lnTo>
                <a:lnTo>
                  <a:pt x="5278945" y="0"/>
                </a:lnTo>
                <a:lnTo>
                  <a:pt x="5338259" y="0"/>
                </a:lnTo>
              </a:path>
            </a:pathLst>
          </a:custGeom>
          <a:noFill/>
          <a:ln w="13680">
            <a:solidFill>
              <a:srgbClr val="ff0000"/>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1043" name="tx26" descr=""/>
          <p:cNvPicPr/>
          <p:nvPr/>
        </p:nvPicPr>
        <p:blipFill>
          <a:blip r:embed="rId86"/>
          <a:stretch/>
        </p:blipFill>
        <p:spPr>
          <a:xfrm>
            <a:off x="14452560" y="4392720"/>
            <a:ext cx="3711600" cy="244440"/>
          </a:xfrm>
          <a:prstGeom prst="rect">
            <a:avLst/>
          </a:prstGeom>
          <a:ln w="0">
            <a:noFill/>
          </a:ln>
        </p:spPr>
      </p:pic>
      <p:pic>
        <p:nvPicPr>
          <p:cNvPr id="1044" name="tx27" descr=""/>
          <p:cNvPicPr/>
          <p:nvPr/>
        </p:nvPicPr>
        <p:blipFill>
          <a:blip r:embed="rId87"/>
          <a:stretch/>
        </p:blipFill>
        <p:spPr>
          <a:xfrm>
            <a:off x="14452560" y="4673520"/>
            <a:ext cx="2357640" cy="203400"/>
          </a:xfrm>
          <a:prstGeom prst="rect">
            <a:avLst/>
          </a:prstGeom>
          <a:ln w="0">
            <a:noFill/>
          </a:ln>
        </p:spPr>
      </p:pic>
      <p:pic>
        <p:nvPicPr>
          <p:cNvPr id="1045" name="tx28" descr=""/>
          <p:cNvPicPr/>
          <p:nvPr/>
        </p:nvPicPr>
        <p:blipFill>
          <a:blip r:embed="rId88"/>
          <a:stretch/>
        </p:blipFill>
        <p:spPr>
          <a:xfrm>
            <a:off x="14454360" y="4916520"/>
            <a:ext cx="2357280" cy="203040"/>
          </a:xfrm>
          <a:prstGeom prst="rect">
            <a:avLst/>
          </a:prstGeom>
          <a:ln w="0">
            <a:noFill/>
          </a:ln>
        </p:spPr>
      </p:pic>
      <p:pic>
        <p:nvPicPr>
          <p:cNvPr id="1046" name="tx29" descr=""/>
          <p:cNvPicPr/>
          <p:nvPr/>
        </p:nvPicPr>
        <p:blipFill>
          <a:blip r:embed="rId89"/>
          <a:stretch/>
        </p:blipFill>
        <p:spPr>
          <a:xfrm>
            <a:off x="14452560" y="5402160"/>
            <a:ext cx="1082880" cy="203400"/>
          </a:xfrm>
          <a:prstGeom prst="rect">
            <a:avLst/>
          </a:prstGeom>
          <a:ln w="0">
            <a:noFill/>
          </a:ln>
        </p:spPr>
      </p:pic>
      <p:sp>
        <p:nvSpPr>
          <p:cNvPr id="1047" name="pl30"/>
          <p:cNvSpPr/>
          <p:nvPr/>
        </p:nvSpPr>
        <p:spPr>
          <a:xfrm>
            <a:off x="12336480" y="1000080"/>
            <a:ext cx="5872320" cy="5324400"/>
          </a:xfrm>
          <a:custGeom>
            <a:avLst/>
            <a:gdLst/>
            <a:ahLst/>
            <a:rect l="l" t="t" r="r" b="b"/>
            <a:pathLst>
              <a:path w="5872085" h="6136999">
                <a:moveTo>
                  <a:pt x="0" y="6136999"/>
                </a:moveTo>
                <a:lnTo>
                  <a:pt x="5872085" y="0"/>
                </a:lnTo>
              </a:path>
            </a:pathLst>
          </a:custGeom>
          <a:noFill/>
          <a:ln w="13680">
            <a:solidFill>
              <a:srgbClr val="000000"/>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48" name="rc31"/>
          <p:cNvSpPr/>
          <p:nvPr/>
        </p:nvSpPr>
        <p:spPr>
          <a:xfrm>
            <a:off x="12336480" y="1000080"/>
            <a:ext cx="5872320" cy="5324400"/>
          </a:xfrm>
          <a:prstGeom prst="rect">
            <a:avLst/>
          </a:prstGeom>
          <a:noFill/>
          <a:ln cap="rnd" w="13680">
            <a:solidFill>
              <a:srgbClr val="333333"/>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49" name="tx32"/>
          <p:cNvSpPr/>
          <p:nvPr/>
        </p:nvSpPr>
        <p:spPr>
          <a:xfrm>
            <a:off x="11779200" y="5999040"/>
            <a:ext cx="493920" cy="162000"/>
          </a:xfrm>
          <a:prstGeom prst="rect">
            <a:avLst/>
          </a:prstGeom>
          <a:noFill/>
          <a:ln w="0">
            <a:noFill/>
          </a:ln>
        </p:spPr>
        <p:style>
          <a:lnRef idx="0"/>
          <a:fillRef idx="0"/>
          <a:effectRef idx="0"/>
          <a:fontRef idx="minor"/>
        </p:style>
        <p:txBody>
          <a:bodyPr wrap="none" lIns="0" rIns="0" tIns="0" bIns="0" anchor="ctr" anchorCtr="1">
            <a:noAutofit/>
          </a:bodyPr>
          <a:p>
            <a:pPr>
              <a:lnSpc>
                <a:spcPts val="1998"/>
              </a:lnSpc>
              <a:tabLst>
                <a:tab algn="l" pos="0"/>
                <a:tab algn="l" pos="1487520"/>
                <a:tab algn="l" pos="2975040"/>
                <a:tab algn="l" pos="4462560"/>
                <a:tab algn="l" pos="5950080"/>
                <a:tab algn="l" pos="7437600"/>
                <a:tab algn="l" pos="8924760"/>
                <a:tab algn="l" pos="10412280"/>
              </a:tabLst>
            </a:pPr>
            <a:r>
              <a:rPr b="0" lang="zh-CN" sz="2000" spc="-1" strike="noStrike">
                <a:solidFill>
                  <a:srgbClr val="4d4d4d"/>
                </a:solidFill>
                <a:latin typeface="Arial"/>
              </a:rPr>
              <a:t>0.00</a:t>
            </a:r>
            <a:endParaRPr b="0" lang="en-US" sz="2000" spc="-1" strike="noStrike">
              <a:solidFill>
                <a:srgbClr val="000000"/>
              </a:solidFill>
              <a:latin typeface="Arial"/>
            </a:endParaRPr>
          </a:p>
        </p:txBody>
      </p:sp>
      <p:sp>
        <p:nvSpPr>
          <p:cNvPr id="1050" name="tx33"/>
          <p:cNvSpPr/>
          <p:nvPr/>
        </p:nvSpPr>
        <p:spPr>
          <a:xfrm>
            <a:off x="11779200" y="4789440"/>
            <a:ext cx="493920" cy="162000"/>
          </a:xfrm>
          <a:prstGeom prst="rect">
            <a:avLst/>
          </a:prstGeom>
          <a:noFill/>
          <a:ln w="0">
            <a:noFill/>
          </a:ln>
        </p:spPr>
        <p:style>
          <a:lnRef idx="0"/>
          <a:fillRef idx="0"/>
          <a:effectRef idx="0"/>
          <a:fontRef idx="minor"/>
        </p:style>
        <p:txBody>
          <a:bodyPr wrap="none" lIns="0" rIns="0" tIns="0" bIns="0" anchor="ctr" anchorCtr="1">
            <a:noAutofit/>
          </a:bodyPr>
          <a:p>
            <a:pPr>
              <a:lnSpc>
                <a:spcPts val="1998"/>
              </a:lnSpc>
              <a:tabLst>
                <a:tab algn="l" pos="0"/>
                <a:tab algn="l" pos="1487520"/>
                <a:tab algn="l" pos="2975040"/>
                <a:tab algn="l" pos="4462560"/>
                <a:tab algn="l" pos="5950080"/>
                <a:tab algn="l" pos="7437600"/>
                <a:tab algn="l" pos="8924760"/>
                <a:tab algn="l" pos="10412280"/>
              </a:tabLst>
            </a:pPr>
            <a:r>
              <a:rPr b="0" lang="zh-CN" sz="2000" spc="-1" strike="noStrike">
                <a:solidFill>
                  <a:srgbClr val="4d4d4d"/>
                </a:solidFill>
                <a:latin typeface="Arial"/>
              </a:rPr>
              <a:t>0.25</a:t>
            </a:r>
            <a:endParaRPr b="0" lang="en-US" sz="2000" spc="-1" strike="noStrike">
              <a:solidFill>
                <a:srgbClr val="000000"/>
              </a:solidFill>
              <a:latin typeface="Arial"/>
            </a:endParaRPr>
          </a:p>
        </p:txBody>
      </p:sp>
      <p:sp>
        <p:nvSpPr>
          <p:cNvPr id="1051" name="tx34"/>
          <p:cNvSpPr/>
          <p:nvPr/>
        </p:nvSpPr>
        <p:spPr>
          <a:xfrm>
            <a:off x="11779200" y="3579840"/>
            <a:ext cx="493920" cy="162000"/>
          </a:xfrm>
          <a:prstGeom prst="rect">
            <a:avLst/>
          </a:prstGeom>
          <a:noFill/>
          <a:ln w="0">
            <a:noFill/>
          </a:ln>
        </p:spPr>
        <p:style>
          <a:lnRef idx="0"/>
          <a:fillRef idx="0"/>
          <a:effectRef idx="0"/>
          <a:fontRef idx="minor"/>
        </p:style>
        <p:txBody>
          <a:bodyPr wrap="none" lIns="0" rIns="0" tIns="0" bIns="0" anchor="ctr" anchorCtr="1">
            <a:noAutofit/>
          </a:bodyPr>
          <a:p>
            <a:pPr>
              <a:lnSpc>
                <a:spcPts val="1998"/>
              </a:lnSpc>
              <a:tabLst>
                <a:tab algn="l" pos="0"/>
                <a:tab algn="l" pos="1487520"/>
                <a:tab algn="l" pos="2975040"/>
                <a:tab algn="l" pos="4462560"/>
                <a:tab algn="l" pos="5950080"/>
                <a:tab algn="l" pos="7437600"/>
                <a:tab algn="l" pos="8924760"/>
                <a:tab algn="l" pos="10412280"/>
              </a:tabLst>
            </a:pPr>
            <a:r>
              <a:rPr b="0" lang="zh-CN" sz="2000" spc="-1" strike="noStrike">
                <a:solidFill>
                  <a:srgbClr val="4d4d4d"/>
                </a:solidFill>
                <a:latin typeface="Arial"/>
              </a:rPr>
              <a:t>0.50</a:t>
            </a:r>
            <a:endParaRPr b="0" lang="en-US" sz="2000" spc="-1" strike="noStrike">
              <a:solidFill>
                <a:srgbClr val="000000"/>
              </a:solidFill>
              <a:latin typeface="Arial"/>
            </a:endParaRPr>
          </a:p>
        </p:txBody>
      </p:sp>
      <p:sp>
        <p:nvSpPr>
          <p:cNvPr id="1052" name="tx35"/>
          <p:cNvSpPr/>
          <p:nvPr/>
        </p:nvSpPr>
        <p:spPr>
          <a:xfrm>
            <a:off x="11779200" y="2370240"/>
            <a:ext cx="493920" cy="162000"/>
          </a:xfrm>
          <a:prstGeom prst="rect">
            <a:avLst/>
          </a:prstGeom>
          <a:noFill/>
          <a:ln w="0">
            <a:noFill/>
          </a:ln>
        </p:spPr>
        <p:style>
          <a:lnRef idx="0"/>
          <a:fillRef idx="0"/>
          <a:effectRef idx="0"/>
          <a:fontRef idx="minor"/>
        </p:style>
        <p:txBody>
          <a:bodyPr wrap="none" lIns="0" rIns="0" tIns="0" bIns="0" anchor="ctr" anchorCtr="1">
            <a:noAutofit/>
          </a:bodyPr>
          <a:p>
            <a:pPr>
              <a:lnSpc>
                <a:spcPts val="1998"/>
              </a:lnSpc>
              <a:tabLst>
                <a:tab algn="l" pos="0"/>
                <a:tab algn="l" pos="1487520"/>
                <a:tab algn="l" pos="2975040"/>
                <a:tab algn="l" pos="4462560"/>
                <a:tab algn="l" pos="5950080"/>
                <a:tab algn="l" pos="7437600"/>
                <a:tab algn="l" pos="8924760"/>
                <a:tab algn="l" pos="10412280"/>
              </a:tabLst>
            </a:pPr>
            <a:r>
              <a:rPr b="0" lang="zh-CN" sz="2000" spc="-1" strike="noStrike">
                <a:solidFill>
                  <a:srgbClr val="4d4d4d"/>
                </a:solidFill>
                <a:latin typeface="Arial"/>
              </a:rPr>
              <a:t>0.75</a:t>
            </a:r>
            <a:endParaRPr b="0" lang="en-US" sz="2000" spc="-1" strike="noStrike">
              <a:solidFill>
                <a:srgbClr val="000000"/>
              </a:solidFill>
              <a:latin typeface="Arial"/>
            </a:endParaRPr>
          </a:p>
        </p:txBody>
      </p:sp>
      <p:sp>
        <p:nvSpPr>
          <p:cNvPr id="1053" name="tx36"/>
          <p:cNvSpPr/>
          <p:nvPr/>
        </p:nvSpPr>
        <p:spPr>
          <a:xfrm>
            <a:off x="11779200" y="1160640"/>
            <a:ext cx="493920" cy="160200"/>
          </a:xfrm>
          <a:prstGeom prst="rect">
            <a:avLst/>
          </a:prstGeom>
          <a:noFill/>
          <a:ln w="0">
            <a:noFill/>
          </a:ln>
        </p:spPr>
        <p:style>
          <a:lnRef idx="0"/>
          <a:fillRef idx="0"/>
          <a:effectRef idx="0"/>
          <a:fontRef idx="minor"/>
        </p:style>
        <p:txBody>
          <a:bodyPr wrap="none" lIns="0" rIns="0" tIns="0" bIns="0" anchor="ctr" anchorCtr="1">
            <a:noAutofit/>
          </a:bodyPr>
          <a:p>
            <a:pPr>
              <a:lnSpc>
                <a:spcPts val="1998"/>
              </a:lnSpc>
              <a:tabLst>
                <a:tab algn="l" pos="0"/>
                <a:tab algn="l" pos="1487520"/>
                <a:tab algn="l" pos="2975040"/>
                <a:tab algn="l" pos="4462560"/>
                <a:tab algn="l" pos="5950080"/>
                <a:tab algn="l" pos="7437600"/>
                <a:tab algn="l" pos="8924760"/>
                <a:tab algn="l" pos="10412280"/>
              </a:tabLst>
            </a:pPr>
            <a:r>
              <a:rPr b="0" lang="zh-CN" sz="2000" spc="-1" strike="noStrike">
                <a:solidFill>
                  <a:srgbClr val="4d4d4d"/>
                </a:solidFill>
                <a:latin typeface="Arial"/>
              </a:rPr>
              <a:t>1.00</a:t>
            </a:r>
            <a:endParaRPr b="0" lang="en-US" sz="2000" spc="-1" strike="noStrike">
              <a:solidFill>
                <a:srgbClr val="000000"/>
              </a:solidFill>
              <a:latin typeface="Arial"/>
            </a:endParaRPr>
          </a:p>
        </p:txBody>
      </p:sp>
      <p:sp>
        <p:nvSpPr>
          <p:cNvPr id="1054" name="pl37"/>
          <p:cNvSpPr/>
          <p:nvPr/>
        </p:nvSpPr>
        <p:spPr>
          <a:xfrm>
            <a:off x="12301560" y="6081840"/>
            <a:ext cx="3492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55" name="pl38"/>
          <p:cNvSpPr/>
          <p:nvPr/>
        </p:nvSpPr>
        <p:spPr>
          <a:xfrm>
            <a:off x="12301560" y="4871880"/>
            <a:ext cx="3492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56" name="pl39"/>
          <p:cNvSpPr/>
          <p:nvPr/>
        </p:nvSpPr>
        <p:spPr>
          <a:xfrm>
            <a:off x="12301560" y="3662280"/>
            <a:ext cx="3492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57" name="pl40"/>
          <p:cNvSpPr/>
          <p:nvPr/>
        </p:nvSpPr>
        <p:spPr>
          <a:xfrm>
            <a:off x="12301560" y="2452680"/>
            <a:ext cx="3492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58" name="pl41"/>
          <p:cNvSpPr/>
          <p:nvPr/>
        </p:nvSpPr>
        <p:spPr>
          <a:xfrm>
            <a:off x="12301560" y="1243080"/>
            <a:ext cx="34920" cy="360"/>
          </a:xfrm>
          <a:custGeom>
            <a:avLst/>
            <a:gdLst/>
            <a:ahLst/>
            <a:rect l="l" t="t" r="r" b="b"/>
            <a:pathLst>
              <a:path w="34794" h="1">
                <a:moveTo>
                  <a:pt x="0" y="0"/>
                </a:moveTo>
                <a:lnTo>
                  <a:pt x="34794" y="0"/>
                </a:lnTo>
              </a:path>
            </a:pathLst>
          </a:custGeom>
          <a:noFill/>
          <a:ln w="13680">
            <a:solidFill>
              <a:srgbClr val="333333"/>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59" name="pl42"/>
          <p:cNvSpPr/>
          <p:nvPr/>
        </p:nvSpPr>
        <p:spPr>
          <a:xfrm>
            <a:off x="17940240" y="6324480"/>
            <a:ext cx="360" cy="30240"/>
          </a:xfrm>
          <a:custGeom>
            <a:avLst/>
            <a:gdLst/>
            <a:ahLst/>
            <a:rect l="l" t="t" r="r" b="b"/>
            <a:pathLst>
              <a:path w="1" h="34794">
                <a:moveTo>
                  <a:pt x="0" y="34794"/>
                </a:moveTo>
                <a:lnTo>
                  <a:pt x="0" y="0"/>
                </a:lnTo>
              </a:path>
            </a:pathLst>
          </a:custGeom>
          <a:noFill/>
          <a:ln w="13680">
            <a:solidFill>
              <a:srgbClr val="333333"/>
            </a:solidFill>
            <a:round/>
          </a:ln>
        </p:spPr>
        <p:style>
          <a:lnRef idx="0"/>
          <a:fillRef idx="0"/>
          <a:effectRef idx="0"/>
          <a:fontRef idx="minor"/>
        </p:style>
        <p:txBody>
          <a:bodyPr lIns="90000" rIns="90000" tIns="-16560" bIns="-165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60" name="pl43"/>
          <p:cNvSpPr/>
          <p:nvPr/>
        </p:nvSpPr>
        <p:spPr>
          <a:xfrm>
            <a:off x="16606800" y="6324480"/>
            <a:ext cx="360" cy="30240"/>
          </a:xfrm>
          <a:custGeom>
            <a:avLst/>
            <a:gdLst/>
            <a:ahLst/>
            <a:rect l="l" t="t" r="r" b="b"/>
            <a:pathLst>
              <a:path w="1" h="34794">
                <a:moveTo>
                  <a:pt x="0" y="34794"/>
                </a:moveTo>
                <a:lnTo>
                  <a:pt x="0" y="0"/>
                </a:lnTo>
              </a:path>
            </a:pathLst>
          </a:custGeom>
          <a:noFill/>
          <a:ln w="13680">
            <a:solidFill>
              <a:srgbClr val="333333"/>
            </a:solidFill>
            <a:round/>
          </a:ln>
        </p:spPr>
        <p:style>
          <a:lnRef idx="0"/>
          <a:fillRef idx="0"/>
          <a:effectRef idx="0"/>
          <a:fontRef idx="minor"/>
        </p:style>
        <p:txBody>
          <a:bodyPr lIns="90000" rIns="90000" tIns="-16560" bIns="-165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61" name="pl44"/>
          <p:cNvSpPr/>
          <p:nvPr/>
        </p:nvSpPr>
        <p:spPr>
          <a:xfrm>
            <a:off x="15271920" y="6324480"/>
            <a:ext cx="360" cy="30240"/>
          </a:xfrm>
          <a:custGeom>
            <a:avLst/>
            <a:gdLst/>
            <a:ahLst/>
            <a:rect l="l" t="t" r="r" b="b"/>
            <a:pathLst>
              <a:path w="1" h="34794">
                <a:moveTo>
                  <a:pt x="0" y="34794"/>
                </a:moveTo>
                <a:lnTo>
                  <a:pt x="0" y="0"/>
                </a:lnTo>
              </a:path>
            </a:pathLst>
          </a:custGeom>
          <a:noFill/>
          <a:ln w="13680">
            <a:solidFill>
              <a:srgbClr val="333333"/>
            </a:solidFill>
            <a:round/>
          </a:ln>
        </p:spPr>
        <p:style>
          <a:lnRef idx="0"/>
          <a:fillRef idx="0"/>
          <a:effectRef idx="0"/>
          <a:fontRef idx="minor"/>
        </p:style>
        <p:txBody>
          <a:bodyPr lIns="90000" rIns="90000" tIns="-16560" bIns="-165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62" name="pl45"/>
          <p:cNvSpPr/>
          <p:nvPr/>
        </p:nvSpPr>
        <p:spPr>
          <a:xfrm>
            <a:off x="13936680" y="6324480"/>
            <a:ext cx="360" cy="30240"/>
          </a:xfrm>
          <a:custGeom>
            <a:avLst/>
            <a:gdLst/>
            <a:ahLst/>
            <a:rect l="l" t="t" r="r" b="b"/>
            <a:pathLst>
              <a:path w="1" h="34794">
                <a:moveTo>
                  <a:pt x="0" y="34794"/>
                </a:moveTo>
                <a:lnTo>
                  <a:pt x="0" y="0"/>
                </a:lnTo>
              </a:path>
            </a:pathLst>
          </a:custGeom>
          <a:noFill/>
          <a:ln w="13680">
            <a:solidFill>
              <a:srgbClr val="333333"/>
            </a:solidFill>
            <a:round/>
          </a:ln>
        </p:spPr>
        <p:style>
          <a:lnRef idx="0"/>
          <a:fillRef idx="0"/>
          <a:effectRef idx="0"/>
          <a:fontRef idx="minor"/>
        </p:style>
        <p:txBody>
          <a:bodyPr lIns="90000" rIns="90000" tIns="-16560" bIns="-165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63" name="pl46"/>
          <p:cNvSpPr/>
          <p:nvPr/>
        </p:nvSpPr>
        <p:spPr>
          <a:xfrm>
            <a:off x="12603240" y="6324480"/>
            <a:ext cx="360" cy="30240"/>
          </a:xfrm>
          <a:custGeom>
            <a:avLst/>
            <a:gdLst/>
            <a:ahLst/>
            <a:rect l="l" t="t" r="r" b="b"/>
            <a:pathLst>
              <a:path w="1" h="34794">
                <a:moveTo>
                  <a:pt x="0" y="34794"/>
                </a:moveTo>
                <a:lnTo>
                  <a:pt x="0" y="0"/>
                </a:lnTo>
              </a:path>
            </a:pathLst>
          </a:custGeom>
          <a:noFill/>
          <a:ln w="13680">
            <a:solidFill>
              <a:srgbClr val="333333"/>
            </a:solidFill>
            <a:round/>
          </a:ln>
        </p:spPr>
        <p:style>
          <a:lnRef idx="0"/>
          <a:fillRef idx="0"/>
          <a:effectRef idx="0"/>
          <a:fontRef idx="minor"/>
        </p:style>
        <p:txBody>
          <a:bodyPr lIns="90000" rIns="90000" tIns="-16560" bIns="-1656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64" name="tx47"/>
          <p:cNvSpPr/>
          <p:nvPr/>
        </p:nvSpPr>
        <p:spPr>
          <a:xfrm>
            <a:off x="17694360" y="6431040"/>
            <a:ext cx="493560" cy="160200"/>
          </a:xfrm>
          <a:prstGeom prst="rect">
            <a:avLst/>
          </a:prstGeom>
          <a:noFill/>
          <a:ln w="0">
            <a:noFill/>
          </a:ln>
        </p:spPr>
        <p:style>
          <a:lnRef idx="0"/>
          <a:fillRef idx="0"/>
          <a:effectRef idx="0"/>
          <a:fontRef idx="minor"/>
        </p:style>
        <p:txBody>
          <a:bodyPr wrap="none" lIns="0" rIns="0" tIns="0" bIns="0" anchor="ctr" anchorCtr="1">
            <a:noAutofit/>
          </a:bodyPr>
          <a:p>
            <a:pPr>
              <a:lnSpc>
                <a:spcPts val="1998"/>
              </a:lnSpc>
              <a:tabLst>
                <a:tab algn="l" pos="0"/>
                <a:tab algn="l" pos="1487520"/>
                <a:tab algn="l" pos="2975040"/>
                <a:tab algn="l" pos="4462560"/>
                <a:tab algn="l" pos="5950080"/>
                <a:tab algn="l" pos="7437600"/>
                <a:tab algn="l" pos="8924760"/>
                <a:tab algn="l" pos="10412280"/>
              </a:tabLst>
            </a:pPr>
            <a:r>
              <a:rPr b="0" lang="zh-CN" sz="2000" spc="-1" strike="noStrike">
                <a:solidFill>
                  <a:srgbClr val="4d4d4d"/>
                </a:solidFill>
                <a:latin typeface="Arial"/>
              </a:rPr>
              <a:t>0.00</a:t>
            </a:r>
            <a:endParaRPr b="0" lang="en-US" sz="2000" spc="-1" strike="noStrike">
              <a:solidFill>
                <a:srgbClr val="000000"/>
              </a:solidFill>
              <a:latin typeface="Arial"/>
            </a:endParaRPr>
          </a:p>
        </p:txBody>
      </p:sp>
      <p:sp>
        <p:nvSpPr>
          <p:cNvPr id="1065" name="tx48"/>
          <p:cNvSpPr/>
          <p:nvPr/>
        </p:nvSpPr>
        <p:spPr>
          <a:xfrm>
            <a:off x="16359120" y="6431040"/>
            <a:ext cx="493920" cy="160200"/>
          </a:xfrm>
          <a:prstGeom prst="rect">
            <a:avLst/>
          </a:prstGeom>
          <a:noFill/>
          <a:ln w="0">
            <a:noFill/>
          </a:ln>
        </p:spPr>
        <p:style>
          <a:lnRef idx="0"/>
          <a:fillRef idx="0"/>
          <a:effectRef idx="0"/>
          <a:fontRef idx="minor"/>
        </p:style>
        <p:txBody>
          <a:bodyPr wrap="none" lIns="0" rIns="0" tIns="0" bIns="0" anchor="ctr" anchorCtr="1">
            <a:noAutofit/>
          </a:bodyPr>
          <a:p>
            <a:pPr>
              <a:lnSpc>
                <a:spcPts val="1998"/>
              </a:lnSpc>
              <a:tabLst>
                <a:tab algn="l" pos="0"/>
                <a:tab algn="l" pos="1487520"/>
                <a:tab algn="l" pos="2975040"/>
                <a:tab algn="l" pos="4462560"/>
                <a:tab algn="l" pos="5950080"/>
                <a:tab algn="l" pos="7437600"/>
                <a:tab algn="l" pos="8924760"/>
                <a:tab algn="l" pos="10412280"/>
              </a:tabLst>
            </a:pPr>
            <a:r>
              <a:rPr b="0" lang="zh-CN" sz="2000" spc="-1" strike="noStrike">
                <a:solidFill>
                  <a:srgbClr val="4d4d4d"/>
                </a:solidFill>
                <a:latin typeface="Arial"/>
              </a:rPr>
              <a:t>0.25</a:t>
            </a:r>
            <a:endParaRPr b="0" lang="en-US" sz="2000" spc="-1" strike="noStrike">
              <a:solidFill>
                <a:srgbClr val="000000"/>
              </a:solidFill>
              <a:latin typeface="Arial"/>
            </a:endParaRPr>
          </a:p>
        </p:txBody>
      </p:sp>
      <p:sp>
        <p:nvSpPr>
          <p:cNvPr id="1066" name="tx49"/>
          <p:cNvSpPr/>
          <p:nvPr/>
        </p:nvSpPr>
        <p:spPr>
          <a:xfrm>
            <a:off x="15024240" y="6431040"/>
            <a:ext cx="495000" cy="160200"/>
          </a:xfrm>
          <a:prstGeom prst="rect">
            <a:avLst/>
          </a:prstGeom>
          <a:noFill/>
          <a:ln w="0">
            <a:noFill/>
          </a:ln>
        </p:spPr>
        <p:style>
          <a:lnRef idx="0"/>
          <a:fillRef idx="0"/>
          <a:effectRef idx="0"/>
          <a:fontRef idx="minor"/>
        </p:style>
        <p:txBody>
          <a:bodyPr wrap="none" lIns="0" rIns="0" tIns="0" bIns="0" anchor="ctr" anchorCtr="1">
            <a:noAutofit/>
          </a:bodyPr>
          <a:p>
            <a:pPr>
              <a:lnSpc>
                <a:spcPts val="1998"/>
              </a:lnSpc>
              <a:tabLst>
                <a:tab algn="l" pos="0"/>
                <a:tab algn="l" pos="1487520"/>
                <a:tab algn="l" pos="2975040"/>
                <a:tab algn="l" pos="4462560"/>
                <a:tab algn="l" pos="5950080"/>
                <a:tab algn="l" pos="7437600"/>
                <a:tab algn="l" pos="8924760"/>
                <a:tab algn="l" pos="10412280"/>
              </a:tabLst>
            </a:pPr>
            <a:r>
              <a:rPr b="0" lang="zh-CN" sz="2000" spc="-1" strike="noStrike">
                <a:solidFill>
                  <a:srgbClr val="4d4d4d"/>
                </a:solidFill>
                <a:latin typeface="Arial"/>
              </a:rPr>
              <a:t>0.50</a:t>
            </a:r>
            <a:endParaRPr b="0" lang="en-US" sz="2000" spc="-1" strike="noStrike">
              <a:solidFill>
                <a:srgbClr val="000000"/>
              </a:solidFill>
              <a:latin typeface="Arial"/>
            </a:endParaRPr>
          </a:p>
        </p:txBody>
      </p:sp>
      <p:sp>
        <p:nvSpPr>
          <p:cNvPr id="1067" name="tx50"/>
          <p:cNvSpPr/>
          <p:nvPr/>
        </p:nvSpPr>
        <p:spPr>
          <a:xfrm>
            <a:off x="13690440" y="6431040"/>
            <a:ext cx="493920" cy="160200"/>
          </a:xfrm>
          <a:prstGeom prst="rect">
            <a:avLst/>
          </a:prstGeom>
          <a:noFill/>
          <a:ln w="0">
            <a:noFill/>
          </a:ln>
        </p:spPr>
        <p:style>
          <a:lnRef idx="0"/>
          <a:fillRef idx="0"/>
          <a:effectRef idx="0"/>
          <a:fontRef idx="minor"/>
        </p:style>
        <p:txBody>
          <a:bodyPr wrap="none" lIns="0" rIns="0" tIns="0" bIns="0" anchor="ctr" anchorCtr="1">
            <a:noAutofit/>
          </a:bodyPr>
          <a:p>
            <a:pPr>
              <a:lnSpc>
                <a:spcPts val="1998"/>
              </a:lnSpc>
              <a:tabLst>
                <a:tab algn="l" pos="0"/>
                <a:tab algn="l" pos="1487520"/>
                <a:tab algn="l" pos="2975040"/>
                <a:tab algn="l" pos="4462560"/>
                <a:tab algn="l" pos="5950080"/>
                <a:tab algn="l" pos="7437600"/>
                <a:tab algn="l" pos="8924760"/>
                <a:tab algn="l" pos="10412280"/>
              </a:tabLst>
            </a:pPr>
            <a:r>
              <a:rPr b="0" lang="zh-CN" sz="2000" spc="-1" strike="noStrike">
                <a:solidFill>
                  <a:srgbClr val="4d4d4d"/>
                </a:solidFill>
                <a:latin typeface="Arial"/>
              </a:rPr>
              <a:t>0.75</a:t>
            </a:r>
            <a:endParaRPr b="0" lang="en-US" sz="2000" spc="-1" strike="noStrike">
              <a:solidFill>
                <a:srgbClr val="000000"/>
              </a:solidFill>
              <a:latin typeface="Arial"/>
            </a:endParaRPr>
          </a:p>
        </p:txBody>
      </p:sp>
      <p:sp>
        <p:nvSpPr>
          <p:cNvPr id="1068" name="tx51"/>
          <p:cNvSpPr/>
          <p:nvPr/>
        </p:nvSpPr>
        <p:spPr>
          <a:xfrm>
            <a:off x="12355560" y="6431040"/>
            <a:ext cx="493560" cy="160200"/>
          </a:xfrm>
          <a:prstGeom prst="rect">
            <a:avLst/>
          </a:prstGeom>
          <a:noFill/>
          <a:ln w="0">
            <a:noFill/>
          </a:ln>
        </p:spPr>
        <p:style>
          <a:lnRef idx="0"/>
          <a:fillRef idx="0"/>
          <a:effectRef idx="0"/>
          <a:fontRef idx="minor"/>
        </p:style>
        <p:txBody>
          <a:bodyPr wrap="none" lIns="0" rIns="0" tIns="0" bIns="0" anchor="ctr" anchorCtr="1">
            <a:noAutofit/>
          </a:bodyPr>
          <a:p>
            <a:pPr>
              <a:lnSpc>
                <a:spcPts val="1998"/>
              </a:lnSpc>
              <a:tabLst>
                <a:tab algn="l" pos="0"/>
                <a:tab algn="l" pos="1487520"/>
                <a:tab algn="l" pos="2975040"/>
                <a:tab algn="l" pos="4462560"/>
                <a:tab algn="l" pos="5950080"/>
                <a:tab algn="l" pos="7437600"/>
                <a:tab algn="l" pos="8924760"/>
                <a:tab algn="l" pos="10412280"/>
              </a:tabLst>
            </a:pPr>
            <a:r>
              <a:rPr b="0" lang="zh-CN" sz="2000" spc="-1" strike="noStrike">
                <a:solidFill>
                  <a:srgbClr val="4d4d4d"/>
                </a:solidFill>
                <a:latin typeface="Arial"/>
              </a:rPr>
              <a:t>1.00</a:t>
            </a:r>
            <a:endParaRPr b="0" lang="en-US" sz="2000" spc="-1" strike="noStrike">
              <a:solidFill>
                <a:srgbClr val="000000"/>
              </a:solidFill>
              <a:latin typeface="Arial"/>
            </a:endParaRPr>
          </a:p>
        </p:txBody>
      </p:sp>
      <p:sp>
        <p:nvSpPr>
          <p:cNvPr id="1069" name="tx52"/>
          <p:cNvSpPr/>
          <p:nvPr/>
        </p:nvSpPr>
        <p:spPr>
          <a:xfrm>
            <a:off x="14586120" y="6721560"/>
            <a:ext cx="1371600" cy="249120"/>
          </a:xfrm>
          <a:prstGeom prst="rect">
            <a:avLst/>
          </a:prstGeom>
          <a:noFill/>
          <a:ln w="0">
            <a:noFill/>
          </a:ln>
        </p:spPr>
        <p:style>
          <a:lnRef idx="0"/>
          <a:fillRef idx="0"/>
          <a:effectRef idx="0"/>
          <a:fontRef idx="minor"/>
        </p:style>
        <p:txBody>
          <a:bodyPr wrap="none" lIns="0" rIns="0" tIns="0" bIns="0" anchor="ctr" anchorCtr="1">
            <a:noAutofit/>
          </a:bodyPr>
          <a:p>
            <a:pPr>
              <a:lnSpc>
                <a:spcPts val="2398"/>
              </a:lnSpc>
              <a:tabLst>
                <a:tab algn="l" pos="0"/>
                <a:tab algn="l" pos="1487520"/>
                <a:tab algn="l" pos="2975040"/>
                <a:tab algn="l" pos="4462560"/>
                <a:tab algn="l" pos="5950080"/>
                <a:tab algn="l" pos="7437600"/>
                <a:tab algn="l" pos="8924760"/>
                <a:tab algn="l" pos="10412280"/>
              </a:tabLst>
            </a:pPr>
            <a:r>
              <a:rPr b="0" lang="zh-CN" sz="2400" spc="-1" strike="noStrike">
                <a:solidFill>
                  <a:srgbClr val="000000"/>
                </a:solidFill>
                <a:latin typeface="Arial"/>
              </a:rPr>
              <a:t>Specificity</a:t>
            </a:r>
            <a:endParaRPr b="0" lang="en-US" sz="2400" spc="-1" strike="noStrike">
              <a:solidFill>
                <a:srgbClr val="000000"/>
              </a:solidFill>
              <a:latin typeface="Arial"/>
            </a:endParaRPr>
          </a:p>
        </p:txBody>
      </p:sp>
      <p:sp>
        <p:nvSpPr>
          <p:cNvPr id="1070" name="tx53"/>
          <p:cNvSpPr/>
          <p:nvPr/>
        </p:nvSpPr>
        <p:spPr>
          <a:xfrm rot="16200000">
            <a:off x="10720440" y="3519360"/>
            <a:ext cx="1190520" cy="285480"/>
          </a:xfrm>
          <a:prstGeom prst="rect">
            <a:avLst/>
          </a:prstGeom>
          <a:noFill/>
          <a:ln w="0">
            <a:noFill/>
          </a:ln>
        </p:spPr>
        <p:style>
          <a:lnRef idx="0"/>
          <a:fillRef idx="0"/>
          <a:effectRef idx="0"/>
          <a:fontRef idx="minor"/>
        </p:style>
        <p:txBody>
          <a:bodyPr wrap="none" lIns="0" rIns="0" tIns="0" bIns="0" anchor="ctr" anchorCtr="1">
            <a:noAutofit/>
          </a:bodyPr>
          <a:p>
            <a:pPr>
              <a:lnSpc>
                <a:spcPts val="2398"/>
              </a:lnSpc>
              <a:tabLst>
                <a:tab algn="l" pos="0"/>
                <a:tab algn="l" pos="1487520"/>
                <a:tab algn="l" pos="2975040"/>
                <a:tab algn="l" pos="4462560"/>
                <a:tab algn="l" pos="5950080"/>
                <a:tab algn="l" pos="7437600"/>
                <a:tab algn="l" pos="8924760"/>
                <a:tab algn="l" pos="10412280"/>
              </a:tabLst>
            </a:pPr>
            <a:r>
              <a:rPr b="0" lang="zh-CN" sz="2400" spc="-1" strike="noStrike">
                <a:solidFill>
                  <a:srgbClr val="000000"/>
                </a:solidFill>
                <a:latin typeface="Arial"/>
              </a:rPr>
              <a:t>Sensitivity</a:t>
            </a:r>
            <a:endParaRPr b="0" lang="en-US" sz="2400" spc="-1" strike="noStrike">
              <a:solidFill>
                <a:srgbClr val="000000"/>
              </a:solidFill>
              <a:latin typeface="Arial"/>
            </a:endParaRPr>
          </a:p>
        </p:txBody>
      </p:sp>
      <p:sp>
        <p:nvSpPr>
          <p:cNvPr id="1071" name="rc54"/>
          <p:cNvSpPr/>
          <p:nvPr/>
        </p:nvSpPr>
        <p:spPr>
          <a:xfrm>
            <a:off x="12942720" y="1055520"/>
            <a:ext cx="1135080" cy="954360"/>
          </a:xfrm>
          <a:prstGeom prst="rect">
            <a:avLst/>
          </a:prstGeom>
          <a:solidFill>
            <a:srgbClr val="ffffff"/>
          </a:solidFill>
          <a:ln cap="rnd" w="13680">
            <a:solidFill>
              <a:srgbClr val="000000"/>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72" name="rc55"/>
          <p:cNvSpPr/>
          <p:nvPr/>
        </p:nvSpPr>
        <p:spPr>
          <a:xfrm>
            <a:off x="13012560" y="1176480"/>
            <a:ext cx="219240" cy="38736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73" name="pl56"/>
          <p:cNvSpPr/>
          <p:nvPr/>
        </p:nvSpPr>
        <p:spPr>
          <a:xfrm>
            <a:off x="13033440" y="1370160"/>
            <a:ext cx="176040" cy="360"/>
          </a:xfrm>
          <a:custGeom>
            <a:avLst/>
            <a:gdLst/>
            <a:ahLst/>
            <a:rect l="l" t="t" r="r" b="b"/>
            <a:pathLst>
              <a:path w="175564" h="1">
                <a:moveTo>
                  <a:pt x="0" y="0"/>
                </a:moveTo>
                <a:lnTo>
                  <a:pt x="175564" y="0"/>
                </a:lnTo>
              </a:path>
            </a:pathLst>
          </a:custGeom>
          <a:noFill/>
          <a:ln w="1368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74" name="rc57"/>
          <p:cNvSpPr/>
          <p:nvPr/>
        </p:nvSpPr>
        <p:spPr>
          <a:xfrm>
            <a:off x="13012560" y="1563840"/>
            <a:ext cx="219240" cy="38556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75" name="pl58"/>
          <p:cNvSpPr/>
          <p:nvPr/>
        </p:nvSpPr>
        <p:spPr>
          <a:xfrm>
            <a:off x="13033440" y="1755720"/>
            <a:ext cx="176040" cy="360"/>
          </a:xfrm>
          <a:custGeom>
            <a:avLst/>
            <a:gdLst/>
            <a:ahLst/>
            <a:rect l="l" t="t" r="r" b="b"/>
            <a:pathLst>
              <a:path w="175564" h="1">
                <a:moveTo>
                  <a:pt x="0" y="0"/>
                </a:moveTo>
                <a:lnTo>
                  <a:pt x="175564" y="0"/>
                </a:lnTo>
              </a:path>
            </a:pathLst>
          </a:custGeom>
          <a:noFill/>
          <a:ln w="13680">
            <a:solidFill>
              <a:srgbClr val="ff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76" name="tx59"/>
          <p:cNvSpPr/>
          <p:nvPr/>
        </p:nvSpPr>
        <p:spPr>
          <a:xfrm>
            <a:off x="13409640" y="1279440"/>
            <a:ext cx="409680" cy="162000"/>
          </a:xfrm>
          <a:prstGeom prst="rect">
            <a:avLst/>
          </a:prstGeom>
          <a:noFill/>
          <a:ln w="0">
            <a:noFill/>
          </a:ln>
        </p:spPr>
        <p:style>
          <a:lnRef idx="0"/>
          <a:fillRef idx="0"/>
          <a:effectRef idx="0"/>
          <a:fontRef idx="minor"/>
        </p:style>
        <p:txBody>
          <a:bodyPr wrap="none" lIns="0" rIns="0" tIns="0" bIns="0" anchor="ctr" anchorCtr="1">
            <a:noAutofit/>
          </a:bodyPr>
          <a:p>
            <a:pPr>
              <a:lnSpc>
                <a:spcPts val="1998"/>
              </a:lnSpc>
              <a:tabLst>
                <a:tab algn="l" pos="0"/>
                <a:tab algn="l" pos="1487520"/>
                <a:tab algn="l" pos="2975040"/>
                <a:tab algn="l" pos="4462560"/>
                <a:tab algn="l" pos="5950080"/>
                <a:tab algn="l" pos="7437600"/>
                <a:tab algn="l" pos="8924760"/>
                <a:tab algn="l" pos="10412280"/>
              </a:tabLst>
            </a:pPr>
            <a:r>
              <a:rPr b="0" lang="zh-CN" sz="2000" spc="-1" strike="noStrike">
                <a:solidFill>
                  <a:srgbClr val="000000"/>
                </a:solidFill>
                <a:latin typeface="Arial"/>
              </a:rPr>
              <a:t>1se</a:t>
            </a:r>
            <a:endParaRPr b="0" lang="en-US" sz="2000" spc="-1" strike="noStrike">
              <a:solidFill>
                <a:srgbClr val="000000"/>
              </a:solidFill>
              <a:latin typeface="Arial"/>
            </a:endParaRPr>
          </a:p>
        </p:txBody>
      </p:sp>
      <p:sp>
        <p:nvSpPr>
          <p:cNvPr id="1077" name="tx60"/>
          <p:cNvSpPr/>
          <p:nvPr/>
        </p:nvSpPr>
        <p:spPr>
          <a:xfrm>
            <a:off x="13409640" y="1670040"/>
            <a:ext cx="409680" cy="157320"/>
          </a:xfrm>
          <a:prstGeom prst="rect">
            <a:avLst/>
          </a:prstGeom>
          <a:noFill/>
          <a:ln w="0">
            <a:noFill/>
          </a:ln>
        </p:spPr>
        <p:style>
          <a:lnRef idx="0"/>
          <a:fillRef idx="0"/>
          <a:effectRef idx="0"/>
          <a:fontRef idx="minor"/>
        </p:style>
        <p:txBody>
          <a:bodyPr wrap="none" lIns="0" rIns="0" tIns="0" bIns="0" anchor="ctr" anchorCtr="1">
            <a:noAutofit/>
          </a:bodyPr>
          <a:p>
            <a:pPr>
              <a:lnSpc>
                <a:spcPts val="1998"/>
              </a:lnSpc>
              <a:tabLst>
                <a:tab algn="l" pos="0"/>
                <a:tab algn="l" pos="1487520"/>
                <a:tab algn="l" pos="2975040"/>
                <a:tab algn="l" pos="4462560"/>
                <a:tab algn="l" pos="5950080"/>
                <a:tab algn="l" pos="7437600"/>
                <a:tab algn="l" pos="8924760"/>
                <a:tab algn="l" pos="10412280"/>
              </a:tabLst>
            </a:pPr>
            <a:r>
              <a:rPr b="0" lang="zh-CN" sz="2000" spc="-1" strike="noStrike">
                <a:solidFill>
                  <a:srgbClr val="000000"/>
                </a:solidFill>
                <a:latin typeface="Arial"/>
              </a:rPr>
              <a:t>min</a:t>
            </a:r>
            <a:endParaRPr b="0" lang="en-US" sz="2000" spc="-1" strike="noStrike">
              <a:solidFill>
                <a:srgbClr val="000000"/>
              </a:solidFill>
              <a:latin typeface="Arial"/>
            </a:endParaRPr>
          </a:p>
        </p:txBody>
      </p:sp>
      <p:sp>
        <p:nvSpPr>
          <p:cNvPr id="1078" name="文本框 121"/>
          <p:cNvSpPr/>
          <p:nvPr/>
        </p:nvSpPr>
        <p:spPr>
          <a:xfrm>
            <a:off x="13650840" y="414360"/>
            <a:ext cx="288612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1487520"/>
                <a:tab algn="l" pos="2975040"/>
                <a:tab algn="l" pos="4462560"/>
                <a:tab algn="l" pos="5950080"/>
                <a:tab algn="l" pos="7437600"/>
                <a:tab algn="l" pos="8924760"/>
                <a:tab algn="l" pos="10412280"/>
              </a:tabLst>
            </a:pPr>
            <a:r>
              <a:rPr b="0" lang="en-US" sz="1800" spc="-1" strike="noStrike">
                <a:solidFill>
                  <a:srgbClr val="000000"/>
                </a:solidFill>
                <a:latin typeface="Times New Roman"/>
              </a:rPr>
              <a:t>External test cohort </a:t>
            </a:r>
            <a:endParaRPr b="0" lang="en-US" sz="1800" spc="-1" strike="noStrike">
              <a:solidFill>
                <a:srgbClr val="000000"/>
              </a:solidFill>
              <a:latin typeface="Arial"/>
            </a:endParaRPr>
          </a:p>
        </p:txBody>
      </p:sp>
      <p:pic>
        <p:nvPicPr>
          <p:cNvPr id="1079" name="tx77" descr=""/>
          <p:cNvPicPr/>
          <p:nvPr/>
        </p:nvPicPr>
        <p:blipFill>
          <a:blip r:embed="rId90"/>
          <a:stretch/>
        </p:blipFill>
        <p:spPr>
          <a:xfrm>
            <a:off x="4784760" y="9750600"/>
            <a:ext cx="603360" cy="207720"/>
          </a:xfrm>
          <a:prstGeom prst="rect">
            <a:avLst/>
          </a:prstGeom>
          <a:ln w="0">
            <a:noFill/>
          </a:ln>
        </p:spPr>
      </p:pic>
      <p:pic>
        <p:nvPicPr>
          <p:cNvPr id="1080" name="tx82" descr=""/>
          <p:cNvPicPr/>
          <p:nvPr/>
        </p:nvPicPr>
        <p:blipFill>
          <a:blip r:embed="rId91"/>
          <a:stretch/>
        </p:blipFill>
        <p:spPr>
          <a:xfrm>
            <a:off x="12825360" y="11264760"/>
            <a:ext cx="617760" cy="173160"/>
          </a:xfrm>
          <a:prstGeom prst="rect">
            <a:avLst/>
          </a:prstGeom>
          <a:ln w="0">
            <a:noFill/>
          </a:ln>
        </p:spPr>
      </p:pic>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81" name="文本框 625"/>
          <p:cNvSpPr/>
          <p:nvPr/>
        </p:nvSpPr>
        <p:spPr>
          <a:xfrm>
            <a:off x="2633760" y="5599080"/>
            <a:ext cx="16129080" cy="54558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1487520"/>
                <a:tab algn="l" pos="2975040"/>
                <a:tab algn="l" pos="4462560"/>
                <a:tab algn="l" pos="5950080"/>
                <a:tab algn="l" pos="7437600"/>
                <a:tab algn="l" pos="8924760"/>
                <a:tab algn="l" pos="10412280"/>
              </a:tabLst>
            </a:pPr>
            <a:r>
              <a:rPr b="1" lang="en-US" sz="3200" spc="-1" strike="noStrike">
                <a:solidFill>
                  <a:srgbClr val="000000"/>
                </a:solidFill>
                <a:latin typeface="Times New Roman"/>
              </a:rPr>
              <a:t>Figure S4</a:t>
            </a:r>
            <a:r>
              <a:rPr b="0" lang="en-US" sz="3200" spc="-1" strike="noStrike">
                <a:solidFill>
                  <a:srgbClr val="000000"/>
                </a:solidFill>
                <a:latin typeface="Times New Roman"/>
              </a:rPr>
              <a:t>. The ROC analysis and nomogram for CRC metastasis.</a:t>
            </a:r>
            <a:endParaRPr b="0" lang="en-US" sz="3200" spc="-1" strike="noStrike">
              <a:solidFill>
                <a:srgbClr val="000000"/>
              </a:solidFill>
              <a:latin typeface="Arial"/>
            </a:endParaRPr>
          </a:p>
          <a:p>
            <a:pPr algn="just">
              <a:lnSpc>
                <a:spcPct val="100000"/>
              </a:lnSpc>
              <a:tabLst>
                <a:tab algn="l" pos="0"/>
                <a:tab algn="l" pos="1487520"/>
                <a:tab algn="l" pos="2975040"/>
                <a:tab algn="l" pos="4462560"/>
                <a:tab algn="l" pos="5950080"/>
                <a:tab algn="l" pos="7437600"/>
                <a:tab algn="l" pos="8924760"/>
                <a:tab algn="l" pos="10412280"/>
              </a:tabLst>
            </a:pPr>
            <a:r>
              <a:rPr b="0" lang="en-US" sz="3200" spc="-1" strike="noStrike">
                <a:solidFill>
                  <a:srgbClr val="000000"/>
                </a:solidFill>
                <a:latin typeface="Times New Roman"/>
              </a:rPr>
              <a:t>ROC analysis based on the sensitivity and specificity of multivariate, selected by minimum criteria (min) and 1 standard error of the minimum criteria (1se), for predicting tumor metastasis in the internal test cohort (A) and the external test cohort (B). The nomogram was developed in the primary cohort, based on 1se criteria (C) and min criteria (D). </a:t>
            </a:r>
            <a:endParaRPr b="0" lang="en-US" sz="3200" spc="-1" strike="noStrike">
              <a:solidFill>
                <a:srgbClr val="000000"/>
              </a:solidFill>
              <a:latin typeface="Arial"/>
            </a:endParaRPr>
          </a:p>
          <a:p>
            <a:pPr algn="just">
              <a:lnSpc>
                <a:spcPct val="100000"/>
              </a:lnSpc>
              <a:tabLst>
                <a:tab algn="l" pos="0"/>
                <a:tab algn="l" pos="1487520"/>
                <a:tab algn="l" pos="2975040"/>
                <a:tab algn="l" pos="4462560"/>
                <a:tab algn="l" pos="5950080"/>
                <a:tab algn="l" pos="7437600"/>
                <a:tab algn="l" pos="8924760"/>
                <a:tab algn="l" pos="10412280"/>
              </a:tabLst>
            </a:pPr>
            <a:r>
              <a:rPr b="0" lang="en-US" sz="3200" spc="-1" strike="noStrike">
                <a:solidFill>
                  <a:srgbClr val="000000"/>
                </a:solidFill>
                <a:latin typeface="Times New Roman"/>
              </a:rPr>
              <a:t>Nomogram read guidance: Score each variable according to its value level (represented by Points line on the nomogram), and then add the scores of each variable to get the total score (represented by Total points line on the nomogram). The probability corresponding to the vertical line of the total score is the probability of metastasis in patients, and the higher the score, the higher the probability of metastasis.</a:t>
            </a:r>
            <a:endParaRPr b="0" lang="en-US" sz="3200" spc="-1" strike="noStrike">
              <a:solidFill>
                <a:srgbClr val="000000"/>
              </a:solidFill>
              <a:latin typeface="Arial"/>
            </a:endParaRPr>
          </a:p>
          <a:p>
            <a:pPr algn="just">
              <a:lnSpc>
                <a:spcPct val="100000"/>
              </a:lnSpc>
              <a:tabLst>
                <a:tab algn="l" pos="0"/>
                <a:tab algn="l" pos="1487520"/>
                <a:tab algn="l" pos="2975040"/>
                <a:tab algn="l" pos="4462560"/>
                <a:tab algn="l" pos="5950080"/>
                <a:tab algn="l" pos="7437600"/>
                <a:tab algn="l" pos="8924760"/>
                <a:tab algn="l" pos="10412280"/>
              </a:tabLst>
            </a:pP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082" name="组合 227"/>
          <p:cNvGrpSpPr/>
          <p:nvPr/>
        </p:nvGrpSpPr>
        <p:grpSpPr>
          <a:xfrm>
            <a:off x="7167600" y="3635280"/>
            <a:ext cx="7289640" cy="7043760"/>
            <a:chOff x="7167600" y="3635280"/>
            <a:chExt cx="7289640" cy="7043760"/>
          </a:xfrm>
        </p:grpSpPr>
        <p:sp>
          <p:nvSpPr>
            <p:cNvPr id="1083" name="rc3"/>
            <p:cNvSpPr/>
            <p:nvPr/>
          </p:nvSpPr>
          <p:spPr>
            <a:xfrm>
              <a:off x="7392240" y="3635280"/>
              <a:ext cx="7065000" cy="7043760"/>
            </a:xfrm>
            <a:prstGeom prst="rect">
              <a:avLst/>
            </a:prstGeom>
            <a:solidFill>
              <a:srgbClr val="ffffff"/>
            </a:solidFill>
            <a:ln cap="rnd" w="9360">
              <a:solidFill>
                <a:srgbClr val="ffffff"/>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84" name="pl4"/>
            <p:cNvSpPr/>
            <p:nvPr/>
          </p:nvSpPr>
          <p:spPr>
            <a:xfrm>
              <a:off x="8337600" y="9781200"/>
              <a:ext cx="5527440" cy="360"/>
            </a:xfrm>
            <a:custGeom>
              <a:avLst/>
              <a:gdLst/>
              <a:ahLst/>
              <a:rect l="l" t="t" r="r" b="b"/>
              <a:pathLst>
                <a:path w="5723466" h="1">
                  <a:moveTo>
                    <a:pt x="0" y="0"/>
                  </a:moveTo>
                  <a:lnTo>
                    <a:pt x="5723466"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85" name="pl5"/>
            <p:cNvSpPr/>
            <p:nvPr/>
          </p:nvSpPr>
          <p:spPr>
            <a:xfrm>
              <a:off x="8337600" y="9781200"/>
              <a:ext cx="360" cy="87840"/>
            </a:xfrm>
            <a:custGeom>
              <a:avLst/>
              <a:gdLst/>
              <a:ahLst/>
              <a:rect l="l" t="t" r="r" b="b"/>
              <a:pathLst>
                <a:path w="1" h="91440">
                  <a:moveTo>
                    <a:pt x="0" y="0"/>
                  </a:moveTo>
                  <a:lnTo>
                    <a:pt x="0" y="91440"/>
                  </a:lnTo>
                </a:path>
              </a:pathLst>
            </a:custGeom>
            <a:noFill/>
            <a:ln cap="rnd" w="9360">
              <a:solidFill>
                <a:srgbClr val="000000"/>
              </a:solidFill>
              <a:round/>
            </a:ln>
          </p:spPr>
          <p:style>
            <a:lnRef idx="0"/>
            <a:fillRef idx="0"/>
            <a:effectRef idx="0"/>
            <a:fontRef idx="minor"/>
          </p:style>
          <p:txBody>
            <a:bodyPr lIns="90000" rIns="90000" tIns="41040" bIns="410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86" name="pl6"/>
            <p:cNvSpPr/>
            <p:nvPr/>
          </p:nvSpPr>
          <p:spPr>
            <a:xfrm>
              <a:off x="9443160" y="9781200"/>
              <a:ext cx="360" cy="87840"/>
            </a:xfrm>
            <a:custGeom>
              <a:avLst/>
              <a:gdLst/>
              <a:ahLst/>
              <a:rect l="l" t="t" r="r" b="b"/>
              <a:pathLst>
                <a:path w="1" h="91440">
                  <a:moveTo>
                    <a:pt x="0" y="0"/>
                  </a:moveTo>
                  <a:lnTo>
                    <a:pt x="0" y="91440"/>
                  </a:lnTo>
                </a:path>
              </a:pathLst>
            </a:custGeom>
            <a:noFill/>
            <a:ln cap="rnd" w="9360">
              <a:solidFill>
                <a:srgbClr val="000000"/>
              </a:solidFill>
              <a:round/>
            </a:ln>
          </p:spPr>
          <p:style>
            <a:lnRef idx="0"/>
            <a:fillRef idx="0"/>
            <a:effectRef idx="0"/>
            <a:fontRef idx="minor"/>
          </p:style>
          <p:txBody>
            <a:bodyPr lIns="90000" rIns="90000" tIns="41040" bIns="410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87" name="pl7"/>
            <p:cNvSpPr/>
            <p:nvPr/>
          </p:nvSpPr>
          <p:spPr>
            <a:xfrm>
              <a:off x="10548720" y="9781200"/>
              <a:ext cx="360" cy="87840"/>
            </a:xfrm>
            <a:custGeom>
              <a:avLst/>
              <a:gdLst/>
              <a:ahLst/>
              <a:rect l="l" t="t" r="r" b="b"/>
              <a:pathLst>
                <a:path w="1" h="91440">
                  <a:moveTo>
                    <a:pt x="0" y="0"/>
                  </a:moveTo>
                  <a:lnTo>
                    <a:pt x="0" y="91440"/>
                  </a:lnTo>
                </a:path>
              </a:pathLst>
            </a:custGeom>
            <a:noFill/>
            <a:ln cap="rnd" w="9360">
              <a:solidFill>
                <a:srgbClr val="000000"/>
              </a:solidFill>
              <a:round/>
            </a:ln>
          </p:spPr>
          <p:style>
            <a:lnRef idx="0"/>
            <a:fillRef idx="0"/>
            <a:effectRef idx="0"/>
            <a:fontRef idx="minor"/>
          </p:style>
          <p:txBody>
            <a:bodyPr lIns="90000" rIns="90000" tIns="41040" bIns="410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88" name="pl8"/>
            <p:cNvSpPr/>
            <p:nvPr/>
          </p:nvSpPr>
          <p:spPr>
            <a:xfrm>
              <a:off x="11654280" y="9781200"/>
              <a:ext cx="360" cy="87840"/>
            </a:xfrm>
            <a:custGeom>
              <a:avLst/>
              <a:gdLst/>
              <a:ahLst/>
              <a:rect l="l" t="t" r="r" b="b"/>
              <a:pathLst>
                <a:path w="1" h="91440">
                  <a:moveTo>
                    <a:pt x="0" y="0"/>
                  </a:moveTo>
                  <a:lnTo>
                    <a:pt x="0" y="91440"/>
                  </a:lnTo>
                </a:path>
              </a:pathLst>
            </a:custGeom>
            <a:noFill/>
            <a:ln cap="rnd" w="9360">
              <a:solidFill>
                <a:srgbClr val="000000"/>
              </a:solidFill>
              <a:round/>
            </a:ln>
          </p:spPr>
          <p:style>
            <a:lnRef idx="0"/>
            <a:fillRef idx="0"/>
            <a:effectRef idx="0"/>
            <a:fontRef idx="minor"/>
          </p:style>
          <p:txBody>
            <a:bodyPr lIns="90000" rIns="90000" tIns="41040" bIns="410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89" name="pl9"/>
            <p:cNvSpPr/>
            <p:nvPr/>
          </p:nvSpPr>
          <p:spPr>
            <a:xfrm>
              <a:off x="12759840" y="9781200"/>
              <a:ext cx="360" cy="87840"/>
            </a:xfrm>
            <a:custGeom>
              <a:avLst/>
              <a:gdLst/>
              <a:ahLst/>
              <a:rect l="l" t="t" r="r" b="b"/>
              <a:pathLst>
                <a:path w="1" h="91440">
                  <a:moveTo>
                    <a:pt x="0" y="0"/>
                  </a:moveTo>
                  <a:lnTo>
                    <a:pt x="0" y="91440"/>
                  </a:lnTo>
                </a:path>
              </a:pathLst>
            </a:custGeom>
            <a:noFill/>
            <a:ln cap="rnd" w="9360">
              <a:solidFill>
                <a:srgbClr val="000000"/>
              </a:solidFill>
              <a:round/>
            </a:ln>
          </p:spPr>
          <p:style>
            <a:lnRef idx="0"/>
            <a:fillRef idx="0"/>
            <a:effectRef idx="0"/>
            <a:fontRef idx="minor"/>
          </p:style>
          <p:txBody>
            <a:bodyPr lIns="90000" rIns="90000" tIns="41040" bIns="410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90" name="pl10"/>
            <p:cNvSpPr/>
            <p:nvPr/>
          </p:nvSpPr>
          <p:spPr>
            <a:xfrm>
              <a:off x="13865400" y="9781200"/>
              <a:ext cx="360" cy="87840"/>
            </a:xfrm>
            <a:custGeom>
              <a:avLst/>
              <a:gdLst/>
              <a:ahLst/>
              <a:rect l="l" t="t" r="r" b="b"/>
              <a:pathLst>
                <a:path w="1" h="91440">
                  <a:moveTo>
                    <a:pt x="0" y="0"/>
                  </a:moveTo>
                  <a:lnTo>
                    <a:pt x="0" y="91440"/>
                  </a:lnTo>
                </a:path>
              </a:pathLst>
            </a:custGeom>
            <a:noFill/>
            <a:ln cap="rnd" w="9360">
              <a:solidFill>
                <a:srgbClr val="000000"/>
              </a:solidFill>
              <a:round/>
            </a:ln>
          </p:spPr>
          <p:style>
            <a:lnRef idx="0"/>
            <a:fillRef idx="0"/>
            <a:effectRef idx="0"/>
            <a:fontRef idx="minor"/>
          </p:style>
          <p:txBody>
            <a:bodyPr lIns="90000" rIns="90000" tIns="41040" bIns="410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91" name="tx11"/>
            <p:cNvSpPr/>
            <p:nvPr/>
          </p:nvSpPr>
          <p:spPr>
            <a:xfrm>
              <a:off x="8184240" y="9937080"/>
              <a:ext cx="306720" cy="16056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0</a:t>
              </a:r>
              <a:endParaRPr b="0" lang="en-US" sz="1800" spc="-1" strike="noStrike">
                <a:solidFill>
                  <a:srgbClr val="000000"/>
                </a:solidFill>
                <a:latin typeface="Arial"/>
              </a:endParaRPr>
            </a:p>
          </p:txBody>
        </p:sp>
        <p:sp>
          <p:nvSpPr>
            <p:cNvPr id="1092" name="tx12"/>
            <p:cNvSpPr/>
            <p:nvPr/>
          </p:nvSpPr>
          <p:spPr>
            <a:xfrm>
              <a:off x="9289800" y="9937080"/>
              <a:ext cx="306720" cy="16056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2</a:t>
              </a:r>
              <a:endParaRPr b="0" lang="en-US" sz="1800" spc="-1" strike="noStrike">
                <a:solidFill>
                  <a:srgbClr val="000000"/>
                </a:solidFill>
                <a:latin typeface="Arial"/>
              </a:endParaRPr>
            </a:p>
          </p:txBody>
        </p:sp>
        <p:sp>
          <p:nvSpPr>
            <p:cNvPr id="1093" name="tx13"/>
            <p:cNvSpPr/>
            <p:nvPr/>
          </p:nvSpPr>
          <p:spPr>
            <a:xfrm>
              <a:off x="10395360" y="9937080"/>
              <a:ext cx="306720" cy="16056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4</a:t>
              </a:r>
              <a:endParaRPr b="0" lang="en-US" sz="1800" spc="-1" strike="noStrike">
                <a:solidFill>
                  <a:srgbClr val="000000"/>
                </a:solidFill>
                <a:latin typeface="Arial"/>
              </a:endParaRPr>
            </a:p>
          </p:txBody>
        </p:sp>
        <p:sp>
          <p:nvSpPr>
            <p:cNvPr id="1094" name="tx14"/>
            <p:cNvSpPr/>
            <p:nvPr/>
          </p:nvSpPr>
          <p:spPr>
            <a:xfrm>
              <a:off x="11500920" y="9937080"/>
              <a:ext cx="306720" cy="16056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6</a:t>
              </a:r>
              <a:endParaRPr b="0" lang="en-US" sz="1800" spc="-1" strike="noStrike">
                <a:solidFill>
                  <a:srgbClr val="000000"/>
                </a:solidFill>
                <a:latin typeface="Arial"/>
              </a:endParaRPr>
            </a:p>
          </p:txBody>
        </p:sp>
        <p:sp>
          <p:nvSpPr>
            <p:cNvPr id="1095" name="tx15"/>
            <p:cNvSpPr/>
            <p:nvPr/>
          </p:nvSpPr>
          <p:spPr>
            <a:xfrm>
              <a:off x="12606480" y="9937080"/>
              <a:ext cx="306720" cy="16056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8</a:t>
              </a:r>
              <a:endParaRPr b="0" lang="en-US" sz="1800" spc="-1" strike="noStrike">
                <a:solidFill>
                  <a:srgbClr val="000000"/>
                </a:solidFill>
                <a:latin typeface="Arial"/>
              </a:endParaRPr>
            </a:p>
          </p:txBody>
        </p:sp>
        <p:sp>
          <p:nvSpPr>
            <p:cNvPr id="1096" name="tx16"/>
            <p:cNvSpPr/>
            <p:nvPr/>
          </p:nvSpPr>
          <p:spPr>
            <a:xfrm>
              <a:off x="13712040" y="9937080"/>
              <a:ext cx="306720" cy="16056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1.0</a:t>
              </a:r>
              <a:endParaRPr b="0" lang="en-US" sz="1800" spc="-1" strike="noStrike">
                <a:solidFill>
                  <a:srgbClr val="000000"/>
                </a:solidFill>
                <a:latin typeface="Arial"/>
              </a:endParaRPr>
            </a:p>
          </p:txBody>
        </p:sp>
        <p:sp>
          <p:nvSpPr>
            <p:cNvPr id="1097" name="pl17"/>
            <p:cNvSpPr/>
            <p:nvPr/>
          </p:nvSpPr>
          <p:spPr>
            <a:xfrm>
              <a:off x="8116560" y="4557960"/>
              <a:ext cx="360" cy="5022000"/>
            </a:xfrm>
            <a:custGeom>
              <a:avLst/>
              <a:gdLst/>
              <a:ahLst/>
              <a:rect l="l" t="t" r="r" b="b"/>
              <a:pathLst>
                <a:path w="1" h="5215466">
                  <a:moveTo>
                    <a:pt x="0" y="5215466"/>
                  </a:moveTo>
                  <a:lnTo>
                    <a:pt x="0" y="0"/>
                  </a:lnTo>
                </a:path>
              </a:pathLst>
            </a:custGeom>
            <a:noFill/>
            <a:ln cap="rnd" w="9360">
              <a:solidFill>
                <a:srgbClr val="000000"/>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98" name="pl18"/>
            <p:cNvSpPr/>
            <p:nvPr/>
          </p:nvSpPr>
          <p:spPr>
            <a:xfrm>
              <a:off x="8028360" y="9580320"/>
              <a:ext cx="88200" cy="360"/>
            </a:xfrm>
            <a:custGeom>
              <a:avLst/>
              <a:gdLst/>
              <a:ahLst/>
              <a:rect l="l" t="t" r="r" b="b"/>
              <a:pathLst>
                <a:path w="91439" h="1">
                  <a:moveTo>
                    <a:pt x="91439"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099" name="pl19"/>
            <p:cNvSpPr/>
            <p:nvPr/>
          </p:nvSpPr>
          <p:spPr>
            <a:xfrm>
              <a:off x="8028360" y="8575920"/>
              <a:ext cx="88200" cy="360"/>
            </a:xfrm>
            <a:custGeom>
              <a:avLst/>
              <a:gdLst/>
              <a:ahLst/>
              <a:rect l="l" t="t" r="r" b="b"/>
              <a:pathLst>
                <a:path w="91439" h="1">
                  <a:moveTo>
                    <a:pt x="91439"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00" name="pl20"/>
            <p:cNvSpPr/>
            <p:nvPr/>
          </p:nvSpPr>
          <p:spPr>
            <a:xfrm>
              <a:off x="8028360" y="7571160"/>
              <a:ext cx="88200" cy="360"/>
            </a:xfrm>
            <a:custGeom>
              <a:avLst/>
              <a:gdLst/>
              <a:ahLst/>
              <a:rect l="l" t="t" r="r" b="b"/>
              <a:pathLst>
                <a:path w="91439" h="1">
                  <a:moveTo>
                    <a:pt x="91439"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01" name="pl21"/>
            <p:cNvSpPr/>
            <p:nvPr/>
          </p:nvSpPr>
          <p:spPr>
            <a:xfrm>
              <a:off x="8028360" y="6566760"/>
              <a:ext cx="88200" cy="360"/>
            </a:xfrm>
            <a:custGeom>
              <a:avLst/>
              <a:gdLst/>
              <a:ahLst/>
              <a:rect l="l" t="t" r="r" b="b"/>
              <a:pathLst>
                <a:path w="91439" h="1">
                  <a:moveTo>
                    <a:pt x="91439"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02" name="pl22"/>
            <p:cNvSpPr/>
            <p:nvPr/>
          </p:nvSpPr>
          <p:spPr>
            <a:xfrm>
              <a:off x="8028360" y="5562360"/>
              <a:ext cx="88200" cy="360"/>
            </a:xfrm>
            <a:custGeom>
              <a:avLst/>
              <a:gdLst/>
              <a:ahLst/>
              <a:rect l="l" t="t" r="r" b="b"/>
              <a:pathLst>
                <a:path w="91439" h="1">
                  <a:moveTo>
                    <a:pt x="91439"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03" name="pl23"/>
            <p:cNvSpPr/>
            <p:nvPr/>
          </p:nvSpPr>
          <p:spPr>
            <a:xfrm>
              <a:off x="8028360" y="4557960"/>
              <a:ext cx="88200" cy="360"/>
            </a:xfrm>
            <a:custGeom>
              <a:avLst/>
              <a:gdLst/>
              <a:ahLst/>
              <a:rect l="l" t="t" r="r" b="b"/>
              <a:pathLst>
                <a:path w="91439" h="1">
                  <a:moveTo>
                    <a:pt x="91439"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04" name="tx24"/>
            <p:cNvSpPr/>
            <p:nvPr/>
          </p:nvSpPr>
          <p:spPr>
            <a:xfrm rot="16200000">
              <a:off x="7670880" y="9499680"/>
              <a:ext cx="306000" cy="16128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0</a:t>
              </a:r>
              <a:endParaRPr b="0" lang="en-US" sz="1800" spc="-1" strike="noStrike">
                <a:solidFill>
                  <a:srgbClr val="000000"/>
                </a:solidFill>
                <a:latin typeface="Arial"/>
              </a:endParaRPr>
            </a:p>
          </p:txBody>
        </p:sp>
        <p:sp>
          <p:nvSpPr>
            <p:cNvPr id="1105" name="tx25"/>
            <p:cNvSpPr/>
            <p:nvPr/>
          </p:nvSpPr>
          <p:spPr>
            <a:xfrm rot="16200000">
              <a:off x="7670880" y="8495280"/>
              <a:ext cx="306000" cy="16128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2</a:t>
              </a:r>
              <a:endParaRPr b="0" lang="en-US" sz="1800" spc="-1" strike="noStrike">
                <a:solidFill>
                  <a:srgbClr val="000000"/>
                </a:solidFill>
                <a:latin typeface="Arial"/>
              </a:endParaRPr>
            </a:p>
          </p:txBody>
        </p:sp>
        <p:sp>
          <p:nvSpPr>
            <p:cNvPr id="1106" name="tx26"/>
            <p:cNvSpPr/>
            <p:nvPr/>
          </p:nvSpPr>
          <p:spPr>
            <a:xfrm rot="16200000">
              <a:off x="7670880" y="7490520"/>
              <a:ext cx="306000" cy="16128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4</a:t>
              </a:r>
              <a:endParaRPr b="0" lang="en-US" sz="1800" spc="-1" strike="noStrike">
                <a:solidFill>
                  <a:srgbClr val="000000"/>
                </a:solidFill>
                <a:latin typeface="Arial"/>
              </a:endParaRPr>
            </a:p>
          </p:txBody>
        </p:sp>
        <p:sp>
          <p:nvSpPr>
            <p:cNvPr id="1107" name="tx27"/>
            <p:cNvSpPr/>
            <p:nvPr/>
          </p:nvSpPr>
          <p:spPr>
            <a:xfrm rot="16200000">
              <a:off x="7670880" y="6486120"/>
              <a:ext cx="306000" cy="16128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6</a:t>
              </a:r>
              <a:endParaRPr b="0" lang="en-US" sz="1800" spc="-1" strike="noStrike">
                <a:solidFill>
                  <a:srgbClr val="000000"/>
                </a:solidFill>
                <a:latin typeface="Arial"/>
              </a:endParaRPr>
            </a:p>
          </p:txBody>
        </p:sp>
        <p:sp>
          <p:nvSpPr>
            <p:cNvPr id="1108" name="tx28"/>
            <p:cNvSpPr/>
            <p:nvPr/>
          </p:nvSpPr>
          <p:spPr>
            <a:xfrm rot="16200000">
              <a:off x="7670880" y="5481720"/>
              <a:ext cx="306000" cy="16128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8</a:t>
              </a:r>
              <a:endParaRPr b="0" lang="en-US" sz="1800" spc="-1" strike="noStrike">
                <a:solidFill>
                  <a:srgbClr val="000000"/>
                </a:solidFill>
                <a:latin typeface="Arial"/>
              </a:endParaRPr>
            </a:p>
          </p:txBody>
        </p:sp>
        <p:sp>
          <p:nvSpPr>
            <p:cNvPr id="1109" name="tx29"/>
            <p:cNvSpPr/>
            <p:nvPr/>
          </p:nvSpPr>
          <p:spPr>
            <a:xfrm rot="16200000">
              <a:off x="7670880" y="4477320"/>
              <a:ext cx="306000" cy="16128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1.0</a:t>
              </a:r>
              <a:endParaRPr b="0" lang="en-US" sz="1800" spc="-1" strike="noStrike">
                <a:solidFill>
                  <a:srgbClr val="000000"/>
                </a:solidFill>
                <a:latin typeface="Arial"/>
              </a:endParaRPr>
            </a:p>
          </p:txBody>
        </p:sp>
        <p:sp>
          <p:nvSpPr>
            <p:cNvPr id="1110" name="pl30"/>
            <p:cNvSpPr/>
            <p:nvPr/>
          </p:nvSpPr>
          <p:spPr>
            <a:xfrm>
              <a:off x="8116560" y="4357080"/>
              <a:ext cx="5969880" cy="5423760"/>
            </a:xfrm>
            <a:custGeom>
              <a:avLst/>
              <a:gdLst/>
              <a:ahLst/>
              <a:rect l="l" t="t" r="r" b="b"/>
              <a:pathLst>
                <a:path w="6181344" h="5632704">
                  <a:moveTo>
                    <a:pt x="0" y="5632704"/>
                  </a:moveTo>
                  <a:lnTo>
                    <a:pt x="6181344" y="5632704"/>
                  </a:lnTo>
                  <a:lnTo>
                    <a:pt x="6181344" y="0"/>
                  </a:lnTo>
                  <a:lnTo>
                    <a:pt x="0" y="0"/>
                  </a:lnTo>
                  <a:lnTo>
                    <a:pt x="0" y="5632704"/>
                  </a:lnTo>
                </a:path>
              </a:pathLst>
            </a:custGeom>
            <a:noFill/>
            <a:ln cap="rnd" w="9360">
              <a:solidFill>
                <a:srgbClr val="000000"/>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11" name="tx32"/>
            <p:cNvSpPr/>
            <p:nvPr/>
          </p:nvSpPr>
          <p:spPr>
            <a:xfrm>
              <a:off x="10101240" y="10422360"/>
              <a:ext cx="2000160" cy="20376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Predicted probability</a:t>
              </a:r>
              <a:endParaRPr b="0" lang="en-US" sz="1800" spc="-1" strike="noStrike">
                <a:solidFill>
                  <a:srgbClr val="000000"/>
                </a:solidFill>
                <a:latin typeface="Arial"/>
              </a:endParaRPr>
            </a:p>
          </p:txBody>
        </p:sp>
        <p:sp>
          <p:nvSpPr>
            <p:cNvPr id="1112" name="tx33"/>
            <p:cNvSpPr/>
            <p:nvPr/>
          </p:nvSpPr>
          <p:spPr>
            <a:xfrm rot="16200000">
              <a:off x="6347520" y="6965280"/>
              <a:ext cx="1847160" cy="20700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Observed mortality</a:t>
              </a:r>
              <a:endParaRPr b="0" lang="en-US" sz="1800" spc="-1" strike="noStrike">
                <a:solidFill>
                  <a:srgbClr val="000000"/>
                </a:solidFill>
                <a:latin typeface="Arial"/>
              </a:endParaRPr>
            </a:p>
          </p:txBody>
        </p:sp>
        <p:sp>
          <p:nvSpPr>
            <p:cNvPr id="1113" name="pg34"/>
            <p:cNvSpPr/>
            <p:nvPr/>
          </p:nvSpPr>
          <p:spPr>
            <a:xfrm>
              <a:off x="9349200" y="4557960"/>
              <a:ext cx="4514400" cy="4598280"/>
            </a:xfrm>
            <a:custGeom>
              <a:avLst/>
              <a:gdLst/>
              <a:ahLst/>
              <a:rect l="l" t="t" r="r" b="b"/>
              <a:pathLst>
                <a:path w="4674591" h="4775293">
                  <a:moveTo>
                    <a:pt x="0" y="3482220"/>
                  </a:moveTo>
                  <a:lnTo>
                    <a:pt x="47218" y="3471444"/>
                  </a:lnTo>
                  <a:lnTo>
                    <a:pt x="86345" y="3461420"/>
                  </a:lnTo>
                  <a:lnTo>
                    <a:pt x="94436" y="3459111"/>
                  </a:lnTo>
                  <a:lnTo>
                    <a:pt x="141654" y="3443460"/>
                  </a:lnTo>
                  <a:lnTo>
                    <a:pt x="177944" y="3430987"/>
                  </a:lnTo>
                  <a:lnTo>
                    <a:pt x="188872" y="3426828"/>
                  </a:lnTo>
                  <a:lnTo>
                    <a:pt x="236090" y="3407758"/>
                  </a:lnTo>
                  <a:lnTo>
                    <a:pt x="274812" y="3389613"/>
                  </a:lnTo>
                  <a:lnTo>
                    <a:pt x="283308" y="3385611"/>
                  </a:lnTo>
                  <a:lnTo>
                    <a:pt x="330526" y="3362605"/>
                  </a:lnTo>
                  <a:lnTo>
                    <a:pt x="376915" y="3337617"/>
                  </a:lnTo>
                  <a:lnTo>
                    <a:pt x="377744" y="3337154"/>
                  </a:lnTo>
                  <a:lnTo>
                    <a:pt x="424962" y="3309910"/>
                  </a:lnTo>
                  <a:lnTo>
                    <a:pt x="472180" y="3280969"/>
                  </a:lnTo>
                  <a:lnTo>
                    <a:pt x="484158" y="3273315"/>
                  </a:lnTo>
                  <a:lnTo>
                    <a:pt x="519399" y="3249956"/>
                  </a:lnTo>
                  <a:lnTo>
                    <a:pt x="566617" y="3218384"/>
                  </a:lnTo>
                  <a:lnTo>
                    <a:pt x="596390" y="3197135"/>
                  </a:lnTo>
                  <a:lnTo>
                    <a:pt x="613835" y="3184842"/>
                  </a:lnTo>
                  <a:lnTo>
                    <a:pt x="661053" y="3150216"/>
                  </a:lnTo>
                  <a:lnTo>
                    <a:pt x="708271" y="3114316"/>
                  </a:lnTo>
                  <a:lnTo>
                    <a:pt x="713392" y="3110351"/>
                  </a:lnTo>
                  <a:lnTo>
                    <a:pt x="755489" y="3077366"/>
                  </a:lnTo>
                  <a:lnTo>
                    <a:pt x="802707" y="3039489"/>
                  </a:lnTo>
                  <a:lnTo>
                    <a:pt x="834880" y="3012936"/>
                  </a:lnTo>
                  <a:lnTo>
                    <a:pt x="849925" y="3000755"/>
                  </a:lnTo>
                  <a:lnTo>
                    <a:pt x="897143" y="2961419"/>
                  </a:lnTo>
                  <a:lnTo>
                    <a:pt x="944361" y="2920903"/>
                  </a:lnTo>
                  <a:lnTo>
                    <a:pt x="960504" y="2907566"/>
                  </a:lnTo>
                  <a:lnTo>
                    <a:pt x="991579" y="2880666"/>
                  </a:lnTo>
                  <a:lnTo>
                    <a:pt x="1038798" y="2839374"/>
                  </a:lnTo>
                  <a:lnTo>
                    <a:pt x="1086016" y="2797902"/>
                  </a:lnTo>
                  <a:lnTo>
                    <a:pt x="1089847" y="2794951"/>
                  </a:lnTo>
                  <a:lnTo>
                    <a:pt x="1133234" y="2756059"/>
                  </a:lnTo>
                  <a:lnTo>
                    <a:pt x="1180452" y="2713696"/>
                  </a:lnTo>
                  <a:lnTo>
                    <a:pt x="1222433" y="2675860"/>
                  </a:lnTo>
                  <a:lnTo>
                    <a:pt x="1227670" y="2671433"/>
                  </a:lnTo>
                  <a:lnTo>
                    <a:pt x="1274888" y="2628405"/>
                  </a:lnTo>
                  <a:lnTo>
                    <a:pt x="1322106" y="2585039"/>
                  </a:lnTo>
                  <a:lnTo>
                    <a:pt x="1357729" y="2551886"/>
                  </a:lnTo>
                  <a:lnTo>
                    <a:pt x="1369324" y="2541334"/>
                  </a:lnTo>
                  <a:lnTo>
                    <a:pt x="1416542" y="2496993"/>
                  </a:lnTo>
                  <a:lnTo>
                    <a:pt x="1463760" y="2452751"/>
                  </a:lnTo>
                  <a:lnTo>
                    <a:pt x="1495152" y="2423413"/>
                  </a:lnTo>
                  <a:lnTo>
                    <a:pt x="1510978" y="2408600"/>
                  </a:lnTo>
                  <a:lnTo>
                    <a:pt x="1558197" y="2363557"/>
                  </a:lnTo>
                  <a:lnTo>
                    <a:pt x="1605415" y="2318648"/>
                  </a:lnTo>
                  <a:lnTo>
                    <a:pt x="1634083" y="2291523"/>
                  </a:lnTo>
                  <a:lnTo>
                    <a:pt x="1652633" y="2273872"/>
                  </a:lnTo>
                  <a:lnTo>
                    <a:pt x="1699851" y="2228367"/>
                  </a:lnTo>
                  <a:lnTo>
                    <a:pt x="1747069" y="2183047"/>
                  </a:lnTo>
                  <a:lnTo>
                    <a:pt x="1773873" y="2157505"/>
                  </a:lnTo>
                  <a:lnTo>
                    <a:pt x="1794287" y="2137915"/>
                  </a:lnTo>
                  <a:lnTo>
                    <a:pt x="1841505" y="2092227"/>
                  </a:lnTo>
                  <a:lnTo>
                    <a:pt x="1888723" y="2046784"/>
                  </a:lnTo>
                  <a:lnTo>
                    <a:pt x="1913857" y="2022810"/>
                  </a:lnTo>
                  <a:lnTo>
                    <a:pt x="1935941" y="2001590"/>
                  </a:lnTo>
                  <a:lnTo>
                    <a:pt x="1983159" y="1956015"/>
                  </a:lnTo>
                  <a:lnTo>
                    <a:pt x="2030377" y="1910746"/>
                  </a:lnTo>
                  <a:lnTo>
                    <a:pt x="2053366" y="1888941"/>
                  </a:lnTo>
                  <a:lnTo>
                    <a:pt x="2077596" y="1865781"/>
                  </a:lnTo>
                  <a:lnTo>
                    <a:pt x="2124814" y="1820607"/>
                  </a:lnTo>
                  <a:lnTo>
                    <a:pt x="2172032" y="1775788"/>
                  </a:lnTo>
                  <a:lnTo>
                    <a:pt x="2191740" y="1757322"/>
                  </a:lnTo>
                  <a:lnTo>
                    <a:pt x="2219250" y="1731319"/>
                  </a:lnTo>
                  <a:lnTo>
                    <a:pt x="2266468" y="1686796"/>
                  </a:lnTo>
                  <a:lnTo>
                    <a:pt x="2313686" y="1642662"/>
                  </a:lnTo>
                  <a:lnTo>
                    <a:pt x="2328343" y="1629193"/>
                  </a:lnTo>
                  <a:lnTo>
                    <a:pt x="2360904" y="1598901"/>
                  </a:lnTo>
                  <a:lnTo>
                    <a:pt x="2408122" y="1555224"/>
                  </a:lnTo>
                  <a:lnTo>
                    <a:pt x="2455340" y="1512126"/>
                  </a:lnTo>
                  <a:lnTo>
                    <a:pt x="2462567" y="1505287"/>
                  </a:lnTo>
                  <a:lnTo>
                    <a:pt x="2502558" y="1469043"/>
                  </a:lnTo>
                  <a:lnTo>
                    <a:pt x="2549776" y="1426480"/>
                  </a:lnTo>
                  <a:lnTo>
                    <a:pt x="2593851" y="1386778"/>
                  </a:lnTo>
                  <a:lnTo>
                    <a:pt x="2596995" y="1383969"/>
                  </a:lnTo>
                  <a:lnTo>
                    <a:pt x="2644213" y="1341840"/>
                  </a:lnTo>
                  <a:lnTo>
                    <a:pt x="2691431" y="1300047"/>
                  </a:lnTo>
                  <a:lnTo>
                    <a:pt x="2721685" y="1273492"/>
                  </a:lnTo>
                  <a:lnTo>
                    <a:pt x="2738649" y="1258646"/>
                  </a:lnTo>
                  <a:lnTo>
                    <a:pt x="2785867" y="1217014"/>
                  </a:lnTo>
                  <a:lnTo>
                    <a:pt x="2833085" y="1175879"/>
                  </a:lnTo>
                  <a:lnTo>
                    <a:pt x="2845617" y="1164865"/>
                  </a:lnTo>
                  <a:lnTo>
                    <a:pt x="2880303" y="1134190"/>
                  </a:lnTo>
                  <a:lnTo>
                    <a:pt x="2927521" y="1092646"/>
                  </a:lnTo>
                  <a:lnTo>
                    <a:pt x="2965258" y="1058982"/>
                  </a:lnTo>
                  <a:lnTo>
                    <a:pt x="2974739" y="1050451"/>
                  </a:lnTo>
                  <a:lnTo>
                    <a:pt x="3021957" y="1007782"/>
                  </a:lnTo>
                  <a:lnTo>
                    <a:pt x="3069175" y="964526"/>
                  </a:lnTo>
                  <a:lnTo>
                    <a:pt x="3080284" y="954301"/>
                  </a:lnTo>
                  <a:lnTo>
                    <a:pt x="3116394" y="920081"/>
                  </a:lnTo>
                  <a:lnTo>
                    <a:pt x="3163612" y="875714"/>
                  </a:lnTo>
                  <a:lnTo>
                    <a:pt x="3190441" y="850739"/>
                  </a:lnTo>
                  <a:lnTo>
                    <a:pt x="3210830" y="831433"/>
                  </a:lnTo>
                  <a:lnTo>
                    <a:pt x="3258048" y="785812"/>
                  </a:lnTo>
                  <a:lnTo>
                    <a:pt x="3295538" y="750015"/>
                  </a:lnTo>
                  <a:lnTo>
                    <a:pt x="3305266" y="740978"/>
                  </a:lnTo>
                  <a:lnTo>
                    <a:pt x="3352484" y="695030"/>
                  </a:lnTo>
                  <a:lnTo>
                    <a:pt x="3395447" y="653840"/>
                  </a:lnTo>
                  <a:lnTo>
                    <a:pt x="3399702" y="650142"/>
                  </a:lnTo>
                  <a:lnTo>
                    <a:pt x="3446920" y="604581"/>
                  </a:lnTo>
                  <a:lnTo>
                    <a:pt x="3490101" y="563773"/>
                  </a:lnTo>
                  <a:lnTo>
                    <a:pt x="3494138" y="560294"/>
                  </a:lnTo>
                  <a:lnTo>
                    <a:pt x="3541356" y="515847"/>
                  </a:lnTo>
                  <a:lnTo>
                    <a:pt x="3579486" y="480952"/>
                  </a:lnTo>
                  <a:lnTo>
                    <a:pt x="3588574" y="472884"/>
                  </a:lnTo>
                  <a:lnTo>
                    <a:pt x="3635793" y="430294"/>
                  </a:lnTo>
                  <a:lnTo>
                    <a:pt x="3663638" y="406068"/>
                  </a:lnTo>
                  <a:lnTo>
                    <a:pt x="3683011" y="389387"/>
                  </a:lnTo>
                  <a:lnTo>
                    <a:pt x="3730229" y="349410"/>
                  </a:lnTo>
                  <a:lnTo>
                    <a:pt x="3742635" y="339408"/>
                  </a:lnTo>
                  <a:lnTo>
                    <a:pt x="3777447" y="311263"/>
                  </a:lnTo>
                  <a:lnTo>
                    <a:pt x="3816594" y="280810"/>
                  </a:lnTo>
                  <a:lnTo>
                    <a:pt x="3824665" y="274804"/>
                  </a:lnTo>
                  <a:lnTo>
                    <a:pt x="3871883" y="239968"/>
                  </a:lnTo>
                  <a:lnTo>
                    <a:pt x="3885661" y="230359"/>
                  </a:lnTo>
                  <a:lnTo>
                    <a:pt x="3919101" y="207386"/>
                  </a:lnTo>
                  <a:lnTo>
                    <a:pt x="3950007" y="187182"/>
                  </a:lnTo>
                  <a:lnTo>
                    <a:pt x="3966319" y="176934"/>
                  </a:lnTo>
                  <a:lnTo>
                    <a:pt x="4009822" y="150788"/>
                  </a:lnTo>
                  <a:lnTo>
                    <a:pt x="4013537" y="148655"/>
                  </a:lnTo>
                  <a:lnTo>
                    <a:pt x="4060755" y="122832"/>
                  </a:lnTo>
                  <a:lnTo>
                    <a:pt x="4065313" y="120473"/>
                  </a:lnTo>
                  <a:lnTo>
                    <a:pt x="4107973" y="99539"/>
                  </a:lnTo>
                  <a:lnTo>
                    <a:pt x="4116694" y="95514"/>
                  </a:lnTo>
                  <a:lnTo>
                    <a:pt x="4155192" y="78788"/>
                  </a:lnTo>
                  <a:lnTo>
                    <a:pt x="4164186" y="75130"/>
                  </a:lnTo>
                  <a:lnTo>
                    <a:pt x="4202410" y="60630"/>
                  </a:lnTo>
                  <a:lnTo>
                    <a:pt x="4208012" y="58649"/>
                  </a:lnTo>
                  <a:lnTo>
                    <a:pt x="4248395" y="45449"/>
                  </a:lnTo>
                  <a:lnTo>
                    <a:pt x="4249628" y="45076"/>
                  </a:lnTo>
                  <a:lnTo>
                    <a:pt x="4285553" y="34975"/>
                  </a:lnTo>
                  <a:lnTo>
                    <a:pt x="4296846" y="32101"/>
                  </a:lnTo>
                  <a:lnTo>
                    <a:pt x="4319701" y="26720"/>
                  </a:lnTo>
                  <a:lnTo>
                    <a:pt x="4344064" y="21620"/>
                  </a:lnTo>
                  <a:lnTo>
                    <a:pt x="4351045" y="20275"/>
                  </a:lnTo>
                  <a:lnTo>
                    <a:pt x="4379786" y="15271"/>
                  </a:lnTo>
                  <a:lnTo>
                    <a:pt x="4391282" y="13509"/>
                  </a:lnTo>
                  <a:lnTo>
                    <a:pt x="4406113" y="11431"/>
                  </a:lnTo>
                  <a:lnTo>
                    <a:pt x="4430208" y="8497"/>
                  </a:lnTo>
                  <a:lnTo>
                    <a:pt x="4438500" y="7611"/>
                  </a:lnTo>
                  <a:lnTo>
                    <a:pt x="4452241" y="6276"/>
                  </a:lnTo>
                  <a:lnTo>
                    <a:pt x="4472374" y="4598"/>
                  </a:lnTo>
                  <a:lnTo>
                    <a:pt x="4485718" y="3668"/>
                  </a:lnTo>
                  <a:lnTo>
                    <a:pt x="4490758" y="3352"/>
                  </a:lnTo>
                  <a:lnTo>
                    <a:pt x="4507534" y="2426"/>
                  </a:lnTo>
                  <a:lnTo>
                    <a:pt x="4522834" y="1746"/>
                  </a:lnTo>
                  <a:lnTo>
                    <a:pt x="4532936" y="1374"/>
                  </a:lnTo>
                  <a:lnTo>
                    <a:pt x="4536781" y="1248"/>
                  </a:lnTo>
                  <a:lnTo>
                    <a:pt x="4549489" y="884"/>
                  </a:lnTo>
                  <a:lnTo>
                    <a:pt x="4561062" y="624"/>
                  </a:lnTo>
                  <a:lnTo>
                    <a:pt x="4571597" y="437"/>
                  </a:lnTo>
                  <a:lnTo>
                    <a:pt x="4580154" y="317"/>
                  </a:lnTo>
                  <a:lnTo>
                    <a:pt x="4581184" y="305"/>
                  </a:lnTo>
                  <a:lnTo>
                    <a:pt x="4589906" y="210"/>
                  </a:lnTo>
                  <a:lnTo>
                    <a:pt x="4597839" y="144"/>
                  </a:lnTo>
                  <a:lnTo>
                    <a:pt x="4605051" y="98"/>
                  </a:lnTo>
                  <a:lnTo>
                    <a:pt x="4611607" y="67"/>
                  </a:lnTo>
                  <a:lnTo>
                    <a:pt x="4617564" y="45"/>
                  </a:lnTo>
                  <a:lnTo>
                    <a:pt x="4622978" y="30"/>
                  </a:lnTo>
                  <a:lnTo>
                    <a:pt x="4627372" y="21"/>
                  </a:lnTo>
                  <a:lnTo>
                    <a:pt x="4627895" y="20"/>
                  </a:lnTo>
                  <a:lnTo>
                    <a:pt x="4632361" y="13"/>
                  </a:lnTo>
                  <a:lnTo>
                    <a:pt x="4636418" y="8"/>
                  </a:lnTo>
                  <a:lnTo>
                    <a:pt x="4640101" y="5"/>
                  </a:lnTo>
                  <a:lnTo>
                    <a:pt x="4643444" y="3"/>
                  </a:lnTo>
                  <a:lnTo>
                    <a:pt x="4646480" y="2"/>
                  </a:lnTo>
                  <a:lnTo>
                    <a:pt x="4649235" y="1"/>
                  </a:lnTo>
                  <a:lnTo>
                    <a:pt x="4651736" y="0"/>
                  </a:lnTo>
                  <a:lnTo>
                    <a:pt x="4654005" y="0"/>
                  </a:lnTo>
                  <a:lnTo>
                    <a:pt x="4656065" y="0"/>
                  </a:lnTo>
                  <a:lnTo>
                    <a:pt x="4657934" y="0"/>
                  </a:lnTo>
                  <a:lnTo>
                    <a:pt x="4659629" y="0"/>
                  </a:lnTo>
                  <a:lnTo>
                    <a:pt x="4661168" y="0"/>
                  </a:lnTo>
                  <a:lnTo>
                    <a:pt x="4662563" y="0"/>
                  </a:lnTo>
                  <a:lnTo>
                    <a:pt x="4663830" y="0"/>
                  </a:lnTo>
                  <a:lnTo>
                    <a:pt x="4664978" y="0"/>
                  </a:lnTo>
                  <a:lnTo>
                    <a:pt x="4666020" y="0"/>
                  </a:lnTo>
                  <a:lnTo>
                    <a:pt x="4666965" y="0"/>
                  </a:lnTo>
                  <a:lnTo>
                    <a:pt x="4667823" y="0"/>
                  </a:lnTo>
                  <a:lnTo>
                    <a:pt x="4668600" y="0"/>
                  </a:lnTo>
                  <a:lnTo>
                    <a:pt x="4669305" y="0"/>
                  </a:lnTo>
                  <a:lnTo>
                    <a:pt x="4669945" y="0"/>
                  </a:lnTo>
                  <a:lnTo>
                    <a:pt x="4670525" y="0"/>
                  </a:lnTo>
                  <a:lnTo>
                    <a:pt x="4671052" y="0"/>
                  </a:lnTo>
                  <a:lnTo>
                    <a:pt x="4671529" y="0"/>
                  </a:lnTo>
                  <a:lnTo>
                    <a:pt x="4671962" y="0"/>
                  </a:lnTo>
                  <a:lnTo>
                    <a:pt x="4672354" y="0"/>
                  </a:lnTo>
                  <a:lnTo>
                    <a:pt x="4672710" y="0"/>
                  </a:lnTo>
                  <a:lnTo>
                    <a:pt x="4673033" y="0"/>
                  </a:lnTo>
                  <a:lnTo>
                    <a:pt x="4673326" y="0"/>
                  </a:lnTo>
                  <a:lnTo>
                    <a:pt x="4673591" y="0"/>
                  </a:lnTo>
                  <a:lnTo>
                    <a:pt x="4673832" y="0"/>
                  </a:lnTo>
                  <a:lnTo>
                    <a:pt x="4674050" y="0"/>
                  </a:lnTo>
                  <a:lnTo>
                    <a:pt x="4674248" y="0"/>
                  </a:lnTo>
                  <a:lnTo>
                    <a:pt x="4674428" y="0"/>
                  </a:lnTo>
                  <a:lnTo>
                    <a:pt x="4674591" y="0"/>
                  </a:lnTo>
                  <a:lnTo>
                    <a:pt x="4674591" y="4068819"/>
                  </a:lnTo>
                  <a:lnTo>
                    <a:pt x="4674428" y="3945941"/>
                  </a:lnTo>
                  <a:lnTo>
                    <a:pt x="4674248" y="3817702"/>
                  </a:lnTo>
                  <a:lnTo>
                    <a:pt x="4674050" y="3685006"/>
                  </a:lnTo>
                  <a:lnTo>
                    <a:pt x="4673832" y="3548855"/>
                  </a:lnTo>
                  <a:lnTo>
                    <a:pt x="4673591" y="3410317"/>
                  </a:lnTo>
                  <a:lnTo>
                    <a:pt x="4673326" y="3270492"/>
                  </a:lnTo>
                  <a:lnTo>
                    <a:pt x="4673033" y="3130479"/>
                  </a:lnTo>
                  <a:lnTo>
                    <a:pt x="4672710" y="2991341"/>
                  </a:lnTo>
                  <a:lnTo>
                    <a:pt x="4672354" y="2854073"/>
                  </a:lnTo>
                  <a:lnTo>
                    <a:pt x="4671962" y="2719583"/>
                  </a:lnTo>
                  <a:lnTo>
                    <a:pt x="4671529" y="2588675"/>
                  </a:lnTo>
                  <a:lnTo>
                    <a:pt x="4671052" y="2463109"/>
                  </a:lnTo>
                  <a:lnTo>
                    <a:pt x="4670525" y="2339847"/>
                  </a:lnTo>
                  <a:lnTo>
                    <a:pt x="4669945" y="2223608"/>
                  </a:lnTo>
                  <a:lnTo>
                    <a:pt x="4669305" y="2112603"/>
                  </a:lnTo>
                  <a:lnTo>
                    <a:pt x="4668600" y="2007382"/>
                  </a:lnTo>
                  <a:lnTo>
                    <a:pt x="4667823" y="1908056"/>
                  </a:lnTo>
                  <a:lnTo>
                    <a:pt x="4666965" y="1814656"/>
                  </a:lnTo>
                  <a:lnTo>
                    <a:pt x="4666020" y="1727137"/>
                  </a:lnTo>
                  <a:lnTo>
                    <a:pt x="4664978" y="1645398"/>
                  </a:lnTo>
                  <a:lnTo>
                    <a:pt x="4663830" y="1569291"/>
                  </a:lnTo>
                  <a:lnTo>
                    <a:pt x="4662563" y="1498634"/>
                  </a:lnTo>
                  <a:lnTo>
                    <a:pt x="4661168" y="1433218"/>
                  </a:lnTo>
                  <a:lnTo>
                    <a:pt x="4659629" y="1372819"/>
                  </a:lnTo>
                  <a:lnTo>
                    <a:pt x="4657934" y="1317202"/>
                  </a:lnTo>
                  <a:lnTo>
                    <a:pt x="4656065" y="1266131"/>
                  </a:lnTo>
                  <a:lnTo>
                    <a:pt x="4654005" y="1219369"/>
                  </a:lnTo>
                  <a:lnTo>
                    <a:pt x="4651736" y="1176687"/>
                  </a:lnTo>
                  <a:lnTo>
                    <a:pt x="4649235" y="1137863"/>
                  </a:lnTo>
                  <a:lnTo>
                    <a:pt x="4646480" y="1102684"/>
                  </a:lnTo>
                  <a:lnTo>
                    <a:pt x="4643444" y="1070951"/>
                  </a:lnTo>
                  <a:lnTo>
                    <a:pt x="4640101" y="1042478"/>
                  </a:lnTo>
                  <a:lnTo>
                    <a:pt x="4636418" y="1017091"/>
                  </a:lnTo>
                  <a:lnTo>
                    <a:pt x="4632361" y="994627"/>
                  </a:lnTo>
                  <a:lnTo>
                    <a:pt x="4627895" y="974613"/>
                  </a:lnTo>
                  <a:lnTo>
                    <a:pt x="4627372" y="972860"/>
                  </a:lnTo>
                  <a:lnTo>
                    <a:pt x="4622978" y="957917"/>
                  </a:lnTo>
                  <a:lnTo>
                    <a:pt x="4617564" y="943413"/>
                  </a:lnTo>
                  <a:lnTo>
                    <a:pt x="4611607" y="931331"/>
                  </a:lnTo>
                  <a:lnTo>
                    <a:pt x="4605051" y="921578"/>
                  </a:lnTo>
                  <a:lnTo>
                    <a:pt x="4597839" y="914071"/>
                  </a:lnTo>
                  <a:lnTo>
                    <a:pt x="4589906" y="908739"/>
                  </a:lnTo>
                  <a:lnTo>
                    <a:pt x="4581184" y="905217"/>
                  </a:lnTo>
                  <a:lnTo>
                    <a:pt x="4580154" y="905230"/>
                  </a:lnTo>
                  <a:lnTo>
                    <a:pt x="4571597" y="904380"/>
                  </a:lnTo>
                  <a:lnTo>
                    <a:pt x="4561062" y="905261"/>
                  </a:lnTo>
                  <a:lnTo>
                    <a:pt x="4549489" y="908143"/>
                  </a:lnTo>
                  <a:lnTo>
                    <a:pt x="4536781" y="912730"/>
                  </a:lnTo>
                  <a:lnTo>
                    <a:pt x="4532936" y="914605"/>
                  </a:lnTo>
                  <a:lnTo>
                    <a:pt x="4522834" y="919835"/>
                  </a:lnTo>
                  <a:lnTo>
                    <a:pt x="4507534" y="928636"/>
                  </a:lnTo>
                  <a:lnTo>
                    <a:pt x="4490758" y="939139"/>
                  </a:lnTo>
                  <a:lnTo>
                    <a:pt x="4485718" y="942680"/>
                  </a:lnTo>
                  <a:lnTo>
                    <a:pt x="4472374" y="951880"/>
                  </a:lnTo>
                  <a:lnTo>
                    <a:pt x="4452241" y="966774"/>
                  </a:lnTo>
                  <a:lnTo>
                    <a:pt x="4438500" y="977122"/>
                  </a:lnTo>
                  <a:lnTo>
                    <a:pt x="4430208" y="983476"/>
                  </a:lnTo>
                  <a:lnTo>
                    <a:pt x="4406113" y="1002474"/>
                  </a:lnTo>
                  <a:lnTo>
                    <a:pt x="4391282" y="1014241"/>
                  </a:lnTo>
                  <a:lnTo>
                    <a:pt x="4379786" y="1023406"/>
                  </a:lnTo>
                  <a:lnTo>
                    <a:pt x="4351045" y="1046629"/>
                  </a:lnTo>
                  <a:lnTo>
                    <a:pt x="4344064" y="1052454"/>
                  </a:lnTo>
                  <a:lnTo>
                    <a:pt x="4319701" y="1072205"/>
                  </a:lnTo>
                  <a:lnTo>
                    <a:pt x="4296846" y="1090669"/>
                  </a:lnTo>
                  <a:lnTo>
                    <a:pt x="4285553" y="1100121"/>
                  </a:lnTo>
                  <a:lnTo>
                    <a:pt x="4249628" y="1128949"/>
                  </a:lnTo>
                  <a:lnTo>
                    <a:pt x="4248395" y="1130286"/>
                  </a:lnTo>
                  <a:lnTo>
                    <a:pt x="4208012" y="1162541"/>
                  </a:lnTo>
                  <a:lnTo>
                    <a:pt x="4202410" y="1167307"/>
                  </a:lnTo>
                  <a:lnTo>
                    <a:pt x="4164186" y="1197678"/>
                  </a:lnTo>
                  <a:lnTo>
                    <a:pt x="4155192" y="1205084"/>
                  </a:lnTo>
                  <a:lnTo>
                    <a:pt x="4116694" y="1235439"/>
                  </a:lnTo>
                  <a:lnTo>
                    <a:pt x="4107973" y="1242597"/>
                  </a:lnTo>
                  <a:lnTo>
                    <a:pt x="4065313" y="1275924"/>
                  </a:lnTo>
                  <a:lnTo>
                    <a:pt x="4060755" y="1279800"/>
                  </a:lnTo>
                  <a:lnTo>
                    <a:pt x="4013537" y="1316358"/>
                  </a:lnTo>
                  <a:lnTo>
                    <a:pt x="4009822" y="1319484"/>
                  </a:lnTo>
                  <a:lnTo>
                    <a:pt x="3966319" y="1352963"/>
                  </a:lnTo>
                  <a:lnTo>
                    <a:pt x="3950007" y="1365615"/>
                  </a:lnTo>
                  <a:lnTo>
                    <a:pt x="3919101" y="1389377"/>
                  </a:lnTo>
                  <a:lnTo>
                    <a:pt x="3885661" y="1414840"/>
                  </a:lnTo>
                  <a:lnTo>
                    <a:pt x="3871883" y="1425584"/>
                  </a:lnTo>
                  <a:lnTo>
                    <a:pt x="3824665" y="1461211"/>
                  </a:lnTo>
                  <a:lnTo>
                    <a:pt x="3816594" y="1467481"/>
                  </a:lnTo>
                  <a:lnTo>
                    <a:pt x="3777447" y="1497038"/>
                  </a:lnTo>
                  <a:lnTo>
                    <a:pt x="3742635" y="1523140"/>
                  </a:lnTo>
                  <a:lnTo>
                    <a:pt x="3730229" y="1532704"/>
                  </a:lnTo>
                  <a:lnTo>
                    <a:pt x="3683011" y="1567931"/>
                  </a:lnTo>
                  <a:lnTo>
                    <a:pt x="3663638" y="1582477"/>
                  </a:lnTo>
                  <a:lnTo>
                    <a:pt x="3635793" y="1603498"/>
                  </a:lnTo>
                  <a:lnTo>
                    <a:pt x="3588574" y="1638538"/>
                  </a:lnTo>
                  <a:lnTo>
                    <a:pt x="3579486" y="1645470"/>
                  </a:lnTo>
                  <a:lnTo>
                    <a:pt x="3541356" y="1674074"/>
                  </a:lnTo>
                  <a:lnTo>
                    <a:pt x="3494138" y="1709072"/>
                  </a:lnTo>
                  <a:lnTo>
                    <a:pt x="3490101" y="1712299"/>
                  </a:lnTo>
                  <a:lnTo>
                    <a:pt x="3446920" y="1744694"/>
                  </a:lnTo>
                  <a:lnTo>
                    <a:pt x="3399702" y="1779785"/>
                  </a:lnTo>
                  <a:lnTo>
                    <a:pt x="3395447" y="1783209"/>
                  </a:lnTo>
                  <a:lnTo>
                    <a:pt x="3352484" y="1815641"/>
                  </a:lnTo>
                  <a:lnTo>
                    <a:pt x="3305266" y="1850979"/>
                  </a:lnTo>
                  <a:lnTo>
                    <a:pt x="3295538" y="1858536"/>
                  </a:lnTo>
                  <a:lnTo>
                    <a:pt x="3258048" y="1887223"/>
                  </a:lnTo>
                  <a:lnTo>
                    <a:pt x="3210830" y="1923022"/>
                  </a:lnTo>
                  <a:lnTo>
                    <a:pt x="3190441" y="1938742"/>
                  </a:lnTo>
                  <a:lnTo>
                    <a:pt x="3163612" y="1959757"/>
                  </a:lnTo>
                  <a:lnTo>
                    <a:pt x="3116394" y="1996319"/>
                  </a:lnTo>
                  <a:lnTo>
                    <a:pt x="3080284" y="2024391"/>
                  </a:lnTo>
                  <a:lnTo>
                    <a:pt x="3069175" y="2033544"/>
                  </a:lnTo>
                  <a:lnTo>
                    <a:pt x="3021957" y="2071006"/>
                  </a:lnTo>
                  <a:lnTo>
                    <a:pt x="2974739" y="2108358"/>
                  </a:lnTo>
                  <a:lnTo>
                    <a:pt x="2965258" y="2116249"/>
                  </a:lnTo>
                  <a:lnTo>
                    <a:pt x="2927521" y="2146961"/>
                  </a:lnTo>
                  <a:lnTo>
                    <a:pt x="2880303" y="2185293"/>
                  </a:lnTo>
                  <a:lnTo>
                    <a:pt x="2845617" y="2213608"/>
                  </a:lnTo>
                  <a:lnTo>
                    <a:pt x="2833085" y="2224372"/>
                  </a:lnTo>
                  <a:lnTo>
                    <a:pt x="2785867" y="2263611"/>
                  </a:lnTo>
                  <a:lnTo>
                    <a:pt x="2738649" y="2302755"/>
                  </a:lnTo>
                  <a:lnTo>
                    <a:pt x="2721685" y="2317145"/>
                  </a:lnTo>
                  <a:lnTo>
                    <a:pt x="2691431" y="2342942"/>
                  </a:lnTo>
                  <a:lnTo>
                    <a:pt x="2644213" y="2383081"/>
                  </a:lnTo>
                  <a:lnTo>
                    <a:pt x="2596995" y="2423268"/>
                  </a:lnTo>
                  <a:lnTo>
                    <a:pt x="2593851" y="2425960"/>
                  </a:lnTo>
                  <a:lnTo>
                    <a:pt x="2549776" y="2463821"/>
                  </a:lnTo>
                  <a:lnTo>
                    <a:pt x="2502558" y="2504372"/>
                  </a:lnTo>
                  <a:lnTo>
                    <a:pt x="2462567" y="2538640"/>
                  </a:lnTo>
                  <a:lnTo>
                    <a:pt x="2455340" y="2545247"/>
                  </a:lnTo>
                  <a:lnTo>
                    <a:pt x="2408122" y="2586117"/>
                  </a:lnTo>
                  <a:lnTo>
                    <a:pt x="2360904" y="2626853"/>
                  </a:lnTo>
                  <a:lnTo>
                    <a:pt x="2328343" y="2654955"/>
                  </a:lnTo>
                  <a:lnTo>
                    <a:pt x="2313686" y="2667967"/>
                  </a:lnTo>
                  <a:lnTo>
                    <a:pt x="2266468" y="2708894"/>
                  </a:lnTo>
                  <a:lnTo>
                    <a:pt x="2219250" y="2749566"/>
                  </a:lnTo>
                  <a:lnTo>
                    <a:pt x="2191740" y="2773302"/>
                  </a:lnTo>
                  <a:lnTo>
                    <a:pt x="2172032" y="2790579"/>
                  </a:lnTo>
                  <a:lnTo>
                    <a:pt x="2124814" y="2831295"/>
                  </a:lnTo>
                  <a:lnTo>
                    <a:pt x="2077596" y="2871676"/>
                  </a:lnTo>
                  <a:lnTo>
                    <a:pt x="2053366" y="2892449"/>
                  </a:lnTo>
                  <a:lnTo>
                    <a:pt x="2030377" y="2912347"/>
                  </a:lnTo>
                  <a:lnTo>
                    <a:pt x="1983159" y="2952659"/>
                  </a:lnTo>
                  <a:lnTo>
                    <a:pt x="1935941" y="2992811"/>
                  </a:lnTo>
                  <a:lnTo>
                    <a:pt x="1913857" y="3011460"/>
                  </a:lnTo>
                  <a:lnTo>
                    <a:pt x="1888723" y="3032801"/>
                  </a:lnTo>
                  <a:lnTo>
                    <a:pt x="1841505" y="3072629"/>
                  </a:lnTo>
                  <a:lnTo>
                    <a:pt x="1794287" y="3112067"/>
                  </a:lnTo>
                  <a:lnTo>
                    <a:pt x="1773873" y="3129206"/>
                  </a:lnTo>
                  <a:lnTo>
                    <a:pt x="1747069" y="3151817"/>
                  </a:lnTo>
                  <a:lnTo>
                    <a:pt x="1699851" y="3191211"/>
                  </a:lnTo>
                  <a:lnTo>
                    <a:pt x="1652633" y="3230232"/>
                  </a:lnTo>
                  <a:lnTo>
                    <a:pt x="1634083" y="3245702"/>
                  </a:lnTo>
                  <a:lnTo>
                    <a:pt x="1605415" y="3269700"/>
                  </a:lnTo>
                  <a:lnTo>
                    <a:pt x="1558197" y="3308870"/>
                  </a:lnTo>
                  <a:lnTo>
                    <a:pt x="1510978" y="3347714"/>
                  </a:lnTo>
                  <a:lnTo>
                    <a:pt x="1495152" y="3360965"/>
                  </a:lnTo>
                  <a:lnTo>
                    <a:pt x="1463760" y="3387262"/>
                  </a:lnTo>
                  <a:lnTo>
                    <a:pt x="1416542" y="3426612"/>
                  </a:lnTo>
                  <a:lnTo>
                    <a:pt x="1369324" y="3465714"/>
                  </a:lnTo>
                  <a:lnTo>
                    <a:pt x="1357729" y="3475679"/>
                  </a:lnTo>
                  <a:lnTo>
                    <a:pt x="1322106" y="3505929"/>
                  </a:lnTo>
                  <a:lnTo>
                    <a:pt x="1274888" y="3546079"/>
                  </a:lnTo>
                  <a:lnTo>
                    <a:pt x="1227670" y="3586099"/>
                  </a:lnTo>
                  <a:lnTo>
                    <a:pt x="1222433" y="3591064"/>
                  </a:lnTo>
                  <a:lnTo>
                    <a:pt x="1180452" y="3627776"/>
                  </a:lnTo>
                  <a:lnTo>
                    <a:pt x="1133234" y="3669431"/>
                  </a:lnTo>
                  <a:lnTo>
                    <a:pt x="1089847" y="3707863"/>
                  </a:lnTo>
                  <a:lnTo>
                    <a:pt x="1086016" y="3712011"/>
                  </a:lnTo>
                  <a:lnTo>
                    <a:pt x="1038798" y="3755297"/>
                  </a:lnTo>
                  <a:lnTo>
                    <a:pt x="991579" y="3799056"/>
                  </a:lnTo>
                  <a:lnTo>
                    <a:pt x="960504" y="3828397"/>
                  </a:lnTo>
                  <a:lnTo>
                    <a:pt x="944361" y="3843835"/>
                  </a:lnTo>
                  <a:lnTo>
                    <a:pt x="897143" y="3889862"/>
                  </a:lnTo>
                  <a:lnTo>
                    <a:pt x="849925" y="3936873"/>
                  </a:lnTo>
                  <a:lnTo>
                    <a:pt x="834880" y="3952214"/>
                  </a:lnTo>
                  <a:lnTo>
                    <a:pt x="802707" y="3984571"/>
                  </a:lnTo>
                  <a:lnTo>
                    <a:pt x="755489" y="4033502"/>
                  </a:lnTo>
                  <a:lnTo>
                    <a:pt x="713392" y="4077032"/>
                  </a:lnTo>
                  <a:lnTo>
                    <a:pt x="708271" y="4082371"/>
                  </a:lnTo>
                  <a:lnTo>
                    <a:pt x="661053" y="4131546"/>
                  </a:lnTo>
                  <a:lnTo>
                    <a:pt x="613835" y="4180634"/>
                  </a:lnTo>
                  <a:lnTo>
                    <a:pt x="596390" y="4198942"/>
                  </a:lnTo>
                  <a:lnTo>
                    <a:pt x="566617" y="4230148"/>
                  </a:lnTo>
                  <a:lnTo>
                    <a:pt x="519399" y="4279136"/>
                  </a:lnTo>
                  <a:lnTo>
                    <a:pt x="484158" y="4315480"/>
                  </a:lnTo>
                  <a:lnTo>
                    <a:pt x="472180" y="4328003"/>
                  </a:lnTo>
                  <a:lnTo>
                    <a:pt x="424962" y="4376339"/>
                  </a:lnTo>
                  <a:lnTo>
                    <a:pt x="377744" y="4424114"/>
                  </a:lnTo>
                  <a:lnTo>
                    <a:pt x="376915" y="4424948"/>
                  </a:lnTo>
                  <a:lnTo>
                    <a:pt x="330526" y="4471256"/>
                  </a:lnTo>
                  <a:lnTo>
                    <a:pt x="283308" y="4517528"/>
                  </a:lnTo>
                  <a:lnTo>
                    <a:pt x="274812" y="4525875"/>
                  </a:lnTo>
                  <a:lnTo>
                    <a:pt x="236090" y="4563208"/>
                  </a:lnTo>
                  <a:lnTo>
                    <a:pt x="188872" y="4607735"/>
                  </a:lnTo>
                  <a:lnTo>
                    <a:pt x="177944" y="4617981"/>
                  </a:lnTo>
                  <a:lnTo>
                    <a:pt x="141654" y="4651443"/>
                  </a:lnTo>
                  <a:lnTo>
                    <a:pt x="94436" y="4693862"/>
                  </a:lnTo>
                  <a:lnTo>
                    <a:pt x="86345" y="4701087"/>
                  </a:lnTo>
                  <a:lnTo>
                    <a:pt x="47218" y="4735265"/>
                  </a:lnTo>
                  <a:lnTo>
                    <a:pt x="0" y="4775293"/>
                  </a:lnTo>
                  <a:lnTo>
                    <a:pt x="0" y="3482220"/>
                  </a:lnTo>
                  <a:close/>
                </a:path>
              </a:pathLst>
            </a:custGeom>
            <a:solidFill>
              <a:srgbClr val="808080"/>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14" name="pg35"/>
            <p:cNvSpPr/>
            <p:nvPr/>
          </p:nvSpPr>
          <p:spPr>
            <a:xfrm>
              <a:off x="9349200" y="4557960"/>
              <a:ext cx="4514400" cy="4470840"/>
            </a:xfrm>
            <a:custGeom>
              <a:avLst/>
              <a:gdLst/>
              <a:ahLst/>
              <a:rect l="l" t="t" r="r" b="b"/>
              <a:pathLst>
                <a:path w="4674591" h="4643119">
                  <a:moveTo>
                    <a:pt x="0" y="3789796"/>
                  </a:moveTo>
                  <a:lnTo>
                    <a:pt x="47218" y="3769096"/>
                  </a:lnTo>
                  <a:lnTo>
                    <a:pt x="86345" y="3745977"/>
                  </a:lnTo>
                  <a:lnTo>
                    <a:pt x="94436" y="3741096"/>
                  </a:lnTo>
                  <a:lnTo>
                    <a:pt x="141654" y="3711620"/>
                  </a:lnTo>
                  <a:lnTo>
                    <a:pt x="177944" y="3688934"/>
                  </a:lnTo>
                  <a:lnTo>
                    <a:pt x="188872" y="3681914"/>
                  </a:lnTo>
                  <a:lnTo>
                    <a:pt x="236090" y="3650405"/>
                  </a:lnTo>
                  <a:lnTo>
                    <a:pt x="274812" y="3624671"/>
                  </a:lnTo>
                  <a:lnTo>
                    <a:pt x="283308" y="3618870"/>
                  </a:lnTo>
                  <a:lnTo>
                    <a:pt x="330526" y="3585605"/>
                  </a:lnTo>
                  <a:lnTo>
                    <a:pt x="376915" y="3552636"/>
                  </a:lnTo>
                  <a:lnTo>
                    <a:pt x="377744" y="3552035"/>
                  </a:lnTo>
                  <a:lnTo>
                    <a:pt x="424962" y="3517317"/>
                  </a:lnTo>
                  <a:lnTo>
                    <a:pt x="472180" y="3481791"/>
                  </a:lnTo>
                  <a:lnTo>
                    <a:pt x="484158" y="3473114"/>
                  </a:lnTo>
                  <a:lnTo>
                    <a:pt x="519399" y="3445623"/>
                  </a:lnTo>
                  <a:lnTo>
                    <a:pt x="566617" y="3408204"/>
                  </a:lnTo>
                  <a:lnTo>
                    <a:pt x="596390" y="3384656"/>
                  </a:lnTo>
                  <a:lnTo>
                    <a:pt x="613835" y="3370662"/>
                  </a:lnTo>
                  <a:lnTo>
                    <a:pt x="661053" y="3332014"/>
                  </a:lnTo>
                  <a:lnTo>
                    <a:pt x="708271" y="3292616"/>
                  </a:lnTo>
                  <a:lnTo>
                    <a:pt x="713392" y="3288310"/>
                  </a:lnTo>
                  <a:lnTo>
                    <a:pt x="755489" y="3252586"/>
                  </a:lnTo>
                  <a:lnTo>
                    <a:pt x="802707" y="3211548"/>
                  </a:lnTo>
                  <a:lnTo>
                    <a:pt x="834880" y="3183833"/>
                  </a:lnTo>
                  <a:lnTo>
                    <a:pt x="849925" y="3170816"/>
                  </a:lnTo>
                  <a:lnTo>
                    <a:pt x="897143" y="3128879"/>
                  </a:lnTo>
                  <a:lnTo>
                    <a:pt x="944361" y="3086910"/>
                  </a:lnTo>
                  <a:lnTo>
                    <a:pt x="960504" y="3072778"/>
                  </a:lnTo>
                  <a:lnTo>
                    <a:pt x="991579" y="3044742"/>
                  </a:lnTo>
                  <a:lnTo>
                    <a:pt x="1038798" y="3001863"/>
                  </a:lnTo>
                  <a:lnTo>
                    <a:pt x="1086016" y="2958885"/>
                  </a:lnTo>
                  <a:lnTo>
                    <a:pt x="1089847" y="2955386"/>
                  </a:lnTo>
                  <a:lnTo>
                    <a:pt x="1133234" y="2915633"/>
                  </a:lnTo>
                  <a:lnTo>
                    <a:pt x="1180452" y="2872140"/>
                  </a:lnTo>
                  <a:lnTo>
                    <a:pt x="1222433" y="2833345"/>
                  </a:lnTo>
                  <a:lnTo>
                    <a:pt x="1227670" y="2828709"/>
                  </a:lnTo>
                  <a:lnTo>
                    <a:pt x="1274888" y="2784513"/>
                  </a:lnTo>
                  <a:lnTo>
                    <a:pt x="1322106" y="2740420"/>
                  </a:lnTo>
                  <a:lnTo>
                    <a:pt x="1357729" y="2707162"/>
                  </a:lnTo>
                  <a:lnTo>
                    <a:pt x="1369324" y="2696416"/>
                  </a:lnTo>
                  <a:lnTo>
                    <a:pt x="1416542" y="2651764"/>
                  </a:lnTo>
                  <a:lnTo>
                    <a:pt x="1463760" y="2607236"/>
                  </a:lnTo>
                  <a:lnTo>
                    <a:pt x="1495152" y="2577712"/>
                  </a:lnTo>
                  <a:lnTo>
                    <a:pt x="1510978" y="2562822"/>
                  </a:lnTo>
                  <a:lnTo>
                    <a:pt x="1558197" y="2517874"/>
                  </a:lnTo>
                  <a:lnTo>
                    <a:pt x="1605415" y="2473075"/>
                  </a:lnTo>
                  <a:lnTo>
                    <a:pt x="1634083" y="2445995"/>
                  </a:lnTo>
                  <a:lnTo>
                    <a:pt x="1652633" y="2428419"/>
                  </a:lnTo>
                  <a:lnTo>
                    <a:pt x="1699851" y="2383342"/>
                  </a:lnTo>
                  <a:lnTo>
                    <a:pt x="1747069" y="2338445"/>
                  </a:lnTo>
                  <a:lnTo>
                    <a:pt x="1773873" y="2313105"/>
                  </a:lnTo>
                  <a:lnTo>
                    <a:pt x="1794287" y="2293727"/>
                  </a:lnTo>
                  <a:lnTo>
                    <a:pt x="1841505" y="2248699"/>
                  </a:lnTo>
                  <a:lnTo>
                    <a:pt x="1888723" y="2203886"/>
                  </a:lnTo>
                  <a:lnTo>
                    <a:pt x="1913857" y="2180194"/>
                  </a:lnTo>
                  <a:lnTo>
                    <a:pt x="1935941" y="2159287"/>
                  </a:lnTo>
                  <a:lnTo>
                    <a:pt x="1983159" y="2114485"/>
                  </a:lnTo>
                  <a:lnTo>
                    <a:pt x="2030377" y="2069931"/>
                  </a:lnTo>
                  <a:lnTo>
                    <a:pt x="2053366" y="2048411"/>
                  </a:lnTo>
                  <a:lnTo>
                    <a:pt x="2077596" y="2025622"/>
                  </a:lnTo>
                  <a:lnTo>
                    <a:pt x="2124814" y="1981209"/>
                  </a:lnTo>
                  <a:lnTo>
                    <a:pt x="2172032" y="1937070"/>
                  </a:lnTo>
                  <a:lnTo>
                    <a:pt x="2191740" y="1918819"/>
                  </a:lnTo>
                  <a:lnTo>
                    <a:pt x="2219250" y="1893197"/>
                  </a:lnTo>
                  <a:lnTo>
                    <a:pt x="2266468" y="1849307"/>
                  </a:lnTo>
                  <a:lnTo>
                    <a:pt x="2313686" y="1805703"/>
                  </a:lnTo>
                  <a:lnTo>
                    <a:pt x="2328343" y="1792221"/>
                  </a:lnTo>
                  <a:lnTo>
                    <a:pt x="2360904" y="1762433"/>
                  </a:lnTo>
                  <a:lnTo>
                    <a:pt x="2408122" y="1718694"/>
                  </a:lnTo>
                  <a:lnTo>
                    <a:pt x="2455340" y="1675839"/>
                  </a:lnTo>
                  <a:lnTo>
                    <a:pt x="2462567" y="1669322"/>
                  </a:lnTo>
                  <a:lnTo>
                    <a:pt x="2502558" y="1632896"/>
                  </a:lnTo>
                  <a:lnTo>
                    <a:pt x="2549776" y="1590690"/>
                  </a:lnTo>
                  <a:lnTo>
                    <a:pt x="2593851" y="1551131"/>
                  </a:lnTo>
                  <a:lnTo>
                    <a:pt x="2596995" y="1548316"/>
                  </a:lnTo>
                  <a:lnTo>
                    <a:pt x="2644213" y="1506049"/>
                  </a:lnTo>
                  <a:lnTo>
                    <a:pt x="2691431" y="1463990"/>
                  </a:lnTo>
                  <a:lnTo>
                    <a:pt x="2721685" y="1437193"/>
                  </a:lnTo>
                  <a:lnTo>
                    <a:pt x="2738649" y="1422191"/>
                  </a:lnTo>
                  <a:lnTo>
                    <a:pt x="2785867" y="1380175"/>
                  </a:lnTo>
                  <a:lnTo>
                    <a:pt x="2833085" y="1338315"/>
                  </a:lnTo>
                  <a:lnTo>
                    <a:pt x="2845617" y="1327416"/>
                  </a:lnTo>
                  <a:lnTo>
                    <a:pt x="2880303" y="1296555"/>
                  </a:lnTo>
                  <a:lnTo>
                    <a:pt x="2927521" y="1254450"/>
                  </a:lnTo>
                  <a:lnTo>
                    <a:pt x="2965258" y="1220861"/>
                  </a:lnTo>
                  <a:lnTo>
                    <a:pt x="2974739" y="1212402"/>
                  </a:lnTo>
                  <a:lnTo>
                    <a:pt x="3021957" y="1170230"/>
                  </a:lnTo>
                  <a:lnTo>
                    <a:pt x="3069175" y="1127554"/>
                  </a:lnTo>
                  <a:lnTo>
                    <a:pt x="3080284" y="1117444"/>
                  </a:lnTo>
                  <a:lnTo>
                    <a:pt x="3116394" y="1084307"/>
                  </a:lnTo>
                  <a:lnTo>
                    <a:pt x="3163612" y="1040753"/>
                  </a:lnTo>
                  <a:lnTo>
                    <a:pt x="3190441" y="1016088"/>
                  </a:lnTo>
                  <a:lnTo>
                    <a:pt x="3210830" y="997014"/>
                  </a:lnTo>
                  <a:lnTo>
                    <a:pt x="3258048" y="952950"/>
                  </a:lnTo>
                  <a:lnTo>
                    <a:pt x="3295538" y="917999"/>
                  </a:lnTo>
                  <a:lnTo>
                    <a:pt x="3305266" y="908588"/>
                  </a:lnTo>
                  <a:lnTo>
                    <a:pt x="3352484" y="863979"/>
                  </a:lnTo>
                  <a:lnTo>
                    <a:pt x="3395447" y="823296"/>
                  </a:lnTo>
                  <a:lnTo>
                    <a:pt x="3399702" y="819255"/>
                  </a:lnTo>
                  <a:lnTo>
                    <a:pt x="3446920" y="774229"/>
                  </a:lnTo>
                  <a:lnTo>
                    <a:pt x="3490101" y="733283"/>
                  </a:lnTo>
                  <a:lnTo>
                    <a:pt x="3494138" y="729445"/>
                  </a:lnTo>
                  <a:lnTo>
                    <a:pt x="3541356" y="684512"/>
                  </a:lnTo>
                  <a:lnTo>
                    <a:pt x="3579486" y="648613"/>
                  </a:lnTo>
                  <a:lnTo>
                    <a:pt x="3588574" y="640217"/>
                  </a:lnTo>
                  <a:lnTo>
                    <a:pt x="3635793" y="595621"/>
                  </a:lnTo>
                  <a:lnTo>
                    <a:pt x="3663638" y="569845"/>
                  </a:lnTo>
                  <a:lnTo>
                    <a:pt x="3683011" y="551936"/>
                  </a:lnTo>
                  <a:lnTo>
                    <a:pt x="3730229" y="508404"/>
                  </a:lnTo>
                  <a:lnTo>
                    <a:pt x="3742635" y="497332"/>
                  </a:lnTo>
                  <a:lnTo>
                    <a:pt x="3777447" y="465865"/>
                  </a:lnTo>
                  <a:lnTo>
                    <a:pt x="3816594" y="431112"/>
                  </a:lnTo>
                  <a:lnTo>
                    <a:pt x="3824665" y="424036"/>
                  </a:lnTo>
                  <a:lnTo>
                    <a:pt x="3871883" y="383097"/>
                  </a:lnTo>
                  <a:lnTo>
                    <a:pt x="3885661" y="371608"/>
                  </a:lnTo>
                  <a:lnTo>
                    <a:pt x="3919101" y="343559"/>
                  </a:lnTo>
                  <a:lnTo>
                    <a:pt x="3950007" y="318285"/>
                  </a:lnTo>
                  <a:lnTo>
                    <a:pt x="3966319" y="305220"/>
                  </a:lnTo>
                  <a:lnTo>
                    <a:pt x="4009822" y="271042"/>
                  </a:lnTo>
                  <a:lnTo>
                    <a:pt x="4013537" y="268194"/>
                  </a:lnTo>
                  <a:lnTo>
                    <a:pt x="4060755" y="232860"/>
                  </a:lnTo>
                  <a:lnTo>
                    <a:pt x="4065313" y="229546"/>
                  </a:lnTo>
                  <a:lnTo>
                    <a:pt x="4107973" y="199383"/>
                  </a:lnTo>
                  <a:lnTo>
                    <a:pt x="4116694" y="193410"/>
                  </a:lnTo>
                  <a:lnTo>
                    <a:pt x="4155192" y="167869"/>
                  </a:lnTo>
                  <a:lnTo>
                    <a:pt x="4164186" y="162108"/>
                  </a:lnTo>
                  <a:lnTo>
                    <a:pt x="4202410" y="138519"/>
                  </a:lnTo>
                  <a:lnTo>
                    <a:pt x="4208012" y="135190"/>
                  </a:lnTo>
                  <a:lnTo>
                    <a:pt x="4248395" y="112199"/>
                  </a:lnTo>
                  <a:lnTo>
                    <a:pt x="4249628" y="111525"/>
                  </a:lnTo>
                  <a:lnTo>
                    <a:pt x="4285553" y="92694"/>
                  </a:lnTo>
                  <a:lnTo>
                    <a:pt x="4296846" y="87088"/>
                  </a:lnTo>
                  <a:lnTo>
                    <a:pt x="4319701" y="76219"/>
                  </a:lnTo>
                  <a:lnTo>
                    <a:pt x="4344064" y="65368"/>
                  </a:lnTo>
                  <a:lnTo>
                    <a:pt x="4351045" y="62398"/>
                  </a:lnTo>
                  <a:lnTo>
                    <a:pt x="4379786" y="50838"/>
                  </a:lnTo>
                  <a:lnTo>
                    <a:pt x="4391282" y="46535"/>
                  </a:lnTo>
                  <a:lnTo>
                    <a:pt x="4406113" y="41259"/>
                  </a:lnTo>
                  <a:lnTo>
                    <a:pt x="4430208" y="33338"/>
                  </a:lnTo>
                  <a:lnTo>
                    <a:pt x="4438500" y="30804"/>
                  </a:lnTo>
                  <a:lnTo>
                    <a:pt x="4452241" y="26825"/>
                  </a:lnTo>
                  <a:lnTo>
                    <a:pt x="4472374" y="21496"/>
                  </a:lnTo>
                  <a:lnTo>
                    <a:pt x="4485718" y="18296"/>
                  </a:lnTo>
                  <a:lnTo>
                    <a:pt x="4490758" y="17155"/>
                  </a:lnTo>
                  <a:lnTo>
                    <a:pt x="4507534" y="13638"/>
                  </a:lnTo>
                  <a:lnTo>
                    <a:pt x="4522834" y="10790"/>
                  </a:lnTo>
                  <a:lnTo>
                    <a:pt x="4532936" y="9108"/>
                  </a:lnTo>
                  <a:lnTo>
                    <a:pt x="4536781" y="8509"/>
                  </a:lnTo>
                  <a:lnTo>
                    <a:pt x="4549489" y="6683"/>
                  </a:lnTo>
                  <a:lnTo>
                    <a:pt x="4561062" y="5229"/>
                  </a:lnTo>
                  <a:lnTo>
                    <a:pt x="4571597" y="4075"/>
                  </a:lnTo>
                  <a:lnTo>
                    <a:pt x="4580154" y="3255"/>
                  </a:lnTo>
                  <a:lnTo>
                    <a:pt x="4581184" y="3164"/>
                  </a:lnTo>
                  <a:lnTo>
                    <a:pt x="4589906" y="2446"/>
                  </a:lnTo>
                  <a:lnTo>
                    <a:pt x="4597839" y="1884"/>
                  </a:lnTo>
                  <a:lnTo>
                    <a:pt x="4605051" y="1446"/>
                  </a:lnTo>
                  <a:lnTo>
                    <a:pt x="4611607" y="1105"/>
                  </a:lnTo>
                  <a:lnTo>
                    <a:pt x="4617564" y="841"/>
                  </a:lnTo>
                  <a:lnTo>
                    <a:pt x="4622978" y="638"/>
                  </a:lnTo>
                  <a:lnTo>
                    <a:pt x="4627372" y="497"/>
                  </a:lnTo>
                  <a:lnTo>
                    <a:pt x="4627895" y="482"/>
                  </a:lnTo>
                  <a:lnTo>
                    <a:pt x="4632361" y="363"/>
                  </a:lnTo>
                  <a:lnTo>
                    <a:pt x="4636418" y="272"/>
                  </a:lnTo>
                  <a:lnTo>
                    <a:pt x="4640101" y="203"/>
                  </a:lnTo>
                  <a:lnTo>
                    <a:pt x="4643444" y="151"/>
                  </a:lnTo>
                  <a:lnTo>
                    <a:pt x="4646480" y="112"/>
                  </a:lnTo>
                  <a:lnTo>
                    <a:pt x="4649235" y="82"/>
                  </a:lnTo>
                  <a:lnTo>
                    <a:pt x="4651736" y="60"/>
                  </a:lnTo>
                  <a:lnTo>
                    <a:pt x="4654005" y="44"/>
                  </a:lnTo>
                  <a:lnTo>
                    <a:pt x="4656065" y="32"/>
                  </a:lnTo>
                  <a:lnTo>
                    <a:pt x="4657934" y="23"/>
                  </a:lnTo>
                  <a:lnTo>
                    <a:pt x="4659629" y="17"/>
                  </a:lnTo>
                  <a:lnTo>
                    <a:pt x="4661168" y="12"/>
                  </a:lnTo>
                  <a:lnTo>
                    <a:pt x="4662563" y="8"/>
                  </a:lnTo>
                  <a:lnTo>
                    <a:pt x="4663830" y="6"/>
                  </a:lnTo>
                  <a:lnTo>
                    <a:pt x="4664978" y="4"/>
                  </a:lnTo>
                  <a:lnTo>
                    <a:pt x="4666020" y="3"/>
                  </a:lnTo>
                  <a:lnTo>
                    <a:pt x="4666965" y="2"/>
                  </a:lnTo>
                  <a:lnTo>
                    <a:pt x="4667823" y="1"/>
                  </a:lnTo>
                  <a:lnTo>
                    <a:pt x="4668600" y="1"/>
                  </a:lnTo>
                  <a:lnTo>
                    <a:pt x="4669305" y="0"/>
                  </a:lnTo>
                  <a:lnTo>
                    <a:pt x="4669945" y="0"/>
                  </a:lnTo>
                  <a:lnTo>
                    <a:pt x="4670525" y="0"/>
                  </a:lnTo>
                  <a:lnTo>
                    <a:pt x="4671052" y="0"/>
                  </a:lnTo>
                  <a:lnTo>
                    <a:pt x="4671529" y="0"/>
                  </a:lnTo>
                  <a:lnTo>
                    <a:pt x="4671962" y="0"/>
                  </a:lnTo>
                  <a:lnTo>
                    <a:pt x="4672354" y="0"/>
                  </a:lnTo>
                  <a:lnTo>
                    <a:pt x="4672710" y="0"/>
                  </a:lnTo>
                  <a:lnTo>
                    <a:pt x="4673033" y="0"/>
                  </a:lnTo>
                  <a:lnTo>
                    <a:pt x="4673326" y="0"/>
                  </a:lnTo>
                  <a:lnTo>
                    <a:pt x="4673591" y="0"/>
                  </a:lnTo>
                  <a:lnTo>
                    <a:pt x="4673832" y="0"/>
                  </a:lnTo>
                  <a:lnTo>
                    <a:pt x="4674050" y="0"/>
                  </a:lnTo>
                  <a:lnTo>
                    <a:pt x="4674248" y="0"/>
                  </a:lnTo>
                  <a:lnTo>
                    <a:pt x="4674428" y="0"/>
                  </a:lnTo>
                  <a:lnTo>
                    <a:pt x="4674591" y="0"/>
                  </a:lnTo>
                  <a:lnTo>
                    <a:pt x="4674591" y="2282139"/>
                  </a:lnTo>
                  <a:lnTo>
                    <a:pt x="4674428" y="2160902"/>
                  </a:lnTo>
                  <a:lnTo>
                    <a:pt x="4674248" y="2044826"/>
                  </a:lnTo>
                  <a:lnTo>
                    <a:pt x="4674050" y="1934179"/>
                  </a:lnTo>
                  <a:lnTo>
                    <a:pt x="4673832" y="1829133"/>
                  </a:lnTo>
                  <a:lnTo>
                    <a:pt x="4673591" y="1729771"/>
                  </a:lnTo>
                  <a:lnTo>
                    <a:pt x="4673326" y="1636098"/>
                  </a:lnTo>
                  <a:lnTo>
                    <a:pt x="4673033" y="1548058"/>
                  </a:lnTo>
                  <a:lnTo>
                    <a:pt x="4672710" y="1466004"/>
                  </a:lnTo>
                  <a:lnTo>
                    <a:pt x="4672354" y="1388234"/>
                  </a:lnTo>
                  <a:lnTo>
                    <a:pt x="4671962" y="1316397"/>
                  </a:lnTo>
                  <a:lnTo>
                    <a:pt x="4671529" y="1249383"/>
                  </a:lnTo>
                  <a:lnTo>
                    <a:pt x="4671052" y="1187109"/>
                  </a:lnTo>
                  <a:lnTo>
                    <a:pt x="4670525" y="1129339"/>
                  </a:lnTo>
                  <a:lnTo>
                    <a:pt x="4669945" y="1075832"/>
                  </a:lnTo>
                  <a:lnTo>
                    <a:pt x="4669305" y="1026350"/>
                  </a:lnTo>
                  <a:lnTo>
                    <a:pt x="4668600" y="980657"/>
                  </a:lnTo>
                  <a:lnTo>
                    <a:pt x="4667823" y="938525"/>
                  </a:lnTo>
                  <a:lnTo>
                    <a:pt x="4666965" y="899736"/>
                  </a:lnTo>
                  <a:lnTo>
                    <a:pt x="4666020" y="864081"/>
                  </a:lnTo>
                  <a:lnTo>
                    <a:pt x="4664978" y="831363"/>
                  </a:lnTo>
                  <a:lnTo>
                    <a:pt x="4663830" y="801397"/>
                  </a:lnTo>
                  <a:lnTo>
                    <a:pt x="4662563" y="774011"/>
                  </a:lnTo>
                  <a:lnTo>
                    <a:pt x="4661168" y="749045"/>
                  </a:lnTo>
                  <a:lnTo>
                    <a:pt x="4659629" y="726351"/>
                  </a:lnTo>
                  <a:lnTo>
                    <a:pt x="4657934" y="705793"/>
                  </a:lnTo>
                  <a:lnTo>
                    <a:pt x="4656065" y="687249"/>
                  </a:lnTo>
                  <a:lnTo>
                    <a:pt x="4654005" y="670604"/>
                  </a:lnTo>
                  <a:lnTo>
                    <a:pt x="4651736" y="655758"/>
                  </a:lnTo>
                  <a:lnTo>
                    <a:pt x="4649235" y="642618"/>
                  </a:lnTo>
                  <a:lnTo>
                    <a:pt x="4646480" y="631103"/>
                  </a:lnTo>
                  <a:lnTo>
                    <a:pt x="4643444" y="621141"/>
                  </a:lnTo>
                  <a:lnTo>
                    <a:pt x="4640101" y="612669"/>
                  </a:lnTo>
                  <a:lnTo>
                    <a:pt x="4636418" y="605631"/>
                  </a:lnTo>
                  <a:lnTo>
                    <a:pt x="4632361" y="600011"/>
                  </a:lnTo>
                  <a:lnTo>
                    <a:pt x="4627895" y="595650"/>
                  </a:lnTo>
                  <a:lnTo>
                    <a:pt x="4627372" y="595256"/>
                  </a:lnTo>
                  <a:lnTo>
                    <a:pt x="4622978" y="592695"/>
                  </a:lnTo>
                  <a:lnTo>
                    <a:pt x="4617564" y="591004"/>
                  </a:lnTo>
                  <a:lnTo>
                    <a:pt x="4611607" y="590589"/>
                  </a:lnTo>
                  <a:lnTo>
                    <a:pt x="4605051" y="591440"/>
                  </a:lnTo>
                  <a:lnTo>
                    <a:pt x="4597839" y="593552"/>
                  </a:lnTo>
                  <a:lnTo>
                    <a:pt x="4589906" y="596962"/>
                  </a:lnTo>
                  <a:lnTo>
                    <a:pt x="4581184" y="601548"/>
                  </a:lnTo>
                  <a:lnTo>
                    <a:pt x="4580154" y="602150"/>
                  </a:lnTo>
                  <a:lnTo>
                    <a:pt x="4571597" y="607518"/>
                  </a:lnTo>
                  <a:lnTo>
                    <a:pt x="4561062" y="614767"/>
                  </a:lnTo>
                  <a:lnTo>
                    <a:pt x="4549489" y="623356"/>
                  </a:lnTo>
                  <a:lnTo>
                    <a:pt x="4536781" y="633180"/>
                  </a:lnTo>
                  <a:lnTo>
                    <a:pt x="4532936" y="636339"/>
                  </a:lnTo>
                  <a:lnTo>
                    <a:pt x="4522834" y="644689"/>
                  </a:lnTo>
                  <a:lnTo>
                    <a:pt x="4507534" y="657527"/>
                  </a:lnTo>
                  <a:lnTo>
                    <a:pt x="4490758" y="671731"/>
                  </a:lnTo>
                  <a:lnTo>
                    <a:pt x="4485718" y="676146"/>
                  </a:lnTo>
                  <a:lnTo>
                    <a:pt x="4472374" y="687802"/>
                  </a:lnTo>
                  <a:lnTo>
                    <a:pt x="4452241" y="705271"/>
                  </a:lnTo>
                  <a:lnTo>
                    <a:pt x="4438500" y="717247"/>
                  </a:lnTo>
                  <a:lnTo>
                    <a:pt x="4430208" y="724657"/>
                  </a:lnTo>
                  <a:lnTo>
                    <a:pt x="4406113" y="745620"/>
                  </a:lnTo>
                  <a:lnTo>
                    <a:pt x="4391282" y="758540"/>
                  </a:lnTo>
                  <a:lnTo>
                    <a:pt x="4379786" y="768713"/>
                  </a:lnTo>
                  <a:lnTo>
                    <a:pt x="4351045" y="793477"/>
                  </a:lnTo>
                  <a:lnTo>
                    <a:pt x="4344064" y="799618"/>
                  </a:lnTo>
                  <a:lnTo>
                    <a:pt x="4319701" y="820586"/>
                  </a:lnTo>
                  <a:lnTo>
                    <a:pt x="4296846" y="840093"/>
                  </a:lnTo>
                  <a:lnTo>
                    <a:pt x="4285553" y="849914"/>
                  </a:lnTo>
                  <a:lnTo>
                    <a:pt x="4249628" y="880193"/>
                  </a:lnTo>
                  <a:lnTo>
                    <a:pt x="4248395" y="881465"/>
                  </a:lnTo>
                  <a:lnTo>
                    <a:pt x="4208012" y="915193"/>
                  </a:lnTo>
                  <a:lnTo>
                    <a:pt x="4202410" y="920061"/>
                  </a:lnTo>
                  <a:lnTo>
                    <a:pt x="4164186" y="951713"/>
                  </a:lnTo>
                  <a:lnTo>
                    <a:pt x="4155192" y="959329"/>
                  </a:lnTo>
                  <a:lnTo>
                    <a:pt x="4116694" y="990923"/>
                  </a:lnTo>
                  <a:lnTo>
                    <a:pt x="4107973" y="998273"/>
                  </a:lnTo>
                  <a:lnTo>
                    <a:pt x="4065313" y="1032969"/>
                  </a:lnTo>
                  <a:lnTo>
                    <a:pt x="4060755" y="1036904"/>
                  </a:lnTo>
                  <a:lnTo>
                    <a:pt x="4013537" y="1075002"/>
                  </a:lnTo>
                  <a:lnTo>
                    <a:pt x="4009822" y="1078184"/>
                  </a:lnTo>
                  <a:lnTo>
                    <a:pt x="3966319" y="1113102"/>
                  </a:lnTo>
                  <a:lnTo>
                    <a:pt x="3950007" y="1126267"/>
                  </a:lnTo>
                  <a:lnTo>
                    <a:pt x="3919101" y="1151051"/>
                  </a:lnTo>
                  <a:lnTo>
                    <a:pt x="3885661" y="1177681"/>
                  </a:lnTo>
                  <a:lnTo>
                    <a:pt x="3871883" y="1188848"/>
                  </a:lnTo>
                  <a:lnTo>
                    <a:pt x="3824665" y="1226216"/>
                  </a:lnTo>
                  <a:lnTo>
                    <a:pt x="3816594" y="1232745"/>
                  </a:lnTo>
                  <a:lnTo>
                    <a:pt x="3777447" y="1263762"/>
                  </a:lnTo>
                  <a:lnTo>
                    <a:pt x="3742635" y="1291223"/>
                  </a:lnTo>
                  <a:lnTo>
                    <a:pt x="3730229" y="1301217"/>
                  </a:lnTo>
                  <a:lnTo>
                    <a:pt x="3683011" y="1338365"/>
                  </a:lnTo>
                  <a:lnTo>
                    <a:pt x="3663638" y="1353691"/>
                  </a:lnTo>
                  <a:lnTo>
                    <a:pt x="3635793" y="1375816"/>
                  </a:lnTo>
                  <a:lnTo>
                    <a:pt x="3588574" y="1412900"/>
                  </a:lnTo>
                  <a:lnTo>
                    <a:pt x="3579486" y="1420190"/>
                  </a:lnTo>
                  <a:lnTo>
                    <a:pt x="3541356" y="1450407"/>
                  </a:lnTo>
                  <a:lnTo>
                    <a:pt x="3494138" y="1487545"/>
                  </a:lnTo>
                  <a:lnTo>
                    <a:pt x="3490101" y="1490905"/>
                  </a:lnTo>
                  <a:lnTo>
                    <a:pt x="3446920" y="1525195"/>
                  </a:lnTo>
                  <a:lnTo>
                    <a:pt x="3399702" y="1562488"/>
                  </a:lnTo>
                  <a:lnTo>
                    <a:pt x="3395447" y="1566051"/>
                  </a:lnTo>
                  <a:lnTo>
                    <a:pt x="3352484" y="1600381"/>
                  </a:lnTo>
                  <a:lnTo>
                    <a:pt x="3305266" y="1637935"/>
                  </a:lnTo>
                  <a:lnTo>
                    <a:pt x="3295538" y="1645879"/>
                  </a:lnTo>
                  <a:lnTo>
                    <a:pt x="3258048" y="1676161"/>
                  </a:lnTo>
                  <a:lnTo>
                    <a:pt x="3210830" y="1714107"/>
                  </a:lnTo>
                  <a:lnTo>
                    <a:pt x="3190441" y="1730682"/>
                  </a:lnTo>
                  <a:lnTo>
                    <a:pt x="3163612" y="1752717"/>
                  </a:lnTo>
                  <a:lnTo>
                    <a:pt x="3116394" y="1791226"/>
                  </a:lnTo>
                  <a:lnTo>
                    <a:pt x="3080284" y="1820767"/>
                  </a:lnTo>
                  <a:lnTo>
                    <a:pt x="3069175" y="1830201"/>
                  </a:lnTo>
                  <a:lnTo>
                    <a:pt x="3021957" y="1869341"/>
                  </a:lnTo>
                  <a:lnTo>
                    <a:pt x="2974739" y="1908432"/>
                  </a:lnTo>
                  <a:lnTo>
                    <a:pt x="2965258" y="1916540"/>
                  </a:lnTo>
                  <a:lnTo>
                    <a:pt x="2927521" y="1948353"/>
                  </a:lnTo>
                  <a:lnTo>
                    <a:pt x="2880303" y="1988113"/>
                  </a:lnTo>
                  <a:lnTo>
                    <a:pt x="2845617" y="2017434"/>
                  </a:lnTo>
                  <a:lnTo>
                    <a:pt x="2833085" y="2028373"/>
                  </a:lnTo>
                  <a:lnTo>
                    <a:pt x="2785867" y="2068745"/>
                  </a:lnTo>
                  <a:lnTo>
                    <a:pt x="2738649" y="2109078"/>
                  </a:lnTo>
                  <a:lnTo>
                    <a:pt x="2721685" y="2123781"/>
                  </a:lnTo>
                  <a:lnTo>
                    <a:pt x="2691431" y="2150089"/>
                  </a:lnTo>
                  <a:lnTo>
                    <a:pt x="2644213" y="2191080"/>
                  </a:lnTo>
                  <a:lnTo>
                    <a:pt x="2596995" y="2232118"/>
                  </a:lnTo>
                  <a:lnTo>
                    <a:pt x="2593851" y="2234861"/>
                  </a:lnTo>
                  <a:lnTo>
                    <a:pt x="2549776" y="2273397"/>
                  </a:lnTo>
                  <a:lnTo>
                    <a:pt x="2502558" y="2314754"/>
                  </a:lnTo>
                  <a:lnTo>
                    <a:pt x="2462567" y="2349848"/>
                  </a:lnTo>
                  <a:lnTo>
                    <a:pt x="2455340" y="2356203"/>
                  </a:lnTo>
                  <a:lnTo>
                    <a:pt x="2408122" y="2397722"/>
                  </a:lnTo>
                  <a:lnTo>
                    <a:pt x="2360904" y="2439173"/>
                  </a:lnTo>
                  <a:lnTo>
                    <a:pt x="2328343" y="2467773"/>
                  </a:lnTo>
                  <a:lnTo>
                    <a:pt x="2313686" y="2480877"/>
                  </a:lnTo>
                  <a:lnTo>
                    <a:pt x="2266468" y="2522479"/>
                  </a:lnTo>
                  <a:lnTo>
                    <a:pt x="2219250" y="2563938"/>
                  </a:lnTo>
                  <a:lnTo>
                    <a:pt x="2191740" y="2588126"/>
                  </a:lnTo>
                  <a:lnTo>
                    <a:pt x="2172032" y="2605630"/>
                  </a:lnTo>
                  <a:lnTo>
                    <a:pt x="2124814" y="2647400"/>
                  </a:lnTo>
                  <a:lnTo>
                    <a:pt x="2077596" y="2688804"/>
                  </a:lnTo>
                  <a:lnTo>
                    <a:pt x="2053366" y="2710110"/>
                  </a:lnTo>
                  <a:lnTo>
                    <a:pt x="2030377" y="2730425"/>
                  </a:lnTo>
                  <a:lnTo>
                    <a:pt x="1983159" y="2771946"/>
                  </a:lnTo>
                  <a:lnTo>
                    <a:pt x="1935941" y="2812490"/>
                  </a:lnTo>
                  <a:lnTo>
                    <a:pt x="1913857" y="2831899"/>
                  </a:lnTo>
                  <a:lnTo>
                    <a:pt x="1888723" y="2853872"/>
                  </a:lnTo>
                  <a:lnTo>
                    <a:pt x="1841505" y="2895007"/>
                  </a:lnTo>
                  <a:lnTo>
                    <a:pt x="1794287" y="2935923"/>
                  </a:lnTo>
                  <a:lnTo>
                    <a:pt x="1773873" y="2953685"/>
                  </a:lnTo>
                  <a:lnTo>
                    <a:pt x="1747069" y="2977092"/>
                  </a:lnTo>
                  <a:lnTo>
                    <a:pt x="1699851" y="3018066"/>
                  </a:lnTo>
                  <a:lnTo>
                    <a:pt x="1652633" y="3058836"/>
                  </a:lnTo>
                  <a:lnTo>
                    <a:pt x="1634083" y="3074961"/>
                  </a:lnTo>
                  <a:lnTo>
                    <a:pt x="1605415" y="3099956"/>
                  </a:lnTo>
                  <a:lnTo>
                    <a:pt x="1558197" y="3140922"/>
                  </a:lnTo>
                  <a:lnTo>
                    <a:pt x="1510978" y="3181716"/>
                  </a:lnTo>
                  <a:lnTo>
                    <a:pt x="1495152" y="3195556"/>
                  </a:lnTo>
                  <a:lnTo>
                    <a:pt x="1463760" y="3223033"/>
                  </a:lnTo>
                  <a:lnTo>
                    <a:pt x="1416542" y="3264259"/>
                  </a:lnTo>
                  <a:lnTo>
                    <a:pt x="1369324" y="3305365"/>
                  </a:lnTo>
                  <a:lnTo>
                    <a:pt x="1357729" y="3315709"/>
                  </a:lnTo>
                  <a:lnTo>
                    <a:pt x="1322106" y="3347254"/>
                  </a:lnTo>
                  <a:lnTo>
                    <a:pt x="1274888" y="3389131"/>
                  </a:lnTo>
                  <a:lnTo>
                    <a:pt x="1227670" y="3430962"/>
                  </a:lnTo>
                  <a:lnTo>
                    <a:pt x="1222433" y="3435948"/>
                  </a:lnTo>
                  <a:lnTo>
                    <a:pt x="1180452" y="3473903"/>
                  </a:lnTo>
                  <a:lnTo>
                    <a:pt x="1133234" y="3516851"/>
                  </a:lnTo>
                  <a:lnTo>
                    <a:pt x="1089847" y="3556442"/>
                  </a:lnTo>
                  <a:lnTo>
                    <a:pt x="1086016" y="3560421"/>
                  </a:lnTo>
                  <a:lnTo>
                    <a:pt x="1038798" y="3604462"/>
                  </a:lnTo>
                  <a:lnTo>
                    <a:pt x="991579" y="3648826"/>
                  </a:lnTo>
                  <a:lnTo>
                    <a:pt x="960504" y="3678383"/>
                  </a:lnTo>
                  <a:lnTo>
                    <a:pt x="944361" y="3694321"/>
                  </a:lnTo>
                  <a:lnTo>
                    <a:pt x="897143" y="3740156"/>
                  </a:lnTo>
                  <a:lnTo>
                    <a:pt x="849925" y="3786245"/>
                  </a:lnTo>
                  <a:lnTo>
                    <a:pt x="834880" y="3801328"/>
                  </a:lnTo>
                  <a:lnTo>
                    <a:pt x="802707" y="3833273"/>
                  </a:lnTo>
                  <a:lnTo>
                    <a:pt x="755489" y="3881266"/>
                  </a:lnTo>
                  <a:lnTo>
                    <a:pt x="713392" y="3924080"/>
                  </a:lnTo>
                  <a:lnTo>
                    <a:pt x="708271" y="3929322"/>
                  </a:lnTo>
                  <a:lnTo>
                    <a:pt x="661053" y="3977936"/>
                  </a:lnTo>
                  <a:lnTo>
                    <a:pt x="613835" y="4026228"/>
                  </a:lnTo>
                  <a:lnTo>
                    <a:pt x="596390" y="4044324"/>
                  </a:lnTo>
                  <a:lnTo>
                    <a:pt x="566617" y="4075298"/>
                  </a:lnTo>
                  <a:lnTo>
                    <a:pt x="519399" y="4124172"/>
                  </a:lnTo>
                  <a:lnTo>
                    <a:pt x="484158" y="4160628"/>
                  </a:lnTo>
                  <a:lnTo>
                    <a:pt x="472180" y="4173214"/>
                  </a:lnTo>
                  <a:lnTo>
                    <a:pt x="424962" y="4222063"/>
                  </a:lnTo>
                  <a:lnTo>
                    <a:pt x="377744" y="4270703"/>
                  </a:lnTo>
                  <a:lnTo>
                    <a:pt x="376915" y="4271556"/>
                  </a:lnTo>
                  <a:lnTo>
                    <a:pt x="330526" y="4319079"/>
                  </a:lnTo>
                  <a:lnTo>
                    <a:pt x="283308" y="4366980"/>
                  </a:lnTo>
                  <a:lnTo>
                    <a:pt x="274812" y="4375656"/>
                  </a:lnTo>
                  <a:lnTo>
                    <a:pt x="236090" y="4414673"/>
                  </a:lnTo>
                  <a:lnTo>
                    <a:pt x="188872" y="4461637"/>
                  </a:lnTo>
                  <a:lnTo>
                    <a:pt x="177944" y="4472502"/>
                  </a:lnTo>
                  <a:lnTo>
                    <a:pt x="141654" y="4508189"/>
                  </a:lnTo>
                  <a:lnTo>
                    <a:pt x="94436" y="4553888"/>
                  </a:lnTo>
                  <a:lnTo>
                    <a:pt x="86345" y="4561715"/>
                  </a:lnTo>
                  <a:lnTo>
                    <a:pt x="47218" y="4598990"/>
                  </a:lnTo>
                  <a:lnTo>
                    <a:pt x="0" y="4643119"/>
                  </a:lnTo>
                  <a:lnTo>
                    <a:pt x="0" y="3789796"/>
                  </a:lnTo>
                  <a:close/>
                </a:path>
              </a:pathLst>
            </a:custGeom>
            <a:solidFill>
              <a:srgbClr val="cccccc"/>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15" name="pl36"/>
            <p:cNvSpPr/>
            <p:nvPr/>
          </p:nvSpPr>
          <p:spPr>
            <a:xfrm>
              <a:off x="8337600" y="4557960"/>
              <a:ext cx="5527440" cy="5022000"/>
            </a:xfrm>
            <a:custGeom>
              <a:avLst/>
              <a:gdLst/>
              <a:ahLst/>
              <a:rect l="l" t="t" r="r" b="b"/>
              <a:pathLst>
                <a:path w="5723466" h="5215466">
                  <a:moveTo>
                    <a:pt x="0" y="5215466"/>
                  </a:moveTo>
                  <a:lnTo>
                    <a:pt x="5723466" y="0"/>
                  </a:lnTo>
                </a:path>
              </a:pathLst>
            </a:custGeom>
            <a:noFill/>
            <a:ln cap="rnd" w="16560">
              <a:solidFill>
                <a:srgbClr val="ff0000"/>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16" name="tx37"/>
            <p:cNvSpPr/>
            <p:nvPr/>
          </p:nvSpPr>
          <p:spPr>
            <a:xfrm>
              <a:off x="8337600" y="4458960"/>
              <a:ext cx="1382760" cy="13608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zh-CN" sz="1200" spc="-1" strike="noStrike">
                  <a:solidFill>
                    <a:srgbClr val="000000"/>
                  </a:solidFill>
                  <a:latin typeface="Arial"/>
                </a:rPr>
                <a:t>Polynomial degree: 2</a:t>
              </a:r>
              <a:endParaRPr b="0" lang="en-US" sz="1200" spc="-1" strike="noStrike">
                <a:solidFill>
                  <a:srgbClr val="000000"/>
                </a:solidFill>
                <a:latin typeface="Arial"/>
              </a:endParaRPr>
            </a:p>
          </p:txBody>
        </p:sp>
        <p:sp>
          <p:nvSpPr>
            <p:cNvPr id="1117" name="tx38"/>
            <p:cNvSpPr/>
            <p:nvPr/>
          </p:nvSpPr>
          <p:spPr>
            <a:xfrm>
              <a:off x="8337600" y="4712760"/>
              <a:ext cx="932760" cy="13464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zh-CN" sz="1200" spc="-1" strike="noStrike">
                  <a:solidFill>
                    <a:srgbClr val="000000"/>
                  </a:solidFill>
                  <a:latin typeface="Arial"/>
                </a:rPr>
                <a:t>p-value: 0.875</a:t>
              </a:r>
              <a:endParaRPr b="0" lang="en-US" sz="1200" spc="-1" strike="noStrike">
                <a:solidFill>
                  <a:srgbClr val="000000"/>
                </a:solidFill>
                <a:latin typeface="Arial"/>
              </a:endParaRPr>
            </a:p>
          </p:txBody>
        </p:sp>
        <p:sp>
          <p:nvSpPr>
            <p:cNvPr id="1118" name="tx39"/>
            <p:cNvSpPr/>
            <p:nvPr/>
          </p:nvSpPr>
          <p:spPr>
            <a:xfrm>
              <a:off x="8337600" y="5004720"/>
              <a:ext cx="408960" cy="10692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zh-CN" sz="1200" spc="-1" strike="noStrike">
                  <a:solidFill>
                    <a:srgbClr val="000000"/>
                  </a:solidFill>
                  <a:latin typeface="Arial"/>
                </a:rPr>
                <a:t>n: 178</a:t>
              </a:r>
              <a:endParaRPr b="0" lang="en-US" sz="1200" spc="-1" strike="noStrike">
                <a:solidFill>
                  <a:srgbClr val="000000"/>
                </a:solidFill>
                <a:latin typeface="Arial"/>
              </a:endParaRPr>
            </a:p>
          </p:txBody>
        </p:sp>
        <p:sp>
          <p:nvSpPr>
            <p:cNvPr id="1119" name="pl40"/>
            <p:cNvSpPr/>
            <p:nvPr/>
          </p:nvSpPr>
          <p:spPr>
            <a:xfrm>
              <a:off x="10548720" y="9705600"/>
              <a:ext cx="3316320" cy="360"/>
            </a:xfrm>
            <a:custGeom>
              <a:avLst/>
              <a:gdLst/>
              <a:ahLst/>
              <a:rect l="l" t="t" r="r" b="b"/>
              <a:pathLst>
                <a:path w="3434080" h="1">
                  <a:moveTo>
                    <a:pt x="0" y="0"/>
                  </a:moveTo>
                  <a:lnTo>
                    <a:pt x="343408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1120" name="tx41" descr=""/>
            <p:cNvPicPr/>
            <p:nvPr/>
          </p:nvPicPr>
          <p:blipFill>
            <a:blip r:embed="rId1"/>
            <a:stretch/>
          </p:blipFill>
          <p:spPr>
            <a:xfrm>
              <a:off x="10958040" y="9487440"/>
              <a:ext cx="286920" cy="145800"/>
            </a:xfrm>
            <a:prstGeom prst="rect">
              <a:avLst/>
            </a:prstGeom>
            <a:ln w="0">
              <a:noFill/>
            </a:ln>
          </p:spPr>
        </p:pic>
        <p:sp>
          <p:nvSpPr>
            <p:cNvPr id="1121" name="pg42"/>
            <p:cNvSpPr/>
            <p:nvPr/>
          </p:nvSpPr>
          <p:spPr>
            <a:xfrm>
              <a:off x="10659240" y="9504720"/>
              <a:ext cx="165600" cy="150480"/>
            </a:xfrm>
            <a:custGeom>
              <a:avLst/>
              <a:gdLst/>
              <a:ahLst/>
              <a:rect l="l" t="t" r="r" b="b"/>
              <a:pathLst>
                <a:path w="171704" h="156463">
                  <a:moveTo>
                    <a:pt x="171704" y="156463"/>
                  </a:moveTo>
                  <a:lnTo>
                    <a:pt x="0" y="156463"/>
                  </a:lnTo>
                  <a:lnTo>
                    <a:pt x="0" y="0"/>
                  </a:lnTo>
                  <a:lnTo>
                    <a:pt x="171704" y="0"/>
                  </a:lnTo>
                  <a:lnTo>
                    <a:pt x="171704" y="156463"/>
                  </a:lnTo>
                  <a:close/>
                </a:path>
              </a:pathLst>
            </a:custGeom>
            <a:solidFill>
              <a:srgbClr val="808080"/>
            </a:solidFill>
            <a:ln cap="rnd" w="9360">
              <a:solidFill>
                <a:srgbClr val="808080"/>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1122" name="tx43" descr=""/>
            <p:cNvPicPr/>
            <p:nvPr/>
          </p:nvPicPr>
          <p:blipFill>
            <a:blip r:embed="rId2"/>
            <a:stretch/>
          </p:blipFill>
          <p:spPr>
            <a:xfrm>
              <a:off x="13075920" y="9491040"/>
              <a:ext cx="474120" cy="145800"/>
            </a:xfrm>
            <a:prstGeom prst="rect">
              <a:avLst/>
            </a:prstGeom>
            <a:ln w="0">
              <a:noFill/>
            </a:ln>
          </p:spPr>
        </p:pic>
        <p:pic>
          <p:nvPicPr>
            <p:cNvPr id="1123" name="tx44" descr=""/>
            <p:cNvPicPr/>
            <p:nvPr/>
          </p:nvPicPr>
          <p:blipFill>
            <a:blip r:embed="rId3"/>
            <a:stretch/>
          </p:blipFill>
          <p:spPr>
            <a:xfrm>
              <a:off x="11970360" y="9491040"/>
              <a:ext cx="474120" cy="145800"/>
            </a:xfrm>
            <a:prstGeom prst="rect">
              <a:avLst/>
            </a:prstGeom>
            <a:ln w="0">
              <a:noFill/>
            </a:ln>
          </p:spPr>
        </p:pic>
        <p:sp>
          <p:nvSpPr>
            <p:cNvPr id="1124" name="pl45"/>
            <p:cNvSpPr/>
            <p:nvPr/>
          </p:nvSpPr>
          <p:spPr>
            <a:xfrm>
              <a:off x="10548720" y="9454680"/>
              <a:ext cx="3316320" cy="360"/>
            </a:xfrm>
            <a:custGeom>
              <a:avLst/>
              <a:gdLst/>
              <a:ahLst/>
              <a:rect l="l" t="t" r="r" b="b"/>
              <a:pathLst>
                <a:path w="3434080" h="1">
                  <a:moveTo>
                    <a:pt x="0" y="0"/>
                  </a:moveTo>
                  <a:lnTo>
                    <a:pt x="343408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1125" name="tx46" descr=""/>
            <p:cNvPicPr/>
            <p:nvPr/>
          </p:nvPicPr>
          <p:blipFill>
            <a:blip r:embed="rId4"/>
            <a:stretch/>
          </p:blipFill>
          <p:spPr>
            <a:xfrm>
              <a:off x="10958040" y="9236520"/>
              <a:ext cx="286920" cy="145800"/>
            </a:xfrm>
            <a:prstGeom prst="rect">
              <a:avLst/>
            </a:prstGeom>
            <a:ln w="0">
              <a:noFill/>
            </a:ln>
          </p:spPr>
        </p:pic>
        <p:sp>
          <p:nvSpPr>
            <p:cNvPr id="1126" name="pg47"/>
            <p:cNvSpPr/>
            <p:nvPr/>
          </p:nvSpPr>
          <p:spPr>
            <a:xfrm>
              <a:off x="10659240" y="9253800"/>
              <a:ext cx="165600" cy="150480"/>
            </a:xfrm>
            <a:custGeom>
              <a:avLst/>
              <a:gdLst/>
              <a:ahLst/>
              <a:rect l="l" t="t" r="r" b="b"/>
              <a:pathLst>
                <a:path w="171704" h="156463">
                  <a:moveTo>
                    <a:pt x="171704" y="156463"/>
                  </a:moveTo>
                  <a:lnTo>
                    <a:pt x="0" y="156463"/>
                  </a:lnTo>
                  <a:lnTo>
                    <a:pt x="0" y="0"/>
                  </a:lnTo>
                  <a:lnTo>
                    <a:pt x="171704" y="0"/>
                  </a:lnTo>
                  <a:lnTo>
                    <a:pt x="171704" y="156463"/>
                  </a:lnTo>
                  <a:close/>
                </a:path>
              </a:pathLst>
            </a:custGeom>
            <a:solidFill>
              <a:srgbClr val="cccccc"/>
            </a:solidFill>
            <a:ln cap="rnd" w="9360">
              <a:solidFill>
                <a:srgbClr val="cccccc"/>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1127" name="tx48" descr=""/>
            <p:cNvPicPr/>
            <p:nvPr/>
          </p:nvPicPr>
          <p:blipFill>
            <a:blip r:embed="rId5"/>
            <a:stretch/>
          </p:blipFill>
          <p:spPr>
            <a:xfrm>
              <a:off x="13075920" y="9239760"/>
              <a:ext cx="474120" cy="145800"/>
            </a:xfrm>
            <a:prstGeom prst="rect">
              <a:avLst/>
            </a:prstGeom>
            <a:ln w="0">
              <a:noFill/>
            </a:ln>
          </p:spPr>
        </p:pic>
        <p:pic>
          <p:nvPicPr>
            <p:cNvPr id="1128" name="tx49" descr=""/>
            <p:cNvPicPr/>
            <p:nvPr/>
          </p:nvPicPr>
          <p:blipFill>
            <a:blip r:embed="rId6"/>
            <a:stretch/>
          </p:blipFill>
          <p:spPr>
            <a:xfrm>
              <a:off x="11970360" y="9239760"/>
              <a:ext cx="474120" cy="145800"/>
            </a:xfrm>
            <a:prstGeom prst="rect">
              <a:avLst/>
            </a:prstGeom>
            <a:ln w="0">
              <a:noFill/>
            </a:ln>
          </p:spPr>
        </p:pic>
        <p:sp>
          <p:nvSpPr>
            <p:cNvPr id="1129" name="pl50"/>
            <p:cNvSpPr/>
            <p:nvPr/>
          </p:nvSpPr>
          <p:spPr>
            <a:xfrm>
              <a:off x="10548720" y="9203400"/>
              <a:ext cx="3316320" cy="360"/>
            </a:xfrm>
            <a:custGeom>
              <a:avLst/>
              <a:gdLst/>
              <a:ahLst/>
              <a:rect l="l" t="t" r="r" b="b"/>
              <a:pathLst>
                <a:path w="3434080" h="1">
                  <a:moveTo>
                    <a:pt x="0" y="0"/>
                  </a:moveTo>
                  <a:lnTo>
                    <a:pt x="343408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1130" name="tx51" descr=""/>
            <p:cNvPicPr/>
            <p:nvPr/>
          </p:nvPicPr>
          <p:blipFill>
            <a:blip r:embed="rId7"/>
            <a:stretch/>
          </p:blipFill>
          <p:spPr>
            <a:xfrm>
              <a:off x="10821240" y="8841600"/>
              <a:ext cx="561240" cy="119880"/>
            </a:xfrm>
            <a:prstGeom prst="rect">
              <a:avLst/>
            </a:prstGeom>
            <a:ln w="0">
              <a:noFill/>
            </a:ln>
          </p:spPr>
        </p:pic>
        <p:pic>
          <p:nvPicPr>
            <p:cNvPr id="1131" name="tx52" descr=""/>
            <p:cNvPicPr/>
            <p:nvPr/>
          </p:nvPicPr>
          <p:blipFill>
            <a:blip r:embed="rId8"/>
            <a:stretch/>
          </p:blipFill>
          <p:spPr>
            <a:xfrm>
              <a:off x="10981080" y="8965440"/>
              <a:ext cx="241920" cy="119880"/>
            </a:xfrm>
            <a:prstGeom prst="rect">
              <a:avLst/>
            </a:prstGeom>
            <a:ln w="0">
              <a:noFill/>
            </a:ln>
          </p:spPr>
        </p:pic>
        <p:pic>
          <p:nvPicPr>
            <p:cNvPr id="1132" name="tx53" descr=""/>
            <p:cNvPicPr/>
            <p:nvPr/>
          </p:nvPicPr>
          <p:blipFill>
            <a:blip r:embed="rId9"/>
            <a:stretch/>
          </p:blipFill>
          <p:spPr>
            <a:xfrm>
              <a:off x="12050640" y="8841600"/>
              <a:ext cx="312840" cy="119880"/>
            </a:xfrm>
            <a:prstGeom prst="rect">
              <a:avLst/>
            </a:prstGeom>
            <a:ln w="0">
              <a:noFill/>
            </a:ln>
          </p:spPr>
        </p:pic>
        <p:pic>
          <p:nvPicPr>
            <p:cNvPr id="1133" name="tx54" descr=""/>
            <p:cNvPicPr/>
            <p:nvPr/>
          </p:nvPicPr>
          <p:blipFill>
            <a:blip r:embed="rId10"/>
            <a:stretch/>
          </p:blipFill>
          <p:spPr>
            <a:xfrm>
              <a:off x="11920320" y="8965440"/>
              <a:ext cx="573840" cy="119880"/>
            </a:xfrm>
            <a:prstGeom prst="rect">
              <a:avLst/>
            </a:prstGeom>
            <a:ln w="0">
              <a:noFill/>
            </a:ln>
          </p:spPr>
        </p:pic>
        <p:pic>
          <p:nvPicPr>
            <p:cNvPr id="1134" name="tx55" descr=""/>
            <p:cNvPicPr/>
            <p:nvPr/>
          </p:nvPicPr>
          <p:blipFill>
            <a:blip r:embed="rId11"/>
            <a:stretch/>
          </p:blipFill>
          <p:spPr>
            <a:xfrm>
              <a:off x="13185720" y="8841600"/>
              <a:ext cx="254520" cy="119880"/>
            </a:xfrm>
            <a:prstGeom prst="rect">
              <a:avLst/>
            </a:prstGeom>
            <a:ln w="0">
              <a:noFill/>
            </a:ln>
          </p:spPr>
        </p:pic>
        <p:pic>
          <p:nvPicPr>
            <p:cNvPr id="1135" name="tx56" descr=""/>
            <p:cNvPicPr/>
            <p:nvPr/>
          </p:nvPicPr>
          <p:blipFill>
            <a:blip r:embed="rId12"/>
            <a:stretch/>
          </p:blipFill>
          <p:spPr>
            <a:xfrm>
              <a:off x="13026240" y="8965440"/>
              <a:ext cx="573840" cy="119880"/>
            </a:xfrm>
            <a:prstGeom prst="rect">
              <a:avLst/>
            </a:prstGeom>
            <a:ln w="0">
              <a:noFill/>
            </a:ln>
          </p:spPr>
        </p:pic>
      </p:grpSp>
      <p:grpSp>
        <p:nvGrpSpPr>
          <p:cNvPr id="1136" name="组合 172"/>
          <p:cNvGrpSpPr/>
          <p:nvPr/>
        </p:nvGrpSpPr>
        <p:grpSpPr>
          <a:xfrm>
            <a:off x="101520" y="3668760"/>
            <a:ext cx="7288200" cy="6767640"/>
            <a:chOff x="101520" y="3668760"/>
            <a:chExt cx="7288200" cy="6767640"/>
          </a:xfrm>
        </p:grpSpPr>
        <p:sp>
          <p:nvSpPr>
            <p:cNvPr id="1137" name="rc3"/>
            <p:cNvSpPr/>
            <p:nvPr/>
          </p:nvSpPr>
          <p:spPr>
            <a:xfrm>
              <a:off x="326160" y="3668760"/>
              <a:ext cx="7063560" cy="6767640"/>
            </a:xfrm>
            <a:prstGeom prst="rect">
              <a:avLst/>
            </a:prstGeom>
            <a:solidFill>
              <a:srgbClr val="ffffff"/>
            </a:solidFill>
            <a:ln cap="rnd" w="9360">
              <a:solidFill>
                <a:srgbClr val="ffffff"/>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38" name="pl4"/>
            <p:cNvSpPr/>
            <p:nvPr/>
          </p:nvSpPr>
          <p:spPr>
            <a:xfrm>
              <a:off x="1271520" y="9573480"/>
              <a:ext cx="5526360" cy="360"/>
            </a:xfrm>
            <a:custGeom>
              <a:avLst/>
              <a:gdLst/>
              <a:ahLst/>
              <a:rect l="l" t="t" r="r" b="b"/>
              <a:pathLst>
                <a:path w="5723466" h="1">
                  <a:moveTo>
                    <a:pt x="0" y="0"/>
                  </a:moveTo>
                  <a:lnTo>
                    <a:pt x="5723466"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39" name="pl5"/>
            <p:cNvSpPr/>
            <p:nvPr/>
          </p:nvSpPr>
          <p:spPr>
            <a:xfrm>
              <a:off x="1271520" y="9573480"/>
              <a:ext cx="360" cy="84240"/>
            </a:xfrm>
            <a:custGeom>
              <a:avLst/>
              <a:gdLst/>
              <a:ahLst/>
              <a:rect l="l" t="t" r="r" b="b"/>
              <a:pathLst>
                <a:path w="1" h="91440">
                  <a:moveTo>
                    <a:pt x="0" y="0"/>
                  </a:moveTo>
                  <a:lnTo>
                    <a:pt x="0" y="91440"/>
                  </a:lnTo>
                </a:path>
              </a:pathLst>
            </a:custGeom>
            <a:noFill/>
            <a:ln cap="rnd" w="9360">
              <a:solidFill>
                <a:srgbClr val="000000"/>
              </a:solidFill>
              <a:round/>
            </a:ln>
          </p:spPr>
          <p:style>
            <a:lnRef idx="0"/>
            <a:fillRef idx="0"/>
            <a:effectRef idx="0"/>
            <a:fontRef idx="minor"/>
          </p:style>
          <p:txBody>
            <a:bodyPr lIns="90000" rIns="90000" tIns="37440" bIns="37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40" name="pl6"/>
            <p:cNvSpPr/>
            <p:nvPr/>
          </p:nvSpPr>
          <p:spPr>
            <a:xfrm>
              <a:off x="2376720" y="9573480"/>
              <a:ext cx="360" cy="84240"/>
            </a:xfrm>
            <a:custGeom>
              <a:avLst/>
              <a:gdLst/>
              <a:ahLst/>
              <a:rect l="l" t="t" r="r" b="b"/>
              <a:pathLst>
                <a:path w="1" h="91440">
                  <a:moveTo>
                    <a:pt x="0" y="0"/>
                  </a:moveTo>
                  <a:lnTo>
                    <a:pt x="0" y="91440"/>
                  </a:lnTo>
                </a:path>
              </a:pathLst>
            </a:custGeom>
            <a:noFill/>
            <a:ln cap="rnd" w="9360">
              <a:solidFill>
                <a:srgbClr val="000000"/>
              </a:solidFill>
              <a:round/>
            </a:ln>
          </p:spPr>
          <p:style>
            <a:lnRef idx="0"/>
            <a:fillRef idx="0"/>
            <a:effectRef idx="0"/>
            <a:fontRef idx="minor"/>
          </p:style>
          <p:txBody>
            <a:bodyPr lIns="90000" rIns="90000" tIns="37440" bIns="37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41" name="pl7"/>
            <p:cNvSpPr/>
            <p:nvPr/>
          </p:nvSpPr>
          <p:spPr>
            <a:xfrm>
              <a:off x="3481920" y="9573480"/>
              <a:ext cx="360" cy="84240"/>
            </a:xfrm>
            <a:custGeom>
              <a:avLst/>
              <a:gdLst/>
              <a:ahLst/>
              <a:rect l="l" t="t" r="r" b="b"/>
              <a:pathLst>
                <a:path w="1" h="91440">
                  <a:moveTo>
                    <a:pt x="0" y="0"/>
                  </a:moveTo>
                  <a:lnTo>
                    <a:pt x="0" y="91440"/>
                  </a:lnTo>
                </a:path>
              </a:pathLst>
            </a:custGeom>
            <a:noFill/>
            <a:ln cap="rnd" w="9360">
              <a:solidFill>
                <a:srgbClr val="000000"/>
              </a:solidFill>
              <a:round/>
            </a:ln>
          </p:spPr>
          <p:style>
            <a:lnRef idx="0"/>
            <a:fillRef idx="0"/>
            <a:effectRef idx="0"/>
            <a:fontRef idx="minor"/>
          </p:style>
          <p:txBody>
            <a:bodyPr lIns="90000" rIns="90000" tIns="37440" bIns="37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42" name="pl8"/>
            <p:cNvSpPr/>
            <p:nvPr/>
          </p:nvSpPr>
          <p:spPr>
            <a:xfrm>
              <a:off x="4587480" y="9573480"/>
              <a:ext cx="360" cy="84240"/>
            </a:xfrm>
            <a:custGeom>
              <a:avLst/>
              <a:gdLst/>
              <a:ahLst/>
              <a:rect l="l" t="t" r="r" b="b"/>
              <a:pathLst>
                <a:path w="1" h="91440">
                  <a:moveTo>
                    <a:pt x="0" y="0"/>
                  </a:moveTo>
                  <a:lnTo>
                    <a:pt x="0" y="91440"/>
                  </a:lnTo>
                </a:path>
              </a:pathLst>
            </a:custGeom>
            <a:noFill/>
            <a:ln cap="rnd" w="9360">
              <a:solidFill>
                <a:srgbClr val="000000"/>
              </a:solidFill>
              <a:round/>
            </a:ln>
          </p:spPr>
          <p:style>
            <a:lnRef idx="0"/>
            <a:fillRef idx="0"/>
            <a:effectRef idx="0"/>
            <a:fontRef idx="minor"/>
          </p:style>
          <p:txBody>
            <a:bodyPr lIns="90000" rIns="90000" tIns="37440" bIns="37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43" name="pl9"/>
            <p:cNvSpPr/>
            <p:nvPr/>
          </p:nvSpPr>
          <p:spPr>
            <a:xfrm>
              <a:off x="5692680" y="9573480"/>
              <a:ext cx="360" cy="84240"/>
            </a:xfrm>
            <a:custGeom>
              <a:avLst/>
              <a:gdLst/>
              <a:ahLst/>
              <a:rect l="l" t="t" r="r" b="b"/>
              <a:pathLst>
                <a:path w="1" h="91440">
                  <a:moveTo>
                    <a:pt x="0" y="0"/>
                  </a:moveTo>
                  <a:lnTo>
                    <a:pt x="0" y="91440"/>
                  </a:lnTo>
                </a:path>
              </a:pathLst>
            </a:custGeom>
            <a:noFill/>
            <a:ln cap="rnd" w="9360">
              <a:solidFill>
                <a:srgbClr val="000000"/>
              </a:solidFill>
              <a:round/>
            </a:ln>
          </p:spPr>
          <p:style>
            <a:lnRef idx="0"/>
            <a:fillRef idx="0"/>
            <a:effectRef idx="0"/>
            <a:fontRef idx="minor"/>
          </p:style>
          <p:txBody>
            <a:bodyPr lIns="90000" rIns="90000" tIns="37440" bIns="37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44" name="pl10"/>
            <p:cNvSpPr/>
            <p:nvPr/>
          </p:nvSpPr>
          <p:spPr>
            <a:xfrm>
              <a:off x="6797880" y="9573480"/>
              <a:ext cx="360" cy="84240"/>
            </a:xfrm>
            <a:custGeom>
              <a:avLst/>
              <a:gdLst/>
              <a:ahLst/>
              <a:rect l="l" t="t" r="r" b="b"/>
              <a:pathLst>
                <a:path w="1" h="91440">
                  <a:moveTo>
                    <a:pt x="0" y="0"/>
                  </a:moveTo>
                  <a:lnTo>
                    <a:pt x="0" y="91440"/>
                  </a:lnTo>
                </a:path>
              </a:pathLst>
            </a:custGeom>
            <a:noFill/>
            <a:ln cap="rnd" w="9360">
              <a:solidFill>
                <a:srgbClr val="000000"/>
              </a:solidFill>
              <a:round/>
            </a:ln>
          </p:spPr>
          <p:style>
            <a:lnRef idx="0"/>
            <a:fillRef idx="0"/>
            <a:effectRef idx="0"/>
            <a:fontRef idx="minor"/>
          </p:style>
          <p:txBody>
            <a:bodyPr lIns="90000" rIns="90000" tIns="37440" bIns="37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45" name="tx11"/>
            <p:cNvSpPr/>
            <p:nvPr/>
          </p:nvSpPr>
          <p:spPr>
            <a:xfrm>
              <a:off x="1117800" y="9723600"/>
              <a:ext cx="306720" cy="15444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0</a:t>
              </a:r>
              <a:endParaRPr b="0" lang="en-US" sz="1800" spc="-1" strike="noStrike">
                <a:solidFill>
                  <a:srgbClr val="000000"/>
                </a:solidFill>
                <a:latin typeface="Arial"/>
              </a:endParaRPr>
            </a:p>
          </p:txBody>
        </p:sp>
        <p:sp>
          <p:nvSpPr>
            <p:cNvPr id="1146" name="tx12"/>
            <p:cNvSpPr/>
            <p:nvPr/>
          </p:nvSpPr>
          <p:spPr>
            <a:xfrm>
              <a:off x="2223360" y="9723600"/>
              <a:ext cx="306720" cy="15444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2</a:t>
              </a:r>
              <a:endParaRPr b="0" lang="en-US" sz="1800" spc="-1" strike="noStrike">
                <a:solidFill>
                  <a:srgbClr val="000000"/>
                </a:solidFill>
                <a:latin typeface="Arial"/>
              </a:endParaRPr>
            </a:p>
          </p:txBody>
        </p:sp>
        <p:sp>
          <p:nvSpPr>
            <p:cNvPr id="1147" name="tx13"/>
            <p:cNvSpPr/>
            <p:nvPr/>
          </p:nvSpPr>
          <p:spPr>
            <a:xfrm>
              <a:off x="3328560" y="9723600"/>
              <a:ext cx="306720" cy="15444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4</a:t>
              </a:r>
              <a:endParaRPr b="0" lang="en-US" sz="1800" spc="-1" strike="noStrike">
                <a:solidFill>
                  <a:srgbClr val="000000"/>
                </a:solidFill>
                <a:latin typeface="Arial"/>
              </a:endParaRPr>
            </a:p>
          </p:txBody>
        </p:sp>
        <p:sp>
          <p:nvSpPr>
            <p:cNvPr id="1148" name="tx14"/>
            <p:cNvSpPr/>
            <p:nvPr/>
          </p:nvSpPr>
          <p:spPr>
            <a:xfrm>
              <a:off x="4433760" y="9723600"/>
              <a:ext cx="306720" cy="15444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6</a:t>
              </a:r>
              <a:endParaRPr b="0" lang="en-US" sz="1800" spc="-1" strike="noStrike">
                <a:solidFill>
                  <a:srgbClr val="000000"/>
                </a:solidFill>
                <a:latin typeface="Arial"/>
              </a:endParaRPr>
            </a:p>
          </p:txBody>
        </p:sp>
        <p:sp>
          <p:nvSpPr>
            <p:cNvPr id="1149" name="tx15"/>
            <p:cNvSpPr/>
            <p:nvPr/>
          </p:nvSpPr>
          <p:spPr>
            <a:xfrm>
              <a:off x="5539320" y="9723600"/>
              <a:ext cx="306720" cy="15444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8</a:t>
              </a:r>
              <a:endParaRPr b="0" lang="en-US" sz="1800" spc="-1" strike="noStrike">
                <a:solidFill>
                  <a:srgbClr val="000000"/>
                </a:solidFill>
                <a:latin typeface="Arial"/>
              </a:endParaRPr>
            </a:p>
          </p:txBody>
        </p:sp>
        <p:sp>
          <p:nvSpPr>
            <p:cNvPr id="1150" name="tx16"/>
            <p:cNvSpPr/>
            <p:nvPr/>
          </p:nvSpPr>
          <p:spPr>
            <a:xfrm>
              <a:off x="6644520" y="9723600"/>
              <a:ext cx="306720" cy="15444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1.0</a:t>
              </a:r>
              <a:endParaRPr b="0" lang="en-US" sz="1800" spc="-1" strike="noStrike">
                <a:solidFill>
                  <a:srgbClr val="000000"/>
                </a:solidFill>
                <a:latin typeface="Arial"/>
              </a:endParaRPr>
            </a:p>
          </p:txBody>
        </p:sp>
        <p:sp>
          <p:nvSpPr>
            <p:cNvPr id="1151" name="pl17"/>
            <p:cNvSpPr/>
            <p:nvPr/>
          </p:nvSpPr>
          <p:spPr>
            <a:xfrm>
              <a:off x="1050120" y="4555440"/>
              <a:ext cx="360" cy="4825080"/>
            </a:xfrm>
            <a:custGeom>
              <a:avLst/>
              <a:gdLst/>
              <a:ahLst/>
              <a:rect l="l" t="t" r="r" b="b"/>
              <a:pathLst>
                <a:path w="1" h="5215466">
                  <a:moveTo>
                    <a:pt x="0" y="5215466"/>
                  </a:moveTo>
                  <a:lnTo>
                    <a:pt x="0" y="0"/>
                  </a:lnTo>
                </a:path>
              </a:pathLst>
            </a:custGeom>
            <a:noFill/>
            <a:ln cap="rnd" w="9360">
              <a:solidFill>
                <a:srgbClr val="000000"/>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52" name="pl18"/>
            <p:cNvSpPr/>
            <p:nvPr/>
          </p:nvSpPr>
          <p:spPr>
            <a:xfrm>
              <a:off x="961920" y="9380520"/>
              <a:ext cx="88200" cy="360"/>
            </a:xfrm>
            <a:custGeom>
              <a:avLst/>
              <a:gdLst/>
              <a:ahLst/>
              <a:rect l="l" t="t" r="r" b="b"/>
              <a:pathLst>
                <a:path w="91439" h="1">
                  <a:moveTo>
                    <a:pt x="91439"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53" name="pl19"/>
            <p:cNvSpPr/>
            <p:nvPr/>
          </p:nvSpPr>
          <p:spPr>
            <a:xfrm>
              <a:off x="961920" y="8415720"/>
              <a:ext cx="88200" cy="360"/>
            </a:xfrm>
            <a:custGeom>
              <a:avLst/>
              <a:gdLst/>
              <a:ahLst/>
              <a:rect l="l" t="t" r="r" b="b"/>
              <a:pathLst>
                <a:path w="91439" h="1">
                  <a:moveTo>
                    <a:pt x="91439"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54" name="pl20"/>
            <p:cNvSpPr/>
            <p:nvPr/>
          </p:nvSpPr>
          <p:spPr>
            <a:xfrm>
              <a:off x="961920" y="7450560"/>
              <a:ext cx="88200" cy="360"/>
            </a:xfrm>
            <a:custGeom>
              <a:avLst/>
              <a:gdLst/>
              <a:ahLst/>
              <a:rect l="l" t="t" r="r" b="b"/>
              <a:pathLst>
                <a:path w="91439" h="1">
                  <a:moveTo>
                    <a:pt x="91439"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55" name="pl21"/>
            <p:cNvSpPr/>
            <p:nvPr/>
          </p:nvSpPr>
          <p:spPr>
            <a:xfrm>
              <a:off x="961920" y="6485400"/>
              <a:ext cx="88200" cy="360"/>
            </a:xfrm>
            <a:custGeom>
              <a:avLst/>
              <a:gdLst/>
              <a:ahLst/>
              <a:rect l="l" t="t" r="r" b="b"/>
              <a:pathLst>
                <a:path w="91439" h="1">
                  <a:moveTo>
                    <a:pt x="91439"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56" name="pl22"/>
            <p:cNvSpPr/>
            <p:nvPr/>
          </p:nvSpPr>
          <p:spPr>
            <a:xfrm>
              <a:off x="961920" y="5520240"/>
              <a:ext cx="88200" cy="360"/>
            </a:xfrm>
            <a:custGeom>
              <a:avLst/>
              <a:gdLst/>
              <a:ahLst/>
              <a:rect l="l" t="t" r="r" b="b"/>
              <a:pathLst>
                <a:path w="91439" h="1">
                  <a:moveTo>
                    <a:pt x="91439"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57" name="pl23"/>
            <p:cNvSpPr/>
            <p:nvPr/>
          </p:nvSpPr>
          <p:spPr>
            <a:xfrm>
              <a:off x="961920" y="4555440"/>
              <a:ext cx="88200" cy="360"/>
            </a:xfrm>
            <a:custGeom>
              <a:avLst/>
              <a:gdLst/>
              <a:ahLst/>
              <a:rect l="l" t="t" r="r" b="b"/>
              <a:pathLst>
                <a:path w="91439" h="1">
                  <a:moveTo>
                    <a:pt x="91439"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58" name="tx24"/>
            <p:cNvSpPr/>
            <p:nvPr/>
          </p:nvSpPr>
          <p:spPr>
            <a:xfrm rot="16200000">
              <a:off x="610920" y="9299880"/>
              <a:ext cx="293760" cy="16128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0</a:t>
              </a:r>
              <a:endParaRPr b="0" lang="en-US" sz="1800" spc="-1" strike="noStrike">
                <a:solidFill>
                  <a:srgbClr val="000000"/>
                </a:solidFill>
                <a:latin typeface="Arial"/>
              </a:endParaRPr>
            </a:p>
          </p:txBody>
        </p:sp>
        <p:sp>
          <p:nvSpPr>
            <p:cNvPr id="1159" name="tx25"/>
            <p:cNvSpPr/>
            <p:nvPr/>
          </p:nvSpPr>
          <p:spPr>
            <a:xfrm rot="16200000">
              <a:off x="610920" y="8334720"/>
              <a:ext cx="293760" cy="16128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2</a:t>
              </a:r>
              <a:endParaRPr b="0" lang="en-US" sz="1800" spc="-1" strike="noStrike">
                <a:solidFill>
                  <a:srgbClr val="000000"/>
                </a:solidFill>
                <a:latin typeface="Arial"/>
              </a:endParaRPr>
            </a:p>
          </p:txBody>
        </p:sp>
        <p:sp>
          <p:nvSpPr>
            <p:cNvPr id="1160" name="tx26"/>
            <p:cNvSpPr/>
            <p:nvPr/>
          </p:nvSpPr>
          <p:spPr>
            <a:xfrm rot="16200000">
              <a:off x="610920" y="7369920"/>
              <a:ext cx="293760" cy="16128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4</a:t>
              </a:r>
              <a:endParaRPr b="0" lang="en-US" sz="1800" spc="-1" strike="noStrike">
                <a:solidFill>
                  <a:srgbClr val="000000"/>
                </a:solidFill>
                <a:latin typeface="Arial"/>
              </a:endParaRPr>
            </a:p>
          </p:txBody>
        </p:sp>
        <p:sp>
          <p:nvSpPr>
            <p:cNvPr id="1161" name="tx27"/>
            <p:cNvSpPr/>
            <p:nvPr/>
          </p:nvSpPr>
          <p:spPr>
            <a:xfrm rot="16200000">
              <a:off x="610920" y="6404760"/>
              <a:ext cx="293760" cy="16128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6</a:t>
              </a:r>
              <a:endParaRPr b="0" lang="en-US" sz="1800" spc="-1" strike="noStrike">
                <a:solidFill>
                  <a:srgbClr val="000000"/>
                </a:solidFill>
                <a:latin typeface="Arial"/>
              </a:endParaRPr>
            </a:p>
          </p:txBody>
        </p:sp>
        <p:sp>
          <p:nvSpPr>
            <p:cNvPr id="1162" name="tx28"/>
            <p:cNvSpPr/>
            <p:nvPr/>
          </p:nvSpPr>
          <p:spPr>
            <a:xfrm rot="16200000">
              <a:off x="610920" y="5439600"/>
              <a:ext cx="293760" cy="16128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8</a:t>
              </a:r>
              <a:endParaRPr b="0" lang="en-US" sz="1800" spc="-1" strike="noStrike">
                <a:solidFill>
                  <a:srgbClr val="000000"/>
                </a:solidFill>
                <a:latin typeface="Arial"/>
              </a:endParaRPr>
            </a:p>
          </p:txBody>
        </p:sp>
        <p:sp>
          <p:nvSpPr>
            <p:cNvPr id="1163" name="tx29"/>
            <p:cNvSpPr/>
            <p:nvPr/>
          </p:nvSpPr>
          <p:spPr>
            <a:xfrm rot="16200000">
              <a:off x="610920" y="4474440"/>
              <a:ext cx="293760" cy="16128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1.0</a:t>
              </a:r>
              <a:endParaRPr b="0" lang="en-US" sz="1800" spc="-1" strike="noStrike">
                <a:solidFill>
                  <a:srgbClr val="000000"/>
                </a:solidFill>
                <a:latin typeface="Arial"/>
              </a:endParaRPr>
            </a:p>
          </p:txBody>
        </p:sp>
        <p:sp>
          <p:nvSpPr>
            <p:cNvPr id="1164" name="pl30"/>
            <p:cNvSpPr/>
            <p:nvPr/>
          </p:nvSpPr>
          <p:spPr>
            <a:xfrm>
              <a:off x="1050120" y="4362120"/>
              <a:ext cx="5968440" cy="5211000"/>
            </a:xfrm>
            <a:custGeom>
              <a:avLst/>
              <a:gdLst/>
              <a:ahLst/>
              <a:rect l="l" t="t" r="r" b="b"/>
              <a:pathLst>
                <a:path w="6181344" h="5632704">
                  <a:moveTo>
                    <a:pt x="0" y="5632704"/>
                  </a:moveTo>
                  <a:lnTo>
                    <a:pt x="6181344" y="5632704"/>
                  </a:lnTo>
                  <a:lnTo>
                    <a:pt x="6181344" y="0"/>
                  </a:lnTo>
                  <a:lnTo>
                    <a:pt x="0" y="0"/>
                  </a:lnTo>
                  <a:lnTo>
                    <a:pt x="0" y="5632704"/>
                  </a:lnTo>
                </a:path>
              </a:pathLst>
            </a:custGeom>
            <a:noFill/>
            <a:ln cap="rnd" w="9360">
              <a:solidFill>
                <a:srgbClr val="000000"/>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65" name="tx32"/>
            <p:cNvSpPr/>
            <p:nvPr/>
          </p:nvSpPr>
          <p:spPr>
            <a:xfrm>
              <a:off x="3034800" y="10189800"/>
              <a:ext cx="1999800" cy="19584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Predicted probability</a:t>
              </a:r>
              <a:endParaRPr b="0" lang="en-US" sz="1800" spc="-1" strike="noStrike">
                <a:solidFill>
                  <a:srgbClr val="000000"/>
                </a:solidFill>
                <a:latin typeface="Arial"/>
              </a:endParaRPr>
            </a:p>
          </p:txBody>
        </p:sp>
        <p:sp>
          <p:nvSpPr>
            <p:cNvPr id="1166" name="tx33"/>
            <p:cNvSpPr/>
            <p:nvPr/>
          </p:nvSpPr>
          <p:spPr>
            <a:xfrm rot="16200000">
              <a:off x="-682200" y="6864120"/>
              <a:ext cx="1774800" cy="20700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Observed mortality</a:t>
              </a:r>
              <a:endParaRPr b="0" lang="en-US" sz="1800" spc="-1" strike="noStrike">
                <a:solidFill>
                  <a:srgbClr val="000000"/>
                </a:solidFill>
                <a:latin typeface="Arial"/>
              </a:endParaRPr>
            </a:p>
          </p:txBody>
        </p:sp>
        <p:sp>
          <p:nvSpPr>
            <p:cNvPr id="1167" name="pg34"/>
            <p:cNvSpPr/>
            <p:nvPr/>
          </p:nvSpPr>
          <p:spPr>
            <a:xfrm>
              <a:off x="2337840" y="4555440"/>
              <a:ext cx="4455000" cy="4544640"/>
            </a:xfrm>
            <a:custGeom>
              <a:avLst/>
              <a:gdLst/>
              <a:ahLst/>
              <a:rect l="l" t="t" r="r" b="b"/>
              <a:pathLst>
                <a:path w="4613929" h="4912147">
                  <a:moveTo>
                    <a:pt x="0" y="4028916"/>
                  </a:moveTo>
                  <a:lnTo>
                    <a:pt x="46605" y="3996265"/>
                  </a:lnTo>
                  <a:lnTo>
                    <a:pt x="78221" y="3973934"/>
                  </a:lnTo>
                  <a:lnTo>
                    <a:pt x="93210" y="3963154"/>
                  </a:lnTo>
                  <a:lnTo>
                    <a:pt x="139816" y="3927034"/>
                  </a:lnTo>
                  <a:lnTo>
                    <a:pt x="160465" y="3911388"/>
                  </a:lnTo>
                  <a:lnTo>
                    <a:pt x="186421" y="3890355"/>
                  </a:lnTo>
                  <a:lnTo>
                    <a:pt x="233026" y="3850761"/>
                  </a:lnTo>
                  <a:lnTo>
                    <a:pt x="246726" y="3839734"/>
                  </a:lnTo>
                  <a:lnTo>
                    <a:pt x="279632" y="3810328"/>
                  </a:lnTo>
                  <a:lnTo>
                    <a:pt x="326237" y="3767129"/>
                  </a:lnTo>
                  <a:lnTo>
                    <a:pt x="336967" y="3757921"/>
                  </a:lnTo>
                  <a:lnTo>
                    <a:pt x="372842" y="3722884"/>
                  </a:lnTo>
                  <a:lnTo>
                    <a:pt x="419448" y="3677001"/>
                  </a:lnTo>
                  <a:lnTo>
                    <a:pt x="431119" y="3665027"/>
                  </a:lnTo>
                  <a:lnTo>
                    <a:pt x="466053" y="3628786"/>
                  </a:lnTo>
                  <a:lnTo>
                    <a:pt x="512658" y="3579014"/>
                  </a:lnTo>
                  <a:lnTo>
                    <a:pt x="529075" y="3561255"/>
                  </a:lnTo>
                  <a:lnTo>
                    <a:pt x="559264" y="3527948"/>
                  </a:lnTo>
                  <a:lnTo>
                    <a:pt x="605869" y="3475790"/>
                  </a:lnTo>
                  <a:lnTo>
                    <a:pt x="630689" y="3447447"/>
                  </a:lnTo>
                  <a:lnTo>
                    <a:pt x="652474" y="3422563"/>
                  </a:lnTo>
                  <a:lnTo>
                    <a:pt x="699080" y="3368725"/>
                  </a:lnTo>
                  <a:lnTo>
                    <a:pt x="735781" y="3325676"/>
                  </a:lnTo>
                  <a:lnTo>
                    <a:pt x="745685" y="3313953"/>
                  </a:lnTo>
                  <a:lnTo>
                    <a:pt x="792290" y="3258479"/>
                  </a:lnTo>
                  <a:lnTo>
                    <a:pt x="838896" y="3202259"/>
                  </a:lnTo>
                  <a:lnTo>
                    <a:pt x="844127" y="3195898"/>
                  </a:lnTo>
                  <a:lnTo>
                    <a:pt x="885501" y="3145339"/>
                  </a:lnTo>
                  <a:lnTo>
                    <a:pt x="932106" y="3087737"/>
                  </a:lnTo>
                  <a:lnTo>
                    <a:pt x="955469" y="3058468"/>
                  </a:lnTo>
                  <a:lnTo>
                    <a:pt x="978712" y="3029330"/>
                  </a:lnTo>
                  <a:lnTo>
                    <a:pt x="1025317" y="2970569"/>
                  </a:lnTo>
                  <a:lnTo>
                    <a:pt x="1069509" y="2913629"/>
                  </a:lnTo>
                  <a:lnTo>
                    <a:pt x="1071922" y="2910534"/>
                  </a:lnTo>
                  <a:lnTo>
                    <a:pt x="1118528" y="2850312"/>
                  </a:lnTo>
                  <a:lnTo>
                    <a:pt x="1165133" y="2789741"/>
                  </a:lnTo>
                  <a:lnTo>
                    <a:pt x="1185914" y="2763008"/>
                  </a:lnTo>
                  <a:lnTo>
                    <a:pt x="1211738" y="2729025"/>
                  </a:lnTo>
                  <a:lnTo>
                    <a:pt x="1258344" y="2667089"/>
                  </a:lnTo>
                  <a:lnTo>
                    <a:pt x="1304323" y="2606026"/>
                  </a:lnTo>
                  <a:lnTo>
                    <a:pt x="1304949" y="2605193"/>
                  </a:lnTo>
                  <a:lnTo>
                    <a:pt x="1351555" y="2542969"/>
                  </a:lnTo>
                  <a:lnTo>
                    <a:pt x="1398160" y="2480578"/>
                  </a:lnTo>
                  <a:lnTo>
                    <a:pt x="1424344" y="2445799"/>
                  </a:lnTo>
                  <a:lnTo>
                    <a:pt x="1444765" y="2418446"/>
                  </a:lnTo>
                  <a:lnTo>
                    <a:pt x="1491371" y="2355480"/>
                  </a:lnTo>
                  <a:lnTo>
                    <a:pt x="1537976" y="2292953"/>
                  </a:lnTo>
                  <a:lnTo>
                    <a:pt x="1545564" y="2283213"/>
                  </a:lnTo>
                  <a:lnTo>
                    <a:pt x="1584581" y="2230704"/>
                  </a:lnTo>
                  <a:lnTo>
                    <a:pt x="1631187" y="2168425"/>
                  </a:lnTo>
                  <a:lnTo>
                    <a:pt x="1667553" y="2120294"/>
                  </a:lnTo>
                  <a:lnTo>
                    <a:pt x="1677792" y="2106946"/>
                  </a:lnTo>
                  <a:lnTo>
                    <a:pt x="1724397" y="2045175"/>
                  </a:lnTo>
                  <a:lnTo>
                    <a:pt x="1771003" y="1984235"/>
                  </a:lnTo>
                  <a:lnTo>
                    <a:pt x="1789868" y="1959987"/>
                  </a:lnTo>
                  <a:lnTo>
                    <a:pt x="1817608" y="1924061"/>
                  </a:lnTo>
                  <a:lnTo>
                    <a:pt x="1864213" y="1864136"/>
                  </a:lnTo>
                  <a:lnTo>
                    <a:pt x="1910819" y="1805108"/>
                  </a:lnTo>
                  <a:lnTo>
                    <a:pt x="1912065" y="1803539"/>
                  </a:lnTo>
                  <a:lnTo>
                    <a:pt x="1957424" y="1746848"/>
                  </a:lnTo>
                  <a:lnTo>
                    <a:pt x="2004029" y="1689410"/>
                  </a:lnTo>
                  <a:lnTo>
                    <a:pt x="2033698" y="1653423"/>
                  </a:lnTo>
                  <a:lnTo>
                    <a:pt x="2050635" y="1633023"/>
                  </a:lnTo>
                  <a:lnTo>
                    <a:pt x="2097240" y="1577191"/>
                  </a:lnTo>
                  <a:lnTo>
                    <a:pt x="2143845" y="1522486"/>
                  </a:lnTo>
                  <a:lnTo>
                    <a:pt x="2154331" y="1510484"/>
                  </a:lnTo>
                  <a:lnTo>
                    <a:pt x="2190451" y="1468835"/>
                  </a:lnTo>
                  <a:lnTo>
                    <a:pt x="2237056" y="1416051"/>
                  </a:lnTo>
                  <a:lnTo>
                    <a:pt x="2273542" y="1375555"/>
                  </a:lnTo>
                  <a:lnTo>
                    <a:pt x="2283661" y="1364507"/>
                  </a:lnTo>
                  <a:lnTo>
                    <a:pt x="2330267" y="1313708"/>
                  </a:lnTo>
                  <a:lnTo>
                    <a:pt x="2376872" y="1264095"/>
                  </a:lnTo>
                  <a:lnTo>
                    <a:pt x="2390929" y="1249468"/>
                  </a:lnTo>
                  <a:lnTo>
                    <a:pt x="2423477" y="1215603"/>
                  </a:lnTo>
                  <a:lnTo>
                    <a:pt x="2470083" y="1167997"/>
                  </a:lnTo>
                  <a:lnTo>
                    <a:pt x="2506116" y="1132050"/>
                  </a:lnTo>
                  <a:lnTo>
                    <a:pt x="2516688" y="1121652"/>
                  </a:lnTo>
                  <a:lnTo>
                    <a:pt x="2563293" y="1076105"/>
                  </a:lnTo>
                  <a:lnTo>
                    <a:pt x="2609899" y="1031376"/>
                  </a:lnTo>
                  <a:lnTo>
                    <a:pt x="2618755" y="1023023"/>
                  </a:lnTo>
                  <a:lnTo>
                    <a:pt x="2656504" y="987641"/>
                  </a:lnTo>
                  <a:lnTo>
                    <a:pt x="2703110" y="944926"/>
                  </a:lnTo>
                  <a:lnTo>
                    <a:pt x="2728533" y="921885"/>
                  </a:lnTo>
                  <a:lnTo>
                    <a:pt x="2749715" y="902604"/>
                  </a:lnTo>
                  <a:lnTo>
                    <a:pt x="2796320" y="860664"/>
                  </a:lnTo>
                  <a:lnTo>
                    <a:pt x="2835173" y="825862"/>
                  </a:lnTo>
                  <a:lnTo>
                    <a:pt x="2842926" y="818914"/>
                  </a:lnTo>
                  <a:lnTo>
                    <a:pt x="2889531" y="776783"/>
                  </a:lnTo>
                  <a:lnTo>
                    <a:pt x="2936136" y="735357"/>
                  </a:lnTo>
                  <a:lnTo>
                    <a:pt x="2938435" y="733885"/>
                  </a:lnTo>
                  <a:lnTo>
                    <a:pt x="2982742" y="694313"/>
                  </a:lnTo>
                  <a:lnTo>
                    <a:pt x="3029347" y="653515"/>
                  </a:lnTo>
                  <a:lnTo>
                    <a:pt x="3038118" y="646354"/>
                  </a:lnTo>
                  <a:lnTo>
                    <a:pt x="3075952" y="613404"/>
                  </a:lnTo>
                  <a:lnTo>
                    <a:pt x="3122558" y="573577"/>
                  </a:lnTo>
                  <a:lnTo>
                    <a:pt x="3134059" y="564259"/>
                  </a:lnTo>
                  <a:lnTo>
                    <a:pt x="3169163" y="534769"/>
                  </a:lnTo>
                  <a:lnTo>
                    <a:pt x="3215768" y="496463"/>
                  </a:lnTo>
                  <a:lnTo>
                    <a:pt x="3226136" y="488405"/>
                  </a:lnTo>
                  <a:lnTo>
                    <a:pt x="3262374" y="459366"/>
                  </a:lnTo>
                  <a:lnTo>
                    <a:pt x="3308979" y="423071"/>
                  </a:lnTo>
                  <a:lnTo>
                    <a:pt x="3314261" y="419299"/>
                  </a:lnTo>
                  <a:lnTo>
                    <a:pt x="3355584" y="388084"/>
                  </a:lnTo>
                  <a:lnTo>
                    <a:pt x="3398381" y="356978"/>
                  </a:lnTo>
                  <a:lnTo>
                    <a:pt x="3402190" y="354263"/>
                  </a:lnTo>
                  <a:lnTo>
                    <a:pt x="3448795" y="321714"/>
                  </a:lnTo>
                  <a:lnTo>
                    <a:pt x="3478478" y="301887"/>
                  </a:lnTo>
                  <a:lnTo>
                    <a:pt x="3495400" y="290807"/>
                  </a:lnTo>
                  <a:lnTo>
                    <a:pt x="3542006" y="261051"/>
                  </a:lnTo>
                  <a:lnTo>
                    <a:pt x="3554561" y="253464"/>
                  </a:lnTo>
                  <a:lnTo>
                    <a:pt x="3588611" y="233033"/>
                  </a:lnTo>
                  <a:lnTo>
                    <a:pt x="3626667" y="211259"/>
                  </a:lnTo>
                  <a:lnTo>
                    <a:pt x="3635216" y="206522"/>
                  </a:lnTo>
                  <a:lnTo>
                    <a:pt x="3681822" y="181582"/>
                  </a:lnTo>
                  <a:lnTo>
                    <a:pt x="3694858" y="175051"/>
                  </a:lnTo>
                  <a:lnTo>
                    <a:pt x="3728427" y="158468"/>
                  </a:lnTo>
                  <a:lnTo>
                    <a:pt x="3759214" y="144074"/>
                  </a:lnTo>
                  <a:lnTo>
                    <a:pt x="3775032" y="136971"/>
                  </a:lnTo>
                  <a:lnTo>
                    <a:pt x="3819835" y="117812"/>
                  </a:lnTo>
                  <a:lnTo>
                    <a:pt x="3821638" y="117078"/>
                  </a:lnTo>
                  <a:lnTo>
                    <a:pt x="3868243" y="99028"/>
                  </a:lnTo>
                  <a:lnTo>
                    <a:pt x="3876833" y="95881"/>
                  </a:lnTo>
                  <a:lnTo>
                    <a:pt x="3914848" y="82645"/>
                  </a:lnTo>
                  <a:lnTo>
                    <a:pt x="3930335" y="77577"/>
                  </a:lnTo>
                  <a:lnTo>
                    <a:pt x="3961454" y="67943"/>
                  </a:lnTo>
                  <a:lnTo>
                    <a:pt x="3980474" y="62426"/>
                  </a:lnTo>
                  <a:lnTo>
                    <a:pt x="4008059" y="54898"/>
                  </a:lnTo>
                  <a:lnTo>
                    <a:pt x="4027391" y="49969"/>
                  </a:lnTo>
                  <a:lnTo>
                    <a:pt x="4054665" y="43470"/>
                  </a:lnTo>
                  <a:lnTo>
                    <a:pt x="4071232" y="39791"/>
                  </a:lnTo>
                  <a:lnTo>
                    <a:pt x="4101270" y="33629"/>
                  </a:lnTo>
                  <a:lnTo>
                    <a:pt x="4112145" y="31516"/>
                  </a:lnTo>
                  <a:lnTo>
                    <a:pt x="4147875" y="25250"/>
                  </a:lnTo>
                  <a:lnTo>
                    <a:pt x="4150279" y="24859"/>
                  </a:lnTo>
                  <a:lnTo>
                    <a:pt x="4185781" y="19484"/>
                  </a:lnTo>
                  <a:lnTo>
                    <a:pt x="4194481" y="18295"/>
                  </a:lnTo>
                  <a:lnTo>
                    <a:pt x="4218800" y="15219"/>
                  </a:lnTo>
                  <a:lnTo>
                    <a:pt x="4241086" y="12712"/>
                  </a:lnTo>
                  <a:lnTo>
                    <a:pt x="4249477" y="11841"/>
                  </a:lnTo>
                  <a:lnTo>
                    <a:pt x="4277953" y="9135"/>
                  </a:lnTo>
                  <a:lnTo>
                    <a:pt x="4287691" y="8320"/>
                  </a:lnTo>
                  <a:lnTo>
                    <a:pt x="4304364" y="7036"/>
                  </a:lnTo>
                  <a:lnTo>
                    <a:pt x="4328839" y="5397"/>
                  </a:lnTo>
                  <a:lnTo>
                    <a:pt x="4334297" y="5070"/>
                  </a:lnTo>
                  <a:lnTo>
                    <a:pt x="4351504" y="4118"/>
                  </a:lnTo>
                  <a:lnTo>
                    <a:pt x="4372479" y="3129"/>
                  </a:lnTo>
                  <a:lnTo>
                    <a:pt x="4380902" y="2781"/>
                  </a:lnTo>
                  <a:lnTo>
                    <a:pt x="4391878" y="2367"/>
                  </a:lnTo>
                  <a:lnTo>
                    <a:pt x="4409808" y="1782"/>
                  </a:lnTo>
                  <a:lnTo>
                    <a:pt x="4426373" y="1335"/>
                  </a:lnTo>
                  <a:lnTo>
                    <a:pt x="4427507" y="1308"/>
                  </a:lnTo>
                  <a:lnTo>
                    <a:pt x="4441667" y="997"/>
                  </a:lnTo>
                  <a:lnTo>
                    <a:pt x="4455783" y="740"/>
                  </a:lnTo>
                  <a:lnTo>
                    <a:pt x="4468805" y="547"/>
                  </a:lnTo>
                  <a:lnTo>
                    <a:pt x="4474113" y="480"/>
                  </a:lnTo>
                  <a:lnTo>
                    <a:pt x="4480814" y="403"/>
                  </a:lnTo>
                  <a:lnTo>
                    <a:pt x="4491885" y="295"/>
                  </a:lnTo>
                  <a:lnTo>
                    <a:pt x="4502087" y="215"/>
                  </a:lnTo>
                  <a:lnTo>
                    <a:pt x="4511485" y="156"/>
                  </a:lnTo>
                  <a:lnTo>
                    <a:pt x="4520142" y="113"/>
                  </a:lnTo>
                  <a:lnTo>
                    <a:pt x="4520718" y="110"/>
                  </a:lnTo>
                  <a:lnTo>
                    <a:pt x="4528112" y="81"/>
                  </a:lnTo>
                  <a:lnTo>
                    <a:pt x="4535449" y="58"/>
                  </a:lnTo>
                  <a:lnTo>
                    <a:pt x="4542202" y="41"/>
                  </a:lnTo>
                  <a:lnTo>
                    <a:pt x="4548415" y="29"/>
                  </a:lnTo>
                  <a:lnTo>
                    <a:pt x="4554132" y="21"/>
                  </a:lnTo>
                  <a:lnTo>
                    <a:pt x="4559390" y="14"/>
                  </a:lnTo>
                  <a:lnTo>
                    <a:pt x="4564226" y="10"/>
                  </a:lnTo>
                  <a:lnTo>
                    <a:pt x="4567323" y="8"/>
                  </a:lnTo>
                  <a:lnTo>
                    <a:pt x="4568672" y="7"/>
                  </a:lnTo>
                  <a:lnTo>
                    <a:pt x="4572761" y="5"/>
                  </a:lnTo>
                  <a:lnTo>
                    <a:pt x="4576520" y="3"/>
                  </a:lnTo>
                  <a:lnTo>
                    <a:pt x="4579975" y="2"/>
                  </a:lnTo>
                  <a:lnTo>
                    <a:pt x="4583150" y="1"/>
                  </a:lnTo>
                  <a:lnTo>
                    <a:pt x="4586069" y="1"/>
                  </a:lnTo>
                  <a:lnTo>
                    <a:pt x="4588750" y="0"/>
                  </a:lnTo>
                  <a:lnTo>
                    <a:pt x="4591215" y="0"/>
                  </a:lnTo>
                  <a:lnTo>
                    <a:pt x="4593479" y="0"/>
                  </a:lnTo>
                  <a:lnTo>
                    <a:pt x="4595559" y="0"/>
                  </a:lnTo>
                  <a:lnTo>
                    <a:pt x="4597470" y="0"/>
                  </a:lnTo>
                  <a:lnTo>
                    <a:pt x="4599226" y="0"/>
                  </a:lnTo>
                  <a:lnTo>
                    <a:pt x="4600839" y="0"/>
                  </a:lnTo>
                  <a:lnTo>
                    <a:pt x="4602320" y="0"/>
                  </a:lnTo>
                  <a:lnTo>
                    <a:pt x="4603681" y="0"/>
                  </a:lnTo>
                  <a:lnTo>
                    <a:pt x="4604931" y="0"/>
                  </a:lnTo>
                  <a:lnTo>
                    <a:pt x="4606078" y="0"/>
                  </a:lnTo>
                  <a:lnTo>
                    <a:pt x="4607132" y="0"/>
                  </a:lnTo>
                  <a:lnTo>
                    <a:pt x="4608101" y="0"/>
                  </a:lnTo>
                  <a:lnTo>
                    <a:pt x="4608990" y="0"/>
                  </a:lnTo>
                  <a:lnTo>
                    <a:pt x="4609806" y="0"/>
                  </a:lnTo>
                  <a:lnTo>
                    <a:pt x="4610556" y="0"/>
                  </a:lnTo>
                  <a:lnTo>
                    <a:pt x="4611244" y="0"/>
                  </a:lnTo>
                  <a:lnTo>
                    <a:pt x="4611876" y="0"/>
                  </a:lnTo>
                  <a:lnTo>
                    <a:pt x="4612457" y="0"/>
                  </a:lnTo>
                  <a:lnTo>
                    <a:pt x="4612990" y="0"/>
                  </a:lnTo>
                  <a:lnTo>
                    <a:pt x="4613479" y="0"/>
                  </a:lnTo>
                  <a:lnTo>
                    <a:pt x="4613929" y="0"/>
                  </a:lnTo>
                  <a:lnTo>
                    <a:pt x="4613929" y="4482380"/>
                  </a:lnTo>
                  <a:lnTo>
                    <a:pt x="4613479" y="4377060"/>
                  </a:lnTo>
                  <a:lnTo>
                    <a:pt x="4612990" y="4262719"/>
                  </a:lnTo>
                  <a:lnTo>
                    <a:pt x="4612457" y="4139792"/>
                  </a:lnTo>
                  <a:lnTo>
                    <a:pt x="4611876" y="4008949"/>
                  </a:lnTo>
                  <a:lnTo>
                    <a:pt x="4611244" y="3873004"/>
                  </a:lnTo>
                  <a:lnTo>
                    <a:pt x="4610556" y="3727071"/>
                  </a:lnTo>
                  <a:lnTo>
                    <a:pt x="4609806" y="3579305"/>
                  </a:lnTo>
                  <a:lnTo>
                    <a:pt x="4608990" y="3427704"/>
                  </a:lnTo>
                  <a:lnTo>
                    <a:pt x="4608101" y="3272711"/>
                  </a:lnTo>
                  <a:lnTo>
                    <a:pt x="4607132" y="3118749"/>
                  </a:lnTo>
                  <a:lnTo>
                    <a:pt x="4606078" y="2965420"/>
                  </a:lnTo>
                  <a:lnTo>
                    <a:pt x="4604931" y="2814328"/>
                  </a:lnTo>
                  <a:lnTo>
                    <a:pt x="4603681" y="2666654"/>
                  </a:lnTo>
                  <a:lnTo>
                    <a:pt x="4602320" y="2523425"/>
                  </a:lnTo>
                  <a:lnTo>
                    <a:pt x="4600839" y="2385496"/>
                  </a:lnTo>
                  <a:lnTo>
                    <a:pt x="4599226" y="2253547"/>
                  </a:lnTo>
                  <a:lnTo>
                    <a:pt x="4597470" y="2128081"/>
                  </a:lnTo>
                  <a:lnTo>
                    <a:pt x="4595559" y="2009441"/>
                  </a:lnTo>
                  <a:lnTo>
                    <a:pt x="4593479" y="1897823"/>
                  </a:lnTo>
                  <a:lnTo>
                    <a:pt x="4591215" y="1793294"/>
                  </a:lnTo>
                  <a:lnTo>
                    <a:pt x="4588750" y="1695812"/>
                  </a:lnTo>
                  <a:lnTo>
                    <a:pt x="4586069" y="1605250"/>
                  </a:lnTo>
                  <a:lnTo>
                    <a:pt x="4583150" y="1521411"/>
                  </a:lnTo>
                  <a:lnTo>
                    <a:pt x="4579975" y="1444049"/>
                  </a:lnTo>
                  <a:lnTo>
                    <a:pt x="4576520" y="1372882"/>
                  </a:lnTo>
                  <a:lnTo>
                    <a:pt x="4572761" y="1307603"/>
                  </a:lnTo>
                  <a:lnTo>
                    <a:pt x="4568672" y="1247558"/>
                  </a:lnTo>
                  <a:lnTo>
                    <a:pt x="4567323" y="1230148"/>
                  </a:lnTo>
                  <a:lnTo>
                    <a:pt x="4564226" y="1193468"/>
                  </a:lnTo>
                  <a:lnTo>
                    <a:pt x="4559390" y="1143977"/>
                  </a:lnTo>
                  <a:lnTo>
                    <a:pt x="4554132" y="1099134"/>
                  </a:lnTo>
                  <a:lnTo>
                    <a:pt x="4548415" y="1058650"/>
                  </a:lnTo>
                  <a:lnTo>
                    <a:pt x="4542202" y="1022253"/>
                  </a:lnTo>
                  <a:lnTo>
                    <a:pt x="4535449" y="989691"/>
                  </a:lnTo>
                  <a:lnTo>
                    <a:pt x="4528112" y="960728"/>
                  </a:lnTo>
                  <a:lnTo>
                    <a:pt x="4520718" y="936826"/>
                  </a:lnTo>
                  <a:lnTo>
                    <a:pt x="4520142" y="935152"/>
                  </a:lnTo>
                  <a:lnTo>
                    <a:pt x="4511485" y="912766"/>
                  </a:lnTo>
                  <a:lnTo>
                    <a:pt x="4502087" y="893395"/>
                  </a:lnTo>
                  <a:lnTo>
                    <a:pt x="4491885" y="876878"/>
                  </a:lnTo>
                  <a:lnTo>
                    <a:pt x="4480814" y="862858"/>
                  </a:lnTo>
                  <a:lnTo>
                    <a:pt x="4474113" y="856144"/>
                  </a:lnTo>
                  <a:lnTo>
                    <a:pt x="4468805" y="851884"/>
                  </a:lnTo>
                  <a:lnTo>
                    <a:pt x="4455783" y="843173"/>
                  </a:lnTo>
                  <a:lnTo>
                    <a:pt x="4441667" y="836816"/>
                  </a:lnTo>
                  <a:lnTo>
                    <a:pt x="4427507" y="832776"/>
                  </a:lnTo>
                  <a:lnTo>
                    <a:pt x="4426373" y="832876"/>
                  </a:lnTo>
                  <a:lnTo>
                    <a:pt x="4409808" y="831150"/>
                  </a:lnTo>
                  <a:lnTo>
                    <a:pt x="4391878" y="831446"/>
                  </a:lnTo>
                  <a:lnTo>
                    <a:pt x="4380902" y="832679"/>
                  </a:lnTo>
                  <a:lnTo>
                    <a:pt x="4372479" y="834319"/>
                  </a:lnTo>
                  <a:lnTo>
                    <a:pt x="4351504" y="839036"/>
                  </a:lnTo>
                  <a:lnTo>
                    <a:pt x="4334297" y="844049"/>
                  </a:lnTo>
                  <a:lnTo>
                    <a:pt x="4328839" y="846142"/>
                  </a:lnTo>
                  <a:lnTo>
                    <a:pt x="4304364" y="855119"/>
                  </a:lnTo>
                  <a:lnTo>
                    <a:pt x="4287691" y="862031"/>
                  </a:lnTo>
                  <a:lnTo>
                    <a:pt x="4277953" y="866591"/>
                  </a:lnTo>
                  <a:lnTo>
                    <a:pt x="4249477" y="879845"/>
                  </a:lnTo>
                  <a:lnTo>
                    <a:pt x="4241086" y="884156"/>
                  </a:lnTo>
                  <a:lnTo>
                    <a:pt x="4218800" y="895706"/>
                  </a:lnTo>
                  <a:lnTo>
                    <a:pt x="4194481" y="908747"/>
                  </a:lnTo>
                  <a:lnTo>
                    <a:pt x="4185781" y="913836"/>
                  </a:lnTo>
                  <a:lnTo>
                    <a:pt x="4150279" y="933914"/>
                  </a:lnTo>
                  <a:lnTo>
                    <a:pt x="4147875" y="935554"/>
                  </a:lnTo>
                  <a:lnTo>
                    <a:pt x="4112145" y="956677"/>
                  </a:lnTo>
                  <a:lnTo>
                    <a:pt x="4101270" y="963428"/>
                  </a:lnTo>
                  <a:lnTo>
                    <a:pt x="4071232" y="981921"/>
                  </a:lnTo>
                  <a:lnTo>
                    <a:pt x="4054665" y="992400"/>
                  </a:lnTo>
                  <a:lnTo>
                    <a:pt x="4027391" y="1009717"/>
                  </a:lnTo>
                  <a:lnTo>
                    <a:pt x="4008059" y="1022227"/>
                  </a:lnTo>
                  <a:lnTo>
                    <a:pt x="3980474" y="1040160"/>
                  </a:lnTo>
                  <a:lnTo>
                    <a:pt x="3961454" y="1052748"/>
                  </a:lnTo>
                  <a:lnTo>
                    <a:pt x="3930335" y="1073359"/>
                  </a:lnTo>
                  <a:lnTo>
                    <a:pt x="3914848" y="1083859"/>
                  </a:lnTo>
                  <a:lnTo>
                    <a:pt x="3876833" y="1109434"/>
                  </a:lnTo>
                  <a:lnTo>
                    <a:pt x="3868243" y="1115474"/>
                  </a:lnTo>
                  <a:lnTo>
                    <a:pt x="3821638" y="1147273"/>
                  </a:lnTo>
                  <a:lnTo>
                    <a:pt x="3819835" y="1148685"/>
                  </a:lnTo>
                  <a:lnTo>
                    <a:pt x="3775032" y="1179677"/>
                  </a:lnTo>
                  <a:lnTo>
                    <a:pt x="3759214" y="1190804"/>
                  </a:lnTo>
                  <a:lnTo>
                    <a:pt x="3728427" y="1212488"/>
                  </a:lnTo>
                  <a:lnTo>
                    <a:pt x="3694858" y="1236213"/>
                  </a:lnTo>
                  <a:lnTo>
                    <a:pt x="3681822" y="1245646"/>
                  </a:lnTo>
                  <a:lnTo>
                    <a:pt x="3635216" y="1278906"/>
                  </a:lnTo>
                  <a:lnTo>
                    <a:pt x="3626667" y="1285162"/>
                  </a:lnTo>
                  <a:lnTo>
                    <a:pt x="3588611" y="1312704"/>
                  </a:lnTo>
                  <a:lnTo>
                    <a:pt x="3554561" y="1337470"/>
                  </a:lnTo>
                  <a:lnTo>
                    <a:pt x="3542006" y="1346801"/>
                  </a:lnTo>
                  <a:lnTo>
                    <a:pt x="3495400" y="1381010"/>
                  </a:lnTo>
                  <a:lnTo>
                    <a:pt x="3478478" y="1393586"/>
                  </a:lnTo>
                  <a:lnTo>
                    <a:pt x="3448795" y="1415765"/>
                  </a:lnTo>
                  <a:lnTo>
                    <a:pt x="3402190" y="1450560"/>
                  </a:lnTo>
                  <a:lnTo>
                    <a:pt x="3398381" y="1453540"/>
                  </a:lnTo>
                  <a:lnTo>
                    <a:pt x="3355584" y="1485903"/>
                  </a:lnTo>
                  <a:lnTo>
                    <a:pt x="3314261" y="1517291"/>
                  </a:lnTo>
                  <a:lnTo>
                    <a:pt x="3308979" y="1521469"/>
                  </a:lnTo>
                  <a:lnTo>
                    <a:pt x="3262374" y="1557264"/>
                  </a:lnTo>
                  <a:lnTo>
                    <a:pt x="3226136" y="1585273"/>
                  </a:lnTo>
                  <a:lnTo>
                    <a:pt x="3215768" y="1593478"/>
                  </a:lnTo>
                  <a:lnTo>
                    <a:pt x="3169163" y="1629899"/>
                  </a:lnTo>
                  <a:lnTo>
                    <a:pt x="3134059" y="1657514"/>
                  </a:lnTo>
                  <a:lnTo>
                    <a:pt x="3122558" y="1666766"/>
                  </a:lnTo>
                  <a:lnTo>
                    <a:pt x="3075952" y="1703860"/>
                  </a:lnTo>
                  <a:lnTo>
                    <a:pt x="3038118" y="1734163"/>
                  </a:lnTo>
                  <a:lnTo>
                    <a:pt x="3029347" y="1741392"/>
                  </a:lnTo>
                  <a:lnTo>
                    <a:pt x="2982742" y="1779234"/>
                  </a:lnTo>
                  <a:lnTo>
                    <a:pt x="2938435" y="1815546"/>
                  </a:lnTo>
                  <a:lnTo>
                    <a:pt x="2936136" y="1817439"/>
                  </a:lnTo>
                  <a:lnTo>
                    <a:pt x="2889531" y="1856044"/>
                  </a:lnTo>
                  <a:lnTo>
                    <a:pt x="2842926" y="1894830"/>
                  </a:lnTo>
                  <a:lnTo>
                    <a:pt x="2835173" y="1901472"/>
                  </a:lnTo>
                  <a:lnTo>
                    <a:pt x="2796320" y="1934424"/>
                  </a:lnTo>
                  <a:lnTo>
                    <a:pt x="2749715" y="1974067"/>
                  </a:lnTo>
                  <a:lnTo>
                    <a:pt x="2728533" y="1992323"/>
                  </a:lnTo>
                  <a:lnTo>
                    <a:pt x="2703110" y="2014527"/>
                  </a:lnTo>
                  <a:lnTo>
                    <a:pt x="2656504" y="2055220"/>
                  </a:lnTo>
                  <a:lnTo>
                    <a:pt x="2618755" y="2088421"/>
                  </a:lnTo>
                  <a:lnTo>
                    <a:pt x="2609899" y="2096565"/>
                  </a:lnTo>
                  <a:lnTo>
                    <a:pt x="2563293" y="2138450"/>
                  </a:lnTo>
                  <a:lnTo>
                    <a:pt x="2516688" y="2180508"/>
                  </a:lnTo>
                  <a:lnTo>
                    <a:pt x="2506116" y="2190390"/>
                  </a:lnTo>
                  <a:lnTo>
                    <a:pt x="2470083" y="2223887"/>
                  </a:lnTo>
                  <a:lnTo>
                    <a:pt x="2423477" y="2267601"/>
                  </a:lnTo>
                  <a:lnTo>
                    <a:pt x="2390929" y="2298542"/>
                  </a:lnTo>
                  <a:lnTo>
                    <a:pt x="2376872" y="2312030"/>
                  </a:lnTo>
                  <a:lnTo>
                    <a:pt x="2330267" y="2356689"/>
                  </a:lnTo>
                  <a:lnTo>
                    <a:pt x="2283661" y="2402706"/>
                  </a:lnTo>
                  <a:lnTo>
                    <a:pt x="2273542" y="2412754"/>
                  </a:lnTo>
                  <a:lnTo>
                    <a:pt x="2237056" y="2449332"/>
                  </a:lnTo>
                  <a:lnTo>
                    <a:pt x="2190451" y="2496397"/>
                  </a:lnTo>
                  <a:lnTo>
                    <a:pt x="2154331" y="2533249"/>
                  </a:lnTo>
                  <a:lnTo>
                    <a:pt x="2143845" y="2544032"/>
                  </a:lnTo>
                  <a:lnTo>
                    <a:pt x="2097240" y="2592187"/>
                  </a:lnTo>
                  <a:lnTo>
                    <a:pt x="2050635" y="2640807"/>
                  </a:lnTo>
                  <a:lnTo>
                    <a:pt x="2033698" y="2658434"/>
                  </a:lnTo>
                  <a:lnTo>
                    <a:pt x="2004029" y="2689840"/>
                  </a:lnTo>
                  <a:lnTo>
                    <a:pt x="1957424" y="2739234"/>
                  </a:lnTo>
                  <a:lnTo>
                    <a:pt x="1912065" y="2787609"/>
                  </a:lnTo>
                  <a:lnTo>
                    <a:pt x="1910819" y="2788943"/>
                  </a:lnTo>
                  <a:lnTo>
                    <a:pt x="1864213" y="2838924"/>
                  </a:lnTo>
                  <a:lnTo>
                    <a:pt x="1817608" y="2888915"/>
                  </a:lnTo>
                  <a:lnTo>
                    <a:pt x="1789868" y="2918828"/>
                  </a:lnTo>
                  <a:lnTo>
                    <a:pt x="1771003" y="2939530"/>
                  </a:lnTo>
                  <a:lnTo>
                    <a:pt x="1724397" y="2990101"/>
                  </a:lnTo>
                  <a:lnTo>
                    <a:pt x="1677792" y="3040487"/>
                  </a:lnTo>
                  <a:lnTo>
                    <a:pt x="1667553" y="3051831"/>
                  </a:lnTo>
                  <a:lnTo>
                    <a:pt x="1631187" y="3091643"/>
                  </a:lnTo>
                  <a:lnTo>
                    <a:pt x="1584581" y="3142490"/>
                  </a:lnTo>
                  <a:lnTo>
                    <a:pt x="1545564" y="3184984"/>
                  </a:lnTo>
                  <a:lnTo>
                    <a:pt x="1537976" y="3193663"/>
                  </a:lnTo>
                  <a:lnTo>
                    <a:pt x="1491371" y="3244864"/>
                  </a:lnTo>
                  <a:lnTo>
                    <a:pt x="1444765" y="3295868"/>
                  </a:lnTo>
                  <a:lnTo>
                    <a:pt x="1424344" y="3318459"/>
                  </a:lnTo>
                  <a:lnTo>
                    <a:pt x="1398160" y="3347722"/>
                  </a:lnTo>
                  <a:lnTo>
                    <a:pt x="1351555" y="3399477"/>
                  </a:lnTo>
                  <a:lnTo>
                    <a:pt x="1304949" y="3451468"/>
                  </a:lnTo>
                  <a:lnTo>
                    <a:pt x="1304323" y="3452168"/>
                  </a:lnTo>
                  <a:lnTo>
                    <a:pt x="1258344" y="3503856"/>
                  </a:lnTo>
                  <a:lnTo>
                    <a:pt x="1211738" y="3556204"/>
                  </a:lnTo>
                  <a:lnTo>
                    <a:pt x="1185914" y="3585578"/>
                  </a:lnTo>
                  <a:lnTo>
                    <a:pt x="1165133" y="3609968"/>
                  </a:lnTo>
                  <a:lnTo>
                    <a:pt x="1118528" y="3663938"/>
                  </a:lnTo>
                  <a:lnTo>
                    <a:pt x="1071922" y="3717796"/>
                  </a:lnTo>
                  <a:lnTo>
                    <a:pt x="1069509" y="3721411"/>
                  </a:lnTo>
                  <a:lnTo>
                    <a:pt x="1025317" y="3774154"/>
                  </a:lnTo>
                  <a:lnTo>
                    <a:pt x="978712" y="3829927"/>
                  </a:lnTo>
                  <a:lnTo>
                    <a:pt x="955469" y="3858413"/>
                  </a:lnTo>
                  <a:lnTo>
                    <a:pt x="932106" y="3887090"/>
                  </a:lnTo>
                  <a:lnTo>
                    <a:pt x="885501" y="3945288"/>
                  </a:lnTo>
                  <a:lnTo>
                    <a:pt x="844127" y="3997414"/>
                  </a:lnTo>
                  <a:lnTo>
                    <a:pt x="838896" y="4004034"/>
                  </a:lnTo>
                  <a:lnTo>
                    <a:pt x="792290" y="4063019"/>
                  </a:lnTo>
                  <a:lnTo>
                    <a:pt x="745685" y="4122176"/>
                  </a:lnTo>
                  <a:lnTo>
                    <a:pt x="735781" y="4134694"/>
                  </a:lnTo>
                  <a:lnTo>
                    <a:pt x="699080" y="4180601"/>
                  </a:lnTo>
                  <a:lnTo>
                    <a:pt x="652474" y="4239071"/>
                  </a:lnTo>
                  <a:lnTo>
                    <a:pt x="630689" y="4265892"/>
                  </a:lnTo>
                  <a:lnTo>
                    <a:pt x="605869" y="4296479"/>
                  </a:lnTo>
                  <a:lnTo>
                    <a:pt x="559264" y="4353009"/>
                  </a:lnTo>
                  <a:lnTo>
                    <a:pt x="529075" y="4389037"/>
                  </a:lnTo>
                  <a:lnTo>
                    <a:pt x="512658" y="4408490"/>
                  </a:lnTo>
                  <a:lnTo>
                    <a:pt x="466053" y="4462762"/>
                  </a:lnTo>
                  <a:lnTo>
                    <a:pt x="431119" y="4502544"/>
                  </a:lnTo>
                  <a:lnTo>
                    <a:pt x="419448" y="4515678"/>
                  </a:lnTo>
                  <a:lnTo>
                    <a:pt x="372842" y="4567038"/>
                  </a:lnTo>
                  <a:lnTo>
                    <a:pt x="336967" y="4605452"/>
                  </a:lnTo>
                  <a:lnTo>
                    <a:pt x="326237" y="4616906"/>
                  </a:lnTo>
                  <a:lnTo>
                    <a:pt x="279632" y="4664917"/>
                  </a:lnTo>
                  <a:lnTo>
                    <a:pt x="246726" y="4697717"/>
                  </a:lnTo>
                  <a:lnTo>
                    <a:pt x="233026" y="4711216"/>
                  </a:lnTo>
                  <a:lnTo>
                    <a:pt x="186421" y="4755463"/>
                  </a:lnTo>
                  <a:lnTo>
                    <a:pt x="160465" y="4779273"/>
                  </a:lnTo>
                  <a:lnTo>
                    <a:pt x="139816" y="4797839"/>
                  </a:lnTo>
                  <a:lnTo>
                    <a:pt x="93210" y="4838015"/>
                  </a:lnTo>
                  <a:lnTo>
                    <a:pt x="78221" y="4850538"/>
                  </a:lnTo>
                  <a:lnTo>
                    <a:pt x="46605" y="4876203"/>
                  </a:lnTo>
                  <a:lnTo>
                    <a:pt x="0" y="4912147"/>
                  </a:lnTo>
                  <a:lnTo>
                    <a:pt x="0" y="4028916"/>
                  </a:lnTo>
                  <a:close/>
                </a:path>
              </a:pathLst>
            </a:custGeom>
            <a:solidFill>
              <a:srgbClr val="808080"/>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68" name="pg35"/>
            <p:cNvSpPr/>
            <p:nvPr/>
          </p:nvSpPr>
          <p:spPr>
            <a:xfrm>
              <a:off x="2337840" y="4555440"/>
              <a:ext cx="4455000" cy="4463280"/>
            </a:xfrm>
            <a:custGeom>
              <a:avLst/>
              <a:gdLst/>
              <a:ahLst/>
              <a:rect l="l" t="t" r="r" b="b"/>
              <a:pathLst>
                <a:path w="4613929" h="4824358">
                  <a:moveTo>
                    <a:pt x="0" y="4261968"/>
                  </a:moveTo>
                  <a:lnTo>
                    <a:pt x="46605" y="4223409"/>
                  </a:lnTo>
                  <a:lnTo>
                    <a:pt x="78221" y="4194164"/>
                  </a:lnTo>
                  <a:lnTo>
                    <a:pt x="93210" y="4180175"/>
                  </a:lnTo>
                  <a:lnTo>
                    <a:pt x="139816" y="4135207"/>
                  </a:lnTo>
                  <a:lnTo>
                    <a:pt x="160465" y="4115438"/>
                  </a:lnTo>
                  <a:lnTo>
                    <a:pt x="186421" y="4089813"/>
                  </a:lnTo>
                  <a:lnTo>
                    <a:pt x="233026" y="4042705"/>
                  </a:lnTo>
                  <a:lnTo>
                    <a:pt x="246726" y="4029173"/>
                  </a:lnTo>
                  <a:lnTo>
                    <a:pt x="279632" y="3995020"/>
                  </a:lnTo>
                  <a:lnTo>
                    <a:pt x="326237" y="3946224"/>
                  </a:lnTo>
                  <a:lnTo>
                    <a:pt x="336967" y="3934748"/>
                  </a:lnTo>
                  <a:lnTo>
                    <a:pt x="372842" y="3896068"/>
                  </a:lnTo>
                  <a:lnTo>
                    <a:pt x="419448" y="3844851"/>
                  </a:lnTo>
                  <a:lnTo>
                    <a:pt x="431119" y="3831896"/>
                  </a:lnTo>
                  <a:lnTo>
                    <a:pt x="466053" y="3792653"/>
                  </a:lnTo>
                  <a:lnTo>
                    <a:pt x="512658" y="3739563"/>
                  </a:lnTo>
                  <a:lnTo>
                    <a:pt x="529075" y="3720717"/>
                  </a:lnTo>
                  <a:lnTo>
                    <a:pt x="559264" y="3685665"/>
                  </a:lnTo>
                  <a:lnTo>
                    <a:pt x="605869" y="3631029"/>
                  </a:lnTo>
                  <a:lnTo>
                    <a:pt x="630689" y="3601545"/>
                  </a:lnTo>
                  <a:lnTo>
                    <a:pt x="652474" y="3575637"/>
                  </a:lnTo>
                  <a:lnTo>
                    <a:pt x="699080" y="3519770"/>
                  </a:lnTo>
                  <a:lnTo>
                    <a:pt x="735781" y="3475067"/>
                  </a:lnTo>
                  <a:lnTo>
                    <a:pt x="745685" y="3463219"/>
                  </a:lnTo>
                  <a:lnTo>
                    <a:pt x="792290" y="3406138"/>
                  </a:lnTo>
                  <a:lnTo>
                    <a:pt x="838896" y="3348512"/>
                  </a:lnTo>
                  <a:lnTo>
                    <a:pt x="844127" y="3342016"/>
                  </a:lnTo>
                  <a:lnTo>
                    <a:pt x="885501" y="3290383"/>
                  </a:lnTo>
                  <a:lnTo>
                    <a:pt x="932106" y="3231776"/>
                  </a:lnTo>
                  <a:lnTo>
                    <a:pt x="955469" y="3202132"/>
                  </a:lnTo>
                  <a:lnTo>
                    <a:pt x="978712" y="3172625"/>
                  </a:lnTo>
                  <a:lnTo>
                    <a:pt x="1025317" y="3112861"/>
                  </a:lnTo>
                  <a:lnTo>
                    <a:pt x="1069509" y="3056139"/>
                  </a:lnTo>
                  <a:lnTo>
                    <a:pt x="1071922" y="3053030"/>
                  </a:lnTo>
                  <a:lnTo>
                    <a:pt x="1118528" y="2992727"/>
                  </a:lnTo>
                  <a:lnTo>
                    <a:pt x="1165133" y="2932229"/>
                  </a:lnTo>
                  <a:lnTo>
                    <a:pt x="1185914" y="2905447"/>
                  </a:lnTo>
                  <a:lnTo>
                    <a:pt x="1211738" y="2871683"/>
                  </a:lnTo>
                  <a:lnTo>
                    <a:pt x="1258344" y="2810400"/>
                  </a:lnTo>
                  <a:lnTo>
                    <a:pt x="1304323" y="2750036"/>
                  </a:lnTo>
                  <a:lnTo>
                    <a:pt x="1304949" y="2749213"/>
                  </a:lnTo>
                  <a:lnTo>
                    <a:pt x="1351555" y="2687889"/>
                  </a:lnTo>
                  <a:lnTo>
                    <a:pt x="1398160" y="2626542"/>
                  </a:lnTo>
                  <a:lnTo>
                    <a:pt x="1424344" y="2592297"/>
                  </a:lnTo>
                  <a:lnTo>
                    <a:pt x="1444765" y="2565460"/>
                  </a:lnTo>
                  <a:lnTo>
                    <a:pt x="1491371" y="2503933"/>
                  </a:lnTo>
                  <a:lnTo>
                    <a:pt x="1537976" y="2442803"/>
                  </a:lnTo>
                  <a:lnTo>
                    <a:pt x="1545564" y="2433150"/>
                  </a:lnTo>
                  <a:lnTo>
                    <a:pt x="1584581" y="2381968"/>
                  </a:lnTo>
                  <a:lnTo>
                    <a:pt x="1631187" y="2321235"/>
                  </a:lnTo>
                  <a:lnTo>
                    <a:pt x="1667553" y="2274237"/>
                  </a:lnTo>
                  <a:lnTo>
                    <a:pt x="1677792" y="2261153"/>
                  </a:lnTo>
                  <a:lnTo>
                    <a:pt x="1724397" y="2201003"/>
                  </a:lnTo>
                  <a:lnTo>
                    <a:pt x="1771003" y="2141537"/>
                  </a:lnTo>
                  <a:lnTo>
                    <a:pt x="1789868" y="2117783"/>
                  </a:lnTo>
                  <a:lnTo>
                    <a:pt x="1817608" y="2082713"/>
                  </a:lnTo>
                  <a:lnTo>
                    <a:pt x="1864213" y="2024189"/>
                  </a:lnTo>
                  <a:lnTo>
                    <a:pt x="1910819" y="1966404"/>
                  </a:lnTo>
                  <a:lnTo>
                    <a:pt x="1912065" y="1964867"/>
                  </a:lnTo>
                  <a:lnTo>
                    <a:pt x="1957424" y="1909274"/>
                  </a:lnTo>
                  <a:lnTo>
                    <a:pt x="2004029" y="1852837"/>
                  </a:lnTo>
                  <a:lnTo>
                    <a:pt x="2033698" y="1817377"/>
                  </a:lnTo>
                  <a:lnTo>
                    <a:pt x="2050635" y="1797256"/>
                  </a:lnTo>
                  <a:lnTo>
                    <a:pt x="2097240" y="1742187"/>
                  </a:lnTo>
                  <a:lnTo>
                    <a:pt x="2143845" y="1688031"/>
                  </a:lnTo>
                  <a:lnTo>
                    <a:pt x="2154331" y="1676079"/>
                  </a:lnTo>
                  <a:lnTo>
                    <a:pt x="2190451" y="1634740"/>
                  </a:lnTo>
                  <a:lnTo>
                    <a:pt x="2237056" y="1582183"/>
                  </a:lnTo>
                  <a:lnTo>
                    <a:pt x="2273542" y="1541712"/>
                  </a:lnTo>
                  <a:lnTo>
                    <a:pt x="2283661" y="1530631"/>
                  </a:lnTo>
                  <a:lnTo>
                    <a:pt x="2330267" y="1479729"/>
                  </a:lnTo>
                  <a:lnTo>
                    <a:pt x="2376872" y="1429798"/>
                  </a:lnTo>
                  <a:lnTo>
                    <a:pt x="2390929" y="1414921"/>
                  </a:lnTo>
                  <a:lnTo>
                    <a:pt x="2423477" y="1380742"/>
                  </a:lnTo>
                  <a:lnTo>
                    <a:pt x="2470083" y="1332559"/>
                  </a:lnTo>
                  <a:lnTo>
                    <a:pt x="2506116" y="1295972"/>
                  </a:lnTo>
                  <a:lnTo>
                    <a:pt x="2516688" y="1285359"/>
                  </a:lnTo>
                  <a:lnTo>
                    <a:pt x="2563293" y="1238483"/>
                  </a:lnTo>
                  <a:lnTo>
                    <a:pt x="2609899" y="1193147"/>
                  </a:lnTo>
                  <a:lnTo>
                    <a:pt x="2618755" y="1184581"/>
                  </a:lnTo>
                  <a:lnTo>
                    <a:pt x="2656504" y="1148363"/>
                  </a:lnTo>
                  <a:lnTo>
                    <a:pt x="2703110" y="1104351"/>
                  </a:lnTo>
                  <a:lnTo>
                    <a:pt x="2728533" y="1080756"/>
                  </a:lnTo>
                  <a:lnTo>
                    <a:pt x="2749715" y="1061207"/>
                  </a:lnTo>
                  <a:lnTo>
                    <a:pt x="2796320" y="1018511"/>
                  </a:lnTo>
                  <a:lnTo>
                    <a:pt x="2835173" y="983520"/>
                  </a:lnTo>
                  <a:lnTo>
                    <a:pt x="2842926" y="976597"/>
                  </a:lnTo>
                  <a:lnTo>
                    <a:pt x="2889531" y="935343"/>
                  </a:lnTo>
                  <a:lnTo>
                    <a:pt x="2936136" y="894396"/>
                  </a:lnTo>
                  <a:lnTo>
                    <a:pt x="2938435" y="892387"/>
                  </a:lnTo>
                  <a:lnTo>
                    <a:pt x="2982742" y="853829"/>
                  </a:lnTo>
                  <a:lnTo>
                    <a:pt x="3029347" y="813275"/>
                  </a:lnTo>
                  <a:lnTo>
                    <a:pt x="3038118" y="806063"/>
                  </a:lnTo>
                  <a:lnTo>
                    <a:pt x="3075952" y="773518"/>
                  </a:lnTo>
                  <a:lnTo>
                    <a:pt x="3122558" y="733918"/>
                  </a:lnTo>
                  <a:lnTo>
                    <a:pt x="3134059" y="724549"/>
                  </a:lnTo>
                  <a:lnTo>
                    <a:pt x="3169163" y="695012"/>
                  </a:lnTo>
                  <a:lnTo>
                    <a:pt x="3215768" y="656309"/>
                  </a:lnTo>
                  <a:lnTo>
                    <a:pt x="3226136" y="648076"/>
                  </a:lnTo>
                  <a:lnTo>
                    <a:pt x="3262374" y="618393"/>
                  </a:lnTo>
                  <a:lnTo>
                    <a:pt x="3308979" y="580858"/>
                  </a:lnTo>
                  <a:lnTo>
                    <a:pt x="3314261" y="576658"/>
                  </a:lnTo>
                  <a:lnTo>
                    <a:pt x="3355584" y="544097"/>
                  </a:lnTo>
                  <a:lnTo>
                    <a:pt x="3398381" y="511011"/>
                  </a:lnTo>
                  <a:lnTo>
                    <a:pt x="3402190" y="508095"/>
                  </a:lnTo>
                  <a:lnTo>
                    <a:pt x="3448795" y="472780"/>
                  </a:lnTo>
                  <a:lnTo>
                    <a:pt x="3478478" y="450914"/>
                  </a:lnTo>
                  <a:lnTo>
                    <a:pt x="3495400" y="438571"/>
                  </a:lnTo>
                  <a:lnTo>
                    <a:pt x="3542006" y="404933"/>
                  </a:lnTo>
                  <a:lnTo>
                    <a:pt x="3554561" y="396221"/>
                  </a:lnTo>
                  <a:lnTo>
                    <a:pt x="3588611" y="372487"/>
                  </a:lnTo>
                  <a:lnTo>
                    <a:pt x="3626667" y="346673"/>
                  </a:lnTo>
                  <a:lnTo>
                    <a:pt x="3635216" y="340979"/>
                  </a:lnTo>
                  <a:lnTo>
                    <a:pt x="3681822" y="310481"/>
                  </a:lnTo>
                  <a:lnTo>
                    <a:pt x="3694858" y="302185"/>
                  </a:lnTo>
                  <a:lnTo>
                    <a:pt x="3728427" y="281266"/>
                  </a:lnTo>
                  <a:lnTo>
                    <a:pt x="3759214" y="262642"/>
                  </a:lnTo>
                  <a:lnTo>
                    <a:pt x="3775032" y="253258"/>
                  </a:lnTo>
                  <a:lnTo>
                    <a:pt x="3819835" y="227315"/>
                  </a:lnTo>
                  <a:lnTo>
                    <a:pt x="3821638" y="226301"/>
                  </a:lnTo>
                  <a:lnTo>
                    <a:pt x="3868243" y="200817"/>
                  </a:lnTo>
                  <a:lnTo>
                    <a:pt x="3876833" y="196256"/>
                  </a:lnTo>
                  <a:lnTo>
                    <a:pt x="3914848" y="176623"/>
                  </a:lnTo>
                  <a:lnTo>
                    <a:pt x="3930335" y="168892"/>
                  </a:lnTo>
                  <a:lnTo>
                    <a:pt x="3961454" y="153807"/>
                  </a:lnTo>
                  <a:lnTo>
                    <a:pt x="3980474" y="144913"/>
                  </a:lnTo>
                  <a:lnTo>
                    <a:pt x="4008059" y="132421"/>
                  </a:lnTo>
                  <a:lnTo>
                    <a:pt x="4027391" y="123987"/>
                  </a:lnTo>
                  <a:lnTo>
                    <a:pt x="4054665" y="112506"/>
                  </a:lnTo>
                  <a:lnTo>
                    <a:pt x="4071232" y="105794"/>
                  </a:lnTo>
                  <a:lnTo>
                    <a:pt x="4101270" y="94105"/>
                  </a:lnTo>
                  <a:lnTo>
                    <a:pt x="4112145" y="90035"/>
                  </a:lnTo>
                  <a:lnTo>
                    <a:pt x="4147875" y="77256"/>
                  </a:lnTo>
                  <a:lnTo>
                    <a:pt x="4150279" y="76430"/>
                  </a:lnTo>
                  <a:lnTo>
                    <a:pt x="4185781" y="64744"/>
                  </a:lnTo>
                  <a:lnTo>
                    <a:pt x="4194481" y="61998"/>
                  </a:lnTo>
                  <a:lnTo>
                    <a:pt x="4218800" y="54687"/>
                  </a:lnTo>
                  <a:lnTo>
                    <a:pt x="4241086" y="48392"/>
                  </a:lnTo>
                  <a:lnTo>
                    <a:pt x="4249477" y="46123"/>
                  </a:lnTo>
                  <a:lnTo>
                    <a:pt x="4277953" y="38703"/>
                  </a:lnTo>
                  <a:lnTo>
                    <a:pt x="4287691" y="36343"/>
                  </a:lnTo>
                  <a:lnTo>
                    <a:pt x="4304364" y="32478"/>
                  </a:lnTo>
                  <a:lnTo>
                    <a:pt x="4328839" y="27207"/>
                  </a:lnTo>
                  <a:lnTo>
                    <a:pt x="4334297" y="26097"/>
                  </a:lnTo>
                  <a:lnTo>
                    <a:pt x="4351504" y="22751"/>
                  </a:lnTo>
                  <a:lnTo>
                    <a:pt x="4372479" y="18913"/>
                  </a:lnTo>
                  <a:lnTo>
                    <a:pt x="4380902" y="17495"/>
                  </a:lnTo>
                  <a:lnTo>
                    <a:pt x="4391878" y="15734"/>
                  </a:lnTo>
                  <a:lnTo>
                    <a:pt x="4409808" y="13067"/>
                  </a:lnTo>
                  <a:lnTo>
                    <a:pt x="4426373" y="10833"/>
                  </a:lnTo>
                  <a:lnTo>
                    <a:pt x="4427507" y="10688"/>
                  </a:lnTo>
                  <a:lnTo>
                    <a:pt x="4441667" y="8965"/>
                  </a:lnTo>
                  <a:lnTo>
                    <a:pt x="4455783" y="7380"/>
                  </a:lnTo>
                  <a:lnTo>
                    <a:pt x="4468805" y="6077"/>
                  </a:lnTo>
                  <a:lnTo>
                    <a:pt x="4474113" y="5585"/>
                  </a:lnTo>
                  <a:lnTo>
                    <a:pt x="4480814" y="4996"/>
                  </a:lnTo>
                  <a:lnTo>
                    <a:pt x="4491885" y="4099"/>
                  </a:lnTo>
                  <a:lnTo>
                    <a:pt x="4502087" y="3358"/>
                  </a:lnTo>
                  <a:lnTo>
                    <a:pt x="4511485" y="2746"/>
                  </a:lnTo>
                  <a:lnTo>
                    <a:pt x="4520142" y="2234"/>
                  </a:lnTo>
                  <a:lnTo>
                    <a:pt x="4520718" y="2202"/>
                  </a:lnTo>
                  <a:lnTo>
                    <a:pt x="4528112" y="1818"/>
                  </a:lnTo>
                  <a:lnTo>
                    <a:pt x="4535449" y="1476"/>
                  </a:lnTo>
                  <a:lnTo>
                    <a:pt x="4542202" y="1197"/>
                  </a:lnTo>
                  <a:lnTo>
                    <a:pt x="4548415" y="969"/>
                  </a:lnTo>
                  <a:lnTo>
                    <a:pt x="4554132" y="783"/>
                  </a:lnTo>
                  <a:lnTo>
                    <a:pt x="4559390" y="631"/>
                  </a:lnTo>
                  <a:lnTo>
                    <a:pt x="4564226" y="508"/>
                  </a:lnTo>
                  <a:lnTo>
                    <a:pt x="4567323" y="435"/>
                  </a:lnTo>
                  <a:lnTo>
                    <a:pt x="4568672" y="406"/>
                  </a:lnTo>
                  <a:lnTo>
                    <a:pt x="4572761" y="325"/>
                  </a:lnTo>
                  <a:lnTo>
                    <a:pt x="4576520" y="260"/>
                  </a:lnTo>
                  <a:lnTo>
                    <a:pt x="4579975" y="207"/>
                  </a:lnTo>
                  <a:lnTo>
                    <a:pt x="4583150" y="165"/>
                  </a:lnTo>
                  <a:lnTo>
                    <a:pt x="4586069" y="131"/>
                  </a:lnTo>
                  <a:lnTo>
                    <a:pt x="4588750" y="104"/>
                  </a:lnTo>
                  <a:lnTo>
                    <a:pt x="4591215" y="82"/>
                  </a:lnTo>
                  <a:lnTo>
                    <a:pt x="4593479" y="65"/>
                  </a:lnTo>
                  <a:lnTo>
                    <a:pt x="4595559" y="51"/>
                  </a:lnTo>
                  <a:lnTo>
                    <a:pt x="4597470" y="40"/>
                  </a:lnTo>
                  <a:lnTo>
                    <a:pt x="4599226" y="31"/>
                  </a:lnTo>
                  <a:lnTo>
                    <a:pt x="4600839" y="24"/>
                  </a:lnTo>
                  <a:lnTo>
                    <a:pt x="4602320" y="19"/>
                  </a:lnTo>
                  <a:lnTo>
                    <a:pt x="4603681" y="14"/>
                  </a:lnTo>
                  <a:lnTo>
                    <a:pt x="4604931" y="11"/>
                  </a:lnTo>
                  <a:lnTo>
                    <a:pt x="4606078" y="8"/>
                  </a:lnTo>
                  <a:lnTo>
                    <a:pt x="4607132" y="6"/>
                  </a:lnTo>
                  <a:lnTo>
                    <a:pt x="4608101" y="5"/>
                  </a:lnTo>
                  <a:lnTo>
                    <a:pt x="4608990" y="3"/>
                  </a:lnTo>
                  <a:lnTo>
                    <a:pt x="4609806" y="2"/>
                  </a:lnTo>
                  <a:lnTo>
                    <a:pt x="4610556" y="2"/>
                  </a:lnTo>
                  <a:lnTo>
                    <a:pt x="4611244" y="1"/>
                  </a:lnTo>
                  <a:lnTo>
                    <a:pt x="4611876" y="1"/>
                  </a:lnTo>
                  <a:lnTo>
                    <a:pt x="4612457" y="0"/>
                  </a:lnTo>
                  <a:lnTo>
                    <a:pt x="4612990" y="0"/>
                  </a:lnTo>
                  <a:lnTo>
                    <a:pt x="4613479" y="0"/>
                  </a:lnTo>
                  <a:lnTo>
                    <a:pt x="4613929" y="0"/>
                  </a:lnTo>
                  <a:lnTo>
                    <a:pt x="4613929" y="3064470"/>
                  </a:lnTo>
                  <a:lnTo>
                    <a:pt x="4613479" y="2904042"/>
                  </a:lnTo>
                  <a:lnTo>
                    <a:pt x="4612990" y="2750313"/>
                  </a:lnTo>
                  <a:lnTo>
                    <a:pt x="4612457" y="2599293"/>
                  </a:lnTo>
                  <a:lnTo>
                    <a:pt x="4611876" y="2452025"/>
                  </a:lnTo>
                  <a:lnTo>
                    <a:pt x="4611244" y="2308820"/>
                  </a:lnTo>
                  <a:lnTo>
                    <a:pt x="4610556" y="2172382"/>
                  </a:lnTo>
                  <a:lnTo>
                    <a:pt x="4609806" y="2042071"/>
                  </a:lnTo>
                  <a:lnTo>
                    <a:pt x="4608990" y="1918471"/>
                  </a:lnTo>
                  <a:lnTo>
                    <a:pt x="4608101" y="1801819"/>
                  </a:lnTo>
                  <a:lnTo>
                    <a:pt x="4607132" y="1692218"/>
                  </a:lnTo>
                  <a:lnTo>
                    <a:pt x="4606078" y="1589658"/>
                  </a:lnTo>
                  <a:lnTo>
                    <a:pt x="4604931" y="1494032"/>
                  </a:lnTo>
                  <a:lnTo>
                    <a:pt x="4603681" y="1405158"/>
                  </a:lnTo>
                  <a:lnTo>
                    <a:pt x="4602320" y="1322794"/>
                  </a:lnTo>
                  <a:lnTo>
                    <a:pt x="4600839" y="1246658"/>
                  </a:lnTo>
                  <a:lnTo>
                    <a:pt x="4599226" y="1176439"/>
                  </a:lnTo>
                  <a:lnTo>
                    <a:pt x="4597470" y="1111811"/>
                  </a:lnTo>
                  <a:lnTo>
                    <a:pt x="4595559" y="1052440"/>
                  </a:lnTo>
                  <a:lnTo>
                    <a:pt x="4593479" y="997996"/>
                  </a:lnTo>
                  <a:lnTo>
                    <a:pt x="4591215" y="948152"/>
                  </a:lnTo>
                  <a:lnTo>
                    <a:pt x="4588750" y="902595"/>
                  </a:lnTo>
                  <a:lnTo>
                    <a:pt x="4586069" y="861027"/>
                  </a:lnTo>
                  <a:lnTo>
                    <a:pt x="4583150" y="823166"/>
                  </a:lnTo>
                  <a:lnTo>
                    <a:pt x="4579975" y="788749"/>
                  </a:lnTo>
                  <a:lnTo>
                    <a:pt x="4576520" y="757531"/>
                  </a:lnTo>
                  <a:lnTo>
                    <a:pt x="4572761" y="729285"/>
                  </a:lnTo>
                  <a:lnTo>
                    <a:pt x="4568672" y="703667"/>
                  </a:lnTo>
                  <a:lnTo>
                    <a:pt x="4567323" y="696302"/>
                  </a:lnTo>
                  <a:lnTo>
                    <a:pt x="4564226" y="680903"/>
                  </a:lnTo>
                  <a:lnTo>
                    <a:pt x="4559390" y="660406"/>
                  </a:lnTo>
                  <a:lnTo>
                    <a:pt x="4554132" y="642161"/>
                  </a:lnTo>
                  <a:lnTo>
                    <a:pt x="4548415" y="626028"/>
                  </a:lnTo>
                  <a:lnTo>
                    <a:pt x="4542202" y="611884"/>
                  </a:lnTo>
                  <a:lnTo>
                    <a:pt x="4535449" y="599621"/>
                  </a:lnTo>
                  <a:lnTo>
                    <a:pt x="4528112" y="589143"/>
                  </a:lnTo>
                  <a:lnTo>
                    <a:pt x="4520718" y="580924"/>
                  </a:lnTo>
                  <a:lnTo>
                    <a:pt x="4520142" y="580367"/>
                  </a:lnTo>
                  <a:lnTo>
                    <a:pt x="4511485" y="573223"/>
                  </a:lnTo>
                  <a:lnTo>
                    <a:pt x="4502087" y="567649"/>
                  </a:lnTo>
                  <a:lnTo>
                    <a:pt x="4491885" y="563600"/>
                  </a:lnTo>
                  <a:lnTo>
                    <a:pt x="4480814" y="560942"/>
                  </a:lnTo>
                  <a:lnTo>
                    <a:pt x="4474113" y="560116"/>
                  </a:lnTo>
                  <a:lnTo>
                    <a:pt x="4468805" y="559926"/>
                  </a:lnTo>
                  <a:lnTo>
                    <a:pt x="4455783" y="560255"/>
                  </a:lnTo>
                  <a:lnTo>
                    <a:pt x="4441667" y="562012"/>
                  </a:lnTo>
                  <a:lnTo>
                    <a:pt x="4427507" y="564921"/>
                  </a:lnTo>
                  <a:lnTo>
                    <a:pt x="4426373" y="565196"/>
                  </a:lnTo>
                  <a:lnTo>
                    <a:pt x="4409808" y="569817"/>
                  </a:lnTo>
                  <a:lnTo>
                    <a:pt x="4391878" y="575799"/>
                  </a:lnTo>
                  <a:lnTo>
                    <a:pt x="4380902" y="579941"/>
                  </a:lnTo>
                  <a:lnTo>
                    <a:pt x="4372479" y="583442"/>
                  </a:lnTo>
                  <a:lnTo>
                    <a:pt x="4351504" y="592451"/>
                  </a:lnTo>
                  <a:lnTo>
                    <a:pt x="4334297" y="600374"/>
                  </a:lnTo>
                  <a:lnTo>
                    <a:pt x="4328839" y="603131"/>
                  </a:lnTo>
                  <a:lnTo>
                    <a:pt x="4304364" y="615281"/>
                  </a:lnTo>
                  <a:lnTo>
                    <a:pt x="4287691" y="623942"/>
                  </a:lnTo>
                  <a:lnTo>
                    <a:pt x="4277953" y="629268"/>
                  </a:lnTo>
                  <a:lnTo>
                    <a:pt x="4249477" y="644780"/>
                  </a:lnTo>
                  <a:lnTo>
                    <a:pt x="4241086" y="649562"/>
                  </a:lnTo>
                  <a:lnTo>
                    <a:pt x="4218800" y="662315"/>
                  </a:lnTo>
                  <a:lnTo>
                    <a:pt x="4194481" y="676462"/>
                  </a:lnTo>
                  <a:lnTo>
                    <a:pt x="4185781" y="681761"/>
                  </a:lnTo>
                  <a:lnTo>
                    <a:pt x="4150279" y="702998"/>
                  </a:lnTo>
                  <a:lnTo>
                    <a:pt x="4147875" y="704598"/>
                  </a:lnTo>
                  <a:lnTo>
                    <a:pt x="4112145" y="726517"/>
                  </a:lnTo>
                  <a:lnTo>
                    <a:pt x="4101270" y="733383"/>
                  </a:lnTo>
                  <a:lnTo>
                    <a:pt x="4071232" y="752277"/>
                  </a:lnTo>
                  <a:lnTo>
                    <a:pt x="4054665" y="762879"/>
                  </a:lnTo>
                  <a:lnTo>
                    <a:pt x="4027391" y="780399"/>
                  </a:lnTo>
                  <a:lnTo>
                    <a:pt x="4008059" y="792982"/>
                  </a:lnTo>
                  <a:lnTo>
                    <a:pt x="3980474" y="811022"/>
                  </a:lnTo>
                  <a:lnTo>
                    <a:pt x="3961454" y="823624"/>
                  </a:lnTo>
                  <a:lnTo>
                    <a:pt x="3930335" y="844298"/>
                  </a:lnTo>
                  <a:lnTo>
                    <a:pt x="3914848" y="854764"/>
                  </a:lnTo>
                  <a:lnTo>
                    <a:pt x="3876833" y="880391"/>
                  </a:lnTo>
                  <a:lnTo>
                    <a:pt x="3868243" y="886371"/>
                  </a:lnTo>
                  <a:lnTo>
                    <a:pt x="3821638" y="918343"/>
                  </a:lnTo>
                  <a:lnTo>
                    <a:pt x="3819835" y="919589"/>
                  </a:lnTo>
                  <a:lnTo>
                    <a:pt x="3775032" y="950655"/>
                  </a:lnTo>
                  <a:lnTo>
                    <a:pt x="3759214" y="961782"/>
                  </a:lnTo>
                  <a:lnTo>
                    <a:pt x="3728427" y="983513"/>
                  </a:lnTo>
                  <a:lnTo>
                    <a:pt x="3694858" y="1007348"/>
                  </a:lnTo>
                  <a:lnTo>
                    <a:pt x="3681822" y="1016776"/>
                  </a:lnTo>
                  <a:lnTo>
                    <a:pt x="3635216" y="1050282"/>
                  </a:lnTo>
                  <a:lnTo>
                    <a:pt x="3626667" y="1056553"/>
                  </a:lnTo>
                  <a:lnTo>
                    <a:pt x="3588611" y="1084334"/>
                  </a:lnTo>
                  <a:lnTo>
                    <a:pt x="3554561" y="1109378"/>
                  </a:lnTo>
                  <a:lnTo>
                    <a:pt x="3542006" y="1118774"/>
                  </a:lnTo>
                  <a:lnTo>
                    <a:pt x="3495400" y="1153477"/>
                  </a:lnTo>
                  <a:lnTo>
                    <a:pt x="3478478" y="1166231"/>
                  </a:lnTo>
                  <a:lnTo>
                    <a:pt x="3448795" y="1188746"/>
                  </a:lnTo>
                  <a:lnTo>
                    <a:pt x="3402190" y="1224232"/>
                  </a:lnTo>
                  <a:lnTo>
                    <a:pt x="3398381" y="1227235"/>
                  </a:lnTo>
                  <a:lnTo>
                    <a:pt x="3355584" y="1260291"/>
                  </a:lnTo>
                  <a:lnTo>
                    <a:pt x="3314261" y="1292460"/>
                  </a:lnTo>
                  <a:lnTo>
                    <a:pt x="3308979" y="1296698"/>
                  </a:lnTo>
                  <a:lnTo>
                    <a:pt x="3262374" y="1333460"/>
                  </a:lnTo>
                  <a:lnTo>
                    <a:pt x="3226136" y="1362302"/>
                  </a:lnTo>
                  <a:lnTo>
                    <a:pt x="3215768" y="1370709"/>
                  </a:lnTo>
                  <a:lnTo>
                    <a:pt x="3169163" y="1408298"/>
                  </a:lnTo>
                  <a:lnTo>
                    <a:pt x="3134059" y="1436867"/>
                  </a:lnTo>
                  <a:lnTo>
                    <a:pt x="3122558" y="1446393"/>
                  </a:lnTo>
                  <a:lnTo>
                    <a:pt x="3075952" y="1484844"/>
                  </a:lnTo>
                  <a:lnTo>
                    <a:pt x="3038118" y="1516335"/>
                  </a:lnTo>
                  <a:lnTo>
                    <a:pt x="3029347" y="1523794"/>
                  </a:lnTo>
                  <a:lnTo>
                    <a:pt x="2982742" y="1563154"/>
                  </a:lnTo>
                  <a:lnTo>
                    <a:pt x="2938435" y="1600988"/>
                  </a:lnTo>
                  <a:lnTo>
                    <a:pt x="2936136" y="1602962"/>
                  </a:lnTo>
                  <a:lnTo>
                    <a:pt x="2889531" y="1643233"/>
                  </a:lnTo>
                  <a:lnTo>
                    <a:pt x="2842926" y="1683832"/>
                  </a:lnTo>
                  <a:lnTo>
                    <a:pt x="2835173" y="1690731"/>
                  </a:lnTo>
                  <a:lnTo>
                    <a:pt x="2796320" y="1725154"/>
                  </a:lnTo>
                  <a:lnTo>
                    <a:pt x="2749715" y="1766716"/>
                  </a:lnTo>
                  <a:lnTo>
                    <a:pt x="2728533" y="1785824"/>
                  </a:lnTo>
                  <a:lnTo>
                    <a:pt x="2703110" y="1808985"/>
                  </a:lnTo>
                  <a:lnTo>
                    <a:pt x="2656504" y="1851647"/>
                  </a:lnTo>
                  <a:lnTo>
                    <a:pt x="2618755" y="1886562"/>
                  </a:lnTo>
                  <a:lnTo>
                    <a:pt x="2609899" y="1894807"/>
                  </a:lnTo>
                  <a:lnTo>
                    <a:pt x="2563293" y="1938604"/>
                  </a:lnTo>
                  <a:lnTo>
                    <a:pt x="2516688" y="1982637"/>
                  </a:lnTo>
                  <a:lnTo>
                    <a:pt x="2506116" y="1992748"/>
                  </a:lnTo>
                  <a:lnTo>
                    <a:pt x="2470083" y="2027477"/>
                  </a:lnTo>
                  <a:lnTo>
                    <a:pt x="2423477" y="2072786"/>
                  </a:lnTo>
                  <a:lnTo>
                    <a:pt x="2390929" y="2104751"/>
                  </a:lnTo>
                  <a:lnTo>
                    <a:pt x="2376872" y="2118656"/>
                  </a:lnTo>
                  <a:lnTo>
                    <a:pt x="2330267" y="2165091"/>
                  </a:lnTo>
                  <a:lnTo>
                    <a:pt x="2283661" y="2212110"/>
                  </a:lnTo>
                  <a:lnTo>
                    <a:pt x="2273542" y="2222012"/>
                  </a:lnTo>
                  <a:lnTo>
                    <a:pt x="2237056" y="2259442"/>
                  </a:lnTo>
                  <a:lnTo>
                    <a:pt x="2190451" y="2307807"/>
                  </a:lnTo>
                  <a:lnTo>
                    <a:pt x="2154331" y="2345619"/>
                  </a:lnTo>
                  <a:lnTo>
                    <a:pt x="2143845" y="2356018"/>
                  </a:lnTo>
                  <a:lnTo>
                    <a:pt x="2097240" y="2405466"/>
                  </a:lnTo>
                  <a:lnTo>
                    <a:pt x="2050635" y="2455183"/>
                  </a:lnTo>
                  <a:lnTo>
                    <a:pt x="2033698" y="2473507"/>
                  </a:lnTo>
                  <a:lnTo>
                    <a:pt x="2004029" y="2505605"/>
                  </a:lnTo>
                  <a:lnTo>
                    <a:pt x="1957424" y="2556247"/>
                  </a:lnTo>
                  <a:lnTo>
                    <a:pt x="1912065" y="2605939"/>
                  </a:lnTo>
                  <a:lnTo>
                    <a:pt x="1910819" y="2607310"/>
                  </a:lnTo>
                  <a:lnTo>
                    <a:pt x="1864213" y="2658765"/>
                  </a:lnTo>
                  <a:lnTo>
                    <a:pt x="1817608" y="2710440"/>
                  </a:lnTo>
                  <a:lnTo>
                    <a:pt x="1789868" y="2741403"/>
                  </a:lnTo>
                  <a:lnTo>
                    <a:pt x="1771003" y="2762739"/>
                  </a:lnTo>
                  <a:lnTo>
                    <a:pt x="1724397" y="2815215"/>
                  </a:lnTo>
                  <a:lnTo>
                    <a:pt x="1677792" y="2867770"/>
                  </a:lnTo>
                  <a:lnTo>
                    <a:pt x="1667553" y="2879529"/>
                  </a:lnTo>
                  <a:lnTo>
                    <a:pt x="1631187" y="2921043"/>
                  </a:lnTo>
                  <a:lnTo>
                    <a:pt x="1584581" y="2974301"/>
                  </a:lnTo>
                  <a:lnTo>
                    <a:pt x="1545564" y="3018982"/>
                  </a:lnTo>
                  <a:lnTo>
                    <a:pt x="1537976" y="3027972"/>
                  </a:lnTo>
                  <a:lnTo>
                    <a:pt x="1491371" y="3081841"/>
                  </a:lnTo>
                  <a:lnTo>
                    <a:pt x="1444765" y="3135751"/>
                  </a:lnTo>
                  <a:lnTo>
                    <a:pt x="1424344" y="3159593"/>
                  </a:lnTo>
                  <a:lnTo>
                    <a:pt x="1398160" y="3190415"/>
                  </a:lnTo>
                  <a:lnTo>
                    <a:pt x="1351555" y="3245166"/>
                  </a:lnTo>
                  <a:lnTo>
                    <a:pt x="1304949" y="3300224"/>
                  </a:lnTo>
                  <a:lnTo>
                    <a:pt x="1304323" y="3300966"/>
                  </a:lnTo>
                  <a:lnTo>
                    <a:pt x="1258344" y="3355681"/>
                  </a:lnTo>
                  <a:lnTo>
                    <a:pt x="1211738" y="3411233"/>
                  </a:lnTo>
                  <a:lnTo>
                    <a:pt x="1185914" y="3442311"/>
                  </a:lnTo>
                  <a:lnTo>
                    <a:pt x="1165133" y="3467839"/>
                  </a:lnTo>
                  <a:lnTo>
                    <a:pt x="1118528" y="3524619"/>
                  </a:lnTo>
                  <a:lnTo>
                    <a:pt x="1071922" y="3581427"/>
                  </a:lnTo>
                  <a:lnTo>
                    <a:pt x="1069509" y="3584851"/>
                  </a:lnTo>
                  <a:lnTo>
                    <a:pt x="1025317" y="3639260"/>
                  </a:lnTo>
                  <a:lnTo>
                    <a:pt x="978712" y="3697740"/>
                  </a:lnTo>
                  <a:lnTo>
                    <a:pt x="955469" y="3727016"/>
                  </a:lnTo>
                  <a:lnTo>
                    <a:pt x="932106" y="3756438"/>
                  </a:lnTo>
                  <a:lnTo>
                    <a:pt x="885501" y="3815612"/>
                  </a:lnTo>
                  <a:lnTo>
                    <a:pt x="844127" y="3868329"/>
                  </a:lnTo>
                  <a:lnTo>
                    <a:pt x="838896" y="3875009"/>
                  </a:lnTo>
                  <a:lnTo>
                    <a:pt x="792290" y="3934482"/>
                  </a:lnTo>
                  <a:lnTo>
                    <a:pt x="745685" y="3993884"/>
                  </a:lnTo>
                  <a:lnTo>
                    <a:pt x="735781" y="4006563"/>
                  </a:lnTo>
                  <a:lnTo>
                    <a:pt x="699080" y="4053338"/>
                  </a:lnTo>
                  <a:lnTo>
                    <a:pt x="652474" y="4112118"/>
                  </a:lnTo>
                  <a:lnTo>
                    <a:pt x="630689" y="4139135"/>
                  </a:lnTo>
                  <a:lnTo>
                    <a:pt x="605869" y="4170180"/>
                  </a:lnTo>
                  <a:lnTo>
                    <a:pt x="559264" y="4227627"/>
                  </a:lnTo>
                  <a:lnTo>
                    <a:pt x="529075" y="4264733"/>
                  </a:lnTo>
                  <a:lnTo>
                    <a:pt x="512658" y="4284687"/>
                  </a:lnTo>
                  <a:lnTo>
                    <a:pt x="466053" y="4340607"/>
                  </a:lnTo>
                  <a:lnTo>
                    <a:pt x="431119" y="4382009"/>
                  </a:lnTo>
                  <a:lnTo>
                    <a:pt x="419448" y="4395661"/>
                  </a:lnTo>
                  <a:lnTo>
                    <a:pt x="372842" y="4449369"/>
                  </a:lnTo>
                  <a:lnTo>
                    <a:pt x="336967" y="4489833"/>
                  </a:lnTo>
                  <a:lnTo>
                    <a:pt x="326237" y="4501793"/>
                  </a:lnTo>
                  <a:lnTo>
                    <a:pt x="279632" y="4552773"/>
                  </a:lnTo>
                  <a:lnTo>
                    <a:pt x="246726" y="4587872"/>
                  </a:lnTo>
                  <a:lnTo>
                    <a:pt x="233026" y="4602356"/>
                  </a:lnTo>
                  <a:lnTo>
                    <a:pt x="186421" y="4650238"/>
                  </a:lnTo>
                  <a:lnTo>
                    <a:pt x="160465" y="4676206"/>
                  </a:lnTo>
                  <a:lnTo>
                    <a:pt x="139816" y="4696546"/>
                  </a:lnTo>
                  <a:lnTo>
                    <a:pt x="93210" y="4740973"/>
                  </a:lnTo>
                  <a:lnTo>
                    <a:pt x="78221" y="4754917"/>
                  </a:lnTo>
                  <a:lnTo>
                    <a:pt x="46605" y="4783672"/>
                  </a:lnTo>
                  <a:lnTo>
                    <a:pt x="0" y="4824358"/>
                  </a:lnTo>
                  <a:lnTo>
                    <a:pt x="0" y="4261968"/>
                  </a:lnTo>
                  <a:close/>
                </a:path>
              </a:pathLst>
            </a:custGeom>
            <a:solidFill>
              <a:srgbClr val="cccccc"/>
            </a:solidFill>
            <a:ln w="0">
              <a:noFill/>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69" name="pl36"/>
            <p:cNvSpPr/>
            <p:nvPr/>
          </p:nvSpPr>
          <p:spPr>
            <a:xfrm>
              <a:off x="1271520" y="4555440"/>
              <a:ext cx="5526360" cy="4825080"/>
            </a:xfrm>
            <a:custGeom>
              <a:avLst/>
              <a:gdLst/>
              <a:ahLst/>
              <a:rect l="l" t="t" r="r" b="b"/>
              <a:pathLst>
                <a:path w="5723466" h="5215466">
                  <a:moveTo>
                    <a:pt x="0" y="5215466"/>
                  </a:moveTo>
                  <a:lnTo>
                    <a:pt x="5723466" y="0"/>
                  </a:lnTo>
                </a:path>
              </a:pathLst>
            </a:custGeom>
            <a:noFill/>
            <a:ln cap="rnd" w="16560">
              <a:solidFill>
                <a:srgbClr val="ff0000"/>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70" name="tx37"/>
            <p:cNvSpPr/>
            <p:nvPr/>
          </p:nvSpPr>
          <p:spPr>
            <a:xfrm>
              <a:off x="1271520" y="4460040"/>
              <a:ext cx="1382400" cy="13068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zh-CN" sz="1200" spc="-1" strike="noStrike">
                  <a:solidFill>
                    <a:srgbClr val="000000"/>
                  </a:solidFill>
                  <a:latin typeface="Arial"/>
                </a:rPr>
                <a:t>Polynomial degree: 2</a:t>
              </a:r>
              <a:endParaRPr b="0" lang="en-US" sz="1200" spc="-1" strike="noStrike">
                <a:solidFill>
                  <a:srgbClr val="000000"/>
                </a:solidFill>
                <a:latin typeface="Arial"/>
              </a:endParaRPr>
            </a:p>
          </p:txBody>
        </p:sp>
        <p:sp>
          <p:nvSpPr>
            <p:cNvPr id="1171" name="tx38"/>
            <p:cNvSpPr/>
            <p:nvPr/>
          </p:nvSpPr>
          <p:spPr>
            <a:xfrm>
              <a:off x="1271520" y="4703760"/>
              <a:ext cx="932400" cy="12924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zh-CN" sz="1200" spc="-1" strike="noStrike">
                  <a:solidFill>
                    <a:srgbClr val="000000"/>
                  </a:solidFill>
                  <a:latin typeface="Arial"/>
                </a:rPr>
                <a:t>p-value: 0.108</a:t>
              </a:r>
              <a:endParaRPr b="0" lang="en-US" sz="1200" spc="-1" strike="noStrike">
                <a:solidFill>
                  <a:srgbClr val="000000"/>
                </a:solidFill>
                <a:latin typeface="Arial"/>
              </a:endParaRPr>
            </a:p>
          </p:txBody>
        </p:sp>
        <p:sp>
          <p:nvSpPr>
            <p:cNvPr id="1172" name="tx39"/>
            <p:cNvSpPr/>
            <p:nvPr/>
          </p:nvSpPr>
          <p:spPr>
            <a:xfrm>
              <a:off x="1271520" y="4984560"/>
              <a:ext cx="408960" cy="10296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zh-CN" sz="1200" spc="-1" strike="noStrike">
                  <a:solidFill>
                    <a:srgbClr val="000000"/>
                  </a:solidFill>
                  <a:latin typeface="Arial"/>
                </a:rPr>
                <a:t>n: 203</a:t>
              </a:r>
              <a:endParaRPr b="0" lang="en-US" sz="1200" spc="-1" strike="noStrike">
                <a:solidFill>
                  <a:srgbClr val="000000"/>
                </a:solidFill>
                <a:latin typeface="Arial"/>
              </a:endParaRPr>
            </a:p>
          </p:txBody>
        </p:sp>
        <p:sp>
          <p:nvSpPr>
            <p:cNvPr id="1173" name="pl40"/>
            <p:cNvSpPr/>
            <p:nvPr/>
          </p:nvSpPr>
          <p:spPr>
            <a:xfrm>
              <a:off x="3481920" y="9501120"/>
              <a:ext cx="3315960" cy="360"/>
            </a:xfrm>
            <a:custGeom>
              <a:avLst/>
              <a:gdLst/>
              <a:ahLst/>
              <a:rect l="l" t="t" r="r" b="b"/>
              <a:pathLst>
                <a:path w="3434080" h="1">
                  <a:moveTo>
                    <a:pt x="0" y="0"/>
                  </a:moveTo>
                  <a:lnTo>
                    <a:pt x="343408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1174" name="tx41" descr=""/>
            <p:cNvPicPr/>
            <p:nvPr/>
          </p:nvPicPr>
          <p:blipFill>
            <a:blip r:embed="rId13"/>
            <a:stretch/>
          </p:blipFill>
          <p:spPr>
            <a:xfrm>
              <a:off x="3891600" y="9287640"/>
              <a:ext cx="286920" cy="145800"/>
            </a:xfrm>
            <a:prstGeom prst="rect">
              <a:avLst/>
            </a:prstGeom>
            <a:ln w="0">
              <a:noFill/>
            </a:ln>
          </p:spPr>
        </p:pic>
        <p:sp>
          <p:nvSpPr>
            <p:cNvPr id="1175" name="pg42"/>
            <p:cNvSpPr/>
            <p:nvPr/>
          </p:nvSpPr>
          <p:spPr>
            <a:xfrm>
              <a:off x="3592440" y="9308160"/>
              <a:ext cx="165600" cy="144720"/>
            </a:xfrm>
            <a:custGeom>
              <a:avLst/>
              <a:gdLst/>
              <a:ahLst/>
              <a:rect l="l" t="t" r="r" b="b"/>
              <a:pathLst>
                <a:path w="171704" h="156463">
                  <a:moveTo>
                    <a:pt x="171704" y="156463"/>
                  </a:moveTo>
                  <a:lnTo>
                    <a:pt x="0" y="156463"/>
                  </a:lnTo>
                  <a:lnTo>
                    <a:pt x="0" y="0"/>
                  </a:lnTo>
                  <a:lnTo>
                    <a:pt x="171704" y="0"/>
                  </a:lnTo>
                  <a:lnTo>
                    <a:pt x="171704" y="156463"/>
                  </a:lnTo>
                  <a:close/>
                </a:path>
              </a:pathLst>
            </a:custGeom>
            <a:solidFill>
              <a:srgbClr val="808080"/>
            </a:solidFill>
            <a:ln cap="rnd" w="9360">
              <a:solidFill>
                <a:srgbClr val="808080"/>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1176" name="tx43" descr=""/>
            <p:cNvPicPr/>
            <p:nvPr/>
          </p:nvPicPr>
          <p:blipFill>
            <a:blip r:embed="rId14"/>
            <a:stretch/>
          </p:blipFill>
          <p:spPr>
            <a:xfrm>
              <a:off x="6008400" y="9291600"/>
              <a:ext cx="474120" cy="145800"/>
            </a:xfrm>
            <a:prstGeom prst="rect">
              <a:avLst/>
            </a:prstGeom>
            <a:ln w="0">
              <a:noFill/>
            </a:ln>
          </p:spPr>
        </p:pic>
        <p:pic>
          <p:nvPicPr>
            <p:cNvPr id="1177" name="tx44" descr=""/>
            <p:cNvPicPr/>
            <p:nvPr/>
          </p:nvPicPr>
          <p:blipFill>
            <a:blip r:embed="rId15"/>
            <a:stretch/>
          </p:blipFill>
          <p:spPr>
            <a:xfrm>
              <a:off x="4903560" y="9291600"/>
              <a:ext cx="474120" cy="145800"/>
            </a:xfrm>
            <a:prstGeom prst="rect">
              <a:avLst/>
            </a:prstGeom>
            <a:ln w="0">
              <a:noFill/>
            </a:ln>
          </p:spPr>
        </p:pic>
        <p:sp>
          <p:nvSpPr>
            <p:cNvPr id="1178" name="pl45"/>
            <p:cNvSpPr/>
            <p:nvPr/>
          </p:nvSpPr>
          <p:spPr>
            <a:xfrm>
              <a:off x="3481920" y="9259920"/>
              <a:ext cx="3315960" cy="360"/>
            </a:xfrm>
            <a:custGeom>
              <a:avLst/>
              <a:gdLst/>
              <a:ahLst/>
              <a:rect l="l" t="t" r="r" b="b"/>
              <a:pathLst>
                <a:path w="3434080" h="1">
                  <a:moveTo>
                    <a:pt x="0" y="0"/>
                  </a:moveTo>
                  <a:lnTo>
                    <a:pt x="343408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1179" name="tx46" descr=""/>
            <p:cNvPicPr/>
            <p:nvPr/>
          </p:nvPicPr>
          <p:blipFill>
            <a:blip r:embed="rId16"/>
            <a:stretch/>
          </p:blipFill>
          <p:spPr>
            <a:xfrm>
              <a:off x="3891600" y="9046440"/>
              <a:ext cx="286920" cy="145800"/>
            </a:xfrm>
            <a:prstGeom prst="rect">
              <a:avLst/>
            </a:prstGeom>
            <a:ln w="0">
              <a:noFill/>
            </a:ln>
          </p:spPr>
        </p:pic>
        <p:sp>
          <p:nvSpPr>
            <p:cNvPr id="1180" name="pg47"/>
            <p:cNvSpPr/>
            <p:nvPr/>
          </p:nvSpPr>
          <p:spPr>
            <a:xfrm>
              <a:off x="3592440" y="9066960"/>
              <a:ext cx="165600" cy="144720"/>
            </a:xfrm>
            <a:custGeom>
              <a:avLst/>
              <a:gdLst/>
              <a:ahLst/>
              <a:rect l="l" t="t" r="r" b="b"/>
              <a:pathLst>
                <a:path w="171704" h="156463">
                  <a:moveTo>
                    <a:pt x="171704" y="156463"/>
                  </a:moveTo>
                  <a:lnTo>
                    <a:pt x="0" y="156463"/>
                  </a:lnTo>
                  <a:lnTo>
                    <a:pt x="0" y="0"/>
                  </a:lnTo>
                  <a:lnTo>
                    <a:pt x="171704" y="0"/>
                  </a:lnTo>
                  <a:lnTo>
                    <a:pt x="171704" y="156463"/>
                  </a:lnTo>
                  <a:close/>
                </a:path>
              </a:pathLst>
            </a:custGeom>
            <a:solidFill>
              <a:srgbClr val="cccccc"/>
            </a:solidFill>
            <a:ln cap="rnd" w="9360">
              <a:solidFill>
                <a:srgbClr val="cccccc"/>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1181" name="tx48" descr=""/>
            <p:cNvPicPr/>
            <p:nvPr/>
          </p:nvPicPr>
          <p:blipFill>
            <a:blip r:embed="rId17"/>
            <a:stretch/>
          </p:blipFill>
          <p:spPr>
            <a:xfrm>
              <a:off x="6008400" y="9050400"/>
              <a:ext cx="474120" cy="145800"/>
            </a:xfrm>
            <a:prstGeom prst="rect">
              <a:avLst/>
            </a:prstGeom>
            <a:ln w="0">
              <a:noFill/>
            </a:ln>
          </p:spPr>
        </p:pic>
        <p:pic>
          <p:nvPicPr>
            <p:cNvPr id="1182" name="tx49" descr=""/>
            <p:cNvPicPr/>
            <p:nvPr/>
          </p:nvPicPr>
          <p:blipFill>
            <a:blip r:embed="rId18"/>
            <a:stretch/>
          </p:blipFill>
          <p:spPr>
            <a:xfrm>
              <a:off x="4816080" y="9048960"/>
              <a:ext cx="646920" cy="145800"/>
            </a:xfrm>
            <a:prstGeom prst="rect">
              <a:avLst/>
            </a:prstGeom>
            <a:ln w="0">
              <a:noFill/>
            </a:ln>
          </p:spPr>
        </p:pic>
        <p:sp>
          <p:nvSpPr>
            <p:cNvPr id="1183" name="pl50"/>
            <p:cNvSpPr/>
            <p:nvPr/>
          </p:nvSpPr>
          <p:spPr>
            <a:xfrm>
              <a:off x="3481920" y="9018720"/>
              <a:ext cx="3315960" cy="360"/>
            </a:xfrm>
            <a:custGeom>
              <a:avLst/>
              <a:gdLst/>
              <a:ahLst/>
              <a:rect l="l" t="t" r="r" b="b"/>
              <a:pathLst>
                <a:path w="3434080" h="1">
                  <a:moveTo>
                    <a:pt x="0" y="0"/>
                  </a:moveTo>
                  <a:lnTo>
                    <a:pt x="343408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pic>
          <p:nvPicPr>
            <p:cNvPr id="1184" name="tx51" descr=""/>
            <p:cNvPicPr/>
            <p:nvPr/>
          </p:nvPicPr>
          <p:blipFill>
            <a:blip r:embed="rId19"/>
            <a:stretch/>
          </p:blipFill>
          <p:spPr>
            <a:xfrm>
              <a:off x="3754440" y="8668440"/>
              <a:ext cx="561240" cy="119880"/>
            </a:xfrm>
            <a:prstGeom prst="rect">
              <a:avLst/>
            </a:prstGeom>
            <a:ln w="0">
              <a:noFill/>
            </a:ln>
          </p:spPr>
        </p:pic>
        <p:pic>
          <p:nvPicPr>
            <p:cNvPr id="1185" name="tx52" descr=""/>
            <p:cNvPicPr/>
            <p:nvPr/>
          </p:nvPicPr>
          <p:blipFill>
            <a:blip r:embed="rId20"/>
            <a:stretch/>
          </p:blipFill>
          <p:spPr>
            <a:xfrm>
              <a:off x="3913920" y="8787240"/>
              <a:ext cx="241920" cy="119880"/>
            </a:xfrm>
            <a:prstGeom prst="rect">
              <a:avLst/>
            </a:prstGeom>
            <a:ln w="0">
              <a:noFill/>
            </a:ln>
          </p:spPr>
        </p:pic>
        <p:pic>
          <p:nvPicPr>
            <p:cNvPr id="1186" name="tx53" descr=""/>
            <p:cNvPicPr/>
            <p:nvPr/>
          </p:nvPicPr>
          <p:blipFill>
            <a:blip r:embed="rId21"/>
            <a:stretch/>
          </p:blipFill>
          <p:spPr>
            <a:xfrm>
              <a:off x="4983120" y="8668440"/>
              <a:ext cx="312840" cy="119880"/>
            </a:xfrm>
            <a:prstGeom prst="rect">
              <a:avLst/>
            </a:prstGeom>
            <a:ln w="0">
              <a:noFill/>
            </a:ln>
          </p:spPr>
        </p:pic>
        <p:pic>
          <p:nvPicPr>
            <p:cNvPr id="1187" name="tx54" descr=""/>
            <p:cNvPicPr/>
            <p:nvPr/>
          </p:nvPicPr>
          <p:blipFill>
            <a:blip r:embed="rId22"/>
            <a:stretch/>
          </p:blipFill>
          <p:spPr>
            <a:xfrm>
              <a:off x="4853880" y="8787240"/>
              <a:ext cx="573840" cy="119880"/>
            </a:xfrm>
            <a:prstGeom prst="rect">
              <a:avLst/>
            </a:prstGeom>
            <a:ln w="0">
              <a:noFill/>
            </a:ln>
          </p:spPr>
        </p:pic>
        <p:pic>
          <p:nvPicPr>
            <p:cNvPr id="1188" name="tx55" descr=""/>
            <p:cNvPicPr/>
            <p:nvPr/>
          </p:nvPicPr>
          <p:blipFill>
            <a:blip r:embed="rId23"/>
            <a:stretch/>
          </p:blipFill>
          <p:spPr>
            <a:xfrm>
              <a:off x="6118200" y="8668440"/>
              <a:ext cx="254520" cy="119880"/>
            </a:xfrm>
            <a:prstGeom prst="rect">
              <a:avLst/>
            </a:prstGeom>
            <a:ln w="0">
              <a:noFill/>
            </a:ln>
          </p:spPr>
        </p:pic>
        <p:pic>
          <p:nvPicPr>
            <p:cNvPr id="1189" name="tx56" descr=""/>
            <p:cNvPicPr/>
            <p:nvPr/>
          </p:nvPicPr>
          <p:blipFill>
            <a:blip r:embed="rId24"/>
            <a:stretch/>
          </p:blipFill>
          <p:spPr>
            <a:xfrm>
              <a:off x="5958720" y="8787240"/>
              <a:ext cx="573840" cy="119880"/>
            </a:xfrm>
            <a:prstGeom prst="rect">
              <a:avLst/>
            </a:prstGeom>
            <a:ln w="0">
              <a:noFill/>
            </a:ln>
          </p:spPr>
        </p:pic>
      </p:grpSp>
      <p:grpSp>
        <p:nvGrpSpPr>
          <p:cNvPr id="1190" name="组合 118"/>
          <p:cNvGrpSpPr/>
          <p:nvPr/>
        </p:nvGrpSpPr>
        <p:grpSpPr>
          <a:xfrm>
            <a:off x="14482800" y="3989520"/>
            <a:ext cx="6775560" cy="6689520"/>
            <a:chOff x="14482800" y="3989520"/>
            <a:chExt cx="6775560" cy="6689520"/>
          </a:xfrm>
        </p:grpSpPr>
        <p:sp>
          <p:nvSpPr>
            <p:cNvPr id="1191" name="rc3"/>
            <p:cNvSpPr/>
            <p:nvPr/>
          </p:nvSpPr>
          <p:spPr>
            <a:xfrm>
              <a:off x="14652000" y="3989520"/>
              <a:ext cx="6606360" cy="6689520"/>
            </a:xfrm>
            <a:prstGeom prst="rect">
              <a:avLst/>
            </a:prstGeom>
            <a:solidFill>
              <a:srgbClr val="ffffff"/>
            </a:solidFill>
            <a:ln cap="rnd" w="9360">
              <a:solidFill>
                <a:srgbClr val="ffffff"/>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92" name="pl4"/>
            <p:cNvSpPr/>
            <p:nvPr/>
          </p:nvSpPr>
          <p:spPr>
            <a:xfrm>
              <a:off x="15535800" y="9826200"/>
              <a:ext cx="5168880" cy="360"/>
            </a:xfrm>
            <a:custGeom>
              <a:avLst/>
              <a:gdLst/>
              <a:ahLst/>
              <a:rect l="l" t="t" r="r" b="b"/>
              <a:pathLst>
                <a:path w="5723466" h="1">
                  <a:moveTo>
                    <a:pt x="0" y="0"/>
                  </a:moveTo>
                  <a:lnTo>
                    <a:pt x="5723466"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93" name="pl5"/>
            <p:cNvSpPr/>
            <p:nvPr/>
          </p:nvSpPr>
          <p:spPr>
            <a:xfrm>
              <a:off x="15535800" y="9826200"/>
              <a:ext cx="360" cy="83520"/>
            </a:xfrm>
            <a:custGeom>
              <a:avLst/>
              <a:gdLst/>
              <a:ahLst/>
              <a:rect l="l" t="t" r="r" b="b"/>
              <a:pathLst>
                <a:path w="1" h="91440">
                  <a:moveTo>
                    <a:pt x="0" y="0"/>
                  </a:moveTo>
                  <a:lnTo>
                    <a:pt x="0" y="91440"/>
                  </a:lnTo>
                </a:path>
              </a:pathLst>
            </a:custGeom>
            <a:noFill/>
            <a:ln cap="rnd" w="9360">
              <a:solidFill>
                <a:srgbClr val="000000"/>
              </a:solidFill>
              <a:round/>
            </a:ln>
          </p:spPr>
          <p:style>
            <a:lnRef idx="0"/>
            <a:fillRef idx="0"/>
            <a:effectRef idx="0"/>
            <a:fontRef idx="minor"/>
          </p:style>
          <p:txBody>
            <a:bodyPr lIns="90000" rIns="90000" tIns="36720" bIns="367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94" name="pl6"/>
            <p:cNvSpPr/>
            <p:nvPr/>
          </p:nvSpPr>
          <p:spPr>
            <a:xfrm>
              <a:off x="16569720" y="9826200"/>
              <a:ext cx="360" cy="83520"/>
            </a:xfrm>
            <a:custGeom>
              <a:avLst/>
              <a:gdLst/>
              <a:ahLst/>
              <a:rect l="l" t="t" r="r" b="b"/>
              <a:pathLst>
                <a:path w="1" h="91440">
                  <a:moveTo>
                    <a:pt x="0" y="0"/>
                  </a:moveTo>
                  <a:lnTo>
                    <a:pt x="0" y="91440"/>
                  </a:lnTo>
                </a:path>
              </a:pathLst>
            </a:custGeom>
            <a:noFill/>
            <a:ln cap="rnd" w="9360">
              <a:solidFill>
                <a:srgbClr val="000000"/>
              </a:solidFill>
              <a:round/>
            </a:ln>
          </p:spPr>
          <p:style>
            <a:lnRef idx="0"/>
            <a:fillRef idx="0"/>
            <a:effectRef idx="0"/>
            <a:fontRef idx="minor"/>
          </p:style>
          <p:txBody>
            <a:bodyPr lIns="90000" rIns="90000" tIns="36720" bIns="367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95" name="pl7"/>
            <p:cNvSpPr/>
            <p:nvPr/>
          </p:nvSpPr>
          <p:spPr>
            <a:xfrm>
              <a:off x="17603640" y="9826200"/>
              <a:ext cx="360" cy="83520"/>
            </a:xfrm>
            <a:custGeom>
              <a:avLst/>
              <a:gdLst/>
              <a:ahLst/>
              <a:rect l="l" t="t" r="r" b="b"/>
              <a:pathLst>
                <a:path w="1" h="91440">
                  <a:moveTo>
                    <a:pt x="0" y="0"/>
                  </a:moveTo>
                  <a:lnTo>
                    <a:pt x="0" y="91440"/>
                  </a:lnTo>
                </a:path>
              </a:pathLst>
            </a:custGeom>
            <a:noFill/>
            <a:ln cap="rnd" w="9360">
              <a:solidFill>
                <a:srgbClr val="000000"/>
              </a:solidFill>
              <a:round/>
            </a:ln>
          </p:spPr>
          <p:style>
            <a:lnRef idx="0"/>
            <a:fillRef idx="0"/>
            <a:effectRef idx="0"/>
            <a:fontRef idx="minor"/>
          </p:style>
          <p:txBody>
            <a:bodyPr lIns="90000" rIns="90000" tIns="36720" bIns="367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96" name="pl8"/>
            <p:cNvSpPr/>
            <p:nvPr/>
          </p:nvSpPr>
          <p:spPr>
            <a:xfrm>
              <a:off x="18637200" y="9826200"/>
              <a:ext cx="360" cy="83520"/>
            </a:xfrm>
            <a:custGeom>
              <a:avLst/>
              <a:gdLst/>
              <a:ahLst/>
              <a:rect l="l" t="t" r="r" b="b"/>
              <a:pathLst>
                <a:path w="1" h="91440">
                  <a:moveTo>
                    <a:pt x="0" y="0"/>
                  </a:moveTo>
                  <a:lnTo>
                    <a:pt x="0" y="91440"/>
                  </a:lnTo>
                </a:path>
              </a:pathLst>
            </a:custGeom>
            <a:noFill/>
            <a:ln cap="rnd" w="9360">
              <a:solidFill>
                <a:srgbClr val="000000"/>
              </a:solidFill>
              <a:round/>
            </a:ln>
          </p:spPr>
          <p:style>
            <a:lnRef idx="0"/>
            <a:fillRef idx="0"/>
            <a:effectRef idx="0"/>
            <a:fontRef idx="minor"/>
          </p:style>
          <p:txBody>
            <a:bodyPr lIns="90000" rIns="90000" tIns="36720" bIns="367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97" name="pl9"/>
            <p:cNvSpPr/>
            <p:nvPr/>
          </p:nvSpPr>
          <p:spPr>
            <a:xfrm>
              <a:off x="19671120" y="9826200"/>
              <a:ext cx="360" cy="83520"/>
            </a:xfrm>
            <a:custGeom>
              <a:avLst/>
              <a:gdLst/>
              <a:ahLst/>
              <a:rect l="l" t="t" r="r" b="b"/>
              <a:pathLst>
                <a:path w="1" h="91440">
                  <a:moveTo>
                    <a:pt x="0" y="0"/>
                  </a:moveTo>
                  <a:lnTo>
                    <a:pt x="0" y="91440"/>
                  </a:lnTo>
                </a:path>
              </a:pathLst>
            </a:custGeom>
            <a:noFill/>
            <a:ln cap="rnd" w="9360">
              <a:solidFill>
                <a:srgbClr val="000000"/>
              </a:solidFill>
              <a:round/>
            </a:ln>
          </p:spPr>
          <p:style>
            <a:lnRef idx="0"/>
            <a:fillRef idx="0"/>
            <a:effectRef idx="0"/>
            <a:fontRef idx="minor"/>
          </p:style>
          <p:txBody>
            <a:bodyPr lIns="90000" rIns="90000" tIns="36720" bIns="367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98" name="pl10"/>
            <p:cNvSpPr/>
            <p:nvPr/>
          </p:nvSpPr>
          <p:spPr>
            <a:xfrm>
              <a:off x="20705040" y="9826200"/>
              <a:ext cx="360" cy="83520"/>
            </a:xfrm>
            <a:custGeom>
              <a:avLst/>
              <a:gdLst/>
              <a:ahLst/>
              <a:rect l="l" t="t" r="r" b="b"/>
              <a:pathLst>
                <a:path w="1" h="91440">
                  <a:moveTo>
                    <a:pt x="0" y="0"/>
                  </a:moveTo>
                  <a:lnTo>
                    <a:pt x="0" y="91440"/>
                  </a:lnTo>
                </a:path>
              </a:pathLst>
            </a:custGeom>
            <a:noFill/>
            <a:ln cap="rnd" w="9360">
              <a:solidFill>
                <a:srgbClr val="000000"/>
              </a:solidFill>
              <a:round/>
            </a:ln>
          </p:spPr>
          <p:style>
            <a:lnRef idx="0"/>
            <a:fillRef idx="0"/>
            <a:effectRef idx="0"/>
            <a:fontRef idx="minor"/>
          </p:style>
          <p:txBody>
            <a:bodyPr lIns="90000" rIns="90000" tIns="36720" bIns="3672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199" name="tx11"/>
            <p:cNvSpPr/>
            <p:nvPr/>
          </p:nvSpPr>
          <p:spPr>
            <a:xfrm>
              <a:off x="15392520" y="9974520"/>
              <a:ext cx="286920" cy="15264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0</a:t>
              </a:r>
              <a:endParaRPr b="0" lang="en-US" sz="1800" spc="-1" strike="noStrike">
                <a:solidFill>
                  <a:srgbClr val="000000"/>
                </a:solidFill>
                <a:latin typeface="Arial"/>
              </a:endParaRPr>
            </a:p>
          </p:txBody>
        </p:sp>
        <p:sp>
          <p:nvSpPr>
            <p:cNvPr id="1200" name="tx12"/>
            <p:cNvSpPr/>
            <p:nvPr/>
          </p:nvSpPr>
          <p:spPr>
            <a:xfrm>
              <a:off x="16426080" y="9974520"/>
              <a:ext cx="286920" cy="15264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2</a:t>
              </a:r>
              <a:endParaRPr b="0" lang="en-US" sz="1800" spc="-1" strike="noStrike">
                <a:solidFill>
                  <a:srgbClr val="000000"/>
                </a:solidFill>
                <a:latin typeface="Arial"/>
              </a:endParaRPr>
            </a:p>
          </p:txBody>
        </p:sp>
        <p:sp>
          <p:nvSpPr>
            <p:cNvPr id="1201" name="tx13"/>
            <p:cNvSpPr/>
            <p:nvPr/>
          </p:nvSpPr>
          <p:spPr>
            <a:xfrm>
              <a:off x="17460000" y="9974520"/>
              <a:ext cx="286920" cy="15264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4</a:t>
              </a:r>
              <a:endParaRPr b="0" lang="en-US" sz="1800" spc="-1" strike="noStrike">
                <a:solidFill>
                  <a:srgbClr val="000000"/>
                </a:solidFill>
                <a:latin typeface="Arial"/>
              </a:endParaRPr>
            </a:p>
          </p:txBody>
        </p:sp>
        <p:sp>
          <p:nvSpPr>
            <p:cNvPr id="1202" name="tx14"/>
            <p:cNvSpPr/>
            <p:nvPr/>
          </p:nvSpPr>
          <p:spPr>
            <a:xfrm>
              <a:off x="18493920" y="9974520"/>
              <a:ext cx="286920" cy="15264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6</a:t>
              </a:r>
              <a:endParaRPr b="0" lang="en-US" sz="1800" spc="-1" strike="noStrike">
                <a:solidFill>
                  <a:srgbClr val="000000"/>
                </a:solidFill>
                <a:latin typeface="Arial"/>
              </a:endParaRPr>
            </a:p>
          </p:txBody>
        </p:sp>
        <p:sp>
          <p:nvSpPr>
            <p:cNvPr id="1203" name="tx15"/>
            <p:cNvSpPr/>
            <p:nvPr/>
          </p:nvSpPr>
          <p:spPr>
            <a:xfrm>
              <a:off x="19527480" y="9974520"/>
              <a:ext cx="286920" cy="15264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8</a:t>
              </a:r>
              <a:endParaRPr b="0" lang="en-US" sz="1800" spc="-1" strike="noStrike">
                <a:solidFill>
                  <a:srgbClr val="000000"/>
                </a:solidFill>
                <a:latin typeface="Arial"/>
              </a:endParaRPr>
            </a:p>
          </p:txBody>
        </p:sp>
        <p:sp>
          <p:nvSpPr>
            <p:cNvPr id="1204" name="tx16"/>
            <p:cNvSpPr/>
            <p:nvPr/>
          </p:nvSpPr>
          <p:spPr>
            <a:xfrm>
              <a:off x="20561400" y="9974520"/>
              <a:ext cx="286920" cy="15264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1.0</a:t>
              </a:r>
              <a:endParaRPr b="0" lang="en-US" sz="1800" spc="-1" strike="noStrike">
                <a:solidFill>
                  <a:srgbClr val="000000"/>
                </a:solidFill>
                <a:latin typeface="Arial"/>
              </a:endParaRPr>
            </a:p>
          </p:txBody>
        </p:sp>
        <p:sp>
          <p:nvSpPr>
            <p:cNvPr id="1205" name="pl17"/>
            <p:cNvSpPr/>
            <p:nvPr/>
          </p:nvSpPr>
          <p:spPr>
            <a:xfrm>
              <a:off x="15329160" y="4865760"/>
              <a:ext cx="360" cy="4542480"/>
            </a:xfrm>
            <a:custGeom>
              <a:avLst/>
              <a:gdLst/>
              <a:ahLst/>
              <a:rect l="l" t="t" r="r" b="b"/>
              <a:pathLst>
                <a:path w="1" h="4967111">
                  <a:moveTo>
                    <a:pt x="0" y="4967111"/>
                  </a:moveTo>
                  <a:lnTo>
                    <a:pt x="0" y="0"/>
                  </a:lnTo>
                </a:path>
              </a:pathLst>
            </a:custGeom>
            <a:noFill/>
            <a:ln cap="rnd" w="9360">
              <a:solidFill>
                <a:srgbClr val="000000"/>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06" name="pl18"/>
            <p:cNvSpPr/>
            <p:nvPr/>
          </p:nvSpPr>
          <p:spPr>
            <a:xfrm>
              <a:off x="15246720" y="9408240"/>
              <a:ext cx="82440" cy="360"/>
            </a:xfrm>
            <a:custGeom>
              <a:avLst/>
              <a:gdLst/>
              <a:ahLst/>
              <a:rect l="l" t="t" r="r" b="b"/>
              <a:pathLst>
                <a:path w="91439" h="1">
                  <a:moveTo>
                    <a:pt x="91439"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07" name="pl19"/>
            <p:cNvSpPr/>
            <p:nvPr/>
          </p:nvSpPr>
          <p:spPr>
            <a:xfrm>
              <a:off x="15246720" y="8499960"/>
              <a:ext cx="82440" cy="360"/>
            </a:xfrm>
            <a:custGeom>
              <a:avLst/>
              <a:gdLst/>
              <a:ahLst/>
              <a:rect l="l" t="t" r="r" b="b"/>
              <a:pathLst>
                <a:path w="91439" h="1">
                  <a:moveTo>
                    <a:pt x="91439"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08" name="pl20"/>
            <p:cNvSpPr/>
            <p:nvPr/>
          </p:nvSpPr>
          <p:spPr>
            <a:xfrm>
              <a:off x="15246720" y="7591320"/>
              <a:ext cx="82440" cy="360"/>
            </a:xfrm>
            <a:custGeom>
              <a:avLst/>
              <a:gdLst/>
              <a:ahLst/>
              <a:rect l="l" t="t" r="r" b="b"/>
              <a:pathLst>
                <a:path w="91439" h="1">
                  <a:moveTo>
                    <a:pt x="91439"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09" name="pl21"/>
            <p:cNvSpPr/>
            <p:nvPr/>
          </p:nvSpPr>
          <p:spPr>
            <a:xfrm>
              <a:off x="15246720" y="6682680"/>
              <a:ext cx="82440" cy="360"/>
            </a:xfrm>
            <a:custGeom>
              <a:avLst/>
              <a:gdLst/>
              <a:ahLst/>
              <a:rect l="l" t="t" r="r" b="b"/>
              <a:pathLst>
                <a:path w="91439" h="1">
                  <a:moveTo>
                    <a:pt x="91439"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10" name="pl22"/>
            <p:cNvSpPr/>
            <p:nvPr/>
          </p:nvSpPr>
          <p:spPr>
            <a:xfrm>
              <a:off x="15246720" y="5774400"/>
              <a:ext cx="82440" cy="360"/>
            </a:xfrm>
            <a:custGeom>
              <a:avLst/>
              <a:gdLst/>
              <a:ahLst/>
              <a:rect l="l" t="t" r="r" b="b"/>
              <a:pathLst>
                <a:path w="91439" h="1">
                  <a:moveTo>
                    <a:pt x="91439"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11" name="pl23"/>
            <p:cNvSpPr/>
            <p:nvPr/>
          </p:nvSpPr>
          <p:spPr>
            <a:xfrm>
              <a:off x="15246720" y="4865760"/>
              <a:ext cx="82440" cy="360"/>
            </a:xfrm>
            <a:custGeom>
              <a:avLst/>
              <a:gdLst/>
              <a:ahLst/>
              <a:rect l="l" t="t" r="r" b="b"/>
              <a:pathLst>
                <a:path w="91439" h="1">
                  <a:moveTo>
                    <a:pt x="91439" y="0"/>
                  </a:moveTo>
                  <a:lnTo>
                    <a:pt x="0"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12" name="tx24"/>
            <p:cNvSpPr/>
            <p:nvPr/>
          </p:nvSpPr>
          <p:spPr>
            <a:xfrm rot="16200000">
              <a:off x="14910120" y="9332640"/>
              <a:ext cx="290520" cy="15084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0</a:t>
              </a:r>
              <a:endParaRPr b="0" lang="en-US" sz="1800" spc="-1" strike="noStrike">
                <a:solidFill>
                  <a:srgbClr val="000000"/>
                </a:solidFill>
                <a:latin typeface="Arial"/>
              </a:endParaRPr>
            </a:p>
          </p:txBody>
        </p:sp>
        <p:sp>
          <p:nvSpPr>
            <p:cNvPr id="1213" name="tx25"/>
            <p:cNvSpPr/>
            <p:nvPr/>
          </p:nvSpPr>
          <p:spPr>
            <a:xfrm rot="16200000">
              <a:off x="14910120" y="8424000"/>
              <a:ext cx="290520" cy="15084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2</a:t>
              </a:r>
              <a:endParaRPr b="0" lang="en-US" sz="1800" spc="-1" strike="noStrike">
                <a:solidFill>
                  <a:srgbClr val="000000"/>
                </a:solidFill>
                <a:latin typeface="Arial"/>
              </a:endParaRPr>
            </a:p>
          </p:txBody>
        </p:sp>
        <p:sp>
          <p:nvSpPr>
            <p:cNvPr id="1214" name="tx26"/>
            <p:cNvSpPr/>
            <p:nvPr/>
          </p:nvSpPr>
          <p:spPr>
            <a:xfrm rot="16200000">
              <a:off x="14910120" y="7515360"/>
              <a:ext cx="290520" cy="15084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4</a:t>
              </a:r>
              <a:endParaRPr b="0" lang="en-US" sz="1800" spc="-1" strike="noStrike">
                <a:solidFill>
                  <a:srgbClr val="000000"/>
                </a:solidFill>
                <a:latin typeface="Arial"/>
              </a:endParaRPr>
            </a:p>
          </p:txBody>
        </p:sp>
        <p:sp>
          <p:nvSpPr>
            <p:cNvPr id="1215" name="tx27"/>
            <p:cNvSpPr/>
            <p:nvPr/>
          </p:nvSpPr>
          <p:spPr>
            <a:xfrm rot="16200000">
              <a:off x="14910120" y="6607080"/>
              <a:ext cx="290520" cy="15084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6</a:t>
              </a:r>
              <a:endParaRPr b="0" lang="en-US" sz="1800" spc="-1" strike="noStrike">
                <a:solidFill>
                  <a:srgbClr val="000000"/>
                </a:solidFill>
                <a:latin typeface="Arial"/>
              </a:endParaRPr>
            </a:p>
          </p:txBody>
        </p:sp>
        <p:sp>
          <p:nvSpPr>
            <p:cNvPr id="1216" name="tx28"/>
            <p:cNvSpPr/>
            <p:nvPr/>
          </p:nvSpPr>
          <p:spPr>
            <a:xfrm rot="16200000">
              <a:off x="14910120" y="5698440"/>
              <a:ext cx="290520" cy="15084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0.8</a:t>
              </a:r>
              <a:endParaRPr b="0" lang="en-US" sz="1800" spc="-1" strike="noStrike">
                <a:solidFill>
                  <a:srgbClr val="000000"/>
                </a:solidFill>
                <a:latin typeface="Arial"/>
              </a:endParaRPr>
            </a:p>
          </p:txBody>
        </p:sp>
        <p:sp>
          <p:nvSpPr>
            <p:cNvPr id="1217" name="tx29"/>
            <p:cNvSpPr/>
            <p:nvPr/>
          </p:nvSpPr>
          <p:spPr>
            <a:xfrm rot="16200000">
              <a:off x="14910120" y="4790160"/>
              <a:ext cx="290520" cy="15084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1.0</a:t>
              </a:r>
              <a:endParaRPr b="0" lang="en-US" sz="1800" spc="-1" strike="noStrike">
                <a:solidFill>
                  <a:srgbClr val="000000"/>
                </a:solidFill>
                <a:latin typeface="Arial"/>
              </a:endParaRPr>
            </a:p>
          </p:txBody>
        </p:sp>
        <p:sp>
          <p:nvSpPr>
            <p:cNvPr id="1218" name="tx30"/>
            <p:cNvSpPr/>
            <p:nvPr/>
          </p:nvSpPr>
          <p:spPr>
            <a:xfrm rot="16200000">
              <a:off x="13397040" y="7174080"/>
              <a:ext cx="2324160" cy="152640"/>
            </a:xfrm>
            <a:prstGeom prst="rect">
              <a:avLst/>
            </a:prstGeom>
            <a:noFill/>
            <a:ln w="0">
              <a:noFill/>
            </a:ln>
          </p:spPr>
          <p:style>
            <a:lnRef idx="0"/>
            <a:fillRef idx="0"/>
            <a:effectRef idx="0"/>
            <a:fontRef idx="minor"/>
          </p:style>
          <p:txBody>
            <a:bodyPr wrap="none" lIns="0" rIns="0" tIns="0" bIns="0" anchor="ctr" anchorCtr="1">
              <a:noAutofit/>
            </a:bodyPr>
            <a:p>
              <a:pPr>
                <a:lnSpc>
                  <a:spcPts val="1800"/>
                </a:lnSpc>
                <a:tabLst>
                  <a:tab algn="l" pos="0"/>
                  <a:tab algn="l" pos="1487520"/>
                  <a:tab algn="l" pos="2975040"/>
                  <a:tab algn="l" pos="4462560"/>
                  <a:tab algn="l" pos="5950080"/>
                  <a:tab algn="l" pos="7437600"/>
                  <a:tab algn="l" pos="8924760"/>
                  <a:tab algn="l" pos="10412280"/>
                </a:tabLst>
              </a:pPr>
              <a:r>
                <a:rPr b="0" lang="zh-CN" sz="1800" spc="-1" strike="noStrike">
                  <a:solidFill>
                    <a:srgbClr val="000000"/>
                  </a:solidFill>
                  <a:latin typeface="Arial"/>
                </a:rPr>
                <a:t>Standardized Net Benefit</a:t>
              </a:r>
              <a:endParaRPr b="0" lang="en-US" sz="1800" spc="-1" strike="noStrike">
                <a:solidFill>
                  <a:srgbClr val="000000"/>
                </a:solidFill>
                <a:latin typeface="Arial"/>
              </a:endParaRPr>
            </a:p>
          </p:txBody>
        </p:sp>
        <p:sp>
          <p:nvSpPr>
            <p:cNvPr id="1219" name="pl31"/>
            <p:cNvSpPr/>
            <p:nvPr/>
          </p:nvSpPr>
          <p:spPr>
            <a:xfrm>
              <a:off x="15535800" y="4674960"/>
              <a:ext cx="360" cy="5150880"/>
            </a:xfrm>
            <a:custGeom>
              <a:avLst/>
              <a:gdLst/>
              <a:ahLst/>
              <a:rect l="l" t="t" r="r" b="b"/>
              <a:pathLst>
                <a:path w="1" h="5632703">
                  <a:moveTo>
                    <a:pt x="0" y="5632703"/>
                  </a:moveTo>
                  <a:lnTo>
                    <a:pt x="0" y="0"/>
                  </a:lnTo>
                </a:path>
              </a:pathLst>
            </a:custGeom>
            <a:noFill/>
            <a:ln cap="rnd" w="936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20" name="pl32"/>
            <p:cNvSpPr/>
            <p:nvPr/>
          </p:nvSpPr>
          <p:spPr>
            <a:xfrm>
              <a:off x="16569720" y="4674960"/>
              <a:ext cx="360" cy="5150880"/>
            </a:xfrm>
            <a:custGeom>
              <a:avLst/>
              <a:gdLst/>
              <a:ahLst/>
              <a:rect l="l" t="t" r="r" b="b"/>
              <a:pathLst>
                <a:path w="1" h="5632703">
                  <a:moveTo>
                    <a:pt x="0" y="5632703"/>
                  </a:moveTo>
                  <a:lnTo>
                    <a:pt x="0" y="0"/>
                  </a:lnTo>
                </a:path>
              </a:pathLst>
            </a:custGeom>
            <a:noFill/>
            <a:ln cap="rnd" w="936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21" name="pl33"/>
            <p:cNvSpPr/>
            <p:nvPr/>
          </p:nvSpPr>
          <p:spPr>
            <a:xfrm>
              <a:off x="17603640" y="4674960"/>
              <a:ext cx="360" cy="5150880"/>
            </a:xfrm>
            <a:custGeom>
              <a:avLst/>
              <a:gdLst/>
              <a:ahLst/>
              <a:rect l="l" t="t" r="r" b="b"/>
              <a:pathLst>
                <a:path w="1" h="5632703">
                  <a:moveTo>
                    <a:pt x="0" y="5632703"/>
                  </a:moveTo>
                  <a:lnTo>
                    <a:pt x="0" y="0"/>
                  </a:lnTo>
                </a:path>
              </a:pathLst>
            </a:custGeom>
            <a:noFill/>
            <a:ln cap="rnd" w="936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22" name="pl34"/>
            <p:cNvSpPr/>
            <p:nvPr/>
          </p:nvSpPr>
          <p:spPr>
            <a:xfrm>
              <a:off x="18637200" y="4674960"/>
              <a:ext cx="360" cy="5150880"/>
            </a:xfrm>
            <a:custGeom>
              <a:avLst/>
              <a:gdLst/>
              <a:ahLst/>
              <a:rect l="l" t="t" r="r" b="b"/>
              <a:pathLst>
                <a:path w="1" h="5632703">
                  <a:moveTo>
                    <a:pt x="0" y="5632703"/>
                  </a:moveTo>
                  <a:lnTo>
                    <a:pt x="0" y="0"/>
                  </a:lnTo>
                </a:path>
              </a:pathLst>
            </a:custGeom>
            <a:noFill/>
            <a:ln cap="rnd" w="936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23" name="pl35"/>
            <p:cNvSpPr/>
            <p:nvPr/>
          </p:nvSpPr>
          <p:spPr>
            <a:xfrm>
              <a:off x="19671120" y="4674960"/>
              <a:ext cx="360" cy="5150880"/>
            </a:xfrm>
            <a:custGeom>
              <a:avLst/>
              <a:gdLst/>
              <a:ahLst/>
              <a:rect l="l" t="t" r="r" b="b"/>
              <a:pathLst>
                <a:path w="1" h="5632703">
                  <a:moveTo>
                    <a:pt x="0" y="5632703"/>
                  </a:moveTo>
                  <a:lnTo>
                    <a:pt x="0" y="0"/>
                  </a:lnTo>
                </a:path>
              </a:pathLst>
            </a:custGeom>
            <a:noFill/>
            <a:ln cap="rnd" w="936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24" name="pl36"/>
            <p:cNvSpPr/>
            <p:nvPr/>
          </p:nvSpPr>
          <p:spPr>
            <a:xfrm>
              <a:off x="20705040" y="4674960"/>
              <a:ext cx="360" cy="5150880"/>
            </a:xfrm>
            <a:custGeom>
              <a:avLst/>
              <a:gdLst/>
              <a:ahLst/>
              <a:rect l="l" t="t" r="r" b="b"/>
              <a:pathLst>
                <a:path w="1" h="5632703">
                  <a:moveTo>
                    <a:pt x="0" y="5632703"/>
                  </a:moveTo>
                  <a:lnTo>
                    <a:pt x="0" y="0"/>
                  </a:lnTo>
                </a:path>
              </a:pathLst>
            </a:custGeom>
            <a:noFill/>
            <a:ln cap="rnd" w="9360">
              <a:solidFill>
                <a:srgbClr val="ebebeb"/>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25" name="pl37"/>
            <p:cNvSpPr/>
            <p:nvPr/>
          </p:nvSpPr>
          <p:spPr>
            <a:xfrm>
              <a:off x="15329160" y="9408240"/>
              <a:ext cx="5582520" cy="360"/>
            </a:xfrm>
            <a:custGeom>
              <a:avLst/>
              <a:gdLst/>
              <a:ahLst/>
              <a:rect l="l" t="t" r="r" b="b"/>
              <a:pathLst>
                <a:path w="6181344" h="1">
                  <a:moveTo>
                    <a:pt x="0" y="0"/>
                  </a:moveTo>
                  <a:lnTo>
                    <a:pt x="6181344" y="0"/>
                  </a:lnTo>
                </a:path>
              </a:pathLst>
            </a:custGeom>
            <a:noFill/>
            <a:ln cap="rnd" w="936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26" name="pl38"/>
            <p:cNvSpPr/>
            <p:nvPr/>
          </p:nvSpPr>
          <p:spPr>
            <a:xfrm>
              <a:off x="15329160" y="8499960"/>
              <a:ext cx="5582520" cy="360"/>
            </a:xfrm>
            <a:custGeom>
              <a:avLst/>
              <a:gdLst/>
              <a:ahLst/>
              <a:rect l="l" t="t" r="r" b="b"/>
              <a:pathLst>
                <a:path w="6181344" h="1">
                  <a:moveTo>
                    <a:pt x="0" y="0"/>
                  </a:moveTo>
                  <a:lnTo>
                    <a:pt x="6181344" y="0"/>
                  </a:lnTo>
                </a:path>
              </a:pathLst>
            </a:custGeom>
            <a:noFill/>
            <a:ln cap="rnd" w="936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27" name="pl39"/>
            <p:cNvSpPr/>
            <p:nvPr/>
          </p:nvSpPr>
          <p:spPr>
            <a:xfrm>
              <a:off x="15329160" y="7591320"/>
              <a:ext cx="5582520" cy="360"/>
            </a:xfrm>
            <a:custGeom>
              <a:avLst/>
              <a:gdLst/>
              <a:ahLst/>
              <a:rect l="l" t="t" r="r" b="b"/>
              <a:pathLst>
                <a:path w="6181344" h="1">
                  <a:moveTo>
                    <a:pt x="0" y="0"/>
                  </a:moveTo>
                  <a:lnTo>
                    <a:pt x="6181344" y="0"/>
                  </a:lnTo>
                </a:path>
              </a:pathLst>
            </a:custGeom>
            <a:noFill/>
            <a:ln cap="rnd" w="936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28" name="pl40"/>
            <p:cNvSpPr/>
            <p:nvPr/>
          </p:nvSpPr>
          <p:spPr>
            <a:xfrm>
              <a:off x="15329160" y="6682680"/>
              <a:ext cx="5582520" cy="360"/>
            </a:xfrm>
            <a:custGeom>
              <a:avLst/>
              <a:gdLst/>
              <a:ahLst/>
              <a:rect l="l" t="t" r="r" b="b"/>
              <a:pathLst>
                <a:path w="6181344" h="1">
                  <a:moveTo>
                    <a:pt x="0" y="0"/>
                  </a:moveTo>
                  <a:lnTo>
                    <a:pt x="6181344" y="0"/>
                  </a:lnTo>
                </a:path>
              </a:pathLst>
            </a:custGeom>
            <a:noFill/>
            <a:ln cap="rnd" w="936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29" name="pl41"/>
            <p:cNvSpPr/>
            <p:nvPr/>
          </p:nvSpPr>
          <p:spPr>
            <a:xfrm>
              <a:off x="15329160" y="5774400"/>
              <a:ext cx="5582520" cy="360"/>
            </a:xfrm>
            <a:custGeom>
              <a:avLst/>
              <a:gdLst/>
              <a:ahLst/>
              <a:rect l="l" t="t" r="r" b="b"/>
              <a:pathLst>
                <a:path w="6181344" h="1">
                  <a:moveTo>
                    <a:pt x="0" y="0"/>
                  </a:moveTo>
                  <a:lnTo>
                    <a:pt x="6181344" y="0"/>
                  </a:lnTo>
                </a:path>
              </a:pathLst>
            </a:custGeom>
            <a:noFill/>
            <a:ln cap="rnd" w="936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30" name="pl42"/>
            <p:cNvSpPr/>
            <p:nvPr/>
          </p:nvSpPr>
          <p:spPr>
            <a:xfrm>
              <a:off x="15329160" y="4865760"/>
              <a:ext cx="5582520" cy="360"/>
            </a:xfrm>
            <a:custGeom>
              <a:avLst/>
              <a:gdLst/>
              <a:ahLst/>
              <a:rect l="l" t="t" r="r" b="b"/>
              <a:pathLst>
                <a:path w="6181344" h="1">
                  <a:moveTo>
                    <a:pt x="0" y="0"/>
                  </a:moveTo>
                  <a:lnTo>
                    <a:pt x="6181344" y="0"/>
                  </a:lnTo>
                </a:path>
              </a:pathLst>
            </a:custGeom>
            <a:noFill/>
            <a:ln cap="rnd" w="9360">
              <a:solidFill>
                <a:srgbClr val="ebebeb"/>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31" name="pl43"/>
            <p:cNvSpPr/>
            <p:nvPr/>
          </p:nvSpPr>
          <p:spPr>
            <a:xfrm>
              <a:off x="15535800" y="9408240"/>
              <a:ext cx="5117040" cy="360"/>
            </a:xfrm>
            <a:custGeom>
              <a:avLst/>
              <a:gdLst/>
              <a:ahLst/>
              <a:rect l="l" t="t" r="r" b="b"/>
              <a:pathLst>
                <a:path w="5666232" h="1">
                  <a:moveTo>
                    <a:pt x="0" y="0"/>
                  </a:moveTo>
                  <a:lnTo>
                    <a:pt x="57234" y="0"/>
                  </a:lnTo>
                  <a:lnTo>
                    <a:pt x="114469" y="0"/>
                  </a:lnTo>
                  <a:lnTo>
                    <a:pt x="171704" y="0"/>
                  </a:lnTo>
                  <a:lnTo>
                    <a:pt x="228938" y="0"/>
                  </a:lnTo>
                  <a:lnTo>
                    <a:pt x="286173" y="0"/>
                  </a:lnTo>
                  <a:lnTo>
                    <a:pt x="343408" y="0"/>
                  </a:lnTo>
                  <a:lnTo>
                    <a:pt x="400642" y="0"/>
                  </a:lnTo>
                  <a:lnTo>
                    <a:pt x="457877" y="0"/>
                  </a:lnTo>
                  <a:lnTo>
                    <a:pt x="515112" y="0"/>
                  </a:lnTo>
                  <a:lnTo>
                    <a:pt x="572346" y="0"/>
                  </a:lnTo>
                  <a:lnTo>
                    <a:pt x="629581" y="0"/>
                  </a:lnTo>
                  <a:lnTo>
                    <a:pt x="686816" y="0"/>
                  </a:lnTo>
                  <a:lnTo>
                    <a:pt x="744050" y="0"/>
                  </a:lnTo>
                  <a:lnTo>
                    <a:pt x="801285" y="0"/>
                  </a:lnTo>
                  <a:lnTo>
                    <a:pt x="858520" y="0"/>
                  </a:lnTo>
                  <a:lnTo>
                    <a:pt x="915754" y="0"/>
                  </a:lnTo>
                  <a:lnTo>
                    <a:pt x="972989" y="0"/>
                  </a:lnTo>
                  <a:lnTo>
                    <a:pt x="1030224" y="0"/>
                  </a:lnTo>
                  <a:lnTo>
                    <a:pt x="1087458" y="0"/>
                  </a:lnTo>
                  <a:lnTo>
                    <a:pt x="1144693" y="0"/>
                  </a:lnTo>
                  <a:lnTo>
                    <a:pt x="1201927" y="0"/>
                  </a:lnTo>
                  <a:lnTo>
                    <a:pt x="1259162" y="0"/>
                  </a:lnTo>
                  <a:lnTo>
                    <a:pt x="1316397" y="0"/>
                  </a:lnTo>
                  <a:lnTo>
                    <a:pt x="1373632" y="0"/>
                  </a:lnTo>
                  <a:lnTo>
                    <a:pt x="1430866" y="0"/>
                  </a:lnTo>
                  <a:lnTo>
                    <a:pt x="1488101" y="0"/>
                  </a:lnTo>
                  <a:lnTo>
                    <a:pt x="1545336" y="0"/>
                  </a:lnTo>
                  <a:lnTo>
                    <a:pt x="1602570" y="0"/>
                  </a:lnTo>
                  <a:lnTo>
                    <a:pt x="1659805" y="0"/>
                  </a:lnTo>
                  <a:lnTo>
                    <a:pt x="1717040" y="0"/>
                  </a:lnTo>
                  <a:lnTo>
                    <a:pt x="1774274" y="0"/>
                  </a:lnTo>
                  <a:lnTo>
                    <a:pt x="1831509" y="0"/>
                  </a:lnTo>
                  <a:lnTo>
                    <a:pt x="1888744" y="0"/>
                  </a:lnTo>
                  <a:lnTo>
                    <a:pt x="1945978" y="0"/>
                  </a:lnTo>
                  <a:lnTo>
                    <a:pt x="2003213" y="0"/>
                  </a:lnTo>
                  <a:lnTo>
                    <a:pt x="2060448" y="0"/>
                  </a:lnTo>
                  <a:lnTo>
                    <a:pt x="2117682" y="0"/>
                  </a:lnTo>
                  <a:lnTo>
                    <a:pt x="2174917" y="0"/>
                  </a:lnTo>
                  <a:lnTo>
                    <a:pt x="2232152" y="0"/>
                  </a:lnTo>
                  <a:lnTo>
                    <a:pt x="2289386" y="0"/>
                  </a:lnTo>
                  <a:lnTo>
                    <a:pt x="2346621" y="0"/>
                  </a:lnTo>
                  <a:lnTo>
                    <a:pt x="2403855" y="0"/>
                  </a:lnTo>
                  <a:lnTo>
                    <a:pt x="2461090" y="0"/>
                  </a:lnTo>
                  <a:lnTo>
                    <a:pt x="2518325" y="0"/>
                  </a:lnTo>
                  <a:lnTo>
                    <a:pt x="2575560" y="0"/>
                  </a:lnTo>
                  <a:lnTo>
                    <a:pt x="2632794" y="0"/>
                  </a:lnTo>
                  <a:lnTo>
                    <a:pt x="2690029" y="0"/>
                  </a:lnTo>
                  <a:lnTo>
                    <a:pt x="2747264" y="0"/>
                  </a:lnTo>
                  <a:lnTo>
                    <a:pt x="2804498" y="0"/>
                  </a:lnTo>
                  <a:lnTo>
                    <a:pt x="2861733" y="0"/>
                  </a:lnTo>
                  <a:lnTo>
                    <a:pt x="2918968" y="0"/>
                  </a:lnTo>
                  <a:lnTo>
                    <a:pt x="2976202" y="0"/>
                  </a:lnTo>
                  <a:lnTo>
                    <a:pt x="3033437" y="0"/>
                  </a:lnTo>
                  <a:lnTo>
                    <a:pt x="3090672" y="0"/>
                  </a:lnTo>
                  <a:lnTo>
                    <a:pt x="3147906" y="0"/>
                  </a:lnTo>
                  <a:lnTo>
                    <a:pt x="3205141" y="0"/>
                  </a:lnTo>
                  <a:lnTo>
                    <a:pt x="3262376" y="0"/>
                  </a:lnTo>
                  <a:lnTo>
                    <a:pt x="3319610" y="0"/>
                  </a:lnTo>
                  <a:lnTo>
                    <a:pt x="3376845" y="0"/>
                  </a:lnTo>
                  <a:lnTo>
                    <a:pt x="3434079" y="0"/>
                  </a:lnTo>
                  <a:lnTo>
                    <a:pt x="3491314" y="0"/>
                  </a:lnTo>
                  <a:lnTo>
                    <a:pt x="3548549" y="0"/>
                  </a:lnTo>
                  <a:lnTo>
                    <a:pt x="3605784" y="0"/>
                  </a:lnTo>
                  <a:lnTo>
                    <a:pt x="3663018" y="0"/>
                  </a:lnTo>
                  <a:lnTo>
                    <a:pt x="3720253" y="0"/>
                  </a:lnTo>
                  <a:lnTo>
                    <a:pt x="3777488" y="0"/>
                  </a:lnTo>
                  <a:lnTo>
                    <a:pt x="3834722" y="0"/>
                  </a:lnTo>
                  <a:lnTo>
                    <a:pt x="3891957" y="0"/>
                  </a:lnTo>
                  <a:lnTo>
                    <a:pt x="3949192" y="0"/>
                  </a:lnTo>
                  <a:lnTo>
                    <a:pt x="4006426" y="0"/>
                  </a:lnTo>
                  <a:lnTo>
                    <a:pt x="4063661" y="0"/>
                  </a:lnTo>
                  <a:lnTo>
                    <a:pt x="4120896" y="0"/>
                  </a:lnTo>
                  <a:lnTo>
                    <a:pt x="4178130" y="0"/>
                  </a:lnTo>
                  <a:lnTo>
                    <a:pt x="4235365" y="0"/>
                  </a:lnTo>
                  <a:lnTo>
                    <a:pt x="4292600" y="0"/>
                  </a:lnTo>
                  <a:lnTo>
                    <a:pt x="4349834" y="0"/>
                  </a:lnTo>
                  <a:lnTo>
                    <a:pt x="4407069" y="0"/>
                  </a:lnTo>
                  <a:lnTo>
                    <a:pt x="4464304" y="0"/>
                  </a:lnTo>
                  <a:lnTo>
                    <a:pt x="4521538" y="0"/>
                  </a:lnTo>
                  <a:lnTo>
                    <a:pt x="4578773" y="0"/>
                  </a:lnTo>
                  <a:lnTo>
                    <a:pt x="4636008" y="0"/>
                  </a:lnTo>
                  <a:lnTo>
                    <a:pt x="4693242" y="0"/>
                  </a:lnTo>
                  <a:lnTo>
                    <a:pt x="4750477" y="0"/>
                  </a:lnTo>
                  <a:lnTo>
                    <a:pt x="4807711" y="0"/>
                  </a:lnTo>
                  <a:lnTo>
                    <a:pt x="4864946" y="0"/>
                  </a:lnTo>
                  <a:lnTo>
                    <a:pt x="4922181" y="0"/>
                  </a:lnTo>
                  <a:lnTo>
                    <a:pt x="4979416" y="0"/>
                  </a:lnTo>
                  <a:lnTo>
                    <a:pt x="5036650" y="0"/>
                  </a:lnTo>
                  <a:lnTo>
                    <a:pt x="5093885" y="0"/>
                  </a:lnTo>
                  <a:lnTo>
                    <a:pt x="5151119" y="0"/>
                  </a:lnTo>
                  <a:lnTo>
                    <a:pt x="5208354" y="0"/>
                  </a:lnTo>
                  <a:lnTo>
                    <a:pt x="5265589" y="0"/>
                  </a:lnTo>
                  <a:lnTo>
                    <a:pt x="5322823" y="0"/>
                  </a:lnTo>
                  <a:lnTo>
                    <a:pt x="5380058" y="0"/>
                  </a:lnTo>
                  <a:lnTo>
                    <a:pt x="5437293" y="0"/>
                  </a:lnTo>
                  <a:lnTo>
                    <a:pt x="5494528" y="0"/>
                  </a:lnTo>
                  <a:lnTo>
                    <a:pt x="5551762" y="0"/>
                  </a:lnTo>
                  <a:lnTo>
                    <a:pt x="5608997" y="0"/>
                  </a:lnTo>
                  <a:lnTo>
                    <a:pt x="5666232"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32" name="pl44"/>
            <p:cNvSpPr/>
            <p:nvPr/>
          </p:nvSpPr>
          <p:spPr>
            <a:xfrm>
              <a:off x="15535800" y="4865760"/>
              <a:ext cx="2352600" cy="4960080"/>
            </a:xfrm>
            <a:custGeom>
              <a:avLst/>
              <a:gdLst/>
              <a:ahLst/>
              <a:rect l="l" t="t" r="r" b="b"/>
              <a:pathLst>
                <a:path w="2605198" h="5424085">
                  <a:moveTo>
                    <a:pt x="0" y="0"/>
                  </a:moveTo>
                  <a:lnTo>
                    <a:pt x="57234" y="65566"/>
                  </a:lnTo>
                  <a:lnTo>
                    <a:pt x="114469" y="132471"/>
                  </a:lnTo>
                  <a:lnTo>
                    <a:pt x="171704" y="200756"/>
                  </a:lnTo>
                  <a:lnTo>
                    <a:pt x="228938" y="270462"/>
                  </a:lnTo>
                  <a:lnTo>
                    <a:pt x="286173" y="341637"/>
                  </a:lnTo>
                  <a:lnTo>
                    <a:pt x="343408" y="414326"/>
                  </a:lnTo>
                  <a:lnTo>
                    <a:pt x="400642" y="488578"/>
                  </a:lnTo>
                  <a:lnTo>
                    <a:pt x="457877" y="564444"/>
                  </a:lnTo>
                  <a:lnTo>
                    <a:pt x="515112" y="641978"/>
                  </a:lnTo>
                  <a:lnTo>
                    <a:pt x="572346" y="721234"/>
                  </a:lnTo>
                  <a:lnTo>
                    <a:pt x="629581" y="802272"/>
                  </a:lnTo>
                  <a:lnTo>
                    <a:pt x="686816" y="885151"/>
                  </a:lnTo>
                  <a:lnTo>
                    <a:pt x="744050" y="969936"/>
                  </a:lnTo>
                  <a:lnTo>
                    <a:pt x="801285" y="1056692"/>
                  </a:lnTo>
                  <a:lnTo>
                    <a:pt x="858520" y="1145490"/>
                  </a:lnTo>
                  <a:lnTo>
                    <a:pt x="915754" y="1236402"/>
                  </a:lnTo>
                  <a:lnTo>
                    <a:pt x="972989" y="1329504"/>
                  </a:lnTo>
                  <a:lnTo>
                    <a:pt x="1030224" y="1424878"/>
                  </a:lnTo>
                  <a:lnTo>
                    <a:pt x="1087458" y="1522606"/>
                  </a:lnTo>
                  <a:lnTo>
                    <a:pt x="1144693" y="1622777"/>
                  </a:lnTo>
                  <a:lnTo>
                    <a:pt x="1201927" y="1725485"/>
                  </a:lnTo>
                  <a:lnTo>
                    <a:pt x="1259162" y="1830826"/>
                  </a:lnTo>
                  <a:lnTo>
                    <a:pt x="1316397" y="1938903"/>
                  </a:lnTo>
                  <a:lnTo>
                    <a:pt x="1373632" y="2049824"/>
                  </a:lnTo>
                  <a:lnTo>
                    <a:pt x="1430866" y="2163703"/>
                  </a:lnTo>
                  <a:lnTo>
                    <a:pt x="1488101" y="2280660"/>
                  </a:lnTo>
                  <a:lnTo>
                    <a:pt x="1545336" y="2400821"/>
                  </a:lnTo>
                  <a:lnTo>
                    <a:pt x="1602570" y="2524320"/>
                  </a:lnTo>
                  <a:lnTo>
                    <a:pt x="1659805" y="2651298"/>
                  </a:lnTo>
                  <a:lnTo>
                    <a:pt x="1717040" y="2781904"/>
                  </a:lnTo>
                  <a:lnTo>
                    <a:pt x="1774274" y="2916296"/>
                  </a:lnTo>
                  <a:lnTo>
                    <a:pt x="1831509" y="3054640"/>
                  </a:lnTo>
                  <a:lnTo>
                    <a:pt x="1888744" y="3197114"/>
                  </a:lnTo>
                  <a:lnTo>
                    <a:pt x="1945978" y="3343905"/>
                  </a:lnTo>
                  <a:lnTo>
                    <a:pt x="2003213" y="3495213"/>
                  </a:lnTo>
                  <a:lnTo>
                    <a:pt x="2060448" y="3651249"/>
                  </a:lnTo>
                  <a:lnTo>
                    <a:pt x="2117682" y="3812239"/>
                  </a:lnTo>
                  <a:lnTo>
                    <a:pt x="2174917" y="3978422"/>
                  </a:lnTo>
                  <a:lnTo>
                    <a:pt x="2232152" y="4150054"/>
                  </a:lnTo>
                  <a:lnTo>
                    <a:pt x="2289386" y="4327407"/>
                  </a:lnTo>
                  <a:lnTo>
                    <a:pt x="2346621" y="4510772"/>
                  </a:lnTo>
                  <a:lnTo>
                    <a:pt x="2403855" y="4700459"/>
                  </a:lnTo>
                  <a:lnTo>
                    <a:pt x="2461090" y="4896803"/>
                  </a:lnTo>
                  <a:lnTo>
                    <a:pt x="2518325" y="5100158"/>
                  </a:lnTo>
                  <a:lnTo>
                    <a:pt x="2575560" y="5310909"/>
                  </a:lnTo>
                  <a:lnTo>
                    <a:pt x="2605198" y="5424085"/>
                  </a:lnTo>
                </a:path>
              </a:pathLst>
            </a:custGeom>
            <a:noFill/>
            <a:ln cap="rnd" w="9360">
              <a:solidFill>
                <a:srgbClr val="a8a8a8"/>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33" name="pl45"/>
            <p:cNvSpPr/>
            <p:nvPr/>
          </p:nvSpPr>
          <p:spPr>
            <a:xfrm>
              <a:off x="15535800" y="4865760"/>
              <a:ext cx="5117040" cy="4800600"/>
            </a:xfrm>
            <a:custGeom>
              <a:avLst/>
              <a:gdLst/>
              <a:ahLst/>
              <a:rect l="l" t="t" r="r" b="b"/>
              <a:pathLst>
                <a:path w="5666232" h="5249333">
                  <a:moveTo>
                    <a:pt x="0" y="0"/>
                  </a:moveTo>
                  <a:lnTo>
                    <a:pt x="57234" y="65566"/>
                  </a:lnTo>
                  <a:lnTo>
                    <a:pt x="114469" y="132471"/>
                  </a:lnTo>
                  <a:lnTo>
                    <a:pt x="171704" y="200756"/>
                  </a:lnTo>
                  <a:lnTo>
                    <a:pt x="228938" y="270462"/>
                  </a:lnTo>
                  <a:lnTo>
                    <a:pt x="286173" y="341637"/>
                  </a:lnTo>
                  <a:lnTo>
                    <a:pt x="343408" y="414326"/>
                  </a:lnTo>
                  <a:lnTo>
                    <a:pt x="400642" y="488578"/>
                  </a:lnTo>
                  <a:lnTo>
                    <a:pt x="457877" y="564444"/>
                  </a:lnTo>
                  <a:lnTo>
                    <a:pt x="515112" y="641978"/>
                  </a:lnTo>
                  <a:lnTo>
                    <a:pt x="572346" y="721234"/>
                  </a:lnTo>
                  <a:lnTo>
                    <a:pt x="629581" y="802272"/>
                  </a:lnTo>
                  <a:lnTo>
                    <a:pt x="686816" y="885151"/>
                  </a:lnTo>
                  <a:lnTo>
                    <a:pt x="744050" y="969936"/>
                  </a:lnTo>
                  <a:lnTo>
                    <a:pt x="801285" y="1056692"/>
                  </a:lnTo>
                  <a:lnTo>
                    <a:pt x="858520" y="1145490"/>
                  </a:lnTo>
                  <a:lnTo>
                    <a:pt x="915754" y="1236402"/>
                  </a:lnTo>
                  <a:lnTo>
                    <a:pt x="972989" y="1160851"/>
                  </a:lnTo>
                  <a:lnTo>
                    <a:pt x="1030224" y="1223880"/>
                  </a:lnTo>
                  <a:lnTo>
                    <a:pt x="1087458" y="1288466"/>
                  </a:lnTo>
                  <a:lnTo>
                    <a:pt x="1144693" y="1354666"/>
                  </a:lnTo>
                  <a:lnTo>
                    <a:pt x="1201927" y="1422542"/>
                  </a:lnTo>
                  <a:lnTo>
                    <a:pt x="1259162" y="1492159"/>
                  </a:lnTo>
                  <a:lnTo>
                    <a:pt x="1316397" y="1563584"/>
                  </a:lnTo>
                  <a:lnTo>
                    <a:pt x="1373632" y="1636888"/>
                  </a:lnTo>
                  <a:lnTo>
                    <a:pt x="1430866" y="1712148"/>
                  </a:lnTo>
                  <a:lnTo>
                    <a:pt x="1488101" y="1789441"/>
                  </a:lnTo>
                  <a:lnTo>
                    <a:pt x="1545336" y="1868852"/>
                  </a:lnTo>
                  <a:lnTo>
                    <a:pt x="1602570" y="1950469"/>
                  </a:lnTo>
                  <a:lnTo>
                    <a:pt x="1659805" y="2034384"/>
                  </a:lnTo>
                  <a:lnTo>
                    <a:pt x="1717040" y="2120698"/>
                  </a:lnTo>
                  <a:lnTo>
                    <a:pt x="1774274" y="2209513"/>
                  </a:lnTo>
                  <a:lnTo>
                    <a:pt x="1831509" y="2300941"/>
                  </a:lnTo>
                  <a:lnTo>
                    <a:pt x="1888744" y="2395097"/>
                  </a:lnTo>
                  <a:lnTo>
                    <a:pt x="1945978" y="2492107"/>
                  </a:lnTo>
                  <a:lnTo>
                    <a:pt x="2003213" y="3087076"/>
                  </a:lnTo>
                  <a:lnTo>
                    <a:pt x="2060448" y="3146777"/>
                  </a:lnTo>
                  <a:lnTo>
                    <a:pt x="2117682" y="3026497"/>
                  </a:lnTo>
                  <a:lnTo>
                    <a:pt x="2174917" y="3069849"/>
                  </a:lnTo>
                  <a:lnTo>
                    <a:pt x="2232152" y="3114622"/>
                  </a:lnTo>
                  <a:lnTo>
                    <a:pt x="2289386" y="3160888"/>
                  </a:lnTo>
                  <a:lnTo>
                    <a:pt x="2346621" y="3208723"/>
                  </a:lnTo>
                  <a:lnTo>
                    <a:pt x="2403855" y="3258206"/>
                  </a:lnTo>
                  <a:lnTo>
                    <a:pt x="2461090" y="3309426"/>
                  </a:lnTo>
                  <a:lnTo>
                    <a:pt x="2518325" y="3362476"/>
                  </a:lnTo>
                  <a:lnTo>
                    <a:pt x="2575560" y="3417454"/>
                  </a:lnTo>
                  <a:lnTo>
                    <a:pt x="2632794" y="3474469"/>
                  </a:lnTo>
                  <a:lnTo>
                    <a:pt x="2690029" y="3533635"/>
                  </a:lnTo>
                  <a:lnTo>
                    <a:pt x="2747264" y="3595076"/>
                  </a:lnTo>
                  <a:lnTo>
                    <a:pt x="2804498" y="3658928"/>
                  </a:lnTo>
                  <a:lnTo>
                    <a:pt x="2861733" y="3725333"/>
                  </a:lnTo>
                  <a:lnTo>
                    <a:pt x="2918968" y="3794448"/>
                  </a:lnTo>
                  <a:lnTo>
                    <a:pt x="2976202" y="3866444"/>
                  </a:lnTo>
                  <a:lnTo>
                    <a:pt x="3033437" y="3941503"/>
                  </a:lnTo>
                  <a:lnTo>
                    <a:pt x="3090672" y="4019826"/>
                  </a:lnTo>
                  <a:lnTo>
                    <a:pt x="3147906" y="4101629"/>
                  </a:lnTo>
                  <a:lnTo>
                    <a:pt x="3205141" y="4187151"/>
                  </a:lnTo>
                  <a:lnTo>
                    <a:pt x="3262376" y="4276651"/>
                  </a:lnTo>
                  <a:lnTo>
                    <a:pt x="3319610" y="4370412"/>
                  </a:lnTo>
                  <a:lnTo>
                    <a:pt x="3376845" y="3995165"/>
                  </a:lnTo>
                  <a:lnTo>
                    <a:pt x="3434079" y="4063999"/>
                  </a:lnTo>
                  <a:lnTo>
                    <a:pt x="3491314" y="4561868"/>
                  </a:lnTo>
                  <a:lnTo>
                    <a:pt x="3548549" y="4580912"/>
                  </a:lnTo>
                  <a:lnTo>
                    <a:pt x="3605784" y="4600984"/>
                  </a:lnTo>
                  <a:lnTo>
                    <a:pt x="3663018" y="4622172"/>
                  </a:lnTo>
                  <a:lnTo>
                    <a:pt x="3720253" y="4644571"/>
                  </a:lnTo>
                  <a:lnTo>
                    <a:pt x="3777488" y="4668287"/>
                  </a:lnTo>
                  <a:lnTo>
                    <a:pt x="3834722" y="4693441"/>
                  </a:lnTo>
                  <a:lnTo>
                    <a:pt x="3891957" y="4720166"/>
                  </a:lnTo>
                  <a:lnTo>
                    <a:pt x="3949192" y="4748616"/>
                  </a:lnTo>
                  <a:lnTo>
                    <a:pt x="4006426" y="4778962"/>
                  </a:lnTo>
                  <a:lnTo>
                    <a:pt x="4063661" y="4811402"/>
                  </a:lnTo>
                  <a:lnTo>
                    <a:pt x="4120896" y="4846158"/>
                  </a:lnTo>
                  <a:lnTo>
                    <a:pt x="4178130" y="4883489"/>
                  </a:lnTo>
                  <a:lnTo>
                    <a:pt x="4235365" y="4923692"/>
                  </a:lnTo>
                  <a:lnTo>
                    <a:pt x="4292600" y="4967111"/>
                  </a:lnTo>
                  <a:lnTo>
                    <a:pt x="4349834" y="5014148"/>
                  </a:lnTo>
                  <a:lnTo>
                    <a:pt x="4407069" y="5065275"/>
                  </a:lnTo>
                  <a:lnTo>
                    <a:pt x="4464304" y="5121050"/>
                  </a:lnTo>
                  <a:lnTo>
                    <a:pt x="4521538" y="5182137"/>
                  </a:lnTo>
                  <a:lnTo>
                    <a:pt x="4578773" y="5249333"/>
                  </a:lnTo>
                  <a:lnTo>
                    <a:pt x="4636008" y="4967111"/>
                  </a:lnTo>
                  <a:lnTo>
                    <a:pt x="4693242" y="4967111"/>
                  </a:lnTo>
                  <a:lnTo>
                    <a:pt x="4750477" y="4967111"/>
                  </a:lnTo>
                  <a:lnTo>
                    <a:pt x="4807711" y="4967111"/>
                  </a:lnTo>
                  <a:lnTo>
                    <a:pt x="4864946" y="4967111"/>
                  </a:lnTo>
                  <a:lnTo>
                    <a:pt x="4922181" y="4967111"/>
                  </a:lnTo>
                  <a:lnTo>
                    <a:pt x="4979416" y="4967111"/>
                  </a:lnTo>
                  <a:lnTo>
                    <a:pt x="5036650" y="4967111"/>
                  </a:lnTo>
                  <a:lnTo>
                    <a:pt x="5093885" y="4967111"/>
                  </a:lnTo>
                  <a:lnTo>
                    <a:pt x="5151119" y="4967111"/>
                  </a:lnTo>
                  <a:lnTo>
                    <a:pt x="5208354" y="4967111"/>
                  </a:lnTo>
                  <a:lnTo>
                    <a:pt x="5265589" y="4967111"/>
                  </a:lnTo>
                  <a:lnTo>
                    <a:pt x="5322823" y="4967111"/>
                  </a:lnTo>
                  <a:lnTo>
                    <a:pt x="5380058" y="4967111"/>
                  </a:lnTo>
                  <a:lnTo>
                    <a:pt x="5437293" y="4967111"/>
                  </a:lnTo>
                  <a:lnTo>
                    <a:pt x="5494528" y="4967111"/>
                  </a:lnTo>
                  <a:lnTo>
                    <a:pt x="5551762" y="4967111"/>
                  </a:lnTo>
                  <a:lnTo>
                    <a:pt x="5608997" y="4967111"/>
                  </a:lnTo>
                  <a:lnTo>
                    <a:pt x="5666232" y="4967111"/>
                  </a:lnTo>
                </a:path>
              </a:pathLst>
            </a:custGeom>
            <a:noFill/>
            <a:ln cap="rnd" w="11520">
              <a:solidFill>
                <a:srgbClr val="cc0000"/>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34" name="pl46"/>
            <p:cNvSpPr/>
            <p:nvPr/>
          </p:nvSpPr>
          <p:spPr>
            <a:xfrm>
              <a:off x="15535800" y="4865760"/>
              <a:ext cx="5117040" cy="4490640"/>
            </a:xfrm>
            <a:custGeom>
              <a:avLst/>
              <a:gdLst/>
              <a:ahLst/>
              <a:rect l="l" t="t" r="r" b="b"/>
              <a:pathLst>
                <a:path w="5666232" h="4910666">
                  <a:moveTo>
                    <a:pt x="0" y="0"/>
                  </a:moveTo>
                  <a:lnTo>
                    <a:pt x="57234" y="65566"/>
                  </a:lnTo>
                  <a:lnTo>
                    <a:pt x="114469" y="132471"/>
                  </a:lnTo>
                  <a:lnTo>
                    <a:pt x="171704" y="200756"/>
                  </a:lnTo>
                  <a:lnTo>
                    <a:pt x="228938" y="270462"/>
                  </a:lnTo>
                  <a:lnTo>
                    <a:pt x="286173" y="341637"/>
                  </a:lnTo>
                  <a:lnTo>
                    <a:pt x="343408" y="414326"/>
                  </a:lnTo>
                  <a:lnTo>
                    <a:pt x="400642" y="488578"/>
                  </a:lnTo>
                  <a:lnTo>
                    <a:pt x="457877" y="564444"/>
                  </a:lnTo>
                  <a:lnTo>
                    <a:pt x="515112" y="641978"/>
                  </a:lnTo>
                  <a:lnTo>
                    <a:pt x="572346" y="721234"/>
                  </a:lnTo>
                  <a:lnTo>
                    <a:pt x="629581" y="802272"/>
                  </a:lnTo>
                  <a:lnTo>
                    <a:pt x="686816" y="885151"/>
                  </a:lnTo>
                  <a:lnTo>
                    <a:pt x="744050" y="961501"/>
                  </a:lnTo>
                  <a:lnTo>
                    <a:pt x="801285" y="975307"/>
                  </a:lnTo>
                  <a:lnTo>
                    <a:pt x="858520" y="1135529"/>
                  </a:lnTo>
                  <a:lnTo>
                    <a:pt x="915754" y="1169206"/>
                  </a:lnTo>
                  <a:lnTo>
                    <a:pt x="972989" y="1221376"/>
                  </a:lnTo>
                  <a:lnTo>
                    <a:pt x="1030224" y="1247284"/>
                  </a:lnTo>
                  <a:lnTo>
                    <a:pt x="1087458" y="1307978"/>
                  </a:lnTo>
                  <a:lnTo>
                    <a:pt x="1144693" y="1354666"/>
                  </a:lnTo>
                  <a:lnTo>
                    <a:pt x="1201927" y="1414683"/>
                  </a:lnTo>
                  <a:lnTo>
                    <a:pt x="1259162" y="1490712"/>
                  </a:lnTo>
                  <a:lnTo>
                    <a:pt x="1316397" y="1591440"/>
                  </a:lnTo>
                  <a:lnTo>
                    <a:pt x="1373632" y="1690362"/>
                  </a:lnTo>
                  <a:lnTo>
                    <a:pt x="1430866" y="1768592"/>
                  </a:lnTo>
                  <a:lnTo>
                    <a:pt x="1488101" y="1826054"/>
                  </a:lnTo>
                  <a:lnTo>
                    <a:pt x="1545336" y="1912925"/>
                  </a:lnTo>
                  <a:lnTo>
                    <a:pt x="1602570" y="1912839"/>
                  </a:lnTo>
                  <a:lnTo>
                    <a:pt x="1659805" y="2014510"/>
                  </a:lnTo>
                  <a:lnTo>
                    <a:pt x="1717040" y="2177142"/>
                  </a:lnTo>
                  <a:lnTo>
                    <a:pt x="1774274" y="2247143"/>
                  </a:lnTo>
                  <a:lnTo>
                    <a:pt x="1831509" y="2287660"/>
                  </a:lnTo>
                  <a:lnTo>
                    <a:pt x="1888744" y="2238401"/>
                  </a:lnTo>
                  <a:lnTo>
                    <a:pt x="1945978" y="2579340"/>
                  </a:lnTo>
                  <a:lnTo>
                    <a:pt x="2003213" y="2609470"/>
                  </a:lnTo>
                  <a:lnTo>
                    <a:pt x="2060448" y="2607027"/>
                  </a:lnTo>
                  <a:lnTo>
                    <a:pt x="2117682" y="2657368"/>
                  </a:lnTo>
                  <a:lnTo>
                    <a:pt x="2174917" y="2738465"/>
                  </a:lnTo>
                  <a:lnTo>
                    <a:pt x="2232152" y="2798163"/>
                  </a:lnTo>
                  <a:lnTo>
                    <a:pt x="2289386" y="2822222"/>
                  </a:lnTo>
                  <a:lnTo>
                    <a:pt x="2346621" y="3070960"/>
                  </a:lnTo>
                  <a:lnTo>
                    <a:pt x="2403855" y="3246528"/>
                  </a:lnTo>
                  <a:lnTo>
                    <a:pt x="2461090" y="3395578"/>
                  </a:lnTo>
                  <a:lnTo>
                    <a:pt x="2518325" y="3382634"/>
                  </a:lnTo>
                  <a:lnTo>
                    <a:pt x="2575560" y="3453373"/>
                  </a:lnTo>
                  <a:lnTo>
                    <a:pt x="2632794" y="3426386"/>
                  </a:lnTo>
                  <a:lnTo>
                    <a:pt x="2690029" y="3552805"/>
                  </a:lnTo>
                  <a:lnTo>
                    <a:pt x="2747264" y="3399692"/>
                  </a:lnTo>
                  <a:lnTo>
                    <a:pt x="2804498" y="3396627"/>
                  </a:lnTo>
                  <a:lnTo>
                    <a:pt x="2861733" y="3386666"/>
                  </a:lnTo>
                  <a:lnTo>
                    <a:pt x="2918968" y="3369387"/>
                  </a:lnTo>
                  <a:lnTo>
                    <a:pt x="2976202" y="3579518"/>
                  </a:lnTo>
                  <a:lnTo>
                    <a:pt x="3033437" y="3614846"/>
                  </a:lnTo>
                  <a:lnTo>
                    <a:pt x="3090672" y="3656618"/>
                  </a:lnTo>
                  <a:lnTo>
                    <a:pt x="3147906" y="3687703"/>
                  </a:lnTo>
                  <a:lnTo>
                    <a:pt x="3205141" y="3715070"/>
                  </a:lnTo>
                  <a:lnTo>
                    <a:pt x="3262376" y="3869726"/>
                  </a:lnTo>
                  <a:lnTo>
                    <a:pt x="3319610" y="4082814"/>
                  </a:lnTo>
                  <a:lnTo>
                    <a:pt x="3376845" y="4103924"/>
                  </a:lnTo>
                  <a:lnTo>
                    <a:pt x="3434079" y="4120444"/>
                  </a:lnTo>
                  <a:lnTo>
                    <a:pt x="3491314" y="3987293"/>
                  </a:lnTo>
                  <a:lnTo>
                    <a:pt x="3548549" y="4081824"/>
                  </a:lnTo>
                  <a:lnTo>
                    <a:pt x="3605784" y="4195195"/>
                  </a:lnTo>
                  <a:lnTo>
                    <a:pt x="3663018" y="4132987"/>
                  </a:lnTo>
                  <a:lnTo>
                    <a:pt x="3720253" y="4225269"/>
                  </a:lnTo>
                  <a:lnTo>
                    <a:pt x="3777488" y="4263215"/>
                  </a:lnTo>
                  <a:lnTo>
                    <a:pt x="3834722" y="4416350"/>
                  </a:lnTo>
                  <a:lnTo>
                    <a:pt x="3891957" y="4219222"/>
                  </a:lnTo>
                  <a:lnTo>
                    <a:pt x="3949192" y="4253362"/>
                  </a:lnTo>
                  <a:lnTo>
                    <a:pt x="4006426" y="4289777"/>
                  </a:lnTo>
                  <a:lnTo>
                    <a:pt x="4063661" y="4385149"/>
                  </a:lnTo>
                  <a:lnTo>
                    <a:pt x="4120896" y="4281714"/>
                  </a:lnTo>
                  <a:lnTo>
                    <a:pt x="4178130" y="4375489"/>
                  </a:lnTo>
                  <a:lnTo>
                    <a:pt x="4235365" y="4311487"/>
                  </a:lnTo>
                  <a:lnTo>
                    <a:pt x="4292600" y="4402666"/>
                  </a:lnTo>
                  <a:lnTo>
                    <a:pt x="4349834" y="4261555"/>
                  </a:lnTo>
                  <a:lnTo>
                    <a:pt x="4407069" y="4348676"/>
                  </a:lnTo>
                  <a:lnTo>
                    <a:pt x="4464304" y="4382141"/>
                  </a:lnTo>
                  <a:lnTo>
                    <a:pt x="4521538" y="4475238"/>
                  </a:lnTo>
                  <a:lnTo>
                    <a:pt x="4578773" y="4346222"/>
                  </a:lnTo>
                  <a:lnTo>
                    <a:pt x="4636008" y="4488818"/>
                  </a:lnTo>
                  <a:lnTo>
                    <a:pt x="4693242" y="4321135"/>
                  </a:lnTo>
                  <a:lnTo>
                    <a:pt x="4750477" y="4508915"/>
                  </a:lnTo>
                  <a:lnTo>
                    <a:pt x="4807711" y="4529666"/>
                  </a:lnTo>
                  <a:lnTo>
                    <a:pt x="4864946" y="4553185"/>
                  </a:lnTo>
                  <a:lnTo>
                    <a:pt x="4922181" y="4580063"/>
                  </a:lnTo>
                  <a:lnTo>
                    <a:pt x="4979416" y="4289777"/>
                  </a:lnTo>
                  <a:lnTo>
                    <a:pt x="5036650" y="4289777"/>
                  </a:lnTo>
                  <a:lnTo>
                    <a:pt x="5093885" y="4346222"/>
                  </a:lnTo>
                  <a:lnTo>
                    <a:pt x="5151119" y="4346222"/>
                  </a:lnTo>
                  <a:lnTo>
                    <a:pt x="5208354" y="4346222"/>
                  </a:lnTo>
                  <a:lnTo>
                    <a:pt x="5265589" y="4402666"/>
                  </a:lnTo>
                  <a:lnTo>
                    <a:pt x="5322823" y="4459111"/>
                  </a:lnTo>
                  <a:lnTo>
                    <a:pt x="5380058" y="4515555"/>
                  </a:lnTo>
                  <a:lnTo>
                    <a:pt x="5437293" y="4515555"/>
                  </a:lnTo>
                  <a:lnTo>
                    <a:pt x="5494528" y="4684888"/>
                  </a:lnTo>
                  <a:lnTo>
                    <a:pt x="5551762" y="4741333"/>
                  </a:lnTo>
                  <a:lnTo>
                    <a:pt x="5608997" y="4741333"/>
                  </a:lnTo>
                  <a:lnTo>
                    <a:pt x="5666232" y="4910666"/>
                  </a:lnTo>
                </a:path>
              </a:pathLst>
            </a:custGeom>
            <a:noFill/>
            <a:ln cap="rnd" w="11520">
              <a:solidFill>
                <a:srgbClr val="00cccc"/>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35" name="rc47"/>
            <p:cNvSpPr/>
            <p:nvPr/>
          </p:nvSpPr>
          <p:spPr>
            <a:xfrm>
              <a:off x="19859400" y="4674960"/>
              <a:ext cx="1352160" cy="1317240"/>
            </a:xfrm>
            <a:prstGeom prst="rect">
              <a:avLst/>
            </a:prstGeom>
            <a:solidFill>
              <a:srgbClr val="ffffff"/>
            </a:solidFill>
            <a:ln cap="rnd" w="9360">
              <a:solidFill>
                <a:srgbClr val="000000"/>
              </a:solidFill>
              <a:round/>
            </a:ln>
          </p:spPr>
          <p:style>
            <a:lnRef idx="0"/>
            <a:fillRef idx="0"/>
            <a:effectRef idx="0"/>
            <a:fontRef idx="minor"/>
          </p:style>
          <p:txBody>
            <a:bodyPr lIns="90000" rIns="90000" tIns="46800" bIns="4680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36" name="pl48"/>
            <p:cNvSpPr/>
            <p:nvPr/>
          </p:nvSpPr>
          <p:spPr>
            <a:xfrm>
              <a:off x="19969200" y="4938480"/>
              <a:ext cx="219600" cy="360"/>
            </a:xfrm>
            <a:custGeom>
              <a:avLst/>
              <a:gdLst/>
              <a:ahLst/>
              <a:rect l="l" t="t" r="r" b="b"/>
              <a:pathLst>
                <a:path w="243546" h="1">
                  <a:moveTo>
                    <a:pt x="0" y="0"/>
                  </a:moveTo>
                  <a:lnTo>
                    <a:pt x="243546" y="0"/>
                  </a:lnTo>
                </a:path>
              </a:pathLst>
            </a:custGeom>
            <a:noFill/>
            <a:ln cap="rnd" w="11520">
              <a:solidFill>
                <a:srgbClr val="cc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37" name="pl49"/>
            <p:cNvSpPr/>
            <p:nvPr/>
          </p:nvSpPr>
          <p:spPr>
            <a:xfrm>
              <a:off x="19969200" y="5202000"/>
              <a:ext cx="219600" cy="360"/>
            </a:xfrm>
            <a:custGeom>
              <a:avLst/>
              <a:gdLst/>
              <a:ahLst/>
              <a:rect l="l" t="t" r="r" b="b"/>
              <a:pathLst>
                <a:path w="243546" h="1">
                  <a:moveTo>
                    <a:pt x="0" y="0"/>
                  </a:moveTo>
                  <a:lnTo>
                    <a:pt x="243546" y="0"/>
                  </a:lnTo>
                </a:path>
              </a:pathLst>
            </a:custGeom>
            <a:noFill/>
            <a:ln cap="rnd" w="11520">
              <a:solidFill>
                <a:srgbClr val="00cccc"/>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38" name="pl50"/>
            <p:cNvSpPr/>
            <p:nvPr/>
          </p:nvSpPr>
          <p:spPr>
            <a:xfrm>
              <a:off x="19969200" y="5465520"/>
              <a:ext cx="219600" cy="360"/>
            </a:xfrm>
            <a:custGeom>
              <a:avLst/>
              <a:gdLst/>
              <a:ahLst/>
              <a:rect l="l" t="t" r="r" b="b"/>
              <a:pathLst>
                <a:path w="243546" h="1">
                  <a:moveTo>
                    <a:pt x="0" y="0"/>
                  </a:moveTo>
                  <a:lnTo>
                    <a:pt x="243546" y="0"/>
                  </a:lnTo>
                </a:path>
              </a:pathLst>
            </a:custGeom>
            <a:noFill/>
            <a:ln cap="rnd" w="9360">
              <a:solidFill>
                <a:srgbClr val="a8a8a8"/>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39" name="pl51"/>
            <p:cNvSpPr/>
            <p:nvPr/>
          </p:nvSpPr>
          <p:spPr>
            <a:xfrm>
              <a:off x="19969200" y="5729040"/>
              <a:ext cx="219600" cy="360"/>
            </a:xfrm>
            <a:custGeom>
              <a:avLst/>
              <a:gdLst/>
              <a:ahLst/>
              <a:rect l="l" t="t" r="r" b="b"/>
              <a:pathLst>
                <a:path w="243546" h="1">
                  <a:moveTo>
                    <a:pt x="0" y="0"/>
                  </a:moveTo>
                  <a:lnTo>
                    <a:pt x="243546" y="0"/>
                  </a:lnTo>
                </a:path>
              </a:pathLst>
            </a:custGeom>
            <a:noFill/>
            <a:ln cap="rnd" w="9360">
              <a:solidFill>
                <a:srgbClr val="000000"/>
              </a:solidFill>
              <a:round/>
            </a:ln>
          </p:spPr>
          <p:style>
            <a:lnRef idx="0"/>
            <a:fillRef idx="0"/>
            <a:effectRef idx="0"/>
            <a:fontRef idx="minor"/>
          </p:style>
          <p:txBody>
            <a:bodyPr lIns="90000" rIns="90000" tIns="-46440" bIns="-46440" anchor="t">
              <a:noAutofit/>
            </a:bodyPr>
            <a:p>
              <a:pPr>
                <a:tabLst>
                  <a:tab algn="l" pos="0"/>
                  <a:tab algn="l" pos="1487520"/>
                  <a:tab algn="l" pos="2975040"/>
                  <a:tab algn="l" pos="4462560"/>
                  <a:tab algn="l" pos="5950080"/>
                  <a:tab algn="l" pos="7437600"/>
                  <a:tab algn="l" pos="8924760"/>
                  <a:tab algn="l" pos="10412280"/>
                </a:tabLst>
              </a:pPr>
              <a:endParaRPr b="0" lang="en-US" sz="3000" spc="-1" strike="noStrike">
                <a:solidFill>
                  <a:srgbClr val="000000"/>
                </a:solidFill>
                <a:latin typeface="Arial"/>
              </a:endParaRPr>
            </a:p>
          </p:txBody>
        </p:sp>
        <p:sp>
          <p:nvSpPr>
            <p:cNvPr id="1240" name="tx52"/>
            <p:cNvSpPr/>
            <p:nvPr/>
          </p:nvSpPr>
          <p:spPr>
            <a:xfrm>
              <a:off x="20299320" y="4886640"/>
              <a:ext cx="634680" cy="10152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zh-CN" sz="1200" spc="-1" strike="noStrike">
                  <a:solidFill>
                    <a:srgbClr val="000000"/>
                  </a:solidFill>
                  <a:latin typeface="Arial"/>
                </a:rPr>
                <a:t>Model 1se</a:t>
              </a:r>
              <a:endParaRPr b="0" lang="en-US" sz="1200" spc="-1" strike="noStrike">
                <a:solidFill>
                  <a:srgbClr val="000000"/>
                </a:solidFill>
                <a:latin typeface="Arial"/>
              </a:endParaRPr>
            </a:p>
          </p:txBody>
        </p:sp>
        <p:sp>
          <p:nvSpPr>
            <p:cNvPr id="1241" name="tx53"/>
            <p:cNvSpPr/>
            <p:nvPr/>
          </p:nvSpPr>
          <p:spPr>
            <a:xfrm>
              <a:off x="20299320" y="5150520"/>
              <a:ext cx="634680" cy="10116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zh-CN" sz="1200" spc="-1" strike="noStrike">
                  <a:solidFill>
                    <a:srgbClr val="000000"/>
                  </a:solidFill>
                  <a:latin typeface="Arial"/>
                </a:rPr>
                <a:t>Model min</a:t>
              </a:r>
              <a:endParaRPr b="0" lang="en-US" sz="1200" spc="-1" strike="noStrike">
                <a:solidFill>
                  <a:srgbClr val="000000"/>
                </a:solidFill>
                <a:latin typeface="Arial"/>
              </a:endParaRPr>
            </a:p>
          </p:txBody>
        </p:sp>
        <p:sp>
          <p:nvSpPr>
            <p:cNvPr id="1242" name="tx54"/>
            <p:cNvSpPr/>
            <p:nvPr/>
          </p:nvSpPr>
          <p:spPr>
            <a:xfrm>
              <a:off x="20299320" y="5415480"/>
              <a:ext cx="152640" cy="9972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zh-CN" sz="1200" spc="-1" strike="noStrike">
                  <a:solidFill>
                    <a:srgbClr val="000000"/>
                  </a:solidFill>
                  <a:latin typeface="Arial"/>
                </a:rPr>
                <a:t>All</a:t>
              </a:r>
              <a:endParaRPr b="0" lang="en-US" sz="1200" spc="-1" strike="noStrike">
                <a:solidFill>
                  <a:srgbClr val="000000"/>
                </a:solidFill>
                <a:latin typeface="Arial"/>
              </a:endParaRPr>
            </a:p>
          </p:txBody>
        </p:sp>
        <p:sp>
          <p:nvSpPr>
            <p:cNvPr id="1243" name="tx55"/>
            <p:cNvSpPr/>
            <p:nvPr/>
          </p:nvSpPr>
          <p:spPr>
            <a:xfrm>
              <a:off x="20299320" y="5677560"/>
              <a:ext cx="328680" cy="10116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zh-CN" sz="1200" spc="-1" strike="noStrike">
                  <a:solidFill>
                    <a:srgbClr val="000000"/>
                  </a:solidFill>
                  <a:latin typeface="Arial"/>
                </a:rPr>
                <a:t>None</a:t>
              </a:r>
              <a:endParaRPr b="0" lang="en-US" sz="1200" spc="-1" strike="noStrike">
                <a:solidFill>
                  <a:srgbClr val="000000"/>
                </a:solidFill>
                <a:latin typeface="Arial"/>
              </a:endParaRPr>
            </a:p>
          </p:txBody>
        </p:sp>
        <p:sp>
          <p:nvSpPr>
            <p:cNvPr id="1244" name="tx56"/>
            <p:cNvSpPr/>
            <p:nvPr/>
          </p:nvSpPr>
          <p:spPr>
            <a:xfrm>
              <a:off x="17500680" y="10332720"/>
              <a:ext cx="1239120" cy="128880"/>
            </a:xfrm>
            <a:prstGeom prst="rect">
              <a:avLst/>
            </a:prstGeom>
            <a:noFill/>
            <a:ln w="0">
              <a:noFill/>
            </a:ln>
          </p:spPr>
          <p:style>
            <a:lnRef idx="0"/>
            <a:fillRef idx="0"/>
            <a:effectRef idx="0"/>
            <a:fontRef idx="minor"/>
          </p:style>
          <p:txBody>
            <a:bodyPr wrap="none" lIns="0" rIns="0" tIns="0" bIns="0" anchor="ctr" anchorCtr="1">
              <a:noAutofit/>
            </a:bodyPr>
            <a:p>
              <a:pPr>
                <a:lnSpc>
                  <a:spcPts val="1199"/>
                </a:lnSpc>
                <a:tabLst>
                  <a:tab algn="l" pos="0"/>
                  <a:tab algn="l" pos="1487520"/>
                  <a:tab algn="l" pos="2975040"/>
                  <a:tab algn="l" pos="4462560"/>
                  <a:tab algn="l" pos="5950080"/>
                  <a:tab algn="l" pos="7437600"/>
                  <a:tab algn="l" pos="8924760"/>
                  <a:tab algn="l" pos="10412280"/>
                </a:tabLst>
              </a:pPr>
              <a:r>
                <a:rPr b="0" lang="zh-CN" sz="1200" spc="-1" strike="noStrike">
                  <a:solidFill>
                    <a:srgbClr val="000000"/>
                  </a:solidFill>
                  <a:latin typeface="Arial"/>
                </a:rPr>
                <a:t>High Risk Threshold</a:t>
              </a:r>
              <a:endParaRPr b="0" lang="en-US" sz="1200" spc="-1" strike="noStrike">
                <a:solidFill>
                  <a:srgbClr val="000000"/>
                </a:solidFill>
                <a:latin typeface="Arial"/>
              </a:endParaRPr>
            </a:p>
          </p:txBody>
        </p:sp>
      </p:grpSp>
      <p:sp>
        <p:nvSpPr>
          <p:cNvPr id="1245" name="文本框 169"/>
          <p:cNvSpPr/>
          <p:nvPr/>
        </p:nvSpPr>
        <p:spPr>
          <a:xfrm>
            <a:off x="131760" y="3564000"/>
            <a:ext cx="939960" cy="55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1487520"/>
                <a:tab algn="l" pos="2975040"/>
                <a:tab algn="l" pos="4462560"/>
                <a:tab algn="l" pos="5950080"/>
                <a:tab algn="l" pos="7437600"/>
                <a:tab algn="l" pos="8924760"/>
                <a:tab algn="l" pos="10412280"/>
              </a:tabLst>
            </a:pPr>
            <a:r>
              <a:rPr b="1" lang="en-US" sz="3000" spc="-1" strike="noStrike">
                <a:solidFill>
                  <a:srgbClr val="000000"/>
                </a:solidFill>
                <a:latin typeface="Times New Roman"/>
              </a:rPr>
              <a:t>A</a:t>
            </a:r>
            <a:endParaRPr b="0" lang="en-US" sz="3000" spc="-1" strike="noStrike">
              <a:solidFill>
                <a:srgbClr val="000000"/>
              </a:solidFill>
              <a:latin typeface="Arial"/>
            </a:endParaRPr>
          </a:p>
        </p:txBody>
      </p:sp>
      <p:sp>
        <p:nvSpPr>
          <p:cNvPr id="1246" name="文本框 170"/>
          <p:cNvSpPr/>
          <p:nvPr/>
        </p:nvSpPr>
        <p:spPr>
          <a:xfrm>
            <a:off x="7419960" y="3564000"/>
            <a:ext cx="939960" cy="55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1487520"/>
                <a:tab algn="l" pos="2975040"/>
                <a:tab algn="l" pos="4462560"/>
                <a:tab algn="l" pos="5950080"/>
                <a:tab algn="l" pos="7437600"/>
                <a:tab algn="l" pos="8924760"/>
                <a:tab algn="l" pos="10412280"/>
              </a:tabLst>
            </a:pPr>
            <a:r>
              <a:rPr b="1" lang="en-US" sz="3000" spc="-1" strike="noStrike">
                <a:solidFill>
                  <a:srgbClr val="000000"/>
                </a:solidFill>
                <a:latin typeface="Times New Roman"/>
              </a:rPr>
              <a:t>B</a:t>
            </a:r>
            <a:endParaRPr b="0" lang="en-US" sz="3000" spc="-1" strike="noStrike">
              <a:solidFill>
                <a:srgbClr val="000000"/>
              </a:solidFill>
              <a:latin typeface="Arial"/>
            </a:endParaRPr>
          </a:p>
        </p:txBody>
      </p:sp>
      <p:sp>
        <p:nvSpPr>
          <p:cNvPr id="1247" name="文本框 171"/>
          <p:cNvSpPr/>
          <p:nvPr/>
        </p:nvSpPr>
        <p:spPr>
          <a:xfrm>
            <a:off x="14347800" y="3603600"/>
            <a:ext cx="939960" cy="55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1487520"/>
                <a:tab algn="l" pos="2975040"/>
                <a:tab algn="l" pos="4462560"/>
                <a:tab algn="l" pos="5950080"/>
                <a:tab algn="l" pos="7437600"/>
                <a:tab algn="l" pos="8924760"/>
                <a:tab algn="l" pos="10412280"/>
              </a:tabLst>
            </a:pPr>
            <a:r>
              <a:rPr b="1" lang="en-US" sz="3000" spc="-1" strike="noStrike">
                <a:solidFill>
                  <a:srgbClr val="000000"/>
                </a:solidFill>
                <a:latin typeface="Times New Roman"/>
              </a:rPr>
              <a:t>C</a:t>
            </a:r>
            <a:endParaRPr b="0" lang="en-US" sz="3000" spc="-1" strike="noStrike">
              <a:solidFill>
                <a:srgbClr val="000000"/>
              </a:solidFill>
              <a:latin typeface="Arial"/>
            </a:endParaRPr>
          </a:p>
        </p:txBody>
      </p:sp>
      <p:sp>
        <p:nvSpPr>
          <p:cNvPr id="1248" name="文本框 173"/>
          <p:cNvSpPr/>
          <p:nvPr/>
        </p:nvSpPr>
        <p:spPr>
          <a:xfrm>
            <a:off x="206280" y="2935440"/>
            <a:ext cx="2152800" cy="55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1487520"/>
                <a:tab algn="l" pos="2975040"/>
                <a:tab algn="l" pos="4462560"/>
                <a:tab algn="l" pos="5950080"/>
                <a:tab algn="l" pos="7437600"/>
                <a:tab algn="l" pos="8924760"/>
                <a:tab algn="l" pos="10412280"/>
              </a:tabLst>
            </a:pPr>
            <a:r>
              <a:rPr b="1" lang="en-US" sz="3000" spc="-1" strike="noStrike">
                <a:solidFill>
                  <a:srgbClr val="000000"/>
                </a:solidFill>
                <a:latin typeface="Times New Roman"/>
              </a:rPr>
              <a:t>Fig.S5</a:t>
            </a:r>
            <a:endParaRPr b="0" lang="en-US" sz="3000" spc="-1" strike="noStrike">
              <a:solidFill>
                <a:srgbClr val="000000"/>
              </a:solidFill>
              <a:latin typeface="Arial"/>
            </a:endParaRPr>
          </a:p>
        </p:txBody>
      </p:sp>
      <p:sp>
        <p:nvSpPr>
          <p:cNvPr id="1249" name="tx31"/>
          <p:cNvSpPr/>
          <p:nvPr/>
        </p:nvSpPr>
        <p:spPr>
          <a:xfrm>
            <a:off x="9110520" y="3948120"/>
            <a:ext cx="4176720" cy="312840"/>
          </a:xfrm>
          <a:prstGeom prst="rect">
            <a:avLst/>
          </a:prstGeom>
          <a:noFill/>
          <a:ln w="0">
            <a:noFill/>
          </a:ln>
        </p:spPr>
        <p:style>
          <a:lnRef idx="0"/>
          <a:fillRef idx="0"/>
          <a:effectRef idx="0"/>
          <a:fontRef idx="minor"/>
        </p:style>
        <p:txBody>
          <a:bodyPr wrap="none" lIns="0" rIns="0" tIns="0" bIns="0" anchor="ctr" anchorCtr="1">
            <a:noAutofit/>
          </a:bodyPr>
          <a:p>
            <a:pPr>
              <a:lnSpc>
                <a:spcPts val="1437"/>
              </a:lnSpc>
              <a:tabLst>
                <a:tab algn="l" pos="0"/>
                <a:tab algn="l" pos="1487520"/>
                <a:tab algn="l" pos="2975040"/>
                <a:tab algn="l" pos="4462560"/>
                <a:tab algn="l" pos="5950080"/>
                <a:tab algn="l" pos="7437600"/>
                <a:tab algn="l" pos="8924760"/>
                <a:tab algn="l" pos="10412280"/>
              </a:tabLst>
            </a:pPr>
            <a:r>
              <a:rPr b="0" lang="en-US" sz="1800" spc="-1" strike="noStrike">
                <a:solidFill>
                  <a:srgbClr val="000000"/>
                </a:solidFill>
                <a:latin typeface="Times New Roman"/>
              </a:rPr>
              <a:t>External test cohort </a:t>
            </a:r>
            <a:r>
              <a:rPr b="0" lang="en-US" sz="1800" spc="-1" strike="noStrike">
                <a:solidFill>
                  <a:srgbClr val="000000"/>
                </a:solidFill>
                <a:latin typeface="Times New Roman"/>
              </a:rPr>
              <a:t>c</a:t>
            </a:r>
            <a:r>
              <a:rPr b="0" lang="zh-CN" sz="1800" spc="-1" strike="noStrike">
                <a:solidFill>
                  <a:srgbClr val="000000"/>
                </a:solidFill>
                <a:latin typeface="Times New Roman"/>
              </a:rPr>
              <a:t>alibration </a:t>
            </a:r>
            <a:r>
              <a:rPr b="0" lang="en-US" sz="1800" spc="-1" strike="noStrike">
                <a:solidFill>
                  <a:srgbClr val="000000"/>
                </a:solidFill>
                <a:latin typeface="Times New Roman"/>
              </a:rPr>
              <a:t>belt</a:t>
            </a:r>
            <a:endParaRPr b="0" lang="en-US" sz="1800" spc="-1" strike="noStrike">
              <a:solidFill>
                <a:srgbClr val="000000"/>
              </a:solidFill>
              <a:latin typeface="Arial"/>
            </a:endParaRPr>
          </a:p>
        </p:txBody>
      </p:sp>
      <p:sp>
        <p:nvSpPr>
          <p:cNvPr id="1250" name="tx31"/>
          <p:cNvSpPr/>
          <p:nvPr/>
        </p:nvSpPr>
        <p:spPr>
          <a:xfrm>
            <a:off x="1898640" y="3981600"/>
            <a:ext cx="4348080" cy="312480"/>
          </a:xfrm>
          <a:prstGeom prst="rect">
            <a:avLst/>
          </a:prstGeom>
          <a:noFill/>
          <a:ln w="0">
            <a:noFill/>
          </a:ln>
        </p:spPr>
        <p:style>
          <a:lnRef idx="0"/>
          <a:fillRef idx="0"/>
          <a:effectRef idx="0"/>
          <a:fontRef idx="minor"/>
        </p:style>
        <p:txBody>
          <a:bodyPr wrap="none" lIns="0" rIns="0" tIns="0" bIns="0" anchor="ctr" anchorCtr="1">
            <a:noAutofit/>
          </a:bodyPr>
          <a:p>
            <a:pPr>
              <a:lnSpc>
                <a:spcPts val="1437"/>
              </a:lnSpc>
              <a:tabLst>
                <a:tab algn="l" pos="0"/>
                <a:tab algn="l" pos="1487520"/>
                <a:tab algn="l" pos="2975040"/>
                <a:tab algn="l" pos="4462560"/>
                <a:tab algn="l" pos="5950080"/>
                <a:tab algn="l" pos="7437600"/>
                <a:tab algn="l" pos="8924760"/>
                <a:tab algn="l" pos="10412280"/>
              </a:tabLst>
            </a:pPr>
            <a:r>
              <a:rPr b="0" lang="en-US" sz="1800" spc="-1" strike="noStrike">
                <a:solidFill>
                  <a:srgbClr val="000000"/>
                </a:solidFill>
                <a:latin typeface="Times New Roman"/>
              </a:rPr>
              <a:t>Internal test cohort </a:t>
            </a:r>
            <a:r>
              <a:rPr b="0" lang="en-US" sz="1800" spc="-1" strike="noStrike">
                <a:solidFill>
                  <a:srgbClr val="000000"/>
                </a:solidFill>
                <a:latin typeface="Times New Roman"/>
              </a:rPr>
              <a:t>c</a:t>
            </a:r>
            <a:r>
              <a:rPr b="0" lang="zh-CN" sz="1800" spc="-1" strike="noStrike">
                <a:solidFill>
                  <a:srgbClr val="000000"/>
                </a:solidFill>
                <a:latin typeface="Times New Roman"/>
              </a:rPr>
              <a:t>alibration </a:t>
            </a:r>
            <a:r>
              <a:rPr b="0" lang="en-US" sz="1800" spc="-1" strike="noStrike">
                <a:solidFill>
                  <a:srgbClr val="000000"/>
                </a:solidFill>
                <a:latin typeface="Times New Roman"/>
              </a:rPr>
              <a:t>belt</a:t>
            </a:r>
            <a:endParaRPr b="0" lang="en-US" sz="1800" spc="-1" strike="noStrike">
              <a:solidFill>
                <a:srgbClr val="000000"/>
              </a:solidFill>
              <a:latin typeface="Arial"/>
            </a:endParaRPr>
          </a:p>
        </p:txBody>
      </p:sp>
      <p:sp>
        <p:nvSpPr>
          <p:cNvPr id="1251" name="tx31"/>
          <p:cNvSpPr/>
          <p:nvPr/>
        </p:nvSpPr>
        <p:spPr>
          <a:xfrm>
            <a:off x="15638400" y="3978360"/>
            <a:ext cx="4176720" cy="312480"/>
          </a:xfrm>
          <a:prstGeom prst="rect">
            <a:avLst/>
          </a:prstGeom>
          <a:noFill/>
          <a:ln w="0">
            <a:noFill/>
          </a:ln>
        </p:spPr>
        <p:style>
          <a:lnRef idx="0"/>
          <a:fillRef idx="0"/>
          <a:effectRef idx="0"/>
          <a:fontRef idx="minor"/>
        </p:style>
        <p:txBody>
          <a:bodyPr wrap="none" lIns="0" rIns="0" tIns="0" bIns="0" anchor="ctr" anchorCtr="1">
            <a:noAutofit/>
          </a:bodyPr>
          <a:p>
            <a:pPr>
              <a:lnSpc>
                <a:spcPts val="1437"/>
              </a:lnSpc>
              <a:tabLst>
                <a:tab algn="l" pos="0"/>
                <a:tab algn="l" pos="1487520"/>
                <a:tab algn="l" pos="2975040"/>
                <a:tab algn="l" pos="4462560"/>
                <a:tab algn="l" pos="5950080"/>
                <a:tab algn="l" pos="7437600"/>
                <a:tab algn="l" pos="8924760"/>
                <a:tab algn="l" pos="10412280"/>
              </a:tabLst>
            </a:pPr>
            <a:r>
              <a:rPr b="0" lang="en-US" sz="1800" spc="-1" strike="noStrike">
                <a:solidFill>
                  <a:srgbClr val="000000"/>
                </a:solidFill>
                <a:latin typeface="Times New Roman"/>
              </a:rPr>
              <a:t>Decision curve</a:t>
            </a:r>
            <a:endParaRPr b="0" lang="en-US" sz="1800" spc="-1" strike="noStrike">
              <a:solidFill>
                <a:srgbClr val="000000"/>
              </a:solidFill>
              <a:latin typeface="Arial"/>
            </a:endParaRPr>
          </a:p>
        </p:txBody>
      </p:sp>
      <p:sp>
        <p:nvSpPr>
          <p:cNvPr id="1252" name="文本框 172"/>
          <p:cNvSpPr/>
          <p:nvPr/>
        </p:nvSpPr>
        <p:spPr>
          <a:xfrm>
            <a:off x="1841400" y="11431440"/>
            <a:ext cx="18073800" cy="19227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1487520"/>
                <a:tab algn="l" pos="2975040"/>
                <a:tab algn="l" pos="4462560"/>
                <a:tab algn="l" pos="5950080"/>
                <a:tab algn="l" pos="7437600"/>
                <a:tab algn="l" pos="8924760"/>
                <a:tab algn="l" pos="10412280"/>
              </a:tabLst>
            </a:pPr>
            <a:r>
              <a:rPr b="1" lang="en-US" sz="2400" spc="-1" strike="noStrike">
                <a:solidFill>
                  <a:srgbClr val="000000"/>
                </a:solidFill>
                <a:latin typeface="Times New Roman"/>
              </a:rPr>
              <a:t>Figure S5</a:t>
            </a:r>
            <a:r>
              <a:rPr b="0" lang="en-US" sz="2400" spc="-1" strike="noStrike">
                <a:solidFill>
                  <a:srgbClr val="000000"/>
                </a:solidFill>
                <a:latin typeface="Times New Roman"/>
              </a:rPr>
              <a:t>. Calibration belt and decision curve analysis of the multivariate nomogram for CRC metastasis. </a:t>
            </a:r>
            <a:endParaRPr b="0" lang="en-US" sz="2400" spc="-1" strike="noStrike">
              <a:solidFill>
                <a:srgbClr val="000000"/>
              </a:solidFill>
              <a:latin typeface="Arial"/>
            </a:endParaRPr>
          </a:p>
          <a:p>
            <a:pPr algn="just">
              <a:lnSpc>
                <a:spcPct val="100000"/>
              </a:lnSpc>
              <a:tabLst>
                <a:tab algn="l" pos="0"/>
                <a:tab algn="l" pos="1487520"/>
                <a:tab algn="l" pos="2975040"/>
                <a:tab algn="l" pos="4462560"/>
                <a:tab algn="l" pos="5950080"/>
                <a:tab algn="l" pos="7437600"/>
                <a:tab algn="l" pos="8924760"/>
                <a:tab algn="l" pos="10412280"/>
              </a:tabLst>
            </a:pPr>
            <a:r>
              <a:rPr b="0" lang="en-US" sz="2400" spc="-1" strike="noStrike">
                <a:solidFill>
                  <a:srgbClr val="000000"/>
                </a:solidFill>
                <a:latin typeface="Times New Roman"/>
              </a:rPr>
              <a:t>(A) Calibration belt of the min multivariate nomogram in the internal test cohort. (B) Calibration belt of the 1se multivariate nomogram in the external test cohort. (C) The vertical-axis measures the net benefit. The red line represents the model based on 1se model. The blue line represents the model based on min model. The gray line represents the assumption that all patients have CRC metastases. Thin black line represents the assumption that no patients have CRC metastases.</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07-14T21:05:00Z</dcterms:created>
  <dc:creator>Tom Wenseleers</dc:creator>
  <dc:description/>
  <dc:language>en-US</dc:language>
  <cp:lastModifiedBy>SYZX</cp:lastModifiedBy>
  <dcterms:modified xsi:type="dcterms:W3CDTF">2022-02-09T08:29:55Z</dcterms:modified>
  <cp:revision>234</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501E7C0355844F6DA72B461796F3C92B</vt:lpwstr>
  </property>
  <property fmtid="{D5CDD505-2E9C-101B-9397-08002B2CF9AE}" pid="3" name="KSOProductBuildVer">
    <vt:lpwstr>2052-11.1.0.11294</vt:lpwstr>
  </property>
</Properties>
</file>